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drawings/drawing4.xml" ContentType="application/vnd.openxmlformats-officedocument.drawingml.chartshapes+xml"/>
  <Override PartName="/ppt/charts/chart5.xml" ContentType="application/vnd.openxmlformats-officedocument.drawingml.chart+xml"/>
  <Override PartName="/ppt/drawings/drawing5.xml" ContentType="application/vnd.openxmlformats-officedocument.drawingml.chartshapes+xml"/>
  <Override PartName="/ppt/charts/chart6.xml" ContentType="application/vnd.openxmlformats-officedocument.drawingml.chart+xml"/>
  <Override PartName="/ppt/drawings/drawing6.xml" ContentType="application/vnd.openxmlformats-officedocument.drawingml.chartshapes+xml"/>
  <Override PartName="/ppt/charts/chart7.xml" ContentType="application/vnd.openxmlformats-officedocument.drawingml.chart+xml"/>
  <Override PartName="/ppt/drawings/drawing7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906000" type="A4"/>
  <p:notesSz cx="6807200" cy="9939338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72" userDrawn="1">
          <p15:clr>
            <a:srgbClr val="A4A3A4"/>
          </p15:clr>
        </p15:guide>
        <p15:guide id="2" pos="153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9CC"/>
    <a:srgbClr val="006600"/>
    <a:srgbClr val="FF00FF"/>
    <a:srgbClr val="0000FF"/>
    <a:srgbClr val="9933FF"/>
    <a:srgbClr val="0066FF"/>
    <a:srgbClr val="FF3300"/>
    <a:srgbClr val="CCFF99"/>
    <a:srgbClr val="FFCCFF"/>
    <a:srgbClr val="66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 varScale="1">
        <p:scale>
          <a:sx n="74" d="100"/>
          <a:sy n="74" d="100"/>
        </p:scale>
        <p:origin x="3120" y="54"/>
      </p:cViewPr>
      <p:guideLst>
        <p:guide orient="horz" pos="1872"/>
        <p:guide pos="1531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.xml"/><Relationship Id="rId2" Type="http://schemas.openxmlformats.org/officeDocument/2006/relationships/oleObject" Target="file:///C:\My%20Documents\DATA\2007\May\30may07_Ry3ab_N_1a.xls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2.xml"/><Relationship Id="rId2" Type="http://schemas.openxmlformats.org/officeDocument/2006/relationships/oleObject" Target="file:///C:\My%20Documents\DATA\2007\March\20-26mar07\23mar07_antiRyRcADPR_1a1.xls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3.xml"/><Relationship Id="rId2" Type="http://schemas.openxmlformats.org/officeDocument/2006/relationships/oleObject" Target="file:///C:\My%20Documents\DATA\2010\July\12july10\12july10_F5N_RyR2abN_1.xls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4.xml"/><Relationship Id="rId2" Type="http://schemas.openxmlformats.org/officeDocument/2006/relationships/oleObject" Target="file:///C:\My%20Documents\DATA\2010\July\14july10\14july10_F5N_RyR2ab%20cADPR_2.xls" TargetMode="External"/><Relationship Id="rId1" Type="http://schemas.openxmlformats.org/officeDocument/2006/relationships/themeOverride" Target="../theme/themeOverride4.xm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5.xml"/><Relationship Id="rId1" Type="http://schemas.openxmlformats.org/officeDocument/2006/relationships/oleObject" Target="file:///E:\My%20Documents\DATA\2007\May\2_4may07\4may07_abRy3_cANip3_2a.xls" TargetMode="Externa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6.xml"/><Relationship Id="rId1" Type="http://schemas.openxmlformats.org/officeDocument/2006/relationships/oleObject" Target="file:///E:\My%20Documents\PAPERS\RyR%20NAADP\abRyR_stats_jun13.xls" TargetMode="External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7.xml"/><Relationship Id="rId1" Type="http://schemas.openxmlformats.org/officeDocument/2006/relationships/oleObject" Target="file:///E:\My%20Documents\DATA\2007\May\2_4may07\2may07_abRy3_N_1a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7.5969107269118333E-2"/>
          <c:y val="0.12365623859689652"/>
          <c:w val="0.87441992856699469"/>
          <c:h val="0.65620219647404365"/>
        </c:manualLayout>
      </c:layout>
      <c:scatterChart>
        <c:scatterStyle val="smoothMarker"/>
        <c:varyColors val="0"/>
        <c:ser>
          <c:idx val="0"/>
          <c:order val="0"/>
          <c:spPr>
            <a:ln w="28575">
              <a:solidFill>
                <a:sysClr val="windowText" lastClr="000000"/>
              </a:solidFill>
              <a:prstDash val="solid"/>
            </a:ln>
          </c:spPr>
          <c:marker>
            <c:symbol val="none"/>
          </c:marker>
          <c:xVal>
            <c:numRef>
              <c:f>'30may07_Ry3ab_N_1a'!$C$1:$C$1200</c:f>
              <c:numCache>
                <c:formatCode>General</c:formatCode>
                <c:ptCount val="1200"/>
                <c:pt idx="0">
                  <c:v>0</c:v>
                </c:pt>
                <c:pt idx="1">
                  <c:v>1.6300000000000001</c:v>
                </c:pt>
                <c:pt idx="2">
                  <c:v>3.2600000000000002</c:v>
                </c:pt>
                <c:pt idx="3">
                  <c:v>4.8899999999999997</c:v>
                </c:pt>
                <c:pt idx="4">
                  <c:v>6.52</c:v>
                </c:pt>
                <c:pt idx="5">
                  <c:v>8.15</c:v>
                </c:pt>
                <c:pt idx="6">
                  <c:v>9.7800000000000011</c:v>
                </c:pt>
                <c:pt idx="7">
                  <c:v>11.41</c:v>
                </c:pt>
                <c:pt idx="8">
                  <c:v>13.04</c:v>
                </c:pt>
                <c:pt idx="9">
                  <c:v>14.67</c:v>
                </c:pt>
                <c:pt idx="10">
                  <c:v>16.3</c:v>
                </c:pt>
                <c:pt idx="11">
                  <c:v>17.93</c:v>
                </c:pt>
                <c:pt idx="12">
                  <c:v>19.559999999999999</c:v>
                </c:pt>
                <c:pt idx="13">
                  <c:v>21.19</c:v>
                </c:pt>
                <c:pt idx="14">
                  <c:v>22.82</c:v>
                </c:pt>
                <c:pt idx="15">
                  <c:v>24.45</c:v>
                </c:pt>
                <c:pt idx="16">
                  <c:v>26.08</c:v>
                </c:pt>
                <c:pt idx="17">
                  <c:v>27.71</c:v>
                </c:pt>
                <c:pt idx="18">
                  <c:v>29.34</c:v>
                </c:pt>
                <c:pt idx="19">
                  <c:v>30.97</c:v>
                </c:pt>
                <c:pt idx="20">
                  <c:v>32.6</c:v>
                </c:pt>
                <c:pt idx="21">
                  <c:v>34.230000000000011</c:v>
                </c:pt>
                <c:pt idx="22">
                  <c:v>35.86</c:v>
                </c:pt>
                <c:pt idx="23">
                  <c:v>37.49</c:v>
                </c:pt>
                <c:pt idx="24">
                  <c:v>39.120000000000012</c:v>
                </c:pt>
                <c:pt idx="25">
                  <c:v>40.75</c:v>
                </c:pt>
                <c:pt idx="26">
                  <c:v>42.38</c:v>
                </c:pt>
                <c:pt idx="27">
                  <c:v>44.01</c:v>
                </c:pt>
                <c:pt idx="28">
                  <c:v>45.64</c:v>
                </c:pt>
                <c:pt idx="29">
                  <c:v>47.27</c:v>
                </c:pt>
                <c:pt idx="30">
                  <c:v>48.9</c:v>
                </c:pt>
                <c:pt idx="31">
                  <c:v>50.53</c:v>
                </c:pt>
                <c:pt idx="32">
                  <c:v>52.160000000000011</c:v>
                </c:pt>
                <c:pt idx="33">
                  <c:v>53.790000000000013</c:v>
                </c:pt>
                <c:pt idx="34">
                  <c:v>55.42</c:v>
                </c:pt>
                <c:pt idx="35">
                  <c:v>57.05</c:v>
                </c:pt>
                <c:pt idx="36">
                  <c:v>58.68</c:v>
                </c:pt>
                <c:pt idx="37">
                  <c:v>60.31</c:v>
                </c:pt>
                <c:pt idx="38">
                  <c:v>61.94</c:v>
                </c:pt>
                <c:pt idx="39">
                  <c:v>63.57</c:v>
                </c:pt>
                <c:pt idx="40">
                  <c:v>65.2</c:v>
                </c:pt>
                <c:pt idx="41">
                  <c:v>66.83</c:v>
                </c:pt>
                <c:pt idx="42">
                  <c:v>68.459999999999994</c:v>
                </c:pt>
                <c:pt idx="43">
                  <c:v>70.09</c:v>
                </c:pt>
                <c:pt idx="44">
                  <c:v>71.72</c:v>
                </c:pt>
                <c:pt idx="45">
                  <c:v>73.349999999999994</c:v>
                </c:pt>
                <c:pt idx="46">
                  <c:v>74.98</c:v>
                </c:pt>
                <c:pt idx="47">
                  <c:v>76.61</c:v>
                </c:pt>
                <c:pt idx="48">
                  <c:v>78.239999999999995</c:v>
                </c:pt>
                <c:pt idx="49">
                  <c:v>79.86999999999999</c:v>
                </c:pt>
                <c:pt idx="50">
                  <c:v>81.5</c:v>
                </c:pt>
                <c:pt idx="51">
                  <c:v>83.13</c:v>
                </c:pt>
                <c:pt idx="52">
                  <c:v>84.76</c:v>
                </c:pt>
                <c:pt idx="53">
                  <c:v>86.39</c:v>
                </c:pt>
                <c:pt idx="54">
                  <c:v>88.02</c:v>
                </c:pt>
                <c:pt idx="55">
                  <c:v>89.649999999999991</c:v>
                </c:pt>
                <c:pt idx="56">
                  <c:v>91.28</c:v>
                </c:pt>
                <c:pt idx="57">
                  <c:v>92.910000000000025</c:v>
                </c:pt>
                <c:pt idx="58">
                  <c:v>94.54</c:v>
                </c:pt>
                <c:pt idx="59">
                  <c:v>96.169999999999987</c:v>
                </c:pt>
                <c:pt idx="60">
                  <c:v>97.8</c:v>
                </c:pt>
                <c:pt idx="61">
                  <c:v>99.43</c:v>
                </c:pt>
                <c:pt idx="62">
                  <c:v>101.06</c:v>
                </c:pt>
                <c:pt idx="63">
                  <c:v>102.69</c:v>
                </c:pt>
                <c:pt idx="64">
                  <c:v>104.32</c:v>
                </c:pt>
                <c:pt idx="65">
                  <c:v>105.95</c:v>
                </c:pt>
                <c:pt idx="66">
                  <c:v>107.58</c:v>
                </c:pt>
                <c:pt idx="67">
                  <c:v>109.21000000000002</c:v>
                </c:pt>
                <c:pt idx="68">
                  <c:v>110.84</c:v>
                </c:pt>
                <c:pt idx="69">
                  <c:v>112.47</c:v>
                </c:pt>
                <c:pt idx="70">
                  <c:v>114.1</c:v>
                </c:pt>
                <c:pt idx="71">
                  <c:v>115.73</c:v>
                </c:pt>
                <c:pt idx="72">
                  <c:v>117.36</c:v>
                </c:pt>
                <c:pt idx="73">
                  <c:v>118.99000000000002</c:v>
                </c:pt>
                <c:pt idx="74">
                  <c:v>120.61999999999999</c:v>
                </c:pt>
                <c:pt idx="75">
                  <c:v>122.25</c:v>
                </c:pt>
                <c:pt idx="76">
                  <c:v>123.88</c:v>
                </c:pt>
                <c:pt idx="77">
                  <c:v>125.51</c:v>
                </c:pt>
                <c:pt idx="78">
                  <c:v>127.14</c:v>
                </c:pt>
                <c:pt idx="79">
                  <c:v>128.76999999999998</c:v>
                </c:pt>
                <c:pt idx="80">
                  <c:v>130.4</c:v>
                </c:pt>
                <c:pt idx="81">
                  <c:v>132.03</c:v>
                </c:pt>
                <c:pt idx="82">
                  <c:v>133.66</c:v>
                </c:pt>
                <c:pt idx="83">
                  <c:v>135.29</c:v>
                </c:pt>
                <c:pt idx="84">
                  <c:v>136.91999999999999</c:v>
                </c:pt>
                <c:pt idx="85">
                  <c:v>138.55000000000001</c:v>
                </c:pt>
                <c:pt idx="86">
                  <c:v>140.18</c:v>
                </c:pt>
                <c:pt idx="87">
                  <c:v>141.81</c:v>
                </c:pt>
                <c:pt idx="88">
                  <c:v>143.44</c:v>
                </c:pt>
                <c:pt idx="89">
                  <c:v>145.07</c:v>
                </c:pt>
                <c:pt idx="90">
                  <c:v>146.69999999999999</c:v>
                </c:pt>
                <c:pt idx="91">
                  <c:v>148.33000000000001</c:v>
                </c:pt>
                <c:pt idx="92">
                  <c:v>149.96</c:v>
                </c:pt>
                <c:pt idx="93">
                  <c:v>151.59</c:v>
                </c:pt>
                <c:pt idx="94">
                  <c:v>153.22</c:v>
                </c:pt>
                <c:pt idx="95">
                  <c:v>154.85000000000079</c:v>
                </c:pt>
                <c:pt idx="96">
                  <c:v>156.47999999999999</c:v>
                </c:pt>
                <c:pt idx="97">
                  <c:v>158.10999999999999</c:v>
                </c:pt>
                <c:pt idx="98">
                  <c:v>159.73999999999998</c:v>
                </c:pt>
                <c:pt idx="99">
                  <c:v>161.37</c:v>
                </c:pt>
                <c:pt idx="100">
                  <c:v>163</c:v>
                </c:pt>
                <c:pt idx="101">
                  <c:v>164.63</c:v>
                </c:pt>
                <c:pt idx="102">
                  <c:v>166.26</c:v>
                </c:pt>
                <c:pt idx="103">
                  <c:v>167.89000000000001</c:v>
                </c:pt>
                <c:pt idx="104">
                  <c:v>169.52</c:v>
                </c:pt>
                <c:pt idx="105">
                  <c:v>171.15</c:v>
                </c:pt>
                <c:pt idx="106">
                  <c:v>172.78</c:v>
                </c:pt>
                <c:pt idx="107">
                  <c:v>174.41</c:v>
                </c:pt>
                <c:pt idx="108">
                  <c:v>176.04</c:v>
                </c:pt>
                <c:pt idx="109">
                  <c:v>177.67</c:v>
                </c:pt>
                <c:pt idx="110">
                  <c:v>179.3</c:v>
                </c:pt>
                <c:pt idx="111">
                  <c:v>180.93</c:v>
                </c:pt>
                <c:pt idx="112">
                  <c:v>182.56</c:v>
                </c:pt>
                <c:pt idx="113">
                  <c:v>184.19</c:v>
                </c:pt>
                <c:pt idx="114">
                  <c:v>185.82000000000079</c:v>
                </c:pt>
                <c:pt idx="115">
                  <c:v>187.45000000000007</c:v>
                </c:pt>
                <c:pt idx="116">
                  <c:v>189.08</c:v>
                </c:pt>
                <c:pt idx="117">
                  <c:v>190.70999999999998</c:v>
                </c:pt>
                <c:pt idx="118">
                  <c:v>192.34</c:v>
                </c:pt>
                <c:pt idx="119">
                  <c:v>193.97</c:v>
                </c:pt>
                <c:pt idx="120">
                  <c:v>195.6</c:v>
                </c:pt>
                <c:pt idx="121">
                  <c:v>197.23</c:v>
                </c:pt>
                <c:pt idx="122">
                  <c:v>198.86</c:v>
                </c:pt>
                <c:pt idx="123">
                  <c:v>200.49</c:v>
                </c:pt>
                <c:pt idx="124">
                  <c:v>202.12</c:v>
                </c:pt>
                <c:pt idx="125">
                  <c:v>203.75</c:v>
                </c:pt>
                <c:pt idx="126">
                  <c:v>205.38000000000079</c:v>
                </c:pt>
                <c:pt idx="127">
                  <c:v>207.01</c:v>
                </c:pt>
                <c:pt idx="128">
                  <c:v>208.64</c:v>
                </c:pt>
                <c:pt idx="129">
                  <c:v>210.26999999999998</c:v>
                </c:pt>
                <c:pt idx="130">
                  <c:v>211.9</c:v>
                </c:pt>
                <c:pt idx="131">
                  <c:v>213.53</c:v>
                </c:pt>
                <c:pt idx="132">
                  <c:v>215.16</c:v>
                </c:pt>
                <c:pt idx="133">
                  <c:v>216.79</c:v>
                </c:pt>
                <c:pt idx="134">
                  <c:v>218.42000000000004</c:v>
                </c:pt>
                <c:pt idx="135">
                  <c:v>220.05</c:v>
                </c:pt>
                <c:pt idx="136">
                  <c:v>221.68</c:v>
                </c:pt>
                <c:pt idx="137">
                  <c:v>223.31</c:v>
                </c:pt>
                <c:pt idx="138">
                  <c:v>224.94</c:v>
                </c:pt>
                <c:pt idx="139">
                  <c:v>226.57</c:v>
                </c:pt>
                <c:pt idx="140">
                  <c:v>228.2</c:v>
                </c:pt>
                <c:pt idx="141">
                  <c:v>229.83</c:v>
                </c:pt>
                <c:pt idx="142">
                  <c:v>231.46</c:v>
                </c:pt>
                <c:pt idx="143">
                  <c:v>233.09</c:v>
                </c:pt>
                <c:pt idx="144">
                  <c:v>234.72</c:v>
                </c:pt>
                <c:pt idx="145">
                  <c:v>236.35000000000079</c:v>
                </c:pt>
                <c:pt idx="146">
                  <c:v>237.98000000000027</c:v>
                </c:pt>
                <c:pt idx="147">
                  <c:v>239.60999999999999</c:v>
                </c:pt>
                <c:pt idx="148">
                  <c:v>241.23999999999998</c:v>
                </c:pt>
                <c:pt idx="149">
                  <c:v>242.87</c:v>
                </c:pt>
                <c:pt idx="150">
                  <c:v>244.5</c:v>
                </c:pt>
                <c:pt idx="151">
                  <c:v>246.13</c:v>
                </c:pt>
                <c:pt idx="152">
                  <c:v>247.76</c:v>
                </c:pt>
                <c:pt idx="153">
                  <c:v>249.39000000000001</c:v>
                </c:pt>
                <c:pt idx="154">
                  <c:v>251.02</c:v>
                </c:pt>
                <c:pt idx="155">
                  <c:v>252.65</c:v>
                </c:pt>
                <c:pt idx="156">
                  <c:v>254.28</c:v>
                </c:pt>
                <c:pt idx="157">
                  <c:v>255.91</c:v>
                </c:pt>
                <c:pt idx="158">
                  <c:v>257.54000000000002</c:v>
                </c:pt>
                <c:pt idx="159">
                  <c:v>259.17</c:v>
                </c:pt>
                <c:pt idx="160">
                  <c:v>260.8</c:v>
                </c:pt>
                <c:pt idx="161">
                  <c:v>262.42999999999893</c:v>
                </c:pt>
                <c:pt idx="162">
                  <c:v>264.06</c:v>
                </c:pt>
                <c:pt idx="163">
                  <c:v>265.69</c:v>
                </c:pt>
                <c:pt idx="164">
                  <c:v>267.32</c:v>
                </c:pt>
                <c:pt idx="165">
                  <c:v>268.95</c:v>
                </c:pt>
                <c:pt idx="166">
                  <c:v>270.58</c:v>
                </c:pt>
                <c:pt idx="167">
                  <c:v>272.20999999999964</c:v>
                </c:pt>
                <c:pt idx="168">
                  <c:v>273.83999999999969</c:v>
                </c:pt>
                <c:pt idx="169">
                  <c:v>275.47000000000003</c:v>
                </c:pt>
                <c:pt idx="170">
                  <c:v>277.10000000000002</c:v>
                </c:pt>
                <c:pt idx="171">
                  <c:v>278.72999999999894</c:v>
                </c:pt>
                <c:pt idx="172">
                  <c:v>280.36</c:v>
                </c:pt>
                <c:pt idx="173">
                  <c:v>281.98999999999899</c:v>
                </c:pt>
                <c:pt idx="174">
                  <c:v>283.62</c:v>
                </c:pt>
                <c:pt idx="175">
                  <c:v>285.25</c:v>
                </c:pt>
                <c:pt idx="176">
                  <c:v>286.88</c:v>
                </c:pt>
                <c:pt idx="177">
                  <c:v>288.51</c:v>
                </c:pt>
                <c:pt idx="178">
                  <c:v>290.14000000000038</c:v>
                </c:pt>
                <c:pt idx="179">
                  <c:v>291.77</c:v>
                </c:pt>
                <c:pt idx="180">
                  <c:v>293.39999999999969</c:v>
                </c:pt>
                <c:pt idx="181">
                  <c:v>295.02999999999969</c:v>
                </c:pt>
                <c:pt idx="182">
                  <c:v>296.66000000000008</c:v>
                </c:pt>
                <c:pt idx="183">
                  <c:v>298.28999999999894</c:v>
                </c:pt>
                <c:pt idx="184">
                  <c:v>299.91999999999899</c:v>
                </c:pt>
                <c:pt idx="185">
                  <c:v>301.55</c:v>
                </c:pt>
                <c:pt idx="186">
                  <c:v>303.18</c:v>
                </c:pt>
                <c:pt idx="187">
                  <c:v>304.81</c:v>
                </c:pt>
                <c:pt idx="188">
                  <c:v>306.44</c:v>
                </c:pt>
                <c:pt idx="189">
                  <c:v>308.07</c:v>
                </c:pt>
                <c:pt idx="190">
                  <c:v>309.7</c:v>
                </c:pt>
                <c:pt idx="191">
                  <c:v>311.33</c:v>
                </c:pt>
                <c:pt idx="192">
                  <c:v>312.95999999999964</c:v>
                </c:pt>
                <c:pt idx="193">
                  <c:v>314.58999999999969</c:v>
                </c:pt>
                <c:pt idx="194">
                  <c:v>316.22000000000003</c:v>
                </c:pt>
                <c:pt idx="195">
                  <c:v>317.85000000000002</c:v>
                </c:pt>
                <c:pt idx="196">
                  <c:v>319.47999999999894</c:v>
                </c:pt>
                <c:pt idx="197">
                  <c:v>321.11</c:v>
                </c:pt>
                <c:pt idx="198">
                  <c:v>322.74</c:v>
                </c:pt>
                <c:pt idx="199">
                  <c:v>324.37</c:v>
                </c:pt>
                <c:pt idx="200">
                  <c:v>326</c:v>
                </c:pt>
                <c:pt idx="201">
                  <c:v>327.63</c:v>
                </c:pt>
                <c:pt idx="202">
                  <c:v>329.26</c:v>
                </c:pt>
                <c:pt idx="203">
                  <c:v>330.89</c:v>
                </c:pt>
                <c:pt idx="204">
                  <c:v>332.52</c:v>
                </c:pt>
                <c:pt idx="205">
                  <c:v>334.15000000000032</c:v>
                </c:pt>
                <c:pt idx="206">
                  <c:v>335.78</c:v>
                </c:pt>
                <c:pt idx="207">
                  <c:v>337.40999999999963</c:v>
                </c:pt>
                <c:pt idx="208">
                  <c:v>339.04</c:v>
                </c:pt>
                <c:pt idx="209">
                  <c:v>340.67</c:v>
                </c:pt>
                <c:pt idx="210">
                  <c:v>342.3</c:v>
                </c:pt>
                <c:pt idx="211">
                  <c:v>343.92999999999893</c:v>
                </c:pt>
                <c:pt idx="212">
                  <c:v>345.56</c:v>
                </c:pt>
                <c:pt idx="213">
                  <c:v>347.19</c:v>
                </c:pt>
                <c:pt idx="214">
                  <c:v>348.82</c:v>
                </c:pt>
                <c:pt idx="215">
                  <c:v>350.45</c:v>
                </c:pt>
                <c:pt idx="216">
                  <c:v>352.08</c:v>
                </c:pt>
                <c:pt idx="217">
                  <c:v>353.71</c:v>
                </c:pt>
                <c:pt idx="218">
                  <c:v>355.34000000000032</c:v>
                </c:pt>
                <c:pt idx="219">
                  <c:v>356.96999999999969</c:v>
                </c:pt>
                <c:pt idx="220">
                  <c:v>358.6</c:v>
                </c:pt>
                <c:pt idx="221">
                  <c:v>360.22999999999894</c:v>
                </c:pt>
                <c:pt idx="222">
                  <c:v>361.86</c:v>
                </c:pt>
                <c:pt idx="223">
                  <c:v>363.48999999999899</c:v>
                </c:pt>
                <c:pt idx="224">
                  <c:v>365.12</c:v>
                </c:pt>
                <c:pt idx="225">
                  <c:v>366.75</c:v>
                </c:pt>
                <c:pt idx="226">
                  <c:v>368.38</c:v>
                </c:pt>
                <c:pt idx="227">
                  <c:v>370.01</c:v>
                </c:pt>
                <c:pt idx="228">
                  <c:v>371.64000000000038</c:v>
                </c:pt>
                <c:pt idx="229">
                  <c:v>373.27</c:v>
                </c:pt>
                <c:pt idx="230">
                  <c:v>374.9</c:v>
                </c:pt>
                <c:pt idx="231">
                  <c:v>376.53</c:v>
                </c:pt>
                <c:pt idx="232">
                  <c:v>378.16</c:v>
                </c:pt>
                <c:pt idx="233">
                  <c:v>379.78999999999894</c:v>
                </c:pt>
                <c:pt idx="234">
                  <c:v>381.41999999999899</c:v>
                </c:pt>
                <c:pt idx="235">
                  <c:v>383.05</c:v>
                </c:pt>
                <c:pt idx="236">
                  <c:v>384.68</c:v>
                </c:pt>
                <c:pt idx="237">
                  <c:v>386.31</c:v>
                </c:pt>
                <c:pt idx="238">
                  <c:v>387.94</c:v>
                </c:pt>
                <c:pt idx="239">
                  <c:v>389.57</c:v>
                </c:pt>
                <c:pt idx="240">
                  <c:v>391.2</c:v>
                </c:pt>
                <c:pt idx="241">
                  <c:v>392.83</c:v>
                </c:pt>
                <c:pt idx="242">
                  <c:v>394.46</c:v>
                </c:pt>
                <c:pt idx="243">
                  <c:v>396.09</c:v>
                </c:pt>
                <c:pt idx="244">
                  <c:v>397.71999999999969</c:v>
                </c:pt>
                <c:pt idx="245">
                  <c:v>399.35</c:v>
                </c:pt>
                <c:pt idx="246">
                  <c:v>400.97999999999894</c:v>
                </c:pt>
                <c:pt idx="247">
                  <c:v>402.61</c:v>
                </c:pt>
                <c:pt idx="248">
                  <c:v>404.24</c:v>
                </c:pt>
                <c:pt idx="249">
                  <c:v>405.87</c:v>
                </c:pt>
                <c:pt idx="250">
                  <c:v>407.5</c:v>
                </c:pt>
                <c:pt idx="251">
                  <c:v>409.13</c:v>
                </c:pt>
                <c:pt idx="252">
                  <c:v>410.76</c:v>
                </c:pt>
                <c:pt idx="253">
                  <c:v>412.39</c:v>
                </c:pt>
                <c:pt idx="254">
                  <c:v>414.02</c:v>
                </c:pt>
                <c:pt idx="255">
                  <c:v>415.65000000000032</c:v>
                </c:pt>
                <c:pt idx="256">
                  <c:v>417.28</c:v>
                </c:pt>
                <c:pt idx="257">
                  <c:v>418.90999999999963</c:v>
                </c:pt>
                <c:pt idx="258">
                  <c:v>420.54</c:v>
                </c:pt>
                <c:pt idx="259">
                  <c:v>422.17</c:v>
                </c:pt>
                <c:pt idx="260">
                  <c:v>423.8</c:v>
                </c:pt>
                <c:pt idx="261">
                  <c:v>425.42999999999893</c:v>
                </c:pt>
                <c:pt idx="262">
                  <c:v>427.06</c:v>
                </c:pt>
                <c:pt idx="263">
                  <c:v>428.69</c:v>
                </c:pt>
                <c:pt idx="264">
                  <c:v>430.32</c:v>
                </c:pt>
                <c:pt idx="265">
                  <c:v>431.95</c:v>
                </c:pt>
                <c:pt idx="266">
                  <c:v>433.58</c:v>
                </c:pt>
                <c:pt idx="267">
                  <c:v>435.21</c:v>
                </c:pt>
                <c:pt idx="268">
                  <c:v>436.84000000000032</c:v>
                </c:pt>
                <c:pt idx="269">
                  <c:v>438.46999999999969</c:v>
                </c:pt>
                <c:pt idx="270">
                  <c:v>440.1</c:v>
                </c:pt>
                <c:pt idx="271">
                  <c:v>441.72999999999894</c:v>
                </c:pt>
                <c:pt idx="272">
                  <c:v>443.36</c:v>
                </c:pt>
                <c:pt idx="273">
                  <c:v>444.98999999999899</c:v>
                </c:pt>
                <c:pt idx="274">
                  <c:v>446.62</c:v>
                </c:pt>
                <c:pt idx="275">
                  <c:v>448.25</c:v>
                </c:pt>
                <c:pt idx="276">
                  <c:v>449.88</c:v>
                </c:pt>
                <c:pt idx="277">
                  <c:v>451.51</c:v>
                </c:pt>
                <c:pt idx="278">
                  <c:v>453.14000000000038</c:v>
                </c:pt>
                <c:pt idx="279">
                  <c:v>454.77</c:v>
                </c:pt>
                <c:pt idx="280">
                  <c:v>456.4</c:v>
                </c:pt>
                <c:pt idx="281">
                  <c:v>458.03</c:v>
                </c:pt>
                <c:pt idx="282">
                  <c:v>459.66</c:v>
                </c:pt>
                <c:pt idx="283">
                  <c:v>461.28999999999894</c:v>
                </c:pt>
                <c:pt idx="284">
                  <c:v>462.91999999999899</c:v>
                </c:pt>
                <c:pt idx="285">
                  <c:v>464.55</c:v>
                </c:pt>
                <c:pt idx="286">
                  <c:v>466.18</c:v>
                </c:pt>
                <c:pt idx="287">
                  <c:v>467.81</c:v>
                </c:pt>
                <c:pt idx="288">
                  <c:v>469.44</c:v>
                </c:pt>
                <c:pt idx="289">
                  <c:v>471.07</c:v>
                </c:pt>
                <c:pt idx="290">
                  <c:v>472.7</c:v>
                </c:pt>
                <c:pt idx="291">
                  <c:v>474.33</c:v>
                </c:pt>
                <c:pt idx="292">
                  <c:v>475.96</c:v>
                </c:pt>
                <c:pt idx="293">
                  <c:v>477.59</c:v>
                </c:pt>
                <c:pt idx="294">
                  <c:v>479.21999999999969</c:v>
                </c:pt>
                <c:pt idx="295">
                  <c:v>480.85</c:v>
                </c:pt>
                <c:pt idx="296">
                  <c:v>482.47999999999894</c:v>
                </c:pt>
                <c:pt idx="297">
                  <c:v>484.11</c:v>
                </c:pt>
                <c:pt idx="298">
                  <c:v>485.74</c:v>
                </c:pt>
                <c:pt idx="299">
                  <c:v>487.37</c:v>
                </c:pt>
                <c:pt idx="300">
                  <c:v>489</c:v>
                </c:pt>
                <c:pt idx="301">
                  <c:v>490.63</c:v>
                </c:pt>
                <c:pt idx="302">
                  <c:v>492.26</c:v>
                </c:pt>
                <c:pt idx="303">
                  <c:v>493.89</c:v>
                </c:pt>
                <c:pt idx="304">
                  <c:v>495.52</c:v>
                </c:pt>
                <c:pt idx="305">
                  <c:v>497.15000000000032</c:v>
                </c:pt>
                <c:pt idx="306">
                  <c:v>498.78</c:v>
                </c:pt>
                <c:pt idx="307">
                  <c:v>500.40999999999963</c:v>
                </c:pt>
                <c:pt idx="308">
                  <c:v>502.04</c:v>
                </c:pt>
                <c:pt idx="309">
                  <c:v>503.67</c:v>
                </c:pt>
                <c:pt idx="310">
                  <c:v>505.3</c:v>
                </c:pt>
                <c:pt idx="311">
                  <c:v>506.92999999999893</c:v>
                </c:pt>
                <c:pt idx="312">
                  <c:v>508.56</c:v>
                </c:pt>
                <c:pt idx="313">
                  <c:v>510.19</c:v>
                </c:pt>
                <c:pt idx="314">
                  <c:v>511.82</c:v>
                </c:pt>
                <c:pt idx="315">
                  <c:v>513.44999999999948</c:v>
                </c:pt>
                <c:pt idx="316">
                  <c:v>515.08000000000004</c:v>
                </c:pt>
                <c:pt idx="317">
                  <c:v>516.71</c:v>
                </c:pt>
                <c:pt idx="318">
                  <c:v>518.33999999999946</c:v>
                </c:pt>
                <c:pt idx="319">
                  <c:v>519.97</c:v>
                </c:pt>
                <c:pt idx="320">
                  <c:v>521.6</c:v>
                </c:pt>
                <c:pt idx="321">
                  <c:v>523.23</c:v>
                </c:pt>
                <c:pt idx="322">
                  <c:v>524.85999999999797</c:v>
                </c:pt>
                <c:pt idx="323">
                  <c:v>526.49</c:v>
                </c:pt>
                <c:pt idx="324">
                  <c:v>528.12</c:v>
                </c:pt>
                <c:pt idx="325">
                  <c:v>529.75</c:v>
                </c:pt>
                <c:pt idx="326">
                  <c:v>531.38</c:v>
                </c:pt>
                <c:pt idx="327">
                  <c:v>533.01</c:v>
                </c:pt>
                <c:pt idx="328">
                  <c:v>534.64</c:v>
                </c:pt>
                <c:pt idx="329">
                  <c:v>536.27000000000055</c:v>
                </c:pt>
                <c:pt idx="330">
                  <c:v>537.9</c:v>
                </c:pt>
                <c:pt idx="331">
                  <c:v>539.53</c:v>
                </c:pt>
                <c:pt idx="332">
                  <c:v>541.16</c:v>
                </c:pt>
                <c:pt idx="333">
                  <c:v>542.79000000000053</c:v>
                </c:pt>
                <c:pt idx="334">
                  <c:v>544.41999999999996</c:v>
                </c:pt>
                <c:pt idx="335">
                  <c:v>546.04999999999939</c:v>
                </c:pt>
                <c:pt idx="336">
                  <c:v>547.67999999999995</c:v>
                </c:pt>
                <c:pt idx="337">
                  <c:v>549.30999999999949</c:v>
                </c:pt>
                <c:pt idx="338">
                  <c:v>550.93999999999949</c:v>
                </c:pt>
                <c:pt idx="339">
                  <c:v>552.57000000000005</c:v>
                </c:pt>
                <c:pt idx="340">
                  <c:v>554.20000000000005</c:v>
                </c:pt>
                <c:pt idx="341">
                  <c:v>555.82999999999947</c:v>
                </c:pt>
                <c:pt idx="342">
                  <c:v>557.45999999999947</c:v>
                </c:pt>
                <c:pt idx="343">
                  <c:v>559.09</c:v>
                </c:pt>
                <c:pt idx="344">
                  <c:v>560.72</c:v>
                </c:pt>
                <c:pt idx="345">
                  <c:v>562.34999999999798</c:v>
                </c:pt>
                <c:pt idx="346">
                  <c:v>563.98</c:v>
                </c:pt>
                <c:pt idx="347">
                  <c:v>565.61</c:v>
                </c:pt>
                <c:pt idx="348">
                  <c:v>567.24</c:v>
                </c:pt>
                <c:pt idx="349">
                  <c:v>568.87</c:v>
                </c:pt>
                <c:pt idx="350">
                  <c:v>570.5</c:v>
                </c:pt>
                <c:pt idx="351">
                  <c:v>572.13</c:v>
                </c:pt>
                <c:pt idx="352">
                  <c:v>573.76</c:v>
                </c:pt>
                <c:pt idx="353">
                  <c:v>575.39</c:v>
                </c:pt>
                <c:pt idx="354">
                  <c:v>577.02</c:v>
                </c:pt>
                <c:pt idx="355">
                  <c:v>578.65</c:v>
                </c:pt>
                <c:pt idx="356">
                  <c:v>580.28000000000054</c:v>
                </c:pt>
                <c:pt idx="357">
                  <c:v>581.91</c:v>
                </c:pt>
                <c:pt idx="358">
                  <c:v>583.54</c:v>
                </c:pt>
                <c:pt idx="359">
                  <c:v>585.16999999999996</c:v>
                </c:pt>
                <c:pt idx="360">
                  <c:v>586.79999999999995</c:v>
                </c:pt>
                <c:pt idx="361">
                  <c:v>588.42999999999938</c:v>
                </c:pt>
                <c:pt idx="362">
                  <c:v>590.05999999999949</c:v>
                </c:pt>
                <c:pt idx="363">
                  <c:v>591.69000000000005</c:v>
                </c:pt>
                <c:pt idx="364">
                  <c:v>593.31999999999948</c:v>
                </c:pt>
                <c:pt idx="365">
                  <c:v>594.94999999999948</c:v>
                </c:pt>
                <c:pt idx="366">
                  <c:v>596.58000000000004</c:v>
                </c:pt>
                <c:pt idx="367">
                  <c:v>598.21</c:v>
                </c:pt>
                <c:pt idx="368">
                  <c:v>599.83999999999946</c:v>
                </c:pt>
                <c:pt idx="369">
                  <c:v>601.47</c:v>
                </c:pt>
                <c:pt idx="370">
                  <c:v>603.1</c:v>
                </c:pt>
                <c:pt idx="371">
                  <c:v>604.73</c:v>
                </c:pt>
                <c:pt idx="372">
                  <c:v>606.35999999999797</c:v>
                </c:pt>
                <c:pt idx="373">
                  <c:v>607.99</c:v>
                </c:pt>
                <c:pt idx="374">
                  <c:v>609.62</c:v>
                </c:pt>
                <c:pt idx="375">
                  <c:v>611.25</c:v>
                </c:pt>
                <c:pt idx="376">
                  <c:v>612.88</c:v>
                </c:pt>
                <c:pt idx="377">
                  <c:v>614.51</c:v>
                </c:pt>
                <c:pt idx="378">
                  <c:v>616.14</c:v>
                </c:pt>
                <c:pt idx="379">
                  <c:v>617.77000000000055</c:v>
                </c:pt>
                <c:pt idx="380">
                  <c:v>619.4</c:v>
                </c:pt>
                <c:pt idx="381">
                  <c:v>621.03</c:v>
                </c:pt>
                <c:pt idx="382">
                  <c:v>622.66</c:v>
                </c:pt>
                <c:pt idx="383">
                  <c:v>624.29000000000053</c:v>
                </c:pt>
                <c:pt idx="384">
                  <c:v>625.91999999999996</c:v>
                </c:pt>
                <c:pt idx="385">
                  <c:v>627.54999999999939</c:v>
                </c:pt>
                <c:pt idx="386">
                  <c:v>629.17999999999995</c:v>
                </c:pt>
                <c:pt idx="387">
                  <c:v>630.80999999999949</c:v>
                </c:pt>
                <c:pt idx="388">
                  <c:v>632.43999999999949</c:v>
                </c:pt>
                <c:pt idx="389">
                  <c:v>634.07000000000005</c:v>
                </c:pt>
                <c:pt idx="390">
                  <c:v>635.70000000000005</c:v>
                </c:pt>
                <c:pt idx="391">
                  <c:v>637.32999999999947</c:v>
                </c:pt>
                <c:pt idx="392">
                  <c:v>638.95999999999947</c:v>
                </c:pt>
                <c:pt idx="393">
                  <c:v>640.59</c:v>
                </c:pt>
                <c:pt idx="394">
                  <c:v>642.22</c:v>
                </c:pt>
                <c:pt idx="395">
                  <c:v>643.84999999999798</c:v>
                </c:pt>
                <c:pt idx="396">
                  <c:v>645.48</c:v>
                </c:pt>
                <c:pt idx="397">
                  <c:v>647.11</c:v>
                </c:pt>
                <c:pt idx="398">
                  <c:v>648.74</c:v>
                </c:pt>
                <c:pt idx="399">
                  <c:v>650.37</c:v>
                </c:pt>
                <c:pt idx="400">
                  <c:v>652</c:v>
                </c:pt>
                <c:pt idx="401">
                  <c:v>653.63</c:v>
                </c:pt>
                <c:pt idx="402">
                  <c:v>655.26</c:v>
                </c:pt>
                <c:pt idx="403">
                  <c:v>656.89</c:v>
                </c:pt>
                <c:pt idx="404">
                  <c:v>658.52</c:v>
                </c:pt>
                <c:pt idx="405">
                  <c:v>660.15</c:v>
                </c:pt>
                <c:pt idx="406">
                  <c:v>661.78000000000054</c:v>
                </c:pt>
                <c:pt idx="407">
                  <c:v>663.41</c:v>
                </c:pt>
                <c:pt idx="408">
                  <c:v>665.04</c:v>
                </c:pt>
                <c:pt idx="409">
                  <c:v>666.67000000000053</c:v>
                </c:pt>
                <c:pt idx="410">
                  <c:v>668.3</c:v>
                </c:pt>
                <c:pt idx="411">
                  <c:v>669.93</c:v>
                </c:pt>
                <c:pt idx="412">
                  <c:v>671.56</c:v>
                </c:pt>
                <c:pt idx="413">
                  <c:v>673.18999999999994</c:v>
                </c:pt>
                <c:pt idx="414">
                  <c:v>674.81999999999948</c:v>
                </c:pt>
                <c:pt idx="415">
                  <c:v>676.44999999999948</c:v>
                </c:pt>
                <c:pt idx="416">
                  <c:v>678.07999999999993</c:v>
                </c:pt>
                <c:pt idx="417">
                  <c:v>679.70999999999992</c:v>
                </c:pt>
                <c:pt idx="418">
                  <c:v>681.33999999999946</c:v>
                </c:pt>
                <c:pt idx="419">
                  <c:v>682.96999999999946</c:v>
                </c:pt>
                <c:pt idx="420">
                  <c:v>684.59999999999991</c:v>
                </c:pt>
                <c:pt idx="421">
                  <c:v>686.2299999999999</c:v>
                </c:pt>
                <c:pt idx="422">
                  <c:v>687.85999999999797</c:v>
                </c:pt>
                <c:pt idx="423">
                  <c:v>689.4899999999999</c:v>
                </c:pt>
                <c:pt idx="424">
                  <c:v>691.11999999999989</c:v>
                </c:pt>
                <c:pt idx="425">
                  <c:v>692.74999999999989</c:v>
                </c:pt>
                <c:pt idx="426">
                  <c:v>694.37999999999988</c:v>
                </c:pt>
                <c:pt idx="427">
                  <c:v>696.00999999999988</c:v>
                </c:pt>
                <c:pt idx="428">
                  <c:v>697.63999999999987</c:v>
                </c:pt>
                <c:pt idx="429">
                  <c:v>699.26999999999987</c:v>
                </c:pt>
                <c:pt idx="430">
                  <c:v>700.89999999999986</c:v>
                </c:pt>
                <c:pt idx="431">
                  <c:v>702.52999999999986</c:v>
                </c:pt>
                <c:pt idx="432">
                  <c:v>704.1599999999994</c:v>
                </c:pt>
                <c:pt idx="433">
                  <c:v>705.78999999999985</c:v>
                </c:pt>
                <c:pt idx="434">
                  <c:v>707.41999999999939</c:v>
                </c:pt>
                <c:pt idx="435">
                  <c:v>709.04999999999939</c:v>
                </c:pt>
                <c:pt idx="436">
                  <c:v>710.67999999999984</c:v>
                </c:pt>
                <c:pt idx="437">
                  <c:v>712.30999999999949</c:v>
                </c:pt>
                <c:pt idx="438">
                  <c:v>713.93999999999949</c:v>
                </c:pt>
                <c:pt idx="439">
                  <c:v>715.56999999999948</c:v>
                </c:pt>
                <c:pt idx="440">
                  <c:v>717.19999999999982</c:v>
                </c:pt>
                <c:pt idx="441">
                  <c:v>718.82999999999947</c:v>
                </c:pt>
                <c:pt idx="442">
                  <c:v>720.45999999999947</c:v>
                </c:pt>
                <c:pt idx="443">
                  <c:v>722.0899999999998</c:v>
                </c:pt>
                <c:pt idx="444">
                  <c:v>723.7199999999998</c:v>
                </c:pt>
                <c:pt idx="445">
                  <c:v>725.34999999999798</c:v>
                </c:pt>
                <c:pt idx="446">
                  <c:v>726.97999999999979</c:v>
                </c:pt>
                <c:pt idx="447">
                  <c:v>728.60999999999979</c:v>
                </c:pt>
                <c:pt idx="448">
                  <c:v>730.23999999999978</c:v>
                </c:pt>
                <c:pt idx="449">
                  <c:v>731.86999999999796</c:v>
                </c:pt>
                <c:pt idx="450">
                  <c:v>733.49999999999977</c:v>
                </c:pt>
                <c:pt idx="451">
                  <c:v>735.12999999999977</c:v>
                </c:pt>
                <c:pt idx="452">
                  <c:v>736.75999999999976</c:v>
                </c:pt>
                <c:pt idx="453">
                  <c:v>738.38999999999976</c:v>
                </c:pt>
                <c:pt idx="454">
                  <c:v>740.01999999999941</c:v>
                </c:pt>
                <c:pt idx="455">
                  <c:v>741.64999999999941</c:v>
                </c:pt>
                <c:pt idx="456">
                  <c:v>743.27999999999975</c:v>
                </c:pt>
                <c:pt idx="457">
                  <c:v>744.9099999999994</c:v>
                </c:pt>
                <c:pt idx="458">
                  <c:v>746.5399999999994</c:v>
                </c:pt>
                <c:pt idx="459">
                  <c:v>748.16999999999939</c:v>
                </c:pt>
                <c:pt idx="460">
                  <c:v>749.79999999999973</c:v>
                </c:pt>
                <c:pt idx="461">
                  <c:v>751.42999999999938</c:v>
                </c:pt>
                <c:pt idx="462">
                  <c:v>753.05999999999949</c:v>
                </c:pt>
                <c:pt idx="463">
                  <c:v>754.68999999999971</c:v>
                </c:pt>
                <c:pt idx="464">
                  <c:v>756.31999999999948</c:v>
                </c:pt>
                <c:pt idx="465">
                  <c:v>757.94999999999948</c:v>
                </c:pt>
                <c:pt idx="466">
                  <c:v>759.5799999999997</c:v>
                </c:pt>
                <c:pt idx="467">
                  <c:v>761.2099999999997</c:v>
                </c:pt>
                <c:pt idx="468">
                  <c:v>762.83999999999946</c:v>
                </c:pt>
                <c:pt idx="469">
                  <c:v>764.46999999999946</c:v>
                </c:pt>
                <c:pt idx="470">
                  <c:v>766.09999999999968</c:v>
                </c:pt>
                <c:pt idx="471">
                  <c:v>767.72999999999968</c:v>
                </c:pt>
                <c:pt idx="472">
                  <c:v>769.35999999999797</c:v>
                </c:pt>
                <c:pt idx="473">
                  <c:v>770.98999999999967</c:v>
                </c:pt>
                <c:pt idx="474">
                  <c:v>772.61999999999966</c:v>
                </c:pt>
                <c:pt idx="475">
                  <c:v>774.24999999999966</c:v>
                </c:pt>
                <c:pt idx="476">
                  <c:v>775.87999999999943</c:v>
                </c:pt>
                <c:pt idx="477">
                  <c:v>777.50999999999942</c:v>
                </c:pt>
                <c:pt idx="478">
                  <c:v>779.13999999999942</c:v>
                </c:pt>
                <c:pt idx="479">
                  <c:v>780.76999999999941</c:v>
                </c:pt>
                <c:pt idx="480">
                  <c:v>782.39999999999941</c:v>
                </c:pt>
                <c:pt idx="481">
                  <c:v>784.0299999999994</c:v>
                </c:pt>
                <c:pt idx="482">
                  <c:v>785.6599999999994</c:v>
                </c:pt>
                <c:pt idx="483">
                  <c:v>787.28999999999962</c:v>
                </c:pt>
                <c:pt idx="484">
                  <c:v>788.91999999999939</c:v>
                </c:pt>
                <c:pt idx="485">
                  <c:v>790.54999999999939</c:v>
                </c:pt>
                <c:pt idx="486">
                  <c:v>792.17999999999961</c:v>
                </c:pt>
                <c:pt idx="487">
                  <c:v>793.80999999999949</c:v>
                </c:pt>
                <c:pt idx="488">
                  <c:v>795.43999999999949</c:v>
                </c:pt>
                <c:pt idx="489">
                  <c:v>797.06999999999948</c:v>
                </c:pt>
                <c:pt idx="490">
                  <c:v>798.69999999999959</c:v>
                </c:pt>
                <c:pt idx="491">
                  <c:v>800.32999999999947</c:v>
                </c:pt>
                <c:pt idx="492">
                  <c:v>801.95999999999947</c:v>
                </c:pt>
                <c:pt idx="493">
                  <c:v>803.58999999999958</c:v>
                </c:pt>
                <c:pt idx="494">
                  <c:v>805.21999999999957</c:v>
                </c:pt>
                <c:pt idx="495">
                  <c:v>806.84999999999798</c:v>
                </c:pt>
                <c:pt idx="496">
                  <c:v>808.47999999999956</c:v>
                </c:pt>
                <c:pt idx="497">
                  <c:v>810.10999999999956</c:v>
                </c:pt>
                <c:pt idx="498">
                  <c:v>811.73999999999944</c:v>
                </c:pt>
                <c:pt idx="499">
                  <c:v>813.36999999999796</c:v>
                </c:pt>
                <c:pt idx="500">
                  <c:v>814.99999999999943</c:v>
                </c:pt>
                <c:pt idx="501">
                  <c:v>816.62999999999943</c:v>
                </c:pt>
                <c:pt idx="502">
                  <c:v>818.25999999999942</c:v>
                </c:pt>
                <c:pt idx="503">
                  <c:v>819.88999999999942</c:v>
                </c:pt>
                <c:pt idx="504">
                  <c:v>821.51999999999941</c:v>
                </c:pt>
                <c:pt idx="505">
                  <c:v>823.14999999999941</c:v>
                </c:pt>
                <c:pt idx="506">
                  <c:v>824.77999999999952</c:v>
                </c:pt>
                <c:pt idx="507">
                  <c:v>826.4099999999994</c:v>
                </c:pt>
                <c:pt idx="508">
                  <c:v>828.0399999999994</c:v>
                </c:pt>
                <c:pt idx="509">
                  <c:v>829.66999999999939</c:v>
                </c:pt>
                <c:pt idx="510">
                  <c:v>831.2999999999995</c:v>
                </c:pt>
                <c:pt idx="511">
                  <c:v>832.92999999999938</c:v>
                </c:pt>
                <c:pt idx="512">
                  <c:v>834.55999999999949</c:v>
                </c:pt>
                <c:pt idx="513">
                  <c:v>836.1899999999996</c:v>
                </c:pt>
                <c:pt idx="514">
                  <c:v>837.81999999999948</c:v>
                </c:pt>
                <c:pt idx="515">
                  <c:v>839.44999999999948</c:v>
                </c:pt>
                <c:pt idx="516">
                  <c:v>841.07999999999959</c:v>
                </c:pt>
                <c:pt idx="517">
                  <c:v>842.70999999999958</c:v>
                </c:pt>
                <c:pt idx="518">
                  <c:v>844.33999999999946</c:v>
                </c:pt>
                <c:pt idx="519">
                  <c:v>845.96999999999946</c:v>
                </c:pt>
                <c:pt idx="520">
                  <c:v>847.59999999999945</c:v>
                </c:pt>
                <c:pt idx="521">
                  <c:v>849.22999999999945</c:v>
                </c:pt>
                <c:pt idx="522">
                  <c:v>850.85999999999797</c:v>
                </c:pt>
                <c:pt idx="523">
                  <c:v>852.48999999999944</c:v>
                </c:pt>
                <c:pt idx="524">
                  <c:v>854.11999999999944</c:v>
                </c:pt>
                <c:pt idx="525">
                  <c:v>855.74999999999943</c:v>
                </c:pt>
                <c:pt idx="526">
                  <c:v>857.37999999999943</c:v>
                </c:pt>
                <c:pt idx="527">
                  <c:v>859.00999999999942</c:v>
                </c:pt>
                <c:pt idx="528">
                  <c:v>860.63999999999942</c:v>
                </c:pt>
                <c:pt idx="529">
                  <c:v>862.26999999999941</c:v>
                </c:pt>
                <c:pt idx="530">
                  <c:v>863.89999999999941</c:v>
                </c:pt>
                <c:pt idx="531">
                  <c:v>865.5299999999994</c:v>
                </c:pt>
                <c:pt idx="532">
                  <c:v>867.1599999999994</c:v>
                </c:pt>
                <c:pt idx="533">
                  <c:v>868.78999999999951</c:v>
                </c:pt>
                <c:pt idx="534">
                  <c:v>870.41999999999939</c:v>
                </c:pt>
                <c:pt idx="535">
                  <c:v>872.04999999999939</c:v>
                </c:pt>
                <c:pt idx="536">
                  <c:v>873.6799999999995</c:v>
                </c:pt>
                <c:pt idx="537">
                  <c:v>875.30999999999938</c:v>
                </c:pt>
                <c:pt idx="538">
                  <c:v>876.93999999999937</c:v>
                </c:pt>
                <c:pt idx="539">
                  <c:v>878.56999999999937</c:v>
                </c:pt>
                <c:pt idx="540">
                  <c:v>880.19999999999959</c:v>
                </c:pt>
                <c:pt idx="541">
                  <c:v>881.82999999999936</c:v>
                </c:pt>
                <c:pt idx="542">
                  <c:v>883.45999999999799</c:v>
                </c:pt>
                <c:pt idx="543">
                  <c:v>885.08999999999935</c:v>
                </c:pt>
                <c:pt idx="544">
                  <c:v>886.71999999999935</c:v>
                </c:pt>
                <c:pt idx="545">
                  <c:v>888.34999999999798</c:v>
                </c:pt>
                <c:pt idx="546">
                  <c:v>889.97999999999934</c:v>
                </c:pt>
                <c:pt idx="547">
                  <c:v>891.60999999999933</c:v>
                </c:pt>
                <c:pt idx="548">
                  <c:v>893.23999999999933</c:v>
                </c:pt>
                <c:pt idx="549">
                  <c:v>894.86999999999796</c:v>
                </c:pt>
                <c:pt idx="550">
                  <c:v>896.49999999999932</c:v>
                </c:pt>
                <c:pt idx="551">
                  <c:v>898.12999999999931</c:v>
                </c:pt>
                <c:pt idx="552">
                  <c:v>899.75999999999931</c:v>
                </c:pt>
                <c:pt idx="553">
                  <c:v>901.3899999999993</c:v>
                </c:pt>
                <c:pt idx="554">
                  <c:v>903.0199999999993</c:v>
                </c:pt>
                <c:pt idx="555">
                  <c:v>904.6499999999993</c:v>
                </c:pt>
                <c:pt idx="556">
                  <c:v>906.27999999999952</c:v>
                </c:pt>
                <c:pt idx="557">
                  <c:v>907.90999999999929</c:v>
                </c:pt>
                <c:pt idx="558">
                  <c:v>909.53999999999928</c:v>
                </c:pt>
                <c:pt idx="559">
                  <c:v>911.16999999999928</c:v>
                </c:pt>
                <c:pt idx="560">
                  <c:v>912.7999999999995</c:v>
                </c:pt>
                <c:pt idx="561">
                  <c:v>914.42999999999927</c:v>
                </c:pt>
                <c:pt idx="562">
                  <c:v>916.05999999999926</c:v>
                </c:pt>
                <c:pt idx="563">
                  <c:v>917.6899999999996</c:v>
                </c:pt>
                <c:pt idx="564">
                  <c:v>919.31999999999846</c:v>
                </c:pt>
                <c:pt idx="565">
                  <c:v>920.94999999999789</c:v>
                </c:pt>
                <c:pt idx="566">
                  <c:v>922.57999999999925</c:v>
                </c:pt>
                <c:pt idx="567">
                  <c:v>924.20999999999924</c:v>
                </c:pt>
                <c:pt idx="568">
                  <c:v>925.83999999999799</c:v>
                </c:pt>
                <c:pt idx="569">
                  <c:v>927.46999999999798</c:v>
                </c:pt>
                <c:pt idx="570">
                  <c:v>929.09999999999923</c:v>
                </c:pt>
                <c:pt idx="571">
                  <c:v>930.72999999999922</c:v>
                </c:pt>
                <c:pt idx="572">
                  <c:v>932.35999999999797</c:v>
                </c:pt>
                <c:pt idx="573">
                  <c:v>933.98999999999921</c:v>
                </c:pt>
                <c:pt idx="574">
                  <c:v>935.61999999999921</c:v>
                </c:pt>
                <c:pt idx="575">
                  <c:v>937.2499999999992</c:v>
                </c:pt>
                <c:pt idx="576">
                  <c:v>938.8799999999992</c:v>
                </c:pt>
                <c:pt idx="577">
                  <c:v>940.5099999999992</c:v>
                </c:pt>
                <c:pt idx="578">
                  <c:v>942.13999999999919</c:v>
                </c:pt>
                <c:pt idx="579">
                  <c:v>943.76999999999919</c:v>
                </c:pt>
                <c:pt idx="580">
                  <c:v>945.39999999999918</c:v>
                </c:pt>
                <c:pt idx="581">
                  <c:v>947.02999999999918</c:v>
                </c:pt>
                <c:pt idx="582">
                  <c:v>948.65999999999917</c:v>
                </c:pt>
                <c:pt idx="583">
                  <c:v>950.28999999999951</c:v>
                </c:pt>
                <c:pt idx="584">
                  <c:v>951.91999999999916</c:v>
                </c:pt>
                <c:pt idx="585">
                  <c:v>953.54999999999916</c:v>
                </c:pt>
                <c:pt idx="586">
                  <c:v>955.17999999999915</c:v>
                </c:pt>
                <c:pt idx="587">
                  <c:v>956.80999999999847</c:v>
                </c:pt>
                <c:pt idx="588">
                  <c:v>958.43999999999846</c:v>
                </c:pt>
                <c:pt idx="589">
                  <c:v>960.06999999999846</c:v>
                </c:pt>
                <c:pt idx="590">
                  <c:v>961.69999999999914</c:v>
                </c:pt>
                <c:pt idx="591">
                  <c:v>963.32999999999799</c:v>
                </c:pt>
                <c:pt idx="592">
                  <c:v>964.95999999999799</c:v>
                </c:pt>
                <c:pt idx="593">
                  <c:v>966.58999999999912</c:v>
                </c:pt>
                <c:pt idx="594">
                  <c:v>968.21999999999912</c:v>
                </c:pt>
                <c:pt idx="595">
                  <c:v>969.84999999999798</c:v>
                </c:pt>
                <c:pt idx="596">
                  <c:v>971.47999999999911</c:v>
                </c:pt>
                <c:pt idx="597">
                  <c:v>973.1099999999991</c:v>
                </c:pt>
                <c:pt idx="598">
                  <c:v>974.7399999999991</c:v>
                </c:pt>
                <c:pt idx="599">
                  <c:v>976.36999999999796</c:v>
                </c:pt>
                <c:pt idx="600">
                  <c:v>977.99999999999909</c:v>
                </c:pt>
                <c:pt idx="601">
                  <c:v>979.62999999999909</c:v>
                </c:pt>
                <c:pt idx="602">
                  <c:v>981.25999999999908</c:v>
                </c:pt>
                <c:pt idx="603">
                  <c:v>982.88999999999908</c:v>
                </c:pt>
                <c:pt idx="604">
                  <c:v>984.51999999999907</c:v>
                </c:pt>
                <c:pt idx="605">
                  <c:v>986.14999999999907</c:v>
                </c:pt>
                <c:pt idx="606">
                  <c:v>987.77999999999952</c:v>
                </c:pt>
                <c:pt idx="607">
                  <c:v>989.40999999999906</c:v>
                </c:pt>
                <c:pt idx="608">
                  <c:v>991.03999999999849</c:v>
                </c:pt>
                <c:pt idx="609">
                  <c:v>992.66999999999848</c:v>
                </c:pt>
                <c:pt idx="610">
                  <c:v>994.29999999999905</c:v>
                </c:pt>
                <c:pt idx="611">
                  <c:v>995.92999999999847</c:v>
                </c:pt>
                <c:pt idx="612">
                  <c:v>997.55999999999847</c:v>
                </c:pt>
                <c:pt idx="613">
                  <c:v>999.18999999999903</c:v>
                </c:pt>
                <c:pt idx="614">
                  <c:v>1000.8199999999979</c:v>
                </c:pt>
                <c:pt idx="615">
                  <c:v>1002.4499999999979</c:v>
                </c:pt>
                <c:pt idx="616">
                  <c:v>1004.079999999999</c:v>
                </c:pt>
                <c:pt idx="617">
                  <c:v>1005.709999999999</c:v>
                </c:pt>
                <c:pt idx="618">
                  <c:v>1007.3399999999979</c:v>
                </c:pt>
                <c:pt idx="619">
                  <c:v>1008.9699999999979</c:v>
                </c:pt>
                <c:pt idx="620">
                  <c:v>1010.599999999999</c:v>
                </c:pt>
                <c:pt idx="621">
                  <c:v>1012.229999999999</c:v>
                </c:pt>
                <c:pt idx="622">
                  <c:v>1013.8599999999979</c:v>
                </c:pt>
                <c:pt idx="623">
                  <c:v>1015.489999999999</c:v>
                </c:pt>
                <c:pt idx="624">
                  <c:v>1017.119999999999</c:v>
                </c:pt>
                <c:pt idx="625">
                  <c:v>1018.749999999999</c:v>
                </c:pt>
                <c:pt idx="626">
                  <c:v>1020.379999999999</c:v>
                </c:pt>
                <c:pt idx="627">
                  <c:v>1022.009999999999</c:v>
                </c:pt>
                <c:pt idx="628">
                  <c:v>1023.639999999999</c:v>
                </c:pt>
                <c:pt idx="629">
                  <c:v>1025.2699999999991</c:v>
                </c:pt>
                <c:pt idx="630">
                  <c:v>1026.8999999999992</c:v>
                </c:pt>
                <c:pt idx="631">
                  <c:v>1028.5299999999993</c:v>
                </c:pt>
                <c:pt idx="632">
                  <c:v>1030.1599999999994</c:v>
                </c:pt>
                <c:pt idx="633">
                  <c:v>1031.7899999999995</c:v>
                </c:pt>
                <c:pt idx="634">
                  <c:v>1033.42</c:v>
                </c:pt>
                <c:pt idx="635">
                  <c:v>1035.0499999999997</c:v>
                </c:pt>
                <c:pt idx="636">
                  <c:v>1036.6799999999998</c:v>
                </c:pt>
                <c:pt idx="637">
                  <c:v>1038.31</c:v>
                </c:pt>
                <c:pt idx="638">
                  <c:v>1039.94</c:v>
                </c:pt>
                <c:pt idx="639">
                  <c:v>1041.5700000000002</c:v>
                </c:pt>
                <c:pt idx="640">
                  <c:v>1043.2000000000003</c:v>
                </c:pt>
                <c:pt idx="641">
                  <c:v>1044.8300000000004</c:v>
                </c:pt>
                <c:pt idx="642">
                  <c:v>1046.4600000000005</c:v>
                </c:pt>
                <c:pt idx="643">
                  <c:v>1048.0900000000006</c:v>
                </c:pt>
                <c:pt idx="644">
                  <c:v>1049.7200000000007</c:v>
                </c:pt>
                <c:pt idx="645">
                  <c:v>1051.3500000000008</c:v>
                </c:pt>
                <c:pt idx="646">
                  <c:v>1052.9800000000009</c:v>
                </c:pt>
                <c:pt idx="647">
                  <c:v>1054.6100000000008</c:v>
                </c:pt>
                <c:pt idx="648">
                  <c:v>1056.2400000000009</c:v>
                </c:pt>
                <c:pt idx="649">
                  <c:v>1057.8700000000008</c:v>
                </c:pt>
                <c:pt idx="650">
                  <c:v>1059.5000000000014</c:v>
                </c:pt>
                <c:pt idx="651">
                  <c:v>1061.1300000000008</c:v>
                </c:pt>
                <c:pt idx="652">
                  <c:v>1062.7600000000016</c:v>
                </c:pt>
                <c:pt idx="653">
                  <c:v>1064.3900000000008</c:v>
                </c:pt>
                <c:pt idx="654">
                  <c:v>1066.0200000000018</c:v>
                </c:pt>
                <c:pt idx="655">
                  <c:v>1067.6500000000008</c:v>
                </c:pt>
                <c:pt idx="656">
                  <c:v>1069.280000000002</c:v>
                </c:pt>
                <c:pt idx="657">
                  <c:v>1070.9100000000021</c:v>
                </c:pt>
                <c:pt idx="658">
                  <c:v>1072.5400000000022</c:v>
                </c:pt>
                <c:pt idx="659">
                  <c:v>1074.1700000000008</c:v>
                </c:pt>
                <c:pt idx="660">
                  <c:v>1075.8000000000025</c:v>
                </c:pt>
                <c:pt idx="661">
                  <c:v>1077.430000000003</c:v>
                </c:pt>
                <c:pt idx="662">
                  <c:v>1079.0600000000027</c:v>
                </c:pt>
                <c:pt idx="663">
                  <c:v>1080.6900000000028</c:v>
                </c:pt>
                <c:pt idx="664">
                  <c:v>1082.3200000000029</c:v>
                </c:pt>
                <c:pt idx="665">
                  <c:v>1083.950000000003</c:v>
                </c:pt>
                <c:pt idx="666">
                  <c:v>1085.5800000000029</c:v>
                </c:pt>
                <c:pt idx="667">
                  <c:v>1087.2100000000032</c:v>
                </c:pt>
                <c:pt idx="668">
                  <c:v>1088.8400000000029</c:v>
                </c:pt>
                <c:pt idx="669">
                  <c:v>1090.4700000000034</c:v>
                </c:pt>
                <c:pt idx="670">
                  <c:v>1092.1000000000029</c:v>
                </c:pt>
                <c:pt idx="671">
                  <c:v>1093.7300000000037</c:v>
                </c:pt>
                <c:pt idx="672">
                  <c:v>1095.3600000000038</c:v>
                </c:pt>
                <c:pt idx="673">
                  <c:v>1096.9900000000039</c:v>
                </c:pt>
                <c:pt idx="674">
                  <c:v>1098.620000000004</c:v>
                </c:pt>
                <c:pt idx="675">
                  <c:v>1100.2500000000041</c:v>
                </c:pt>
                <c:pt idx="676">
                  <c:v>1101.8800000000042</c:v>
                </c:pt>
                <c:pt idx="677">
                  <c:v>1103.5100000000043</c:v>
                </c:pt>
                <c:pt idx="678">
                  <c:v>1105.1400000000044</c:v>
                </c:pt>
                <c:pt idx="679">
                  <c:v>1106.7700000000045</c:v>
                </c:pt>
                <c:pt idx="680">
                  <c:v>1108.4000000000051</c:v>
                </c:pt>
                <c:pt idx="681">
                  <c:v>1110.0300000000047</c:v>
                </c:pt>
                <c:pt idx="682">
                  <c:v>1111.6600000000049</c:v>
                </c:pt>
                <c:pt idx="683">
                  <c:v>1113.290000000005</c:v>
                </c:pt>
                <c:pt idx="684">
                  <c:v>1114.9200000000051</c:v>
                </c:pt>
                <c:pt idx="685">
                  <c:v>1116.5500000000052</c:v>
                </c:pt>
                <c:pt idx="686">
                  <c:v>1118.1800000000048</c:v>
                </c:pt>
                <c:pt idx="687">
                  <c:v>1119.8100000000054</c:v>
                </c:pt>
                <c:pt idx="688">
                  <c:v>1121.4400000000055</c:v>
                </c:pt>
                <c:pt idx="689">
                  <c:v>1123.0700000000056</c:v>
                </c:pt>
                <c:pt idx="690">
                  <c:v>1124.7000000000057</c:v>
                </c:pt>
                <c:pt idx="691">
                  <c:v>1126.3300000000058</c:v>
                </c:pt>
                <c:pt idx="692">
                  <c:v>1127.9600000000059</c:v>
                </c:pt>
                <c:pt idx="693">
                  <c:v>1129.5900000000058</c:v>
                </c:pt>
                <c:pt idx="694">
                  <c:v>1131.2200000000062</c:v>
                </c:pt>
                <c:pt idx="695">
                  <c:v>1132.8500000000058</c:v>
                </c:pt>
                <c:pt idx="696">
                  <c:v>1134.4800000000064</c:v>
                </c:pt>
                <c:pt idx="697">
                  <c:v>1136.1100000000058</c:v>
                </c:pt>
                <c:pt idx="698">
                  <c:v>1137.7400000000066</c:v>
                </c:pt>
                <c:pt idx="699">
                  <c:v>1139.3700000000058</c:v>
                </c:pt>
                <c:pt idx="700">
                  <c:v>1141.0000000000068</c:v>
                </c:pt>
                <c:pt idx="701">
                  <c:v>1142.6300000000058</c:v>
                </c:pt>
                <c:pt idx="702">
                  <c:v>1144.260000000007</c:v>
                </c:pt>
                <c:pt idx="703">
                  <c:v>1145.8900000000058</c:v>
                </c:pt>
                <c:pt idx="704">
                  <c:v>1147.5200000000073</c:v>
                </c:pt>
                <c:pt idx="705">
                  <c:v>1149.1500000000074</c:v>
                </c:pt>
                <c:pt idx="706">
                  <c:v>1150.7800000000075</c:v>
                </c:pt>
                <c:pt idx="707">
                  <c:v>1152.410000000008</c:v>
                </c:pt>
                <c:pt idx="708">
                  <c:v>1154.0400000000077</c:v>
                </c:pt>
                <c:pt idx="709">
                  <c:v>1155.6700000000078</c:v>
                </c:pt>
                <c:pt idx="710">
                  <c:v>1157.3000000000079</c:v>
                </c:pt>
                <c:pt idx="711">
                  <c:v>1158.930000000008</c:v>
                </c:pt>
                <c:pt idx="712">
                  <c:v>1160.5600000000079</c:v>
                </c:pt>
                <c:pt idx="713">
                  <c:v>1162.1900000000078</c:v>
                </c:pt>
                <c:pt idx="714">
                  <c:v>1163.8200000000079</c:v>
                </c:pt>
                <c:pt idx="715">
                  <c:v>1165.4500000000085</c:v>
                </c:pt>
                <c:pt idx="716">
                  <c:v>1167.0800000000086</c:v>
                </c:pt>
                <c:pt idx="717">
                  <c:v>1168.7100000000087</c:v>
                </c:pt>
                <c:pt idx="718">
                  <c:v>1170.3400000000088</c:v>
                </c:pt>
                <c:pt idx="719">
                  <c:v>1171.9700000000089</c:v>
                </c:pt>
                <c:pt idx="720">
                  <c:v>1173.600000000009</c:v>
                </c:pt>
                <c:pt idx="721">
                  <c:v>1175.2300000000091</c:v>
                </c:pt>
                <c:pt idx="722">
                  <c:v>1176.8600000000092</c:v>
                </c:pt>
                <c:pt idx="723">
                  <c:v>1178.4900000000093</c:v>
                </c:pt>
                <c:pt idx="724">
                  <c:v>1180.1200000000094</c:v>
                </c:pt>
                <c:pt idx="725">
                  <c:v>1181.7500000000095</c:v>
                </c:pt>
                <c:pt idx="726">
                  <c:v>1183.3800000000097</c:v>
                </c:pt>
                <c:pt idx="727">
                  <c:v>1185.01000000001</c:v>
                </c:pt>
                <c:pt idx="728">
                  <c:v>1186.6400000000099</c:v>
                </c:pt>
                <c:pt idx="729">
                  <c:v>1188.27000000001</c:v>
                </c:pt>
                <c:pt idx="730">
                  <c:v>1189.9000000000101</c:v>
                </c:pt>
                <c:pt idx="731">
                  <c:v>1191.5300000000102</c:v>
                </c:pt>
                <c:pt idx="732">
                  <c:v>1193.1600000000099</c:v>
                </c:pt>
                <c:pt idx="733">
                  <c:v>1194.7900000000104</c:v>
                </c:pt>
                <c:pt idx="734">
                  <c:v>1196.4200000000105</c:v>
                </c:pt>
                <c:pt idx="735">
                  <c:v>1198.0500000000106</c:v>
                </c:pt>
                <c:pt idx="736">
                  <c:v>1199.6800000000108</c:v>
                </c:pt>
                <c:pt idx="737">
                  <c:v>1201.3100000000109</c:v>
                </c:pt>
                <c:pt idx="738">
                  <c:v>1202.940000000011</c:v>
                </c:pt>
                <c:pt idx="739">
                  <c:v>1204.5700000000109</c:v>
                </c:pt>
                <c:pt idx="740">
                  <c:v>1206.2000000000112</c:v>
                </c:pt>
                <c:pt idx="741">
                  <c:v>1207.8300000000108</c:v>
                </c:pt>
                <c:pt idx="742">
                  <c:v>1209.4600000000114</c:v>
                </c:pt>
                <c:pt idx="743">
                  <c:v>1211.0900000000108</c:v>
                </c:pt>
                <c:pt idx="744">
                  <c:v>1212.7200000000116</c:v>
                </c:pt>
                <c:pt idx="745">
                  <c:v>1214.3500000000108</c:v>
                </c:pt>
                <c:pt idx="746">
                  <c:v>1215.9800000000118</c:v>
                </c:pt>
                <c:pt idx="747">
                  <c:v>1217.610000000012</c:v>
                </c:pt>
                <c:pt idx="748">
                  <c:v>1219.2400000000121</c:v>
                </c:pt>
                <c:pt idx="749">
                  <c:v>1220.8700000000122</c:v>
                </c:pt>
                <c:pt idx="750">
                  <c:v>1222.5000000000123</c:v>
                </c:pt>
                <c:pt idx="751">
                  <c:v>1224.1300000000124</c:v>
                </c:pt>
                <c:pt idx="752">
                  <c:v>1225.7600000000125</c:v>
                </c:pt>
                <c:pt idx="753">
                  <c:v>1227.3900000000126</c:v>
                </c:pt>
                <c:pt idx="754">
                  <c:v>1229.0200000000127</c:v>
                </c:pt>
                <c:pt idx="755">
                  <c:v>1230.6500000000128</c:v>
                </c:pt>
                <c:pt idx="756">
                  <c:v>1232.2800000000129</c:v>
                </c:pt>
                <c:pt idx="757">
                  <c:v>1233.910000000013</c:v>
                </c:pt>
                <c:pt idx="758">
                  <c:v>1235.5400000000132</c:v>
                </c:pt>
                <c:pt idx="759">
                  <c:v>1237.1700000000128</c:v>
                </c:pt>
                <c:pt idx="760">
                  <c:v>1238.8000000000134</c:v>
                </c:pt>
                <c:pt idx="761">
                  <c:v>1240.4300000000135</c:v>
                </c:pt>
                <c:pt idx="762">
                  <c:v>1242.0600000000136</c:v>
                </c:pt>
                <c:pt idx="763">
                  <c:v>1243.6900000000128</c:v>
                </c:pt>
                <c:pt idx="764">
                  <c:v>1245.3200000000138</c:v>
                </c:pt>
                <c:pt idx="765">
                  <c:v>1246.9500000000139</c:v>
                </c:pt>
                <c:pt idx="766">
                  <c:v>1248.580000000014</c:v>
                </c:pt>
                <c:pt idx="767">
                  <c:v>1250.2100000000141</c:v>
                </c:pt>
                <c:pt idx="768">
                  <c:v>1251.8400000000142</c:v>
                </c:pt>
                <c:pt idx="769">
                  <c:v>1253.470000000015</c:v>
                </c:pt>
                <c:pt idx="770">
                  <c:v>1255.1000000000145</c:v>
                </c:pt>
                <c:pt idx="771">
                  <c:v>1256.730000000015</c:v>
                </c:pt>
                <c:pt idx="772">
                  <c:v>1258.3600000000147</c:v>
                </c:pt>
                <c:pt idx="773">
                  <c:v>1259.990000000015</c:v>
                </c:pt>
                <c:pt idx="774">
                  <c:v>1261.6200000000149</c:v>
                </c:pt>
                <c:pt idx="775">
                  <c:v>1263.250000000015</c:v>
                </c:pt>
                <c:pt idx="776">
                  <c:v>1264.8800000000149</c:v>
                </c:pt>
                <c:pt idx="777">
                  <c:v>1266.5100000000152</c:v>
                </c:pt>
                <c:pt idx="778">
                  <c:v>1268.1400000000149</c:v>
                </c:pt>
                <c:pt idx="779">
                  <c:v>1269.7700000000154</c:v>
                </c:pt>
                <c:pt idx="780">
                  <c:v>1271.400000000016</c:v>
                </c:pt>
                <c:pt idx="781">
                  <c:v>1273.0300000000157</c:v>
                </c:pt>
                <c:pt idx="782">
                  <c:v>1274.6600000000158</c:v>
                </c:pt>
                <c:pt idx="783">
                  <c:v>1276.2900000000159</c:v>
                </c:pt>
                <c:pt idx="784">
                  <c:v>1277.920000000016</c:v>
                </c:pt>
                <c:pt idx="785">
                  <c:v>1279.5500000000159</c:v>
                </c:pt>
                <c:pt idx="786">
                  <c:v>1281.1800000000158</c:v>
                </c:pt>
                <c:pt idx="787">
                  <c:v>1282.8100000000159</c:v>
                </c:pt>
                <c:pt idx="788">
                  <c:v>1284.4400000000164</c:v>
                </c:pt>
                <c:pt idx="789">
                  <c:v>1286.0700000000159</c:v>
                </c:pt>
                <c:pt idx="790">
                  <c:v>1287.7000000000166</c:v>
                </c:pt>
                <c:pt idx="791">
                  <c:v>1289.3300000000168</c:v>
                </c:pt>
                <c:pt idx="792">
                  <c:v>1290.9600000000169</c:v>
                </c:pt>
                <c:pt idx="793">
                  <c:v>1292.590000000017</c:v>
                </c:pt>
                <c:pt idx="794">
                  <c:v>1294.2200000000171</c:v>
                </c:pt>
                <c:pt idx="795">
                  <c:v>1295.8500000000172</c:v>
                </c:pt>
                <c:pt idx="796">
                  <c:v>1297.4800000000173</c:v>
                </c:pt>
                <c:pt idx="797">
                  <c:v>1299.1100000000174</c:v>
                </c:pt>
                <c:pt idx="798">
                  <c:v>1300.7400000000175</c:v>
                </c:pt>
                <c:pt idx="799">
                  <c:v>1302.3700000000176</c:v>
                </c:pt>
                <c:pt idx="800">
                  <c:v>1304.0000000000177</c:v>
                </c:pt>
                <c:pt idx="801">
                  <c:v>1305.6300000000178</c:v>
                </c:pt>
                <c:pt idx="802">
                  <c:v>1307.260000000018</c:v>
                </c:pt>
                <c:pt idx="803">
                  <c:v>1308.8900000000178</c:v>
                </c:pt>
                <c:pt idx="804">
                  <c:v>1310.5200000000182</c:v>
                </c:pt>
                <c:pt idx="805">
                  <c:v>1312.1500000000178</c:v>
                </c:pt>
                <c:pt idx="806">
                  <c:v>1313.7800000000184</c:v>
                </c:pt>
                <c:pt idx="807">
                  <c:v>1315.4100000000185</c:v>
                </c:pt>
                <c:pt idx="808">
                  <c:v>1317.0400000000186</c:v>
                </c:pt>
                <c:pt idx="809">
                  <c:v>1318.6700000000178</c:v>
                </c:pt>
                <c:pt idx="810">
                  <c:v>1320.3000000000188</c:v>
                </c:pt>
                <c:pt idx="811">
                  <c:v>1321.9300000000189</c:v>
                </c:pt>
                <c:pt idx="812">
                  <c:v>1323.560000000019</c:v>
                </c:pt>
                <c:pt idx="813">
                  <c:v>1325.1900000000192</c:v>
                </c:pt>
                <c:pt idx="814">
                  <c:v>1326.8200000000193</c:v>
                </c:pt>
                <c:pt idx="815">
                  <c:v>1328.4500000000201</c:v>
                </c:pt>
                <c:pt idx="816">
                  <c:v>1330.0800000000195</c:v>
                </c:pt>
                <c:pt idx="817">
                  <c:v>1331.71000000002</c:v>
                </c:pt>
                <c:pt idx="818">
                  <c:v>1333.3400000000197</c:v>
                </c:pt>
                <c:pt idx="819">
                  <c:v>1334.97000000002</c:v>
                </c:pt>
                <c:pt idx="820">
                  <c:v>1336.6000000000199</c:v>
                </c:pt>
                <c:pt idx="821">
                  <c:v>1338.23000000002</c:v>
                </c:pt>
                <c:pt idx="822">
                  <c:v>1339.8600000000199</c:v>
                </c:pt>
                <c:pt idx="823">
                  <c:v>1341.4900000000202</c:v>
                </c:pt>
                <c:pt idx="824">
                  <c:v>1343.1200000000204</c:v>
                </c:pt>
                <c:pt idx="825">
                  <c:v>1344.7500000000205</c:v>
                </c:pt>
                <c:pt idx="826">
                  <c:v>1346.3800000000206</c:v>
                </c:pt>
                <c:pt idx="827">
                  <c:v>1348.0100000000207</c:v>
                </c:pt>
                <c:pt idx="828">
                  <c:v>1349.6400000000208</c:v>
                </c:pt>
                <c:pt idx="829">
                  <c:v>1351.2700000000209</c:v>
                </c:pt>
                <c:pt idx="830">
                  <c:v>1352.900000000021</c:v>
                </c:pt>
                <c:pt idx="831">
                  <c:v>1354.5300000000209</c:v>
                </c:pt>
                <c:pt idx="832">
                  <c:v>1356.1600000000208</c:v>
                </c:pt>
                <c:pt idx="833">
                  <c:v>1357.7900000000209</c:v>
                </c:pt>
                <c:pt idx="834">
                  <c:v>1359.4200000000214</c:v>
                </c:pt>
                <c:pt idx="835">
                  <c:v>1361.0500000000216</c:v>
                </c:pt>
                <c:pt idx="836">
                  <c:v>1362.6800000000208</c:v>
                </c:pt>
                <c:pt idx="837">
                  <c:v>1364.3100000000218</c:v>
                </c:pt>
                <c:pt idx="838">
                  <c:v>1365.9400000000219</c:v>
                </c:pt>
                <c:pt idx="839">
                  <c:v>1367.570000000022</c:v>
                </c:pt>
                <c:pt idx="840">
                  <c:v>1369.2000000000221</c:v>
                </c:pt>
                <c:pt idx="841">
                  <c:v>1370.8300000000222</c:v>
                </c:pt>
                <c:pt idx="842">
                  <c:v>1372.4600000000223</c:v>
                </c:pt>
                <c:pt idx="843">
                  <c:v>1374.0900000000224</c:v>
                </c:pt>
                <c:pt idx="844">
                  <c:v>1375.7200000000225</c:v>
                </c:pt>
                <c:pt idx="845">
                  <c:v>1377.3500000000226</c:v>
                </c:pt>
                <c:pt idx="846">
                  <c:v>1378.980000000023</c:v>
                </c:pt>
                <c:pt idx="847">
                  <c:v>1380.6100000000229</c:v>
                </c:pt>
                <c:pt idx="848">
                  <c:v>1382.240000000023</c:v>
                </c:pt>
                <c:pt idx="849">
                  <c:v>1383.8700000000229</c:v>
                </c:pt>
                <c:pt idx="850">
                  <c:v>1385.5000000000232</c:v>
                </c:pt>
                <c:pt idx="851">
                  <c:v>1387.1300000000228</c:v>
                </c:pt>
                <c:pt idx="852">
                  <c:v>1388.7600000000234</c:v>
                </c:pt>
                <c:pt idx="853">
                  <c:v>1390.3900000000228</c:v>
                </c:pt>
                <c:pt idx="854">
                  <c:v>1392.0200000000236</c:v>
                </c:pt>
                <c:pt idx="855">
                  <c:v>1393.6500000000228</c:v>
                </c:pt>
                <c:pt idx="856">
                  <c:v>1395.2800000000238</c:v>
                </c:pt>
                <c:pt idx="857">
                  <c:v>1396.9100000000251</c:v>
                </c:pt>
                <c:pt idx="858">
                  <c:v>1398.5400000000241</c:v>
                </c:pt>
                <c:pt idx="859">
                  <c:v>1400.1700000000242</c:v>
                </c:pt>
                <c:pt idx="860">
                  <c:v>1401.8000000000243</c:v>
                </c:pt>
                <c:pt idx="861">
                  <c:v>1403.4300000000251</c:v>
                </c:pt>
                <c:pt idx="862">
                  <c:v>1405.0600000000245</c:v>
                </c:pt>
                <c:pt idx="863">
                  <c:v>1406.6900000000246</c:v>
                </c:pt>
                <c:pt idx="864">
                  <c:v>1408.3200000000247</c:v>
                </c:pt>
                <c:pt idx="865">
                  <c:v>1409.9500000000251</c:v>
                </c:pt>
                <c:pt idx="866">
                  <c:v>1411.5800000000249</c:v>
                </c:pt>
                <c:pt idx="867">
                  <c:v>1413.210000000025</c:v>
                </c:pt>
                <c:pt idx="868">
                  <c:v>1414.8400000000252</c:v>
                </c:pt>
                <c:pt idx="869">
                  <c:v>1416.4700000000253</c:v>
                </c:pt>
                <c:pt idx="870">
                  <c:v>1418.1000000000254</c:v>
                </c:pt>
                <c:pt idx="871">
                  <c:v>1419.7300000000255</c:v>
                </c:pt>
                <c:pt idx="872">
                  <c:v>1421.3600000000256</c:v>
                </c:pt>
                <c:pt idx="873">
                  <c:v>1422.9900000000257</c:v>
                </c:pt>
                <c:pt idx="874">
                  <c:v>1424.6200000000258</c:v>
                </c:pt>
                <c:pt idx="875">
                  <c:v>1426.2500000000259</c:v>
                </c:pt>
                <c:pt idx="876">
                  <c:v>1427.8800000000258</c:v>
                </c:pt>
                <c:pt idx="877">
                  <c:v>1429.5100000000259</c:v>
                </c:pt>
                <c:pt idx="878">
                  <c:v>1431.1400000000258</c:v>
                </c:pt>
                <c:pt idx="879">
                  <c:v>1432.7700000000264</c:v>
                </c:pt>
                <c:pt idx="880">
                  <c:v>1434.4000000000265</c:v>
                </c:pt>
                <c:pt idx="881">
                  <c:v>1436.0300000000266</c:v>
                </c:pt>
                <c:pt idx="882">
                  <c:v>1437.6600000000258</c:v>
                </c:pt>
                <c:pt idx="883">
                  <c:v>1439.2900000000268</c:v>
                </c:pt>
                <c:pt idx="884">
                  <c:v>1440.9200000000269</c:v>
                </c:pt>
                <c:pt idx="885">
                  <c:v>1442.550000000027</c:v>
                </c:pt>
                <c:pt idx="886">
                  <c:v>1444.1800000000258</c:v>
                </c:pt>
                <c:pt idx="887">
                  <c:v>1445.8100000000272</c:v>
                </c:pt>
                <c:pt idx="888">
                  <c:v>1447.4400000000273</c:v>
                </c:pt>
                <c:pt idx="889">
                  <c:v>1449.0700000000274</c:v>
                </c:pt>
                <c:pt idx="890">
                  <c:v>1450.700000000028</c:v>
                </c:pt>
                <c:pt idx="891">
                  <c:v>1452.3300000000277</c:v>
                </c:pt>
                <c:pt idx="892">
                  <c:v>1453.960000000028</c:v>
                </c:pt>
                <c:pt idx="893">
                  <c:v>1455.5900000000279</c:v>
                </c:pt>
                <c:pt idx="894">
                  <c:v>1457.220000000028</c:v>
                </c:pt>
                <c:pt idx="895">
                  <c:v>1458.8500000000279</c:v>
                </c:pt>
                <c:pt idx="896">
                  <c:v>1460.4800000000282</c:v>
                </c:pt>
                <c:pt idx="897">
                  <c:v>1462.1100000000279</c:v>
                </c:pt>
                <c:pt idx="898">
                  <c:v>1463.7400000000284</c:v>
                </c:pt>
                <c:pt idx="899">
                  <c:v>1465.3700000000279</c:v>
                </c:pt>
                <c:pt idx="900">
                  <c:v>1467.0000000000286</c:v>
                </c:pt>
                <c:pt idx="901">
                  <c:v>1468.6300000000288</c:v>
                </c:pt>
                <c:pt idx="902">
                  <c:v>1470.2600000000289</c:v>
                </c:pt>
                <c:pt idx="903">
                  <c:v>1471.890000000029</c:v>
                </c:pt>
                <c:pt idx="904">
                  <c:v>1473.5200000000291</c:v>
                </c:pt>
                <c:pt idx="905">
                  <c:v>1475.1500000000292</c:v>
                </c:pt>
                <c:pt idx="906">
                  <c:v>1476.7800000000293</c:v>
                </c:pt>
                <c:pt idx="907">
                  <c:v>1478.4100000000301</c:v>
                </c:pt>
                <c:pt idx="908">
                  <c:v>1480.0400000000295</c:v>
                </c:pt>
                <c:pt idx="909">
                  <c:v>1481.6700000000296</c:v>
                </c:pt>
                <c:pt idx="910">
                  <c:v>1483.3000000000297</c:v>
                </c:pt>
                <c:pt idx="911">
                  <c:v>1484.9300000000301</c:v>
                </c:pt>
                <c:pt idx="912">
                  <c:v>1486.56000000003</c:v>
                </c:pt>
                <c:pt idx="913">
                  <c:v>1488.1900000000298</c:v>
                </c:pt>
                <c:pt idx="914">
                  <c:v>1489.8200000000302</c:v>
                </c:pt>
                <c:pt idx="915">
                  <c:v>1491.4500000000303</c:v>
                </c:pt>
                <c:pt idx="916">
                  <c:v>1493.0800000000304</c:v>
                </c:pt>
                <c:pt idx="917">
                  <c:v>1494.7100000000305</c:v>
                </c:pt>
                <c:pt idx="918">
                  <c:v>1496.3400000000306</c:v>
                </c:pt>
                <c:pt idx="919">
                  <c:v>1497.9700000000307</c:v>
                </c:pt>
                <c:pt idx="920">
                  <c:v>1499.6000000000308</c:v>
                </c:pt>
                <c:pt idx="921">
                  <c:v>1501.2300000000309</c:v>
                </c:pt>
                <c:pt idx="922">
                  <c:v>1502.8600000000308</c:v>
                </c:pt>
                <c:pt idx="923">
                  <c:v>1504.4900000000312</c:v>
                </c:pt>
                <c:pt idx="924">
                  <c:v>1506.1200000000308</c:v>
                </c:pt>
                <c:pt idx="925">
                  <c:v>1507.7500000000314</c:v>
                </c:pt>
                <c:pt idx="926">
                  <c:v>1509.3800000000308</c:v>
                </c:pt>
                <c:pt idx="927">
                  <c:v>1511.0100000000316</c:v>
                </c:pt>
                <c:pt idx="928">
                  <c:v>1512.6400000000308</c:v>
                </c:pt>
                <c:pt idx="929">
                  <c:v>1514.2700000000318</c:v>
                </c:pt>
                <c:pt idx="930">
                  <c:v>1515.9000000000319</c:v>
                </c:pt>
                <c:pt idx="931">
                  <c:v>1517.530000000032</c:v>
                </c:pt>
                <c:pt idx="932">
                  <c:v>1519.1600000000308</c:v>
                </c:pt>
                <c:pt idx="933">
                  <c:v>1520.7900000000323</c:v>
                </c:pt>
                <c:pt idx="934">
                  <c:v>1522.420000000033</c:v>
                </c:pt>
                <c:pt idx="935">
                  <c:v>1524.0500000000325</c:v>
                </c:pt>
                <c:pt idx="936">
                  <c:v>1525.6800000000326</c:v>
                </c:pt>
                <c:pt idx="937">
                  <c:v>1527.3100000000327</c:v>
                </c:pt>
                <c:pt idx="938">
                  <c:v>1528.940000000033</c:v>
                </c:pt>
                <c:pt idx="939">
                  <c:v>1530.5700000000329</c:v>
                </c:pt>
                <c:pt idx="940">
                  <c:v>1532.200000000033</c:v>
                </c:pt>
                <c:pt idx="941">
                  <c:v>1533.8300000000329</c:v>
                </c:pt>
                <c:pt idx="942">
                  <c:v>1535.4600000000332</c:v>
                </c:pt>
                <c:pt idx="943">
                  <c:v>1537.0900000000329</c:v>
                </c:pt>
                <c:pt idx="944">
                  <c:v>1538.7200000000335</c:v>
                </c:pt>
                <c:pt idx="945">
                  <c:v>1540.3500000000336</c:v>
                </c:pt>
                <c:pt idx="946">
                  <c:v>1541.9800000000337</c:v>
                </c:pt>
                <c:pt idx="947">
                  <c:v>1543.6100000000338</c:v>
                </c:pt>
                <c:pt idx="948">
                  <c:v>1545.2400000000339</c:v>
                </c:pt>
                <c:pt idx="949">
                  <c:v>1546.870000000034</c:v>
                </c:pt>
                <c:pt idx="950">
                  <c:v>1548.5000000000341</c:v>
                </c:pt>
                <c:pt idx="951">
                  <c:v>1550.1300000000342</c:v>
                </c:pt>
                <c:pt idx="952">
                  <c:v>1551.7600000000343</c:v>
                </c:pt>
                <c:pt idx="953">
                  <c:v>1553.3900000000344</c:v>
                </c:pt>
                <c:pt idx="954">
                  <c:v>1555.0200000000345</c:v>
                </c:pt>
                <c:pt idx="955">
                  <c:v>1556.6500000000347</c:v>
                </c:pt>
                <c:pt idx="956">
                  <c:v>1558.280000000035</c:v>
                </c:pt>
                <c:pt idx="957">
                  <c:v>1559.9100000000351</c:v>
                </c:pt>
                <c:pt idx="958">
                  <c:v>1561.540000000035</c:v>
                </c:pt>
                <c:pt idx="959">
                  <c:v>1563.1700000000349</c:v>
                </c:pt>
                <c:pt idx="960">
                  <c:v>1564.8000000000352</c:v>
                </c:pt>
                <c:pt idx="961">
                  <c:v>1566.4300000000353</c:v>
                </c:pt>
                <c:pt idx="962">
                  <c:v>1568.0600000000354</c:v>
                </c:pt>
                <c:pt idx="963">
                  <c:v>1569.6900000000348</c:v>
                </c:pt>
                <c:pt idx="964">
                  <c:v>1571.3200000000356</c:v>
                </c:pt>
                <c:pt idx="965">
                  <c:v>1572.9500000000357</c:v>
                </c:pt>
                <c:pt idx="966">
                  <c:v>1574.5800000000359</c:v>
                </c:pt>
                <c:pt idx="967">
                  <c:v>1576.210000000036</c:v>
                </c:pt>
                <c:pt idx="968">
                  <c:v>1577.8400000000358</c:v>
                </c:pt>
                <c:pt idx="969">
                  <c:v>1579.4700000000362</c:v>
                </c:pt>
                <c:pt idx="970">
                  <c:v>1581.1000000000358</c:v>
                </c:pt>
                <c:pt idx="971">
                  <c:v>1582.7300000000364</c:v>
                </c:pt>
                <c:pt idx="972">
                  <c:v>1584.3600000000358</c:v>
                </c:pt>
                <c:pt idx="973">
                  <c:v>1585.9900000000366</c:v>
                </c:pt>
                <c:pt idx="974">
                  <c:v>1587.6200000000358</c:v>
                </c:pt>
                <c:pt idx="975">
                  <c:v>1589.2500000000368</c:v>
                </c:pt>
                <c:pt idx="976">
                  <c:v>1590.8800000000358</c:v>
                </c:pt>
                <c:pt idx="977">
                  <c:v>1592.5100000000371</c:v>
                </c:pt>
                <c:pt idx="978">
                  <c:v>1594.1400000000372</c:v>
                </c:pt>
                <c:pt idx="979">
                  <c:v>1595.7700000000373</c:v>
                </c:pt>
                <c:pt idx="980">
                  <c:v>1597.4000000000381</c:v>
                </c:pt>
                <c:pt idx="981">
                  <c:v>1599.0300000000375</c:v>
                </c:pt>
                <c:pt idx="982">
                  <c:v>1600.6600000000376</c:v>
                </c:pt>
                <c:pt idx="983">
                  <c:v>1602.2900000000377</c:v>
                </c:pt>
                <c:pt idx="984">
                  <c:v>1603.920000000038</c:v>
                </c:pt>
                <c:pt idx="985">
                  <c:v>1605.5500000000379</c:v>
                </c:pt>
                <c:pt idx="986">
                  <c:v>1607.1800000000378</c:v>
                </c:pt>
                <c:pt idx="987">
                  <c:v>1608.8100000000379</c:v>
                </c:pt>
                <c:pt idx="988">
                  <c:v>1610.4400000000383</c:v>
                </c:pt>
                <c:pt idx="989">
                  <c:v>1612.0700000000384</c:v>
                </c:pt>
                <c:pt idx="990">
                  <c:v>1613.7000000000385</c:v>
                </c:pt>
                <c:pt idx="991">
                  <c:v>1615.3300000000386</c:v>
                </c:pt>
                <c:pt idx="992">
                  <c:v>1616.9600000000387</c:v>
                </c:pt>
                <c:pt idx="993">
                  <c:v>1618.5900000000388</c:v>
                </c:pt>
                <c:pt idx="994">
                  <c:v>1620.2200000000389</c:v>
                </c:pt>
                <c:pt idx="995">
                  <c:v>1621.850000000039</c:v>
                </c:pt>
                <c:pt idx="996">
                  <c:v>1623.4800000000391</c:v>
                </c:pt>
                <c:pt idx="997">
                  <c:v>1625.1100000000392</c:v>
                </c:pt>
                <c:pt idx="998">
                  <c:v>1626.7400000000393</c:v>
                </c:pt>
                <c:pt idx="999">
                  <c:v>1628.3700000000395</c:v>
                </c:pt>
                <c:pt idx="1000">
                  <c:v>1630.00000000004</c:v>
                </c:pt>
                <c:pt idx="1001">
                  <c:v>1631.6300000000397</c:v>
                </c:pt>
                <c:pt idx="1002">
                  <c:v>1633.26000000004</c:v>
                </c:pt>
                <c:pt idx="1003">
                  <c:v>1634.8900000000399</c:v>
                </c:pt>
                <c:pt idx="1004">
                  <c:v>1636.52000000004</c:v>
                </c:pt>
                <c:pt idx="1005">
                  <c:v>1638.1500000000399</c:v>
                </c:pt>
                <c:pt idx="1006">
                  <c:v>1639.7800000000402</c:v>
                </c:pt>
                <c:pt idx="1007">
                  <c:v>1641.4100000000403</c:v>
                </c:pt>
                <c:pt idx="1008">
                  <c:v>1643.0400000000404</c:v>
                </c:pt>
                <c:pt idx="1009">
                  <c:v>1644.6700000000399</c:v>
                </c:pt>
                <c:pt idx="1010">
                  <c:v>1646.3000000000407</c:v>
                </c:pt>
                <c:pt idx="1011">
                  <c:v>1647.930000000041</c:v>
                </c:pt>
                <c:pt idx="1012">
                  <c:v>1649.5600000000409</c:v>
                </c:pt>
                <c:pt idx="1013">
                  <c:v>1651.1900000000408</c:v>
                </c:pt>
                <c:pt idx="1014">
                  <c:v>1652.8200000000409</c:v>
                </c:pt>
                <c:pt idx="1015">
                  <c:v>1654.4500000000412</c:v>
                </c:pt>
                <c:pt idx="1016">
                  <c:v>1656.0800000000409</c:v>
                </c:pt>
                <c:pt idx="1017">
                  <c:v>1657.7100000000414</c:v>
                </c:pt>
                <c:pt idx="1018">
                  <c:v>1659.3400000000408</c:v>
                </c:pt>
                <c:pt idx="1019">
                  <c:v>1660.9700000000416</c:v>
                </c:pt>
                <c:pt idx="1020">
                  <c:v>1662.6000000000408</c:v>
                </c:pt>
                <c:pt idx="1021">
                  <c:v>1664.2300000000419</c:v>
                </c:pt>
                <c:pt idx="1022">
                  <c:v>1665.860000000042</c:v>
                </c:pt>
                <c:pt idx="1023">
                  <c:v>1667.4900000000421</c:v>
                </c:pt>
                <c:pt idx="1024">
                  <c:v>1669.1200000000422</c:v>
                </c:pt>
                <c:pt idx="1025">
                  <c:v>1670.7500000000423</c:v>
                </c:pt>
                <c:pt idx="1026">
                  <c:v>1672.3800000000424</c:v>
                </c:pt>
                <c:pt idx="1027">
                  <c:v>1674.0100000000425</c:v>
                </c:pt>
                <c:pt idx="1028">
                  <c:v>1675.6400000000426</c:v>
                </c:pt>
                <c:pt idx="1029">
                  <c:v>1677.2700000000427</c:v>
                </c:pt>
                <c:pt idx="1030">
                  <c:v>1678.9000000000431</c:v>
                </c:pt>
                <c:pt idx="1031">
                  <c:v>1680.5300000000429</c:v>
                </c:pt>
                <c:pt idx="1032">
                  <c:v>1682.1600000000428</c:v>
                </c:pt>
                <c:pt idx="1033">
                  <c:v>1683.7900000000432</c:v>
                </c:pt>
                <c:pt idx="1034">
                  <c:v>1685.4200000000433</c:v>
                </c:pt>
                <c:pt idx="1035">
                  <c:v>1687.0500000000434</c:v>
                </c:pt>
                <c:pt idx="1036">
                  <c:v>1688.6800000000428</c:v>
                </c:pt>
                <c:pt idx="1037">
                  <c:v>1690.3100000000436</c:v>
                </c:pt>
                <c:pt idx="1038">
                  <c:v>1691.9400000000437</c:v>
                </c:pt>
                <c:pt idx="1039">
                  <c:v>1693.5700000000438</c:v>
                </c:pt>
                <c:pt idx="1040">
                  <c:v>1695.2000000000439</c:v>
                </c:pt>
                <c:pt idx="1041">
                  <c:v>1696.830000000044</c:v>
                </c:pt>
                <c:pt idx="1042">
                  <c:v>1698.4600000000441</c:v>
                </c:pt>
                <c:pt idx="1043">
                  <c:v>1700.0900000000443</c:v>
                </c:pt>
                <c:pt idx="1044">
                  <c:v>1701.720000000045</c:v>
                </c:pt>
                <c:pt idx="1045">
                  <c:v>1703.3500000000445</c:v>
                </c:pt>
                <c:pt idx="1046">
                  <c:v>1704.980000000045</c:v>
                </c:pt>
                <c:pt idx="1047">
                  <c:v>1706.6100000000447</c:v>
                </c:pt>
                <c:pt idx="1048">
                  <c:v>1708.240000000045</c:v>
                </c:pt>
                <c:pt idx="1049">
                  <c:v>1709.8700000000449</c:v>
                </c:pt>
                <c:pt idx="1050">
                  <c:v>1711.500000000045</c:v>
                </c:pt>
                <c:pt idx="1051">
                  <c:v>1713.1300000000449</c:v>
                </c:pt>
                <c:pt idx="1052">
                  <c:v>1714.7600000000452</c:v>
                </c:pt>
                <c:pt idx="1053">
                  <c:v>1716.3900000000449</c:v>
                </c:pt>
                <c:pt idx="1054">
                  <c:v>1718.0200000000455</c:v>
                </c:pt>
                <c:pt idx="1055">
                  <c:v>1719.6500000000456</c:v>
                </c:pt>
                <c:pt idx="1056">
                  <c:v>1721.2800000000457</c:v>
                </c:pt>
                <c:pt idx="1057">
                  <c:v>1722.910000000046</c:v>
                </c:pt>
                <c:pt idx="1058">
                  <c:v>1724.5400000000459</c:v>
                </c:pt>
                <c:pt idx="1059">
                  <c:v>1726.1700000000458</c:v>
                </c:pt>
                <c:pt idx="1060">
                  <c:v>1727.8000000000459</c:v>
                </c:pt>
                <c:pt idx="1061">
                  <c:v>1729.4300000000462</c:v>
                </c:pt>
                <c:pt idx="1062">
                  <c:v>1731.0600000000459</c:v>
                </c:pt>
                <c:pt idx="1063">
                  <c:v>1732.6900000000458</c:v>
                </c:pt>
                <c:pt idx="1064">
                  <c:v>1734.3200000000459</c:v>
                </c:pt>
                <c:pt idx="1065">
                  <c:v>1735.9500000000467</c:v>
                </c:pt>
                <c:pt idx="1066">
                  <c:v>1737.5800000000468</c:v>
                </c:pt>
                <c:pt idx="1067">
                  <c:v>1739.2100000000469</c:v>
                </c:pt>
                <c:pt idx="1068">
                  <c:v>1740.840000000047</c:v>
                </c:pt>
                <c:pt idx="1069">
                  <c:v>1742.4700000000471</c:v>
                </c:pt>
                <c:pt idx="1070">
                  <c:v>1744.1000000000472</c:v>
                </c:pt>
                <c:pt idx="1071">
                  <c:v>1745.7300000000473</c:v>
                </c:pt>
                <c:pt idx="1072">
                  <c:v>1747.3600000000474</c:v>
                </c:pt>
                <c:pt idx="1073">
                  <c:v>1748.9900000000475</c:v>
                </c:pt>
                <c:pt idx="1074">
                  <c:v>1750.6200000000476</c:v>
                </c:pt>
                <c:pt idx="1075">
                  <c:v>1752.2500000000477</c:v>
                </c:pt>
                <c:pt idx="1076">
                  <c:v>1753.8800000000479</c:v>
                </c:pt>
                <c:pt idx="1077">
                  <c:v>1755.510000000048</c:v>
                </c:pt>
                <c:pt idx="1078">
                  <c:v>1757.1400000000478</c:v>
                </c:pt>
                <c:pt idx="1079">
                  <c:v>1758.7700000000482</c:v>
                </c:pt>
                <c:pt idx="1080">
                  <c:v>1760.4000000000483</c:v>
                </c:pt>
                <c:pt idx="1081">
                  <c:v>1762.0300000000484</c:v>
                </c:pt>
                <c:pt idx="1082">
                  <c:v>1763.6600000000478</c:v>
                </c:pt>
                <c:pt idx="1083">
                  <c:v>1765.2900000000486</c:v>
                </c:pt>
                <c:pt idx="1084">
                  <c:v>1766.9200000000487</c:v>
                </c:pt>
                <c:pt idx="1085">
                  <c:v>1768.5500000000488</c:v>
                </c:pt>
                <c:pt idx="1086">
                  <c:v>1770.1800000000478</c:v>
                </c:pt>
                <c:pt idx="1087">
                  <c:v>1771.8100000000491</c:v>
                </c:pt>
                <c:pt idx="1088">
                  <c:v>1773.4400000000501</c:v>
                </c:pt>
                <c:pt idx="1089">
                  <c:v>1775.0700000000493</c:v>
                </c:pt>
                <c:pt idx="1090">
                  <c:v>1776.7000000000501</c:v>
                </c:pt>
                <c:pt idx="1091">
                  <c:v>1778.3300000000495</c:v>
                </c:pt>
                <c:pt idx="1092">
                  <c:v>1779.9600000000501</c:v>
                </c:pt>
                <c:pt idx="1093">
                  <c:v>1781.5900000000497</c:v>
                </c:pt>
                <c:pt idx="1094">
                  <c:v>1783.22000000005</c:v>
                </c:pt>
                <c:pt idx="1095">
                  <c:v>1784.8500000000499</c:v>
                </c:pt>
                <c:pt idx="1096">
                  <c:v>1786.48000000005</c:v>
                </c:pt>
                <c:pt idx="1097">
                  <c:v>1788.1100000000499</c:v>
                </c:pt>
                <c:pt idx="1098">
                  <c:v>1789.7400000000503</c:v>
                </c:pt>
                <c:pt idx="1099">
                  <c:v>1791.3700000000504</c:v>
                </c:pt>
                <c:pt idx="1100">
                  <c:v>1793.0000000000505</c:v>
                </c:pt>
                <c:pt idx="1101">
                  <c:v>1794.6300000000506</c:v>
                </c:pt>
                <c:pt idx="1102">
                  <c:v>1796.2600000000507</c:v>
                </c:pt>
                <c:pt idx="1103">
                  <c:v>1797.8900000000508</c:v>
                </c:pt>
                <c:pt idx="1104">
                  <c:v>1799.5200000000509</c:v>
                </c:pt>
                <c:pt idx="1105">
                  <c:v>1801.1500000000508</c:v>
                </c:pt>
                <c:pt idx="1106">
                  <c:v>1802.7800000000509</c:v>
                </c:pt>
                <c:pt idx="1107">
                  <c:v>1804.4100000000512</c:v>
                </c:pt>
                <c:pt idx="1108">
                  <c:v>1806.0400000000514</c:v>
                </c:pt>
                <c:pt idx="1109">
                  <c:v>1807.6700000000508</c:v>
                </c:pt>
                <c:pt idx="1110">
                  <c:v>1809.3000000000516</c:v>
                </c:pt>
                <c:pt idx="1111">
                  <c:v>1810.9300000000517</c:v>
                </c:pt>
                <c:pt idx="1112">
                  <c:v>1812.5600000000518</c:v>
                </c:pt>
                <c:pt idx="1113">
                  <c:v>1814.1900000000508</c:v>
                </c:pt>
                <c:pt idx="1114">
                  <c:v>1815.820000000052</c:v>
                </c:pt>
                <c:pt idx="1115">
                  <c:v>1817.4500000000521</c:v>
                </c:pt>
                <c:pt idx="1116">
                  <c:v>1819.0800000000522</c:v>
                </c:pt>
                <c:pt idx="1117">
                  <c:v>1820.7100000000523</c:v>
                </c:pt>
                <c:pt idx="1118">
                  <c:v>1822.3400000000524</c:v>
                </c:pt>
                <c:pt idx="1119">
                  <c:v>1823.970000000053</c:v>
                </c:pt>
                <c:pt idx="1120">
                  <c:v>1825.6000000000527</c:v>
                </c:pt>
                <c:pt idx="1121">
                  <c:v>1827.230000000053</c:v>
                </c:pt>
                <c:pt idx="1122">
                  <c:v>1828.8600000000529</c:v>
                </c:pt>
                <c:pt idx="1123">
                  <c:v>1830.490000000053</c:v>
                </c:pt>
                <c:pt idx="1124">
                  <c:v>1832.1200000000529</c:v>
                </c:pt>
                <c:pt idx="1125">
                  <c:v>1833.7500000000532</c:v>
                </c:pt>
                <c:pt idx="1126">
                  <c:v>1835.3800000000529</c:v>
                </c:pt>
                <c:pt idx="1127">
                  <c:v>1837.0100000000534</c:v>
                </c:pt>
                <c:pt idx="1128">
                  <c:v>1838.6400000000529</c:v>
                </c:pt>
                <c:pt idx="1129">
                  <c:v>1840.2700000000536</c:v>
                </c:pt>
                <c:pt idx="1130">
                  <c:v>1841.9000000000551</c:v>
                </c:pt>
                <c:pt idx="1131">
                  <c:v>1843.5300000000539</c:v>
                </c:pt>
                <c:pt idx="1132">
                  <c:v>1845.160000000054</c:v>
                </c:pt>
                <c:pt idx="1133">
                  <c:v>1846.7900000000541</c:v>
                </c:pt>
                <c:pt idx="1134">
                  <c:v>1848.4200000000551</c:v>
                </c:pt>
                <c:pt idx="1135">
                  <c:v>1850.0500000000543</c:v>
                </c:pt>
                <c:pt idx="1136">
                  <c:v>1851.6800000000544</c:v>
                </c:pt>
                <c:pt idx="1137">
                  <c:v>1853.3100000000545</c:v>
                </c:pt>
                <c:pt idx="1138">
                  <c:v>1854.9400000000551</c:v>
                </c:pt>
                <c:pt idx="1139">
                  <c:v>1856.5700000000547</c:v>
                </c:pt>
                <c:pt idx="1140">
                  <c:v>1858.2000000000551</c:v>
                </c:pt>
                <c:pt idx="1141">
                  <c:v>1859.830000000055</c:v>
                </c:pt>
                <c:pt idx="1142">
                  <c:v>1861.4600000000551</c:v>
                </c:pt>
                <c:pt idx="1143">
                  <c:v>1863.0900000000552</c:v>
                </c:pt>
                <c:pt idx="1144">
                  <c:v>1864.7200000000553</c:v>
                </c:pt>
                <c:pt idx="1145">
                  <c:v>1866.3500000000554</c:v>
                </c:pt>
                <c:pt idx="1146">
                  <c:v>1867.9800000000555</c:v>
                </c:pt>
                <c:pt idx="1147">
                  <c:v>1869.6100000000556</c:v>
                </c:pt>
                <c:pt idx="1148">
                  <c:v>1871.2400000000557</c:v>
                </c:pt>
                <c:pt idx="1149">
                  <c:v>1872.8700000000558</c:v>
                </c:pt>
                <c:pt idx="1150">
                  <c:v>1874.5000000000559</c:v>
                </c:pt>
                <c:pt idx="1151">
                  <c:v>1876.1300000000558</c:v>
                </c:pt>
                <c:pt idx="1152">
                  <c:v>1877.7600000000562</c:v>
                </c:pt>
                <c:pt idx="1153">
                  <c:v>1879.3900000000558</c:v>
                </c:pt>
                <c:pt idx="1154">
                  <c:v>1881.0200000000564</c:v>
                </c:pt>
                <c:pt idx="1155">
                  <c:v>1882.6500000000558</c:v>
                </c:pt>
                <c:pt idx="1156">
                  <c:v>1884.2800000000566</c:v>
                </c:pt>
                <c:pt idx="1157">
                  <c:v>1885.9100000000567</c:v>
                </c:pt>
                <c:pt idx="1158">
                  <c:v>1887.5400000000568</c:v>
                </c:pt>
                <c:pt idx="1159">
                  <c:v>1889.1700000000558</c:v>
                </c:pt>
                <c:pt idx="1160">
                  <c:v>1890.800000000057</c:v>
                </c:pt>
                <c:pt idx="1161">
                  <c:v>1892.4300000000571</c:v>
                </c:pt>
                <c:pt idx="1162">
                  <c:v>1894.0600000000572</c:v>
                </c:pt>
                <c:pt idx="1163">
                  <c:v>1895.6900000000574</c:v>
                </c:pt>
                <c:pt idx="1164">
                  <c:v>1897.3200000000575</c:v>
                </c:pt>
                <c:pt idx="1165">
                  <c:v>1898.950000000058</c:v>
                </c:pt>
                <c:pt idx="1166">
                  <c:v>1900.5800000000577</c:v>
                </c:pt>
                <c:pt idx="1167">
                  <c:v>1902.210000000058</c:v>
                </c:pt>
                <c:pt idx="1168">
                  <c:v>1903.8400000000579</c:v>
                </c:pt>
                <c:pt idx="1169">
                  <c:v>1905.470000000058</c:v>
                </c:pt>
                <c:pt idx="1170">
                  <c:v>1907.1000000000579</c:v>
                </c:pt>
                <c:pt idx="1171">
                  <c:v>1908.7300000000582</c:v>
                </c:pt>
                <c:pt idx="1172">
                  <c:v>1910.3600000000579</c:v>
                </c:pt>
                <c:pt idx="1173">
                  <c:v>1911.9900000000584</c:v>
                </c:pt>
                <c:pt idx="1174">
                  <c:v>1913.6200000000586</c:v>
                </c:pt>
                <c:pt idx="1175">
                  <c:v>1915.2500000000587</c:v>
                </c:pt>
                <c:pt idx="1176">
                  <c:v>1916.8800000000588</c:v>
                </c:pt>
                <c:pt idx="1177">
                  <c:v>1918.5100000000589</c:v>
                </c:pt>
                <c:pt idx="1178">
                  <c:v>1920.140000000059</c:v>
                </c:pt>
                <c:pt idx="1179">
                  <c:v>1921.7700000000591</c:v>
                </c:pt>
                <c:pt idx="1180">
                  <c:v>1923.4000000000601</c:v>
                </c:pt>
                <c:pt idx="1181">
                  <c:v>1925.0300000000593</c:v>
                </c:pt>
                <c:pt idx="1182">
                  <c:v>1926.6600000000594</c:v>
                </c:pt>
                <c:pt idx="1183">
                  <c:v>1928.2900000000595</c:v>
                </c:pt>
                <c:pt idx="1184">
                  <c:v>1929.9200000000601</c:v>
                </c:pt>
                <c:pt idx="1185">
                  <c:v>1931.55000000006</c:v>
                </c:pt>
                <c:pt idx="1186">
                  <c:v>1933.1800000000599</c:v>
                </c:pt>
                <c:pt idx="1187">
                  <c:v>1934.81000000006</c:v>
                </c:pt>
                <c:pt idx="1188">
                  <c:v>1936.4400000000601</c:v>
                </c:pt>
                <c:pt idx="1189">
                  <c:v>1938.0700000000602</c:v>
                </c:pt>
                <c:pt idx="1190">
                  <c:v>1939.7000000000603</c:v>
                </c:pt>
                <c:pt idx="1191">
                  <c:v>1941.3300000000604</c:v>
                </c:pt>
                <c:pt idx="1192">
                  <c:v>1942.9600000000605</c:v>
                </c:pt>
                <c:pt idx="1193">
                  <c:v>1944.5900000000606</c:v>
                </c:pt>
                <c:pt idx="1194">
                  <c:v>1946.2200000000607</c:v>
                </c:pt>
                <c:pt idx="1195">
                  <c:v>1947.8500000000608</c:v>
                </c:pt>
                <c:pt idx="1196">
                  <c:v>1949.480000000061</c:v>
                </c:pt>
                <c:pt idx="1197">
                  <c:v>1951.1100000000608</c:v>
                </c:pt>
                <c:pt idx="1198">
                  <c:v>1952.7400000000612</c:v>
                </c:pt>
                <c:pt idx="1199">
                  <c:v>1954.3700000000608</c:v>
                </c:pt>
              </c:numCache>
            </c:numRef>
          </c:xVal>
          <c:yVal>
            <c:numRef>
              <c:f>'30may07_Ry3ab_N_1a'!$I$1:$I$1200</c:f>
              <c:numCache>
                <c:formatCode>General</c:formatCode>
                <c:ptCount val="1200"/>
                <c:pt idx="0">
                  <c:v>1.0099097538946111</c:v>
                </c:pt>
                <c:pt idx="1">
                  <c:v>1.009799474065993</c:v>
                </c:pt>
                <c:pt idx="2">
                  <c:v>1.006936822863028</c:v>
                </c:pt>
                <c:pt idx="3">
                  <c:v>1.0068264284309159</c:v>
                </c:pt>
                <c:pt idx="4">
                  <c:v>1.007660563352724</c:v>
                </c:pt>
                <c:pt idx="5">
                  <c:v>1.0063413107564112</c:v>
                </c:pt>
                <c:pt idx="6">
                  <c:v>1.0063062102566038</c:v>
                </c:pt>
                <c:pt idx="7">
                  <c:v>1.0041248419398088</c:v>
                </c:pt>
                <c:pt idx="8">
                  <c:v>1.0035948234484278</c:v>
                </c:pt>
                <c:pt idx="9">
                  <c:v>1.0058057517463552</c:v>
                </c:pt>
                <c:pt idx="10">
                  <c:v>1.0070816315793978</c:v>
                </c:pt>
                <c:pt idx="11">
                  <c:v>1.0066858146126663</c:v>
                </c:pt>
                <c:pt idx="12">
                  <c:v>1.0058896048520398</c:v>
                </c:pt>
                <c:pt idx="13">
                  <c:v>1.0070720323864057</c:v>
                </c:pt>
                <c:pt idx="14">
                  <c:v>1.0078236563229768</c:v>
                </c:pt>
                <c:pt idx="15">
                  <c:v>1.0059454099933041</c:v>
                </c:pt>
                <c:pt idx="16">
                  <c:v>1.0056974853462217</c:v>
                </c:pt>
                <c:pt idx="17">
                  <c:v>1.0049722101184078</c:v>
                </c:pt>
                <c:pt idx="18">
                  <c:v>1.003208409900866</c:v>
                </c:pt>
                <c:pt idx="19">
                  <c:v>1.0033443515918719</c:v>
                </c:pt>
                <c:pt idx="20">
                  <c:v>1.0036422555492404</c:v>
                </c:pt>
                <c:pt idx="21">
                  <c:v>1.0043200164287902</c:v>
                </c:pt>
                <c:pt idx="22">
                  <c:v>1.001861059962821</c:v>
                </c:pt>
                <c:pt idx="23">
                  <c:v>1.0010624119094358</c:v>
                </c:pt>
                <c:pt idx="24">
                  <c:v>0.99996682530327341</c:v>
                </c:pt>
                <c:pt idx="25">
                  <c:v>1.0015664578813352</c:v>
                </c:pt>
                <c:pt idx="26">
                  <c:v>1.0043727863602023</c:v>
                </c:pt>
                <c:pt idx="27">
                  <c:v>1.0045245352220658</c:v>
                </c:pt>
                <c:pt idx="28">
                  <c:v>1.0035324076612075</c:v>
                </c:pt>
                <c:pt idx="29">
                  <c:v>1.0028610209530249</c:v>
                </c:pt>
                <c:pt idx="30">
                  <c:v>1.0031610075137358</c:v>
                </c:pt>
                <c:pt idx="31">
                  <c:v>1.0048075086762605</c:v>
                </c:pt>
                <c:pt idx="32">
                  <c:v>1.0058284326879476</c:v>
                </c:pt>
                <c:pt idx="33">
                  <c:v>1.0040679634677123</c:v>
                </c:pt>
                <c:pt idx="34">
                  <c:v>1.0019209033000596</c:v>
                </c:pt>
                <c:pt idx="35">
                  <c:v>1.0016235100608926</c:v>
                </c:pt>
                <c:pt idx="36">
                  <c:v>1.0019099197598238</c:v>
                </c:pt>
                <c:pt idx="37">
                  <c:v>1.0051172198644558</c:v>
                </c:pt>
                <c:pt idx="38">
                  <c:v>1.0046192124657658</c:v>
                </c:pt>
                <c:pt idx="39">
                  <c:v>1.0067971232655202</c:v>
                </c:pt>
                <c:pt idx="40">
                  <c:v>1.0082224997889153</c:v>
                </c:pt>
                <c:pt idx="41">
                  <c:v>1.0104077469782566</c:v>
                </c:pt>
                <c:pt idx="42">
                  <c:v>1.0125933700597018</c:v>
                </c:pt>
                <c:pt idx="43">
                  <c:v>1.0126282460436458</c:v>
                </c:pt>
                <c:pt idx="44">
                  <c:v>1.0142641035527613</c:v>
                </c:pt>
                <c:pt idx="45">
                  <c:v>1.0140480042514801</c:v>
                </c:pt>
                <c:pt idx="46">
                  <c:v>1.0136685627613864</c:v>
                </c:pt>
                <c:pt idx="47">
                  <c:v>1.0123916178195074</c:v>
                </c:pt>
                <c:pt idx="48">
                  <c:v>1.012760109410453</c:v>
                </c:pt>
                <c:pt idx="49">
                  <c:v>1.0114243266875909</c:v>
                </c:pt>
                <c:pt idx="50">
                  <c:v>1.0105723211180442</c:v>
                </c:pt>
                <c:pt idx="51">
                  <c:v>1.0099007486714471</c:v>
                </c:pt>
                <c:pt idx="52">
                  <c:v>1.0099272348706039</c:v>
                </c:pt>
                <c:pt idx="53">
                  <c:v>1.0103469925725366</c:v>
                </c:pt>
                <c:pt idx="54">
                  <c:v>1.0105859807512663</c:v>
                </c:pt>
                <c:pt idx="55">
                  <c:v>1.0109473185507061</c:v>
                </c:pt>
                <c:pt idx="56">
                  <c:v>1.0119193792197099</c:v>
                </c:pt>
                <c:pt idx="57">
                  <c:v>1.0121292060779894</c:v>
                </c:pt>
                <c:pt idx="58">
                  <c:v>1.0124282726259126</c:v>
                </c:pt>
                <c:pt idx="59">
                  <c:v>1.0129607050089977</c:v>
                </c:pt>
                <c:pt idx="60">
                  <c:v>1.0127067238928946</c:v>
                </c:pt>
                <c:pt idx="61">
                  <c:v>1.0104896069595808</c:v>
                </c:pt>
                <c:pt idx="62">
                  <c:v>1.0103746386735906</c:v>
                </c:pt>
                <c:pt idx="63">
                  <c:v>1.0079321045793717</c:v>
                </c:pt>
                <c:pt idx="64">
                  <c:v>1.0065852315540793</c:v>
                </c:pt>
                <c:pt idx="65">
                  <c:v>1.0038922947089033</c:v>
                </c:pt>
                <c:pt idx="66">
                  <c:v>1.0015543409146335</c:v>
                </c:pt>
                <c:pt idx="67">
                  <c:v>1.0004378763346427</c:v>
                </c:pt>
                <c:pt idx="68">
                  <c:v>0.99851216371682672</c:v>
                </c:pt>
                <c:pt idx="69">
                  <c:v>0.9971748885894367</c:v>
                </c:pt>
                <c:pt idx="70">
                  <c:v>0.99830728042460759</c:v>
                </c:pt>
                <c:pt idx="71">
                  <c:v>1.0001020921388066</c:v>
                </c:pt>
                <c:pt idx="72">
                  <c:v>1.0016239269193752</c:v>
                </c:pt>
                <c:pt idx="73">
                  <c:v>1.0006492334853758</c:v>
                </c:pt>
                <c:pt idx="74">
                  <c:v>0.99864530976634158</c:v>
                </c:pt>
                <c:pt idx="75">
                  <c:v>0.99718058773413487</c:v>
                </c:pt>
                <c:pt idx="76">
                  <c:v>0.99557727403580332</c:v>
                </c:pt>
                <c:pt idx="77">
                  <c:v>0.99438295932993837</c:v>
                </c:pt>
                <c:pt idx="78">
                  <c:v>0.99223705818410324</c:v>
                </c:pt>
                <c:pt idx="79">
                  <c:v>0.98997243871294183</c:v>
                </c:pt>
                <c:pt idx="80">
                  <c:v>0.98678124158709768</c:v>
                </c:pt>
                <c:pt idx="81">
                  <c:v>0.98553956372732043</c:v>
                </c:pt>
                <c:pt idx="82">
                  <c:v>0.98490900864915765</c:v>
                </c:pt>
                <c:pt idx="83">
                  <c:v>0.9831507336061488</c:v>
                </c:pt>
                <c:pt idx="84">
                  <c:v>0.98339419374819814</c:v>
                </c:pt>
                <c:pt idx="85">
                  <c:v>0.9820377575695276</c:v>
                </c:pt>
                <c:pt idx="86">
                  <c:v>0.97945179615617606</c:v>
                </c:pt>
                <c:pt idx="87">
                  <c:v>0.97981064277808994</c:v>
                </c:pt>
                <c:pt idx="88">
                  <c:v>0.97713838427711996</c:v>
                </c:pt>
                <c:pt idx="89">
                  <c:v>0.9767277518866796</c:v>
                </c:pt>
                <c:pt idx="90">
                  <c:v>0.97670563594161763</c:v>
                </c:pt>
                <c:pt idx="91">
                  <c:v>0.97600028403395167</c:v>
                </c:pt>
                <c:pt idx="92">
                  <c:v>0.97469111213549398</c:v>
                </c:pt>
                <c:pt idx="93">
                  <c:v>0.97322512959174967</c:v>
                </c:pt>
                <c:pt idx="94">
                  <c:v>0.9705655922433557</c:v>
                </c:pt>
                <c:pt idx="95">
                  <c:v>0.96799884383133661</c:v>
                </c:pt>
                <c:pt idx="96">
                  <c:v>0.965902183617949</c:v>
                </c:pt>
                <c:pt idx="97">
                  <c:v>0.96505634737513368</c:v>
                </c:pt>
                <c:pt idx="98">
                  <c:v>0.96245615133348461</c:v>
                </c:pt>
                <c:pt idx="99">
                  <c:v>0.96154548513753568</c:v>
                </c:pt>
                <c:pt idx="100">
                  <c:v>0.96069971560309086</c:v>
                </c:pt>
                <c:pt idx="101">
                  <c:v>0.95826615174767527</c:v>
                </c:pt>
                <c:pt idx="102">
                  <c:v>0.95582662327290391</c:v>
                </c:pt>
                <c:pt idx="103">
                  <c:v>0.95464398331682665</c:v>
                </c:pt>
                <c:pt idx="104">
                  <c:v>0.95236154890589797</c:v>
                </c:pt>
                <c:pt idx="105">
                  <c:v>0.94868827059900518</c:v>
                </c:pt>
                <c:pt idx="106">
                  <c:v>0.94653269754043412</c:v>
                </c:pt>
                <c:pt idx="107">
                  <c:v>0.94435220025877264</c:v>
                </c:pt>
                <c:pt idx="108">
                  <c:v>0.94025909613680392</c:v>
                </c:pt>
                <c:pt idx="109">
                  <c:v>0.93774092347208748</c:v>
                </c:pt>
                <c:pt idx="110">
                  <c:v>0.93593680658979306</c:v>
                </c:pt>
                <c:pt idx="111">
                  <c:v>0.93363680554750761</c:v>
                </c:pt>
                <c:pt idx="112">
                  <c:v>0.93223052810970353</c:v>
                </c:pt>
                <c:pt idx="113">
                  <c:v>0.92972941111081675</c:v>
                </c:pt>
                <c:pt idx="114">
                  <c:v>0.92725023221272762</c:v>
                </c:pt>
                <c:pt idx="115">
                  <c:v>0.92497853069438474</c:v>
                </c:pt>
                <c:pt idx="116">
                  <c:v>0.92193350199688451</c:v>
                </c:pt>
                <c:pt idx="117">
                  <c:v>0.91850166470774119</c:v>
                </c:pt>
                <c:pt idx="118">
                  <c:v>0.91544430570711499</c:v>
                </c:pt>
                <c:pt idx="119">
                  <c:v>0.91286173785050195</c:v>
                </c:pt>
                <c:pt idx="120">
                  <c:v>0.90956688497132232</c:v>
                </c:pt>
                <c:pt idx="121">
                  <c:v>0.90564140284182948</c:v>
                </c:pt>
                <c:pt idx="122">
                  <c:v>0.9030190647274865</c:v>
                </c:pt>
                <c:pt idx="123">
                  <c:v>0.9009701073065397</c:v>
                </c:pt>
                <c:pt idx="124">
                  <c:v>0.89817681915162451</c:v>
                </c:pt>
                <c:pt idx="125">
                  <c:v>0.89698200478709467</c:v>
                </c:pt>
                <c:pt idx="126">
                  <c:v>0.89408895494922858</c:v>
                </c:pt>
                <c:pt idx="127">
                  <c:v>0.89129796436952857</c:v>
                </c:pt>
                <c:pt idx="128">
                  <c:v>0.88836683815882111</c:v>
                </c:pt>
                <c:pt idx="129">
                  <c:v>0.88476957657882371</c:v>
                </c:pt>
                <c:pt idx="130">
                  <c:v>0.88136056377399907</c:v>
                </c:pt>
                <c:pt idx="131">
                  <c:v>0.8782263808269023</c:v>
                </c:pt>
                <c:pt idx="132">
                  <c:v>0.87631102862769261</c:v>
                </c:pt>
                <c:pt idx="133">
                  <c:v>0.87287623104131462</c:v>
                </c:pt>
                <c:pt idx="134">
                  <c:v>0.87030703765320394</c:v>
                </c:pt>
                <c:pt idx="135">
                  <c:v>0.86807191522802163</c:v>
                </c:pt>
                <c:pt idx="136">
                  <c:v>0.86588993033851114</c:v>
                </c:pt>
                <c:pt idx="137">
                  <c:v>0.86398070298015661</c:v>
                </c:pt>
                <c:pt idx="138">
                  <c:v>0.86001602795347865</c:v>
                </c:pt>
                <c:pt idx="139">
                  <c:v>0.85763364599667991</c:v>
                </c:pt>
                <c:pt idx="140">
                  <c:v>0.8558439966501753</c:v>
                </c:pt>
                <c:pt idx="141">
                  <c:v>0.85417544964022663</c:v>
                </c:pt>
                <c:pt idx="142">
                  <c:v>0.85415258920960357</c:v>
                </c:pt>
                <c:pt idx="143">
                  <c:v>0.8522723112188556</c:v>
                </c:pt>
                <c:pt idx="144">
                  <c:v>0.84930541326186593</c:v>
                </c:pt>
                <c:pt idx="145">
                  <c:v>0.84757541275000803</c:v>
                </c:pt>
                <c:pt idx="146">
                  <c:v>0.84644358899429351</c:v>
                </c:pt>
                <c:pt idx="147">
                  <c:v>0.84330223764862355</c:v>
                </c:pt>
                <c:pt idx="148">
                  <c:v>0.84257960924662478</c:v>
                </c:pt>
                <c:pt idx="149">
                  <c:v>0.83973582380923961</c:v>
                </c:pt>
                <c:pt idx="150">
                  <c:v>0.83956309327334688</c:v>
                </c:pt>
                <c:pt idx="151">
                  <c:v>0.8366800873170207</c:v>
                </c:pt>
                <c:pt idx="152">
                  <c:v>0.83540423802736397</c:v>
                </c:pt>
                <c:pt idx="153">
                  <c:v>0.8356734081692041</c:v>
                </c:pt>
                <c:pt idx="154">
                  <c:v>0.834865742050935</c:v>
                </c:pt>
                <c:pt idx="155">
                  <c:v>0.83372509882909573</c:v>
                </c:pt>
                <c:pt idx="156">
                  <c:v>0.83275932498008765</c:v>
                </c:pt>
                <c:pt idx="157">
                  <c:v>0.8335373414864552</c:v>
                </c:pt>
                <c:pt idx="158">
                  <c:v>0.83240229184233105</c:v>
                </c:pt>
                <c:pt idx="159">
                  <c:v>0.83067580422923204</c:v>
                </c:pt>
                <c:pt idx="160">
                  <c:v>0.83043088753658734</c:v>
                </c:pt>
                <c:pt idx="161">
                  <c:v>0.8281248798652967</c:v>
                </c:pt>
                <c:pt idx="162">
                  <c:v>0.82796106554051663</c:v>
                </c:pt>
                <c:pt idx="163">
                  <c:v>0.82728702055183978</c:v>
                </c:pt>
                <c:pt idx="164">
                  <c:v>0.82585256820654651</c:v>
                </c:pt>
                <c:pt idx="165">
                  <c:v>0.82599078426715</c:v>
                </c:pt>
                <c:pt idx="166">
                  <c:v>0.82235801523883933</c:v>
                </c:pt>
                <c:pt idx="167">
                  <c:v>0.82158612730565306</c:v>
                </c:pt>
                <c:pt idx="168">
                  <c:v>0.81996702535250232</c:v>
                </c:pt>
                <c:pt idx="169">
                  <c:v>0.8186112810927052</c:v>
                </c:pt>
                <c:pt idx="170">
                  <c:v>0.82013636623381192</c:v>
                </c:pt>
                <c:pt idx="171">
                  <c:v>0.82030973064000889</c:v>
                </c:pt>
                <c:pt idx="172">
                  <c:v>0.82000252953084407</c:v>
                </c:pt>
                <c:pt idx="173">
                  <c:v>0.81936805508753252</c:v>
                </c:pt>
                <c:pt idx="174">
                  <c:v>0.8168897029075517</c:v>
                </c:pt>
                <c:pt idx="175">
                  <c:v>0.81580686699384064</c:v>
                </c:pt>
                <c:pt idx="176">
                  <c:v>0.8143910043209126</c:v>
                </c:pt>
                <c:pt idx="177">
                  <c:v>0.8133947150350006</c:v>
                </c:pt>
                <c:pt idx="178">
                  <c:v>0.81289329703320923</c:v>
                </c:pt>
                <c:pt idx="179">
                  <c:v>0.81246869423374368</c:v>
                </c:pt>
                <c:pt idx="180">
                  <c:v>0.81006460023554494</c:v>
                </c:pt>
                <c:pt idx="181">
                  <c:v>0.80795203611252764</c:v>
                </c:pt>
                <c:pt idx="182">
                  <c:v>0.80729118665910782</c:v>
                </c:pt>
                <c:pt idx="183">
                  <c:v>0.80590579899932568</c:v>
                </c:pt>
                <c:pt idx="184">
                  <c:v>0.80443115982060909</c:v>
                </c:pt>
                <c:pt idx="185">
                  <c:v>0.80682055466432401</c:v>
                </c:pt>
                <c:pt idx="186">
                  <c:v>0.80574385262239456</c:v>
                </c:pt>
                <c:pt idx="187">
                  <c:v>0.80441791684989361</c:v>
                </c:pt>
                <c:pt idx="188">
                  <c:v>0.80445382447641445</c:v>
                </c:pt>
                <c:pt idx="189">
                  <c:v>0.8028612796628537</c:v>
                </c:pt>
                <c:pt idx="190">
                  <c:v>0.80402292064692249</c:v>
                </c:pt>
                <c:pt idx="191">
                  <c:v>0.80295788010070124</c:v>
                </c:pt>
                <c:pt idx="192">
                  <c:v>0.80412162871683801</c:v>
                </c:pt>
                <c:pt idx="193">
                  <c:v>0.80605711996623608</c:v>
                </c:pt>
                <c:pt idx="194">
                  <c:v>0.80509450908893809</c:v>
                </c:pt>
                <c:pt idx="195">
                  <c:v>0.80606936153172049</c:v>
                </c:pt>
                <c:pt idx="196">
                  <c:v>0.80649930585923457</c:v>
                </c:pt>
                <c:pt idx="197">
                  <c:v>0.80721237682923119</c:v>
                </c:pt>
                <c:pt idx="198">
                  <c:v>0.80617871949288722</c:v>
                </c:pt>
                <c:pt idx="199">
                  <c:v>0.80799241974765856</c:v>
                </c:pt>
                <c:pt idx="200">
                  <c:v>0.80725193111988525</c:v>
                </c:pt>
                <c:pt idx="201">
                  <c:v>0.80715071165411334</c:v>
                </c:pt>
                <c:pt idx="202">
                  <c:v>0.8074241663183348</c:v>
                </c:pt>
                <c:pt idx="203">
                  <c:v>0.80713777177840551</c:v>
                </c:pt>
                <c:pt idx="204">
                  <c:v>0.80788579192708543</c:v>
                </c:pt>
                <c:pt idx="205">
                  <c:v>0.80859463048399294</c:v>
                </c:pt>
                <c:pt idx="206">
                  <c:v>0.80866999220803792</c:v>
                </c:pt>
                <c:pt idx="207">
                  <c:v>0.81031443640016665</c:v>
                </c:pt>
                <c:pt idx="208">
                  <c:v>0.8103306427606155</c:v>
                </c:pt>
                <c:pt idx="209">
                  <c:v>0.80761171231684481</c:v>
                </c:pt>
                <c:pt idx="210">
                  <c:v>0.80920973472220126</c:v>
                </c:pt>
                <c:pt idx="211">
                  <c:v>0.80987376721390003</c:v>
                </c:pt>
                <c:pt idx="212">
                  <c:v>0.80947476758182169</c:v>
                </c:pt>
                <c:pt idx="213">
                  <c:v>0.8104805944171124</c:v>
                </c:pt>
                <c:pt idx="214">
                  <c:v>0.80974660346776961</c:v>
                </c:pt>
                <c:pt idx="215">
                  <c:v>0.81046270604743043</c:v>
                </c:pt>
                <c:pt idx="216">
                  <c:v>0.81065218844005249</c:v>
                </c:pt>
                <c:pt idx="217">
                  <c:v>0.81018616983358849</c:v>
                </c:pt>
                <c:pt idx="218">
                  <c:v>0.80919570052603562</c:v>
                </c:pt>
                <c:pt idx="219">
                  <c:v>0.80834163381639912</c:v>
                </c:pt>
                <c:pt idx="220">
                  <c:v>0.80575615637933062</c:v>
                </c:pt>
                <c:pt idx="221">
                  <c:v>0.80492890427531461</c:v>
                </c:pt>
                <c:pt idx="222">
                  <c:v>0.80723476182801357</c:v>
                </c:pt>
                <c:pt idx="223">
                  <c:v>0.80590779435419224</c:v>
                </c:pt>
                <c:pt idx="224">
                  <c:v>0.80744572066591069</c:v>
                </c:pt>
                <c:pt idx="225">
                  <c:v>0.8085949663461397</c:v>
                </c:pt>
                <c:pt idx="226">
                  <c:v>0.80854357113730457</c:v>
                </c:pt>
                <c:pt idx="227">
                  <c:v>0.80912759396800171</c:v>
                </c:pt>
                <c:pt idx="228">
                  <c:v>0.81042141227748499</c:v>
                </c:pt>
                <c:pt idx="229">
                  <c:v>0.81159573948020169</c:v>
                </c:pt>
                <c:pt idx="230">
                  <c:v>0.81312970116476835</c:v>
                </c:pt>
                <c:pt idx="231">
                  <c:v>0.81561389128841721</c:v>
                </c:pt>
                <c:pt idx="232">
                  <c:v>0.81760108279462362</c:v>
                </c:pt>
                <c:pt idx="233">
                  <c:v>0.81894720019340395</c:v>
                </c:pt>
                <c:pt idx="234">
                  <c:v>0.81898659946221075</c:v>
                </c:pt>
                <c:pt idx="235">
                  <c:v>0.81890215809103717</c:v>
                </c:pt>
                <c:pt idx="236">
                  <c:v>0.82087143409460128</c:v>
                </c:pt>
                <c:pt idx="237">
                  <c:v>0.82233826794633358</c:v>
                </c:pt>
                <c:pt idx="238">
                  <c:v>0.82313510564079362</c:v>
                </c:pt>
                <c:pt idx="239">
                  <c:v>0.82458380289357913</c:v>
                </c:pt>
                <c:pt idx="240">
                  <c:v>0.82567023627273095</c:v>
                </c:pt>
                <c:pt idx="241">
                  <c:v>0.82603216989981887</c:v>
                </c:pt>
                <c:pt idx="242">
                  <c:v>0.82676012371533858</c:v>
                </c:pt>
                <c:pt idx="243">
                  <c:v>0.82654323325403123</c:v>
                </c:pt>
                <c:pt idx="244">
                  <c:v>0.82842482877635559</c:v>
                </c:pt>
                <c:pt idx="245">
                  <c:v>0.82874268319876065</c:v>
                </c:pt>
                <c:pt idx="246">
                  <c:v>0.8314892978915347</c:v>
                </c:pt>
                <c:pt idx="247">
                  <c:v>0.83178274636851723</c:v>
                </c:pt>
                <c:pt idx="248">
                  <c:v>0.83141958837830954</c:v>
                </c:pt>
                <c:pt idx="249">
                  <c:v>0.83176805886791438</c:v>
                </c:pt>
                <c:pt idx="250">
                  <c:v>0.83268566203429983</c:v>
                </c:pt>
                <c:pt idx="251">
                  <c:v>0.83525592879549571</c:v>
                </c:pt>
                <c:pt idx="252">
                  <c:v>0.83509675278582962</c:v>
                </c:pt>
                <c:pt idx="253">
                  <c:v>0.83465933055502273</c:v>
                </c:pt>
                <c:pt idx="254">
                  <c:v>0.83370346368686865</c:v>
                </c:pt>
                <c:pt idx="255">
                  <c:v>0.83105401039340299</c:v>
                </c:pt>
                <c:pt idx="256">
                  <c:v>0.83123183641434872</c:v>
                </c:pt>
                <c:pt idx="257">
                  <c:v>0.83080648495790921</c:v>
                </c:pt>
                <c:pt idx="258">
                  <c:v>0.83008741674867637</c:v>
                </c:pt>
                <c:pt idx="259">
                  <c:v>0.8315310758512382</c:v>
                </c:pt>
                <c:pt idx="260">
                  <c:v>0.83011667788141752</c:v>
                </c:pt>
                <c:pt idx="261">
                  <c:v>0.82858765221121411</c:v>
                </c:pt>
                <c:pt idx="262">
                  <c:v>0.82916015558234757</c:v>
                </c:pt>
                <c:pt idx="263">
                  <c:v>0.83240932393436551</c:v>
                </c:pt>
                <c:pt idx="264">
                  <c:v>0.83177548184488126</c:v>
                </c:pt>
                <c:pt idx="265">
                  <c:v>0.83208439399138323</c:v>
                </c:pt>
                <c:pt idx="266">
                  <c:v>0.83277624375746551</c:v>
                </c:pt>
                <c:pt idx="267">
                  <c:v>0.83368387472026406</c:v>
                </c:pt>
                <c:pt idx="268">
                  <c:v>0.8356581930869309</c:v>
                </c:pt>
                <c:pt idx="269">
                  <c:v>0.83807811498187756</c:v>
                </c:pt>
                <c:pt idx="270">
                  <c:v>0.83838498533929251</c:v>
                </c:pt>
                <c:pt idx="271">
                  <c:v>0.84088098394846889</c:v>
                </c:pt>
                <c:pt idx="272">
                  <c:v>0.84138367763638111</c:v>
                </c:pt>
                <c:pt idx="273">
                  <c:v>0.8430398149435655</c:v>
                </c:pt>
                <c:pt idx="274">
                  <c:v>0.84450466009401504</c:v>
                </c:pt>
                <c:pt idx="275">
                  <c:v>0.84364255825142165</c:v>
                </c:pt>
                <c:pt idx="276">
                  <c:v>0.84653148004363532</c:v>
                </c:pt>
                <c:pt idx="277">
                  <c:v>0.84895139880408055</c:v>
                </c:pt>
                <c:pt idx="278">
                  <c:v>0.85076299644063313</c:v>
                </c:pt>
                <c:pt idx="279">
                  <c:v>0.85331271664593888</c:v>
                </c:pt>
                <c:pt idx="280">
                  <c:v>0.85434170401220488</c:v>
                </c:pt>
                <c:pt idx="281">
                  <c:v>0.85692439660196362</c:v>
                </c:pt>
                <c:pt idx="282">
                  <c:v>0.86003969126818836</c:v>
                </c:pt>
                <c:pt idx="283">
                  <c:v>0.85884002698902684</c:v>
                </c:pt>
                <c:pt idx="284">
                  <c:v>0.86133360142084914</c:v>
                </c:pt>
                <c:pt idx="285">
                  <c:v>0.86516704121420196</c:v>
                </c:pt>
                <c:pt idx="286">
                  <c:v>0.86758651690874078</c:v>
                </c:pt>
                <c:pt idx="287">
                  <c:v>0.86347484934146745</c:v>
                </c:pt>
                <c:pt idx="288">
                  <c:v>0.86582414908466232</c:v>
                </c:pt>
                <c:pt idx="289">
                  <c:v>0.86823650426978494</c:v>
                </c:pt>
                <c:pt idx="290">
                  <c:v>0.87059378985595215</c:v>
                </c:pt>
                <c:pt idx="291">
                  <c:v>0.87267958259033684</c:v>
                </c:pt>
                <c:pt idx="292">
                  <c:v>0.87225722991616739</c:v>
                </c:pt>
                <c:pt idx="293">
                  <c:v>0.8727744774503019</c:v>
                </c:pt>
                <c:pt idx="294">
                  <c:v>0.87320272038740632</c:v>
                </c:pt>
                <c:pt idx="295">
                  <c:v>0.8746056583002908</c:v>
                </c:pt>
                <c:pt idx="296">
                  <c:v>0.87761945455677437</c:v>
                </c:pt>
                <c:pt idx="297">
                  <c:v>0.87956208033252958</c:v>
                </c:pt>
                <c:pt idx="298">
                  <c:v>0.87846680172175529</c:v>
                </c:pt>
                <c:pt idx="299">
                  <c:v>0.87961140279504746</c:v>
                </c:pt>
                <c:pt idx="300">
                  <c:v>0.8796799763601556</c:v>
                </c:pt>
                <c:pt idx="301">
                  <c:v>0.88007640120824249</c:v>
                </c:pt>
                <c:pt idx="302">
                  <c:v>0.8816146018490435</c:v>
                </c:pt>
                <c:pt idx="303">
                  <c:v>0.87922571844533293</c:v>
                </c:pt>
                <c:pt idx="304">
                  <c:v>0.88126352362891858</c:v>
                </c:pt>
                <c:pt idx="305">
                  <c:v>0.87929181311278082</c:v>
                </c:pt>
                <c:pt idx="306">
                  <c:v>0.87991287507938665</c:v>
                </c:pt>
                <c:pt idx="307">
                  <c:v>0.884375139482247</c:v>
                </c:pt>
                <c:pt idx="308">
                  <c:v>0.88609921589136653</c:v>
                </c:pt>
                <c:pt idx="309">
                  <c:v>0.88545596964619999</c:v>
                </c:pt>
                <c:pt idx="310">
                  <c:v>0.88674537710364687</c:v>
                </c:pt>
                <c:pt idx="311">
                  <c:v>0.88983500312926</c:v>
                </c:pt>
                <c:pt idx="312">
                  <c:v>0.89101147312214035</c:v>
                </c:pt>
                <c:pt idx="313">
                  <c:v>0.89087337095791985</c:v>
                </c:pt>
                <c:pt idx="314">
                  <c:v>0.89071382328332771</c:v>
                </c:pt>
                <c:pt idx="315">
                  <c:v>0.8913529969330185</c:v>
                </c:pt>
                <c:pt idx="316">
                  <c:v>0.89220424534153453</c:v>
                </c:pt>
                <c:pt idx="317">
                  <c:v>0.89304359991306459</c:v>
                </c:pt>
                <c:pt idx="318">
                  <c:v>0.89377918146953872</c:v>
                </c:pt>
                <c:pt idx="319">
                  <c:v>0.8946142435013803</c:v>
                </c:pt>
                <c:pt idx="320">
                  <c:v>0.89525752091926525</c:v>
                </c:pt>
                <c:pt idx="321">
                  <c:v>0.89528367490222915</c:v>
                </c:pt>
                <c:pt idx="322">
                  <c:v>0.89861316131594848</c:v>
                </c:pt>
                <c:pt idx="323">
                  <c:v>0.89853573215067917</c:v>
                </c:pt>
                <c:pt idx="324">
                  <c:v>0.89885528374345269</c:v>
                </c:pt>
                <c:pt idx="325">
                  <c:v>0.89846833809762428</c:v>
                </c:pt>
                <c:pt idx="326">
                  <c:v>0.9007591072862694</c:v>
                </c:pt>
                <c:pt idx="327">
                  <c:v>0.90568806836097415</c:v>
                </c:pt>
                <c:pt idx="328">
                  <c:v>0.90566011445898464</c:v>
                </c:pt>
                <c:pt idx="329">
                  <c:v>0.90783410950229548</c:v>
                </c:pt>
                <c:pt idx="330">
                  <c:v>0.9077516436612576</c:v>
                </c:pt>
                <c:pt idx="331">
                  <c:v>0.9104603642892205</c:v>
                </c:pt>
                <c:pt idx="332">
                  <c:v>0.91074089011715664</c:v>
                </c:pt>
                <c:pt idx="333">
                  <c:v>0.91180789028419262</c:v>
                </c:pt>
                <c:pt idx="334">
                  <c:v>0.91048858430704105</c:v>
                </c:pt>
                <c:pt idx="335">
                  <c:v>0.91293726097887862</c:v>
                </c:pt>
                <c:pt idx="336">
                  <c:v>0.91412805973497002</c:v>
                </c:pt>
                <c:pt idx="337">
                  <c:v>0.91543496336517605</c:v>
                </c:pt>
                <c:pt idx="338">
                  <c:v>0.91601906899287233</c:v>
                </c:pt>
                <c:pt idx="339">
                  <c:v>0.91650706366308765</c:v>
                </c:pt>
                <c:pt idx="340">
                  <c:v>0.91833471166636049</c:v>
                </c:pt>
                <c:pt idx="341">
                  <c:v>0.92003161491035168</c:v>
                </c:pt>
                <c:pt idx="342">
                  <c:v>0.92197021749854657</c:v>
                </c:pt>
                <c:pt idx="343">
                  <c:v>0.92243696189259416</c:v>
                </c:pt>
                <c:pt idx="344">
                  <c:v>0.92287134586513841</c:v>
                </c:pt>
                <c:pt idx="345">
                  <c:v>0.92575986440610081</c:v>
                </c:pt>
                <c:pt idx="346">
                  <c:v>0.92628352000995295</c:v>
                </c:pt>
                <c:pt idx="347">
                  <c:v>0.9283169605683802</c:v>
                </c:pt>
                <c:pt idx="348">
                  <c:v>0.93012307953742734</c:v>
                </c:pt>
                <c:pt idx="349">
                  <c:v>0.93250574473242687</c:v>
                </c:pt>
                <c:pt idx="350">
                  <c:v>0.9328626835387589</c:v>
                </c:pt>
                <c:pt idx="351">
                  <c:v>0.93173656493123636</c:v>
                </c:pt>
                <c:pt idx="352">
                  <c:v>0.93335009933216728</c:v>
                </c:pt>
                <c:pt idx="353">
                  <c:v>0.93624375425500761</c:v>
                </c:pt>
                <c:pt idx="354">
                  <c:v>0.93807788968909978</c:v>
                </c:pt>
                <c:pt idx="355">
                  <c:v>0.93383936427265557</c:v>
                </c:pt>
                <c:pt idx="356">
                  <c:v>0.93594566942271962</c:v>
                </c:pt>
                <c:pt idx="357">
                  <c:v>0.93831733478412449</c:v>
                </c:pt>
                <c:pt idx="358">
                  <c:v>0.9412154298604718</c:v>
                </c:pt>
                <c:pt idx="359">
                  <c:v>0.94127999648994065</c:v>
                </c:pt>
                <c:pt idx="360">
                  <c:v>0.94265303663686495</c:v>
                </c:pt>
                <c:pt idx="361">
                  <c:v>0.94501266400382022</c:v>
                </c:pt>
                <c:pt idx="362">
                  <c:v>0.9482878308728605</c:v>
                </c:pt>
                <c:pt idx="363">
                  <c:v>0.94963987571013864</c:v>
                </c:pt>
                <c:pt idx="364">
                  <c:v>0.95063733264731065</c:v>
                </c:pt>
                <c:pt idx="365">
                  <c:v>0.95295587799115322</c:v>
                </c:pt>
                <c:pt idx="366">
                  <c:v>0.95323221596247976</c:v>
                </c:pt>
                <c:pt idx="367">
                  <c:v>0.95623457452368965</c:v>
                </c:pt>
                <c:pt idx="368">
                  <c:v>0.96109650032901373</c:v>
                </c:pt>
                <c:pt idx="369">
                  <c:v>0.96010959244208482</c:v>
                </c:pt>
                <c:pt idx="370">
                  <c:v>0.96080619945332979</c:v>
                </c:pt>
                <c:pt idx="371">
                  <c:v>0.96258342654798168</c:v>
                </c:pt>
                <c:pt idx="372">
                  <c:v>0.96270851573808458</c:v>
                </c:pt>
                <c:pt idx="373">
                  <c:v>0.96487269531537734</c:v>
                </c:pt>
                <c:pt idx="374">
                  <c:v>0.96420556264100565</c:v>
                </c:pt>
                <c:pt idx="375">
                  <c:v>0.96624300055807832</c:v>
                </c:pt>
                <c:pt idx="376">
                  <c:v>0.96702705501888575</c:v>
                </c:pt>
                <c:pt idx="377">
                  <c:v>0.96922099275792151</c:v>
                </c:pt>
                <c:pt idx="378">
                  <c:v>0.97023827572913168</c:v>
                </c:pt>
                <c:pt idx="379">
                  <c:v>0.97348274556697634</c:v>
                </c:pt>
                <c:pt idx="380">
                  <c:v>0.97356636380775941</c:v>
                </c:pt>
                <c:pt idx="381">
                  <c:v>0.97299594540890699</c:v>
                </c:pt>
                <c:pt idx="382">
                  <c:v>0.97441452563966013</c:v>
                </c:pt>
                <c:pt idx="383">
                  <c:v>0.97468717599546106</c:v>
                </c:pt>
                <c:pt idx="384">
                  <c:v>0.97513036285581467</c:v>
                </c:pt>
                <c:pt idx="385">
                  <c:v>0.97508307365921865</c:v>
                </c:pt>
                <c:pt idx="386">
                  <c:v>0.97275035207984584</c:v>
                </c:pt>
                <c:pt idx="387">
                  <c:v>0.97505214461610867</c:v>
                </c:pt>
                <c:pt idx="388">
                  <c:v>0.9777587007532057</c:v>
                </c:pt>
                <c:pt idx="389">
                  <c:v>0.9768665604614204</c:v>
                </c:pt>
                <c:pt idx="390">
                  <c:v>0.97719103464431822</c:v>
                </c:pt>
                <c:pt idx="391">
                  <c:v>0.97694909365178506</c:v>
                </c:pt>
                <c:pt idx="392">
                  <c:v>0.974146276091574</c:v>
                </c:pt>
                <c:pt idx="393">
                  <c:v>0.974753142057593</c:v>
                </c:pt>
                <c:pt idx="394">
                  <c:v>0.97598603981597243</c:v>
                </c:pt>
                <c:pt idx="395">
                  <c:v>0.97589177493036761</c:v>
                </c:pt>
                <c:pt idx="396">
                  <c:v>0.97919643680050616</c:v>
                </c:pt>
                <c:pt idx="397">
                  <c:v>0.97883221217895733</c:v>
                </c:pt>
                <c:pt idx="398">
                  <c:v>0.98011345313603326</c:v>
                </c:pt>
                <c:pt idx="399">
                  <c:v>0.98086501561280304</c:v>
                </c:pt>
                <c:pt idx="400">
                  <c:v>0.98174221443615861</c:v>
                </c:pt>
                <c:pt idx="401">
                  <c:v>0.98053356362811428</c:v>
                </c:pt>
                <c:pt idx="402">
                  <c:v>0.9813325269882881</c:v>
                </c:pt>
                <c:pt idx="403">
                  <c:v>0.98149039824075657</c:v>
                </c:pt>
                <c:pt idx="404">
                  <c:v>0.98285193851520025</c:v>
                </c:pt>
                <c:pt idx="405">
                  <c:v>0.98309518765998671</c:v>
                </c:pt>
                <c:pt idx="406">
                  <c:v>0.98372894162434554</c:v>
                </c:pt>
                <c:pt idx="407">
                  <c:v>0.98494810411516243</c:v>
                </c:pt>
                <c:pt idx="408">
                  <c:v>0.98488094376438706</c:v>
                </c:pt>
                <c:pt idx="409">
                  <c:v>0.98523303796528527</c:v>
                </c:pt>
                <c:pt idx="410">
                  <c:v>0.98825882903125739</c:v>
                </c:pt>
                <c:pt idx="411">
                  <c:v>0.98702371514974652</c:v>
                </c:pt>
                <c:pt idx="412">
                  <c:v>0.9853596506524519</c:v>
                </c:pt>
                <c:pt idx="413">
                  <c:v>0.9853192997127761</c:v>
                </c:pt>
                <c:pt idx="414">
                  <c:v>0.98677077910630018</c:v>
                </c:pt>
                <c:pt idx="415">
                  <c:v>0.98673340227210071</c:v>
                </c:pt>
                <c:pt idx="416">
                  <c:v>0.98807428830914945</c:v>
                </c:pt>
                <c:pt idx="417">
                  <c:v>0.98858397488941041</c:v>
                </c:pt>
                <c:pt idx="418">
                  <c:v>0.9869766892284727</c:v>
                </c:pt>
                <c:pt idx="419">
                  <c:v>0.98767131301531375</c:v>
                </c:pt>
                <c:pt idx="420">
                  <c:v>0.98610372472805519</c:v>
                </c:pt>
                <c:pt idx="421">
                  <c:v>0.98505495770394758</c:v>
                </c:pt>
                <c:pt idx="422">
                  <c:v>0.98530166162940969</c:v>
                </c:pt>
                <c:pt idx="423">
                  <c:v>0.98577962851611733</c:v>
                </c:pt>
                <c:pt idx="424">
                  <c:v>0.98656175590425965</c:v>
                </c:pt>
                <c:pt idx="425">
                  <c:v>0.98704982093707194</c:v>
                </c:pt>
                <c:pt idx="426">
                  <c:v>0.9861922027944664</c:v>
                </c:pt>
                <c:pt idx="427">
                  <c:v>0.98655131457506751</c:v>
                </c:pt>
                <c:pt idx="428">
                  <c:v>0.98676907820352033</c:v>
                </c:pt>
                <c:pt idx="429">
                  <c:v>0.9880724736868296</c:v>
                </c:pt>
                <c:pt idx="430">
                  <c:v>0.98735529256374155</c:v>
                </c:pt>
                <c:pt idx="431">
                  <c:v>0.98663646284031958</c:v>
                </c:pt>
                <c:pt idx="432">
                  <c:v>0.98653332223432466</c:v>
                </c:pt>
                <c:pt idx="433">
                  <c:v>0.98677869981918864</c:v>
                </c:pt>
                <c:pt idx="434">
                  <c:v>0.98457613954964796</c:v>
                </c:pt>
                <c:pt idx="435">
                  <c:v>0.98649907345751575</c:v>
                </c:pt>
                <c:pt idx="436">
                  <c:v>0.985715094233647</c:v>
                </c:pt>
                <c:pt idx="437">
                  <c:v>0.98487156182985258</c:v>
                </c:pt>
                <c:pt idx="438">
                  <c:v>0.98441572085304463</c:v>
                </c:pt>
                <c:pt idx="439">
                  <c:v>0.98365139905601551</c:v>
                </c:pt>
                <c:pt idx="440">
                  <c:v>0.98234290996222129</c:v>
                </c:pt>
                <c:pt idx="441">
                  <c:v>0.98007990789680155</c:v>
                </c:pt>
                <c:pt idx="442">
                  <c:v>0.98049684324273156</c:v>
                </c:pt>
                <c:pt idx="443">
                  <c:v>0.97889577221329982</c:v>
                </c:pt>
                <c:pt idx="444">
                  <c:v>0.97654091695493761</c:v>
                </c:pt>
                <c:pt idx="445">
                  <c:v>0.97669072153148784</c:v>
                </c:pt>
                <c:pt idx="446">
                  <c:v>0.97523405059833113</c:v>
                </c:pt>
                <c:pt idx="447">
                  <c:v>0.97406507288889677</c:v>
                </c:pt>
                <c:pt idx="448">
                  <c:v>0.97053761495387469</c:v>
                </c:pt>
                <c:pt idx="449">
                  <c:v>0.96895339307536654</c:v>
                </c:pt>
                <c:pt idx="450">
                  <c:v>0.96761543365314417</c:v>
                </c:pt>
                <c:pt idx="451">
                  <c:v>0.96561265801951934</c:v>
                </c:pt>
                <c:pt idx="452">
                  <c:v>0.96357506924529612</c:v>
                </c:pt>
                <c:pt idx="453">
                  <c:v>0.95990633996632757</c:v>
                </c:pt>
                <c:pt idx="454">
                  <c:v>0.95811736548352833</c:v>
                </c:pt>
                <c:pt idx="455">
                  <c:v>0.95585305027565592</c:v>
                </c:pt>
                <c:pt idx="456">
                  <c:v>0.95376450816581493</c:v>
                </c:pt>
                <c:pt idx="457">
                  <c:v>0.95029882847725267</c:v>
                </c:pt>
                <c:pt idx="458">
                  <c:v>0.94959521958599713</c:v>
                </c:pt>
                <c:pt idx="459">
                  <c:v>0.9462526445366275</c:v>
                </c:pt>
                <c:pt idx="460">
                  <c:v>0.94449434723560011</c:v>
                </c:pt>
                <c:pt idx="461">
                  <c:v>0.94445674666405377</c:v>
                </c:pt>
                <c:pt idx="462">
                  <c:v>0.9428028250062771</c:v>
                </c:pt>
                <c:pt idx="463">
                  <c:v>0.94091633371411787</c:v>
                </c:pt>
                <c:pt idx="464">
                  <c:v>0.93895791884098467</c:v>
                </c:pt>
                <c:pt idx="465">
                  <c:v>0.9385228079195117</c:v>
                </c:pt>
                <c:pt idx="466">
                  <c:v>0.93723657138304028</c:v>
                </c:pt>
                <c:pt idx="467">
                  <c:v>0.93651767061867763</c:v>
                </c:pt>
                <c:pt idx="468">
                  <c:v>0.93472875030051938</c:v>
                </c:pt>
                <c:pt idx="469">
                  <c:v>0.931190055959361</c:v>
                </c:pt>
                <c:pt idx="470">
                  <c:v>0.92870114198652409</c:v>
                </c:pt>
                <c:pt idx="471">
                  <c:v>0.92592103406840909</c:v>
                </c:pt>
                <c:pt idx="472">
                  <c:v>0.92347876569478682</c:v>
                </c:pt>
                <c:pt idx="473">
                  <c:v>0.92152010658157824</c:v>
                </c:pt>
                <c:pt idx="474">
                  <c:v>0.91891100582783158</c:v>
                </c:pt>
                <c:pt idx="475">
                  <c:v>0.9160645463734316</c:v>
                </c:pt>
                <c:pt idx="476">
                  <c:v>0.91281524247374712</c:v>
                </c:pt>
                <c:pt idx="477">
                  <c:v>0.91139162335096691</c:v>
                </c:pt>
                <c:pt idx="478">
                  <c:v>0.90713496048480813</c:v>
                </c:pt>
                <c:pt idx="479">
                  <c:v>0.90499397203693388</c:v>
                </c:pt>
                <c:pt idx="480">
                  <c:v>0.90222618433538049</c:v>
                </c:pt>
                <c:pt idx="481">
                  <c:v>0.90012270159840513</c:v>
                </c:pt>
                <c:pt idx="482">
                  <c:v>0.89737925103055072</c:v>
                </c:pt>
                <c:pt idx="483">
                  <c:v>0.89450018065943249</c:v>
                </c:pt>
                <c:pt idx="484">
                  <c:v>0.89227125830184084</c:v>
                </c:pt>
                <c:pt idx="485">
                  <c:v>0.88931581764663381</c:v>
                </c:pt>
                <c:pt idx="486">
                  <c:v>0.88460827395411401</c:v>
                </c:pt>
                <c:pt idx="487">
                  <c:v>0.88216453763667357</c:v>
                </c:pt>
                <c:pt idx="488">
                  <c:v>0.87965214229809963</c:v>
                </c:pt>
                <c:pt idx="489">
                  <c:v>0.8774703816188838</c:v>
                </c:pt>
                <c:pt idx="490">
                  <c:v>0.87502367296963124</c:v>
                </c:pt>
                <c:pt idx="491">
                  <c:v>0.87129427866860765</c:v>
                </c:pt>
                <c:pt idx="492">
                  <c:v>0.86977825985487045</c:v>
                </c:pt>
                <c:pt idx="493">
                  <c:v>0.8681954011099805</c:v>
                </c:pt>
                <c:pt idx="494">
                  <c:v>0.86699001961779498</c:v>
                </c:pt>
                <c:pt idx="495">
                  <c:v>0.8653806524071026</c:v>
                </c:pt>
                <c:pt idx="496">
                  <c:v>0.86550711959006854</c:v>
                </c:pt>
                <c:pt idx="497">
                  <c:v>0.86411973259829289</c:v>
                </c:pt>
                <c:pt idx="498">
                  <c:v>0.86565032772650474</c:v>
                </c:pt>
                <c:pt idx="499">
                  <c:v>0.8658406827449866</c:v>
                </c:pt>
                <c:pt idx="500">
                  <c:v>0.86465786907970343</c:v>
                </c:pt>
                <c:pt idx="501">
                  <c:v>0.86275163162675672</c:v>
                </c:pt>
                <c:pt idx="502">
                  <c:v>0.86157362491238842</c:v>
                </c:pt>
                <c:pt idx="503">
                  <c:v>0.8598817038982447</c:v>
                </c:pt>
                <c:pt idx="504">
                  <c:v>0.85882019120552278</c:v>
                </c:pt>
                <c:pt idx="505">
                  <c:v>0.85741955396396996</c:v>
                </c:pt>
                <c:pt idx="506">
                  <c:v>0.85653934130362097</c:v>
                </c:pt>
                <c:pt idx="507">
                  <c:v>0.85456465135784077</c:v>
                </c:pt>
                <c:pt idx="508">
                  <c:v>0.8524303230125635</c:v>
                </c:pt>
                <c:pt idx="509">
                  <c:v>0.84892883177425571</c:v>
                </c:pt>
                <c:pt idx="510">
                  <c:v>0.84866181931509443</c:v>
                </c:pt>
                <c:pt idx="511">
                  <c:v>0.8477191861103458</c:v>
                </c:pt>
                <c:pt idx="512">
                  <c:v>0.84439158987587015</c:v>
                </c:pt>
                <c:pt idx="513">
                  <c:v>0.84225706462226857</c:v>
                </c:pt>
                <c:pt idx="514">
                  <c:v>0.83911621665491365</c:v>
                </c:pt>
                <c:pt idx="515">
                  <c:v>0.83768314123915744</c:v>
                </c:pt>
                <c:pt idx="516">
                  <c:v>0.83552762317712215</c:v>
                </c:pt>
                <c:pt idx="517">
                  <c:v>0.83336444923937969</c:v>
                </c:pt>
                <c:pt idx="518">
                  <c:v>0.83052664911914309</c:v>
                </c:pt>
                <c:pt idx="519">
                  <c:v>0.82889026661805765</c:v>
                </c:pt>
                <c:pt idx="520">
                  <c:v>0.82555166850499695</c:v>
                </c:pt>
                <c:pt idx="521">
                  <c:v>0.82339399335661567</c:v>
                </c:pt>
                <c:pt idx="522">
                  <c:v>0.81783337966744951</c:v>
                </c:pt>
                <c:pt idx="523">
                  <c:v>0.81479632489932741</c:v>
                </c:pt>
                <c:pt idx="524">
                  <c:v>0.81347296519941636</c:v>
                </c:pt>
                <c:pt idx="525">
                  <c:v>0.8126845535514825</c:v>
                </c:pt>
                <c:pt idx="526">
                  <c:v>0.81142286368616467</c:v>
                </c:pt>
                <c:pt idx="527">
                  <c:v>0.81035655770382053</c:v>
                </c:pt>
                <c:pt idx="528">
                  <c:v>0.80799101361791048</c:v>
                </c:pt>
                <c:pt idx="529">
                  <c:v>0.80669826347319917</c:v>
                </c:pt>
                <c:pt idx="530">
                  <c:v>0.80362194304343582</c:v>
                </c:pt>
                <c:pt idx="531">
                  <c:v>0.80267917174470771</c:v>
                </c:pt>
                <c:pt idx="532">
                  <c:v>0.80094203933077768</c:v>
                </c:pt>
                <c:pt idx="533">
                  <c:v>0.79975946420420663</c:v>
                </c:pt>
                <c:pt idx="534">
                  <c:v>0.79667610521922538</c:v>
                </c:pt>
                <c:pt idx="535">
                  <c:v>0.79465858120664457</c:v>
                </c:pt>
                <c:pt idx="536">
                  <c:v>0.79596839418916876</c:v>
                </c:pt>
                <c:pt idx="537">
                  <c:v>0.79435978889163761</c:v>
                </c:pt>
                <c:pt idx="538">
                  <c:v>0.79329554848328565</c:v>
                </c:pt>
                <c:pt idx="539">
                  <c:v>0.79204653861412455</c:v>
                </c:pt>
                <c:pt idx="540">
                  <c:v>0.7926742841008646</c:v>
                </c:pt>
                <c:pt idx="541">
                  <c:v>0.79288866729707264</c:v>
                </c:pt>
                <c:pt idx="542">
                  <c:v>0.79279748546324069</c:v>
                </c:pt>
                <c:pt idx="543">
                  <c:v>0.79250540860050156</c:v>
                </c:pt>
                <c:pt idx="544">
                  <c:v>0.79336499284160256</c:v>
                </c:pt>
                <c:pt idx="545">
                  <c:v>0.79231054684043656</c:v>
                </c:pt>
                <c:pt idx="546">
                  <c:v>0.7926384148199207</c:v>
                </c:pt>
                <c:pt idx="547">
                  <c:v>0.79153693739389264</c:v>
                </c:pt>
                <c:pt idx="548">
                  <c:v>0.79071172594819272</c:v>
                </c:pt>
                <c:pt idx="549">
                  <c:v>0.79006832084192236</c:v>
                </c:pt>
                <c:pt idx="550">
                  <c:v>0.79013616706445366</c:v>
                </c:pt>
                <c:pt idx="551">
                  <c:v>0.78815176563589762</c:v>
                </c:pt>
                <c:pt idx="552">
                  <c:v>0.78860764033693553</c:v>
                </c:pt>
                <c:pt idx="553">
                  <c:v>0.78819227066529185</c:v>
                </c:pt>
                <c:pt idx="554">
                  <c:v>0.78812585519821465</c:v>
                </c:pt>
                <c:pt idx="555">
                  <c:v>0.78796111912198741</c:v>
                </c:pt>
                <c:pt idx="556">
                  <c:v>0.78888391400569924</c:v>
                </c:pt>
                <c:pt idx="557">
                  <c:v>0.79001550456542635</c:v>
                </c:pt>
                <c:pt idx="558">
                  <c:v>0.79045010075348154</c:v>
                </c:pt>
                <c:pt idx="559">
                  <c:v>0.78981677349651169</c:v>
                </c:pt>
                <c:pt idx="560">
                  <c:v>0.78896287785661956</c:v>
                </c:pt>
                <c:pt idx="561">
                  <c:v>0.79159061526658259</c:v>
                </c:pt>
                <c:pt idx="562">
                  <c:v>0.79186669507157104</c:v>
                </c:pt>
                <c:pt idx="563">
                  <c:v>0.79081135626164389</c:v>
                </c:pt>
                <c:pt idx="564">
                  <c:v>0.788837777896089</c:v>
                </c:pt>
                <c:pt idx="565">
                  <c:v>0.78826128054658884</c:v>
                </c:pt>
                <c:pt idx="566">
                  <c:v>0.78856538111315666</c:v>
                </c:pt>
                <c:pt idx="567">
                  <c:v>0.78754249506823959</c:v>
                </c:pt>
                <c:pt idx="568">
                  <c:v>0.78580174891512422</c:v>
                </c:pt>
                <c:pt idx="569">
                  <c:v>0.78466940141465591</c:v>
                </c:pt>
                <c:pt idx="570">
                  <c:v>0.78435482557453562</c:v>
                </c:pt>
                <c:pt idx="571">
                  <c:v>0.78394251787074209</c:v>
                </c:pt>
                <c:pt idx="572">
                  <c:v>0.78277699502506426</c:v>
                </c:pt>
                <c:pt idx="573">
                  <c:v>0.78295126638198864</c:v>
                </c:pt>
                <c:pt idx="574">
                  <c:v>0.78283404925219979</c:v>
                </c:pt>
                <c:pt idx="575">
                  <c:v>0.78473803536572762</c:v>
                </c:pt>
                <c:pt idx="576">
                  <c:v>0.78498759678325458</c:v>
                </c:pt>
                <c:pt idx="577">
                  <c:v>0.78575167072009122</c:v>
                </c:pt>
                <c:pt idx="578">
                  <c:v>0.78586727259474964</c:v>
                </c:pt>
                <c:pt idx="579">
                  <c:v>0.78647685435457471</c:v>
                </c:pt>
                <c:pt idx="580">
                  <c:v>0.78718438894769949</c:v>
                </c:pt>
                <c:pt idx="581">
                  <c:v>0.78854240745768289</c:v>
                </c:pt>
                <c:pt idx="582">
                  <c:v>0.7884062336207327</c:v>
                </c:pt>
                <c:pt idx="583">
                  <c:v>0.78920747266114599</c:v>
                </c:pt>
                <c:pt idx="584">
                  <c:v>0.79093827536594141</c:v>
                </c:pt>
                <c:pt idx="585">
                  <c:v>0.7891562412165859</c:v>
                </c:pt>
                <c:pt idx="586">
                  <c:v>0.78971295298795074</c:v>
                </c:pt>
                <c:pt idx="587">
                  <c:v>0.7918039768293067</c:v>
                </c:pt>
                <c:pt idx="588">
                  <c:v>0.79307147073699913</c:v>
                </c:pt>
                <c:pt idx="589">
                  <c:v>0.79388820370951374</c:v>
                </c:pt>
                <c:pt idx="590">
                  <c:v>0.79333346467388022</c:v>
                </c:pt>
                <c:pt idx="591">
                  <c:v>0.79349801317362134</c:v>
                </c:pt>
                <c:pt idx="592">
                  <c:v>0.79347218097201733</c:v>
                </c:pt>
                <c:pt idx="593">
                  <c:v>0.79462087668371273</c:v>
                </c:pt>
                <c:pt idx="594">
                  <c:v>0.79585746910705457</c:v>
                </c:pt>
                <c:pt idx="595">
                  <c:v>0.79812151897314865</c:v>
                </c:pt>
                <c:pt idx="596">
                  <c:v>0.80043518421554827</c:v>
                </c:pt>
                <c:pt idx="597">
                  <c:v>0.80116694717162595</c:v>
                </c:pt>
                <c:pt idx="598">
                  <c:v>0.80186635202268519</c:v>
                </c:pt>
                <c:pt idx="599">
                  <c:v>0.80242041723455582</c:v>
                </c:pt>
                <c:pt idx="600">
                  <c:v>0.80469674255019086</c:v>
                </c:pt>
                <c:pt idx="601">
                  <c:v>0.80476488236580035</c:v>
                </c:pt>
                <c:pt idx="602">
                  <c:v>0.80636836918311949</c:v>
                </c:pt>
                <c:pt idx="603">
                  <c:v>0.80653248567261437</c:v>
                </c:pt>
                <c:pt idx="604">
                  <c:v>0.80773940991855464</c:v>
                </c:pt>
                <c:pt idx="605">
                  <c:v>0.80831251478329658</c:v>
                </c:pt>
                <c:pt idx="606">
                  <c:v>0.81346152026539054</c:v>
                </c:pt>
                <c:pt idx="607">
                  <c:v>0.81443273350977463</c:v>
                </c:pt>
                <c:pt idx="608">
                  <c:v>0.81497337925183333</c:v>
                </c:pt>
                <c:pt idx="609">
                  <c:v>0.81394276146970801</c:v>
                </c:pt>
                <c:pt idx="610">
                  <c:v>0.81475896325145392</c:v>
                </c:pt>
                <c:pt idx="611">
                  <c:v>0.81618735479911653</c:v>
                </c:pt>
                <c:pt idx="612">
                  <c:v>0.81757253297675658</c:v>
                </c:pt>
                <c:pt idx="613">
                  <c:v>0.81842344667610134</c:v>
                </c:pt>
                <c:pt idx="614">
                  <c:v>0.81975478996979489</c:v>
                </c:pt>
                <c:pt idx="615">
                  <c:v>0.82044076304369273</c:v>
                </c:pt>
                <c:pt idx="616">
                  <c:v>0.82308288370789029</c:v>
                </c:pt>
                <c:pt idx="617">
                  <c:v>0.82446626942521839</c:v>
                </c:pt>
                <c:pt idx="618">
                  <c:v>0.82451106289015752</c:v>
                </c:pt>
                <c:pt idx="619">
                  <c:v>0.82522061968454086</c:v>
                </c:pt>
                <c:pt idx="620">
                  <c:v>0.8248062691042789</c:v>
                </c:pt>
                <c:pt idx="621">
                  <c:v>0.82502570441794487</c:v>
                </c:pt>
                <c:pt idx="622">
                  <c:v>0.82699924914328882</c:v>
                </c:pt>
                <c:pt idx="623">
                  <c:v>0.82797328131967363</c:v>
                </c:pt>
                <c:pt idx="624">
                  <c:v>0.82703515823541163</c:v>
                </c:pt>
                <c:pt idx="625">
                  <c:v>0.82867116057222479</c:v>
                </c:pt>
                <c:pt idx="626">
                  <c:v>0.82977357737389457</c:v>
                </c:pt>
                <c:pt idx="627">
                  <c:v>0.83148501211530113</c:v>
                </c:pt>
                <c:pt idx="628">
                  <c:v>0.83154420813013574</c:v>
                </c:pt>
                <c:pt idx="629">
                  <c:v>0.82983075862406264</c:v>
                </c:pt>
                <c:pt idx="630">
                  <c:v>0.8271696482074562</c:v>
                </c:pt>
                <c:pt idx="631">
                  <c:v>0.82816099349685179</c:v>
                </c:pt>
                <c:pt idx="632">
                  <c:v>0.82725101740534146</c:v>
                </c:pt>
                <c:pt idx="633">
                  <c:v>0.82940332501726644</c:v>
                </c:pt>
                <c:pt idx="634">
                  <c:v>0.83184604559486364</c:v>
                </c:pt>
                <c:pt idx="635">
                  <c:v>0.83384638082085549</c:v>
                </c:pt>
                <c:pt idx="636">
                  <c:v>0.8325264014987287</c:v>
                </c:pt>
                <c:pt idx="637">
                  <c:v>0.83314379374572101</c:v>
                </c:pt>
                <c:pt idx="638">
                  <c:v>0.8358469577879345</c:v>
                </c:pt>
                <c:pt idx="639">
                  <c:v>0.83892463353798896</c:v>
                </c:pt>
                <c:pt idx="640">
                  <c:v>0.83992828339000425</c:v>
                </c:pt>
                <c:pt idx="641">
                  <c:v>0.84060013467808914</c:v>
                </c:pt>
                <c:pt idx="642">
                  <c:v>0.8422969142052027</c:v>
                </c:pt>
                <c:pt idx="643">
                  <c:v>0.8441469011688536</c:v>
                </c:pt>
                <c:pt idx="644">
                  <c:v>0.84486409744862034</c:v>
                </c:pt>
                <c:pt idx="645">
                  <c:v>0.84679713114895583</c:v>
                </c:pt>
                <c:pt idx="646">
                  <c:v>0.84834828860718192</c:v>
                </c:pt>
                <c:pt idx="647">
                  <c:v>0.84809061444736733</c:v>
                </c:pt>
                <c:pt idx="648">
                  <c:v>0.85139112105614423</c:v>
                </c:pt>
                <c:pt idx="649">
                  <c:v>0.85276916578692108</c:v>
                </c:pt>
                <c:pt idx="650">
                  <c:v>0.85444653547971161</c:v>
                </c:pt>
                <c:pt idx="651">
                  <c:v>0.85567936437288739</c:v>
                </c:pt>
                <c:pt idx="652">
                  <c:v>0.85732909000848057</c:v>
                </c:pt>
                <c:pt idx="653">
                  <c:v>0.85863259389318158</c:v>
                </c:pt>
                <c:pt idx="654">
                  <c:v>0.85968445899569701</c:v>
                </c:pt>
                <c:pt idx="655">
                  <c:v>0.85995400967764712</c:v>
                </c:pt>
                <c:pt idx="656">
                  <c:v>0.86336506795373169</c:v>
                </c:pt>
                <c:pt idx="657">
                  <c:v>0.86613110229837809</c:v>
                </c:pt>
                <c:pt idx="658">
                  <c:v>0.86656082693138403</c:v>
                </c:pt>
                <c:pt idx="659">
                  <c:v>0.86663693233251216</c:v>
                </c:pt>
                <c:pt idx="660">
                  <c:v>0.86978177786709054</c:v>
                </c:pt>
                <c:pt idx="661">
                  <c:v>0.87283843409304784</c:v>
                </c:pt>
                <c:pt idx="662">
                  <c:v>0.87329576427871536</c:v>
                </c:pt>
                <c:pt idx="663">
                  <c:v>0.87453067044325661</c:v>
                </c:pt>
                <c:pt idx="664">
                  <c:v>0.87618580826469472</c:v>
                </c:pt>
                <c:pt idx="665">
                  <c:v>0.87805985470952985</c:v>
                </c:pt>
                <c:pt idx="666">
                  <c:v>0.87951339676851481</c:v>
                </c:pt>
                <c:pt idx="667">
                  <c:v>0.88005805367899104</c:v>
                </c:pt>
                <c:pt idx="668">
                  <c:v>0.88439484761682308</c:v>
                </c:pt>
                <c:pt idx="669">
                  <c:v>0.88570902829814591</c:v>
                </c:pt>
                <c:pt idx="670">
                  <c:v>0.8846100119641358</c:v>
                </c:pt>
                <c:pt idx="671">
                  <c:v>0.88876929611581912</c:v>
                </c:pt>
                <c:pt idx="672">
                  <c:v>0.88835752287346359</c:v>
                </c:pt>
                <c:pt idx="673">
                  <c:v>0.89013632280325727</c:v>
                </c:pt>
                <c:pt idx="674">
                  <c:v>0.89168181372612287</c:v>
                </c:pt>
                <c:pt idx="675">
                  <c:v>0.89296025400671453</c:v>
                </c:pt>
                <c:pt idx="676">
                  <c:v>0.89509961121135884</c:v>
                </c:pt>
                <c:pt idx="677">
                  <c:v>0.89814393237782031</c:v>
                </c:pt>
                <c:pt idx="678">
                  <c:v>0.90052231203389665</c:v>
                </c:pt>
                <c:pt idx="679">
                  <c:v>0.90391427448211814</c:v>
                </c:pt>
                <c:pt idx="680">
                  <c:v>0.90401284862740716</c:v>
                </c:pt>
                <c:pt idx="681">
                  <c:v>0.90473304799668497</c:v>
                </c:pt>
                <c:pt idx="682">
                  <c:v>0.90716570401971619</c:v>
                </c:pt>
                <c:pt idx="683">
                  <c:v>0.90908495286433533</c:v>
                </c:pt>
                <c:pt idx="684">
                  <c:v>0.91217454195464509</c:v>
                </c:pt>
                <c:pt idx="685">
                  <c:v>0.91310674851402707</c:v>
                </c:pt>
                <c:pt idx="686">
                  <c:v>0.913970318410811</c:v>
                </c:pt>
                <c:pt idx="687">
                  <c:v>0.91379380455311265</c:v>
                </c:pt>
                <c:pt idx="688">
                  <c:v>0.91671994839811299</c:v>
                </c:pt>
                <c:pt idx="689">
                  <c:v>0.91810221876051623</c:v>
                </c:pt>
                <c:pt idx="690">
                  <c:v>0.9205958869023767</c:v>
                </c:pt>
                <c:pt idx="691">
                  <c:v>0.92347663568383764</c:v>
                </c:pt>
                <c:pt idx="692">
                  <c:v>0.92348540280800961</c:v>
                </c:pt>
                <c:pt idx="693">
                  <c:v>0.92477386664353811</c:v>
                </c:pt>
                <c:pt idx="694">
                  <c:v>0.92689329195799697</c:v>
                </c:pt>
                <c:pt idx="695">
                  <c:v>0.92713827528751269</c:v>
                </c:pt>
                <c:pt idx="696">
                  <c:v>0.92889325685797564</c:v>
                </c:pt>
                <c:pt idx="697">
                  <c:v>0.93052168033873861</c:v>
                </c:pt>
                <c:pt idx="698">
                  <c:v>0.93128428468489066</c:v>
                </c:pt>
                <c:pt idx="699">
                  <c:v>0.93094091282068536</c:v>
                </c:pt>
                <c:pt idx="700">
                  <c:v>0.93196887030904063</c:v>
                </c:pt>
                <c:pt idx="701">
                  <c:v>0.93359061872511961</c:v>
                </c:pt>
                <c:pt idx="702">
                  <c:v>0.93669092984786839</c:v>
                </c:pt>
                <c:pt idx="703">
                  <c:v>0.93722003334120063</c:v>
                </c:pt>
                <c:pt idx="704">
                  <c:v>0.9391413801223415</c:v>
                </c:pt>
                <c:pt idx="705">
                  <c:v>0.94086616667321277</c:v>
                </c:pt>
                <c:pt idx="706">
                  <c:v>0.94050900750719979</c:v>
                </c:pt>
                <c:pt idx="707">
                  <c:v>0.9422849168480838</c:v>
                </c:pt>
                <c:pt idx="708">
                  <c:v>0.94275246963838144</c:v>
                </c:pt>
                <c:pt idx="709">
                  <c:v>0.9428709749091001</c:v>
                </c:pt>
                <c:pt idx="710">
                  <c:v>0.94623427657969705</c:v>
                </c:pt>
                <c:pt idx="711">
                  <c:v>0.9489375817111233</c:v>
                </c:pt>
                <c:pt idx="712">
                  <c:v>0.94966481751491771</c:v>
                </c:pt>
                <c:pt idx="713">
                  <c:v>0.95067790562095567</c:v>
                </c:pt>
                <c:pt idx="714">
                  <c:v>0.9505040873353604</c:v>
                </c:pt>
                <c:pt idx="715">
                  <c:v>0.95049282990420358</c:v>
                </c:pt>
                <c:pt idx="716">
                  <c:v>0.95111524742103271</c:v>
                </c:pt>
                <c:pt idx="717">
                  <c:v>0.95327012050419713</c:v>
                </c:pt>
                <c:pt idx="718">
                  <c:v>0.95672812096672066</c:v>
                </c:pt>
                <c:pt idx="719">
                  <c:v>0.95718898994306356</c:v>
                </c:pt>
                <c:pt idx="720">
                  <c:v>0.95955205873937188</c:v>
                </c:pt>
                <c:pt idx="721">
                  <c:v>0.96124868082672954</c:v>
                </c:pt>
                <c:pt idx="722">
                  <c:v>0.9629822092143896</c:v>
                </c:pt>
                <c:pt idx="723">
                  <c:v>0.96575685497150865</c:v>
                </c:pt>
                <c:pt idx="724">
                  <c:v>0.96719242284802065</c:v>
                </c:pt>
                <c:pt idx="725">
                  <c:v>0.96739274086022842</c:v>
                </c:pt>
                <c:pt idx="726">
                  <c:v>0.96658706116358961</c:v>
                </c:pt>
                <c:pt idx="727">
                  <c:v>0.96719980663976357</c:v>
                </c:pt>
                <c:pt idx="728">
                  <c:v>0.9676043684925667</c:v>
                </c:pt>
                <c:pt idx="729">
                  <c:v>0.96883002437366184</c:v>
                </c:pt>
                <c:pt idx="730">
                  <c:v>0.9719437856404276</c:v>
                </c:pt>
                <c:pt idx="731">
                  <c:v>0.97287825005119821</c:v>
                </c:pt>
                <c:pt idx="732">
                  <c:v>0.9744201477340757</c:v>
                </c:pt>
                <c:pt idx="733">
                  <c:v>0.9761832639827086</c:v>
                </c:pt>
                <c:pt idx="734">
                  <c:v>0.97694155938769889</c:v>
                </c:pt>
                <c:pt idx="735">
                  <c:v>0.97765708279111263</c:v>
                </c:pt>
                <c:pt idx="736">
                  <c:v>0.97808327648046112</c:v>
                </c:pt>
                <c:pt idx="737">
                  <c:v>0.98134873992007632</c:v>
                </c:pt>
                <c:pt idx="738">
                  <c:v>0.98447058786820862</c:v>
                </c:pt>
                <c:pt idx="739">
                  <c:v>0.9865715476164838</c:v>
                </c:pt>
                <c:pt idx="740">
                  <c:v>0.988614505188813</c:v>
                </c:pt>
                <c:pt idx="741">
                  <c:v>0.98959921263429274</c:v>
                </c:pt>
                <c:pt idx="742">
                  <c:v>0.99026326684374888</c:v>
                </c:pt>
                <c:pt idx="743">
                  <c:v>0.99185955933990277</c:v>
                </c:pt>
                <c:pt idx="744">
                  <c:v>0.99198415080508806</c:v>
                </c:pt>
                <c:pt idx="745">
                  <c:v>0.9929305421753315</c:v>
                </c:pt>
                <c:pt idx="746">
                  <c:v>0.99407042899035458</c:v>
                </c:pt>
                <c:pt idx="747">
                  <c:v>0.99491900359386165</c:v>
                </c:pt>
                <c:pt idx="748">
                  <c:v>0.99576315851107344</c:v>
                </c:pt>
                <c:pt idx="749">
                  <c:v>0.99845368046268257</c:v>
                </c:pt>
                <c:pt idx="750">
                  <c:v>1.0000090369941239</c:v>
                </c:pt>
                <c:pt idx="751">
                  <c:v>1.0015403699616343</c:v>
                </c:pt>
                <c:pt idx="752">
                  <c:v>1.00368957468008</c:v>
                </c:pt>
                <c:pt idx="753">
                  <c:v>1.0043047208237381</c:v>
                </c:pt>
                <c:pt idx="754">
                  <c:v>1.0032983063306438</c:v>
                </c:pt>
                <c:pt idx="755">
                  <c:v>1.003011160844923</c:v>
                </c:pt>
                <c:pt idx="756">
                  <c:v>1.002716081293846</c:v>
                </c:pt>
                <c:pt idx="757">
                  <c:v>1.0034563647247641</c:v>
                </c:pt>
                <c:pt idx="758">
                  <c:v>1.0026635160172284</c:v>
                </c:pt>
                <c:pt idx="759">
                  <c:v>1.0035088391190758</c:v>
                </c:pt>
                <c:pt idx="760">
                  <c:v>1.0047625243854261</c:v>
                </c:pt>
                <c:pt idx="761">
                  <c:v>1.0036025824789598</c:v>
                </c:pt>
                <c:pt idx="762">
                  <c:v>1.0023054275502701</c:v>
                </c:pt>
                <c:pt idx="763">
                  <c:v>1.0022816895101878</c:v>
                </c:pt>
                <c:pt idx="764">
                  <c:v>1.0023186828766655</c:v>
                </c:pt>
                <c:pt idx="765">
                  <c:v>1.0020798789026049</c:v>
                </c:pt>
                <c:pt idx="766">
                  <c:v>1.0031195543190319</c:v>
                </c:pt>
                <c:pt idx="767">
                  <c:v>1.0049681986590318</c:v>
                </c:pt>
                <c:pt idx="768">
                  <c:v>1.0051776610485321</c:v>
                </c:pt>
                <c:pt idx="769">
                  <c:v>1.0055535155803419</c:v>
                </c:pt>
                <c:pt idx="770">
                  <c:v>1.0066600255964051</c:v>
                </c:pt>
                <c:pt idx="771">
                  <c:v>1.006799418509899</c:v>
                </c:pt>
                <c:pt idx="772">
                  <c:v>1.0073701872088454</c:v>
                </c:pt>
                <c:pt idx="773">
                  <c:v>1.007474458807041</c:v>
                </c:pt>
                <c:pt idx="774">
                  <c:v>1.0079563636315281</c:v>
                </c:pt>
                <c:pt idx="775">
                  <c:v>1.0081048697377482</c:v>
                </c:pt>
                <c:pt idx="776">
                  <c:v>1.0085714058879958</c:v>
                </c:pt>
                <c:pt idx="777">
                  <c:v>1.0088179656461476</c:v>
                </c:pt>
                <c:pt idx="778">
                  <c:v>1.011075793851812</c:v>
                </c:pt>
                <c:pt idx="779">
                  <c:v>1.0113219610582089</c:v>
                </c:pt>
                <c:pt idx="780">
                  <c:v>1.0120575497275877</c:v>
                </c:pt>
                <c:pt idx="781">
                  <c:v>1.0113540541494725</c:v>
                </c:pt>
                <c:pt idx="782">
                  <c:v>1.013436551711038</c:v>
                </c:pt>
                <c:pt idx="783">
                  <c:v>1.0130132238965681</c:v>
                </c:pt>
                <c:pt idx="784">
                  <c:v>1.0132859681348001</c:v>
                </c:pt>
                <c:pt idx="785">
                  <c:v>1.0142884433061301</c:v>
                </c:pt>
                <c:pt idx="786">
                  <c:v>1.0153009674477402</c:v>
                </c:pt>
                <c:pt idx="787">
                  <c:v>1.0134451582193298</c:v>
                </c:pt>
                <c:pt idx="788">
                  <c:v>1.0126117753144637</c:v>
                </c:pt>
                <c:pt idx="789">
                  <c:v>1.0137106303282237</c:v>
                </c:pt>
                <c:pt idx="790">
                  <c:v>1.0128060029429338</c:v>
                </c:pt>
                <c:pt idx="791">
                  <c:v>1.0130697209274018</c:v>
                </c:pt>
                <c:pt idx="792">
                  <c:v>1.0145289827891868</c:v>
                </c:pt>
                <c:pt idx="793">
                  <c:v>1.0124438047478761</c:v>
                </c:pt>
                <c:pt idx="794">
                  <c:v>1.0130036002883858</c:v>
                </c:pt>
                <c:pt idx="795">
                  <c:v>1.0150330721089698</c:v>
                </c:pt>
                <c:pt idx="796">
                  <c:v>1.0156976299100915</c:v>
                </c:pt>
                <c:pt idx="797">
                  <c:v>1.0157767312806898</c:v>
                </c:pt>
                <c:pt idx="798">
                  <c:v>1.0139975073729652</c:v>
                </c:pt>
                <c:pt idx="799">
                  <c:v>1.0121835640955741</c:v>
                </c:pt>
                <c:pt idx="800">
                  <c:v>1.0139501239184621</c:v>
                </c:pt>
                <c:pt idx="801">
                  <c:v>1.0153488378419613</c:v>
                </c:pt>
                <c:pt idx="802">
                  <c:v>1.0151862396387801</c:v>
                </c:pt>
                <c:pt idx="803">
                  <c:v>1.0159063526942758</c:v>
                </c:pt>
                <c:pt idx="804">
                  <c:v>1.0178994509118937</c:v>
                </c:pt>
                <c:pt idx="805">
                  <c:v>1.0179105679894678</c:v>
                </c:pt>
                <c:pt idx="806">
                  <c:v>1.0175312757067658</c:v>
                </c:pt>
                <c:pt idx="807">
                  <c:v>1.0170915870175719</c:v>
                </c:pt>
                <c:pt idx="808">
                  <c:v>1.0175510941640757</c:v>
                </c:pt>
                <c:pt idx="809">
                  <c:v>1.0205276016839726</c:v>
                </c:pt>
                <c:pt idx="810">
                  <c:v>1.0215031701805133</c:v>
                </c:pt>
                <c:pt idx="811">
                  <c:v>1.0230407682112783</c:v>
                </c:pt>
                <c:pt idx="812">
                  <c:v>1.0227785273368102</c:v>
                </c:pt>
                <c:pt idx="813">
                  <c:v>1.022039324957678</c:v>
                </c:pt>
                <c:pt idx="814">
                  <c:v>1.0229969624034358</c:v>
                </c:pt>
                <c:pt idx="815">
                  <c:v>1.0210513572597451</c:v>
                </c:pt>
                <c:pt idx="816">
                  <c:v>1.0197377948761359</c:v>
                </c:pt>
                <c:pt idx="817">
                  <c:v>1.0213630296518441</c:v>
                </c:pt>
                <c:pt idx="818">
                  <c:v>1.0192575169758293</c:v>
                </c:pt>
                <c:pt idx="819">
                  <c:v>1.0164435705824959</c:v>
                </c:pt>
                <c:pt idx="820">
                  <c:v>1.0141568125963325</c:v>
                </c:pt>
                <c:pt idx="821">
                  <c:v>1.0117270910273037</c:v>
                </c:pt>
                <c:pt idx="822">
                  <c:v>1.014220402001085</c:v>
                </c:pt>
                <c:pt idx="823">
                  <c:v>1.0188459909431309</c:v>
                </c:pt>
                <c:pt idx="824">
                  <c:v>1.0171752146932225</c:v>
                </c:pt>
                <c:pt idx="825">
                  <c:v>1.015416875187479</c:v>
                </c:pt>
                <c:pt idx="826">
                  <c:v>1.0160654499249413</c:v>
                </c:pt>
                <c:pt idx="827">
                  <c:v>1.0165242617197232</c:v>
                </c:pt>
                <c:pt idx="828">
                  <c:v>1.0176291492475438</c:v>
                </c:pt>
                <c:pt idx="829">
                  <c:v>1.0192176864061626</c:v>
                </c:pt>
                <c:pt idx="830">
                  <c:v>1.0174853677739693</c:v>
                </c:pt>
                <c:pt idx="831">
                  <c:v>1.0188291524006676</c:v>
                </c:pt>
                <c:pt idx="832">
                  <c:v>1.0159927272037999</c:v>
                </c:pt>
                <c:pt idx="833">
                  <c:v>1.0137947378558094</c:v>
                </c:pt>
                <c:pt idx="834">
                  <c:v>1.0128654996397235</c:v>
                </c:pt>
                <c:pt idx="835">
                  <c:v>1.0111301841559142</c:v>
                </c:pt>
                <c:pt idx="836">
                  <c:v>1.0152243804403129</c:v>
                </c:pt>
                <c:pt idx="837">
                  <c:v>1.0171569673930547</c:v>
                </c:pt>
                <c:pt idx="838">
                  <c:v>1.0181094174316259</c:v>
                </c:pt>
                <c:pt idx="839">
                  <c:v>1.0192748797577504</c:v>
                </c:pt>
                <c:pt idx="840">
                  <c:v>1.0189573293634757</c:v>
                </c:pt>
                <c:pt idx="841">
                  <c:v>1.0190672761576058</c:v>
                </c:pt>
                <c:pt idx="842">
                  <c:v>1.0198554427135902</c:v>
                </c:pt>
                <c:pt idx="843">
                  <c:v>1.0226943369465524</c:v>
                </c:pt>
                <c:pt idx="844">
                  <c:v>1.0246443738252713</c:v>
                </c:pt>
                <c:pt idx="845">
                  <c:v>1.0274635695663423</c:v>
                </c:pt>
                <c:pt idx="846">
                  <c:v>1.0283881560964261</c:v>
                </c:pt>
                <c:pt idx="847">
                  <c:v>1.0288714075641285</c:v>
                </c:pt>
                <c:pt idx="848">
                  <c:v>1.0288582392606733</c:v>
                </c:pt>
                <c:pt idx="849">
                  <c:v>1.0288897769919683</c:v>
                </c:pt>
                <c:pt idx="850">
                  <c:v>1.0283768342250701</c:v>
                </c:pt>
                <c:pt idx="851">
                  <c:v>1.0267548246040341</c:v>
                </c:pt>
                <c:pt idx="852">
                  <c:v>1.021814648054409</c:v>
                </c:pt>
                <c:pt idx="853">
                  <c:v>1.021753374207242</c:v>
                </c:pt>
                <c:pt idx="854">
                  <c:v>1.0233460443069651</c:v>
                </c:pt>
                <c:pt idx="855">
                  <c:v>1.023057483447338</c:v>
                </c:pt>
                <c:pt idx="856">
                  <c:v>1.0254737209459588</c:v>
                </c:pt>
                <c:pt idx="857">
                  <c:v>1.0236061602196098</c:v>
                </c:pt>
                <c:pt idx="858">
                  <c:v>1.0250027976982934</c:v>
                </c:pt>
                <c:pt idx="859">
                  <c:v>1.0273994182159627</c:v>
                </c:pt>
                <c:pt idx="860">
                  <c:v>1.0271729220019743</c:v>
                </c:pt>
                <c:pt idx="861">
                  <c:v>1.0261861908991532</c:v>
                </c:pt>
                <c:pt idx="862">
                  <c:v>1.0249725991816441</c:v>
                </c:pt>
                <c:pt idx="863">
                  <c:v>1.0254893202467481</c:v>
                </c:pt>
                <c:pt idx="864">
                  <c:v>1.0266866950360638</c:v>
                </c:pt>
                <c:pt idx="865">
                  <c:v>1.0243321263784166</c:v>
                </c:pt>
                <c:pt idx="866">
                  <c:v>1.0251142867873038</c:v>
                </c:pt>
                <c:pt idx="867">
                  <c:v>1.0257854758739848</c:v>
                </c:pt>
                <c:pt idx="868">
                  <c:v>1.0263504860023989</c:v>
                </c:pt>
                <c:pt idx="869">
                  <c:v>1.0273428734762649</c:v>
                </c:pt>
                <c:pt idx="870">
                  <c:v>1.0286224982947538</c:v>
                </c:pt>
                <c:pt idx="871">
                  <c:v>1.0279220812568124</c:v>
                </c:pt>
                <c:pt idx="872">
                  <c:v>1.0267607514027717</c:v>
                </c:pt>
                <c:pt idx="873">
                  <c:v>1.0280160827716653</c:v>
                </c:pt>
                <c:pt idx="874">
                  <c:v>1.0279654169979635</c:v>
                </c:pt>
                <c:pt idx="875">
                  <c:v>1.0299509551056938</c:v>
                </c:pt>
                <c:pt idx="876">
                  <c:v>1.0296090324759051</c:v>
                </c:pt>
                <c:pt idx="877">
                  <c:v>1.0301641589711199</c:v>
                </c:pt>
                <c:pt idx="878">
                  <c:v>1.0301314560516499</c:v>
                </c:pt>
                <c:pt idx="879">
                  <c:v>1.0289204861523198</c:v>
                </c:pt>
                <c:pt idx="880">
                  <c:v>1.0287465257170751</c:v>
                </c:pt>
                <c:pt idx="881">
                  <c:v>1.0320921030757522</c:v>
                </c:pt>
                <c:pt idx="882">
                  <c:v>1.0299911373358035</c:v>
                </c:pt>
                <c:pt idx="883">
                  <c:v>1.0306988929155898</c:v>
                </c:pt>
                <c:pt idx="884">
                  <c:v>1.026548569339728</c:v>
                </c:pt>
                <c:pt idx="885">
                  <c:v>1.0283400324623788</c:v>
                </c:pt>
                <c:pt idx="886">
                  <c:v>1.0278994501183758</c:v>
                </c:pt>
                <c:pt idx="887">
                  <c:v>1.0267747956031206</c:v>
                </c:pt>
                <c:pt idx="888">
                  <c:v>1.0259917895021347</c:v>
                </c:pt>
                <c:pt idx="889">
                  <c:v>1.0297073657286295</c:v>
                </c:pt>
                <c:pt idx="890">
                  <c:v>1.0320229821883486</c:v>
                </c:pt>
                <c:pt idx="891">
                  <c:v>1.0289999823174056</c:v>
                </c:pt>
                <c:pt idx="892">
                  <c:v>1.0279325433910065</c:v>
                </c:pt>
                <c:pt idx="893">
                  <c:v>1.0237295865826246</c:v>
                </c:pt>
                <c:pt idx="894">
                  <c:v>1.0214118633061589</c:v>
                </c:pt>
                <c:pt idx="895">
                  <c:v>1.0197761373029437</c:v>
                </c:pt>
                <c:pt idx="896">
                  <c:v>1.0220988319570401</c:v>
                </c:pt>
                <c:pt idx="897">
                  <c:v>1.0233598332894578</c:v>
                </c:pt>
                <c:pt idx="898">
                  <c:v>1.0245545842189101</c:v>
                </c:pt>
                <c:pt idx="899">
                  <c:v>1.0216507723696158</c:v>
                </c:pt>
                <c:pt idx="900">
                  <c:v>1.0257588658669601</c:v>
                </c:pt>
                <c:pt idx="901">
                  <c:v>1.0255362669619699</c:v>
                </c:pt>
                <c:pt idx="902">
                  <c:v>1.0248181416222322</c:v>
                </c:pt>
                <c:pt idx="903">
                  <c:v>1.0269315960975012</c:v>
                </c:pt>
                <c:pt idx="904">
                  <c:v>1.0274322309456838</c:v>
                </c:pt>
                <c:pt idx="905">
                  <c:v>1.0273100267355491</c:v>
                </c:pt>
                <c:pt idx="906">
                  <c:v>1.0289395498880181</c:v>
                </c:pt>
                <c:pt idx="907">
                  <c:v>1.0301168281770161</c:v>
                </c:pt>
                <c:pt idx="908">
                  <c:v>1.0307067205484233</c:v>
                </c:pt>
                <c:pt idx="909">
                  <c:v>1.0294596892713519</c:v>
                </c:pt>
                <c:pt idx="910">
                  <c:v>1.0301308495305401</c:v>
                </c:pt>
                <c:pt idx="911">
                  <c:v>1.0294577631438691</c:v>
                </c:pt>
                <c:pt idx="912">
                  <c:v>1.0322326896730603</c:v>
                </c:pt>
                <c:pt idx="913">
                  <c:v>1.0324890288631201</c:v>
                </c:pt>
                <c:pt idx="914">
                  <c:v>1.0296238798224258</c:v>
                </c:pt>
                <c:pt idx="915">
                  <c:v>1.0326452537229978</c:v>
                </c:pt>
                <c:pt idx="916">
                  <c:v>1.0322680582411976</c:v>
                </c:pt>
                <c:pt idx="917">
                  <c:v>1.0358869118040124</c:v>
                </c:pt>
                <c:pt idx="918">
                  <c:v>1.0348540231922541</c:v>
                </c:pt>
                <c:pt idx="919">
                  <c:v>1.0349734483740978</c:v>
                </c:pt>
                <c:pt idx="920">
                  <c:v>1.031235509764532</c:v>
                </c:pt>
                <c:pt idx="921">
                  <c:v>1.0313583551106078</c:v>
                </c:pt>
                <c:pt idx="922">
                  <c:v>1.0292124080507361</c:v>
                </c:pt>
                <c:pt idx="923">
                  <c:v>1.0317767085374423</c:v>
                </c:pt>
                <c:pt idx="924">
                  <c:v>1.0310601883215817</c:v>
                </c:pt>
                <c:pt idx="925">
                  <c:v>1.0314465959308772</c:v>
                </c:pt>
                <c:pt idx="926">
                  <c:v>1.0334237490085896</c:v>
                </c:pt>
                <c:pt idx="927">
                  <c:v>1.0315697136134552</c:v>
                </c:pt>
                <c:pt idx="928">
                  <c:v>1.0312807624324056</c:v>
                </c:pt>
                <c:pt idx="929">
                  <c:v>1.029946216773636</c:v>
                </c:pt>
                <c:pt idx="930">
                  <c:v>1.0318216813577319</c:v>
                </c:pt>
                <c:pt idx="931">
                  <c:v>1.0292735766450325</c:v>
                </c:pt>
                <c:pt idx="932">
                  <c:v>1.0307439108253704</c:v>
                </c:pt>
                <c:pt idx="933">
                  <c:v>1.0265609971615179</c:v>
                </c:pt>
                <c:pt idx="934">
                  <c:v>1.0265288082935871</c:v>
                </c:pt>
                <c:pt idx="935">
                  <c:v>1.0290785738773425</c:v>
                </c:pt>
                <c:pt idx="936">
                  <c:v>1.0290884122695976</c:v>
                </c:pt>
                <c:pt idx="937">
                  <c:v>1.0267011999886531</c:v>
                </c:pt>
                <c:pt idx="938">
                  <c:v>1.0272595810021616</c:v>
                </c:pt>
                <c:pt idx="939">
                  <c:v>1.0248902830449449</c:v>
                </c:pt>
                <c:pt idx="940">
                  <c:v>1.0264210369491724</c:v>
                </c:pt>
                <c:pt idx="941">
                  <c:v>1.0236959064252322</c:v>
                </c:pt>
                <c:pt idx="942">
                  <c:v>1.0254470058852443</c:v>
                </c:pt>
                <c:pt idx="943">
                  <c:v>1.0226436674970134</c:v>
                </c:pt>
                <c:pt idx="944">
                  <c:v>1.0257282337353872</c:v>
                </c:pt>
                <c:pt idx="945">
                  <c:v>1.0258991847981056</c:v>
                </c:pt>
                <c:pt idx="946">
                  <c:v>1.0273739529646058</c:v>
                </c:pt>
                <c:pt idx="947">
                  <c:v>1.0268442794075616</c:v>
                </c:pt>
                <c:pt idx="948">
                  <c:v>1.0257705301638287</c:v>
                </c:pt>
                <c:pt idx="949">
                  <c:v>1.0252982813750857</c:v>
                </c:pt>
                <c:pt idx="950">
                  <c:v>1.0238814487596113</c:v>
                </c:pt>
                <c:pt idx="951">
                  <c:v>1.0252210803154695</c:v>
                </c:pt>
                <c:pt idx="952">
                  <c:v>1.0239361880925475</c:v>
                </c:pt>
                <c:pt idx="953">
                  <c:v>1.0243258297814781</c:v>
                </c:pt>
                <c:pt idx="954">
                  <c:v>1.0216292614290914</c:v>
                </c:pt>
                <c:pt idx="955">
                  <c:v>1.022444955480297</c:v>
                </c:pt>
                <c:pt idx="956">
                  <c:v>1.0214542732593059</c:v>
                </c:pt>
                <c:pt idx="957">
                  <c:v>1.0248848626674414</c:v>
                </c:pt>
                <c:pt idx="958">
                  <c:v>1.0248140177500458</c:v>
                </c:pt>
                <c:pt idx="959">
                  <c:v>1.0230414451096035</c:v>
                </c:pt>
                <c:pt idx="960">
                  <c:v>1.0204580259007474</c:v>
                </c:pt>
                <c:pt idx="961">
                  <c:v>1.0216000298032186</c:v>
                </c:pt>
                <c:pt idx="962">
                  <c:v>1.0209166550505466</c:v>
                </c:pt>
                <c:pt idx="963">
                  <c:v>1.0207660861568935</c:v>
                </c:pt>
                <c:pt idx="964">
                  <c:v>1.0191736883148765</c:v>
                </c:pt>
                <c:pt idx="965">
                  <c:v>1.0233951933874457</c:v>
                </c:pt>
                <c:pt idx="966">
                  <c:v>1.0208555245039586</c:v>
                </c:pt>
                <c:pt idx="967">
                  <c:v>1.0229603378247398</c:v>
                </c:pt>
                <c:pt idx="968">
                  <c:v>1.0203423296599483</c:v>
                </c:pt>
                <c:pt idx="969">
                  <c:v>1.0175928852237244</c:v>
                </c:pt>
                <c:pt idx="970">
                  <c:v>1.0162010016174499</c:v>
                </c:pt>
                <c:pt idx="971">
                  <c:v>1.0165019544508171</c:v>
                </c:pt>
                <c:pt idx="972">
                  <c:v>1.0165245861118517</c:v>
                </c:pt>
                <c:pt idx="973">
                  <c:v>1.0150630732518788</c:v>
                </c:pt>
                <c:pt idx="974">
                  <c:v>1.0161018065041838</c:v>
                </c:pt>
                <c:pt idx="975">
                  <c:v>1.0164892545768811</c:v>
                </c:pt>
                <c:pt idx="976">
                  <c:v>1.0147955798188597</c:v>
                </c:pt>
                <c:pt idx="977">
                  <c:v>1.013729983128403</c:v>
                </c:pt>
                <c:pt idx="978">
                  <c:v>1.0119502708663766</c:v>
                </c:pt>
                <c:pt idx="979">
                  <c:v>1.0124723929677175</c:v>
                </c:pt>
                <c:pt idx="980">
                  <c:v>1.0120712272394374</c:v>
                </c:pt>
                <c:pt idx="981">
                  <c:v>1.0120947555068938</c:v>
                </c:pt>
                <c:pt idx="982">
                  <c:v>1.0105657987601198</c:v>
                </c:pt>
                <c:pt idx="983">
                  <c:v>1.010271107228901</c:v>
                </c:pt>
                <c:pt idx="984">
                  <c:v>1.0084617573314119</c:v>
                </c:pt>
                <c:pt idx="985">
                  <c:v>1.0071629622371239</c:v>
                </c:pt>
                <c:pt idx="986">
                  <c:v>1.0062075380189701</c:v>
                </c:pt>
                <c:pt idx="987">
                  <c:v>1.0036959621760977</c:v>
                </c:pt>
                <c:pt idx="988">
                  <c:v>1.0046960077271259</c:v>
                </c:pt>
                <c:pt idx="989">
                  <c:v>1.0034292258147346</c:v>
                </c:pt>
                <c:pt idx="990">
                  <c:v>1.0035836172485182</c:v>
                </c:pt>
                <c:pt idx="991">
                  <c:v>1.0037210113147497</c:v>
                </c:pt>
                <c:pt idx="992">
                  <c:v>1.0037492351948394</c:v>
                </c:pt>
                <c:pt idx="993">
                  <c:v>1.0028777058792568</c:v>
                </c:pt>
                <c:pt idx="994">
                  <c:v>1.0001637931326832</c:v>
                </c:pt>
                <c:pt idx="995">
                  <c:v>0.99763354747544308</c:v>
                </c:pt>
                <c:pt idx="996">
                  <c:v>0.99464095456914092</c:v>
                </c:pt>
                <c:pt idx="997">
                  <c:v>0.99551550869583949</c:v>
                </c:pt>
                <c:pt idx="998">
                  <c:v>0.99155515331465549</c:v>
                </c:pt>
                <c:pt idx="999">
                  <c:v>0.9887745243813405</c:v>
                </c:pt>
                <c:pt idx="1000">
                  <c:v>0.98872488656797675</c:v>
                </c:pt>
                <c:pt idx="1001">
                  <c:v>0.98592479265141664</c:v>
                </c:pt>
                <c:pt idx="1002">
                  <c:v>0.98659609488510758</c:v>
                </c:pt>
                <c:pt idx="1003">
                  <c:v>0.98139359168527307</c:v>
                </c:pt>
                <c:pt idx="1004">
                  <c:v>0.98191284650445676</c:v>
                </c:pt>
                <c:pt idx="1005">
                  <c:v>0.97680414806123528</c:v>
                </c:pt>
                <c:pt idx="1006">
                  <c:v>0.97662300561697613</c:v>
                </c:pt>
                <c:pt idx="1007">
                  <c:v>0.97826843419905662</c:v>
                </c:pt>
                <c:pt idx="1008">
                  <c:v>0.97880565419358678</c:v>
                </c:pt>
                <c:pt idx="1009">
                  <c:v>0.97717362518006268</c:v>
                </c:pt>
                <c:pt idx="1010">
                  <c:v>0.97730001379040965</c:v>
                </c:pt>
                <c:pt idx="1011">
                  <c:v>0.97822866201334746</c:v>
                </c:pt>
                <c:pt idx="1012">
                  <c:v>0.97486694140630326</c:v>
                </c:pt>
                <c:pt idx="1013">
                  <c:v>0.97197810049139044</c:v>
                </c:pt>
                <c:pt idx="1014">
                  <c:v>0.97097869319120156</c:v>
                </c:pt>
                <c:pt idx="1015">
                  <c:v>0.96984664961507683</c:v>
                </c:pt>
                <c:pt idx="1016">
                  <c:v>0.96773891500878628</c:v>
                </c:pt>
                <c:pt idx="1017">
                  <c:v>0.96588161901958391</c:v>
                </c:pt>
                <c:pt idx="1018">
                  <c:v>0.96958281851587802</c:v>
                </c:pt>
                <c:pt idx="1019">
                  <c:v>0.96741577470802853</c:v>
                </c:pt>
                <c:pt idx="1020">
                  <c:v>0.96719044680866462</c:v>
                </c:pt>
                <c:pt idx="1021">
                  <c:v>0.96395869817625968</c:v>
                </c:pt>
                <c:pt idx="1022">
                  <c:v>0.96419597056171336</c:v>
                </c:pt>
                <c:pt idx="1023">
                  <c:v>0.96580185405360408</c:v>
                </c:pt>
                <c:pt idx="1024">
                  <c:v>0.96686867308974356</c:v>
                </c:pt>
                <c:pt idx="1025">
                  <c:v>0.96794549687032561</c:v>
                </c:pt>
                <c:pt idx="1026">
                  <c:v>0.97102734034885263</c:v>
                </c:pt>
                <c:pt idx="1027">
                  <c:v>0.97120335025939464</c:v>
                </c:pt>
                <c:pt idx="1028">
                  <c:v>0.97078085157169625</c:v>
                </c:pt>
                <c:pt idx="1029">
                  <c:v>0.97259348899140252</c:v>
                </c:pt>
                <c:pt idx="1030">
                  <c:v>0.97127442974483469</c:v>
                </c:pt>
                <c:pt idx="1031">
                  <c:v>0.96796526138063477</c:v>
                </c:pt>
                <c:pt idx="1032">
                  <c:v>0.96533450976421731</c:v>
                </c:pt>
                <c:pt idx="1033">
                  <c:v>0.96289470511628561</c:v>
                </c:pt>
                <c:pt idx="1034">
                  <c:v>0.96675135442998006</c:v>
                </c:pt>
                <c:pt idx="1035">
                  <c:v>0.969072154941509</c:v>
                </c:pt>
                <c:pt idx="1036">
                  <c:v>0.96922258688656948</c:v>
                </c:pt>
                <c:pt idx="1037">
                  <c:v>0.96752502825303865</c:v>
                </c:pt>
                <c:pt idx="1038">
                  <c:v>0.96806337467427761</c:v>
                </c:pt>
                <c:pt idx="1039">
                  <c:v>0.96707041749801592</c:v>
                </c:pt>
                <c:pt idx="1040">
                  <c:v>0.96982258607728333</c:v>
                </c:pt>
                <c:pt idx="1041">
                  <c:v>0.97023245499361122</c:v>
                </c:pt>
                <c:pt idx="1042">
                  <c:v>0.9662440635951276</c:v>
                </c:pt>
                <c:pt idx="1043">
                  <c:v>0.96956509542847824</c:v>
                </c:pt>
                <c:pt idx="1044">
                  <c:v>0.96938672865214548</c:v>
                </c:pt>
                <c:pt idx="1045">
                  <c:v>0.9691498436012641</c:v>
                </c:pt>
                <c:pt idx="1046">
                  <c:v>0.96757394606278069</c:v>
                </c:pt>
                <c:pt idx="1047">
                  <c:v>0.96621488283890955</c:v>
                </c:pt>
                <c:pt idx="1048">
                  <c:v>0.96648544626882849</c:v>
                </c:pt>
                <c:pt idx="1049">
                  <c:v>0.96850336463728837</c:v>
                </c:pt>
                <c:pt idx="1050">
                  <c:v>0.96474578822476365</c:v>
                </c:pt>
                <c:pt idx="1051">
                  <c:v>0.96564646630193673</c:v>
                </c:pt>
                <c:pt idx="1052">
                  <c:v>0.96613897321939213</c:v>
                </c:pt>
                <c:pt idx="1053">
                  <c:v>0.96681087033313451</c:v>
                </c:pt>
                <c:pt idx="1054">
                  <c:v>0.96905841565191564</c:v>
                </c:pt>
                <c:pt idx="1055">
                  <c:v>0.97017603837193467</c:v>
                </c:pt>
                <c:pt idx="1056">
                  <c:v>0.97101949896562068</c:v>
                </c:pt>
                <c:pt idx="1057">
                  <c:v>0.974093340630796</c:v>
                </c:pt>
                <c:pt idx="1058">
                  <c:v>0.96930230734141654</c:v>
                </c:pt>
                <c:pt idx="1059">
                  <c:v>0.96840683044488363</c:v>
                </c:pt>
                <c:pt idx="1060">
                  <c:v>0.9665382866953407</c:v>
                </c:pt>
                <c:pt idx="1061">
                  <c:v>0.9670164663701557</c:v>
                </c:pt>
                <c:pt idx="1062">
                  <c:v>0.96804034027179364</c:v>
                </c:pt>
                <c:pt idx="1063">
                  <c:v>0.96646256824350052</c:v>
                </c:pt>
                <c:pt idx="1064">
                  <c:v>0.96336968532691858</c:v>
                </c:pt>
                <c:pt idx="1065">
                  <c:v>0.9658307199391537</c:v>
                </c:pt>
                <c:pt idx="1066">
                  <c:v>0.96700549209366671</c:v>
                </c:pt>
                <c:pt idx="1067">
                  <c:v>0.96454044438356656</c:v>
                </c:pt>
                <c:pt idx="1068">
                  <c:v>0.96241733849863553</c:v>
                </c:pt>
                <c:pt idx="1069">
                  <c:v>0.96381352847822088</c:v>
                </c:pt>
                <c:pt idx="1070">
                  <c:v>0.96649534229596645</c:v>
                </c:pt>
                <c:pt idx="1071">
                  <c:v>0.96720933731979808</c:v>
                </c:pt>
                <c:pt idx="1072">
                  <c:v>0.96350498869688661</c:v>
                </c:pt>
                <c:pt idx="1073">
                  <c:v>0.95934996224493985</c:v>
                </c:pt>
                <c:pt idx="1074">
                  <c:v>0.95623243307706451</c:v>
                </c:pt>
                <c:pt idx="1075">
                  <c:v>0.9575338779878092</c:v>
                </c:pt>
                <c:pt idx="1076">
                  <c:v>0.95643166120620859</c:v>
                </c:pt>
                <c:pt idx="1077">
                  <c:v>0.95386417078659369</c:v>
                </c:pt>
                <c:pt idx="1078">
                  <c:v>0.94878496895421149</c:v>
                </c:pt>
                <c:pt idx="1079">
                  <c:v>0.94618063736346192</c:v>
                </c:pt>
                <c:pt idx="1080">
                  <c:v>0.94287451660197741</c:v>
                </c:pt>
                <c:pt idx="1081">
                  <c:v>0.94634020864325363</c:v>
                </c:pt>
                <c:pt idx="1082">
                  <c:v>0.94347275497824856</c:v>
                </c:pt>
                <c:pt idx="1083">
                  <c:v>0.94220483287920065</c:v>
                </c:pt>
                <c:pt idx="1084">
                  <c:v>0.94046288178207971</c:v>
                </c:pt>
                <c:pt idx="1085">
                  <c:v>0.93740764280845612</c:v>
                </c:pt>
                <c:pt idx="1086">
                  <c:v>0.93311787762476495</c:v>
                </c:pt>
                <c:pt idx="1087">
                  <c:v>0.9308833684318405</c:v>
                </c:pt>
                <c:pt idx="1088">
                  <c:v>0.92949067582960321</c:v>
                </c:pt>
                <c:pt idx="1089">
                  <c:v>0.92457931290235118</c:v>
                </c:pt>
                <c:pt idx="1090">
                  <c:v>0.92161168343211564</c:v>
                </c:pt>
                <c:pt idx="1091">
                  <c:v>0.92177100531792899</c:v>
                </c:pt>
                <c:pt idx="1092">
                  <c:v>0.92607372538219834</c:v>
                </c:pt>
                <c:pt idx="1093">
                  <c:v>0.92240643436612435</c:v>
                </c:pt>
                <c:pt idx="1094">
                  <c:v>0.91818832350835222</c:v>
                </c:pt>
                <c:pt idx="1095">
                  <c:v>0.91133315320399733</c:v>
                </c:pt>
                <c:pt idx="1096">
                  <c:v>0.909967437317723</c:v>
                </c:pt>
                <c:pt idx="1097">
                  <c:v>0.91057353071091562</c:v>
                </c:pt>
                <c:pt idx="1098">
                  <c:v>0.90985605039246809</c:v>
                </c:pt>
                <c:pt idx="1099">
                  <c:v>0.90671135422555282</c:v>
                </c:pt>
                <c:pt idx="1100">
                  <c:v>0.90022001285483111</c:v>
                </c:pt>
                <c:pt idx="1101">
                  <c:v>0.89891110916396177</c:v>
                </c:pt>
                <c:pt idx="1102">
                  <c:v>0.89574825883404907</c:v>
                </c:pt>
                <c:pt idx="1103">
                  <c:v>0.89230668549212522</c:v>
                </c:pt>
                <c:pt idx="1104">
                  <c:v>0.89014931173168232</c:v>
                </c:pt>
                <c:pt idx="1105">
                  <c:v>0.88214989615393014</c:v>
                </c:pt>
                <c:pt idx="1106">
                  <c:v>0.88177290963410615</c:v>
                </c:pt>
                <c:pt idx="1107">
                  <c:v>0.87816911207099735</c:v>
                </c:pt>
                <c:pt idx="1108">
                  <c:v>0.87903992015133581</c:v>
                </c:pt>
                <c:pt idx="1109">
                  <c:v>0.87626137167549145</c:v>
                </c:pt>
                <c:pt idx="1110">
                  <c:v>0.87570893626773494</c:v>
                </c:pt>
                <c:pt idx="1111">
                  <c:v>0.87453190314696549</c:v>
                </c:pt>
                <c:pt idx="1112">
                  <c:v>0.87314216593556249</c:v>
                </c:pt>
                <c:pt idx="1113">
                  <c:v>0.87304442708953212</c:v>
                </c:pt>
                <c:pt idx="1114">
                  <c:v>0.87191793982957633</c:v>
                </c:pt>
                <c:pt idx="1115">
                  <c:v>0.86682218220581675</c:v>
                </c:pt>
                <c:pt idx="1116">
                  <c:v>0.86104072128628761</c:v>
                </c:pt>
                <c:pt idx="1117">
                  <c:v>0.85893005117025778</c:v>
                </c:pt>
                <c:pt idx="1118">
                  <c:v>0.85399223148116865</c:v>
                </c:pt>
                <c:pt idx="1119">
                  <c:v>0.85451005784709011</c:v>
                </c:pt>
                <c:pt idx="1120">
                  <c:v>0.8595427852668841</c:v>
                </c:pt>
                <c:pt idx="1121">
                  <c:v>0.85113104502405645</c:v>
                </c:pt>
                <c:pt idx="1122">
                  <c:v>0.84920454826350356</c:v>
                </c:pt>
                <c:pt idx="1123">
                  <c:v>0.84416845867631662</c:v>
                </c:pt>
                <c:pt idx="1124">
                  <c:v>0.84191486161538165</c:v>
                </c:pt>
                <c:pt idx="1125">
                  <c:v>0.83471649884580812</c:v>
                </c:pt>
                <c:pt idx="1126">
                  <c:v>0.83260833719608263</c:v>
                </c:pt>
                <c:pt idx="1127">
                  <c:v>0.83100804900127623</c:v>
                </c:pt>
                <c:pt idx="1128">
                  <c:v>0.82878197576963686</c:v>
                </c:pt>
                <c:pt idx="1129">
                  <c:v>0.82579351799113165</c:v>
                </c:pt>
                <c:pt idx="1130">
                  <c:v>0.8206863106617156</c:v>
                </c:pt>
                <c:pt idx="1131">
                  <c:v>0.81869996651968746</c:v>
                </c:pt>
                <c:pt idx="1132">
                  <c:v>0.81159541922572764</c:v>
                </c:pt>
                <c:pt idx="1133">
                  <c:v>0.81104191179433804</c:v>
                </c:pt>
                <c:pt idx="1134">
                  <c:v>0.80297303109909146</c:v>
                </c:pt>
                <c:pt idx="1135">
                  <c:v>0.80200440564620268</c:v>
                </c:pt>
                <c:pt idx="1136">
                  <c:v>0.79921588588000458</c:v>
                </c:pt>
                <c:pt idx="1137">
                  <c:v>0.79138745560895851</c:v>
                </c:pt>
                <c:pt idx="1138">
                  <c:v>0.78586430454503808</c:v>
                </c:pt>
                <c:pt idx="1139">
                  <c:v>0.7811825669778506</c:v>
                </c:pt>
                <c:pt idx="1140">
                  <c:v>0.77651310080846314</c:v>
                </c:pt>
                <c:pt idx="1141">
                  <c:v>0.77377873061100966</c:v>
                </c:pt>
                <c:pt idx="1142">
                  <c:v>0.77041491265366202</c:v>
                </c:pt>
                <c:pt idx="1143">
                  <c:v>0.76526556664633383</c:v>
                </c:pt>
                <c:pt idx="1144">
                  <c:v>0.75297085438402112</c:v>
                </c:pt>
                <c:pt idx="1145">
                  <c:v>0.74914736646485158</c:v>
                </c:pt>
                <c:pt idx="1146">
                  <c:v>0.74615924821828283</c:v>
                </c:pt>
                <c:pt idx="1147">
                  <c:v>0.74043661847442666</c:v>
                </c:pt>
                <c:pt idx="1148">
                  <c:v>0.73706119426385963</c:v>
                </c:pt>
                <c:pt idx="1149">
                  <c:v>0.7338348104938669</c:v>
                </c:pt>
                <c:pt idx="1150">
                  <c:v>0.72842174987468267</c:v>
                </c:pt>
                <c:pt idx="1151">
                  <c:v>0.72277770624092663</c:v>
                </c:pt>
                <c:pt idx="1152">
                  <c:v>0.72055073433207595</c:v>
                </c:pt>
                <c:pt idx="1153">
                  <c:v>0.71507132731865763</c:v>
                </c:pt>
                <c:pt idx="1154">
                  <c:v>0.7128264281657426</c:v>
                </c:pt>
                <c:pt idx="1155">
                  <c:v>0.70366230762705251</c:v>
                </c:pt>
                <c:pt idx="1156">
                  <c:v>0.70153754708981708</c:v>
                </c:pt>
                <c:pt idx="1157">
                  <c:v>0.69332388115177612</c:v>
                </c:pt>
                <c:pt idx="1158">
                  <c:v>0.69116776865597251</c:v>
                </c:pt>
                <c:pt idx="1159">
                  <c:v>0.68483806642747302</c:v>
                </c:pt>
                <c:pt idx="1160">
                  <c:v>0.67728435478811644</c:v>
                </c:pt>
                <c:pt idx="1161">
                  <c:v>0.67491292413914261</c:v>
                </c:pt>
                <c:pt idx="1162">
                  <c:v>0.66941241174046651</c:v>
                </c:pt>
                <c:pt idx="1163">
                  <c:v>0.66508913591295948</c:v>
                </c:pt>
                <c:pt idx="1164">
                  <c:v>0.65972399965293704</c:v>
                </c:pt>
                <c:pt idx="1165">
                  <c:v>0.65502413981683694</c:v>
                </c:pt>
                <c:pt idx="1166">
                  <c:v>0.65197628600242064</c:v>
                </c:pt>
                <c:pt idx="1167">
                  <c:v>0.64732004685195776</c:v>
                </c:pt>
                <c:pt idx="1168">
                  <c:v>0.64479102508693364</c:v>
                </c:pt>
                <c:pt idx="1169">
                  <c:v>0.64312722685227164</c:v>
                </c:pt>
                <c:pt idx="1170">
                  <c:v>0.63985139705663063</c:v>
                </c:pt>
                <c:pt idx="1171">
                  <c:v>0.63999178447458382</c:v>
                </c:pt>
                <c:pt idx="1172">
                  <c:v>0.63880809958888429</c:v>
                </c:pt>
                <c:pt idx="1173">
                  <c:v>0.64268864120662583</c:v>
                </c:pt>
                <c:pt idx="1174">
                  <c:v>0.64298544914865963</c:v>
                </c:pt>
                <c:pt idx="1175">
                  <c:v>0.64282598973937866</c:v>
                </c:pt>
                <c:pt idx="1176">
                  <c:v>0.63897587264109101</c:v>
                </c:pt>
                <c:pt idx="1177">
                  <c:v>0.63717466670338341</c:v>
                </c:pt>
                <c:pt idx="1178">
                  <c:v>0.63321559044672671</c:v>
                </c:pt>
                <c:pt idx="1179">
                  <c:v>0.6338665995127315</c:v>
                </c:pt>
                <c:pt idx="1180">
                  <c:v>0.63242783212619658</c:v>
                </c:pt>
                <c:pt idx="1181">
                  <c:v>0.63369814940091962</c:v>
                </c:pt>
                <c:pt idx="1182">
                  <c:v>0.63299540928780884</c:v>
                </c:pt>
                <c:pt idx="1183">
                  <c:v>0.63128512168450601</c:v>
                </c:pt>
                <c:pt idx="1184">
                  <c:v>0.63237250521999977</c:v>
                </c:pt>
                <c:pt idx="1185">
                  <c:v>0.63187657240424</c:v>
                </c:pt>
                <c:pt idx="1186">
                  <c:v>0.63284194166121355</c:v>
                </c:pt>
                <c:pt idx="1187">
                  <c:v>0.63400005504682466</c:v>
                </c:pt>
                <c:pt idx="1188">
                  <c:v>0.63491169230131528</c:v>
                </c:pt>
                <c:pt idx="1189">
                  <c:v>0.63431747544494088</c:v>
                </c:pt>
                <c:pt idx="1190">
                  <c:v>0.635165597435562</c:v>
                </c:pt>
                <c:pt idx="1191">
                  <c:v>0.63634322667634136</c:v>
                </c:pt>
                <c:pt idx="1192">
                  <c:v>0.63586810997177123</c:v>
                </c:pt>
                <c:pt idx="1193">
                  <c:v>0.63610331268613862</c:v>
                </c:pt>
                <c:pt idx="1194">
                  <c:v>0.63392352665530483</c:v>
                </c:pt>
                <c:pt idx="1195">
                  <c:v>0.63344059858564361</c:v>
                </c:pt>
                <c:pt idx="1196">
                  <c:v>0.63236893020053064</c:v>
                </c:pt>
                <c:pt idx="1197">
                  <c:v>0.62888143733393176</c:v>
                </c:pt>
                <c:pt idx="1198">
                  <c:v>0.62821482040383991</c:v>
                </c:pt>
                <c:pt idx="1199">
                  <c:v>0.62673452178924149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49314248"/>
        <c:axId val="249314640"/>
      </c:scatterChart>
      <c:valAx>
        <c:axId val="249314248"/>
        <c:scaling>
          <c:orientation val="minMax"/>
          <c:max val="200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200" b="1" i="0" u="none" strike="noStrike" baseline="0">
                <a:solidFill>
                  <a:srgbClr val="FFFFFF"/>
                </a:solidFill>
                <a:latin typeface="Times New Roman"/>
                <a:ea typeface="Times New Roman"/>
                <a:cs typeface="Times New Roman"/>
              </a:defRPr>
            </a:pPr>
            <a:endParaRPr lang="en-US"/>
          </a:p>
        </c:txPr>
        <c:crossAx val="249314640"/>
        <c:crosses val="autoZero"/>
        <c:crossBetween val="midCat"/>
      </c:valAx>
      <c:valAx>
        <c:axId val="249314640"/>
        <c:scaling>
          <c:orientation val="minMax"/>
          <c:max val="1.1000000000000001"/>
          <c:min val="0.60000000000000064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200" b="1" i="0" u="none" strike="noStrike" baseline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</a:defRPr>
            </a:pPr>
            <a:endParaRPr lang="en-US"/>
          </a:p>
        </c:txPr>
        <c:crossAx val="249314248"/>
        <c:crosses val="autoZero"/>
        <c:crossBetween val="midCat"/>
        <c:majorUnit val="0.1"/>
        <c:minorUnit val="2.0000000000000052E-2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9525">
      <a:noFill/>
    </a:ln>
  </c:spPr>
  <c:txPr>
    <a:bodyPr/>
    <a:lstStyle/>
    <a:p>
      <a:pPr>
        <a:defRPr sz="1200" b="1" i="0" u="none" strike="noStrike" baseline="0">
          <a:solidFill>
            <a:srgbClr val="000000"/>
          </a:solidFill>
          <a:latin typeface="Times New Roman"/>
          <a:ea typeface="Times New Roman"/>
          <a:cs typeface="Times New Roman"/>
        </a:defRPr>
      </a:pPr>
      <a:endParaRPr lang="en-US"/>
    </a:p>
  </c:txPr>
  <c:externalData r:id="rId2">
    <c:autoUpdate val="0"/>
  </c:externalData>
  <c:userShapes r:id="rId3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6089613034623246"/>
          <c:y val="0.14598566161336254"/>
          <c:w val="0.7820773930753564"/>
          <c:h val="0.56569443875178083"/>
        </c:manualLayout>
      </c:layout>
      <c:scatterChart>
        <c:scatterStyle val="smoothMarker"/>
        <c:varyColors val="0"/>
        <c:ser>
          <c:idx val="1"/>
          <c:order val="0"/>
          <c:marker>
            <c:symbol val="none"/>
          </c:marker>
          <c:xVal>
            <c:numRef>
              <c:f>Sheet1!$A$1:$A$2285</c:f>
              <c:numCache>
                <c:formatCode>General</c:formatCode>
                <c:ptCount val="2285"/>
                <c:pt idx="0">
                  <c:v>0</c:v>
                </c:pt>
                <c:pt idx="1">
                  <c:v>1.6300000000000001</c:v>
                </c:pt>
                <c:pt idx="2">
                  <c:v>3.2600000000000002</c:v>
                </c:pt>
                <c:pt idx="3">
                  <c:v>4.8899999999999997</c:v>
                </c:pt>
                <c:pt idx="4">
                  <c:v>6.52</c:v>
                </c:pt>
                <c:pt idx="5">
                  <c:v>8.15</c:v>
                </c:pt>
                <c:pt idx="6">
                  <c:v>9.7800000000000011</c:v>
                </c:pt>
                <c:pt idx="7">
                  <c:v>11.41</c:v>
                </c:pt>
                <c:pt idx="8">
                  <c:v>13.04</c:v>
                </c:pt>
                <c:pt idx="9">
                  <c:v>14.67</c:v>
                </c:pt>
                <c:pt idx="10">
                  <c:v>16.3</c:v>
                </c:pt>
                <c:pt idx="11">
                  <c:v>17.93</c:v>
                </c:pt>
                <c:pt idx="12">
                  <c:v>19.559999999999999</c:v>
                </c:pt>
                <c:pt idx="13">
                  <c:v>21.19</c:v>
                </c:pt>
                <c:pt idx="14">
                  <c:v>22.82</c:v>
                </c:pt>
                <c:pt idx="15">
                  <c:v>24.45</c:v>
                </c:pt>
                <c:pt idx="16">
                  <c:v>26.08</c:v>
                </c:pt>
                <c:pt idx="17">
                  <c:v>27.71</c:v>
                </c:pt>
                <c:pt idx="18">
                  <c:v>29.34</c:v>
                </c:pt>
                <c:pt idx="19">
                  <c:v>30.97</c:v>
                </c:pt>
                <c:pt idx="20">
                  <c:v>32.6</c:v>
                </c:pt>
                <c:pt idx="21">
                  <c:v>34.230000000000011</c:v>
                </c:pt>
                <c:pt idx="22">
                  <c:v>35.86</c:v>
                </c:pt>
                <c:pt idx="23">
                  <c:v>37.49</c:v>
                </c:pt>
                <c:pt idx="24">
                  <c:v>39.120000000000012</c:v>
                </c:pt>
                <c:pt idx="25">
                  <c:v>40.75</c:v>
                </c:pt>
                <c:pt idx="26">
                  <c:v>42.379999999999995</c:v>
                </c:pt>
                <c:pt idx="27">
                  <c:v>44.01</c:v>
                </c:pt>
                <c:pt idx="28">
                  <c:v>45.64</c:v>
                </c:pt>
                <c:pt idx="29">
                  <c:v>47.27</c:v>
                </c:pt>
                <c:pt idx="30">
                  <c:v>48.9</c:v>
                </c:pt>
                <c:pt idx="31">
                  <c:v>50.53</c:v>
                </c:pt>
                <c:pt idx="32">
                  <c:v>52.160000000000011</c:v>
                </c:pt>
                <c:pt idx="33">
                  <c:v>53.790000000000013</c:v>
                </c:pt>
                <c:pt idx="34">
                  <c:v>55.42</c:v>
                </c:pt>
                <c:pt idx="35">
                  <c:v>57.05</c:v>
                </c:pt>
                <c:pt idx="36">
                  <c:v>58.68</c:v>
                </c:pt>
                <c:pt idx="37">
                  <c:v>60.309999999999995</c:v>
                </c:pt>
                <c:pt idx="38">
                  <c:v>61.94</c:v>
                </c:pt>
                <c:pt idx="39">
                  <c:v>63.57</c:v>
                </c:pt>
                <c:pt idx="40">
                  <c:v>65.2</c:v>
                </c:pt>
                <c:pt idx="41">
                  <c:v>66.83</c:v>
                </c:pt>
                <c:pt idx="42">
                  <c:v>68.459999999999994</c:v>
                </c:pt>
                <c:pt idx="43">
                  <c:v>70.09</c:v>
                </c:pt>
                <c:pt idx="44">
                  <c:v>71.72</c:v>
                </c:pt>
                <c:pt idx="45">
                  <c:v>73.349999999999994</c:v>
                </c:pt>
                <c:pt idx="46">
                  <c:v>74.98</c:v>
                </c:pt>
                <c:pt idx="47">
                  <c:v>76.61</c:v>
                </c:pt>
                <c:pt idx="48">
                  <c:v>78.239999999999995</c:v>
                </c:pt>
                <c:pt idx="49">
                  <c:v>79.86999999999999</c:v>
                </c:pt>
                <c:pt idx="50">
                  <c:v>81.5</c:v>
                </c:pt>
                <c:pt idx="51">
                  <c:v>83.13</c:v>
                </c:pt>
                <c:pt idx="52">
                  <c:v>84.76</c:v>
                </c:pt>
                <c:pt idx="53">
                  <c:v>86.39</c:v>
                </c:pt>
                <c:pt idx="54">
                  <c:v>88.02</c:v>
                </c:pt>
                <c:pt idx="55">
                  <c:v>89.649999999999991</c:v>
                </c:pt>
                <c:pt idx="56">
                  <c:v>91.28</c:v>
                </c:pt>
                <c:pt idx="57">
                  <c:v>92.910000000000025</c:v>
                </c:pt>
                <c:pt idx="58">
                  <c:v>94.54</c:v>
                </c:pt>
                <c:pt idx="59">
                  <c:v>96.169999999999987</c:v>
                </c:pt>
                <c:pt idx="60">
                  <c:v>97.8</c:v>
                </c:pt>
                <c:pt idx="61">
                  <c:v>99.43</c:v>
                </c:pt>
                <c:pt idx="62">
                  <c:v>101.06</c:v>
                </c:pt>
                <c:pt idx="63">
                  <c:v>102.69</c:v>
                </c:pt>
                <c:pt idx="64">
                  <c:v>104.32</c:v>
                </c:pt>
                <c:pt idx="65">
                  <c:v>105.95</c:v>
                </c:pt>
                <c:pt idx="66">
                  <c:v>107.58</c:v>
                </c:pt>
                <c:pt idx="67">
                  <c:v>109.21000000000002</c:v>
                </c:pt>
                <c:pt idx="68">
                  <c:v>110.84</c:v>
                </c:pt>
                <c:pt idx="69">
                  <c:v>112.47</c:v>
                </c:pt>
                <c:pt idx="70">
                  <c:v>114.1</c:v>
                </c:pt>
                <c:pt idx="71">
                  <c:v>115.73</c:v>
                </c:pt>
                <c:pt idx="72">
                  <c:v>117.36</c:v>
                </c:pt>
                <c:pt idx="73">
                  <c:v>118.99000000000002</c:v>
                </c:pt>
                <c:pt idx="74">
                  <c:v>120.61999999999999</c:v>
                </c:pt>
                <c:pt idx="75">
                  <c:v>122.25</c:v>
                </c:pt>
                <c:pt idx="76">
                  <c:v>123.88</c:v>
                </c:pt>
                <c:pt idx="77">
                  <c:v>125.51</c:v>
                </c:pt>
                <c:pt idx="78">
                  <c:v>127.14</c:v>
                </c:pt>
                <c:pt idx="79">
                  <c:v>128.76999999999998</c:v>
                </c:pt>
                <c:pt idx="80">
                  <c:v>130.4</c:v>
                </c:pt>
                <c:pt idx="81">
                  <c:v>132.03</c:v>
                </c:pt>
                <c:pt idx="82">
                  <c:v>133.66</c:v>
                </c:pt>
                <c:pt idx="83">
                  <c:v>135.29</c:v>
                </c:pt>
                <c:pt idx="84">
                  <c:v>136.91999999999999</c:v>
                </c:pt>
                <c:pt idx="85">
                  <c:v>138.55000000000001</c:v>
                </c:pt>
                <c:pt idx="86">
                  <c:v>140.18</c:v>
                </c:pt>
                <c:pt idx="87">
                  <c:v>141.81</c:v>
                </c:pt>
                <c:pt idx="88">
                  <c:v>143.44</c:v>
                </c:pt>
                <c:pt idx="89">
                  <c:v>145.07</c:v>
                </c:pt>
                <c:pt idx="90">
                  <c:v>146.69999999999999</c:v>
                </c:pt>
                <c:pt idx="91">
                  <c:v>148.33000000000001</c:v>
                </c:pt>
                <c:pt idx="92">
                  <c:v>149.96</c:v>
                </c:pt>
                <c:pt idx="93">
                  <c:v>151.59</c:v>
                </c:pt>
                <c:pt idx="94">
                  <c:v>153.22</c:v>
                </c:pt>
                <c:pt idx="95">
                  <c:v>154.85000000000008</c:v>
                </c:pt>
                <c:pt idx="96">
                  <c:v>156.47999999999999</c:v>
                </c:pt>
                <c:pt idx="97">
                  <c:v>158.10999999999999</c:v>
                </c:pt>
                <c:pt idx="98">
                  <c:v>159.73999999999998</c:v>
                </c:pt>
                <c:pt idx="99">
                  <c:v>161.37</c:v>
                </c:pt>
                <c:pt idx="100">
                  <c:v>163</c:v>
                </c:pt>
                <c:pt idx="101">
                  <c:v>164.63</c:v>
                </c:pt>
                <c:pt idx="102">
                  <c:v>166.26</c:v>
                </c:pt>
                <c:pt idx="103">
                  <c:v>167.89000000000001</c:v>
                </c:pt>
                <c:pt idx="104">
                  <c:v>169.52</c:v>
                </c:pt>
                <c:pt idx="105">
                  <c:v>171.15</c:v>
                </c:pt>
                <c:pt idx="106">
                  <c:v>172.78</c:v>
                </c:pt>
                <c:pt idx="107">
                  <c:v>174.41</c:v>
                </c:pt>
                <c:pt idx="108">
                  <c:v>176.04</c:v>
                </c:pt>
                <c:pt idx="109">
                  <c:v>177.67</c:v>
                </c:pt>
                <c:pt idx="110">
                  <c:v>179.3</c:v>
                </c:pt>
                <c:pt idx="111">
                  <c:v>180.93</c:v>
                </c:pt>
                <c:pt idx="112">
                  <c:v>182.56</c:v>
                </c:pt>
                <c:pt idx="113">
                  <c:v>184.19</c:v>
                </c:pt>
                <c:pt idx="114">
                  <c:v>185.82000000000008</c:v>
                </c:pt>
                <c:pt idx="115">
                  <c:v>187.45000000000007</c:v>
                </c:pt>
                <c:pt idx="116">
                  <c:v>189.08</c:v>
                </c:pt>
                <c:pt idx="117">
                  <c:v>190.70999999999998</c:v>
                </c:pt>
                <c:pt idx="118">
                  <c:v>192.34</c:v>
                </c:pt>
                <c:pt idx="119">
                  <c:v>193.97</c:v>
                </c:pt>
                <c:pt idx="120">
                  <c:v>195.6</c:v>
                </c:pt>
                <c:pt idx="121">
                  <c:v>197.23</c:v>
                </c:pt>
                <c:pt idx="122">
                  <c:v>198.86</c:v>
                </c:pt>
                <c:pt idx="123">
                  <c:v>200.49</c:v>
                </c:pt>
                <c:pt idx="124">
                  <c:v>202.12</c:v>
                </c:pt>
                <c:pt idx="125">
                  <c:v>203.75</c:v>
                </c:pt>
                <c:pt idx="126">
                  <c:v>205.38000000000008</c:v>
                </c:pt>
                <c:pt idx="127">
                  <c:v>207.01</c:v>
                </c:pt>
                <c:pt idx="128">
                  <c:v>208.64</c:v>
                </c:pt>
                <c:pt idx="129">
                  <c:v>210.26999999999998</c:v>
                </c:pt>
                <c:pt idx="130">
                  <c:v>211.9</c:v>
                </c:pt>
                <c:pt idx="131">
                  <c:v>213.53</c:v>
                </c:pt>
                <c:pt idx="132">
                  <c:v>215.16</c:v>
                </c:pt>
                <c:pt idx="133">
                  <c:v>216.79</c:v>
                </c:pt>
                <c:pt idx="134">
                  <c:v>218.42000000000004</c:v>
                </c:pt>
                <c:pt idx="135">
                  <c:v>220.05</c:v>
                </c:pt>
                <c:pt idx="136">
                  <c:v>221.68</c:v>
                </c:pt>
                <c:pt idx="137">
                  <c:v>223.31</c:v>
                </c:pt>
                <c:pt idx="138">
                  <c:v>224.94</c:v>
                </c:pt>
                <c:pt idx="139">
                  <c:v>226.57</c:v>
                </c:pt>
                <c:pt idx="140">
                  <c:v>228.2</c:v>
                </c:pt>
                <c:pt idx="141">
                  <c:v>229.83</c:v>
                </c:pt>
                <c:pt idx="142">
                  <c:v>231.46</c:v>
                </c:pt>
                <c:pt idx="143">
                  <c:v>233.09</c:v>
                </c:pt>
                <c:pt idx="144">
                  <c:v>234.72</c:v>
                </c:pt>
                <c:pt idx="145">
                  <c:v>236.35000000000008</c:v>
                </c:pt>
                <c:pt idx="146">
                  <c:v>237.98000000000008</c:v>
                </c:pt>
                <c:pt idx="147">
                  <c:v>239.60999999999999</c:v>
                </c:pt>
                <c:pt idx="148">
                  <c:v>241.23999999999998</c:v>
                </c:pt>
                <c:pt idx="149">
                  <c:v>242.87</c:v>
                </c:pt>
                <c:pt idx="150">
                  <c:v>244.5</c:v>
                </c:pt>
                <c:pt idx="151">
                  <c:v>246.13</c:v>
                </c:pt>
                <c:pt idx="152">
                  <c:v>247.76</c:v>
                </c:pt>
                <c:pt idx="153">
                  <c:v>249.39000000000001</c:v>
                </c:pt>
                <c:pt idx="154">
                  <c:v>251.02</c:v>
                </c:pt>
                <c:pt idx="155">
                  <c:v>252.65</c:v>
                </c:pt>
                <c:pt idx="156">
                  <c:v>254.28</c:v>
                </c:pt>
                <c:pt idx="157">
                  <c:v>255.91</c:v>
                </c:pt>
                <c:pt idx="158">
                  <c:v>257.54000000000002</c:v>
                </c:pt>
                <c:pt idx="159">
                  <c:v>259.17</c:v>
                </c:pt>
                <c:pt idx="160">
                  <c:v>260.8</c:v>
                </c:pt>
                <c:pt idx="161">
                  <c:v>262.42999999999984</c:v>
                </c:pt>
                <c:pt idx="162">
                  <c:v>264.06</c:v>
                </c:pt>
                <c:pt idx="163">
                  <c:v>265.69</c:v>
                </c:pt>
                <c:pt idx="164">
                  <c:v>267.32</c:v>
                </c:pt>
                <c:pt idx="165">
                  <c:v>268.95</c:v>
                </c:pt>
                <c:pt idx="166">
                  <c:v>270.58</c:v>
                </c:pt>
                <c:pt idx="167">
                  <c:v>272.20999999999981</c:v>
                </c:pt>
                <c:pt idx="168">
                  <c:v>273.8399999999998</c:v>
                </c:pt>
                <c:pt idx="169">
                  <c:v>275.47000000000003</c:v>
                </c:pt>
                <c:pt idx="170">
                  <c:v>277.10000000000002</c:v>
                </c:pt>
                <c:pt idx="171">
                  <c:v>278.72999999999985</c:v>
                </c:pt>
                <c:pt idx="172">
                  <c:v>280.36</c:v>
                </c:pt>
                <c:pt idx="173">
                  <c:v>281.98999999999984</c:v>
                </c:pt>
                <c:pt idx="174">
                  <c:v>283.62</c:v>
                </c:pt>
                <c:pt idx="175">
                  <c:v>285.25</c:v>
                </c:pt>
                <c:pt idx="176">
                  <c:v>286.88</c:v>
                </c:pt>
                <c:pt idx="177">
                  <c:v>288.51</c:v>
                </c:pt>
                <c:pt idx="178">
                  <c:v>290.14000000000016</c:v>
                </c:pt>
                <c:pt idx="179">
                  <c:v>291.77</c:v>
                </c:pt>
                <c:pt idx="180">
                  <c:v>293.39999999999981</c:v>
                </c:pt>
                <c:pt idx="181">
                  <c:v>295.0299999999998</c:v>
                </c:pt>
                <c:pt idx="182">
                  <c:v>296.66000000000008</c:v>
                </c:pt>
                <c:pt idx="183">
                  <c:v>298.28999999999985</c:v>
                </c:pt>
                <c:pt idx="184">
                  <c:v>299.91999999999985</c:v>
                </c:pt>
                <c:pt idx="185">
                  <c:v>301.55</c:v>
                </c:pt>
                <c:pt idx="186">
                  <c:v>303.18</c:v>
                </c:pt>
                <c:pt idx="187">
                  <c:v>304.81</c:v>
                </c:pt>
                <c:pt idx="188">
                  <c:v>306.44</c:v>
                </c:pt>
                <c:pt idx="189">
                  <c:v>308.07</c:v>
                </c:pt>
                <c:pt idx="190">
                  <c:v>309.7</c:v>
                </c:pt>
                <c:pt idx="191">
                  <c:v>311.33</c:v>
                </c:pt>
                <c:pt idx="192">
                  <c:v>312.95999999999981</c:v>
                </c:pt>
                <c:pt idx="193">
                  <c:v>314.5899999999998</c:v>
                </c:pt>
                <c:pt idx="194">
                  <c:v>316.22000000000003</c:v>
                </c:pt>
                <c:pt idx="195">
                  <c:v>317.85000000000002</c:v>
                </c:pt>
                <c:pt idx="196">
                  <c:v>319.47999999999985</c:v>
                </c:pt>
                <c:pt idx="197">
                  <c:v>321.11</c:v>
                </c:pt>
                <c:pt idx="198">
                  <c:v>322.74</c:v>
                </c:pt>
                <c:pt idx="199">
                  <c:v>324.37</c:v>
                </c:pt>
                <c:pt idx="200">
                  <c:v>326</c:v>
                </c:pt>
                <c:pt idx="201">
                  <c:v>327.63</c:v>
                </c:pt>
                <c:pt idx="202">
                  <c:v>329.26</c:v>
                </c:pt>
                <c:pt idx="203">
                  <c:v>330.89</c:v>
                </c:pt>
                <c:pt idx="204">
                  <c:v>332.52</c:v>
                </c:pt>
                <c:pt idx="205">
                  <c:v>334.15000000000015</c:v>
                </c:pt>
                <c:pt idx="206">
                  <c:v>335.78</c:v>
                </c:pt>
                <c:pt idx="207">
                  <c:v>337.40999999999985</c:v>
                </c:pt>
                <c:pt idx="208">
                  <c:v>339.04</c:v>
                </c:pt>
                <c:pt idx="209">
                  <c:v>340.67</c:v>
                </c:pt>
                <c:pt idx="210">
                  <c:v>342.3</c:v>
                </c:pt>
                <c:pt idx="211">
                  <c:v>343.92999999999984</c:v>
                </c:pt>
                <c:pt idx="212">
                  <c:v>345.56</c:v>
                </c:pt>
                <c:pt idx="213">
                  <c:v>347.19</c:v>
                </c:pt>
                <c:pt idx="214">
                  <c:v>348.82</c:v>
                </c:pt>
                <c:pt idx="215">
                  <c:v>350.45</c:v>
                </c:pt>
                <c:pt idx="216">
                  <c:v>352.08</c:v>
                </c:pt>
                <c:pt idx="217">
                  <c:v>353.71</c:v>
                </c:pt>
                <c:pt idx="218">
                  <c:v>355.34000000000015</c:v>
                </c:pt>
                <c:pt idx="219">
                  <c:v>356.96999999999986</c:v>
                </c:pt>
                <c:pt idx="220">
                  <c:v>358.6</c:v>
                </c:pt>
                <c:pt idx="221">
                  <c:v>360.22999999999985</c:v>
                </c:pt>
                <c:pt idx="222">
                  <c:v>361.86</c:v>
                </c:pt>
                <c:pt idx="223">
                  <c:v>363.48999999999984</c:v>
                </c:pt>
                <c:pt idx="224">
                  <c:v>365.12</c:v>
                </c:pt>
                <c:pt idx="225">
                  <c:v>366.75</c:v>
                </c:pt>
                <c:pt idx="226">
                  <c:v>368.38</c:v>
                </c:pt>
                <c:pt idx="227">
                  <c:v>370.01</c:v>
                </c:pt>
                <c:pt idx="228">
                  <c:v>371.64000000000016</c:v>
                </c:pt>
                <c:pt idx="229">
                  <c:v>373.27</c:v>
                </c:pt>
                <c:pt idx="230">
                  <c:v>374.9</c:v>
                </c:pt>
                <c:pt idx="231">
                  <c:v>376.53</c:v>
                </c:pt>
                <c:pt idx="232">
                  <c:v>378.16</c:v>
                </c:pt>
                <c:pt idx="233">
                  <c:v>379.78999999999985</c:v>
                </c:pt>
                <c:pt idx="234">
                  <c:v>381.41999999999985</c:v>
                </c:pt>
                <c:pt idx="235">
                  <c:v>383.05</c:v>
                </c:pt>
                <c:pt idx="236">
                  <c:v>384.68</c:v>
                </c:pt>
                <c:pt idx="237">
                  <c:v>386.31</c:v>
                </c:pt>
                <c:pt idx="238">
                  <c:v>387.94</c:v>
                </c:pt>
                <c:pt idx="239">
                  <c:v>389.57</c:v>
                </c:pt>
                <c:pt idx="240">
                  <c:v>391.2</c:v>
                </c:pt>
                <c:pt idx="241">
                  <c:v>392.83</c:v>
                </c:pt>
                <c:pt idx="242">
                  <c:v>394.46</c:v>
                </c:pt>
                <c:pt idx="243">
                  <c:v>396.09</c:v>
                </c:pt>
                <c:pt idx="244">
                  <c:v>397.71999999999986</c:v>
                </c:pt>
                <c:pt idx="245">
                  <c:v>399.35</c:v>
                </c:pt>
                <c:pt idx="246">
                  <c:v>400.97999999999985</c:v>
                </c:pt>
                <c:pt idx="247">
                  <c:v>402.61</c:v>
                </c:pt>
                <c:pt idx="248">
                  <c:v>404.24</c:v>
                </c:pt>
                <c:pt idx="249">
                  <c:v>405.87</c:v>
                </c:pt>
                <c:pt idx="250">
                  <c:v>407.5</c:v>
                </c:pt>
                <c:pt idx="251">
                  <c:v>409.13</c:v>
                </c:pt>
                <c:pt idx="252">
                  <c:v>410.76</c:v>
                </c:pt>
                <c:pt idx="253">
                  <c:v>412.39</c:v>
                </c:pt>
                <c:pt idx="254">
                  <c:v>414.02</c:v>
                </c:pt>
                <c:pt idx="255">
                  <c:v>415.65000000000015</c:v>
                </c:pt>
                <c:pt idx="256">
                  <c:v>417.28</c:v>
                </c:pt>
                <c:pt idx="257">
                  <c:v>418.90999999999985</c:v>
                </c:pt>
                <c:pt idx="258">
                  <c:v>420.54</c:v>
                </c:pt>
                <c:pt idx="259">
                  <c:v>422.17</c:v>
                </c:pt>
                <c:pt idx="260">
                  <c:v>423.8</c:v>
                </c:pt>
                <c:pt idx="261">
                  <c:v>425.42999999999984</c:v>
                </c:pt>
                <c:pt idx="262">
                  <c:v>427.06</c:v>
                </c:pt>
                <c:pt idx="263">
                  <c:v>428.69</c:v>
                </c:pt>
                <c:pt idx="264">
                  <c:v>430.32</c:v>
                </c:pt>
                <c:pt idx="265">
                  <c:v>431.95</c:v>
                </c:pt>
                <c:pt idx="266">
                  <c:v>433.58</c:v>
                </c:pt>
                <c:pt idx="267">
                  <c:v>435.21</c:v>
                </c:pt>
                <c:pt idx="268">
                  <c:v>436.84000000000015</c:v>
                </c:pt>
                <c:pt idx="269">
                  <c:v>438.46999999999986</c:v>
                </c:pt>
                <c:pt idx="270">
                  <c:v>440.1</c:v>
                </c:pt>
                <c:pt idx="271">
                  <c:v>441.72999999999985</c:v>
                </c:pt>
                <c:pt idx="272">
                  <c:v>443.36</c:v>
                </c:pt>
                <c:pt idx="273">
                  <c:v>444.98999999999984</c:v>
                </c:pt>
                <c:pt idx="274">
                  <c:v>446.62</c:v>
                </c:pt>
                <c:pt idx="275">
                  <c:v>448.25</c:v>
                </c:pt>
                <c:pt idx="276">
                  <c:v>449.88</c:v>
                </c:pt>
                <c:pt idx="277">
                  <c:v>451.51</c:v>
                </c:pt>
                <c:pt idx="278">
                  <c:v>453.14000000000016</c:v>
                </c:pt>
                <c:pt idx="279">
                  <c:v>454.77</c:v>
                </c:pt>
                <c:pt idx="280">
                  <c:v>456.4</c:v>
                </c:pt>
                <c:pt idx="281">
                  <c:v>458.03</c:v>
                </c:pt>
                <c:pt idx="282">
                  <c:v>459.66</c:v>
                </c:pt>
                <c:pt idx="283">
                  <c:v>461.28999999999985</c:v>
                </c:pt>
                <c:pt idx="284">
                  <c:v>462.91999999999985</c:v>
                </c:pt>
                <c:pt idx="285">
                  <c:v>464.55</c:v>
                </c:pt>
                <c:pt idx="286">
                  <c:v>466.18</c:v>
                </c:pt>
                <c:pt idx="287">
                  <c:v>467.81</c:v>
                </c:pt>
                <c:pt idx="288">
                  <c:v>469.44</c:v>
                </c:pt>
                <c:pt idx="289">
                  <c:v>471.07</c:v>
                </c:pt>
                <c:pt idx="290">
                  <c:v>472.7</c:v>
                </c:pt>
                <c:pt idx="291">
                  <c:v>474.33</c:v>
                </c:pt>
                <c:pt idx="292">
                  <c:v>475.96</c:v>
                </c:pt>
                <c:pt idx="293">
                  <c:v>477.59</c:v>
                </c:pt>
                <c:pt idx="294">
                  <c:v>479.21999999999986</c:v>
                </c:pt>
                <c:pt idx="295">
                  <c:v>480.85</c:v>
                </c:pt>
                <c:pt idx="296">
                  <c:v>482.47999999999985</c:v>
                </c:pt>
                <c:pt idx="297">
                  <c:v>484.11</c:v>
                </c:pt>
                <c:pt idx="298">
                  <c:v>485.74</c:v>
                </c:pt>
                <c:pt idx="299">
                  <c:v>487.37</c:v>
                </c:pt>
                <c:pt idx="300">
                  <c:v>489</c:v>
                </c:pt>
                <c:pt idx="301">
                  <c:v>490.63</c:v>
                </c:pt>
                <c:pt idx="302">
                  <c:v>492.26</c:v>
                </c:pt>
                <c:pt idx="303">
                  <c:v>493.89</c:v>
                </c:pt>
                <c:pt idx="304">
                  <c:v>495.52</c:v>
                </c:pt>
                <c:pt idx="305">
                  <c:v>497.15000000000015</c:v>
                </c:pt>
                <c:pt idx="306">
                  <c:v>498.78</c:v>
                </c:pt>
                <c:pt idx="307">
                  <c:v>500.4099999999998</c:v>
                </c:pt>
                <c:pt idx="308">
                  <c:v>502.03999999999979</c:v>
                </c:pt>
                <c:pt idx="309">
                  <c:v>503.66999999999996</c:v>
                </c:pt>
                <c:pt idx="310">
                  <c:v>505.29999999999978</c:v>
                </c:pt>
                <c:pt idx="311">
                  <c:v>506.92999999999978</c:v>
                </c:pt>
                <c:pt idx="312">
                  <c:v>508.55999999999995</c:v>
                </c:pt>
                <c:pt idx="313">
                  <c:v>510.18999999999994</c:v>
                </c:pt>
                <c:pt idx="314">
                  <c:v>511.81999999999994</c:v>
                </c:pt>
                <c:pt idx="315">
                  <c:v>513.44999999999959</c:v>
                </c:pt>
                <c:pt idx="316">
                  <c:v>515.07999999999993</c:v>
                </c:pt>
                <c:pt idx="317">
                  <c:v>516.70999999999992</c:v>
                </c:pt>
                <c:pt idx="318">
                  <c:v>518.33999999999958</c:v>
                </c:pt>
                <c:pt idx="319">
                  <c:v>519.96999999999957</c:v>
                </c:pt>
                <c:pt idx="320">
                  <c:v>521.59999999999991</c:v>
                </c:pt>
                <c:pt idx="321">
                  <c:v>523.2299999999999</c:v>
                </c:pt>
                <c:pt idx="322">
                  <c:v>524.85999999999956</c:v>
                </c:pt>
                <c:pt idx="323">
                  <c:v>526.4899999999999</c:v>
                </c:pt>
                <c:pt idx="324">
                  <c:v>528.11999999999989</c:v>
                </c:pt>
                <c:pt idx="325">
                  <c:v>529.74999999999989</c:v>
                </c:pt>
                <c:pt idx="326">
                  <c:v>531.37999999999988</c:v>
                </c:pt>
                <c:pt idx="327">
                  <c:v>533.00999999999988</c:v>
                </c:pt>
                <c:pt idx="328">
                  <c:v>534.63999999999987</c:v>
                </c:pt>
                <c:pt idx="329">
                  <c:v>536.26999999999987</c:v>
                </c:pt>
                <c:pt idx="330">
                  <c:v>537.89999999999986</c:v>
                </c:pt>
                <c:pt idx="331">
                  <c:v>539.52999999999986</c:v>
                </c:pt>
                <c:pt idx="332">
                  <c:v>541.15999999999951</c:v>
                </c:pt>
                <c:pt idx="333">
                  <c:v>542.78999999999985</c:v>
                </c:pt>
                <c:pt idx="334">
                  <c:v>544.4199999999995</c:v>
                </c:pt>
                <c:pt idx="335">
                  <c:v>546.0499999999995</c:v>
                </c:pt>
                <c:pt idx="336">
                  <c:v>547.67999999999984</c:v>
                </c:pt>
                <c:pt idx="337">
                  <c:v>549.30999999999949</c:v>
                </c:pt>
                <c:pt idx="338">
                  <c:v>550.93999999999949</c:v>
                </c:pt>
                <c:pt idx="339">
                  <c:v>552.56999999999948</c:v>
                </c:pt>
                <c:pt idx="340">
                  <c:v>554.19999999999982</c:v>
                </c:pt>
                <c:pt idx="341">
                  <c:v>555.82999999999947</c:v>
                </c:pt>
                <c:pt idx="342">
                  <c:v>557.45999999999947</c:v>
                </c:pt>
                <c:pt idx="343">
                  <c:v>559.0899999999998</c:v>
                </c:pt>
                <c:pt idx="344">
                  <c:v>560.7199999999998</c:v>
                </c:pt>
                <c:pt idx="345">
                  <c:v>562.34999999999945</c:v>
                </c:pt>
                <c:pt idx="346">
                  <c:v>563.97999999999979</c:v>
                </c:pt>
                <c:pt idx="347">
                  <c:v>565.60999999999979</c:v>
                </c:pt>
                <c:pt idx="348">
                  <c:v>567.23999999999978</c:v>
                </c:pt>
                <c:pt idx="349">
                  <c:v>568.86999999999932</c:v>
                </c:pt>
                <c:pt idx="350">
                  <c:v>570.49999999999977</c:v>
                </c:pt>
                <c:pt idx="351">
                  <c:v>572.12999999999977</c:v>
                </c:pt>
                <c:pt idx="352">
                  <c:v>573.75999999999976</c:v>
                </c:pt>
                <c:pt idx="353">
                  <c:v>575.38999999999976</c:v>
                </c:pt>
                <c:pt idx="354">
                  <c:v>577.01999999999941</c:v>
                </c:pt>
                <c:pt idx="355">
                  <c:v>578.64999999999941</c:v>
                </c:pt>
                <c:pt idx="356">
                  <c:v>580.27999999999975</c:v>
                </c:pt>
                <c:pt idx="357">
                  <c:v>581.9099999999994</c:v>
                </c:pt>
                <c:pt idx="358">
                  <c:v>583.5399999999994</c:v>
                </c:pt>
                <c:pt idx="359">
                  <c:v>585.16999999999939</c:v>
                </c:pt>
                <c:pt idx="360">
                  <c:v>586.79999999999973</c:v>
                </c:pt>
                <c:pt idx="361">
                  <c:v>588.42999999999938</c:v>
                </c:pt>
                <c:pt idx="362">
                  <c:v>590.05999999999949</c:v>
                </c:pt>
                <c:pt idx="363">
                  <c:v>591.68999999999971</c:v>
                </c:pt>
                <c:pt idx="364">
                  <c:v>593.31999999999948</c:v>
                </c:pt>
                <c:pt idx="365">
                  <c:v>594.94999999999948</c:v>
                </c:pt>
                <c:pt idx="366">
                  <c:v>596.5799999999997</c:v>
                </c:pt>
                <c:pt idx="367">
                  <c:v>598.2099999999997</c:v>
                </c:pt>
                <c:pt idx="368">
                  <c:v>599.83999999999946</c:v>
                </c:pt>
                <c:pt idx="369">
                  <c:v>601.46999999999946</c:v>
                </c:pt>
                <c:pt idx="370">
                  <c:v>603.09999999999968</c:v>
                </c:pt>
                <c:pt idx="371">
                  <c:v>604.72999999999968</c:v>
                </c:pt>
                <c:pt idx="372">
                  <c:v>606.35999999999933</c:v>
                </c:pt>
                <c:pt idx="373">
                  <c:v>607.98999999999967</c:v>
                </c:pt>
                <c:pt idx="374">
                  <c:v>609.61999999999966</c:v>
                </c:pt>
                <c:pt idx="375">
                  <c:v>611.24999999999966</c:v>
                </c:pt>
                <c:pt idx="376">
                  <c:v>612.87999999999943</c:v>
                </c:pt>
                <c:pt idx="377">
                  <c:v>614.50999999999942</c:v>
                </c:pt>
                <c:pt idx="378">
                  <c:v>616.13999999999942</c:v>
                </c:pt>
                <c:pt idx="379">
                  <c:v>617.76999999999941</c:v>
                </c:pt>
                <c:pt idx="380">
                  <c:v>619.39999999999941</c:v>
                </c:pt>
                <c:pt idx="381">
                  <c:v>621.0299999999994</c:v>
                </c:pt>
                <c:pt idx="382">
                  <c:v>622.6599999999994</c:v>
                </c:pt>
                <c:pt idx="383">
                  <c:v>624.28999999999962</c:v>
                </c:pt>
                <c:pt idx="384">
                  <c:v>625.91999999999939</c:v>
                </c:pt>
                <c:pt idx="385">
                  <c:v>627.54999999999939</c:v>
                </c:pt>
                <c:pt idx="386">
                  <c:v>629.17999999999961</c:v>
                </c:pt>
                <c:pt idx="387">
                  <c:v>630.80999999999949</c:v>
                </c:pt>
                <c:pt idx="388">
                  <c:v>632.43999999999949</c:v>
                </c:pt>
                <c:pt idx="389">
                  <c:v>634.06999999999948</c:v>
                </c:pt>
                <c:pt idx="390">
                  <c:v>635.69999999999959</c:v>
                </c:pt>
                <c:pt idx="391">
                  <c:v>637.32999999999947</c:v>
                </c:pt>
                <c:pt idx="392">
                  <c:v>638.95999999999947</c:v>
                </c:pt>
                <c:pt idx="393">
                  <c:v>640.58999999999958</c:v>
                </c:pt>
                <c:pt idx="394">
                  <c:v>642.21999999999957</c:v>
                </c:pt>
                <c:pt idx="395">
                  <c:v>643.84999999999923</c:v>
                </c:pt>
                <c:pt idx="396">
                  <c:v>645.47999999999956</c:v>
                </c:pt>
                <c:pt idx="397">
                  <c:v>647.10999999999956</c:v>
                </c:pt>
                <c:pt idx="398">
                  <c:v>648.73999999999944</c:v>
                </c:pt>
                <c:pt idx="399">
                  <c:v>650.3699999999991</c:v>
                </c:pt>
                <c:pt idx="400">
                  <c:v>651.99999999999943</c:v>
                </c:pt>
                <c:pt idx="401">
                  <c:v>653.62999999999943</c:v>
                </c:pt>
                <c:pt idx="402">
                  <c:v>655.25999999999942</c:v>
                </c:pt>
                <c:pt idx="403">
                  <c:v>656.88999999999942</c:v>
                </c:pt>
                <c:pt idx="404">
                  <c:v>658.51999999999941</c:v>
                </c:pt>
                <c:pt idx="405">
                  <c:v>660.14999999999941</c:v>
                </c:pt>
                <c:pt idx="406">
                  <c:v>661.77999999999952</c:v>
                </c:pt>
                <c:pt idx="407">
                  <c:v>663.4099999999994</c:v>
                </c:pt>
                <c:pt idx="408">
                  <c:v>665.0399999999994</c:v>
                </c:pt>
                <c:pt idx="409">
                  <c:v>666.66999999999939</c:v>
                </c:pt>
                <c:pt idx="410">
                  <c:v>668.2999999999995</c:v>
                </c:pt>
                <c:pt idx="411">
                  <c:v>669.92999999999938</c:v>
                </c:pt>
                <c:pt idx="412">
                  <c:v>671.55999999999949</c:v>
                </c:pt>
                <c:pt idx="413">
                  <c:v>673.1899999999996</c:v>
                </c:pt>
                <c:pt idx="414">
                  <c:v>674.81999999999948</c:v>
                </c:pt>
                <c:pt idx="415">
                  <c:v>676.44999999999948</c:v>
                </c:pt>
                <c:pt idx="416">
                  <c:v>678.07999999999959</c:v>
                </c:pt>
                <c:pt idx="417">
                  <c:v>679.70999999999958</c:v>
                </c:pt>
                <c:pt idx="418">
                  <c:v>681.33999999999946</c:v>
                </c:pt>
                <c:pt idx="419">
                  <c:v>682.96999999999946</c:v>
                </c:pt>
                <c:pt idx="420">
                  <c:v>684.59999999999945</c:v>
                </c:pt>
                <c:pt idx="421">
                  <c:v>686.22999999999945</c:v>
                </c:pt>
                <c:pt idx="422">
                  <c:v>687.8599999999991</c:v>
                </c:pt>
                <c:pt idx="423">
                  <c:v>689.48999999999944</c:v>
                </c:pt>
                <c:pt idx="424">
                  <c:v>691.11999999999944</c:v>
                </c:pt>
                <c:pt idx="425">
                  <c:v>692.74999999999943</c:v>
                </c:pt>
                <c:pt idx="426">
                  <c:v>694.37999999999943</c:v>
                </c:pt>
                <c:pt idx="427">
                  <c:v>696.00999999999942</c:v>
                </c:pt>
                <c:pt idx="428">
                  <c:v>697.63999999999942</c:v>
                </c:pt>
                <c:pt idx="429">
                  <c:v>699.26999999999941</c:v>
                </c:pt>
                <c:pt idx="430">
                  <c:v>700.89999999999941</c:v>
                </c:pt>
                <c:pt idx="431">
                  <c:v>702.5299999999994</c:v>
                </c:pt>
                <c:pt idx="432">
                  <c:v>704.1599999999994</c:v>
                </c:pt>
                <c:pt idx="433">
                  <c:v>705.78999999999951</c:v>
                </c:pt>
                <c:pt idx="434">
                  <c:v>707.41999999999939</c:v>
                </c:pt>
                <c:pt idx="435">
                  <c:v>709.04999999999939</c:v>
                </c:pt>
                <c:pt idx="436">
                  <c:v>710.6799999999995</c:v>
                </c:pt>
                <c:pt idx="437">
                  <c:v>712.30999999999938</c:v>
                </c:pt>
                <c:pt idx="438">
                  <c:v>713.93999999999937</c:v>
                </c:pt>
                <c:pt idx="439">
                  <c:v>715.56999999999937</c:v>
                </c:pt>
                <c:pt idx="440">
                  <c:v>717.19999999999959</c:v>
                </c:pt>
                <c:pt idx="441">
                  <c:v>718.82999999999936</c:v>
                </c:pt>
                <c:pt idx="442">
                  <c:v>720.45999999999901</c:v>
                </c:pt>
                <c:pt idx="443">
                  <c:v>722.08999999999935</c:v>
                </c:pt>
                <c:pt idx="444">
                  <c:v>723.71999999999935</c:v>
                </c:pt>
                <c:pt idx="445">
                  <c:v>725.349999999999</c:v>
                </c:pt>
                <c:pt idx="446">
                  <c:v>726.97999999999934</c:v>
                </c:pt>
                <c:pt idx="447">
                  <c:v>728.60999999999933</c:v>
                </c:pt>
                <c:pt idx="448">
                  <c:v>730.23999999999933</c:v>
                </c:pt>
                <c:pt idx="449">
                  <c:v>731.86999999999898</c:v>
                </c:pt>
                <c:pt idx="450">
                  <c:v>733.49999999999932</c:v>
                </c:pt>
                <c:pt idx="451">
                  <c:v>735.12999999999931</c:v>
                </c:pt>
                <c:pt idx="452">
                  <c:v>736.75999999999931</c:v>
                </c:pt>
                <c:pt idx="453">
                  <c:v>738.3899999999993</c:v>
                </c:pt>
                <c:pt idx="454">
                  <c:v>740.0199999999993</c:v>
                </c:pt>
                <c:pt idx="455">
                  <c:v>741.6499999999993</c:v>
                </c:pt>
                <c:pt idx="456">
                  <c:v>743.27999999999952</c:v>
                </c:pt>
                <c:pt idx="457">
                  <c:v>744.90999999999929</c:v>
                </c:pt>
                <c:pt idx="458">
                  <c:v>746.53999999999928</c:v>
                </c:pt>
                <c:pt idx="459">
                  <c:v>748.16999999999928</c:v>
                </c:pt>
                <c:pt idx="460">
                  <c:v>749.7999999999995</c:v>
                </c:pt>
                <c:pt idx="461">
                  <c:v>751.42999999999927</c:v>
                </c:pt>
                <c:pt idx="462">
                  <c:v>753.05999999999926</c:v>
                </c:pt>
                <c:pt idx="463">
                  <c:v>754.6899999999996</c:v>
                </c:pt>
                <c:pt idx="464">
                  <c:v>756.31999999999891</c:v>
                </c:pt>
                <c:pt idx="465">
                  <c:v>757.94999999999891</c:v>
                </c:pt>
                <c:pt idx="466">
                  <c:v>759.57999999999925</c:v>
                </c:pt>
                <c:pt idx="467">
                  <c:v>761.20999999999924</c:v>
                </c:pt>
                <c:pt idx="468">
                  <c:v>762.83999999999889</c:v>
                </c:pt>
                <c:pt idx="469">
                  <c:v>764.46999999999889</c:v>
                </c:pt>
                <c:pt idx="470">
                  <c:v>766.09999999999923</c:v>
                </c:pt>
                <c:pt idx="471">
                  <c:v>767.72999999999922</c:v>
                </c:pt>
                <c:pt idx="472">
                  <c:v>769.35999999999888</c:v>
                </c:pt>
                <c:pt idx="473">
                  <c:v>770.98999999999921</c:v>
                </c:pt>
                <c:pt idx="474">
                  <c:v>772.61999999999921</c:v>
                </c:pt>
                <c:pt idx="475">
                  <c:v>774.2499999999992</c:v>
                </c:pt>
                <c:pt idx="476">
                  <c:v>775.8799999999992</c:v>
                </c:pt>
                <c:pt idx="477">
                  <c:v>777.5099999999992</c:v>
                </c:pt>
                <c:pt idx="478">
                  <c:v>779.13999999999919</c:v>
                </c:pt>
                <c:pt idx="479">
                  <c:v>780.76999999999919</c:v>
                </c:pt>
                <c:pt idx="480">
                  <c:v>782.39999999999918</c:v>
                </c:pt>
                <c:pt idx="481">
                  <c:v>784.02999999999918</c:v>
                </c:pt>
                <c:pt idx="482">
                  <c:v>785.65999999999917</c:v>
                </c:pt>
                <c:pt idx="483">
                  <c:v>787.28999999999951</c:v>
                </c:pt>
                <c:pt idx="484">
                  <c:v>788.91999999999916</c:v>
                </c:pt>
                <c:pt idx="485">
                  <c:v>790.54999999999916</c:v>
                </c:pt>
                <c:pt idx="486">
                  <c:v>792.17999999999915</c:v>
                </c:pt>
                <c:pt idx="487">
                  <c:v>793.80999999999881</c:v>
                </c:pt>
                <c:pt idx="488">
                  <c:v>795.4399999999988</c:v>
                </c:pt>
                <c:pt idx="489">
                  <c:v>797.0699999999988</c:v>
                </c:pt>
                <c:pt idx="490">
                  <c:v>798.69999999999914</c:v>
                </c:pt>
                <c:pt idx="491">
                  <c:v>800.32999999999879</c:v>
                </c:pt>
                <c:pt idx="492">
                  <c:v>801.95999999999879</c:v>
                </c:pt>
                <c:pt idx="493">
                  <c:v>803.58999999999912</c:v>
                </c:pt>
                <c:pt idx="494">
                  <c:v>805.21999999999912</c:v>
                </c:pt>
                <c:pt idx="495">
                  <c:v>806.84999999999877</c:v>
                </c:pt>
                <c:pt idx="496">
                  <c:v>808.47999999999911</c:v>
                </c:pt>
                <c:pt idx="497">
                  <c:v>810.1099999999991</c:v>
                </c:pt>
                <c:pt idx="498">
                  <c:v>811.7399999999991</c:v>
                </c:pt>
                <c:pt idx="499">
                  <c:v>813.36999999999875</c:v>
                </c:pt>
                <c:pt idx="500">
                  <c:v>814.99999999999909</c:v>
                </c:pt>
                <c:pt idx="501">
                  <c:v>816.62999999999909</c:v>
                </c:pt>
                <c:pt idx="502">
                  <c:v>818.25999999999908</c:v>
                </c:pt>
                <c:pt idx="503">
                  <c:v>819.88999999999908</c:v>
                </c:pt>
                <c:pt idx="504">
                  <c:v>821.51999999999907</c:v>
                </c:pt>
                <c:pt idx="505">
                  <c:v>823.14999999999907</c:v>
                </c:pt>
                <c:pt idx="506">
                  <c:v>824.7799999999994</c:v>
                </c:pt>
                <c:pt idx="507">
                  <c:v>826.40999999999906</c:v>
                </c:pt>
                <c:pt idx="508">
                  <c:v>828.03999999999871</c:v>
                </c:pt>
                <c:pt idx="509">
                  <c:v>829.66999999999871</c:v>
                </c:pt>
                <c:pt idx="510">
                  <c:v>831.29999999999905</c:v>
                </c:pt>
                <c:pt idx="511">
                  <c:v>832.9299999999987</c:v>
                </c:pt>
                <c:pt idx="512">
                  <c:v>834.55999999999869</c:v>
                </c:pt>
                <c:pt idx="513">
                  <c:v>836.18999999999903</c:v>
                </c:pt>
                <c:pt idx="514">
                  <c:v>837.81999999999869</c:v>
                </c:pt>
                <c:pt idx="515">
                  <c:v>839.44999999999868</c:v>
                </c:pt>
                <c:pt idx="516">
                  <c:v>841.07999999999902</c:v>
                </c:pt>
                <c:pt idx="517">
                  <c:v>842.70999999999901</c:v>
                </c:pt>
                <c:pt idx="518">
                  <c:v>844.33999999999867</c:v>
                </c:pt>
                <c:pt idx="519">
                  <c:v>845.96999999999866</c:v>
                </c:pt>
                <c:pt idx="520">
                  <c:v>847.599999999999</c:v>
                </c:pt>
                <c:pt idx="521">
                  <c:v>849.229999999999</c:v>
                </c:pt>
                <c:pt idx="522">
                  <c:v>850.85999999999865</c:v>
                </c:pt>
                <c:pt idx="523">
                  <c:v>852.48999999999899</c:v>
                </c:pt>
                <c:pt idx="524">
                  <c:v>854.11999999999898</c:v>
                </c:pt>
                <c:pt idx="525">
                  <c:v>855.74999999999898</c:v>
                </c:pt>
                <c:pt idx="526">
                  <c:v>857.37999999999897</c:v>
                </c:pt>
                <c:pt idx="527">
                  <c:v>859.00999999999897</c:v>
                </c:pt>
                <c:pt idx="528">
                  <c:v>860.63999999999896</c:v>
                </c:pt>
                <c:pt idx="529">
                  <c:v>862.26999999999896</c:v>
                </c:pt>
                <c:pt idx="530">
                  <c:v>863.89999999999861</c:v>
                </c:pt>
                <c:pt idx="531">
                  <c:v>865.52999999999861</c:v>
                </c:pt>
                <c:pt idx="532">
                  <c:v>867.1599999999986</c:v>
                </c:pt>
                <c:pt idx="533">
                  <c:v>868.78999999999894</c:v>
                </c:pt>
                <c:pt idx="534">
                  <c:v>870.41999999999859</c:v>
                </c:pt>
                <c:pt idx="535">
                  <c:v>872.04999999999859</c:v>
                </c:pt>
                <c:pt idx="536">
                  <c:v>873.67999999999893</c:v>
                </c:pt>
                <c:pt idx="537">
                  <c:v>875.30999999999858</c:v>
                </c:pt>
                <c:pt idx="538">
                  <c:v>876.93999999999858</c:v>
                </c:pt>
                <c:pt idx="539">
                  <c:v>878.56999999999857</c:v>
                </c:pt>
                <c:pt idx="540">
                  <c:v>880.19999999999891</c:v>
                </c:pt>
                <c:pt idx="541">
                  <c:v>881.82999999999856</c:v>
                </c:pt>
                <c:pt idx="542">
                  <c:v>883.45999999999856</c:v>
                </c:pt>
                <c:pt idx="543">
                  <c:v>885.08999999999889</c:v>
                </c:pt>
                <c:pt idx="544">
                  <c:v>886.71999999999889</c:v>
                </c:pt>
                <c:pt idx="545">
                  <c:v>888.34999999999854</c:v>
                </c:pt>
                <c:pt idx="546">
                  <c:v>889.97999999999888</c:v>
                </c:pt>
                <c:pt idx="547">
                  <c:v>891.60999999999888</c:v>
                </c:pt>
                <c:pt idx="548">
                  <c:v>893.23999999999887</c:v>
                </c:pt>
                <c:pt idx="549">
                  <c:v>894.8699999999983</c:v>
                </c:pt>
                <c:pt idx="550">
                  <c:v>896.49999999999886</c:v>
                </c:pt>
                <c:pt idx="551">
                  <c:v>898.12999999999886</c:v>
                </c:pt>
                <c:pt idx="552">
                  <c:v>899.75999999999851</c:v>
                </c:pt>
                <c:pt idx="553">
                  <c:v>901.38999999999851</c:v>
                </c:pt>
                <c:pt idx="554">
                  <c:v>903.0199999999985</c:v>
                </c:pt>
                <c:pt idx="555">
                  <c:v>904.6499999999985</c:v>
                </c:pt>
                <c:pt idx="556">
                  <c:v>906.27999999999884</c:v>
                </c:pt>
                <c:pt idx="557">
                  <c:v>907.90999999999849</c:v>
                </c:pt>
                <c:pt idx="558">
                  <c:v>909.53999999999849</c:v>
                </c:pt>
                <c:pt idx="559">
                  <c:v>911.16999999999848</c:v>
                </c:pt>
                <c:pt idx="560">
                  <c:v>912.79999999999882</c:v>
                </c:pt>
                <c:pt idx="561">
                  <c:v>914.42999999999847</c:v>
                </c:pt>
                <c:pt idx="562">
                  <c:v>916.05999999999847</c:v>
                </c:pt>
                <c:pt idx="563">
                  <c:v>917.6899999999988</c:v>
                </c:pt>
                <c:pt idx="564">
                  <c:v>919.31999999999846</c:v>
                </c:pt>
                <c:pt idx="565">
                  <c:v>920.94999999999845</c:v>
                </c:pt>
                <c:pt idx="566">
                  <c:v>922.57999999999879</c:v>
                </c:pt>
                <c:pt idx="567">
                  <c:v>924.20999999999879</c:v>
                </c:pt>
                <c:pt idx="568">
                  <c:v>925.83999999999833</c:v>
                </c:pt>
                <c:pt idx="569">
                  <c:v>927.46999999999832</c:v>
                </c:pt>
                <c:pt idx="570">
                  <c:v>929.09999999999877</c:v>
                </c:pt>
                <c:pt idx="571">
                  <c:v>930.72999999999877</c:v>
                </c:pt>
                <c:pt idx="572">
                  <c:v>932.35999999999831</c:v>
                </c:pt>
                <c:pt idx="573">
                  <c:v>933.98999999999876</c:v>
                </c:pt>
                <c:pt idx="574">
                  <c:v>935.61999999999841</c:v>
                </c:pt>
                <c:pt idx="575">
                  <c:v>937.24999999999841</c:v>
                </c:pt>
                <c:pt idx="576">
                  <c:v>938.8799999999984</c:v>
                </c:pt>
                <c:pt idx="577">
                  <c:v>940.5099999999984</c:v>
                </c:pt>
                <c:pt idx="578">
                  <c:v>942.13999999999839</c:v>
                </c:pt>
                <c:pt idx="579">
                  <c:v>943.76999999999839</c:v>
                </c:pt>
                <c:pt idx="580">
                  <c:v>945.39999999999839</c:v>
                </c:pt>
                <c:pt idx="581">
                  <c:v>947.02999999999849</c:v>
                </c:pt>
                <c:pt idx="582">
                  <c:v>948.65999999999849</c:v>
                </c:pt>
                <c:pt idx="583">
                  <c:v>950.28999999999871</c:v>
                </c:pt>
                <c:pt idx="584">
                  <c:v>951.91999999999848</c:v>
                </c:pt>
                <c:pt idx="585">
                  <c:v>953.54999999999848</c:v>
                </c:pt>
                <c:pt idx="586">
                  <c:v>955.1799999999987</c:v>
                </c:pt>
                <c:pt idx="587">
                  <c:v>956.80999999999847</c:v>
                </c:pt>
                <c:pt idx="588">
                  <c:v>958.43999999999846</c:v>
                </c:pt>
                <c:pt idx="589">
                  <c:v>960.06999999999846</c:v>
                </c:pt>
                <c:pt idx="590">
                  <c:v>961.69999999999868</c:v>
                </c:pt>
                <c:pt idx="591">
                  <c:v>963.32999999999834</c:v>
                </c:pt>
                <c:pt idx="592">
                  <c:v>964.95999999999833</c:v>
                </c:pt>
                <c:pt idx="593">
                  <c:v>966.58999999999867</c:v>
                </c:pt>
                <c:pt idx="594">
                  <c:v>968.21999999999866</c:v>
                </c:pt>
                <c:pt idx="595">
                  <c:v>969.8499999999982</c:v>
                </c:pt>
                <c:pt idx="596">
                  <c:v>971.47999999999843</c:v>
                </c:pt>
                <c:pt idx="597">
                  <c:v>973.10999999999842</c:v>
                </c:pt>
                <c:pt idx="598">
                  <c:v>974.73999999999842</c:v>
                </c:pt>
                <c:pt idx="599">
                  <c:v>976.36999999999819</c:v>
                </c:pt>
                <c:pt idx="600">
                  <c:v>977.99999999999841</c:v>
                </c:pt>
                <c:pt idx="601">
                  <c:v>979.6299999999984</c:v>
                </c:pt>
                <c:pt idx="602">
                  <c:v>981.2599999999984</c:v>
                </c:pt>
                <c:pt idx="603">
                  <c:v>982.88999999999839</c:v>
                </c:pt>
                <c:pt idx="604">
                  <c:v>984.51999999999839</c:v>
                </c:pt>
                <c:pt idx="605">
                  <c:v>986.14999999999839</c:v>
                </c:pt>
                <c:pt idx="606">
                  <c:v>987.77999999999861</c:v>
                </c:pt>
                <c:pt idx="607">
                  <c:v>989.40999999999849</c:v>
                </c:pt>
                <c:pt idx="608">
                  <c:v>991.03999999999849</c:v>
                </c:pt>
                <c:pt idx="609">
                  <c:v>992.66999999999848</c:v>
                </c:pt>
                <c:pt idx="610">
                  <c:v>994.29999999999859</c:v>
                </c:pt>
                <c:pt idx="611">
                  <c:v>995.92999999999847</c:v>
                </c:pt>
                <c:pt idx="612">
                  <c:v>997.55999999999847</c:v>
                </c:pt>
                <c:pt idx="613">
                  <c:v>999.18999999999858</c:v>
                </c:pt>
                <c:pt idx="614">
                  <c:v>1000.8199999999982</c:v>
                </c:pt>
                <c:pt idx="615">
                  <c:v>1002.4499999999982</c:v>
                </c:pt>
                <c:pt idx="616">
                  <c:v>1004.0799999999986</c:v>
                </c:pt>
                <c:pt idx="617">
                  <c:v>1005.7099999999986</c:v>
                </c:pt>
                <c:pt idx="618">
                  <c:v>1007.3399999999982</c:v>
                </c:pt>
                <c:pt idx="619">
                  <c:v>1008.9699999999981</c:v>
                </c:pt>
                <c:pt idx="620">
                  <c:v>1010.5999999999984</c:v>
                </c:pt>
                <c:pt idx="621">
                  <c:v>1012.2299999999984</c:v>
                </c:pt>
                <c:pt idx="622">
                  <c:v>1013.8599999999981</c:v>
                </c:pt>
                <c:pt idx="623">
                  <c:v>1015.4899999999984</c:v>
                </c:pt>
                <c:pt idx="624">
                  <c:v>1017.1199999999984</c:v>
                </c:pt>
                <c:pt idx="625">
                  <c:v>1018.7499999999984</c:v>
                </c:pt>
                <c:pt idx="626">
                  <c:v>1020.3799999999984</c:v>
                </c:pt>
                <c:pt idx="627">
                  <c:v>1022.0099999999984</c:v>
                </c:pt>
                <c:pt idx="628">
                  <c:v>1023.6399999999984</c:v>
                </c:pt>
                <c:pt idx="629">
                  <c:v>1025.2699999999986</c:v>
                </c:pt>
                <c:pt idx="630">
                  <c:v>1026.899999999998</c:v>
                </c:pt>
                <c:pt idx="631">
                  <c:v>1028.5299999999988</c:v>
                </c:pt>
                <c:pt idx="632">
                  <c:v>1030.1599999999983</c:v>
                </c:pt>
                <c:pt idx="633">
                  <c:v>1031.7899999999991</c:v>
                </c:pt>
                <c:pt idx="634">
                  <c:v>1033.4199999999998</c:v>
                </c:pt>
                <c:pt idx="635">
                  <c:v>1035.0499999999993</c:v>
                </c:pt>
                <c:pt idx="636">
                  <c:v>1036.6799999999994</c:v>
                </c:pt>
                <c:pt idx="637">
                  <c:v>1038.3099999999995</c:v>
                </c:pt>
                <c:pt idx="638">
                  <c:v>1039.94</c:v>
                </c:pt>
                <c:pt idx="639">
                  <c:v>1041.5699999999997</c:v>
                </c:pt>
                <c:pt idx="640">
                  <c:v>1043.1999999999998</c:v>
                </c:pt>
                <c:pt idx="641">
                  <c:v>1044.83</c:v>
                </c:pt>
                <c:pt idx="642">
                  <c:v>1046.46</c:v>
                </c:pt>
                <c:pt idx="643">
                  <c:v>1048.0899999999999</c:v>
                </c:pt>
                <c:pt idx="644">
                  <c:v>1049.7200000000003</c:v>
                </c:pt>
                <c:pt idx="645">
                  <c:v>1051.3500000000004</c:v>
                </c:pt>
                <c:pt idx="646">
                  <c:v>1052.9800000000005</c:v>
                </c:pt>
                <c:pt idx="647">
                  <c:v>1054.6100000000006</c:v>
                </c:pt>
                <c:pt idx="648">
                  <c:v>1056.2400000000007</c:v>
                </c:pt>
                <c:pt idx="649">
                  <c:v>1057.8700000000008</c:v>
                </c:pt>
                <c:pt idx="650">
                  <c:v>1059.5000000000009</c:v>
                </c:pt>
                <c:pt idx="651">
                  <c:v>1061.1300000000008</c:v>
                </c:pt>
                <c:pt idx="652">
                  <c:v>1062.7600000000009</c:v>
                </c:pt>
                <c:pt idx="653">
                  <c:v>1064.3900000000008</c:v>
                </c:pt>
                <c:pt idx="654">
                  <c:v>1066.0200000000009</c:v>
                </c:pt>
                <c:pt idx="655">
                  <c:v>1067.6500000000008</c:v>
                </c:pt>
                <c:pt idx="656">
                  <c:v>1069.2800000000016</c:v>
                </c:pt>
                <c:pt idx="657">
                  <c:v>1070.9100000000017</c:v>
                </c:pt>
                <c:pt idx="658">
                  <c:v>1072.5400000000018</c:v>
                </c:pt>
                <c:pt idx="659">
                  <c:v>1074.1700000000012</c:v>
                </c:pt>
                <c:pt idx="660">
                  <c:v>1075.800000000002</c:v>
                </c:pt>
                <c:pt idx="661">
                  <c:v>1077.4300000000021</c:v>
                </c:pt>
                <c:pt idx="662">
                  <c:v>1079.0600000000022</c:v>
                </c:pt>
                <c:pt idx="663">
                  <c:v>1080.6900000000016</c:v>
                </c:pt>
                <c:pt idx="664">
                  <c:v>1082.3200000000024</c:v>
                </c:pt>
                <c:pt idx="665">
                  <c:v>1083.9500000000025</c:v>
                </c:pt>
                <c:pt idx="666">
                  <c:v>1085.5800000000027</c:v>
                </c:pt>
                <c:pt idx="667">
                  <c:v>1087.210000000003</c:v>
                </c:pt>
                <c:pt idx="668">
                  <c:v>1088.8400000000029</c:v>
                </c:pt>
                <c:pt idx="669">
                  <c:v>1090.470000000003</c:v>
                </c:pt>
                <c:pt idx="670">
                  <c:v>1092.1000000000029</c:v>
                </c:pt>
                <c:pt idx="671">
                  <c:v>1093.7300000000032</c:v>
                </c:pt>
                <c:pt idx="672">
                  <c:v>1095.3600000000029</c:v>
                </c:pt>
                <c:pt idx="673">
                  <c:v>1096.9900000000034</c:v>
                </c:pt>
                <c:pt idx="674">
                  <c:v>1098.6200000000028</c:v>
                </c:pt>
                <c:pt idx="675">
                  <c:v>1100.2500000000036</c:v>
                </c:pt>
                <c:pt idx="676">
                  <c:v>1101.8800000000031</c:v>
                </c:pt>
                <c:pt idx="677">
                  <c:v>1103.5100000000039</c:v>
                </c:pt>
                <c:pt idx="678">
                  <c:v>1105.140000000004</c:v>
                </c:pt>
                <c:pt idx="679">
                  <c:v>1106.7700000000041</c:v>
                </c:pt>
                <c:pt idx="680">
                  <c:v>1108.4000000000049</c:v>
                </c:pt>
                <c:pt idx="681">
                  <c:v>1110.0300000000043</c:v>
                </c:pt>
                <c:pt idx="682">
                  <c:v>1111.6600000000044</c:v>
                </c:pt>
                <c:pt idx="683">
                  <c:v>1113.2900000000045</c:v>
                </c:pt>
                <c:pt idx="684">
                  <c:v>1114.9200000000051</c:v>
                </c:pt>
                <c:pt idx="685">
                  <c:v>1116.5500000000047</c:v>
                </c:pt>
                <c:pt idx="686">
                  <c:v>1118.1800000000048</c:v>
                </c:pt>
                <c:pt idx="687">
                  <c:v>1119.8100000000049</c:v>
                </c:pt>
                <c:pt idx="688">
                  <c:v>1121.4400000000051</c:v>
                </c:pt>
                <c:pt idx="689">
                  <c:v>1123.0700000000052</c:v>
                </c:pt>
                <c:pt idx="690">
                  <c:v>1124.7000000000053</c:v>
                </c:pt>
                <c:pt idx="691">
                  <c:v>1126.3300000000054</c:v>
                </c:pt>
                <c:pt idx="692">
                  <c:v>1127.9600000000055</c:v>
                </c:pt>
                <c:pt idx="693">
                  <c:v>1129.5900000000056</c:v>
                </c:pt>
                <c:pt idx="694">
                  <c:v>1131.2200000000057</c:v>
                </c:pt>
                <c:pt idx="695">
                  <c:v>1132.8500000000058</c:v>
                </c:pt>
                <c:pt idx="696">
                  <c:v>1134.4800000000059</c:v>
                </c:pt>
                <c:pt idx="697">
                  <c:v>1136.1100000000058</c:v>
                </c:pt>
                <c:pt idx="698">
                  <c:v>1137.7400000000059</c:v>
                </c:pt>
                <c:pt idx="699">
                  <c:v>1139.3700000000058</c:v>
                </c:pt>
                <c:pt idx="700">
                  <c:v>1141.0000000000064</c:v>
                </c:pt>
                <c:pt idx="701">
                  <c:v>1142.6300000000058</c:v>
                </c:pt>
                <c:pt idx="702">
                  <c:v>1144.2600000000066</c:v>
                </c:pt>
                <c:pt idx="703">
                  <c:v>1145.890000000006</c:v>
                </c:pt>
                <c:pt idx="704">
                  <c:v>1147.5200000000068</c:v>
                </c:pt>
                <c:pt idx="705">
                  <c:v>1149.1500000000062</c:v>
                </c:pt>
                <c:pt idx="706">
                  <c:v>1150.780000000007</c:v>
                </c:pt>
                <c:pt idx="707">
                  <c:v>1152.4100000000071</c:v>
                </c:pt>
                <c:pt idx="708">
                  <c:v>1154.0400000000072</c:v>
                </c:pt>
                <c:pt idx="709">
                  <c:v>1155.6700000000067</c:v>
                </c:pt>
                <c:pt idx="710">
                  <c:v>1157.3000000000075</c:v>
                </c:pt>
                <c:pt idx="711">
                  <c:v>1158.930000000008</c:v>
                </c:pt>
                <c:pt idx="712">
                  <c:v>1160.5600000000077</c:v>
                </c:pt>
                <c:pt idx="713">
                  <c:v>1162.1900000000078</c:v>
                </c:pt>
                <c:pt idx="714">
                  <c:v>1163.8200000000079</c:v>
                </c:pt>
                <c:pt idx="715">
                  <c:v>1165.450000000008</c:v>
                </c:pt>
                <c:pt idx="716">
                  <c:v>1167.0800000000079</c:v>
                </c:pt>
                <c:pt idx="717">
                  <c:v>1168.7100000000082</c:v>
                </c:pt>
                <c:pt idx="718">
                  <c:v>1170.3400000000079</c:v>
                </c:pt>
                <c:pt idx="719">
                  <c:v>1171.9700000000084</c:v>
                </c:pt>
                <c:pt idx="720">
                  <c:v>1173.6000000000079</c:v>
                </c:pt>
                <c:pt idx="721">
                  <c:v>1175.2300000000087</c:v>
                </c:pt>
                <c:pt idx="722">
                  <c:v>1176.8600000000088</c:v>
                </c:pt>
                <c:pt idx="723">
                  <c:v>1178.4900000000089</c:v>
                </c:pt>
                <c:pt idx="724">
                  <c:v>1180.120000000009</c:v>
                </c:pt>
                <c:pt idx="725">
                  <c:v>1181.7500000000091</c:v>
                </c:pt>
                <c:pt idx="726">
                  <c:v>1183.3800000000092</c:v>
                </c:pt>
                <c:pt idx="727">
                  <c:v>1185.0100000000093</c:v>
                </c:pt>
                <c:pt idx="728">
                  <c:v>1186.6400000000094</c:v>
                </c:pt>
                <c:pt idx="729">
                  <c:v>1188.2700000000095</c:v>
                </c:pt>
                <c:pt idx="730">
                  <c:v>1189.9000000000101</c:v>
                </c:pt>
                <c:pt idx="731">
                  <c:v>1191.5300000000097</c:v>
                </c:pt>
                <c:pt idx="732">
                  <c:v>1193.1600000000099</c:v>
                </c:pt>
                <c:pt idx="733">
                  <c:v>1194.79000000001</c:v>
                </c:pt>
                <c:pt idx="734">
                  <c:v>1196.4200000000101</c:v>
                </c:pt>
                <c:pt idx="735">
                  <c:v>1198.0500000000102</c:v>
                </c:pt>
                <c:pt idx="736">
                  <c:v>1199.6800000000098</c:v>
                </c:pt>
                <c:pt idx="737">
                  <c:v>1201.3100000000104</c:v>
                </c:pt>
                <c:pt idx="738">
                  <c:v>1202.9400000000105</c:v>
                </c:pt>
                <c:pt idx="739">
                  <c:v>1204.5700000000106</c:v>
                </c:pt>
                <c:pt idx="740">
                  <c:v>1206.2000000000107</c:v>
                </c:pt>
                <c:pt idx="741">
                  <c:v>1207.8300000000108</c:v>
                </c:pt>
                <c:pt idx="742">
                  <c:v>1209.460000000011</c:v>
                </c:pt>
                <c:pt idx="743">
                  <c:v>1211.0900000000108</c:v>
                </c:pt>
                <c:pt idx="744">
                  <c:v>1212.7200000000112</c:v>
                </c:pt>
                <c:pt idx="745">
                  <c:v>1214.3500000000108</c:v>
                </c:pt>
                <c:pt idx="746">
                  <c:v>1215.9800000000114</c:v>
                </c:pt>
                <c:pt idx="747">
                  <c:v>1217.6100000000108</c:v>
                </c:pt>
                <c:pt idx="748">
                  <c:v>1219.2400000000116</c:v>
                </c:pt>
                <c:pt idx="749">
                  <c:v>1220.870000000011</c:v>
                </c:pt>
                <c:pt idx="750">
                  <c:v>1222.5000000000118</c:v>
                </c:pt>
                <c:pt idx="751">
                  <c:v>1224.1300000000113</c:v>
                </c:pt>
                <c:pt idx="752">
                  <c:v>1225.760000000012</c:v>
                </c:pt>
                <c:pt idx="753">
                  <c:v>1227.3900000000122</c:v>
                </c:pt>
                <c:pt idx="754">
                  <c:v>1229.0200000000123</c:v>
                </c:pt>
                <c:pt idx="755">
                  <c:v>1230.6500000000124</c:v>
                </c:pt>
                <c:pt idx="756">
                  <c:v>1232.2800000000125</c:v>
                </c:pt>
                <c:pt idx="757">
                  <c:v>1233.910000000013</c:v>
                </c:pt>
                <c:pt idx="758">
                  <c:v>1235.5400000000127</c:v>
                </c:pt>
                <c:pt idx="759">
                  <c:v>1237.1700000000128</c:v>
                </c:pt>
                <c:pt idx="760">
                  <c:v>1238.8000000000129</c:v>
                </c:pt>
                <c:pt idx="761">
                  <c:v>1240.430000000013</c:v>
                </c:pt>
                <c:pt idx="762">
                  <c:v>1242.0600000000129</c:v>
                </c:pt>
                <c:pt idx="763">
                  <c:v>1243.6900000000128</c:v>
                </c:pt>
                <c:pt idx="764">
                  <c:v>1245.3200000000134</c:v>
                </c:pt>
                <c:pt idx="765">
                  <c:v>1246.9500000000135</c:v>
                </c:pt>
                <c:pt idx="766">
                  <c:v>1248.5800000000136</c:v>
                </c:pt>
                <c:pt idx="767">
                  <c:v>1250.2100000000137</c:v>
                </c:pt>
                <c:pt idx="768">
                  <c:v>1251.8400000000138</c:v>
                </c:pt>
                <c:pt idx="769">
                  <c:v>1253.4700000000139</c:v>
                </c:pt>
                <c:pt idx="770">
                  <c:v>1255.100000000014</c:v>
                </c:pt>
                <c:pt idx="771">
                  <c:v>1256.7300000000141</c:v>
                </c:pt>
                <c:pt idx="772">
                  <c:v>1258.3600000000142</c:v>
                </c:pt>
                <c:pt idx="773">
                  <c:v>1259.9900000000143</c:v>
                </c:pt>
                <c:pt idx="774">
                  <c:v>1261.6200000000144</c:v>
                </c:pt>
                <c:pt idx="775">
                  <c:v>1263.250000000015</c:v>
                </c:pt>
                <c:pt idx="776">
                  <c:v>1264.8800000000147</c:v>
                </c:pt>
                <c:pt idx="777">
                  <c:v>1266.510000000015</c:v>
                </c:pt>
                <c:pt idx="778">
                  <c:v>1268.1400000000149</c:v>
                </c:pt>
                <c:pt idx="779">
                  <c:v>1269.770000000015</c:v>
                </c:pt>
                <c:pt idx="780">
                  <c:v>1271.4000000000151</c:v>
                </c:pt>
                <c:pt idx="781">
                  <c:v>1273.0300000000152</c:v>
                </c:pt>
                <c:pt idx="782">
                  <c:v>1274.6600000000149</c:v>
                </c:pt>
                <c:pt idx="783">
                  <c:v>1276.2900000000154</c:v>
                </c:pt>
                <c:pt idx="784">
                  <c:v>1277.9200000000155</c:v>
                </c:pt>
                <c:pt idx="785">
                  <c:v>1279.5500000000156</c:v>
                </c:pt>
                <c:pt idx="786">
                  <c:v>1281.1800000000158</c:v>
                </c:pt>
                <c:pt idx="787">
                  <c:v>1282.8100000000159</c:v>
                </c:pt>
                <c:pt idx="788">
                  <c:v>1284.440000000016</c:v>
                </c:pt>
                <c:pt idx="789">
                  <c:v>1286.0700000000159</c:v>
                </c:pt>
                <c:pt idx="790">
                  <c:v>1287.7000000000162</c:v>
                </c:pt>
                <c:pt idx="791">
                  <c:v>1289.3300000000158</c:v>
                </c:pt>
                <c:pt idx="792">
                  <c:v>1290.9600000000164</c:v>
                </c:pt>
                <c:pt idx="793">
                  <c:v>1292.5900000000158</c:v>
                </c:pt>
                <c:pt idx="794">
                  <c:v>1294.2200000000166</c:v>
                </c:pt>
                <c:pt idx="795">
                  <c:v>1295.8500000000161</c:v>
                </c:pt>
                <c:pt idx="796">
                  <c:v>1297.4800000000168</c:v>
                </c:pt>
                <c:pt idx="797">
                  <c:v>1299.110000000017</c:v>
                </c:pt>
                <c:pt idx="798">
                  <c:v>1300.7400000000171</c:v>
                </c:pt>
                <c:pt idx="799">
                  <c:v>1302.3700000000172</c:v>
                </c:pt>
                <c:pt idx="800">
                  <c:v>1304.0000000000173</c:v>
                </c:pt>
                <c:pt idx="801">
                  <c:v>1305.6300000000174</c:v>
                </c:pt>
                <c:pt idx="802">
                  <c:v>1307.2600000000175</c:v>
                </c:pt>
                <c:pt idx="803">
                  <c:v>1308.8900000000176</c:v>
                </c:pt>
                <c:pt idx="804">
                  <c:v>1310.5200000000177</c:v>
                </c:pt>
                <c:pt idx="805">
                  <c:v>1312.1500000000178</c:v>
                </c:pt>
                <c:pt idx="806">
                  <c:v>1313.7800000000179</c:v>
                </c:pt>
                <c:pt idx="807">
                  <c:v>1315.410000000018</c:v>
                </c:pt>
                <c:pt idx="808">
                  <c:v>1317.0400000000182</c:v>
                </c:pt>
                <c:pt idx="809">
                  <c:v>1318.6700000000178</c:v>
                </c:pt>
                <c:pt idx="810">
                  <c:v>1320.3000000000184</c:v>
                </c:pt>
                <c:pt idx="811">
                  <c:v>1321.9300000000185</c:v>
                </c:pt>
                <c:pt idx="812">
                  <c:v>1323.5600000000186</c:v>
                </c:pt>
                <c:pt idx="813">
                  <c:v>1325.190000000018</c:v>
                </c:pt>
                <c:pt idx="814">
                  <c:v>1326.8200000000188</c:v>
                </c:pt>
                <c:pt idx="815">
                  <c:v>1328.4500000000189</c:v>
                </c:pt>
                <c:pt idx="816">
                  <c:v>1330.080000000019</c:v>
                </c:pt>
                <c:pt idx="817">
                  <c:v>1331.7100000000191</c:v>
                </c:pt>
                <c:pt idx="818">
                  <c:v>1333.3400000000192</c:v>
                </c:pt>
                <c:pt idx="819">
                  <c:v>1334.97000000002</c:v>
                </c:pt>
                <c:pt idx="820">
                  <c:v>1336.6000000000195</c:v>
                </c:pt>
                <c:pt idx="821">
                  <c:v>1338.23000000002</c:v>
                </c:pt>
                <c:pt idx="822">
                  <c:v>1339.8600000000197</c:v>
                </c:pt>
                <c:pt idx="823">
                  <c:v>1341.49000000002</c:v>
                </c:pt>
                <c:pt idx="824">
                  <c:v>1343.1200000000199</c:v>
                </c:pt>
                <c:pt idx="825">
                  <c:v>1344.75000000002</c:v>
                </c:pt>
                <c:pt idx="826">
                  <c:v>1346.3800000000199</c:v>
                </c:pt>
                <c:pt idx="827">
                  <c:v>1348.0100000000202</c:v>
                </c:pt>
                <c:pt idx="828">
                  <c:v>1349.6400000000199</c:v>
                </c:pt>
                <c:pt idx="829">
                  <c:v>1351.2700000000204</c:v>
                </c:pt>
                <c:pt idx="830">
                  <c:v>1352.900000000021</c:v>
                </c:pt>
                <c:pt idx="831">
                  <c:v>1354.5300000000207</c:v>
                </c:pt>
                <c:pt idx="832">
                  <c:v>1356.1600000000208</c:v>
                </c:pt>
                <c:pt idx="833">
                  <c:v>1357.7900000000209</c:v>
                </c:pt>
                <c:pt idx="834">
                  <c:v>1359.420000000021</c:v>
                </c:pt>
                <c:pt idx="835">
                  <c:v>1361.0500000000209</c:v>
                </c:pt>
                <c:pt idx="836">
                  <c:v>1362.6800000000208</c:v>
                </c:pt>
                <c:pt idx="837">
                  <c:v>1364.3100000000209</c:v>
                </c:pt>
                <c:pt idx="838">
                  <c:v>1365.9400000000214</c:v>
                </c:pt>
                <c:pt idx="839">
                  <c:v>1367.5700000000209</c:v>
                </c:pt>
                <c:pt idx="840">
                  <c:v>1369.2000000000216</c:v>
                </c:pt>
                <c:pt idx="841">
                  <c:v>1370.8300000000218</c:v>
                </c:pt>
                <c:pt idx="842">
                  <c:v>1372.4600000000219</c:v>
                </c:pt>
                <c:pt idx="843">
                  <c:v>1374.090000000022</c:v>
                </c:pt>
                <c:pt idx="844">
                  <c:v>1375.7200000000221</c:v>
                </c:pt>
                <c:pt idx="845">
                  <c:v>1377.3500000000222</c:v>
                </c:pt>
                <c:pt idx="846">
                  <c:v>1378.9800000000223</c:v>
                </c:pt>
                <c:pt idx="847">
                  <c:v>1380.6100000000224</c:v>
                </c:pt>
                <c:pt idx="848">
                  <c:v>1382.2400000000225</c:v>
                </c:pt>
                <c:pt idx="849">
                  <c:v>1383.8700000000226</c:v>
                </c:pt>
                <c:pt idx="850">
                  <c:v>1385.5000000000227</c:v>
                </c:pt>
                <c:pt idx="851">
                  <c:v>1387.1300000000228</c:v>
                </c:pt>
                <c:pt idx="852">
                  <c:v>1388.760000000023</c:v>
                </c:pt>
                <c:pt idx="853">
                  <c:v>1390.3900000000228</c:v>
                </c:pt>
                <c:pt idx="854">
                  <c:v>1392.0200000000232</c:v>
                </c:pt>
                <c:pt idx="855">
                  <c:v>1393.6500000000228</c:v>
                </c:pt>
                <c:pt idx="856">
                  <c:v>1395.2800000000234</c:v>
                </c:pt>
                <c:pt idx="857">
                  <c:v>1396.9100000000235</c:v>
                </c:pt>
                <c:pt idx="858">
                  <c:v>1398.5400000000236</c:v>
                </c:pt>
                <c:pt idx="859">
                  <c:v>1400.170000000023</c:v>
                </c:pt>
                <c:pt idx="860">
                  <c:v>1401.8000000000238</c:v>
                </c:pt>
                <c:pt idx="861">
                  <c:v>1403.4300000000239</c:v>
                </c:pt>
                <c:pt idx="862">
                  <c:v>1405.060000000024</c:v>
                </c:pt>
                <c:pt idx="863">
                  <c:v>1406.6900000000242</c:v>
                </c:pt>
                <c:pt idx="864">
                  <c:v>1408.3200000000243</c:v>
                </c:pt>
                <c:pt idx="865">
                  <c:v>1409.9500000000251</c:v>
                </c:pt>
                <c:pt idx="866">
                  <c:v>1411.5800000000245</c:v>
                </c:pt>
                <c:pt idx="867">
                  <c:v>1413.210000000025</c:v>
                </c:pt>
                <c:pt idx="868">
                  <c:v>1414.8400000000247</c:v>
                </c:pt>
                <c:pt idx="869">
                  <c:v>1416.470000000025</c:v>
                </c:pt>
                <c:pt idx="870">
                  <c:v>1418.1000000000249</c:v>
                </c:pt>
                <c:pt idx="871">
                  <c:v>1419.730000000025</c:v>
                </c:pt>
                <c:pt idx="872">
                  <c:v>1421.3600000000249</c:v>
                </c:pt>
                <c:pt idx="873">
                  <c:v>1422.9900000000252</c:v>
                </c:pt>
                <c:pt idx="874">
                  <c:v>1424.6200000000254</c:v>
                </c:pt>
                <c:pt idx="875">
                  <c:v>1426.2500000000255</c:v>
                </c:pt>
                <c:pt idx="876">
                  <c:v>1427.8800000000256</c:v>
                </c:pt>
                <c:pt idx="877">
                  <c:v>1429.5100000000257</c:v>
                </c:pt>
                <c:pt idx="878">
                  <c:v>1431.1400000000258</c:v>
                </c:pt>
                <c:pt idx="879">
                  <c:v>1432.7700000000259</c:v>
                </c:pt>
                <c:pt idx="880">
                  <c:v>1434.400000000026</c:v>
                </c:pt>
                <c:pt idx="881">
                  <c:v>1436.0300000000259</c:v>
                </c:pt>
                <c:pt idx="882">
                  <c:v>1437.6600000000258</c:v>
                </c:pt>
                <c:pt idx="883">
                  <c:v>1439.2900000000259</c:v>
                </c:pt>
                <c:pt idx="884">
                  <c:v>1440.9200000000264</c:v>
                </c:pt>
                <c:pt idx="885">
                  <c:v>1442.5500000000266</c:v>
                </c:pt>
                <c:pt idx="886">
                  <c:v>1444.180000000026</c:v>
                </c:pt>
                <c:pt idx="887">
                  <c:v>1445.8100000000268</c:v>
                </c:pt>
                <c:pt idx="888">
                  <c:v>1447.4400000000269</c:v>
                </c:pt>
                <c:pt idx="889">
                  <c:v>1449.070000000027</c:v>
                </c:pt>
                <c:pt idx="890">
                  <c:v>1450.7000000000271</c:v>
                </c:pt>
                <c:pt idx="891">
                  <c:v>1452.3300000000272</c:v>
                </c:pt>
                <c:pt idx="892">
                  <c:v>1453.9600000000273</c:v>
                </c:pt>
                <c:pt idx="893">
                  <c:v>1455.5900000000274</c:v>
                </c:pt>
                <c:pt idx="894">
                  <c:v>1457.2200000000275</c:v>
                </c:pt>
                <c:pt idx="895">
                  <c:v>1458.8500000000276</c:v>
                </c:pt>
                <c:pt idx="896">
                  <c:v>1460.480000000028</c:v>
                </c:pt>
                <c:pt idx="897">
                  <c:v>1462.1100000000279</c:v>
                </c:pt>
                <c:pt idx="898">
                  <c:v>1463.740000000028</c:v>
                </c:pt>
                <c:pt idx="899">
                  <c:v>1465.3700000000279</c:v>
                </c:pt>
                <c:pt idx="900">
                  <c:v>1467.0000000000282</c:v>
                </c:pt>
                <c:pt idx="901">
                  <c:v>1468.6300000000278</c:v>
                </c:pt>
                <c:pt idx="902">
                  <c:v>1470.2600000000284</c:v>
                </c:pt>
                <c:pt idx="903">
                  <c:v>1471.8900000000278</c:v>
                </c:pt>
                <c:pt idx="904">
                  <c:v>1473.5200000000286</c:v>
                </c:pt>
                <c:pt idx="905">
                  <c:v>1475.1500000000281</c:v>
                </c:pt>
                <c:pt idx="906">
                  <c:v>1476.7800000000288</c:v>
                </c:pt>
                <c:pt idx="907">
                  <c:v>1478.4100000000296</c:v>
                </c:pt>
                <c:pt idx="908">
                  <c:v>1480.0400000000291</c:v>
                </c:pt>
                <c:pt idx="909">
                  <c:v>1481.6700000000292</c:v>
                </c:pt>
                <c:pt idx="910">
                  <c:v>1483.3000000000293</c:v>
                </c:pt>
                <c:pt idx="911">
                  <c:v>1484.9300000000301</c:v>
                </c:pt>
                <c:pt idx="912">
                  <c:v>1486.5600000000295</c:v>
                </c:pt>
                <c:pt idx="913">
                  <c:v>1488.1900000000296</c:v>
                </c:pt>
                <c:pt idx="914">
                  <c:v>1489.8200000000297</c:v>
                </c:pt>
                <c:pt idx="915">
                  <c:v>1491.4500000000301</c:v>
                </c:pt>
                <c:pt idx="916">
                  <c:v>1493.0800000000299</c:v>
                </c:pt>
                <c:pt idx="917">
                  <c:v>1494.71000000003</c:v>
                </c:pt>
                <c:pt idx="918">
                  <c:v>1496.3400000000302</c:v>
                </c:pt>
                <c:pt idx="919">
                  <c:v>1497.9700000000303</c:v>
                </c:pt>
                <c:pt idx="920">
                  <c:v>1499.6000000000304</c:v>
                </c:pt>
                <c:pt idx="921">
                  <c:v>1501.2300000000305</c:v>
                </c:pt>
                <c:pt idx="922">
                  <c:v>1502.8600000000306</c:v>
                </c:pt>
                <c:pt idx="923">
                  <c:v>1504.4900000000307</c:v>
                </c:pt>
                <c:pt idx="924">
                  <c:v>1506.1200000000308</c:v>
                </c:pt>
                <c:pt idx="925">
                  <c:v>1507.7500000000309</c:v>
                </c:pt>
                <c:pt idx="926">
                  <c:v>1509.3800000000308</c:v>
                </c:pt>
                <c:pt idx="927">
                  <c:v>1511.0100000000309</c:v>
                </c:pt>
                <c:pt idx="928">
                  <c:v>1512.6400000000308</c:v>
                </c:pt>
                <c:pt idx="929">
                  <c:v>1514.2700000000314</c:v>
                </c:pt>
                <c:pt idx="930">
                  <c:v>1515.9000000000315</c:v>
                </c:pt>
                <c:pt idx="931">
                  <c:v>1517.5300000000316</c:v>
                </c:pt>
                <c:pt idx="932">
                  <c:v>1519.160000000031</c:v>
                </c:pt>
                <c:pt idx="933">
                  <c:v>1520.7900000000318</c:v>
                </c:pt>
                <c:pt idx="934">
                  <c:v>1522.4200000000319</c:v>
                </c:pt>
                <c:pt idx="935">
                  <c:v>1524.050000000032</c:v>
                </c:pt>
                <c:pt idx="936">
                  <c:v>1525.6800000000314</c:v>
                </c:pt>
                <c:pt idx="937">
                  <c:v>1527.3100000000322</c:v>
                </c:pt>
                <c:pt idx="938">
                  <c:v>1528.9400000000323</c:v>
                </c:pt>
                <c:pt idx="939">
                  <c:v>1530.5700000000325</c:v>
                </c:pt>
                <c:pt idx="940">
                  <c:v>1532.200000000033</c:v>
                </c:pt>
                <c:pt idx="941">
                  <c:v>1533.8300000000327</c:v>
                </c:pt>
                <c:pt idx="942">
                  <c:v>1535.460000000033</c:v>
                </c:pt>
                <c:pt idx="943">
                  <c:v>1537.0900000000329</c:v>
                </c:pt>
                <c:pt idx="944">
                  <c:v>1538.720000000033</c:v>
                </c:pt>
                <c:pt idx="945">
                  <c:v>1540.3500000000329</c:v>
                </c:pt>
                <c:pt idx="946">
                  <c:v>1541.9800000000332</c:v>
                </c:pt>
                <c:pt idx="947">
                  <c:v>1543.6100000000329</c:v>
                </c:pt>
                <c:pt idx="948">
                  <c:v>1545.2400000000334</c:v>
                </c:pt>
                <c:pt idx="949">
                  <c:v>1546.8700000000329</c:v>
                </c:pt>
                <c:pt idx="950">
                  <c:v>1548.5000000000337</c:v>
                </c:pt>
                <c:pt idx="951">
                  <c:v>1550.1300000000338</c:v>
                </c:pt>
                <c:pt idx="952">
                  <c:v>1551.7600000000339</c:v>
                </c:pt>
                <c:pt idx="953">
                  <c:v>1553.390000000034</c:v>
                </c:pt>
                <c:pt idx="954">
                  <c:v>1555.0200000000341</c:v>
                </c:pt>
                <c:pt idx="955">
                  <c:v>1556.6500000000342</c:v>
                </c:pt>
                <c:pt idx="956">
                  <c:v>1558.2800000000343</c:v>
                </c:pt>
                <c:pt idx="957">
                  <c:v>1559.9100000000351</c:v>
                </c:pt>
                <c:pt idx="958">
                  <c:v>1561.5400000000345</c:v>
                </c:pt>
                <c:pt idx="959">
                  <c:v>1563.1700000000346</c:v>
                </c:pt>
                <c:pt idx="960">
                  <c:v>1564.8000000000347</c:v>
                </c:pt>
                <c:pt idx="961">
                  <c:v>1566.4300000000351</c:v>
                </c:pt>
                <c:pt idx="962">
                  <c:v>1568.060000000035</c:v>
                </c:pt>
                <c:pt idx="963">
                  <c:v>1569.6900000000348</c:v>
                </c:pt>
                <c:pt idx="964">
                  <c:v>1571.3200000000352</c:v>
                </c:pt>
                <c:pt idx="965">
                  <c:v>1572.9500000000353</c:v>
                </c:pt>
                <c:pt idx="966">
                  <c:v>1574.5800000000354</c:v>
                </c:pt>
                <c:pt idx="967">
                  <c:v>1576.2100000000355</c:v>
                </c:pt>
                <c:pt idx="968">
                  <c:v>1577.8400000000356</c:v>
                </c:pt>
                <c:pt idx="969">
                  <c:v>1579.4700000000357</c:v>
                </c:pt>
                <c:pt idx="970">
                  <c:v>1581.1000000000358</c:v>
                </c:pt>
                <c:pt idx="971">
                  <c:v>1582.7300000000359</c:v>
                </c:pt>
                <c:pt idx="972">
                  <c:v>1584.3600000000358</c:v>
                </c:pt>
                <c:pt idx="973">
                  <c:v>1585.9900000000362</c:v>
                </c:pt>
                <c:pt idx="974">
                  <c:v>1587.6200000000358</c:v>
                </c:pt>
                <c:pt idx="975">
                  <c:v>1589.2500000000364</c:v>
                </c:pt>
                <c:pt idx="976">
                  <c:v>1590.8800000000358</c:v>
                </c:pt>
                <c:pt idx="977">
                  <c:v>1592.5100000000366</c:v>
                </c:pt>
                <c:pt idx="978">
                  <c:v>1594.140000000036</c:v>
                </c:pt>
                <c:pt idx="979">
                  <c:v>1595.7700000000368</c:v>
                </c:pt>
                <c:pt idx="980">
                  <c:v>1597.4000000000369</c:v>
                </c:pt>
                <c:pt idx="981">
                  <c:v>1599.030000000037</c:v>
                </c:pt>
              </c:numCache>
            </c:numRef>
          </c:xVal>
          <c:yVal>
            <c:numRef>
              <c:f>Sheet1!$B$1:$B$2285</c:f>
              <c:numCache>
                <c:formatCode>General</c:formatCode>
                <c:ptCount val="2285"/>
              </c:numCache>
            </c:numRef>
          </c:yVal>
          <c:smooth val="1"/>
        </c:ser>
        <c:ser>
          <c:idx val="2"/>
          <c:order val="1"/>
          <c:spPr>
            <a:ln>
              <a:solidFill>
                <a:schemeClr val="tx1"/>
              </a:solidFill>
            </a:ln>
          </c:spPr>
          <c:marker>
            <c:symbol val="none"/>
          </c:marker>
          <c:xVal>
            <c:numRef>
              <c:f>Sheet1!$A$1:$A$2285</c:f>
              <c:numCache>
                <c:formatCode>General</c:formatCode>
                <c:ptCount val="2285"/>
                <c:pt idx="0">
                  <c:v>0</c:v>
                </c:pt>
                <c:pt idx="1">
                  <c:v>1.6300000000000001</c:v>
                </c:pt>
                <c:pt idx="2">
                  <c:v>3.2600000000000002</c:v>
                </c:pt>
                <c:pt idx="3">
                  <c:v>4.8899999999999997</c:v>
                </c:pt>
                <c:pt idx="4">
                  <c:v>6.52</c:v>
                </c:pt>
                <c:pt idx="5">
                  <c:v>8.15</c:v>
                </c:pt>
                <c:pt idx="6">
                  <c:v>9.7800000000000011</c:v>
                </c:pt>
                <c:pt idx="7">
                  <c:v>11.41</c:v>
                </c:pt>
                <c:pt idx="8">
                  <c:v>13.04</c:v>
                </c:pt>
                <c:pt idx="9">
                  <c:v>14.67</c:v>
                </c:pt>
                <c:pt idx="10">
                  <c:v>16.3</c:v>
                </c:pt>
                <c:pt idx="11">
                  <c:v>17.93</c:v>
                </c:pt>
                <c:pt idx="12">
                  <c:v>19.559999999999999</c:v>
                </c:pt>
                <c:pt idx="13">
                  <c:v>21.19</c:v>
                </c:pt>
                <c:pt idx="14">
                  <c:v>22.82</c:v>
                </c:pt>
                <c:pt idx="15">
                  <c:v>24.45</c:v>
                </c:pt>
                <c:pt idx="16">
                  <c:v>26.08</c:v>
                </c:pt>
                <c:pt idx="17">
                  <c:v>27.71</c:v>
                </c:pt>
                <c:pt idx="18">
                  <c:v>29.34</c:v>
                </c:pt>
                <c:pt idx="19">
                  <c:v>30.97</c:v>
                </c:pt>
                <c:pt idx="20">
                  <c:v>32.6</c:v>
                </c:pt>
                <c:pt idx="21">
                  <c:v>34.230000000000011</c:v>
                </c:pt>
                <c:pt idx="22">
                  <c:v>35.86</c:v>
                </c:pt>
                <c:pt idx="23">
                  <c:v>37.49</c:v>
                </c:pt>
                <c:pt idx="24">
                  <c:v>39.120000000000012</c:v>
                </c:pt>
                <c:pt idx="25">
                  <c:v>40.75</c:v>
                </c:pt>
                <c:pt idx="26">
                  <c:v>42.379999999999995</c:v>
                </c:pt>
                <c:pt idx="27">
                  <c:v>44.01</c:v>
                </c:pt>
                <c:pt idx="28">
                  <c:v>45.64</c:v>
                </c:pt>
                <c:pt idx="29">
                  <c:v>47.27</c:v>
                </c:pt>
                <c:pt idx="30">
                  <c:v>48.9</c:v>
                </c:pt>
                <c:pt idx="31">
                  <c:v>50.53</c:v>
                </c:pt>
                <c:pt idx="32">
                  <c:v>52.160000000000011</c:v>
                </c:pt>
                <c:pt idx="33">
                  <c:v>53.790000000000013</c:v>
                </c:pt>
                <c:pt idx="34">
                  <c:v>55.42</c:v>
                </c:pt>
                <c:pt idx="35">
                  <c:v>57.05</c:v>
                </c:pt>
                <c:pt idx="36">
                  <c:v>58.68</c:v>
                </c:pt>
                <c:pt idx="37">
                  <c:v>60.309999999999995</c:v>
                </c:pt>
                <c:pt idx="38">
                  <c:v>61.94</c:v>
                </c:pt>
                <c:pt idx="39">
                  <c:v>63.57</c:v>
                </c:pt>
                <c:pt idx="40">
                  <c:v>65.2</c:v>
                </c:pt>
                <c:pt idx="41">
                  <c:v>66.83</c:v>
                </c:pt>
                <c:pt idx="42">
                  <c:v>68.459999999999994</c:v>
                </c:pt>
                <c:pt idx="43">
                  <c:v>70.09</c:v>
                </c:pt>
                <c:pt idx="44">
                  <c:v>71.72</c:v>
                </c:pt>
                <c:pt idx="45">
                  <c:v>73.349999999999994</c:v>
                </c:pt>
                <c:pt idx="46">
                  <c:v>74.98</c:v>
                </c:pt>
                <c:pt idx="47">
                  <c:v>76.61</c:v>
                </c:pt>
                <c:pt idx="48">
                  <c:v>78.239999999999995</c:v>
                </c:pt>
                <c:pt idx="49">
                  <c:v>79.86999999999999</c:v>
                </c:pt>
                <c:pt idx="50">
                  <c:v>81.5</c:v>
                </c:pt>
                <c:pt idx="51">
                  <c:v>83.13</c:v>
                </c:pt>
                <c:pt idx="52">
                  <c:v>84.76</c:v>
                </c:pt>
                <c:pt idx="53">
                  <c:v>86.39</c:v>
                </c:pt>
                <c:pt idx="54">
                  <c:v>88.02</c:v>
                </c:pt>
                <c:pt idx="55">
                  <c:v>89.649999999999991</c:v>
                </c:pt>
                <c:pt idx="56">
                  <c:v>91.28</c:v>
                </c:pt>
                <c:pt idx="57">
                  <c:v>92.910000000000025</c:v>
                </c:pt>
                <c:pt idx="58">
                  <c:v>94.54</c:v>
                </c:pt>
                <c:pt idx="59">
                  <c:v>96.169999999999987</c:v>
                </c:pt>
                <c:pt idx="60">
                  <c:v>97.8</c:v>
                </c:pt>
                <c:pt idx="61">
                  <c:v>99.43</c:v>
                </c:pt>
                <c:pt idx="62">
                  <c:v>101.06</c:v>
                </c:pt>
                <c:pt idx="63">
                  <c:v>102.69</c:v>
                </c:pt>
                <c:pt idx="64">
                  <c:v>104.32</c:v>
                </c:pt>
                <c:pt idx="65">
                  <c:v>105.95</c:v>
                </c:pt>
                <c:pt idx="66">
                  <c:v>107.58</c:v>
                </c:pt>
                <c:pt idx="67">
                  <c:v>109.21000000000002</c:v>
                </c:pt>
                <c:pt idx="68">
                  <c:v>110.84</c:v>
                </c:pt>
                <c:pt idx="69">
                  <c:v>112.47</c:v>
                </c:pt>
                <c:pt idx="70">
                  <c:v>114.1</c:v>
                </c:pt>
                <c:pt idx="71">
                  <c:v>115.73</c:v>
                </c:pt>
                <c:pt idx="72">
                  <c:v>117.36</c:v>
                </c:pt>
                <c:pt idx="73">
                  <c:v>118.99000000000002</c:v>
                </c:pt>
                <c:pt idx="74">
                  <c:v>120.61999999999999</c:v>
                </c:pt>
                <c:pt idx="75">
                  <c:v>122.25</c:v>
                </c:pt>
                <c:pt idx="76">
                  <c:v>123.88</c:v>
                </c:pt>
                <c:pt idx="77">
                  <c:v>125.51</c:v>
                </c:pt>
                <c:pt idx="78">
                  <c:v>127.14</c:v>
                </c:pt>
                <c:pt idx="79">
                  <c:v>128.76999999999998</c:v>
                </c:pt>
                <c:pt idx="80">
                  <c:v>130.4</c:v>
                </c:pt>
                <c:pt idx="81">
                  <c:v>132.03</c:v>
                </c:pt>
                <c:pt idx="82">
                  <c:v>133.66</c:v>
                </c:pt>
                <c:pt idx="83">
                  <c:v>135.29</c:v>
                </c:pt>
                <c:pt idx="84">
                  <c:v>136.91999999999999</c:v>
                </c:pt>
                <c:pt idx="85">
                  <c:v>138.55000000000001</c:v>
                </c:pt>
                <c:pt idx="86">
                  <c:v>140.18</c:v>
                </c:pt>
                <c:pt idx="87">
                  <c:v>141.81</c:v>
                </c:pt>
                <c:pt idx="88">
                  <c:v>143.44</c:v>
                </c:pt>
                <c:pt idx="89">
                  <c:v>145.07</c:v>
                </c:pt>
                <c:pt idx="90">
                  <c:v>146.69999999999999</c:v>
                </c:pt>
                <c:pt idx="91">
                  <c:v>148.33000000000001</c:v>
                </c:pt>
                <c:pt idx="92">
                  <c:v>149.96</c:v>
                </c:pt>
                <c:pt idx="93">
                  <c:v>151.59</c:v>
                </c:pt>
                <c:pt idx="94">
                  <c:v>153.22</c:v>
                </c:pt>
                <c:pt idx="95">
                  <c:v>154.85000000000008</c:v>
                </c:pt>
                <c:pt idx="96">
                  <c:v>156.47999999999999</c:v>
                </c:pt>
                <c:pt idx="97">
                  <c:v>158.10999999999999</c:v>
                </c:pt>
                <c:pt idx="98">
                  <c:v>159.73999999999998</c:v>
                </c:pt>
                <c:pt idx="99">
                  <c:v>161.37</c:v>
                </c:pt>
                <c:pt idx="100">
                  <c:v>163</c:v>
                </c:pt>
                <c:pt idx="101">
                  <c:v>164.63</c:v>
                </c:pt>
                <c:pt idx="102">
                  <c:v>166.26</c:v>
                </c:pt>
                <c:pt idx="103">
                  <c:v>167.89000000000001</c:v>
                </c:pt>
                <c:pt idx="104">
                  <c:v>169.52</c:v>
                </c:pt>
                <c:pt idx="105">
                  <c:v>171.15</c:v>
                </c:pt>
                <c:pt idx="106">
                  <c:v>172.78</c:v>
                </c:pt>
                <c:pt idx="107">
                  <c:v>174.41</c:v>
                </c:pt>
                <c:pt idx="108">
                  <c:v>176.04</c:v>
                </c:pt>
                <c:pt idx="109">
                  <c:v>177.67</c:v>
                </c:pt>
                <c:pt idx="110">
                  <c:v>179.3</c:v>
                </c:pt>
                <c:pt idx="111">
                  <c:v>180.93</c:v>
                </c:pt>
                <c:pt idx="112">
                  <c:v>182.56</c:v>
                </c:pt>
                <c:pt idx="113">
                  <c:v>184.19</c:v>
                </c:pt>
                <c:pt idx="114">
                  <c:v>185.82000000000008</c:v>
                </c:pt>
                <c:pt idx="115">
                  <c:v>187.45000000000007</c:v>
                </c:pt>
                <c:pt idx="116">
                  <c:v>189.08</c:v>
                </c:pt>
                <c:pt idx="117">
                  <c:v>190.70999999999998</c:v>
                </c:pt>
                <c:pt idx="118">
                  <c:v>192.34</c:v>
                </c:pt>
                <c:pt idx="119">
                  <c:v>193.97</c:v>
                </c:pt>
                <c:pt idx="120">
                  <c:v>195.6</c:v>
                </c:pt>
                <c:pt idx="121">
                  <c:v>197.23</c:v>
                </c:pt>
                <c:pt idx="122">
                  <c:v>198.86</c:v>
                </c:pt>
                <c:pt idx="123">
                  <c:v>200.49</c:v>
                </c:pt>
                <c:pt idx="124">
                  <c:v>202.12</c:v>
                </c:pt>
                <c:pt idx="125">
                  <c:v>203.75</c:v>
                </c:pt>
                <c:pt idx="126">
                  <c:v>205.38000000000008</c:v>
                </c:pt>
                <c:pt idx="127">
                  <c:v>207.01</c:v>
                </c:pt>
                <c:pt idx="128">
                  <c:v>208.64</c:v>
                </c:pt>
                <c:pt idx="129">
                  <c:v>210.26999999999998</c:v>
                </c:pt>
                <c:pt idx="130">
                  <c:v>211.9</c:v>
                </c:pt>
                <c:pt idx="131">
                  <c:v>213.53</c:v>
                </c:pt>
                <c:pt idx="132">
                  <c:v>215.16</c:v>
                </c:pt>
                <c:pt idx="133">
                  <c:v>216.79</c:v>
                </c:pt>
                <c:pt idx="134">
                  <c:v>218.42000000000004</c:v>
                </c:pt>
                <c:pt idx="135">
                  <c:v>220.05</c:v>
                </c:pt>
                <c:pt idx="136">
                  <c:v>221.68</c:v>
                </c:pt>
                <c:pt idx="137">
                  <c:v>223.31</c:v>
                </c:pt>
                <c:pt idx="138">
                  <c:v>224.94</c:v>
                </c:pt>
                <c:pt idx="139">
                  <c:v>226.57</c:v>
                </c:pt>
                <c:pt idx="140">
                  <c:v>228.2</c:v>
                </c:pt>
                <c:pt idx="141">
                  <c:v>229.83</c:v>
                </c:pt>
                <c:pt idx="142">
                  <c:v>231.46</c:v>
                </c:pt>
                <c:pt idx="143">
                  <c:v>233.09</c:v>
                </c:pt>
                <c:pt idx="144">
                  <c:v>234.72</c:v>
                </c:pt>
                <c:pt idx="145">
                  <c:v>236.35000000000008</c:v>
                </c:pt>
                <c:pt idx="146">
                  <c:v>237.98000000000008</c:v>
                </c:pt>
                <c:pt idx="147">
                  <c:v>239.60999999999999</c:v>
                </c:pt>
                <c:pt idx="148">
                  <c:v>241.23999999999998</c:v>
                </c:pt>
                <c:pt idx="149">
                  <c:v>242.87</c:v>
                </c:pt>
                <c:pt idx="150">
                  <c:v>244.5</c:v>
                </c:pt>
                <c:pt idx="151">
                  <c:v>246.13</c:v>
                </c:pt>
                <c:pt idx="152">
                  <c:v>247.76</c:v>
                </c:pt>
                <c:pt idx="153">
                  <c:v>249.39000000000001</c:v>
                </c:pt>
                <c:pt idx="154">
                  <c:v>251.02</c:v>
                </c:pt>
                <c:pt idx="155">
                  <c:v>252.65</c:v>
                </c:pt>
                <c:pt idx="156">
                  <c:v>254.28</c:v>
                </c:pt>
                <c:pt idx="157">
                  <c:v>255.91</c:v>
                </c:pt>
                <c:pt idx="158">
                  <c:v>257.54000000000002</c:v>
                </c:pt>
                <c:pt idx="159">
                  <c:v>259.17</c:v>
                </c:pt>
                <c:pt idx="160">
                  <c:v>260.8</c:v>
                </c:pt>
                <c:pt idx="161">
                  <c:v>262.42999999999984</c:v>
                </c:pt>
                <c:pt idx="162">
                  <c:v>264.06</c:v>
                </c:pt>
                <c:pt idx="163">
                  <c:v>265.69</c:v>
                </c:pt>
                <c:pt idx="164">
                  <c:v>267.32</c:v>
                </c:pt>
                <c:pt idx="165">
                  <c:v>268.95</c:v>
                </c:pt>
                <c:pt idx="166">
                  <c:v>270.58</c:v>
                </c:pt>
                <c:pt idx="167">
                  <c:v>272.20999999999981</c:v>
                </c:pt>
                <c:pt idx="168">
                  <c:v>273.8399999999998</c:v>
                </c:pt>
                <c:pt idx="169">
                  <c:v>275.47000000000003</c:v>
                </c:pt>
                <c:pt idx="170">
                  <c:v>277.10000000000002</c:v>
                </c:pt>
                <c:pt idx="171">
                  <c:v>278.72999999999985</c:v>
                </c:pt>
                <c:pt idx="172">
                  <c:v>280.36</c:v>
                </c:pt>
                <c:pt idx="173">
                  <c:v>281.98999999999984</c:v>
                </c:pt>
                <c:pt idx="174">
                  <c:v>283.62</c:v>
                </c:pt>
                <c:pt idx="175">
                  <c:v>285.25</c:v>
                </c:pt>
                <c:pt idx="176">
                  <c:v>286.88</c:v>
                </c:pt>
                <c:pt idx="177">
                  <c:v>288.51</c:v>
                </c:pt>
                <c:pt idx="178">
                  <c:v>290.14000000000016</c:v>
                </c:pt>
                <c:pt idx="179">
                  <c:v>291.77</c:v>
                </c:pt>
                <c:pt idx="180">
                  <c:v>293.39999999999981</c:v>
                </c:pt>
                <c:pt idx="181">
                  <c:v>295.0299999999998</c:v>
                </c:pt>
                <c:pt idx="182">
                  <c:v>296.66000000000008</c:v>
                </c:pt>
                <c:pt idx="183">
                  <c:v>298.28999999999985</c:v>
                </c:pt>
                <c:pt idx="184">
                  <c:v>299.91999999999985</c:v>
                </c:pt>
                <c:pt idx="185">
                  <c:v>301.55</c:v>
                </c:pt>
                <c:pt idx="186">
                  <c:v>303.18</c:v>
                </c:pt>
                <c:pt idx="187">
                  <c:v>304.81</c:v>
                </c:pt>
                <c:pt idx="188">
                  <c:v>306.44</c:v>
                </c:pt>
                <c:pt idx="189">
                  <c:v>308.07</c:v>
                </c:pt>
                <c:pt idx="190">
                  <c:v>309.7</c:v>
                </c:pt>
                <c:pt idx="191">
                  <c:v>311.33</c:v>
                </c:pt>
                <c:pt idx="192">
                  <c:v>312.95999999999981</c:v>
                </c:pt>
                <c:pt idx="193">
                  <c:v>314.5899999999998</c:v>
                </c:pt>
                <c:pt idx="194">
                  <c:v>316.22000000000003</c:v>
                </c:pt>
                <c:pt idx="195">
                  <c:v>317.85000000000002</c:v>
                </c:pt>
                <c:pt idx="196">
                  <c:v>319.47999999999985</c:v>
                </c:pt>
                <c:pt idx="197">
                  <c:v>321.11</c:v>
                </c:pt>
                <c:pt idx="198">
                  <c:v>322.74</c:v>
                </c:pt>
                <c:pt idx="199">
                  <c:v>324.37</c:v>
                </c:pt>
                <c:pt idx="200">
                  <c:v>326</c:v>
                </c:pt>
                <c:pt idx="201">
                  <c:v>327.63</c:v>
                </c:pt>
                <c:pt idx="202">
                  <c:v>329.26</c:v>
                </c:pt>
                <c:pt idx="203">
                  <c:v>330.89</c:v>
                </c:pt>
                <c:pt idx="204">
                  <c:v>332.52</c:v>
                </c:pt>
                <c:pt idx="205">
                  <c:v>334.15000000000015</c:v>
                </c:pt>
                <c:pt idx="206">
                  <c:v>335.78</c:v>
                </c:pt>
                <c:pt idx="207">
                  <c:v>337.40999999999985</c:v>
                </c:pt>
                <c:pt idx="208">
                  <c:v>339.04</c:v>
                </c:pt>
                <c:pt idx="209">
                  <c:v>340.67</c:v>
                </c:pt>
                <c:pt idx="210">
                  <c:v>342.3</c:v>
                </c:pt>
                <c:pt idx="211">
                  <c:v>343.92999999999984</c:v>
                </c:pt>
                <c:pt idx="212">
                  <c:v>345.56</c:v>
                </c:pt>
                <c:pt idx="213">
                  <c:v>347.19</c:v>
                </c:pt>
                <c:pt idx="214">
                  <c:v>348.82</c:v>
                </c:pt>
                <c:pt idx="215">
                  <c:v>350.45</c:v>
                </c:pt>
                <c:pt idx="216">
                  <c:v>352.08</c:v>
                </c:pt>
                <c:pt idx="217">
                  <c:v>353.71</c:v>
                </c:pt>
                <c:pt idx="218">
                  <c:v>355.34000000000015</c:v>
                </c:pt>
                <c:pt idx="219">
                  <c:v>356.96999999999986</c:v>
                </c:pt>
                <c:pt idx="220">
                  <c:v>358.6</c:v>
                </c:pt>
                <c:pt idx="221">
                  <c:v>360.22999999999985</c:v>
                </c:pt>
                <c:pt idx="222">
                  <c:v>361.86</c:v>
                </c:pt>
                <c:pt idx="223">
                  <c:v>363.48999999999984</c:v>
                </c:pt>
                <c:pt idx="224">
                  <c:v>365.12</c:v>
                </c:pt>
                <c:pt idx="225">
                  <c:v>366.75</c:v>
                </c:pt>
                <c:pt idx="226">
                  <c:v>368.38</c:v>
                </c:pt>
                <c:pt idx="227">
                  <c:v>370.01</c:v>
                </c:pt>
                <c:pt idx="228">
                  <c:v>371.64000000000016</c:v>
                </c:pt>
                <c:pt idx="229">
                  <c:v>373.27</c:v>
                </c:pt>
                <c:pt idx="230">
                  <c:v>374.9</c:v>
                </c:pt>
                <c:pt idx="231">
                  <c:v>376.53</c:v>
                </c:pt>
                <c:pt idx="232">
                  <c:v>378.16</c:v>
                </c:pt>
                <c:pt idx="233">
                  <c:v>379.78999999999985</c:v>
                </c:pt>
                <c:pt idx="234">
                  <c:v>381.41999999999985</c:v>
                </c:pt>
                <c:pt idx="235">
                  <c:v>383.05</c:v>
                </c:pt>
                <c:pt idx="236">
                  <c:v>384.68</c:v>
                </c:pt>
                <c:pt idx="237">
                  <c:v>386.31</c:v>
                </c:pt>
                <c:pt idx="238">
                  <c:v>387.94</c:v>
                </c:pt>
                <c:pt idx="239">
                  <c:v>389.57</c:v>
                </c:pt>
                <c:pt idx="240">
                  <c:v>391.2</c:v>
                </c:pt>
                <c:pt idx="241">
                  <c:v>392.83</c:v>
                </c:pt>
                <c:pt idx="242">
                  <c:v>394.46</c:v>
                </c:pt>
                <c:pt idx="243">
                  <c:v>396.09</c:v>
                </c:pt>
                <c:pt idx="244">
                  <c:v>397.71999999999986</c:v>
                </c:pt>
                <c:pt idx="245">
                  <c:v>399.35</c:v>
                </c:pt>
                <c:pt idx="246">
                  <c:v>400.97999999999985</c:v>
                </c:pt>
                <c:pt idx="247">
                  <c:v>402.61</c:v>
                </c:pt>
                <c:pt idx="248">
                  <c:v>404.24</c:v>
                </c:pt>
                <c:pt idx="249">
                  <c:v>405.87</c:v>
                </c:pt>
                <c:pt idx="250">
                  <c:v>407.5</c:v>
                </c:pt>
                <c:pt idx="251">
                  <c:v>409.13</c:v>
                </c:pt>
                <c:pt idx="252">
                  <c:v>410.76</c:v>
                </c:pt>
                <c:pt idx="253">
                  <c:v>412.39</c:v>
                </c:pt>
                <c:pt idx="254">
                  <c:v>414.02</c:v>
                </c:pt>
                <c:pt idx="255">
                  <c:v>415.65000000000015</c:v>
                </c:pt>
                <c:pt idx="256">
                  <c:v>417.28</c:v>
                </c:pt>
                <c:pt idx="257">
                  <c:v>418.90999999999985</c:v>
                </c:pt>
                <c:pt idx="258">
                  <c:v>420.54</c:v>
                </c:pt>
                <c:pt idx="259">
                  <c:v>422.17</c:v>
                </c:pt>
                <c:pt idx="260">
                  <c:v>423.8</c:v>
                </c:pt>
                <c:pt idx="261">
                  <c:v>425.42999999999984</c:v>
                </c:pt>
                <c:pt idx="262">
                  <c:v>427.06</c:v>
                </c:pt>
                <c:pt idx="263">
                  <c:v>428.69</c:v>
                </c:pt>
                <c:pt idx="264">
                  <c:v>430.32</c:v>
                </c:pt>
                <c:pt idx="265">
                  <c:v>431.95</c:v>
                </c:pt>
                <c:pt idx="266">
                  <c:v>433.58</c:v>
                </c:pt>
                <c:pt idx="267">
                  <c:v>435.21</c:v>
                </c:pt>
                <c:pt idx="268">
                  <c:v>436.84000000000015</c:v>
                </c:pt>
                <c:pt idx="269">
                  <c:v>438.46999999999986</c:v>
                </c:pt>
                <c:pt idx="270">
                  <c:v>440.1</c:v>
                </c:pt>
                <c:pt idx="271">
                  <c:v>441.72999999999985</c:v>
                </c:pt>
                <c:pt idx="272">
                  <c:v>443.36</c:v>
                </c:pt>
                <c:pt idx="273">
                  <c:v>444.98999999999984</c:v>
                </c:pt>
                <c:pt idx="274">
                  <c:v>446.62</c:v>
                </c:pt>
                <c:pt idx="275">
                  <c:v>448.25</c:v>
                </c:pt>
                <c:pt idx="276">
                  <c:v>449.88</c:v>
                </c:pt>
                <c:pt idx="277">
                  <c:v>451.51</c:v>
                </c:pt>
                <c:pt idx="278">
                  <c:v>453.14000000000016</c:v>
                </c:pt>
                <c:pt idx="279">
                  <c:v>454.77</c:v>
                </c:pt>
                <c:pt idx="280">
                  <c:v>456.4</c:v>
                </c:pt>
                <c:pt idx="281">
                  <c:v>458.03</c:v>
                </c:pt>
                <c:pt idx="282">
                  <c:v>459.66</c:v>
                </c:pt>
                <c:pt idx="283">
                  <c:v>461.28999999999985</c:v>
                </c:pt>
                <c:pt idx="284">
                  <c:v>462.91999999999985</c:v>
                </c:pt>
                <c:pt idx="285">
                  <c:v>464.55</c:v>
                </c:pt>
                <c:pt idx="286">
                  <c:v>466.18</c:v>
                </c:pt>
                <c:pt idx="287">
                  <c:v>467.81</c:v>
                </c:pt>
                <c:pt idx="288">
                  <c:v>469.44</c:v>
                </c:pt>
                <c:pt idx="289">
                  <c:v>471.07</c:v>
                </c:pt>
                <c:pt idx="290">
                  <c:v>472.7</c:v>
                </c:pt>
                <c:pt idx="291">
                  <c:v>474.33</c:v>
                </c:pt>
                <c:pt idx="292">
                  <c:v>475.96</c:v>
                </c:pt>
                <c:pt idx="293">
                  <c:v>477.59</c:v>
                </c:pt>
                <c:pt idx="294">
                  <c:v>479.21999999999986</c:v>
                </c:pt>
                <c:pt idx="295">
                  <c:v>480.85</c:v>
                </c:pt>
                <c:pt idx="296">
                  <c:v>482.47999999999985</c:v>
                </c:pt>
                <c:pt idx="297">
                  <c:v>484.11</c:v>
                </c:pt>
                <c:pt idx="298">
                  <c:v>485.74</c:v>
                </c:pt>
                <c:pt idx="299">
                  <c:v>487.37</c:v>
                </c:pt>
                <c:pt idx="300">
                  <c:v>489</c:v>
                </c:pt>
                <c:pt idx="301">
                  <c:v>490.63</c:v>
                </c:pt>
                <c:pt idx="302">
                  <c:v>492.26</c:v>
                </c:pt>
                <c:pt idx="303">
                  <c:v>493.89</c:v>
                </c:pt>
                <c:pt idx="304">
                  <c:v>495.52</c:v>
                </c:pt>
                <c:pt idx="305">
                  <c:v>497.15000000000015</c:v>
                </c:pt>
                <c:pt idx="306">
                  <c:v>498.78</c:v>
                </c:pt>
                <c:pt idx="307">
                  <c:v>500.4099999999998</c:v>
                </c:pt>
                <c:pt idx="308">
                  <c:v>502.03999999999979</c:v>
                </c:pt>
                <c:pt idx="309">
                  <c:v>503.66999999999996</c:v>
                </c:pt>
                <c:pt idx="310">
                  <c:v>505.29999999999978</c:v>
                </c:pt>
                <c:pt idx="311">
                  <c:v>506.92999999999978</c:v>
                </c:pt>
                <c:pt idx="312">
                  <c:v>508.55999999999995</c:v>
                </c:pt>
                <c:pt idx="313">
                  <c:v>510.18999999999994</c:v>
                </c:pt>
                <c:pt idx="314">
                  <c:v>511.81999999999994</c:v>
                </c:pt>
                <c:pt idx="315">
                  <c:v>513.44999999999959</c:v>
                </c:pt>
                <c:pt idx="316">
                  <c:v>515.07999999999993</c:v>
                </c:pt>
                <c:pt idx="317">
                  <c:v>516.70999999999992</c:v>
                </c:pt>
                <c:pt idx="318">
                  <c:v>518.33999999999958</c:v>
                </c:pt>
                <c:pt idx="319">
                  <c:v>519.96999999999957</c:v>
                </c:pt>
                <c:pt idx="320">
                  <c:v>521.59999999999991</c:v>
                </c:pt>
                <c:pt idx="321">
                  <c:v>523.2299999999999</c:v>
                </c:pt>
                <c:pt idx="322">
                  <c:v>524.85999999999956</c:v>
                </c:pt>
                <c:pt idx="323">
                  <c:v>526.4899999999999</c:v>
                </c:pt>
                <c:pt idx="324">
                  <c:v>528.11999999999989</c:v>
                </c:pt>
                <c:pt idx="325">
                  <c:v>529.74999999999989</c:v>
                </c:pt>
                <c:pt idx="326">
                  <c:v>531.37999999999988</c:v>
                </c:pt>
                <c:pt idx="327">
                  <c:v>533.00999999999988</c:v>
                </c:pt>
                <c:pt idx="328">
                  <c:v>534.63999999999987</c:v>
                </c:pt>
                <c:pt idx="329">
                  <c:v>536.26999999999987</c:v>
                </c:pt>
                <c:pt idx="330">
                  <c:v>537.89999999999986</c:v>
                </c:pt>
                <c:pt idx="331">
                  <c:v>539.52999999999986</c:v>
                </c:pt>
                <c:pt idx="332">
                  <c:v>541.15999999999951</c:v>
                </c:pt>
                <c:pt idx="333">
                  <c:v>542.78999999999985</c:v>
                </c:pt>
                <c:pt idx="334">
                  <c:v>544.4199999999995</c:v>
                </c:pt>
                <c:pt idx="335">
                  <c:v>546.0499999999995</c:v>
                </c:pt>
                <c:pt idx="336">
                  <c:v>547.67999999999984</c:v>
                </c:pt>
                <c:pt idx="337">
                  <c:v>549.30999999999949</c:v>
                </c:pt>
                <c:pt idx="338">
                  <c:v>550.93999999999949</c:v>
                </c:pt>
                <c:pt idx="339">
                  <c:v>552.56999999999948</c:v>
                </c:pt>
                <c:pt idx="340">
                  <c:v>554.19999999999982</c:v>
                </c:pt>
                <c:pt idx="341">
                  <c:v>555.82999999999947</c:v>
                </c:pt>
                <c:pt idx="342">
                  <c:v>557.45999999999947</c:v>
                </c:pt>
                <c:pt idx="343">
                  <c:v>559.0899999999998</c:v>
                </c:pt>
                <c:pt idx="344">
                  <c:v>560.7199999999998</c:v>
                </c:pt>
                <c:pt idx="345">
                  <c:v>562.34999999999945</c:v>
                </c:pt>
                <c:pt idx="346">
                  <c:v>563.97999999999979</c:v>
                </c:pt>
                <c:pt idx="347">
                  <c:v>565.60999999999979</c:v>
                </c:pt>
                <c:pt idx="348">
                  <c:v>567.23999999999978</c:v>
                </c:pt>
                <c:pt idx="349">
                  <c:v>568.86999999999932</c:v>
                </c:pt>
                <c:pt idx="350">
                  <c:v>570.49999999999977</c:v>
                </c:pt>
                <c:pt idx="351">
                  <c:v>572.12999999999977</c:v>
                </c:pt>
                <c:pt idx="352">
                  <c:v>573.75999999999976</c:v>
                </c:pt>
                <c:pt idx="353">
                  <c:v>575.38999999999976</c:v>
                </c:pt>
                <c:pt idx="354">
                  <c:v>577.01999999999941</c:v>
                </c:pt>
                <c:pt idx="355">
                  <c:v>578.64999999999941</c:v>
                </c:pt>
                <c:pt idx="356">
                  <c:v>580.27999999999975</c:v>
                </c:pt>
                <c:pt idx="357">
                  <c:v>581.9099999999994</c:v>
                </c:pt>
                <c:pt idx="358">
                  <c:v>583.5399999999994</c:v>
                </c:pt>
                <c:pt idx="359">
                  <c:v>585.16999999999939</c:v>
                </c:pt>
                <c:pt idx="360">
                  <c:v>586.79999999999973</c:v>
                </c:pt>
                <c:pt idx="361">
                  <c:v>588.42999999999938</c:v>
                </c:pt>
                <c:pt idx="362">
                  <c:v>590.05999999999949</c:v>
                </c:pt>
                <c:pt idx="363">
                  <c:v>591.68999999999971</c:v>
                </c:pt>
                <c:pt idx="364">
                  <c:v>593.31999999999948</c:v>
                </c:pt>
                <c:pt idx="365">
                  <c:v>594.94999999999948</c:v>
                </c:pt>
                <c:pt idx="366">
                  <c:v>596.5799999999997</c:v>
                </c:pt>
                <c:pt idx="367">
                  <c:v>598.2099999999997</c:v>
                </c:pt>
                <c:pt idx="368">
                  <c:v>599.83999999999946</c:v>
                </c:pt>
                <c:pt idx="369">
                  <c:v>601.46999999999946</c:v>
                </c:pt>
                <c:pt idx="370">
                  <c:v>603.09999999999968</c:v>
                </c:pt>
                <c:pt idx="371">
                  <c:v>604.72999999999968</c:v>
                </c:pt>
                <c:pt idx="372">
                  <c:v>606.35999999999933</c:v>
                </c:pt>
                <c:pt idx="373">
                  <c:v>607.98999999999967</c:v>
                </c:pt>
                <c:pt idx="374">
                  <c:v>609.61999999999966</c:v>
                </c:pt>
                <c:pt idx="375">
                  <c:v>611.24999999999966</c:v>
                </c:pt>
                <c:pt idx="376">
                  <c:v>612.87999999999943</c:v>
                </c:pt>
                <c:pt idx="377">
                  <c:v>614.50999999999942</c:v>
                </c:pt>
                <c:pt idx="378">
                  <c:v>616.13999999999942</c:v>
                </c:pt>
                <c:pt idx="379">
                  <c:v>617.76999999999941</c:v>
                </c:pt>
                <c:pt idx="380">
                  <c:v>619.39999999999941</c:v>
                </c:pt>
                <c:pt idx="381">
                  <c:v>621.0299999999994</c:v>
                </c:pt>
                <c:pt idx="382">
                  <c:v>622.6599999999994</c:v>
                </c:pt>
                <c:pt idx="383">
                  <c:v>624.28999999999962</c:v>
                </c:pt>
                <c:pt idx="384">
                  <c:v>625.91999999999939</c:v>
                </c:pt>
                <c:pt idx="385">
                  <c:v>627.54999999999939</c:v>
                </c:pt>
                <c:pt idx="386">
                  <c:v>629.17999999999961</c:v>
                </c:pt>
                <c:pt idx="387">
                  <c:v>630.80999999999949</c:v>
                </c:pt>
                <c:pt idx="388">
                  <c:v>632.43999999999949</c:v>
                </c:pt>
                <c:pt idx="389">
                  <c:v>634.06999999999948</c:v>
                </c:pt>
                <c:pt idx="390">
                  <c:v>635.69999999999959</c:v>
                </c:pt>
                <c:pt idx="391">
                  <c:v>637.32999999999947</c:v>
                </c:pt>
                <c:pt idx="392">
                  <c:v>638.95999999999947</c:v>
                </c:pt>
                <c:pt idx="393">
                  <c:v>640.58999999999958</c:v>
                </c:pt>
                <c:pt idx="394">
                  <c:v>642.21999999999957</c:v>
                </c:pt>
                <c:pt idx="395">
                  <c:v>643.84999999999923</c:v>
                </c:pt>
                <c:pt idx="396">
                  <c:v>645.47999999999956</c:v>
                </c:pt>
                <c:pt idx="397">
                  <c:v>647.10999999999956</c:v>
                </c:pt>
                <c:pt idx="398">
                  <c:v>648.73999999999944</c:v>
                </c:pt>
                <c:pt idx="399">
                  <c:v>650.3699999999991</c:v>
                </c:pt>
                <c:pt idx="400">
                  <c:v>651.99999999999943</c:v>
                </c:pt>
                <c:pt idx="401">
                  <c:v>653.62999999999943</c:v>
                </c:pt>
                <c:pt idx="402">
                  <c:v>655.25999999999942</c:v>
                </c:pt>
                <c:pt idx="403">
                  <c:v>656.88999999999942</c:v>
                </c:pt>
                <c:pt idx="404">
                  <c:v>658.51999999999941</c:v>
                </c:pt>
                <c:pt idx="405">
                  <c:v>660.14999999999941</c:v>
                </c:pt>
                <c:pt idx="406">
                  <c:v>661.77999999999952</c:v>
                </c:pt>
                <c:pt idx="407">
                  <c:v>663.4099999999994</c:v>
                </c:pt>
                <c:pt idx="408">
                  <c:v>665.0399999999994</c:v>
                </c:pt>
                <c:pt idx="409">
                  <c:v>666.66999999999939</c:v>
                </c:pt>
                <c:pt idx="410">
                  <c:v>668.2999999999995</c:v>
                </c:pt>
                <c:pt idx="411">
                  <c:v>669.92999999999938</c:v>
                </c:pt>
                <c:pt idx="412">
                  <c:v>671.55999999999949</c:v>
                </c:pt>
                <c:pt idx="413">
                  <c:v>673.1899999999996</c:v>
                </c:pt>
                <c:pt idx="414">
                  <c:v>674.81999999999948</c:v>
                </c:pt>
                <c:pt idx="415">
                  <c:v>676.44999999999948</c:v>
                </c:pt>
                <c:pt idx="416">
                  <c:v>678.07999999999959</c:v>
                </c:pt>
                <c:pt idx="417">
                  <c:v>679.70999999999958</c:v>
                </c:pt>
                <c:pt idx="418">
                  <c:v>681.33999999999946</c:v>
                </c:pt>
                <c:pt idx="419">
                  <c:v>682.96999999999946</c:v>
                </c:pt>
                <c:pt idx="420">
                  <c:v>684.59999999999945</c:v>
                </c:pt>
                <c:pt idx="421">
                  <c:v>686.22999999999945</c:v>
                </c:pt>
                <c:pt idx="422">
                  <c:v>687.8599999999991</c:v>
                </c:pt>
                <c:pt idx="423">
                  <c:v>689.48999999999944</c:v>
                </c:pt>
                <c:pt idx="424">
                  <c:v>691.11999999999944</c:v>
                </c:pt>
                <c:pt idx="425">
                  <c:v>692.74999999999943</c:v>
                </c:pt>
                <c:pt idx="426">
                  <c:v>694.37999999999943</c:v>
                </c:pt>
                <c:pt idx="427">
                  <c:v>696.00999999999942</c:v>
                </c:pt>
                <c:pt idx="428">
                  <c:v>697.63999999999942</c:v>
                </c:pt>
                <c:pt idx="429">
                  <c:v>699.26999999999941</c:v>
                </c:pt>
                <c:pt idx="430">
                  <c:v>700.89999999999941</c:v>
                </c:pt>
                <c:pt idx="431">
                  <c:v>702.5299999999994</c:v>
                </c:pt>
                <c:pt idx="432">
                  <c:v>704.1599999999994</c:v>
                </c:pt>
                <c:pt idx="433">
                  <c:v>705.78999999999951</c:v>
                </c:pt>
                <c:pt idx="434">
                  <c:v>707.41999999999939</c:v>
                </c:pt>
                <c:pt idx="435">
                  <c:v>709.04999999999939</c:v>
                </c:pt>
                <c:pt idx="436">
                  <c:v>710.6799999999995</c:v>
                </c:pt>
                <c:pt idx="437">
                  <c:v>712.30999999999938</c:v>
                </c:pt>
                <c:pt idx="438">
                  <c:v>713.93999999999937</c:v>
                </c:pt>
                <c:pt idx="439">
                  <c:v>715.56999999999937</c:v>
                </c:pt>
                <c:pt idx="440">
                  <c:v>717.19999999999959</c:v>
                </c:pt>
                <c:pt idx="441">
                  <c:v>718.82999999999936</c:v>
                </c:pt>
                <c:pt idx="442">
                  <c:v>720.45999999999901</c:v>
                </c:pt>
                <c:pt idx="443">
                  <c:v>722.08999999999935</c:v>
                </c:pt>
                <c:pt idx="444">
                  <c:v>723.71999999999935</c:v>
                </c:pt>
                <c:pt idx="445">
                  <c:v>725.349999999999</c:v>
                </c:pt>
                <c:pt idx="446">
                  <c:v>726.97999999999934</c:v>
                </c:pt>
                <c:pt idx="447">
                  <c:v>728.60999999999933</c:v>
                </c:pt>
                <c:pt idx="448">
                  <c:v>730.23999999999933</c:v>
                </c:pt>
                <c:pt idx="449">
                  <c:v>731.86999999999898</c:v>
                </c:pt>
                <c:pt idx="450">
                  <c:v>733.49999999999932</c:v>
                </c:pt>
                <c:pt idx="451">
                  <c:v>735.12999999999931</c:v>
                </c:pt>
                <c:pt idx="452">
                  <c:v>736.75999999999931</c:v>
                </c:pt>
                <c:pt idx="453">
                  <c:v>738.3899999999993</c:v>
                </c:pt>
                <c:pt idx="454">
                  <c:v>740.0199999999993</c:v>
                </c:pt>
                <c:pt idx="455">
                  <c:v>741.6499999999993</c:v>
                </c:pt>
                <c:pt idx="456">
                  <c:v>743.27999999999952</c:v>
                </c:pt>
                <c:pt idx="457">
                  <c:v>744.90999999999929</c:v>
                </c:pt>
                <c:pt idx="458">
                  <c:v>746.53999999999928</c:v>
                </c:pt>
                <c:pt idx="459">
                  <c:v>748.16999999999928</c:v>
                </c:pt>
                <c:pt idx="460">
                  <c:v>749.7999999999995</c:v>
                </c:pt>
                <c:pt idx="461">
                  <c:v>751.42999999999927</c:v>
                </c:pt>
                <c:pt idx="462">
                  <c:v>753.05999999999926</c:v>
                </c:pt>
                <c:pt idx="463">
                  <c:v>754.6899999999996</c:v>
                </c:pt>
                <c:pt idx="464">
                  <c:v>756.31999999999891</c:v>
                </c:pt>
                <c:pt idx="465">
                  <c:v>757.94999999999891</c:v>
                </c:pt>
                <c:pt idx="466">
                  <c:v>759.57999999999925</c:v>
                </c:pt>
                <c:pt idx="467">
                  <c:v>761.20999999999924</c:v>
                </c:pt>
                <c:pt idx="468">
                  <c:v>762.83999999999889</c:v>
                </c:pt>
                <c:pt idx="469">
                  <c:v>764.46999999999889</c:v>
                </c:pt>
                <c:pt idx="470">
                  <c:v>766.09999999999923</c:v>
                </c:pt>
                <c:pt idx="471">
                  <c:v>767.72999999999922</c:v>
                </c:pt>
                <c:pt idx="472">
                  <c:v>769.35999999999888</c:v>
                </c:pt>
                <c:pt idx="473">
                  <c:v>770.98999999999921</c:v>
                </c:pt>
                <c:pt idx="474">
                  <c:v>772.61999999999921</c:v>
                </c:pt>
                <c:pt idx="475">
                  <c:v>774.2499999999992</c:v>
                </c:pt>
                <c:pt idx="476">
                  <c:v>775.8799999999992</c:v>
                </c:pt>
                <c:pt idx="477">
                  <c:v>777.5099999999992</c:v>
                </c:pt>
                <c:pt idx="478">
                  <c:v>779.13999999999919</c:v>
                </c:pt>
                <c:pt idx="479">
                  <c:v>780.76999999999919</c:v>
                </c:pt>
                <c:pt idx="480">
                  <c:v>782.39999999999918</c:v>
                </c:pt>
                <c:pt idx="481">
                  <c:v>784.02999999999918</c:v>
                </c:pt>
                <c:pt idx="482">
                  <c:v>785.65999999999917</c:v>
                </c:pt>
                <c:pt idx="483">
                  <c:v>787.28999999999951</c:v>
                </c:pt>
                <c:pt idx="484">
                  <c:v>788.91999999999916</c:v>
                </c:pt>
                <c:pt idx="485">
                  <c:v>790.54999999999916</c:v>
                </c:pt>
                <c:pt idx="486">
                  <c:v>792.17999999999915</c:v>
                </c:pt>
                <c:pt idx="487">
                  <c:v>793.80999999999881</c:v>
                </c:pt>
                <c:pt idx="488">
                  <c:v>795.4399999999988</c:v>
                </c:pt>
                <c:pt idx="489">
                  <c:v>797.0699999999988</c:v>
                </c:pt>
                <c:pt idx="490">
                  <c:v>798.69999999999914</c:v>
                </c:pt>
                <c:pt idx="491">
                  <c:v>800.32999999999879</c:v>
                </c:pt>
                <c:pt idx="492">
                  <c:v>801.95999999999879</c:v>
                </c:pt>
                <c:pt idx="493">
                  <c:v>803.58999999999912</c:v>
                </c:pt>
                <c:pt idx="494">
                  <c:v>805.21999999999912</c:v>
                </c:pt>
                <c:pt idx="495">
                  <c:v>806.84999999999877</c:v>
                </c:pt>
                <c:pt idx="496">
                  <c:v>808.47999999999911</c:v>
                </c:pt>
                <c:pt idx="497">
                  <c:v>810.1099999999991</c:v>
                </c:pt>
                <c:pt idx="498">
                  <c:v>811.7399999999991</c:v>
                </c:pt>
                <c:pt idx="499">
                  <c:v>813.36999999999875</c:v>
                </c:pt>
                <c:pt idx="500">
                  <c:v>814.99999999999909</c:v>
                </c:pt>
                <c:pt idx="501">
                  <c:v>816.62999999999909</c:v>
                </c:pt>
                <c:pt idx="502">
                  <c:v>818.25999999999908</c:v>
                </c:pt>
                <c:pt idx="503">
                  <c:v>819.88999999999908</c:v>
                </c:pt>
                <c:pt idx="504">
                  <c:v>821.51999999999907</c:v>
                </c:pt>
                <c:pt idx="505">
                  <c:v>823.14999999999907</c:v>
                </c:pt>
                <c:pt idx="506">
                  <c:v>824.7799999999994</c:v>
                </c:pt>
                <c:pt idx="507">
                  <c:v>826.40999999999906</c:v>
                </c:pt>
                <c:pt idx="508">
                  <c:v>828.03999999999871</c:v>
                </c:pt>
                <c:pt idx="509">
                  <c:v>829.66999999999871</c:v>
                </c:pt>
                <c:pt idx="510">
                  <c:v>831.29999999999905</c:v>
                </c:pt>
                <c:pt idx="511">
                  <c:v>832.9299999999987</c:v>
                </c:pt>
                <c:pt idx="512">
                  <c:v>834.55999999999869</c:v>
                </c:pt>
                <c:pt idx="513">
                  <c:v>836.18999999999903</c:v>
                </c:pt>
                <c:pt idx="514">
                  <c:v>837.81999999999869</c:v>
                </c:pt>
                <c:pt idx="515">
                  <c:v>839.44999999999868</c:v>
                </c:pt>
                <c:pt idx="516">
                  <c:v>841.07999999999902</c:v>
                </c:pt>
                <c:pt idx="517">
                  <c:v>842.70999999999901</c:v>
                </c:pt>
                <c:pt idx="518">
                  <c:v>844.33999999999867</c:v>
                </c:pt>
                <c:pt idx="519">
                  <c:v>845.96999999999866</c:v>
                </c:pt>
                <c:pt idx="520">
                  <c:v>847.599999999999</c:v>
                </c:pt>
                <c:pt idx="521">
                  <c:v>849.229999999999</c:v>
                </c:pt>
                <c:pt idx="522">
                  <c:v>850.85999999999865</c:v>
                </c:pt>
                <c:pt idx="523">
                  <c:v>852.48999999999899</c:v>
                </c:pt>
                <c:pt idx="524">
                  <c:v>854.11999999999898</c:v>
                </c:pt>
                <c:pt idx="525">
                  <c:v>855.74999999999898</c:v>
                </c:pt>
                <c:pt idx="526">
                  <c:v>857.37999999999897</c:v>
                </c:pt>
                <c:pt idx="527">
                  <c:v>859.00999999999897</c:v>
                </c:pt>
                <c:pt idx="528">
                  <c:v>860.63999999999896</c:v>
                </c:pt>
                <c:pt idx="529">
                  <c:v>862.26999999999896</c:v>
                </c:pt>
                <c:pt idx="530">
                  <c:v>863.89999999999861</c:v>
                </c:pt>
                <c:pt idx="531">
                  <c:v>865.52999999999861</c:v>
                </c:pt>
                <c:pt idx="532">
                  <c:v>867.1599999999986</c:v>
                </c:pt>
                <c:pt idx="533">
                  <c:v>868.78999999999894</c:v>
                </c:pt>
                <c:pt idx="534">
                  <c:v>870.41999999999859</c:v>
                </c:pt>
                <c:pt idx="535">
                  <c:v>872.04999999999859</c:v>
                </c:pt>
                <c:pt idx="536">
                  <c:v>873.67999999999893</c:v>
                </c:pt>
                <c:pt idx="537">
                  <c:v>875.30999999999858</c:v>
                </c:pt>
                <c:pt idx="538">
                  <c:v>876.93999999999858</c:v>
                </c:pt>
                <c:pt idx="539">
                  <c:v>878.56999999999857</c:v>
                </c:pt>
                <c:pt idx="540">
                  <c:v>880.19999999999891</c:v>
                </c:pt>
                <c:pt idx="541">
                  <c:v>881.82999999999856</c:v>
                </c:pt>
                <c:pt idx="542">
                  <c:v>883.45999999999856</c:v>
                </c:pt>
                <c:pt idx="543">
                  <c:v>885.08999999999889</c:v>
                </c:pt>
                <c:pt idx="544">
                  <c:v>886.71999999999889</c:v>
                </c:pt>
                <c:pt idx="545">
                  <c:v>888.34999999999854</c:v>
                </c:pt>
                <c:pt idx="546">
                  <c:v>889.97999999999888</c:v>
                </c:pt>
                <c:pt idx="547">
                  <c:v>891.60999999999888</c:v>
                </c:pt>
                <c:pt idx="548">
                  <c:v>893.23999999999887</c:v>
                </c:pt>
                <c:pt idx="549">
                  <c:v>894.8699999999983</c:v>
                </c:pt>
                <c:pt idx="550">
                  <c:v>896.49999999999886</c:v>
                </c:pt>
                <c:pt idx="551">
                  <c:v>898.12999999999886</c:v>
                </c:pt>
                <c:pt idx="552">
                  <c:v>899.75999999999851</c:v>
                </c:pt>
                <c:pt idx="553">
                  <c:v>901.38999999999851</c:v>
                </c:pt>
                <c:pt idx="554">
                  <c:v>903.0199999999985</c:v>
                </c:pt>
                <c:pt idx="555">
                  <c:v>904.6499999999985</c:v>
                </c:pt>
                <c:pt idx="556">
                  <c:v>906.27999999999884</c:v>
                </c:pt>
                <c:pt idx="557">
                  <c:v>907.90999999999849</c:v>
                </c:pt>
                <c:pt idx="558">
                  <c:v>909.53999999999849</c:v>
                </c:pt>
                <c:pt idx="559">
                  <c:v>911.16999999999848</c:v>
                </c:pt>
                <c:pt idx="560">
                  <c:v>912.79999999999882</c:v>
                </c:pt>
                <c:pt idx="561">
                  <c:v>914.42999999999847</c:v>
                </c:pt>
                <c:pt idx="562">
                  <c:v>916.05999999999847</c:v>
                </c:pt>
                <c:pt idx="563">
                  <c:v>917.6899999999988</c:v>
                </c:pt>
                <c:pt idx="564">
                  <c:v>919.31999999999846</c:v>
                </c:pt>
                <c:pt idx="565">
                  <c:v>920.94999999999845</c:v>
                </c:pt>
                <c:pt idx="566">
                  <c:v>922.57999999999879</c:v>
                </c:pt>
                <c:pt idx="567">
                  <c:v>924.20999999999879</c:v>
                </c:pt>
                <c:pt idx="568">
                  <c:v>925.83999999999833</c:v>
                </c:pt>
                <c:pt idx="569">
                  <c:v>927.46999999999832</c:v>
                </c:pt>
                <c:pt idx="570">
                  <c:v>929.09999999999877</c:v>
                </c:pt>
                <c:pt idx="571">
                  <c:v>930.72999999999877</c:v>
                </c:pt>
                <c:pt idx="572">
                  <c:v>932.35999999999831</c:v>
                </c:pt>
                <c:pt idx="573">
                  <c:v>933.98999999999876</c:v>
                </c:pt>
                <c:pt idx="574">
                  <c:v>935.61999999999841</c:v>
                </c:pt>
                <c:pt idx="575">
                  <c:v>937.24999999999841</c:v>
                </c:pt>
                <c:pt idx="576">
                  <c:v>938.8799999999984</c:v>
                </c:pt>
                <c:pt idx="577">
                  <c:v>940.5099999999984</c:v>
                </c:pt>
                <c:pt idx="578">
                  <c:v>942.13999999999839</c:v>
                </c:pt>
                <c:pt idx="579">
                  <c:v>943.76999999999839</c:v>
                </c:pt>
                <c:pt idx="580">
                  <c:v>945.39999999999839</c:v>
                </c:pt>
                <c:pt idx="581">
                  <c:v>947.02999999999849</c:v>
                </c:pt>
                <c:pt idx="582">
                  <c:v>948.65999999999849</c:v>
                </c:pt>
                <c:pt idx="583">
                  <c:v>950.28999999999871</c:v>
                </c:pt>
                <c:pt idx="584">
                  <c:v>951.91999999999848</c:v>
                </c:pt>
                <c:pt idx="585">
                  <c:v>953.54999999999848</c:v>
                </c:pt>
                <c:pt idx="586">
                  <c:v>955.1799999999987</c:v>
                </c:pt>
                <c:pt idx="587">
                  <c:v>956.80999999999847</c:v>
                </c:pt>
                <c:pt idx="588">
                  <c:v>958.43999999999846</c:v>
                </c:pt>
                <c:pt idx="589">
                  <c:v>960.06999999999846</c:v>
                </c:pt>
                <c:pt idx="590">
                  <c:v>961.69999999999868</c:v>
                </c:pt>
                <c:pt idx="591">
                  <c:v>963.32999999999834</c:v>
                </c:pt>
                <c:pt idx="592">
                  <c:v>964.95999999999833</c:v>
                </c:pt>
                <c:pt idx="593">
                  <c:v>966.58999999999867</c:v>
                </c:pt>
                <c:pt idx="594">
                  <c:v>968.21999999999866</c:v>
                </c:pt>
                <c:pt idx="595">
                  <c:v>969.8499999999982</c:v>
                </c:pt>
                <c:pt idx="596">
                  <c:v>971.47999999999843</c:v>
                </c:pt>
                <c:pt idx="597">
                  <c:v>973.10999999999842</c:v>
                </c:pt>
                <c:pt idx="598">
                  <c:v>974.73999999999842</c:v>
                </c:pt>
                <c:pt idx="599">
                  <c:v>976.36999999999819</c:v>
                </c:pt>
                <c:pt idx="600">
                  <c:v>977.99999999999841</c:v>
                </c:pt>
                <c:pt idx="601">
                  <c:v>979.6299999999984</c:v>
                </c:pt>
                <c:pt idx="602">
                  <c:v>981.2599999999984</c:v>
                </c:pt>
                <c:pt idx="603">
                  <c:v>982.88999999999839</c:v>
                </c:pt>
                <c:pt idx="604">
                  <c:v>984.51999999999839</c:v>
                </c:pt>
                <c:pt idx="605">
                  <c:v>986.14999999999839</c:v>
                </c:pt>
                <c:pt idx="606">
                  <c:v>987.77999999999861</c:v>
                </c:pt>
                <c:pt idx="607">
                  <c:v>989.40999999999849</c:v>
                </c:pt>
                <c:pt idx="608">
                  <c:v>991.03999999999849</c:v>
                </c:pt>
                <c:pt idx="609">
                  <c:v>992.66999999999848</c:v>
                </c:pt>
                <c:pt idx="610">
                  <c:v>994.29999999999859</c:v>
                </c:pt>
                <c:pt idx="611">
                  <c:v>995.92999999999847</c:v>
                </c:pt>
                <c:pt idx="612">
                  <c:v>997.55999999999847</c:v>
                </c:pt>
                <c:pt idx="613">
                  <c:v>999.18999999999858</c:v>
                </c:pt>
                <c:pt idx="614">
                  <c:v>1000.8199999999982</c:v>
                </c:pt>
                <c:pt idx="615">
                  <c:v>1002.4499999999982</c:v>
                </c:pt>
                <c:pt idx="616">
                  <c:v>1004.0799999999986</c:v>
                </c:pt>
                <c:pt idx="617">
                  <c:v>1005.7099999999986</c:v>
                </c:pt>
                <c:pt idx="618">
                  <c:v>1007.3399999999982</c:v>
                </c:pt>
                <c:pt idx="619">
                  <c:v>1008.9699999999981</c:v>
                </c:pt>
                <c:pt idx="620">
                  <c:v>1010.5999999999984</c:v>
                </c:pt>
                <c:pt idx="621">
                  <c:v>1012.2299999999984</c:v>
                </c:pt>
                <c:pt idx="622">
                  <c:v>1013.8599999999981</c:v>
                </c:pt>
                <c:pt idx="623">
                  <c:v>1015.4899999999984</c:v>
                </c:pt>
                <c:pt idx="624">
                  <c:v>1017.1199999999984</c:v>
                </c:pt>
                <c:pt idx="625">
                  <c:v>1018.7499999999984</c:v>
                </c:pt>
                <c:pt idx="626">
                  <c:v>1020.3799999999984</c:v>
                </c:pt>
                <c:pt idx="627">
                  <c:v>1022.0099999999984</c:v>
                </c:pt>
                <c:pt idx="628">
                  <c:v>1023.6399999999984</c:v>
                </c:pt>
                <c:pt idx="629">
                  <c:v>1025.2699999999986</c:v>
                </c:pt>
                <c:pt idx="630">
                  <c:v>1026.899999999998</c:v>
                </c:pt>
                <c:pt idx="631">
                  <c:v>1028.5299999999988</c:v>
                </c:pt>
                <c:pt idx="632">
                  <c:v>1030.1599999999983</c:v>
                </c:pt>
                <c:pt idx="633">
                  <c:v>1031.7899999999991</c:v>
                </c:pt>
                <c:pt idx="634">
                  <c:v>1033.4199999999998</c:v>
                </c:pt>
                <c:pt idx="635">
                  <c:v>1035.0499999999993</c:v>
                </c:pt>
                <c:pt idx="636">
                  <c:v>1036.6799999999994</c:v>
                </c:pt>
                <c:pt idx="637">
                  <c:v>1038.3099999999995</c:v>
                </c:pt>
                <c:pt idx="638">
                  <c:v>1039.94</c:v>
                </c:pt>
                <c:pt idx="639">
                  <c:v>1041.5699999999997</c:v>
                </c:pt>
                <c:pt idx="640">
                  <c:v>1043.1999999999998</c:v>
                </c:pt>
                <c:pt idx="641">
                  <c:v>1044.83</c:v>
                </c:pt>
                <c:pt idx="642">
                  <c:v>1046.46</c:v>
                </c:pt>
                <c:pt idx="643">
                  <c:v>1048.0899999999999</c:v>
                </c:pt>
                <c:pt idx="644">
                  <c:v>1049.7200000000003</c:v>
                </c:pt>
                <c:pt idx="645">
                  <c:v>1051.3500000000004</c:v>
                </c:pt>
                <c:pt idx="646">
                  <c:v>1052.9800000000005</c:v>
                </c:pt>
                <c:pt idx="647">
                  <c:v>1054.6100000000006</c:v>
                </c:pt>
                <c:pt idx="648">
                  <c:v>1056.2400000000007</c:v>
                </c:pt>
                <c:pt idx="649">
                  <c:v>1057.8700000000008</c:v>
                </c:pt>
                <c:pt idx="650">
                  <c:v>1059.5000000000009</c:v>
                </c:pt>
                <c:pt idx="651">
                  <c:v>1061.1300000000008</c:v>
                </c:pt>
                <c:pt idx="652">
                  <c:v>1062.7600000000009</c:v>
                </c:pt>
                <c:pt idx="653">
                  <c:v>1064.3900000000008</c:v>
                </c:pt>
                <c:pt idx="654">
                  <c:v>1066.0200000000009</c:v>
                </c:pt>
                <c:pt idx="655">
                  <c:v>1067.6500000000008</c:v>
                </c:pt>
                <c:pt idx="656">
                  <c:v>1069.2800000000016</c:v>
                </c:pt>
                <c:pt idx="657">
                  <c:v>1070.9100000000017</c:v>
                </c:pt>
                <c:pt idx="658">
                  <c:v>1072.5400000000018</c:v>
                </c:pt>
                <c:pt idx="659">
                  <c:v>1074.1700000000012</c:v>
                </c:pt>
                <c:pt idx="660">
                  <c:v>1075.800000000002</c:v>
                </c:pt>
                <c:pt idx="661">
                  <c:v>1077.4300000000021</c:v>
                </c:pt>
                <c:pt idx="662">
                  <c:v>1079.0600000000022</c:v>
                </c:pt>
                <c:pt idx="663">
                  <c:v>1080.6900000000016</c:v>
                </c:pt>
                <c:pt idx="664">
                  <c:v>1082.3200000000024</c:v>
                </c:pt>
                <c:pt idx="665">
                  <c:v>1083.9500000000025</c:v>
                </c:pt>
                <c:pt idx="666">
                  <c:v>1085.5800000000027</c:v>
                </c:pt>
                <c:pt idx="667">
                  <c:v>1087.210000000003</c:v>
                </c:pt>
                <c:pt idx="668">
                  <c:v>1088.8400000000029</c:v>
                </c:pt>
                <c:pt idx="669">
                  <c:v>1090.470000000003</c:v>
                </c:pt>
                <c:pt idx="670">
                  <c:v>1092.1000000000029</c:v>
                </c:pt>
                <c:pt idx="671">
                  <c:v>1093.7300000000032</c:v>
                </c:pt>
                <c:pt idx="672">
                  <c:v>1095.3600000000029</c:v>
                </c:pt>
                <c:pt idx="673">
                  <c:v>1096.9900000000034</c:v>
                </c:pt>
                <c:pt idx="674">
                  <c:v>1098.6200000000028</c:v>
                </c:pt>
                <c:pt idx="675">
                  <c:v>1100.2500000000036</c:v>
                </c:pt>
                <c:pt idx="676">
                  <c:v>1101.8800000000031</c:v>
                </c:pt>
                <c:pt idx="677">
                  <c:v>1103.5100000000039</c:v>
                </c:pt>
                <c:pt idx="678">
                  <c:v>1105.140000000004</c:v>
                </c:pt>
                <c:pt idx="679">
                  <c:v>1106.7700000000041</c:v>
                </c:pt>
                <c:pt idx="680">
                  <c:v>1108.4000000000049</c:v>
                </c:pt>
                <c:pt idx="681">
                  <c:v>1110.0300000000043</c:v>
                </c:pt>
                <c:pt idx="682">
                  <c:v>1111.6600000000044</c:v>
                </c:pt>
                <c:pt idx="683">
                  <c:v>1113.2900000000045</c:v>
                </c:pt>
                <c:pt idx="684">
                  <c:v>1114.9200000000051</c:v>
                </c:pt>
                <c:pt idx="685">
                  <c:v>1116.5500000000047</c:v>
                </c:pt>
                <c:pt idx="686">
                  <c:v>1118.1800000000048</c:v>
                </c:pt>
                <c:pt idx="687">
                  <c:v>1119.8100000000049</c:v>
                </c:pt>
                <c:pt idx="688">
                  <c:v>1121.4400000000051</c:v>
                </c:pt>
                <c:pt idx="689">
                  <c:v>1123.0700000000052</c:v>
                </c:pt>
                <c:pt idx="690">
                  <c:v>1124.7000000000053</c:v>
                </c:pt>
                <c:pt idx="691">
                  <c:v>1126.3300000000054</c:v>
                </c:pt>
                <c:pt idx="692">
                  <c:v>1127.9600000000055</c:v>
                </c:pt>
                <c:pt idx="693">
                  <c:v>1129.5900000000056</c:v>
                </c:pt>
                <c:pt idx="694">
                  <c:v>1131.2200000000057</c:v>
                </c:pt>
                <c:pt idx="695">
                  <c:v>1132.8500000000058</c:v>
                </c:pt>
                <c:pt idx="696">
                  <c:v>1134.4800000000059</c:v>
                </c:pt>
                <c:pt idx="697">
                  <c:v>1136.1100000000058</c:v>
                </c:pt>
                <c:pt idx="698">
                  <c:v>1137.7400000000059</c:v>
                </c:pt>
                <c:pt idx="699">
                  <c:v>1139.3700000000058</c:v>
                </c:pt>
                <c:pt idx="700">
                  <c:v>1141.0000000000064</c:v>
                </c:pt>
                <c:pt idx="701">
                  <c:v>1142.6300000000058</c:v>
                </c:pt>
                <c:pt idx="702">
                  <c:v>1144.2600000000066</c:v>
                </c:pt>
                <c:pt idx="703">
                  <c:v>1145.890000000006</c:v>
                </c:pt>
                <c:pt idx="704">
                  <c:v>1147.5200000000068</c:v>
                </c:pt>
                <c:pt idx="705">
                  <c:v>1149.1500000000062</c:v>
                </c:pt>
                <c:pt idx="706">
                  <c:v>1150.780000000007</c:v>
                </c:pt>
                <c:pt idx="707">
                  <c:v>1152.4100000000071</c:v>
                </c:pt>
                <c:pt idx="708">
                  <c:v>1154.0400000000072</c:v>
                </c:pt>
                <c:pt idx="709">
                  <c:v>1155.6700000000067</c:v>
                </c:pt>
                <c:pt idx="710">
                  <c:v>1157.3000000000075</c:v>
                </c:pt>
                <c:pt idx="711">
                  <c:v>1158.930000000008</c:v>
                </c:pt>
                <c:pt idx="712">
                  <c:v>1160.5600000000077</c:v>
                </c:pt>
                <c:pt idx="713">
                  <c:v>1162.1900000000078</c:v>
                </c:pt>
                <c:pt idx="714">
                  <c:v>1163.8200000000079</c:v>
                </c:pt>
                <c:pt idx="715">
                  <c:v>1165.450000000008</c:v>
                </c:pt>
                <c:pt idx="716">
                  <c:v>1167.0800000000079</c:v>
                </c:pt>
                <c:pt idx="717">
                  <c:v>1168.7100000000082</c:v>
                </c:pt>
                <c:pt idx="718">
                  <c:v>1170.3400000000079</c:v>
                </c:pt>
                <c:pt idx="719">
                  <c:v>1171.9700000000084</c:v>
                </c:pt>
                <c:pt idx="720">
                  <c:v>1173.6000000000079</c:v>
                </c:pt>
                <c:pt idx="721">
                  <c:v>1175.2300000000087</c:v>
                </c:pt>
                <c:pt idx="722">
                  <c:v>1176.8600000000088</c:v>
                </c:pt>
                <c:pt idx="723">
                  <c:v>1178.4900000000089</c:v>
                </c:pt>
                <c:pt idx="724">
                  <c:v>1180.120000000009</c:v>
                </c:pt>
                <c:pt idx="725">
                  <c:v>1181.7500000000091</c:v>
                </c:pt>
                <c:pt idx="726">
                  <c:v>1183.3800000000092</c:v>
                </c:pt>
                <c:pt idx="727">
                  <c:v>1185.0100000000093</c:v>
                </c:pt>
                <c:pt idx="728">
                  <c:v>1186.6400000000094</c:v>
                </c:pt>
                <c:pt idx="729">
                  <c:v>1188.2700000000095</c:v>
                </c:pt>
                <c:pt idx="730">
                  <c:v>1189.9000000000101</c:v>
                </c:pt>
                <c:pt idx="731">
                  <c:v>1191.5300000000097</c:v>
                </c:pt>
                <c:pt idx="732">
                  <c:v>1193.1600000000099</c:v>
                </c:pt>
                <c:pt idx="733">
                  <c:v>1194.79000000001</c:v>
                </c:pt>
                <c:pt idx="734">
                  <c:v>1196.4200000000101</c:v>
                </c:pt>
                <c:pt idx="735">
                  <c:v>1198.0500000000102</c:v>
                </c:pt>
                <c:pt idx="736">
                  <c:v>1199.6800000000098</c:v>
                </c:pt>
                <c:pt idx="737">
                  <c:v>1201.3100000000104</c:v>
                </c:pt>
                <c:pt idx="738">
                  <c:v>1202.9400000000105</c:v>
                </c:pt>
                <c:pt idx="739">
                  <c:v>1204.5700000000106</c:v>
                </c:pt>
                <c:pt idx="740">
                  <c:v>1206.2000000000107</c:v>
                </c:pt>
                <c:pt idx="741">
                  <c:v>1207.8300000000108</c:v>
                </c:pt>
                <c:pt idx="742">
                  <c:v>1209.460000000011</c:v>
                </c:pt>
                <c:pt idx="743">
                  <c:v>1211.0900000000108</c:v>
                </c:pt>
                <c:pt idx="744">
                  <c:v>1212.7200000000112</c:v>
                </c:pt>
                <c:pt idx="745">
                  <c:v>1214.3500000000108</c:v>
                </c:pt>
                <c:pt idx="746">
                  <c:v>1215.9800000000114</c:v>
                </c:pt>
                <c:pt idx="747">
                  <c:v>1217.6100000000108</c:v>
                </c:pt>
                <c:pt idx="748">
                  <c:v>1219.2400000000116</c:v>
                </c:pt>
                <c:pt idx="749">
                  <c:v>1220.870000000011</c:v>
                </c:pt>
                <c:pt idx="750">
                  <c:v>1222.5000000000118</c:v>
                </c:pt>
                <c:pt idx="751">
                  <c:v>1224.1300000000113</c:v>
                </c:pt>
                <c:pt idx="752">
                  <c:v>1225.760000000012</c:v>
                </c:pt>
                <c:pt idx="753">
                  <c:v>1227.3900000000122</c:v>
                </c:pt>
                <c:pt idx="754">
                  <c:v>1229.0200000000123</c:v>
                </c:pt>
                <c:pt idx="755">
                  <c:v>1230.6500000000124</c:v>
                </c:pt>
                <c:pt idx="756">
                  <c:v>1232.2800000000125</c:v>
                </c:pt>
                <c:pt idx="757">
                  <c:v>1233.910000000013</c:v>
                </c:pt>
                <c:pt idx="758">
                  <c:v>1235.5400000000127</c:v>
                </c:pt>
                <c:pt idx="759">
                  <c:v>1237.1700000000128</c:v>
                </c:pt>
                <c:pt idx="760">
                  <c:v>1238.8000000000129</c:v>
                </c:pt>
                <c:pt idx="761">
                  <c:v>1240.430000000013</c:v>
                </c:pt>
                <c:pt idx="762">
                  <c:v>1242.0600000000129</c:v>
                </c:pt>
                <c:pt idx="763">
                  <c:v>1243.6900000000128</c:v>
                </c:pt>
                <c:pt idx="764">
                  <c:v>1245.3200000000134</c:v>
                </c:pt>
                <c:pt idx="765">
                  <c:v>1246.9500000000135</c:v>
                </c:pt>
                <c:pt idx="766">
                  <c:v>1248.5800000000136</c:v>
                </c:pt>
                <c:pt idx="767">
                  <c:v>1250.2100000000137</c:v>
                </c:pt>
                <c:pt idx="768">
                  <c:v>1251.8400000000138</c:v>
                </c:pt>
                <c:pt idx="769">
                  <c:v>1253.4700000000139</c:v>
                </c:pt>
                <c:pt idx="770">
                  <c:v>1255.100000000014</c:v>
                </c:pt>
                <c:pt idx="771">
                  <c:v>1256.7300000000141</c:v>
                </c:pt>
                <c:pt idx="772">
                  <c:v>1258.3600000000142</c:v>
                </c:pt>
                <c:pt idx="773">
                  <c:v>1259.9900000000143</c:v>
                </c:pt>
                <c:pt idx="774">
                  <c:v>1261.6200000000144</c:v>
                </c:pt>
                <c:pt idx="775">
                  <c:v>1263.250000000015</c:v>
                </c:pt>
                <c:pt idx="776">
                  <c:v>1264.8800000000147</c:v>
                </c:pt>
                <c:pt idx="777">
                  <c:v>1266.510000000015</c:v>
                </c:pt>
                <c:pt idx="778">
                  <c:v>1268.1400000000149</c:v>
                </c:pt>
                <c:pt idx="779">
                  <c:v>1269.770000000015</c:v>
                </c:pt>
                <c:pt idx="780">
                  <c:v>1271.4000000000151</c:v>
                </c:pt>
                <c:pt idx="781">
                  <c:v>1273.0300000000152</c:v>
                </c:pt>
                <c:pt idx="782">
                  <c:v>1274.6600000000149</c:v>
                </c:pt>
                <c:pt idx="783">
                  <c:v>1276.2900000000154</c:v>
                </c:pt>
                <c:pt idx="784">
                  <c:v>1277.9200000000155</c:v>
                </c:pt>
                <c:pt idx="785">
                  <c:v>1279.5500000000156</c:v>
                </c:pt>
                <c:pt idx="786">
                  <c:v>1281.1800000000158</c:v>
                </c:pt>
                <c:pt idx="787">
                  <c:v>1282.8100000000159</c:v>
                </c:pt>
                <c:pt idx="788">
                  <c:v>1284.440000000016</c:v>
                </c:pt>
                <c:pt idx="789">
                  <c:v>1286.0700000000159</c:v>
                </c:pt>
                <c:pt idx="790">
                  <c:v>1287.7000000000162</c:v>
                </c:pt>
                <c:pt idx="791">
                  <c:v>1289.3300000000158</c:v>
                </c:pt>
                <c:pt idx="792">
                  <c:v>1290.9600000000164</c:v>
                </c:pt>
                <c:pt idx="793">
                  <c:v>1292.5900000000158</c:v>
                </c:pt>
                <c:pt idx="794">
                  <c:v>1294.2200000000166</c:v>
                </c:pt>
                <c:pt idx="795">
                  <c:v>1295.8500000000161</c:v>
                </c:pt>
                <c:pt idx="796">
                  <c:v>1297.4800000000168</c:v>
                </c:pt>
                <c:pt idx="797">
                  <c:v>1299.110000000017</c:v>
                </c:pt>
                <c:pt idx="798">
                  <c:v>1300.7400000000171</c:v>
                </c:pt>
                <c:pt idx="799">
                  <c:v>1302.3700000000172</c:v>
                </c:pt>
                <c:pt idx="800">
                  <c:v>1304.0000000000173</c:v>
                </c:pt>
                <c:pt idx="801">
                  <c:v>1305.6300000000174</c:v>
                </c:pt>
                <c:pt idx="802">
                  <c:v>1307.2600000000175</c:v>
                </c:pt>
                <c:pt idx="803">
                  <c:v>1308.8900000000176</c:v>
                </c:pt>
                <c:pt idx="804">
                  <c:v>1310.5200000000177</c:v>
                </c:pt>
                <c:pt idx="805">
                  <c:v>1312.1500000000178</c:v>
                </c:pt>
                <c:pt idx="806">
                  <c:v>1313.7800000000179</c:v>
                </c:pt>
                <c:pt idx="807">
                  <c:v>1315.410000000018</c:v>
                </c:pt>
                <c:pt idx="808">
                  <c:v>1317.0400000000182</c:v>
                </c:pt>
                <c:pt idx="809">
                  <c:v>1318.6700000000178</c:v>
                </c:pt>
                <c:pt idx="810">
                  <c:v>1320.3000000000184</c:v>
                </c:pt>
                <c:pt idx="811">
                  <c:v>1321.9300000000185</c:v>
                </c:pt>
                <c:pt idx="812">
                  <c:v>1323.5600000000186</c:v>
                </c:pt>
                <c:pt idx="813">
                  <c:v>1325.190000000018</c:v>
                </c:pt>
                <c:pt idx="814">
                  <c:v>1326.8200000000188</c:v>
                </c:pt>
                <c:pt idx="815">
                  <c:v>1328.4500000000189</c:v>
                </c:pt>
                <c:pt idx="816">
                  <c:v>1330.080000000019</c:v>
                </c:pt>
                <c:pt idx="817">
                  <c:v>1331.7100000000191</c:v>
                </c:pt>
                <c:pt idx="818">
                  <c:v>1333.3400000000192</c:v>
                </c:pt>
                <c:pt idx="819">
                  <c:v>1334.97000000002</c:v>
                </c:pt>
                <c:pt idx="820">
                  <c:v>1336.6000000000195</c:v>
                </c:pt>
                <c:pt idx="821">
                  <c:v>1338.23000000002</c:v>
                </c:pt>
                <c:pt idx="822">
                  <c:v>1339.8600000000197</c:v>
                </c:pt>
                <c:pt idx="823">
                  <c:v>1341.49000000002</c:v>
                </c:pt>
                <c:pt idx="824">
                  <c:v>1343.1200000000199</c:v>
                </c:pt>
                <c:pt idx="825">
                  <c:v>1344.75000000002</c:v>
                </c:pt>
                <c:pt idx="826">
                  <c:v>1346.3800000000199</c:v>
                </c:pt>
                <c:pt idx="827">
                  <c:v>1348.0100000000202</c:v>
                </c:pt>
                <c:pt idx="828">
                  <c:v>1349.6400000000199</c:v>
                </c:pt>
                <c:pt idx="829">
                  <c:v>1351.2700000000204</c:v>
                </c:pt>
                <c:pt idx="830">
                  <c:v>1352.900000000021</c:v>
                </c:pt>
                <c:pt idx="831">
                  <c:v>1354.5300000000207</c:v>
                </c:pt>
                <c:pt idx="832">
                  <c:v>1356.1600000000208</c:v>
                </c:pt>
                <c:pt idx="833">
                  <c:v>1357.7900000000209</c:v>
                </c:pt>
                <c:pt idx="834">
                  <c:v>1359.420000000021</c:v>
                </c:pt>
                <c:pt idx="835">
                  <c:v>1361.0500000000209</c:v>
                </c:pt>
                <c:pt idx="836">
                  <c:v>1362.6800000000208</c:v>
                </c:pt>
                <c:pt idx="837">
                  <c:v>1364.3100000000209</c:v>
                </c:pt>
                <c:pt idx="838">
                  <c:v>1365.9400000000214</c:v>
                </c:pt>
                <c:pt idx="839">
                  <c:v>1367.5700000000209</c:v>
                </c:pt>
                <c:pt idx="840">
                  <c:v>1369.2000000000216</c:v>
                </c:pt>
                <c:pt idx="841">
                  <c:v>1370.8300000000218</c:v>
                </c:pt>
                <c:pt idx="842">
                  <c:v>1372.4600000000219</c:v>
                </c:pt>
                <c:pt idx="843">
                  <c:v>1374.090000000022</c:v>
                </c:pt>
                <c:pt idx="844">
                  <c:v>1375.7200000000221</c:v>
                </c:pt>
                <c:pt idx="845">
                  <c:v>1377.3500000000222</c:v>
                </c:pt>
                <c:pt idx="846">
                  <c:v>1378.9800000000223</c:v>
                </c:pt>
                <c:pt idx="847">
                  <c:v>1380.6100000000224</c:v>
                </c:pt>
                <c:pt idx="848">
                  <c:v>1382.2400000000225</c:v>
                </c:pt>
                <c:pt idx="849">
                  <c:v>1383.8700000000226</c:v>
                </c:pt>
                <c:pt idx="850">
                  <c:v>1385.5000000000227</c:v>
                </c:pt>
                <c:pt idx="851">
                  <c:v>1387.1300000000228</c:v>
                </c:pt>
                <c:pt idx="852">
                  <c:v>1388.760000000023</c:v>
                </c:pt>
                <c:pt idx="853">
                  <c:v>1390.3900000000228</c:v>
                </c:pt>
                <c:pt idx="854">
                  <c:v>1392.0200000000232</c:v>
                </c:pt>
                <c:pt idx="855">
                  <c:v>1393.6500000000228</c:v>
                </c:pt>
                <c:pt idx="856">
                  <c:v>1395.2800000000234</c:v>
                </c:pt>
                <c:pt idx="857">
                  <c:v>1396.9100000000235</c:v>
                </c:pt>
                <c:pt idx="858">
                  <c:v>1398.5400000000236</c:v>
                </c:pt>
                <c:pt idx="859">
                  <c:v>1400.170000000023</c:v>
                </c:pt>
                <c:pt idx="860">
                  <c:v>1401.8000000000238</c:v>
                </c:pt>
                <c:pt idx="861">
                  <c:v>1403.4300000000239</c:v>
                </c:pt>
                <c:pt idx="862">
                  <c:v>1405.060000000024</c:v>
                </c:pt>
                <c:pt idx="863">
                  <c:v>1406.6900000000242</c:v>
                </c:pt>
                <c:pt idx="864">
                  <c:v>1408.3200000000243</c:v>
                </c:pt>
                <c:pt idx="865">
                  <c:v>1409.9500000000251</c:v>
                </c:pt>
                <c:pt idx="866">
                  <c:v>1411.5800000000245</c:v>
                </c:pt>
                <c:pt idx="867">
                  <c:v>1413.210000000025</c:v>
                </c:pt>
                <c:pt idx="868">
                  <c:v>1414.8400000000247</c:v>
                </c:pt>
                <c:pt idx="869">
                  <c:v>1416.470000000025</c:v>
                </c:pt>
                <c:pt idx="870">
                  <c:v>1418.1000000000249</c:v>
                </c:pt>
                <c:pt idx="871">
                  <c:v>1419.730000000025</c:v>
                </c:pt>
                <c:pt idx="872">
                  <c:v>1421.3600000000249</c:v>
                </c:pt>
                <c:pt idx="873">
                  <c:v>1422.9900000000252</c:v>
                </c:pt>
                <c:pt idx="874">
                  <c:v>1424.6200000000254</c:v>
                </c:pt>
                <c:pt idx="875">
                  <c:v>1426.2500000000255</c:v>
                </c:pt>
                <c:pt idx="876">
                  <c:v>1427.8800000000256</c:v>
                </c:pt>
                <c:pt idx="877">
                  <c:v>1429.5100000000257</c:v>
                </c:pt>
                <c:pt idx="878">
                  <c:v>1431.1400000000258</c:v>
                </c:pt>
                <c:pt idx="879">
                  <c:v>1432.7700000000259</c:v>
                </c:pt>
                <c:pt idx="880">
                  <c:v>1434.400000000026</c:v>
                </c:pt>
                <c:pt idx="881">
                  <c:v>1436.0300000000259</c:v>
                </c:pt>
                <c:pt idx="882">
                  <c:v>1437.6600000000258</c:v>
                </c:pt>
                <c:pt idx="883">
                  <c:v>1439.2900000000259</c:v>
                </c:pt>
                <c:pt idx="884">
                  <c:v>1440.9200000000264</c:v>
                </c:pt>
                <c:pt idx="885">
                  <c:v>1442.5500000000266</c:v>
                </c:pt>
                <c:pt idx="886">
                  <c:v>1444.180000000026</c:v>
                </c:pt>
                <c:pt idx="887">
                  <c:v>1445.8100000000268</c:v>
                </c:pt>
                <c:pt idx="888">
                  <c:v>1447.4400000000269</c:v>
                </c:pt>
                <c:pt idx="889">
                  <c:v>1449.070000000027</c:v>
                </c:pt>
                <c:pt idx="890">
                  <c:v>1450.7000000000271</c:v>
                </c:pt>
                <c:pt idx="891">
                  <c:v>1452.3300000000272</c:v>
                </c:pt>
                <c:pt idx="892">
                  <c:v>1453.9600000000273</c:v>
                </c:pt>
                <c:pt idx="893">
                  <c:v>1455.5900000000274</c:v>
                </c:pt>
                <c:pt idx="894">
                  <c:v>1457.2200000000275</c:v>
                </c:pt>
                <c:pt idx="895">
                  <c:v>1458.8500000000276</c:v>
                </c:pt>
                <c:pt idx="896">
                  <c:v>1460.480000000028</c:v>
                </c:pt>
                <c:pt idx="897">
                  <c:v>1462.1100000000279</c:v>
                </c:pt>
                <c:pt idx="898">
                  <c:v>1463.740000000028</c:v>
                </c:pt>
                <c:pt idx="899">
                  <c:v>1465.3700000000279</c:v>
                </c:pt>
                <c:pt idx="900">
                  <c:v>1467.0000000000282</c:v>
                </c:pt>
                <c:pt idx="901">
                  <c:v>1468.6300000000278</c:v>
                </c:pt>
                <c:pt idx="902">
                  <c:v>1470.2600000000284</c:v>
                </c:pt>
                <c:pt idx="903">
                  <c:v>1471.8900000000278</c:v>
                </c:pt>
                <c:pt idx="904">
                  <c:v>1473.5200000000286</c:v>
                </c:pt>
                <c:pt idx="905">
                  <c:v>1475.1500000000281</c:v>
                </c:pt>
                <c:pt idx="906">
                  <c:v>1476.7800000000288</c:v>
                </c:pt>
                <c:pt idx="907">
                  <c:v>1478.4100000000296</c:v>
                </c:pt>
                <c:pt idx="908">
                  <c:v>1480.0400000000291</c:v>
                </c:pt>
                <c:pt idx="909">
                  <c:v>1481.6700000000292</c:v>
                </c:pt>
                <c:pt idx="910">
                  <c:v>1483.3000000000293</c:v>
                </c:pt>
                <c:pt idx="911">
                  <c:v>1484.9300000000301</c:v>
                </c:pt>
                <c:pt idx="912">
                  <c:v>1486.5600000000295</c:v>
                </c:pt>
                <c:pt idx="913">
                  <c:v>1488.1900000000296</c:v>
                </c:pt>
                <c:pt idx="914">
                  <c:v>1489.8200000000297</c:v>
                </c:pt>
                <c:pt idx="915">
                  <c:v>1491.4500000000301</c:v>
                </c:pt>
                <c:pt idx="916">
                  <c:v>1493.0800000000299</c:v>
                </c:pt>
                <c:pt idx="917">
                  <c:v>1494.71000000003</c:v>
                </c:pt>
                <c:pt idx="918">
                  <c:v>1496.3400000000302</c:v>
                </c:pt>
                <c:pt idx="919">
                  <c:v>1497.9700000000303</c:v>
                </c:pt>
                <c:pt idx="920">
                  <c:v>1499.6000000000304</c:v>
                </c:pt>
                <c:pt idx="921">
                  <c:v>1501.2300000000305</c:v>
                </c:pt>
                <c:pt idx="922">
                  <c:v>1502.8600000000306</c:v>
                </c:pt>
                <c:pt idx="923">
                  <c:v>1504.4900000000307</c:v>
                </c:pt>
                <c:pt idx="924">
                  <c:v>1506.1200000000308</c:v>
                </c:pt>
                <c:pt idx="925">
                  <c:v>1507.7500000000309</c:v>
                </c:pt>
                <c:pt idx="926">
                  <c:v>1509.3800000000308</c:v>
                </c:pt>
                <c:pt idx="927">
                  <c:v>1511.0100000000309</c:v>
                </c:pt>
                <c:pt idx="928">
                  <c:v>1512.6400000000308</c:v>
                </c:pt>
                <c:pt idx="929">
                  <c:v>1514.2700000000314</c:v>
                </c:pt>
                <c:pt idx="930">
                  <c:v>1515.9000000000315</c:v>
                </c:pt>
                <c:pt idx="931">
                  <c:v>1517.5300000000316</c:v>
                </c:pt>
                <c:pt idx="932">
                  <c:v>1519.160000000031</c:v>
                </c:pt>
                <c:pt idx="933">
                  <c:v>1520.7900000000318</c:v>
                </c:pt>
                <c:pt idx="934">
                  <c:v>1522.4200000000319</c:v>
                </c:pt>
                <c:pt idx="935">
                  <c:v>1524.050000000032</c:v>
                </c:pt>
                <c:pt idx="936">
                  <c:v>1525.6800000000314</c:v>
                </c:pt>
                <c:pt idx="937">
                  <c:v>1527.3100000000322</c:v>
                </c:pt>
                <c:pt idx="938">
                  <c:v>1528.9400000000323</c:v>
                </c:pt>
                <c:pt idx="939">
                  <c:v>1530.5700000000325</c:v>
                </c:pt>
                <c:pt idx="940">
                  <c:v>1532.200000000033</c:v>
                </c:pt>
                <c:pt idx="941">
                  <c:v>1533.8300000000327</c:v>
                </c:pt>
                <c:pt idx="942">
                  <c:v>1535.460000000033</c:v>
                </c:pt>
                <c:pt idx="943">
                  <c:v>1537.0900000000329</c:v>
                </c:pt>
                <c:pt idx="944">
                  <c:v>1538.720000000033</c:v>
                </c:pt>
                <c:pt idx="945">
                  <c:v>1540.3500000000329</c:v>
                </c:pt>
                <c:pt idx="946">
                  <c:v>1541.9800000000332</c:v>
                </c:pt>
                <c:pt idx="947">
                  <c:v>1543.6100000000329</c:v>
                </c:pt>
                <c:pt idx="948">
                  <c:v>1545.2400000000334</c:v>
                </c:pt>
                <c:pt idx="949">
                  <c:v>1546.8700000000329</c:v>
                </c:pt>
                <c:pt idx="950">
                  <c:v>1548.5000000000337</c:v>
                </c:pt>
                <c:pt idx="951">
                  <c:v>1550.1300000000338</c:v>
                </c:pt>
                <c:pt idx="952">
                  <c:v>1551.7600000000339</c:v>
                </c:pt>
                <c:pt idx="953">
                  <c:v>1553.390000000034</c:v>
                </c:pt>
                <c:pt idx="954">
                  <c:v>1555.0200000000341</c:v>
                </c:pt>
                <c:pt idx="955">
                  <c:v>1556.6500000000342</c:v>
                </c:pt>
                <c:pt idx="956">
                  <c:v>1558.2800000000343</c:v>
                </c:pt>
                <c:pt idx="957">
                  <c:v>1559.9100000000351</c:v>
                </c:pt>
                <c:pt idx="958">
                  <c:v>1561.5400000000345</c:v>
                </c:pt>
                <c:pt idx="959">
                  <c:v>1563.1700000000346</c:v>
                </c:pt>
                <c:pt idx="960">
                  <c:v>1564.8000000000347</c:v>
                </c:pt>
                <c:pt idx="961">
                  <c:v>1566.4300000000351</c:v>
                </c:pt>
                <c:pt idx="962">
                  <c:v>1568.060000000035</c:v>
                </c:pt>
                <c:pt idx="963">
                  <c:v>1569.6900000000348</c:v>
                </c:pt>
                <c:pt idx="964">
                  <c:v>1571.3200000000352</c:v>
                </c:pt>
                <c:pt idx="965">
                  <c:v>1572.9500000000353</c:v>
                </c:pt>
                <c:pt idx="966">
                  <c:v>1574.5800000000354</c:v>
                </c:pt>
                <c:pt idx="967">
                  <c:v>1576.2100000000355</c:v>
                </c:pt>
                <c:pt idx="968">
                  <c:v>1577.8400000000356</c:v>
                </c:pt>
                <c:pt idx="969">
                  <c:v>1579.4700000000357</c:v>
                </c:pt>
                <c:pt idx="970">
                  <c:v>1581.1000000000358</c:v>
                </c:pt>
                <c:pt idx="971">
                  <c:v>1582.7300000000359</c:v>
                </c:pt>
                <c:pt idx="972">
                  <c:v>1584.3600000000358</c:v>
                </c:pt>
                <c:pt idx="973">
                  <c:v>1585.9900000000362</c:v>
                </c:pt>
                <c:pt idx="974">
                  <c:v>1587.6200000000358</c:v>
                </c:pt>
                <c:pt idx="975">
                  <c:v>1589.2500000000364</c:v>
                </c:pt>
                <c:pt idx="976">
                  <c:v>1590.8800000000358</c:v>
                </c:pt>
                <c:pt idx="977">
                  <c:v>1592.5100000000366</c:v>
                </c:pt>
                <c:pt idx="978">
                  <c:v>1594.140000000036</c:v>
                </c:pt>
                <c:pt idx="979">
                  <c:v>1595.7700000000368</c:v>
                </c:pt>
                <c:pt idx="980">
                  <c:v>1597.4000000000369</c:v>
                </c:pt>
                <c:pt idx="981">
                  <c:v>1599.030000000037</c:v>
                </c:pt>
              </c:numCache>
            </c:numRef>
          </c:xVal>
          <c:yVal>
            <c:numRef>
              <c:f>Sheet1!$C$1:$C$2285</c:f>
              <c:numCache>
                <c:formatCode>General</c:formatCode>
                <c:ptCount val="2285"/>
                <c:pt idx="0">
                  <c:v>1.0071767658273261</c:v>
                </c:pt>
                <c:pt idx="1">
                  <c:v>1.0021579399083793</c:v>
                </c:pt>
                <c:pt idx="2">
                  <c:v>1.0002493046523169</c:v>
                </c:pt>
                <c:pt idx="3">
                  <c:v>1.0047247583722312</c:v>
                </c:pt>
                <c:pt idx="4">
                  <c:v>1.0034537102596035</c:v>
                </c:pt>
                <c:pt idx="5">
                  <c:v>1.0062926622195758</c:v>
                </c:pt>
                <c:pt idx="6">
                  <c:v>1.00394654810392</c:v>
                </c:pt>
                <c:pt idx="7">
                  <c:v>0.99753652268103432</c:v>
                </c:pt>
                <c:pt idx="8">
                  <c:v>0.99585976834983625</c:v>
                </c:pt>
                <c:pt idx="9">
                  <c:v>0.99282220388408704</c:v>
                </c:pt>
                <c:pt idx="10">
                  <c:v>0.9918241618257545</c:v>
                </c:pt>
                <c:pt idx="11">
                  <c:v>0.98989333551504199</c:v>
                </c:pt>
                <c:pt idx="12">
                  <c:v>0.9889843666287248</c:v>
                </c:pt>
                <c:pt idx="13">
                  <c:v>0.99434329161200108</c:v>
                </c:pt>
                <c:pt idx="14">
                  <c:v>0.99348818125918359</c:v>
                </c:pt>
                <c:pt idx="15">
                  <c:v>0.99845880590055347</c:v>
                </c:pt>
                <c:pt idx="16">
                  <c:v>0.99578209955755859</c:v>
                </c:pt>
                <c:pt idx="17">
                  <c:v>0.98725387532364139</c:v>
                </c:pt>
                <c:pt idx="18">
                  <c:v>0.987437761743715</c:v>
                </c:pt>
                <c:pt idx="19">
                  <c:v>0.98689452330057958</c:v>
                </c:pt>
                <c:pt idx="20">
                  <c:v>0.99282008968782831</c:v>
                </c:pt>
                <c:pt idx="21">
                  <c:v>0.99456955666993652</c:v>
                </c:pt>
                <c:pt idx="22">
                  <c:v>0.99728251682405367</c:v>
                </c:pt>
                <c:pt idx="23">
                  <c:v>1.0039075914216919</c:v>
                </c:pt>
                <c:pt idx="24">
                  <c:v>1.0010719690658401</c:v>
                </c:pt>
                <c:pt idx="25">
                  <c:v>1.0031873591428624</c:v>
                </c:pt>
                <c:pt idx="26">
                  <c:v>1.0014170580847548</c:v>
                </c:pt>
                <c:pt idx="27">
                  <c:v>1.0076717017702126</c:v>
                </c:pt>
                <c:pt idx="28">
                  <c:v>1.0062894728599674</c:v>
                </c:pt>
                <c:pt idx="29">
                  <c:v>1.0040819707960664</c:v>
                </c:pt>
                <c:pt idx="30">
                  <c:v>1.0084191846653361</c:v>
                </c:pt>
                <c:pt idx="31">
                  <c:v>1.0105609040725965</c:v>
                </c:pt>
                <c:pt idx="32">
                  <c:v>1.0147140696155621</c:v>
                </c:pt>
                <c:pt idx="33">
                  <c:v>1.012672427012506</c:v>
                </c:pt>
                <c:pt idx="34">
                  <c:v>1.0097073528370284</c:v>
                </c:pt>
                <c:pt idx="35">
                  <c:v>1.0056406752974929</c:v>
                </c:pt>
                <c:pt idx="36">
                  <c:v>1.002354220572093</c:v>
                </c:pt>
                <c:pt idx="37">
                  <c:v>1.0102938571565538</c:v>
                </c:pt>
                <c:pt idx="38">
                  <c:v>1.0114497307739734</c:v>
                </c:pt>
                <c:pt idx="39">
                  <c:v>1.0100234012599534</c:v>
                </c:pt>
                <c:pt idx="40">
                  <c:v>1.0096537272135442</c:v>
                </c:pt>
                <c:pt idx="41">
                  <c:v>1.0062741810303402</c:v>
                </c:pt>
                <c:pt idx="42">
                  <c:v>1.0095924592656822</c:v>
                </c:pt>
                <c:pt idx="43">
                  <c:v>1.0135580823372379</c:v>
                </c:pt>
                <c:pt idx="44">
                  <c:v>1.0085109108825185</c:v>
                </c:pt>
                <c:pt idx="45">
                  <c:v>1.0077844099145588</c:v>
                </c:pt>
                <c:pt idx="46">
                  <c:v>1.0114644010601928</c:v>
                </c:pt>
                <c:pt idx="47">
                  <c:v>1.010823455352835</c:v>
                </c:pt>
                <c:pt idx="48">
                  <c:v>1.0140752432629994</c:v>
                </c:pt>
                <c:pt idx="49">
                  <c:v>1.0188069358171257</c:v>
                </c:pt>
                <c:pt idx="50">
                  <c:v>1.0106565001366778</c:v>
                </c:pt>
                <c:pt idx="51">
                  <c:v>1.0111922099380075</c:v>
                </c:pt>
                <c:pt idx="52">
                  <c:v>1.0107517286358259</c:v>
                </c:pt>
                <c:pt idx="53">
                  <c:v>1.0069044407056831</c:v>
                </c:pt>
                <c:pt idx="54">
                  <c:v>1.0116941422485317</c:v>
                </c:pt>
                <c:pt idx="55">
                  <c:v>1.005015296558984</c:v>
                </c:pt>
                <c:pt idx="56">
                  <c:v>1.0062465347113947</c:v>
                </c:pt>
                <c:pt idx="57">
                  <c:v>1.0073135344833852</c:v>
                </c:pt>
                <c:pt idx="58">
                  <c:v>1.006609565525274</c:v>
                </c:pt>
                <c:pt idx="59">
                  <c:v>1.0055848141635424</c:v>
                </c:pt>
                <c:pt idx="60">
                  <c:v>1.0046944192700862</c:v>
                </c:pt>
                <c:pt idx="61">
                  <c:v>1.0025730074072579</c:v>
                </c:pt>
                <c:pt idx="62">
                  <c:v>0.99552476566131731</c:v>
                </c:pt>
                <c:pt idx="63">
                  <c:v>0.99783567468628465</c:v>
                </c:pt>
                <c:pt idx="64">
                  <c:v>0.99735477457055066</c:v>
                </c:pt>
                <c:pt idx="65">
                  <c:v>0.9959336910686245</c:v>
                </c:pt>
                <c:pt idx="66">
                  <c:v>1.0023541912453102</c:v>
                </c:pt>
                <c:pt idx="67">
                  <c:v>0.99847626409133761</c:v>
                </c:pt>
                <c:pt idx="68">
                  <c:v>1.0059530656172804</c:v>
                </c:pt>
                <c:pt idx="69">
                  <c:v>0.99842895331153669</c:v>
                </c:pt>
                <c:pt idx="70">
                  <c:v>1.002856649190256</c:v>
                </c:pt>
                <c:pt idx="71">
                  <c:v>1.0019701518920718</c:v>
                </c:pt>
                <c:pt idx="72">
                  <c:v>0.99860553989137368</c:v>
                </c:pt>
                <c:pt idx="73">
                  <c:v>1.000060070078256</c:v>
                </c:pt>
                <c:pt idx="74">
                  <c:v>1.0020089882312839</c:v>
                </c:pt>
                <c:pt idx="75">
                  <c:v>1.002469313082371</c:v>
                </c:pt>
                <c:pt idx="76">
                  <c:v>1.0086127068935065</c:v>
                </c:pt>
                <c:pt idx="77">
                  <c:v>1.0087336908805944</c:v>
                </c:pt>
                <c:pt idx="78">
                  <c:v>1.0086725228848537</c:v>
                </c:pt>
                <c:pt idx="79">
                  <c:v>1.0022677035970264</c:v>
                </c:pt>
                <c:pt idx="80">
                  <c:v>1.0050053663722582</c:v>
                </c:pt>
                <c:pt idx="81">
                  <c:v>0.99610459199594148</c:v>
                </c:pt>
                <c:pt idx="82">
                  <c:v>1.001325434810814</c:v>
                </c:pt>
                <c:pt idx="83">
                  <c:v>0.99625845135676139</c:v>
                </c:pt>
                <c:pt idx="84">
                  <c:v>0.99317057444276369</c:v>
                </c:pt>
                <c:pt idx="85">
                  <c:v>1.0038147323462492</c:v>
                </c:pt>
                <c:pt idx="86">
                  <c:v>1.0025367978614175</c:v>
                </c:pt>
                <c:pt idx="87">
                  <c:v>1.0036561114205482</c:v>
                </c:pt>
                <c:pt idx="88">
                  <c:v>1.0011927461558132</c:v>
                </c:pt>
                <c:pt idx="89">
                  <c:v>1.0005690240573697</c:v>
                </c:pt>
                <c:pt idx="90">
                  <c:v>0.99920149621457122</c:v>
                </c:pt>
                <c:pt idx="91">
                  <c:v>0.99956370335858924</c:v>
                </c:pt>
                <c:pt idx="92">
                  <c:v>1.0019133510873095</c:v>
                </c:pt>
                <c:pt idx="93">
                  <c:v>1.0005012577609615</c:v>
                </c:pt>
                <c:pt idx="94">
                  <c:v>1.0019063429992692</c:v>
                </c:pt>
                <c:pt idx="95">
                  <c:v>1.00374316108341</c:v>
                </c:pt>
                <c:pt idx="96">
                  <c:v>1.00748766439958</c:v>
                </c:pt>
                <c:pt idx="97">
                  <c:v>1.0066333219139021</c:v>
                </c:pt>
                <c:pt idx="98">
                  <c:v>0.99979291162195927</c:v>
                </c:pt>
                <c:pt idx="99">
                  <c:v>1.0013048346624074</c:v>
                </c:pt>
                <c:pt idx="100">
                  <c:v>1.0006815057064204</c:v>
                </c:pt>
                <c:pt idx="101">
                  <c:v>1.0045952802903588</c:v>
                </c:pt>
                <c:pt idx="102">
                  <c:v>0.99952043503672849</c:v>
                </c:pt>
                <c:pt idx="103">
                  <c:v>1.0017981489546592</c:v>
                </c:pt>
                <c:pt idx="104">
                  <c:v>1.0044281625727529</c:v>
                </c:pt>
                <c:pt idx="105">
                  <c:v>1.0012609626272231</c:v>
                </c:pt>
                <c:pt idx="106">
                  <c:v>1.0062029591773141</c:v>
                </c:pt>
                <c:pt idx="107">
                  <c:v>1.0070907249757441</c:v>
                </c:pt>
                <c:pt idx="108">
                  <c:v>1.0054249419460979</c:v>
                </c:pt>
                <c:pt idx="109">
                  <c:v>1.0046370509269431</c:v>
                </c:pt>
                <c:pt idx="110">
                  <c:v>1.0073739798150407</c:v>
                </c:pt>
                <c:pt idx="111">
                  <c:v>1.005392117395459</c:v>
                </c:pt>
                <c:pt idx="112">
                  <c:v>1.0046001819155945</c:v>
                </c:pt>
                <c:pt idx="113">
                  <c:v>1.0050641137668013</c:v>
                </c:pt>
                <c:pt idx="114">
                  <c:v>1.0052921986493919</c:v>
                </c:pt>
                <c:pt idx="115">
                  <c:v>1.0076545113964095</c:v>
                </c:pt>
                <c:pt idx="116">
                  <c:v>1.0044830177054225</c:v>
                </c:pt>
                <c:pt idx="117">
                  <c:v>1.0021048117626368</c:v>
                </c:pt>
                <c:pt idx="118">
                  <c:v>1.0018833386528312</c:v>
                </c:pt>
                <c:pt idx="119">
                  <c:v>0.99429231070333757</c:v>
                </c:pt>
                <c:pt idx="120">
                  <c:v>0.99451601363038367</c:v>
                </c:pt>
                <c:pt idx="121">
                  <c:v>0.99623189190848183</c:v>
                </c:pt>
                <c:pt idx="122">
                  <c:v>0.99169346996000651</c:v>
                </c:pt>
                <c:pt idx="123">
                  <c:v>0.98781889165826697</c:v>
                </c:pt>
                <c:pt idx="124">
                  <c:v>0.98780213246644366</c:v>
                </c:pt>
                <c:pt idx="125">
                  <c:v>0.99438702582332805</c:v>
                </c:pt>
                <c:pt idx="126">
                  <c:v>0.9934120264494225</c:v>
                </c:pt>
                <c:pt idx="127">
                  <c:v>0.99261107741707544</c:v>
                </c:pt>
                <c:pt idx="128">
                  <c:v>0.98868760293055469</c:v>
                </c:pt>
                <c:pt idx="129">
                  <c:v>0.9887509391614927</c:v>
                </c:pt>
                <c:pt idx="130">
                  <c:v>0.98607065080891243</c:v>
                </c:pt>
                <c:pt idx="131">
                  <c:v>0.98286054605849271</c:v>
                </c:pt>
                <c:pt idx="132">
                  <c:v>0.97774853264134842</c:v>
                </c:pt>
                <c:pt idx="133">
                  <c:v>0.98102313257541229</c:v>
                </c:pt>
                <c:pt idx="134">
                  <c:v>0.97441403657334968</c:v>
                </c:pt>
                <c:pt idx="135">
                  <c:v>0.97634861660164118</c:v>
                </c:pt>
                <c:pt idx="136">
                  <c:v>0.9815076711951255</c:v>
                </c:pt>
                <c:pt idx="137">
                  <c:v>0.97878748483211853</c:v>
                </c:pt>
                <c:pt idx="138">
                  <c:v>0.97286862334307234</c:v>
                </c:pt>
                <c:pt idx="139">
                  <c:v>0.97089633429578925</c:v>
                </c:pt>
                <c:pt idx="140">
                  <c:v>0.96489832654205032</c:v>
                </c:pt>
                <c:pt idx="141">
                  <c:v>0.9650956812442516</c:v>
                </c:pt>
                <c:pt idx="142">
                  <c:v>0.9611152476801188</c:v>
                </c:pt>
                <c:pt idx="143">
                  <c:v>0.96080061899740332</c:v>
                </c:pt>
                <c:pt idx="144">
                  <c:v>0.95812154470878863</c:v>
                </c:pt>
                <c:pt idx="145">
                  <c:v>0.95379058365016534</c:v>
                </c:pt>
                <c:pt idx="146">
                  <c:v>0.94646538360082699</c:v>
                </c:pt>
                <c:pt idx="147">
                  <c:v>0.94079814118028793</c:v>
                </c:pt>
                <c:pt idx="148">
                  <c:v>0.93549575191079271</c:v>
                </c:pt>
                <c:pt idx="149">
                  <c:v>0.92910628181020438</c:v>
                </c:pt>
                <c:pt idx="150">
                  <c:v>0.92750471382825161</c:v>
                </c:pt>
                <c:pt idx="151">
                  <c:v>0.92067945348016755</c:v>
                </c:pt>
                <c:pt idx="152">
                  <c:v>0.91264300436665025</c:v>
                </c:pt>
                <c:pt idx="153">
                  <c:v>0.90978181087874688</c:v>
                </c:pt>
                <c:pt idx="154">
                  <c:v>0.90186615682227766</c:v>
                </c:pt>
                <c:pt idx="155">
                  <c:v>0.8980651750320704</c:v>
                </c:pt>
                <c:pt idx="156">
                  <c:v>0.89179745699937163</c:v>
                </c:pt>
                <c:pt idx="157">
                  <c:v>0.89295296506792132</c:v>
                </c:pt>
                <c:pt idx="158">
                  <c:v>0.89540912499181358</c:v>
                </c:pt>
                <c:pt idx="159">
                  <c:v>0.88986293930170579</c:v>
                </c:pt>
                <c:pt idx="160">
                  <c:v>0.88659746441713372</c:v>
                </c:pt>
                <c:pt idx="161">
                  <c:v>0.8842843988391681</c:v>
                </c:pt>
                <c:pt idx="162">
                  <c:v>0.8800653587886077</c:v>
                </c:pt>
                <c:pt idx="163">
                  <c:v>0.87371823855824482</c:v>
                </c:pt>
                <c:pt idx="164">
                  <c:v>0.86953543096611829</c:v>
                </c:pt>
                <c:pt idx="165">
                  <c:v>0.86461818818607949</c:v>
                </c:pt>
                <c:pt idx="166">
                  <c:v>0.8594517881044238</c:v>
                </c:pt>
                <c:pt idx="167">
                  <c:v>0.85827915374865182</c:v>
                </c:pt>
                <c:pt idx="168">
                  <c:v>0.8550448525747345</c:v>
                </c:pt>
                <c:pt idx="169">
                  <c:v>0.8499946204334865</c:v>
                </c:pt>
                <c:pt idx="170">
                  <c:v>0.84301622840119605</c:v>
                </c:pt>
                <c:pt idx="171">
                  <c:v>0.83543724464033509</c:v>
                </c:pt>
                <c:pt idx="172">
                  <c:v>0.83179826913180532</c:v>
                </c:pt>
                <c:pt idx="173">
                  <c:v>0.83278968354483363</c:v>
                </c:pt>
                <c:pt idx="174">
                  <c:v>0.8253046338875355</c:v>
                </c:pt>
                <c:pt idx="175">
                  <c:v>0.82129178945939074</c:v>
                </c:pt>
                <c:pt idx="176">
                  <c:v>0.82069813618097887</c:v>
                </c:pt>
                <c:pt idx="177">
                  <c:v>0.81877806675641862</c:v>
                </c:pt>
                <c:pt idx="178">
                  <c:v>0.81848300813066732</c:v>
                </c:pt>
                <c:pt idx="179">
                  <c:v>0.81603810592975778</c:v>
                </c:pt>
                <c:pt idx="180">
                  <c:v>0.8134192057803904</c:v>
                </c:pt>
                <c:pt idx="181">
                  <c:v>0.80785356841530809</c:v>
                </c:pt>
                <c:pt idx="182">
                  <c:v>0.81072361821482064</c:v>
                </c:pt>
                <c:pt idx="183">
                  <c:v>0.81443463049681963</c:v>
                </c:pt>
                <c:pt idx="184">
                  <c:v>0.81576025535189434</c:v>
                </c:pt>
                <c:pt idx="185">
                  <c:v>0.81678266761839025</c:v>
                </c:pt>
                <c:pt idx="186">
                  <c:v>0.8091834911486393</c:v>
                </c:pt>
                <c:pt idx="187">
                  <c:v>0.81303283323181463</c:v>
                </c:pt>
                <c:pt idx="188">
                  <c:v>0.80802436655817189</c:v>
                </c:pt>
                <c:pt idx="189">
                  <c:v>0.80933582238216684</c:v>
                </c:pt>
                <c:pt idx="190">
                  <c:v>0.81143535715663839</c:v>
                </c:pt>
                <c:pt idx="191">
                  <c:v>0.8142825280800966</c:v>
                </c:pt>
                <c:pt idx="192">
                  <c:v>0.8111486127439208</c:v>
                </c:pt>
                <c:pt idx="193">
                  <c:v>0.80943849690554481</c:v>
                </c:pt>
                <c:pt idx="194">
                  <c:v>0.8071725183665841</c:v>
                </c:pt>
                <c:pt idx="195">
                  <c:v>0.80578702261023771</c:v>
                </c:pt>
                <c:pt idx="196">
                  <c:v>0.80561163673492164</c:v>
                </c:pt>
                <c:pt idx="197">
                  <c:v>0.80002109034968483</c:v>
                </c:pt>
                <c:pt idx="198">
                  <c:v>0.80095414630491113</c:v>
                </c:pt>
                <c:pt idx="199">
                  <c:v>0.81000555879866298</c:v>
                </c:pt>
                <c:pt idx="200">
                  <c:v>0.80428143858852008</c:v>
                </c:pt>
                <c:pt idx="201">
                  <c:v>0.80344434792674668</c:v>
                </c:pt>
                <c:pt idx="202">
                  <c:v>0.80022972617074373</c:v>
                </c:pt>
                <c:pt idx="203">
                  <c:v>0.79677949371410206</c:v>
                </c:pt>
                <c:pt idx="204">
                  <c:v>0.79452170247859089</c:v>
                </c:pt>
                <c:pt idx="205">
                  <c:v>0.80007041127253875</c:v>
                </c:pt>
                <c:pt idx="206">
                  <c:v>0.79995832842391035</c:v>
                </c:pt>
                <c:pt idx="207">
                  <c:v>0.80421635483479348</c:v>
                </c:pt>
                <c:pt idx="208">
                  <c:v>0.80260884177133351</c:v>
                </c:pt>
                <c:pt idx="209">
                  <c:v>0.79776590910727119</c:v>
                </c:pt>
                <c:pt idx="210">
                  <c:v>0.80630000877218599</c:v>
                </c:pt>
                <c:pt idx="211">
                  <c:v>0.80108359523495709</c:v>
                </c:pt>
                <c:pt idx="212">
                  <c:v>0.79799397727926302</c:v>
                </c:pt>
                <c:pt idx="213">
                  <c:v>0.80143298226954129</c:v>
                </c:pt>
                <c:pt idx="214">
                  <c:v>0.80449818994260913</c:v>
                </c:pt>
                <c:pt idx="215">
                  <c:v>0.80489742190764069</c:v>
                </c:pt>
                <c:pt idx="216">
                  <c:v>0.80605323987759614</c:v>
                </c:pt>
                <c:pt idx="217">
                  <c:v>0.80450806568732958</c:v>
                </c:pt>
                <c:pt idx="218">
                  <c:v>0.80179300321777824</c:v>
                </c:pt>
                <c:pt idx="219">
                  <c:v>0.8094844839653339</c:v>
                </c:pt>
                <c:pt idx="220">
                  <c:v>0.80738798456227567</c:v>
                </c:pt>
                <c:pt idx="221">
                  <c:v>0.80969157248592438</c:v>
                </c:pt>
                <c:pt idx="222">
                  <c:v>0.80491700830738699</c:v>
                </c:pt>
                <c:pt idx="223">
                  <c:v>0.80150773927788488</c:v>
                </c:pt>
                <c:pt idx="224">
                  <c:v>0.80759723884950374</c:v>
                </c:pt>
                <c:pt idx="225">
                  <c:v>0.80533166176158832</c:v>
                </c:pt>
                <c:pt idx="226">
                  <c:v>0.81102492833935291</c:v>
                </c:pt>
                <c:pt idx="227">
                  <c:v>0.81300365085720416</c:v>
                </c:pt>
                <c:pt idx="228">
                  <c:v>0.80867846753866834</c:v>
                </c:pt>
                <c:pt idx="229">
                  <c:v>0.80597711559071972</c:v>
                </c:pt>
                <c:pt idx="230">
                  <c:v>0.80451697844027248</c:v>
                </c:pt>
                <c:pt idx="231">
                  <c:v>0.80589526264428946</c:v>
                </c:pt>
                <c:pt idx="232">
                  <c:v>0.7997679053245792</c:v>
                </c:pt>
                <c:pt idx="233">
                  <c:v>0.8066307443644477</c:v>
                </c:pt>
                <c:pt idx="234">
                  <c:v>0.80368476274907985</c:v>
                </c:pt>
                <c:pt idx="235">
                  <c:v>0.80847514789268737</c:v>
                </c:pt>
                <c:pt idx="236">
                  <c:v>0.8083985850899913</c:v>
                </c:pt>
                <c:pt idx="237">
                  <c:v>0.80325049992469577</c:v>
                </c:pt>
                <c:pt idx="238">
                  <c:v>0.80743957280330669</c:v>
                </c:pt>
                <c:pt idx="239">
                  <c:v>0.80496913340292453</c:v>
                </c:pt>
                <c:pt idx="240">
                  <c:v>0.80285522823556377</c:v>
                </c:pt>
                <c:pt idx="241">
                  <c:v>0.81097621316447899</c:v>
                </c:pt>
                <c:pt idx="242">
                  <c:v>0.81649059459679363</c:v>
                </c:pt>
                <c:pt idx="243">
                  <c:v>0.81420814111406148</c:v>
                </c:pt>
                <c:pt idx="244">
                  <c:v>0.81646656585200694</c:v>
                </c:pt>
                <c:pt idx="245">
                  <c:v>0.81334777886646259</c:v>
                </c:pt>
                <c:pt idx="246">
                  <c:v>0.80822692207768343</c:v>
                </c:pt>
                <c:pt idx="247">
                  <c:v>0.81252669507888453</c:v>
                </c:pt>
                <c:pt idx="248">
                  <c:v>0.81687961460376046</c:v>
                </c:pt>
                <c:pt idx="249">
                  <c:v>0.82076557327577349</c:v>
                </c:pt>
                <c:pt idx="250">
                  <c:v>0.82231225379642536</c:v>
                </c:pt>
                <c:pt idx="251">
                  <c:v>0.821234492831729</c:v>
                </c:pt>
                <c:pt idx="252">
                  <c:v>0.82282951406676963</c:v>
                </c:pt>
                <c:pt idx="253">
                  <c:v>0.82742687231711975</c:v>
                </c:pt>
                <c:pt idx="254">
                  <c:v>0.8181041161462046</c:v>
                </c:pt>
                <c:pt idx="255">
                  <c:v>0.82138427722816931</c:v>
                </c:pt>
                <c:pt idx="256">
                  <c:v>0.82726255346515498</c:v>
                </c:pt>
                <c:pt idx="257">
                  <c:v>0.82747913170165799</c:v>
                </c:pt>
                <c:pt idx="258">
                  <c:v>0.83215206656345664</c:v>
                </c:pt>
                <c:pt idx="259">
                  <c:v>0.83060361740011623</c:v>
                </c:pt>
                <c:pt idx="260">
                  <c:v>0.82949929192529481</c:v>
                </c:pt>
                <c:pt idx="261">
                  <c:v>0.82771003716528491</c:v>
                </c:pt>
                <c:pt idx="262">
                  <c:v>0.82669907924712638</c:v>
                </c:pt>
                <c:pt idx="263">
                  <c:v>0.82718697737883773</c:v>
                </c:pt>
                <c:pt idx="264">
                  <c:v>0.8308182943166601</c:v>
                </c:pt>
                <c:pt idx="265">
                  <c:v>0.83179473031687767</c:v>
                </c:pt>
                <c:pt idx="266">
                  <c:v>0.83004570358100138</c:v>
                </c:pt>
                <c:pt idx="267">
                  <c:v>0.83528298606997886</c:v>
                </c:pt>
                <c:pt idx="268">
                  <c:v>0.83164382074312948</c:v>
                </c:pt>
                <c:pt idx="269">
                  <c:v>0.83315848290360683</c:v>
                </c:pt>
                <c:pt idx="270">
                  <c:v>0.83285479627726466</c:v>
                </c:pt>
                <c:pt idx="271">
                  <c:v>0.83572107544889573</c:v>
                </c:pt>
                <c:pt idx="272">
                  <c:v>0.83661840053476633</c:v>
                </c:pt>
                <c:pt idx="273">
                  <c:v>0.84077834185425659</c:v>
                </c:pt>
                <c:pt idx="274">
                  <c:v>0.84254188372896155</c:v>
                </c:pt>
                <c:pt idx="275">
                  <c:v>0.84364743704493395</c:v>
                </c:pt>
                <c:pt idx="276">
                  <c:v>0.84496206185933642</c:v>
                </c:pt>
                <c:pt idx="277">
                  <c:v>0.84007431922990961</c:v>
                </c:pt>
                <c:pt idx="278">
                  <c:v>0.83672932469094963</c:v>
                </c:pt>
                <c:pt idx="279">
                  <c:v>0.83886626276767862</c:v>
                </c:pt>
                <c:pt idx="280">
                  <c:v>0.84619112778580363</c:v>
                </c:pt>
                <c:pt idx="281">
                  <c:v>0.84886120744014026</c:v>
                </c:pt>
                <c:pt idx="282">
                  <c:v>0.84893506107072692</c:v>
                </c:pt>
                <c:pt idx="283">
                  <c:v>0.85093857224269664</c:v>
                </c:pt>
                <c:pt idx="284">
                  <c:v>0.84984318132051662</c:v>
                </c:pt>
                <c:pt idx="285">
                  <c:v>0.85605661309680658</c:v>
                </c:pt>
                <c:pt idx="286">
                  <c:v>0.85954837271524442</c:v>
                </c:pt>
                <c:pt idx="287">
                  <c:v>0.86229811191008532</c:v>
                </c:pt>
                <c:pt idx="288">
                  <c:v>0.86511905114344045</c:v>
                </c:pt>
                <c:pt idx="289">
                  <c:v>0.86847789363600736</c:v>
                </c:pt>
                <c:pt idx="290">
                  <c:v>0.87475732666455863</c:v>
                </c:pt>
                <c:pt idx="291">
                  <c:v>0.88019641762507816</c:v>
                </c:pt>
                <c:pt idx="292">
                  <c:v>0.87716781650104891</c:v>
                </c:pt>
                <c:pt idx="293">
                  <c:v>0.87903210069163251</c:v>
                </c:pt>
                <c:pt idx="294">
                  <c:v>0.88120791429793166</c:v>
                </c:pt>
                <c:pt idx="295">
                  <c:v>0.88095728265603612</c:v>
                </c:pt>
                <c:pt idx="296">
                  <c:v>0.88923133609277971</c:v>
                </c:pt>
                <c:pt idx="297">
                  <c:v>0.89210522139159765</c:v>
                </c:pt>
                <c:pt idx="298">
                  <c:v>0.89324102435757546</c:v>
                </c:pt>
                <c:pt idx="299">
                  <c:v>0.8892161941985568</c:v>
                </c:pt>
                <c:pt idx="300">
                  <c:v>0.88881843495610113</c:v>
                </c:pt>
                <c:pt idx="301">
                  <c:v>0.89232282477378166</c:v>
                </c:pt>
                <c:pt idx="302">
                  <c:v>0.8887964900366222</c:v>
                </c:pt>
                <c:pt idx="303">
                  <c:v>0.88737212730722625</c:v>
                </c:pt>
                <c:pt idx="304">
                  <c:v>0.88494337746371965</c:v>
                </c:pt>
                <c:pt idx="305">
                  <c:v>0.89370574271488334</c:v>
                </c:pt>
                <c:pt idx="306">
                  <c:v>0.88734808719049163</c:v>
                </c:pt>
                <c:pt idx="307">
                  <c:v>0.89002976090362396</c:v>
                </c:pt>
                <c:pt idx="308">
                  <c:v>0.89548508783635339</c:v>
                </c:pt>
                <c:pt idx="309">
                  <c:v>0.89227362080816053</c:v>
                </c:pt>
                <c:pt idx="310">
                  <c:v>0.8976883313854106</c:v>
                </c:pt>
                <c:pt idx="311">
                  <c:v>0.89921478553653722</c:v>
                </c:pt>
                <c:pt idx="312">
                  <c:v>0.90570042657189775</c:v>
                </c:pt>
                <c:pt idx="313">
                  <c:v>0.90744013994106232</c:v>
                </c:pt>
                <c:pt idx="314">
                  <c:v>0.90666426152601276</c:v>
                </c:pt>
                <c:pt idx="315">
                  <c:v>0.91231923374923618</c:v>
                </c:pt>
                <c:pt idx="316">
                  <c:v>0.91592524033876765</c:v>
                </c:pt>
                <c:pt idx="317">
                  <c:v>0.92065992334071933</c:v>
                </c:pt>
                <c:pt idx="318">
                  <c:v>0.91873329224464895</c:v>
                </c:pt>
                <c:pt idx="319">
                  <c:v>0.9274979746396147</c:v>
                </c:pt>
                <c:pt idx="320">
                  <c:v>0.92541569195344742</c:v>
                </c:pt>
                <c:pt idx="321">
                  <c:v>0.92837215414028806</c:v>
                </c:pt>
                <c:pt idx="322">
                  <c:v>0.92678791534240068</c:v>
                </c:pt>
                <c:pt idx="323">
                  <c:v>0.92446114481693076</c:v>
                </c:pt>
                <c:pt idx="324">
                  <c:v>0.92757319259626758</c:v>
                </c:pt>
                <c:pt idx="325">
                  <c:v>0.92792550164716103</c:v>
                </c:pt>
                <c:pt idx="326">
                  <c:v>0.92833622592443765</c:v>
                </c:pt>
                <c:pt idx="327">
                  <c:v>0.93198112142375189</c:v>
                </c:pt>
                <c:pt idx="328">
                  <c:v>0.93149439785484944</c:v>
                </c:pt>
                <c:pt idx="329">
                  <c:v>0.93429950576269738</c:v>
                </c:pt>
                <c:pt idx="330">
                  <c:v>0.93409689782382477</c:v>
                </c:pt>
                <c:pt idx="331">
                  <c:v>0.93613362284436719</c:v>
                </c:pt>
                <c:pt idx="332">
                  <c:v>0.93382032390646397</c:v>
                </c:pt>
                <c:pt idx="333">
                  <c:v>0.9362610869438116</c:v>
                </c:pt>
                <c:pt idx="334">
                  <c:v>0.9323842456702145</c:v>
                </c:pt>
                <c:pt idx="335">
                  <c:v>0.93892988653698772</c:v>
                </c:pt>
                <c:pt idx="336">
                  <c:v>0.93612858266339016</c:v>
                </c:pt>
                <c:pt idx="337">
                  <c:v>0.93750713086114379</c:v>
                </c:pt>
                <c:pt idx="338">
                  <c:v>0.93618464559643166</c:v>
                </c:pt>
                <c:pt idx="339">
                  <c:v>0.93513379539064856</c:v>
                </c:pt>
                <c:pt idx="340">
                  <c:v>0.93184796508986578</c:v>
                </c:pt>
                <c:pt idx="341">
                  <c:v>0.93501710039898545</c:v>
                </c:pt>
                <c:pt idx="342">
                  <c:v>0.93691511191140819</c:v>
                </c:pt>
                <c:pt idx="343">
                  <c:v>0.93785411041313604</c:v>
                </c:pt>
                <c:pt idx="344">
                  <c:v>0.93646111175153257</c:v>
                </c:pt>
                <c:pt idx="345">
                  <c:v>0.93810169318542791</c:v>
                </c:pt>
                <c:pt idx="346">
                  <c:v>0.9373836243771041</c:v>
                </c:pt>
                <c:pt idx="347">
                  <c:v>0.9363995548055376</c:v>
                </c:pt>
                <c:pt idx="348">
                  <c:v>0.93343368985023178</c:v>
                </c:pt>
                <c:pt idx="349">
                  <c:v>0.94135056305126241</c:v>
                </c:pt>
                <c:pt idx="350">
                  <c:v>0.94143174991628886</c:v>
                </c:pt>
                <c:pt idx="351">
                  <c:v>0.94437783500219763</c:v>
                </c:pt>
                <c:pt idx="352">
                  <c:v>0.9471024251934208</c:v>
                </c:pt>
                <c:pt idx="353">
                  <c:v>0.95180746545231476</c:v>
                </c:pt>
                <c:pt idx="354">
                  <c:v>0.95241296773122797</c:v>
                </c:pt>
                <c:pt idx="355">
                  <c:v>0.94839033245877635</c:v>
                </c:pt>
                <c:pt idx="356">
                  <c:v>0.94840082734862863</c:v>
                </c:pt>
                <c:pt idx="357">
                  <c:v>0.95426931811335591</c:v>
                </c:pt>
                <c:pt idx="358">
                  <c:v>0.95158830815647366</c:v>
                </c:pt>
                <c:pt idx="359">
                  <c:v>0.95048856160458339</c:v>
                </c:pt>
                <c:pt idx="360">
                  <c:v>0.95462952494253239</c:v>
                </c:pt>
                <c:pt idx="361">
                  <c:v>0.95623420264893455</c:v>
                </c:pt>
                <c:pt idx="362">
                  <c:v>0.95207855535498931</c:v>
                </c:pt>
                <c:pt idx="363">
                  <c:v>0.94897576630445235</c:v>
                </c:pt>
                <c:pt idx="364">
                  <c:v>0.94574398999052167</c:v>
                </c:pt>
                <c:pt idx="365">
                  <c:v>0.94557242570953048</c:v>
                </c:pt>
                <c:pt idx="366">
                  <c:v>0.9466435595439654</c:v>
                </c:pt>
                <c:pt idx="367">
                  <c:v>0.9493580472159</c:v>
                </c:pt>
                <c:pt idx="368">
                  <c:v>0.9524235774119556</c:v>
                </c:pt>
                <c:pt idx="369">
                  <c:v>0.95416577911283962</c:v>
                </c:pt>
                <c:pt idx="370">
                  <c:v>0.95753241967151603</c:v>
                </c:pt>
                <c:pt idx="371">
                  <c:v>0.96433210124237678</c:v>
                </c:pt>
                <c:pt idx="372">
                  <c:v>0.97055004617742324</c:v>
                </c:pt>
                <c:pt idx="373">
                  <c:v>0.9708622630085616</c:v>
                </c:pt>
                <c:pt idx="374">
                  <c:v>0.9714807091249319</c:v>
                </c:pt>
                <c:pt idx="375">
                  <c:v>0.97450142451838384</c:v>
                </c:pt>
                <c:pt idx="376">
                  <c:v>0.97660767537294768</c:v>
                </c:pt>
                <c:pt idx="377">
                  <c:v>0.98046296475279882</c:v>
                </c:pt>
                <c:pt idx="378">
                  <c:v>0.98282656535657509</c:v>
                </c:pt>
                <c:pt idx="379">
                  <c:v>0.98221023708010924</c:v>
                </c:pt>
                <c:pt idx="380">
                  <c:v>0.98071500022297409</c:v>
                </c:pt>
                <c:pt idx="381">
                  <c:v>0.98272285992608477</c:v>
                </c:pt>
                <c:pt idx="382">
                  <c:v>0.9819516827350907</c:v>
                </c:pt>
                <c:pt idx="383">
                  <c:v>0.97515518992200578</c:v>
                </c:pt>
                <c:pt idx="384">
                  <c:v>0.97171523663465298</c:v>
                </c:pt>
                <c:pt idx="385">
                  <c:v>0.97114326900832182</c:v>
                </c:pt>
                <c:pt idx="386">
                  <c:v>0.97228552584147043</c:v>
                </c:pt>
                <c:pt idx="387">
                  <c:v>0.97667712378314564</c:v>
                </c:pt>
                <c:pt idx="388">
                  <c:v>0.98223159127487425</c:v>
                </c:pt>
                <c:pt idx="389">
                  <c:v>0.98314299373907577</c:v>
                </c:pt>
                <c:pt idx="390">
                  <c:v>0.9809420625566635</c:v>
                </c:pt>
                <c:pt idx="391">
                  <c:v>0.98374431951528074</c:v>
                </c:pt>
                <c:pt idx="392">
                  <c:v>0.98608010682030156</c:v>
                </c:pt>
                <c:pt idx="393">
                  <c:v>0.98251240081701885</c:v>
                </c:pt>
                <c:pt idx="394">
                  <c:v>0.98229570994040727</c:v>
                </c:pt>
                <c:pt idx="395">
                  <c:v>0.98555077323493401</c:v>
                </c:pt>
                <c:pt idx="396">
                  <c:v>0.99132263641028462</c:v>
                </c:pt>
                <c:pt idx="397">
                  <c:v>0.98807914516709627</c:v>
                </c:pt>
                <c:pt idx="398">
                  <c:v>0.98999743075468183</c:v>
                </c:pt>
                <c:pt idx="399">
                  <c:v>0.99641230506682366</c:v>
                </c:pt>
                <c:pt idx="400">
                  <c:v>0.99113091001231657</c:v>
                </c:pt>
                <c:pt idx="401">
                  <c:v>0.99030100432363133</c:v>
                </c:pt>
                <c:pt idx="402">
                  <c:v>0.99688878951089488</c:v>
                </c:pt>
                <c:pt idx="403">
                  <c:v>1.002602140135139</c:v>
                </c:pt>
                <c:pt idx="404">
                  <c:v>1.0043426943625409</c:v>
                </c:pt>
                <c:pt idx="405">
                  <c:v>0.99854687630739769</c:v>
                </c:pt>
                <c:pt idx="406">
                  <c:v>1.0034971951484735</c:v>
                </c:pt>
                <c:pt idx="407">
                  <c:v>1.0053931065116986</c:v>
                </c:pt>
                <c:pt idx="408">
                  <c:v>1.0043554756968525</c:v>
                </c:pt>
                <c:pt idx="409">
                  <c:v>1.0047199139618863</c:v>
                </c:pt>
                <c:pt idx="410">
                  <c:v>1.0097853109786428</c:v>
                </c:pt>
                <c:pt idx="411">
                  <c:v>1.0077754284735767</c:v>
                </c:pt>
                <c:pt idx="412">
                  <c:v>1.0017578201571309</c:v>
                </c:pt>
                <c:pt idx="413">
                  <c:v>1.0047279883516926</c:v>
                </c:pt>
                <c:pt idx="414">
                  <c:v>1.0058908821338912</c:v>
                </c:pt>
                <c:pt idx="415">
                  <c:v>1.0005791285571479</c:v>
                </c:pt>
                <c:pt idx="416">
                  <c:v>1.0001089914370269</c:v>
                </c:pt>
                <c:pt idx="417">
                  <c:v>0.99838768462345839</c:v>
                </c:pt>
                <c:pt idx="418">
                  <c:v>1.0043087237652981</c:v>
                </c:pt>
                <c:pt idx="419">
                  <c:v>1.0067324760224348</c:v>
                </c:pt>
                <c:pt idx="420">
                  <c:v>1.0056236557063389</c:v>
                </c:pt>
                <c:pt idx="421">
                  <c:v>1.0088683535950116</c:v>
                </c:pt>
                <c:pt idx="422">
                  <c:v>1.0103730304970733</c:v>
                </c:pt>
                <c:pt idx="423">
                  <c:v>1.014704571155447</c:v>
                </c:pt>
                <c:pt idx="424">
                  <c:v>1.0170747958973532</c:v>
                </c:pt>
                <c:pt idx="425">
                  <c:v>1.0181629489683739</c:v>
                </c:pt>
                <c:pt idx="426">
                  <c:v>1.0186606962383156</c:v>
                </c:pt>
                <c:pt idx="427">
                  <c:v>1.0144500545918147</c:v>
                </c:pt>
                <c:pt idx="428">
                  <c:v>1.014207015988966</c:v>
                </c:pt>
                <c:pt idx="429">
                  <c:v>1.0139544367001561</c:v>
                </c:pt>
                <c:pt idx="430">
                  <c:v>1.0158097418123373</c:v>
                </c:pt>
                <c:pt idx="431">
                  <c:v>1.0168128939853383</c:v>
                </c:pt>
                <c:pt idx="432">
                  <c:v>1.0168222803187272</c:v>
                </c:pt>
                <c:pt idx="433">
                  <c:v>1.0196490884888643</c:v>
                </c:pt>
                <c:pt idx="434">
                  <c:v>1.0211801777534437</c:v>
                </c:pt>
                <c:pt idx="435">
                  <c:v>1.0171076859129549</c:v>
                </c:pt>
                <c:pt idx="436">
                  <c:v>1.012374146132083</c:v>
                </c:pt>
                <c:pt idx="437">
                  <c:v>1.0143132343290664</c:v>
                </c:pt>
                <c:pt idx="438">
                  <c:v>1.0176102922267598</c:v>
                </c:pt>
                <c:pt idx="439">
                  <c:v>1.0210579687856889</c:v>
                </c:pt>
                <c:pt idx="440">
                  <c:v>1.0217684817764219</c:v>
                </c:pt>
                <c:pt idx="441">
                  <c:v>1.023836743857959</c:v>
                </c:pt>
                <c:pt idx="442">
                  <c:v>1.0235443195775686</c:v>
                </c:pt>
                <c:pt idx="443">
                  <c:v>1.0172500300995009</c:v>
                </c:pt>
                <c:pt idx="444">
                  <c:v>1.0145044523775806</c:v>
                </c:pt>
                <c:pt idx="445">
                  <c:v>1.0106679048153266</c:v>
                </c:pt>
                <c:pt idx="446">
                  <c:v>1.0074654400858623</c:v>
                </c:pt>
                <c:pt idx="447">
                  <c:v>1.0041210780534218</c:v>
                </c:pt>
                <c:pt idx="448">
                  <c:v>1.0101545443963174</c:v>
                </c:pt>
                <c:pt idx="449">
                  <c:v>1.0140632846746418</c:v>
                </c:pt>
                <c:pt idx="450">
                  <c:v>1.0074498530965859</c:v>
                </c:pt>
                <c:pt idx="451">
                  <c:v>1.004212218771164</c:v>
                </c:pt>
                <c:pt idx="452">
                  <c:v>1.0011474146864439</c:v>
                </c:pt>
                <c:pt idx="453">
                  <c:v>1.0013564765677059</c:v>
                </c:pt>
                <c:pt idx="454">
                  <c:v>0.99996000077039737</c:v>
                </c:pt>
                <c:pt idx="455">
                  <c:v>1.0024840985060326</c:v>
                </c:pt>
                <c:pt idx="456">
                  <c:v>1.0062555490402145</c:v>
                </c:pt>
                <c:pt idx="457">
                  <c:v>1.0058792957782972</c:v>
                </c:pt>
                <c:pt idx="458">
                  <c:v>1.0108211998122378</c:v>
                </c:pt>
                <c:pt idx="459">
                  <c:v>1.0111989321318913</c:v>
                </c:pt>
                <c:pt idx="460">
                  <c:v>1.0117053055245728</c:v>
                </c:pt>
                <c:pt idx="461">
                  <c:v>1.011944644550131</c:v>
                </c:pt>
                <c:pt idx="462">
                  <c:v>1.0057315751758336</c:v>
                </c:pt>
                <c:pt idx="463">
                  <c:v>1.0112009337204748</c:v>
                </c:pt>
                <c:pt idx="464">
                  <c:v>1.0119291026783204</c:v>
                </c:pt>
                <c:pt idx="465">
                  <c:v>1.0140495457879606</c:v>
                </c:pt>
                <c:pt idx="466">
                  <c:v>1.0130833393974714</c:v>
                </c:pt>
                <c:pt idx="467">
                  <c:v>1.0175099963930114</c:v>
                </c:pt>
                <c:pt idx="468">
                  <c:v>1.012121961050062</c:v>
                </c:pt>
                <c:pt idx="469">
                  <c:v>1.0144021314378935</c:v>
                </c:pt>
                <c:pt idx="470">
                  <c:v>1.013724457000472</c:v>
                </c:pt>
                <c:pt idx="471">
                  <c:v>1.0129132686145312</c:v>
                </c:pt>
                <c:pt idx="472">
                  <c:v>1.0099429418857107</c:v>
                </c:pt>
                <c:pt idx="473">
                  <c:v>1.0078196096515346</c:v>
                </c:pt>
                <c:pt idx="474">
                  <c:v>1.007699689497443</c:v>
                </c:pt>
                <c:pt idx="475">
                  <c:v>1.0130840604117761</c:v>
                </c:pt>
                <c:pt idx="476">
                  <c:v>1.0061138899564421</c:v>
                </c:pt>
                <c:pt idx="477">
                  <c:v>1.007706445701013</c:v>
                </c:pt>
                <c:pt idx="478">
                  <c:v>1.0067445403337911</c:v>
                </c:pt>
                <c:pt idx="479">
                  <c:v>1.0063595008200072</c:v>
                </c:pt>
                <c:pt idx="480">
                  <c:v>1.003375645603841</c:v>
                </c:pt>
                <c:pt idx="481">
                  <c:v>1.0035139674578428</c:v>
                </c:pt>
                <c:pt idx="482">
                  <c:v>0.99948855269259962</c:v>
                </c:pt>
                <c:pt idx="483">
                  <c:v>0.99928550821660111</c:v>
                </c:pt>
                <c:pt idx="484">
                  <c:v>1.0017067153893187</c:v>
                </c:pt>
                <c:pt idx="485">
                  <c:v>1.0089346380963724</c:v>
                </c:pt>
                <c:pt idx="486">
                  <c:v>1.0136795553369042</c:v>
                </c:pt>
                <c:pt idx="487">
                  <c:v>1.0098710222375924</c:v>
                </c:pt>
                <c:pt idx="488">
                  <c:v>1.0062138332871642</c:v>
                </c:pt>
                <c:pt idx="489">
                  <c:v>1.0088398000327254</c:v>
                </c:pt>
                <c:pt idx="490">
                  <c:v>1.0089023224662041</c:v>
                </c:pt>
                <c:pt idx="491">
                  <c:v>1.0066595310501021</c:v>
                </c:pt>
                <c:pt idx="492">
                  <c:v>1.006079556188421</c:v>
                </c:pt>
                <c:pt idx="493">
                  <c:v>1.0068160973755138</c:v>
                </c:pt>
                <c:pt idx="494">
                  <c:v>1.0050924787742319</c:v>
                </c:pt>
                <c:pt idx="495">
                  <c:v>1.0090700024271257</c:v>
                </c:pt>
                <c:pt idx="496">
                  <c:v>1.0103963887924134</c:v>
                </c:pt>
                <c:pt idx="497">
                  <c:v>1.0098999259258206</c:v>
                </c:pt>
                <c:pt idx="498">
                  <c:v>1.007692320177245</c:v>
                </c:pt>
                <c:pt idx="499">
                  <c:v>1.0043989984429038</c:v>
                </c:pt>
                <c:pt idx="500">
                  <c:v>1.007356079811462</c:v>
                </c:pt>
                <c:pt idx="501">
                  <c:v>1.0115769639003982</c:v>
                </c:pt>
                <c:pt idx="502">
                  <c:v>1.0131470750060889</c:v>
                </c:pt>
                <c:pt idx="503">
                  <c:v>1.0107938328951804</c:v>
                </c:pt>
                <c:pt idx="504">
                  <c:v>1.0154177196503207</c:v>
                </c:pt>
                <c:pt idx="505">
                  <c:v>1.0181799878324482</c:v>
                </c:pt>
                <c:pt idx="506">
                  <c:v>1.0182425528291259</c:v>
                </c:pt>
                <c:pt idx="507">
                  <c:v>1.0191478751950773</c:v>
                </c:pt>
                <c:pt idx="508">
                  <c:v>1.0162185886282389</c:v>
                </c:pt>
                <c:pt idx="509">
                  <c:v>1.0229872597608975</c:v>
                </c:pt>
                <c:pt idx="510">
                  <c:v>1.023151348221516</c:v>
                </c:pt>
                <c:pt idx="511">
                  <c:v>1.0205677577723937</c:v>
                </c:pt>
                <c:pt idx="512">
                  <c:v>1.0239989292851552</c:v>
                </c:pt>
                <c:pt idx="513">
                  <c:v>1.0186273348383397</c:v>
                </c:pt>
                <c:pt idx="514">
                  <c:v>1.0193367094724282</c:v>
                </c:pt>
                <c:pt idx="515">
                  <c:v>1.0200199120135713</c:v>
                </c:pt>
                <c:pt idx="516">
                  <c:v>1.0212261926232409</c:v>
                </c:pt>
                <c:pt idx="517">
                  <c:v>1.0194091926997506</c:v>
                </c:pt>
                <c:pt idx="518">
                  <c:v>1.0154786836004652</c:v>
                </c:pt>
                <c:pt idx="519">
                  <c:v>1.017185352855716</c:v>
                </c:pt>
                <c:pt idx="520">
                  <c:v>1.020235239085004</c:v>
                </c:pt>
                <c:pt idx="521">
                  <c:v>1.0214592602297257</c:v>
                </c:pt>
                <c:pt idx="522">
                  <c:v>1.0136816196526541</c:v>
                </c:pt>
                <c:pt idx="523">
                  <c:v>1.0112266950866606</c:v>
                </c:pt>
                <c:pt idx="524">
                  <c:v>1.0118744156273833</c:v>
                </c:pt>
                <c:pt idx="525">
                  <c:v>1.0113650152153772</c:v>
                </c:pt>
                <c:pt idx="526">
                  <c:v>1.014839943923816</c:v>
                </c:pt>
                <c:pt idx="527">
                  <c:v>1.015783923519894</c:v>
                </c:pt>
                <c:pt idx="528">
                  <c:v>1.0110919631162589</c:v>
                </c:pt>
                <c:pt idx="529">
                  <c:v>1.0147969372560133</c:v>
                </c:pt>
                <c:pt idx="530">
                  <c:v>1.012900789571572</c:v>
                </c:pt>
                <c:pt idx="531">
                  <c:v>1.0156091365580955</c:v>
                </c:pt>
                <c:pt idx="532">
                  <c:v>1.0108727365901777</c:v>
                </c:pt>
                <c:pt idx="533">
                  <c:v>1.0087774102488603</c:v>
                </c:pt>
                <c:pt idx="534">
                  <c:v>1.0092832283934554</c:v>
                </c:pt>
                <c:pt idx="535">
                  <c:v>1.012802063784616</c:v>
                </c:pt>
                <c:pt idx="536">
                  <c:v>1.0134538432042748</c:v>
                </c:pt>
                <c:pt idx="537">
                  <c:v>1.0122449248655527</c:v>
                </c:pt>
                <c:pt idx="538">
                  <c:v>1.009547012728339</c:v>
                </c:pt>
                <c:pt idx="539">
                  <c:v>1.008656749125477</c:v>
                </c:pt>
                <c:pt idx="540">
                  <c:v>1.0054668324121634</c:v>
                </c:pt>
                <c:pt idx="541">
                  <c:v>1.0112763858529035</c:v>
                </c:pt>
                <c:pt idx="542">
                  <c:v>1.0073777168663609</c:v>
                </c:pt>
                <c:pt idx="543">
                  <c:v>1.0038430193505588</c:v>
                </c:pt>
                <c:pt idx="544">
                  <c:v>1.0064884198749897</c:v>
                </c:pt>
                <c:pt idx="545">
                  <c:v>1.0086601747755302</c:v>
                </c:pt>
                <c:pt idx="546">
                  <c:v>1.0130644523187418</c:v>
                </c:pt>
                <c:pt idx="547">
                  <c:v>1.0196391975174524</c:v>
                </c:pt>
                <c:pt idx="548">
                  <c:v>1.0160955010597179</c:v>
                </c:pt>
                <c:pt idx="549">
                  <c:v>1.0171235940451844</c:v>
                </c:pt>
                <c:pt idx="550">
                  <c:v>1.0146835869222441</c:v>
                </c:pt>
                <c:pt idx="551">
                  <c:v>1.0131250348924412</c:v>
                </c:pt>
                <c:pt idx="552">
                  <c:v>1.014950482061892</c:v>
                </c:pt>
                <c:pt idx="553">
                  <c:v>1.0146940734476746</c:v>
                </c:pt>
                <c:pt idx="554">
                  <c:v>1.0157708400106624</c:v>
                </c:pt>
                <c:pt idx="555">
                  <c:v>1.0137073167275974</c:v>
                </c:pt>
                <c:pt idx="556">
                  <c:v>1.0191833807499673</c:v>
                </c:pt>
                <c:pt idx="557">
                  <c:v>1.0221955208695681</c:v>
                </c:pt>
                <c:pt idx="558">
                  <c:v>1.0206945877495057</c:v>
                </c:pt>
                <c:pt idx="559">
                  <c:v>1.0161324427321246</c:v>
                </c:pt>
                <c:pt idx="560">
                  <c:v>1.0082080102870754</c:v>
                </c:pt>
                <c:pt idx="561">
                  <c:v>1.0085410544579168</c:v>
                </c:pt>
                <c:pt idx="562">
                  <c:v>1.0083862134358248</c:v>
                </c:pt>
                <c:pt idx="563">
                  <c:v>1.0131398520080228</c:v>
                </c:pt>
                <c:pt idx="564">
                  <c:v>1.0166574808617372</c:v>
                </c:pt>
                <c:pt idx="565">
                  <c:v>1.0136015854271476</c:v>
                </c:pt>
                <c:pt idx="566">
                  <c:v>1.0175305737845333</c:v>
                </c:pt>
                <c:pt idx="567">
                  <c:v>1.0186778309367044</c:v>
                </c:pt>
                <c:pt idx="568">
                  <c:v>1.0228330228668461</c:v>
                </c:pt>
                <c:pt idx="569">
                  <c:v>1.0177845561534644</c:v>
                </c:pt>
                <c:pt idx="570">
                  <c:v>1.0126336215220482</c:v>
                </c:pt>
                <c:pt idx="571">
                  <c:v>1.0118816276122651</c:v>
                </c:pt>
                <c:pt idx="572">
                  <c:v>1.0134811491736766</c:v>
                </c:pt>
                <c:pt idx="573">
                  <c:v>1.0191770393215485</c:v>
                </c:pt>
                <c:pt idx="574">
                  <c:v>1.0174551668090457</c:v>
                </c:pt>
                <c:pt idx="575">
                  <c:v>1.0122874393083356</c:v>
                </c:pt>
                <c:pt idx="576">
                  <c:v>1.0146703049104711</c:v>
                </c:pt>
                <c:pt idx="577">
                  <c:v>1.0137363235090402</c:v>
                </c:pt>
                <c:pt idx="578">
                  <c:v>1.0144498671624862</c:v>
                </c:pt>
                <c:pt idx="579">
                  <c:v>1.010211999705209</c:v>
                </c:pt>
                <c:pt idx="580">
                  <c:v>1.0092333752377456</c:v>
                </c:pt>
                <c:pt idx="581">
                  <c:v>1.0103495175240318</c:v>
                </c:pt>
                <c:pt idx="582">
                  <c:v>1.0128878892225981</c:v>
                </c:pt>
                <c:pt idx="583">
                  <c:v>1.0107629669009719</c:v>
                </c:pt>
                <c:pt idx="584">
                  <c:v>1.0107683872143067</c:v>
                </c:pt>
                <c:pt idx="585">
                  <c:v>1.0108707613403842</c:v>
                </c:pt>
                <c:pt idx="586">
                  <c:v>1.0114019571320707</c:v>
                </c:pt>
                <c:pt idx="587">
                  <c:v>1.0152861219967424</c:v>
                </c:pt>
                <c:pt idx="736">
                  <c:v>1.0046918767507003</c:v>
                </c:pt>
                <c:pt idx="737">
                  <c:v>0.99705882352941211</c:v>
                </c:pt>
                <c:pt idx="738">
                  <c:v>0.9966211484593841</c:v>
                </c:pt>
                <c:pt idx="739">
                  <c:v>1.0004551820728291</c:v>
                </c:pt>
                <c:pt idx="740">
                  <c:v>0.99921802054154996</c:v>
                </c:pt>
                <c:pt idx="741">
                  <c:v>1.0049369747899159</c:v>
                </c:pt>
                <c:pt idx="742">
                  <c:v>1.0018382352941166</c:v>
                </c:pt>
                <c:pt idx="743">
                  <c:v>1.002923669467787</c:v>
                </c:pt>
                <c:pt idx="744">
                  <c:v>1.0020716619981327</c:v>
                </c:pt>
                <c:pt idx="745">
                  <c:v>1.0045109710550892</c:v>
                </c:pt>
                <c:pt idx="746">
                  <c:v>1.008181605975724</c:v>
                </c:pt>
                <c:pt idx="747">
                  <c:v>1.0095238095238095</c:v>
                </c:pt>
                <c:pt idx="748">
                  <c:v>1.0108368347338941</c:v>
                </c:pt>
                <c:pt idx="749">
                  <c:v>1.0062324929971982</c:v>
                </c:pt>
                <c:pt idx="750">
                  <c:v>1.0012546685340797</c:v>
                </c:pt>
                <c:pt idx="751">
                  <c:v>1.0018499066293178</c:v>
                </c:pt>
                <c:pt idx="752">
                  <c:v>1.0083041549953315</c:v>
                </c:pt>
                <c:pt idx="753">
                  <c:v>1.0073762838468718</c:v>
                </c:pt>
                <c:pt idx="754">
                  <c:v>1.0046685340802994</c:v>
                </c:pt>
                <c:pt idx="755">
                  <c:v>1.006121615312791</c:v>
                </c:pt>
                <c:pt idx="756">
                  <c:v>1.007749766573296</c:v>
                </c:pt>
                <c:pt idx="757">
                  <c:v>1.0069327731092437</c:v>
                </c:pt>
                <c:pt idx="758">
                  <c:v>1.0066643323996254</c:v>
                </c:pt>
                <c:pt idx="759">
                  <c:v>1.0095296451914086</c:v>
                </c:pt>
                <c:pt idx="760">
                  <c:v>1.004767740429505</c:v>
                </c:pt>
                <c:pt idx="761">
                  <c:v>1.0075105042016814</c:v>
                </c:pt>
                <c:pt idx="762">
                  <c:v>1.004715219421102</c:v>
                </c:pt>
                <c:pt idx="763">
                  <c:v>1.0019666199813253</c:v>
                </c:pt>
                <c:pt idx="764">
                  <c:v>1.0011146125116706</c:v>
                </c:pt>
                <c:pt idx="765">
                  <c:v>1.0044176003734826</c:v>
                </c:pt>
                <c:pt idx="766">
                  <c:v>1.0084383753501398</c:v>
                </c:pt>
                <c:pt idx="767">
                  <c:v>1.0047327264239037</c:v>
                </c:pt>
                <c:pt idx="768">
                  <c:v>1.0081524276377225</c:v>
                </c:pt>
                <c:pt idx="769">
                  <c:v>1.0073879551820728</c:v>
                </c:pt>
                <c:pt idx="770">
                  <c:v>1.0064192343604108</c:v>
                </c:pt>
                <c:pt idx="771">
                  <c:v>1.0034313725490189</c:v>
                </c:pt>
                <c:pt idx="772">
                  <c:v>1.0002684407096172</c:v>
                </c:pt>
                <c:pt idx="773">
                  <c:v>1.0002042483660132</c:v>
                </c:pt>
                <c:pt idx="774">
                  <c:v>1.0033963585434162</c:v>
                </c:pt>
                <c:pt idx="775">
                  <c:v>1.0066001400560225</c:v>
                </c:pt>
                <c:pt idx="776">
                  <c:v>1.004907796451914</c:v>
                </c:pt>
                <c:pt idx="777">
                  <c:v>1.0042658730158731</c:v>
                </c:pt>
                <c:pt idx="778">
                  <c:v>1.0071136788048554</c:v>
                </c:pt>
                <c:pt idx="779">
                  <c:v>1.005654761904762</c:v>
                </c:pt>
                <c:pt idx="780">
                  <c:v>1.0117705415499534</c:v>
                </c:pt>
                <c:pt idx="781">
                  <c:v>1.009611344537815</c:v>
                </c:pt>
                <c:pt idx="782">
                  <c:v>1.0048085901027077</c:v>
                </c:pt>
                <c:pt idx="783">
                  <c:v>0.99995915032679761</c:v>
                </c:pt>
                <c:pt idx="784">
                  <c:v>1.002876984126984</c:v>
                </c:pt>
                <c:pt idx="785">
                  <c:v>0.99868697478991553</c:v>
                </c:pt>
                <c:pt idx="786">
                  <c:v>1.0037581699346405</c:v>
                </c:pt>
                <c:pt idx="787">
                  <c:v>1.00562558356676</c:v>
                </c:pt>
                <c:pt idx="788">
                  <c:v>1.0004493464052286</c:v>
                </c:pt>
                <c:pt idx="789">
                  <c:v>1.0002801120448179</c:v>
                </c:pt>
                <c:pt idx="790">
                  <c:v>1.0028011204481793</c:v>
                </c:pt>
                <c:pt idx="791">
                  <c:v>1.0069094304388422</c:v>
                </c:pt>
                <c:pt idx="792">
                  <c:v>1.004026610644257</c:v>
                </c:pt>
                <c:pt idx="793">
                  <c:v>1.0109535480859011</c:v>
                </c:pt>
                <c:pt idx="794">
                  <c:v>1.0115021008403362</c:v>
                </c:pt>
                <c:pt idx="795">
                  <c:v>1.0119105975723615</c:v>
                </c:pt>
                <c:pt idx="796">
                  <c:v>1.0100081699346413</c:v>
                </c:pt>
                <c:pt idx="797">
                  <c:v>1.0122607376283839</c:v>
                </c:pt>
                <c:pt idx="798">
                  <c:v>1.0107201213818866</c:v>
                </c:pt>
                <c:pt idx="799">
                  <c:v>1.0069327731092437</c:v>
                </c:pt>
                <c:pt idx="800">
                  <c:v>1.009418767507003</c:v>
                </c:pt>
                <c:pt idx="801">
                  <c:v>1.0108776844070964</c:v>
                </c:pt>
                <c:pt idx="802">
                  <c:v>1.0051470588235301</c:v>
                </c:pt>
                <c:pt idx="803">
                  <c:v>1.0057364612511672</c:v>
                </c:pt>
                <c:pt idx="804">
                  <c:v>1.0077789449112986</c:v>
                </c:pt>
                <c:pt idx="805">
                  <c:v>1.0091328197945844</c:v>
                </c:pt>
                <c:pt idx="806">
                  <c:v>1.0100606909430438</c:v>
                </c:pt>
                <c:pt idx="807">
                  <c:v>1.0139647525676918</c:v>
                </c:pt>
                <c:pt idx="808">
                  <c:v>1.013188608776844</c:v>
                </c:pt>
                <c:pt idx="809">
                  <c:v>1.0137663398692804</c:v>
                </c:pt>
                <c:pt idx="810">
                  <c:v>1.0148167600373479</c:v>
                </c:pt>
                <c:pt idx="811">
                  <c:v>1.0134453781512605</c:v>
                </c:pt>
                <c:pt idx="812">
                  <c:v>1.012155695611578</c:v>
                </c:pt>
                <c:pt idx="813">
                  <c:v>1.0116946778711471</c:v>
                </c:pt>
                <c:pt idx="814">
                  <c:v>1.01015406162465</c:v>
                </c:pt>
                <c:pt idx="815">
                  <c:v>1.0079248366013072</c:v>
                </c:pt>
                <c:pt idx="816">
                  <c:v>1.0098447712418299</c:v>
                </c:pt>
                <c:pt idx="817">
                  <c:v>1.0078256302520996</c:v>
                </c:pt>
                <c:pt idx="818">
                  <c:v>1.0092553688141919</c:v>
                </c:pt>
                <c:pt idx="819">
                  <c:v>1.0106851073762841</c:v>
                </c:pt>
                <c:pt idx="820">
                  <c:v>1.0097864145658264</c:v>
                </c:pt>
                <c:pt idx="821">
                  <c:v>1.0050011671335199</c:v>
                </c:pt>
                <c:pt idx="822">
                  <c:v>1.0065301120448178</c:v>
                </c:pt>
                <c:pt idx="823">
                  <c:v>1.0120506535947711</c:v>
                </c:pt>
                <c:pt idx="824">
                  <c:v>1.0138538748832873</c:v>
                </c:pt>
                <c:pt idx="825">
                  <c:v>1.0107668067226883</c:v>
                </c:pt>
                <c:pt idx="826">
                  <c:v>1.0112394957983186</c:v>
                </c:pt>
                <c:pt idx="827">
                  <c:v>1.0105333800186738</c:v>
                </c:pt>
                <c:pt idx="828">
                  <c:v>1.0126692343604102</c:v>
                </c:pt>
                <c:pt idx="829">
                  <c:v>1.0156454248366023</c:v>
                </c:pt>
                <c:pt idx="830">
                  <c:v>1.0139705882352938</c:v>
                </c:pt>
                <c:pt idx="831">
                  <c:v>1.0110994397759099</c:v>
                </c:pt>
                <c:pt idx="832">
                  <c:v>1.0120915032679738</c:v>
                </c:pt>
                <c:pt idx="833">
                  <c:v>1.014233193277311</c:v>
                </c:pt>
                <c:pt idx="834">
                  <c:v>1.0125583566760041</c:v>
                </c:pt>
                <c:pt idx="835">
                  <c:v>1.0112219887955178</c:v>
                </c:pt>
                <c:pt idx="836">
                  <c:v>1.0119631185807656</c:v>
                </c:pt>
                <c:pt idx="837">
                  <c:v>1.0109126984126977</c:v>
                </c:pt>
                <c:pt idx="838">
                  <c:v>1.0142682072829126</c:v>
                </c:pt>
                <c:pt idx="839">
                  <c:v>1.0145950046685341</c:v>
                </c:pt>
                <c:pt idx="840">
                  <c:v>1.0126692343604102</c:v>
                </c:pt>
                <c:pt idx="841">
                  <c:v>1.0102766106442578</c:v>
                </c:pt>
                <c:pt idx="842">
                  <c:v>1.0106909430438842</c:v>
                </c:pt>
                <c:pt idx="843">
                  <c:v>1.0137838468720819</c:v>
                </c:pt>
                <c:pt idx="844">
                  <c:v>1.0116538281979457</c:v>
                </c:pt>
                <c:pt idx="845">
                  <c:v>1.0138246965452835</c:v>
                </c:pt>
                <c:pt idx="846">
                  <c:v>1.0113153594771238</c:v>
                </c:pt>
                <c:pt idx="847">
                  <c:v>1.0085375816993465</c:v>
                </c:pt>
                <c:pt idx="848">
                  <c:v>1.0065126050420168</c:v>
                </c:pt>
                <c:pt idx="849">
                  <c:v>1.0088585434173669</c:v>
                </c:pt>
                <c:pt idx="850">
                  <c:v>1.0112920168067225</c:v>
                </c:pt>
                <c:pt idx="851">
                  <c:v>1.0063667133520067</c:v>
                </c:pt>
                <c:pt idx="852">
                  <c:v>1.0058531746031747</c:v>
                </c:pt>
                <c:pt idx="853">
                  <c:v>1.006372549019608</c:v>
                </c:pt>
                <c:pt idx="854">
                  <c:v>1.0079481792717093</c:v>
                </c:pt>
                <c:pt idx="855">
                  <c:v>1.0115546218487401</c:v>
                </c:pt>
                <c:pt idx="856">
                  <c:v>1.0113795518207283</c:v>
                </c:pt>
                <c:pt idx="857">
                  <c:v>1.0096171802054155</c:v>
                </c:pt>
                <c:pt idx="858">
                  <c:v>1.0083450046685347</c:v>
                </c:pt>
                <c:pt idx="859">
                  <c:v>1.0139880952380946</c:v>
                </c:pt>
                <c:pt idx="860">
                  <c:v>1.0171568627450982</c:v>
                </c:pt>
                <c:pt idx="861">
                  <c:v>1.0155170401493925</c:v>
                </c:pt>
                <c:pt idx="862">
                  <c:v>1.0172443977591024</c:v>
                </c:pt>
                <c:pt idx="863">
                  <c:v>1.0152369281045752</c:v>
                </c:pt>
                <c:pt idx="864">
                  <c:v>1.0118347338935574</c:v>
                </c:pt>
                <c:pt idx="865">
                  <c:v>1.0105333800186738</c:v>
                </c:pt>
                <c:pt idx="866">
                  <c:v>1.0094129318394023</c:v>
                </c:pt>
                <c:pt idx="867">
                  <c:v>1.0099206349206342</c:v>
                </c:pt>
                <c:pt idx="868">
                  <c:v>1.0071486928104565</c:v>
                </c:pt>
                <c:pt idx="869">
                  <c:v>1.0105567226890755</c:v>
                </c:pt>
                <c:pt idx="870">
                  <c:v>1.0085375816993465</c:v>
                </c:pt>
                <c:pt idx="871">
                  <c:v>1.0100898692810465</c:v>
                </c:pt>
                <c:pt idx="872">
                  <c:v>1.0126167133520074</c:v>
                </c:pt>
                <c:pt idx="873">
                  <c:v>1.012284080298786</c:v>
                </c:pt>
                <c:pt idx="874">
                  <c:v>1.0147350606909431</c:v>
                </c:pt>
                <c:pt idx="875">
                  <c:v>1.009249533146592</c:v>
                </c:pt>
                <c:pt idx="876">
                  <c:v>1.0114087301587302</c:v>
                </c:pt>
                <c:pt idx="877">
                  <c:v>1.0092787114845938</c:v>
                </c:pt>
                <c:pt idx="878">
                  <c:v>1.011636321195144</c:v>
                </c:pt>
                <c:pt idx="879">
                  <c:v>1.0114087301587302</c:v>
                </c:pt>
                <c:pt idx="880">
                  <c:v>1.0087243230625578</c:v>
                </c:pt>
                <c:pt idx="881">
                  <c:v>1.0101248832866478</c:v>
                </c:pt>
                <c:pt idx="882">
                  <c:v>1.0069911297852481</c:v>
                </c:pt>
                <c:pt idx="883">
                  <c:v>1.0094712885154054</c:v>
                </c:pt>
                <c:pt idx="884">
                  <c:v>1.0069619514472454</c:v>
                </c:pt>
                <c:pt idx="885">
                  <c:v>1.0066935107376278</c:v>
                </c:pt>
                <c:pt idx="886">
                  <c:v>1.0040791316526618</c:v>
                </c:pt>
                <c:pt idx="887">
                  <c:v>1.0032329598506069</c:v>
                </c:pt>
                <c:pt idx="888">
                  <c:v>1.0072070494864611</c:v>
                </c:pt>
                <c:pt idx="889">
                  <c:v>1.0048669467787121</c:v>
                </c:pt>
                <c:pt idx="890">
                  <c:v>1.0019549486461252</c:v>
                </c:pt>
                <c:pt idx="891">
                  <c:v>1.0029119981325858</c:v>
                </c:pt>
                <c:pt idx="892">
                  <c:v>1.0065417833800179</c:v>
                </c:pt>
                <c:pt idx="893">
                  <c:v>1.0035539215686284</c:v>
                </c:pt>
                <c:pt idx="894">
                  <c:v>1.0008228291316525</c:v>
                </c:pt>
                <c:pt idx="895">
                  <c:v>0.99703548085901028</c:v>
                </c:pt>
                <c:pt idx="896">
                  <c:v>0.99730392156862746</c:v>
                </c:pt>
                <c:pt idx="897">
                  <c:v>1.001108776844071</c:v>
                </c:pt>
                <c:pt idx="898">
                  <c:v>1.0041083099906629</c:v>
                </c:pt>
                <c:pt idx="899">
                  <c:v>1.0023167600373482</c:v>
                </c:pt>
                <c:pt idx="900">
                  <c:v>0.99878618113912199</c:v>
                </c:pt>
                <c:pt idx="901">
                  <c:v>1.0010562558356668</c:v>
                </c:pt>
                <c:pt idx="902">
                  <c:v>1.0006069094304388</c:v>
                </c:pt>
                <c:pt idx="903">
                  <c:v>0.99897292250233438</c:v>
                </c:pt>
                <c:pt idx="904">
                  <c:v>0.99281629318394027</c:v>
                </c:pt>
                <c:pt idx="905">
                  <c:v>0.99193510737628388</c:v>
                </c:pt>
                <c:pt idx="906">
                  <c:v>0.99301470588235219</c:v>
                </c:pt>
                <c:pt idx="907">
                  <c:v>0.99511554621848763</c:v>
                </c:pt>
                <c:pt idx="908">
                  <c:v>0.99612511671335202</c:v>
                </c:pt>
                <c:pt idx="909">
                  <c:v>0.9906687675070025</c:v>
                </c:pt>
                <c:pt idx="910">
                  <c:v>0.99191176470588238</c:v>
                </c:pt>
                <c:pt idx="911">
                  <c:v>0.9940417833800187</c:v>
                </c:pt>
                <c:pt idx="912">
                  <c:v>0.99432189542483662</c:v>
                </c:pt>
                <c:pt idx="913">
                  <c:v>0.9950805322128855</c:v>
                </c:pt>
                <c:pt idx="914">
                  <c:v>0.9916316526610649</c:v>
                </c:pt>
                <c:pt idx="915">
                  <c:v>0.98951914098972871</c:v>
                </c:pt>
                <c:pt idx="916">
                  <c:v>0.98823529411764677</c:v>
                </c:pt>
                <c:pt idx="917">
                  <c:v>0.98763422035480863</c:v>
                </c:pt>
                <c:pt idx="918">
                  <c:v>0.98859710550887059</c:v>
                </c:pt>
                <c:pt idx="919">
                  <c:v>0.9853816526610647</c:v>
                </c:pt>
                <c:pt idx="920">
                  <c:v>0.98918650793650753</c:v>
                </c:pt>
                <c:pt idx="921">
                  <c:v>0.98727824463118585</c:v>
                </c:pt>
                <c:pt idx="922">
                  <c:v>0.98855042016806727</c:v>
                </c:pt>
                <c:pt idx="923">
                  <c:v>0.98974089635854412</c:v>
                </c:pt>
                <c:pt idx="924">
                  <c:v>0.98666549953314664</c:v>
                </c:pt>
                <c:pt idx="925">
                  <c:v>0.98955999066293143</c:v>
                </c:pt>
                <c:pt idx="926">
                  <c:v>0.98629785247432344</c:v>
                </c:pt>
                <c:pt idx="927">
                  <c:v>0.990207749766573</c:v>
                </c:pt>
                <c:pt idx="928">
                  <c:v>0.98929738562091463</c:v>
                </c:pt>
                <c:pt idx="929">
                  <c:v>0.99014355742296889</c:v>
                </c:pt>
                <c:pt idx="930">
                  <c:v>0.98821778711484565</c:v>
                </c:pt>
                <c:pt idx="931">
                  <c:v>0.98298902894491136</c:v>
                </c:pt>
                <c:pt idx="932">
                  <c:v>0.98835784313725439</c:v>
                </c:pt>
                <c:pt idx="933">
                  <c:v>0.98597689075630257</c:v>
                </c:pt>
                <c:pt idx="934">
                  <c:v>0.98726073762838473</c:v>
                </c:pt>
                <c:pt idx="935">
                  <c:v>0.98622198879551826</c:v>
                </c:pt>
                <c:pt idx="936">
                  <c:v>0.98862628384687212</c:v>
                </c:pt>
                <c:pt idx="937">
                  <c:v>0.98472805788982265</c:v>
                </c:pt>
                <c:pt idx="938">
                  <c:v>0.98623366013071867</c:v>
                </c:pt>
                <c:pt idx="939">
                  <c:v>0.99281629318394027</c:v>
                </c:pt>
                <c:pt idx="940">
                  <c:v>0.9900735294117643</c:v>
                </c:pt>
                <c:pt idx="941">
                  <c:v>0.99116479925303458</c:v>
                </c:pt>
                <c:pt idx="942">
                  <c:v>0.99114729225023368</c:v>
                </c:pt>
                <c:pt idx="943">
                  <c:v>0.99478291316526579</c:v>
                </c:pt>
                <c:pt idx="944">
                  <c:v>0.99169584500466867</c:v>
                </c:pt>
                <c:pt idx="945">
                  <c:v>0.99467787114845962</c:v>
                </c:pt>
                <c:pt idx="946">
                  <c:v>0.9923027544351074</c:v>
                </c:pt>
                <c:pt idx="947">
                  <c:v>0.98629785247432344</c:v>
                </c:pt>
                <c:pt idx="948">
                  <c:v>0.98703898225957065</c:v>
                </c:pt>
                <c:pt idx="949">
                  <c:v>0.98968837535014009</c:v>
                </c:pt>
                <c:pt idx="950">
                  <c:v>0.9868055555555556</c:v>
                </c:pt>
                <c:pt idx="951">
                  <c:v>0.98620448179271647</c:v>
                </c:pt>
                <c:pt idx="952">
                  <c:v>0.99070378151260463</c:v>
                </c:pt>
                <c:pt idx="953">
                  <c:v>0.9874883286647993</c:v>
                </c:pt>
                <c:pt idx="954">
                  <c:v>0.99171335200746957</c:v>
                </c:pt>
                <c:pt idx="955">
                  <c:v>0.99331232492997135</c:v>
                </c:pt>
                <c:pt idx="956">
                  <c:v>0.99567577030812371</c:v>
                </c:pt>
                <c:pt idx="957">
                  <c:v>0.99759570494864569</c:v>
                </c:pt>
                <c:pt idx="958">
                  <c:v>0.99979575163398726</c:v>
                </c:pt>
                <c:pt idx="959">
                  <c:v>0.99806255835667568</c:v>
                </c:pt>
                <c:pt idx="960">
                  <c:v>0.9929446778711486</c:v>
                </c:pt>
                <c:pt idx="961">
                  <c:v>0.9979108309990663</c:v>
                </c:pt>
                <c:pt idx="962">
                  <c:v>1.0004668534080299</c:v>
                </c:pt>
                <c:pt idx="963">
                  <c:v>0.99976073762838502</c:v>
                </c:pt>
                <c:pt idx="964">
                  <c:v>0.99494631185807669</c:v>
                </c:pt>
                <c:pt idx="965">
                  <c:v>0.99237861811391259</c:v>
                </c:pt>
                <c:pt idx="966">
                  <c:v>0.99268790849673172</c:v>
                </c:pt>
                <c:pt idx="967">
                  <c:v>0.9948762838468721</c:v>
                </c:pt>
                <c:pt idx="968">
                  <c:v>0.99460784313725459</c:v>
                </c:pt>
                <c:pt idx="969">
                  <c:v>0.99140989729225026</c:v>
                </c:pt>
                <c:pt idx="970">
                  <c:v>0.98440709617180211</c:v>
                </c:pt>
                <c:pt idx="971">
                  <c:v>0.98693977591036386</c:v>
                </c:pt>
                <c:pt idx="972">
                  <c:v>0.98915732959850611</c:v>
                </c:pt>
                <c:pt idx="973">
                  <c:v>0.9916316526610649</c:v>
                </c:pt>
                <c:pt idx="974">
                  <c:v>0.99310224089635812</c:v>
                </c:pt>
                <c:pt idx="975">
                  <c:v>0.99088468720821654</c:v>
                </c:pt>
                <c:pt idx="976">
                  <c:v>0.9929738562091508</c:v>
                </c:pt>
                <c:pt idx="977">
                  <c:v>0.99444444444444469</c:v>
                </c:pt>
                <c:pt idx="978">
                  <c:v>0.99826680672268875</c:v>
                </c:pt>
                <c:pt idx="979">
                  <c:v>0.99751400560224035</c:v>
                </c:pt>
                <c:pt idx="980">
                  <c:v>0.99830182072829132</c:v>
                </c:pt>
                <c:pt idx="981">
                  <c:v>0.9964985994397759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49315424"/>
        <c:axId val="249315816"/>
      </c:scatterChart>
      <c:valAx>
        <c:axId val="249315424"/>
        <c:scaling>
          <c:orientation val="minMax"/>
          <c:max val="170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1125" b="1" i="0" u="none" strike="noStrike" baseline="0">
                    <a:solidFill>
                      <a:srgbClr val="000000"/>
                    </a:solidFill>
                    <a:latin typeface="Times New Roman"/>
                    <a:ea typeface="Times New Roman"/>
                    <a:cs typeface="Times New Roman"/>
                  </a:defRPr>
                </a:pPr>
                <a:r>
                  <a:rPr lang="en-GB"/>
                  <a:t>Time, s</a:t>
                </a:r>
              </a:p>
            </c:rich>
          </c:tx>
          <c:layout>
            <c:manualLayout>
              <c:xMode val="edge"/>
              <c:yMode val="edge"/>
              <c:x val="0.80128281509160582"/>
              <c:y val="0.7891844600473259"/>
            </c:manualLayout>
          </c:layout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125" b="1" i="0" u="none" strike="noStrike" baseline="0">
                <a:solidFill>
                  <a:schemeClr val="bg1"/>
                </a:solidFill>
                <a:latin typeface="Times New Roman"/>
                <a:ea typeface="Times New Roman"/>
                <a:cs typeface="Times New Roman"/>
              </a:defRPr>
            </a:pPr>
            <a:endParaRPr lang="en-US"/>
          </a:p>
        </c:txPr>
        <c:crossAx val="249315816"/>
        <c:crosses val="autoZero"/>
        <c:crossBetween val="midCat"/>
        <c:majorUnit val="500"/>
        <c:minorUnit val="40"/>
      </c:valAx>
      <c:valAx>
        <c:axId val="249315816"/>
        <c:scaling>
          <c:orientation val="minMax"/>
          <c:max val="1.1000000000000001"/>
          <c:min val="0.60000000000000064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200" b="1" i="0" u="none" strike="noStrike" baseline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</a:defRPr>
            </a:pPr>
            <a:endParaRPr lang="en-US"/>
          </a:p>
        </c:txPr>
        <c:crossAx val="249315424"/>
        <c:crosses val="autoZero"/>
        <c:crossBetween val="midCat"/>
        <c:majorUnit val="0.1"/>
        <c:minorUnit val="1.0000000000000005E-2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rgbClr val="FFFFFF"/>
    </a:solidFill>
    <a:ln w="9525">
      <a:noFill/>
    </a:ln>
  </c:spPr>
  <c:txPr>
    <a:bodyPr/>
    <a:lstStyle/>
    <a:p>
      <a:pPr>
        <a:defRPr sz="1200" b="1" i="0" u="none" strike="noStrike" baseline="0">
          <a:solidFill>
            <a:srgbClr val="000000"/>
          </a:solidFill>
          <a:latin typeface="Times New Roman"/>
          <a:ea typeface="Times New Roman"/>
          <a:cs typeface="Times New Roman"/>
        </a:defRPr>
      </a:pPr>
      <a:endParaRPr lang="en-US"/>
    </a:p>
  </c:txPr>
  <c:externalData r:id="rId2">
    <c:autoUpdate val="0"/>
  </c:externalData>
  <c:userShapes r:id="rId3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4162426812033121"/>
          <c:y val="0.11232037141512712"/>
          <c:w val="0.81322309711286089"/>
          <c:h val="0.66553545516584145"/>
        </c:manualLayout>
      </c:layout>
      <c:scatterChart>
        <c:scatterStyle val="smoothMarker"/>
        <c:varyColors val="0"/>
        <c:ser>
          <c:idx val="0"/>
          <c:order val="0"/>
          <c:spPr>
            <a:ln>
              <a:solidFill>
                <a:prstClr val="black"/>
              </a:solidFill>
            </a:ln>
          </c:spPr>
          <c:marker>
            <c:symbol val="none"/>
          </c:marker>
          <c:xVal>
            <c:numRef>
              <c:f>'12july10_F5N_RyR2abN_1'!$A$1:$A$392</c:f>
              <c:numCache>
                <c:formatCode>General</c:formatCode>
                <c:ptCount val="392"/>
                <c:pt idx="0">
                  <c:v>0</c:v>
                </c:pt>
                <c:pt idx="1">
                  <c:v>1.34</c:v>
                </c:pt>
                <c:pt idx="2">
                  <c:v>2.68</c:v>
                </c:pt>
                <c:pt idx="3">
                  <c:v>4.0199999999999996</c:v>
                </c:pt>
                <c:pt idx="4">
                  <c:v>5.3599999999999985</c:v>
                </c:pt>
                <c:pt idx="5">
                  <c:v>6.7</c:v>
                </c:pt>
                <c:pt idx="6">
                  <c:v>8.0400000000000009</c:v>
                </c:pt>
                <c:pt idx="7">
                  <c:v>9.3800000000000008</c:v>
                </c:pt>
                <c:pt idx="8">
                  <c:v>10.72</c:v>
                </c:pt>
                <c:pt idx="9">
                  <c:v>12.06</c:v>
                </c:pt>
                <c:pt idx="10">
                  <c:v>13.4</c:v>
                </c:pt>
                <c:pt idx="11">
                  <c:v>14.74</c:v>
                </c:pt>
                <c:pt idx="12">
                  <c:v>16.079999999999988</c:v>
                </c:pt>
                <c:pt idx="13">
                  <c:v>17.420000000000002</c:v>
                </c:pt>
                <c:pt idx="14">
                  <c:v>18.760000000000002</c:v>
                </c:pt>
                <c:pt idx="15">
                  <c:v>20.100000000000001</c:v>
                </c:pt>
                <c:pt idx="16">
                  <c:v>21.439999999999987</c:v>
                </c:pt>
                <c:pt idx="17">
                  <c:v>22.779999999999987</c:v>
                </c:pt>
                <c:pt idx="18">
                  <c:v>24.12</c:v>
                </c:pt>
                <c:pt idx="19">
                  <c:v>25.459999999999987</c:v>
                </c:pt>
                <c:pt idx="20">
                  <c:v>26.8</c:v>
                </c:pt>
                <c:pt idx="21">
                  <c:v>28.14</c:v>
                </c:pt>
                <c:pt idx="22">
                  <c:v>29.479999999999986</c:v>
                </c:pt>
                <c:pt idx="23">
                  <c:v>30.82</c:v>
                </c:pt>
                <c:pt idx="24">
                  <c:v>32.160000000000011</c:v>
                </c:pt>
                <c:pt idx="25">
                  <c:v>33.5</c:v>
                </c:pt>
                <c:pt idx="26">
                  <c:v>34.840000000000003</c:v>
                </c:pt>
                <c:pt idx="27">
                  <c:v>36.18</c:v>
                </c:pt>
                <c:pt idx="28">
                  <c:v>37.520000000000003</c:v>
                </c:pt>
                <c:pt idx="29">
                  <c:v>38.86</c:v>
                </c:pt>
                <c:pt idx="30">
                  <c:v>40.200000000000003</c:v>
                </c:pt>
                <c:pt idx="31">
                  <c:v>41.54</c:v>
                </c:pt>
                <c:pt idx="32">
                  <c:v>42.88</c:v>
                </c:pt>
                <c:pt idx="33">
                  <c:v>44.220000000000013</c:v>
                </c:pt>
                <c:pt idx="34">
                  <c:v>45.56</c:v>
                </c:pt>
                <c:pt idx="35">
                  <c:v>46.9</c:v>
                </c:pt>
                <c:pt idx="36">
                  <c:v>48.24</c:v>
                </c:pt>
                <c:pt idx="37">
                  <c:v>49.58</c:v>
                </c:pt>
                <c:pt idx="38">
                  <c:v>50.92</c:v>
                </c:pt>
                <c:pt idx="39">
                  <c:v>52.260000000000012</c:v>
                </c:pt>
                <c:pt idx="40">
                  <c:v>53.6</c:v>
                </c:pt>
                <c:pt idx="41">
                  <c:v>54.94</c:v>
                </c:pt>
                <c:pt idx="42">
                  <c:v>56.28</c:v>
                </c:pt>
                <c:pt idx="43">
                  <c:v>57.620000000000012</c:v>
                </c:pt>
                <c:pt idx="44">
                  <c:v>58.96</c:v>
                </c:pt>
                <c:pt idx="45">
                  <c:v>60.3</c:v>
                </c:pt>
                <c:pt idx="46">
                  <c:v>61.64</c:v>
                </c:pt>
                <c:pt idx="47">
                  <c:v>62.98</c:v>
                </c:pt>
                <c:pt idx="48">
                  <c:v>64.319999999999993</c:v>
                </c:pt>
                <c:pt idx="49">
                  <c:v>65.66</c:v>
                </c:pt>
                <c:pt idx="50">
                  <c:v>67</c:v>
                </c:pt>
                <c:pt idx="51">
                  <c:v>68.34</c:v>
                </c:pt>
                <c:pt idx="52">
                  <c:v>69.679999999999978</c:v>
                </c:pt>
                <c:pt idx="53">
                  <c:v>71.02</c:v>
                </c:pt>
                <c:pt idx="54">
                  <c:v>72.36</c:v>
                </c:pt>
                <c:pt idx="55">
                  <c:v>73.7</c:v>
                </c:pt>
                <c:pt idx="56">
                  <c:v>75.040000000000006</c:v>
                </c:pt>
                <c:pt idx="57">
                  <c:v>76.38</c:v>
                </c:pt>
                <c:pt idx="58">
                  <c:v>77.72</c:v>
                </c:pt>
                <c:pt idx="59">
                  <c:v>79.06</c:v>
                </c:pt>
                <c:pt idx="60">
                  <c:v>80.400000000000006</c:v>
                </c:pt>
                <c:pt idx="61">
                  <c:v>81.739999999999995</c:v>
                </c:pt>
                <c:pt idx="62">
                  <c:v>83.08</c:v>
                </c:pt>
                <c:pt idx="63">
                  <c:v>84.42</c:v>
                </c:pt>
                <c:pt idx="64">
                  <c:v>85.76</c:v>
                </c:pt>
                <c:pt idx="65">
                  <c:v>87.1</c:v>
                </c:pt>
                <c:pt idx="66">
                  <c:v>88.440000000000026</c:v>
                </c:pt>
                <c:pt idx="67">
                  <c:v>89.78</c:v>
                </c:pt>
                <c:pt idx="68">
                  <c:v>91.11999999999999</c:v>
                </c:pt>
                <c:pt idx="69">
                  <c:v>92.460000000000022</c:v>
                </c:pt>
                <c:pt idx="70">
                  <c:v>93.8</c:v>
                </c:pt>
                <c:pt idx="71">
                  <c:v>95.14</c:v>
                </c:pt>
                <c:pt idx="72">
                  <c:v>96.48</c:v>
                </c:pt>
                <c:pt idx="73">
                  <c:v>97.82</c:v>
                </c:pt>
                <c:pt idx="74">
                  <c:v>99.16</c:v>
                </c:pt>
                <c:pt idx="75">
                  <c:v>100.5</c:v>
                </c:pt>
                <c:pt idx="76">
                  <c:v>101.84</c:v>
                </c:pt>
                <c:pt idx="77">
                  <c:v>103.17999999999998</c:v>
                </c:pt>
                <c:pt idx="78">
                  <c:v>104.52</c:v>
                </c:pt>
                <c:pt idx="79">
                  <c:v>105.86</c:v>
                </c:pt>
                <c:pt idx="80">
                  <c:v>107.2</c:v>
                </c:pt>
                <c:pt idx="81">
                  <c:v>108.54</c:v>
                </c:pt>
                <c:pt idx="82">
                  <c:v>109.88</c:v>
                </c:pt>
                <c:pt idx="83">
                  <c:v>111.22</c:v>
                </c:pt>
                <c:pt idx="84">
                  <c:v>112.56</c:v>
                </c:pt>
                <c:pt idx="85">
                  <c:v>113.9</c:v>
                </c:pt>
                <c:pt idx="86">
                  <c:v>115.24000000000002</c:v>
                </c:pt>
                <c:pt idx="87">
                  <c:v>116.58</c:v>
                </c:pt>
                <c:pt idx="88">
                  <c:v>117.92</c:v>
                </c:pt>
                <c:pt idx="89">
                  <c:v>119.26</c:v>
                </c:pt>
                <c:pt idx="90">
                  <c:v>120.6</c:v>
                </c:pt>
                <c:pt idx="91">
                  <c:v>121.94000000000032</c:v>
                </c:pt>
                <c:pt idx="92">
                  <c:v>123.28</c:v>
                </c:pt>
                <c:pt idx="93">
                  <c:v>124.61999999999999</c:v>
                </c:pt>
                <c:pt idx="94">
                  <c:v>125.96000000000002</c:v>
                </c:pt>
                <c:pt idx="95">
                  <c:v>127.3</c:v>
                </c:pt>
                <c:pt idx="96">
                  <c:v>128.63999999999999</c:v>
                </c:pt>
                <c:pt idx="97">
                  <c:v>129.97999999999999</c:v>
                </c:pt>
                <c:pt idx="98">
                  <c:v>131.32000000000068</c:v>
                </c:pt>
                <c:pt idx="99">
                  <c:v>132.66</c:v>
                </c:pt>
                <c:pt idx="100">
                  <c:v>134</c:v>
                </c:pt>
                <c:pt idx="101">
                  <c:v>135.34</c:v>
                </c:pt>
                <c:pt idx="102">
                  <c:v>136.68</c:v>
                </c:pt>
                <c:pt idx="103">
                  <c:v>138.02000000000001</c:v>
                </c:pt>
                <c:pt idx="104">
                  <c:v>139.36000000000001</c:v>
                </c:pt>
                <c:pt idx="105">
                  <c:v>140.69999999999999</c:v>
                </c:pt>
                <c:pt idx="106">
                  <c:v>142.04</c:v>
                </c:pt>
                <c:pt idx="107">
                  <c:v>143.38000000000068</c:v>
                </c:pt>
                <c:pt idx="108">
                  <c:v>144.72</c:v>
                </c:pt>
                <c:pt idx="109">
                  <c:v>146.06</c:v>
                </c:pt>
                <c:pt idx="110">
                  <c:v>147.4</c:v>
                </c:pt>
                <c:pt idx="111">
                  <c:v>148.73999999999998</c:v>
                </c:pt>
                <c:pt idx="112">
                  <c:v>150.08000000000001</c:v>
                </c:pt>
                <c:pt idx="113">
                  <c:v>151.41999999999999</c:v>
                </c:pt>
                <c:pt idx="114">
                  <c:v>152.76</c:v>
                </c:pt>
                <c:pt idx="115">
                  <c:v>154.1</c:v>
                </c:pt>
                <c:pt idx="116">
                  <c:v>155.44</c:v>
                </c:pt>
                <c:pt idx="117">
                  <c:v>156.78</c:v>
                </c:pt>
                <c:pt idx="118">
                  <c:v>158.12</c:v>
                </c:pt>
                <c:pt idx="119">
                  <c:v>159.46</c:v>
                </c:pt>
                <c:pt idx="120">
                  <c:v>160.80000000000001</c:v>
                </c:pt>
                <c:pt idx="121">
                  <c:v>162.13999999999999</c:v>
                </c:pt>
                <c:pt idx="122">
                  <c:v>163.47999999999999</c:v>
                </c:pt>
                <c:pt idx="123">
                  <c:v>164.82000000000068</c:v>
                </c:pt>
                <c:pt idx="124">
                  <c:v>166.16</c:v>
                </c:pt>
                <c:pt idx="125">
                  <c:v>167.5</c:v>
                </c:pt>
                <c:pt idx="126">
                  <c:v>168.84</c:v>
                </c:pt>
                <c:pt idx="127">
                  <c:v>170.18</c:v>
                </c:pt>
                <c:pt idx="128">
                  <c:v>171.52</c:v>
                </c:pt>
                <c:pt idx="129">
                  <c:v>172.86</c:v>
                </c:pt>
                <c:pt idx="130">
                  <c:v>174.2</c:v>
                </c:pt>
                <c:pt idx="131">
                  <c:v>175.54</c:v>
                </c:pt>
                <c:pt idx="132">
                  <c:v>176.88000000000068</c:v>
                </c:pt>
                <c:pt idx="133">
                  <c:v>178.22</c:v>
                </c:pt>
                <c:pt idx="134">
                  <c:v>179.56</c:v>
                </c:pt>
                <c:pt idx="135">
                  <c:v>180.9</c:v>
                </c:pt>
                <c:pt idx="136">
                  <c:v>182.23999999999998</c:v>
                </c:pt>
                <c:pt idx="137">
                  <c:v>183.58</c:v>
                </c:pt>
                <c:pt idx="138">
                  <c:v>184.92000000000004</c:v>
                </c:pt>
                <c:pt idx="139">
                  <c:v>186.26</c:v>
                </c:pt>
                <c:pt idx="140">
                  <c:v>187.6</c:v>
                </c:pt>
                <c:pt idx="141">
                  <c:v>188.94</c:v>
                </c:pt>
                <c:pt idx="142">
                  <c:v>190.28</c:v>
                </c:pt>
                <c:pt idx="143">
                  <c:v>191.62</c:v>
                </c:pt>
                <c:pt idx="144">
                  <c:v>192.96</c:v>
                </c:pt>
                <c:pt idx="145">
                  <c:v>194.3</c:v>
                </c:pt>
                <c:pt idx="146">
                  <c:v>195.64</c:v>
                </c:pt>
                <c:pt idx="147">
                  <c:v>196.98000000000027</c:v>
                </c:pt>
                <c:pt idx="148">
                  <c:v>198.32000000000068</c:v>
                </c:pt>
                <c:pt idx="149">
                  <c:v>199.66</c:v>
                </c:pt>
                <c:pt idx="150">
                  <c:v>201</c:v>
                </c:pt>
                <c:pt idx="151">
                  <c:v>202.34</c:v>
                </c:pt>
                <c:pt idx="152">
                  <c:v>203.68</c:v>
                </c:pt>
                <c:pt idx="153">
                  <c:v>205.02</c:v>
                </c:pt>
                <c:pt idx="154">
                  <c:v>206.36</c:v>
                </c:pt>
                <c:pt idx="155">
                  <c:v>207.7</c:v>
                </c:pt>
                <c:pt idx="156">
                  <c:v>209.04</c:v>
                </c:pt>
                <c:pt idx="157">
                  <c:v>210.38000000000068</c:v>
                </c:pt>
                <c:pt idx="158">
                  <c:v>211.72</c:v>
                </c:pt>
                <c:pt idx="159">
                  <c:v>213.06</c:v>
                </c:pt>
                <c:pt idx="160">
                  <c:v>214.4</c:v>
                </c:pt>
                <c:pt idx="161">
                  <c:v>215.73999999999998</c:v>
                </c:pt>
                <c:pt idx="162">
                  <c:v>217.08</c:v>
                </c:pt>
                <c:pt idx="163">
                  <c:v>218.42000000000004</c:v>
                </c:pt>
                <c:pt idx="164">
                  <c:v>219.76</c:v>
                </c:pt>
                <c:pt idx="165">
                  <c:v>221.1</c:v>
                </c:pt>
                <c:pt idx="166">
                  <c:v>222.44</c:v>
                </c:pt>
                <c:pt idx="167">
                  <c:v>223.78</c:v>
                </c:pt>
                <c:pt idx="168">
                  <c:v>225.12</c:v>
                </c:pt>
                <c:pt idx="169">
                  <c:v>226.46</c:v>
                </c:pt>
                <c:pt idx="170">
                  <c:v>227.8</c:v>
                </c:pt>
                <c:pt idx="171">
                  <c:v>229.14</c:v>
                </c:pt>
                <c:pt idx="172">
                  <c:v>230.48000000000027</c:v>
                </c:pt>
                <c:pt idx="173">
                  <c:v>231.82000000000068</c:v>
                </c:pt>
                <c:pt idx="174">
                  <c:v>233.16</c:v>
                </c:pt>
                <c:pt idx="175">
                  <c:v>234.5</c:v>
                </c:pt>
                <c:pt idx="176">
                  <c:v>235.84</c:v>
                </c:pt>
                <c:pt idx="177">
                  <c:v>237.18</c:v>
                </c:pt>
                <c:pt idx="178">
                  <c:v>238.52</c:v>
                </c:pt>
                <c:pt idx="179">
                  <c:v>239.86</c:v>
                </c:pt>
                <c:pt idx="180">
                  <c:v>241.2</c:v>
                </c:pt>
                <c:pt idx="181">
                  <c:v>242.54</c:v>
                </c:pt>
                <c:pt idx="182">
                  <c:v>243.88000000000068</c:v>
                </c:pt>
                <c:pt idx="183">
                  <c:v>245.22</c:v>
                </c:pt>
                <c:pt idx="184">
                  <c:v>246.56</c:v>
                </c:pt>
                <c:pt idx="185">
                  <c:v>247.9</c:v>
                </c:pt>
                <c:pt idx="186">
                  <c:v>249.23999999999998</c:v>
                </c:pt>
                <c:pt idx="187">
                  <c:v>250.58</c:v>
                </c:pt>
                <c:pt idx="188">
                  <c:v>251.92000000000004</c:v>
                </c:pt>
                <c:pt idx="189">
                  <c:v>253.26</c:v>
                </c:pt>
                <c:pt idx="190">
                  <c:v>254.6</c:v>
                </c:pt>
                <c:pt idx="191">
                  <c:v>255.94</c:v>
                </c:pt>
                <c:pt idx="192">
                  <c:v>257.27999999999969</c:v>
                </c:pt>
                <c:pt idx="193">
                  <c:v>258.62</c:v>
                </c:pt>
                <c:pt idx="194">
                  <c:v>259.95999999999964</c:v>
                </c:pt>
                <c:pt idx="195">
                  <c:v>261.3</c:v>
                </c:pt>
                <c:pt idx="196">
                  <c:v>262.64000000000038</c:v>
                </c:pt>
                <c:pt idx="197">
                  <c:v>263.97999999999894</c:v>
                </c:pt>
                <c:pt idx="198">
                  <c:v>265.32</c:v>
                </c:pt>
                <c:pt idx="199">
                  <c:v>266.66000000000008</c:v>
                </c:pt>
                <c:pt idx="200">
                  <c:v>268</c:v>
                </c:pt>
                <c:pt idx="201">
                  <c:v>269.33999999999969</c:v>
                </c:pt>
                <c:pt idx="202">
                  <c:v>270.68</c:v>
                </c:pt>
                <c:pt idx="203">
                  <c:v>272.02</c:v>
                </c:pt>
                <c:pt idx="204">
                  <c:v>273.36</c:v>
                </c:pt>
                <c:pt idx="205">
                  <c:v>274.7</c:v>
                </c:pt>
                <c:pt idx="206">
                  <c:v>276.04000000000002</c:v>
                </c:pt>
                <c:pt idx="207">
                  <c:v>277.38</c:v>
                </c:pt>
                <c:pt idx="208">
                  <c:v>278.72000000000003</c:v>
                </c:pt>
                <c:pt idx="209">
                  <c:v>280.06</c:v>
                </c:pt>
                <c:pt idx="210">
                  <c:v>281.39999999999969</c:v>
                </c:pt>
                <c:pt idx="211">
                  <c:v>282.74</c:v>
                </c:pt>
                <c:pt idx="212">
                  <c:v>284.08</c:v>
                </c:pt>
                <c:pt idx="213">
                  <c:v>285.41999999999899</c:v>
                </c:pt>
                <c:pt idx="214">
                  <c:v>286.76</c:v>
                </c:pt>
                <c:pt idx="215">
                  <c:v>288.10000000000002</c:v>
                </c:pt>
                <c:pt idx="216">
                  <c:v>289.44</c:v>
                </c:pt>
                <c:pt idx="217">
                  <c:v>290.77999999999969</c:v>
                </c:pt>
                <c:pt idx="218">
                  <c:v>292.12</c:v>
                </c:pt>
                <c:pt idx="219">
                  <c:v>293.45999999999964</c:v>
                </c:pt>
                <c:pt idx="220">
                  <c:v>294.8</c:v>
                </c:pt>
                <c:pt idx="221">
                  <c:v>296.14000000000038</c:v>
                </c:pt>
                <c:pt idx="222">
                  <c:v>297.47999999999894</c:v>
                </c:pt>
                <c:pt idx="223">
                  <c:v>298.82</c:v>
                </c:pt>
                <c:pt idx="224">
                  <c:v>300.16000000000008</c:v>
                </c:pt>
                <c:pt idx="225">
                  <c:v>301.5</c:v>
                </c:pt>
                <c:pt idx="226">
                  <c:v>302.83999999999969</c:v>
                </c:pt>
                <c:pt idx="227">
                  <c:v>304.18</c:v>
                </c:pt>
                <c:pt idx="228">
                  <c:v>305.52</c:v>
                </c:pt>
                <c:pt idx="229">
                  <c:v>306.86</c:v>
                </c:pt>
                <c:pt idx="230">
                  <c:v>308.2</c:v>
                </c:pt>
                <c:pt idx="231">
                  <c:v>309.54000000000002</c:v>
                </c:pt>
                <c:pt idx="232">
                  <c:v>310.88</c:v>
                </c:pt>
                <c:pt idx="233">
                  <c:v>312.22000000000003</c:v>
                </c:pt>
                <c:pt idx="234">
                  <c:v>313.56</c:v>
                </c:pt>
                <c:pt idx="235">
                  <c:v>314.89999999999969</c:v>
                </c:pt>
                <c:pt idx="236">
                  <c:v>316.24</c:v>
                </c:pt>
                <c:pt idx="237">
                  <c:v>317.58</c:v>
                </c:pt>
                <c:pt idx="238">
                  <c:v>318.91999999999899</c:v>
                </c:pt>
                <c:pt idx="239">
                  <c:v>320.26</c:v>
                </c:pt>
                <c:pt idx="240">
                  <c:v>321.60000000000002</c:v>
                </c:pt>
                <c:pt idx="241">
                  <c:v>322.94</c:v>
                </c:pt>
                <c:pt idx="242">
                  <c:v>324.27999999999969</c:v>
                </c:pt>
                <c:pt idx="243">
                  <c:v>325.62</c:v>
                </c:pt>
                <c:pt idx="244">
                  <c:v>326.95999999999964</c:v>
                </c:pt>
                <c:pt idx="245">
                  <c:v>328.3</c:v>
                </c:pt>
                <c:pt idx="246">
                  <c:v>329.64000000000038</c:v>
                </c:pt>
                <c:pt idx="247">
                  <c:v>330.97999999999894</c:v>
                </c:pt>
                <c:pt idx="248">
                  <c:v>332.32</c:v>
                </c:pt>
                <c:pt idx="249">
                  <c:v>333.66</c:v>
                </c:pt>
                <c:pt idx="250">
                  <c:v>335</c:v>
                </c:pt>
                <c:pt idx="251">
                  <c:v>336.34000000000032</c:v>
                </c:pt>
                <c:pt idx="252">
                  <c:v>337.68</c:v>
                </c:pt>
                <c:pt idx="253">
                  <c:v>339.02</c:v>
                </c:pt>
                <c:pt idx="254">
                  <c:v>340.36</c:v>
                </c:pt>
                <c:pt idx="255">
                  <c:v>341.7</c:v>
                </c:pt>
                <c:pt idx="256">
                  <c:v>343.04</c:v>
                </c:pt>
                <c:pt idx="257">
                  <c:v>344.38</c:v>
                </c:pt>
                <c:pt idx="258">
                  <c:v>345.71999999999969</c:v>
                </c:pt>
                <c:pt idx="259">
                  <c:v>347.06</c:v>
                </c:pt>
                <c:pt idx="260">
                  <c:v>348.4</c:v>
                </c:pt>
                <c:pt idx="261">
                  <c:v>349.74</c:v>
                </c:pt>
                <c:pt idx="262">
                  <c:v>351.08</c:v>
                </c:pt>
                <c:pt idx="263">
                  <c:v>352.41999999999899</c:v>
                </c:pt>
                <c:pt idx="264">
                  <c:v>353.76</c:v>
                </c:pt>
                <c:pt idx="265">
                  <c:v>355.1</c:v>
                </c:pt>
                <c:pt idx="266">
                  <c:v>356.44</c:v>
                </c:pt>
                <c:pt idx="267">
                  <c:v>357.78</c:v>
                </c:pt>
                <c:pt idx="268">
                  <c:v>359.12</c:v>
                </c:pt>
                <c:pt idx="269">
                  <c:v>360.46</c:v>
                </c:pt>
                <c:pt idx="270">
                  <c:v>361.8</c:v>
                </c:pt>
                <c:pt idx="271">
                  <c:v>363.14000000000038</c:v>
                </c:pt>
                <c:pt idx="272">
                  <c:v>364.47999999999894</c:v>
                </c:pt>
                <c:pt idx="273">
                  <c:v>365.82</c:v>
                </c:pt>
                <c:pt idx="274">
                  <c:v>367.16</c:v>
                </c:pt>
                <c:pt idx="275">
                  <c:v>368.5</c:v>
                </c:pt>
                <c:pt idx="276">
                  <c:v>369.84000000000032</c:v>
                </c:pt>
                <c:pt idx="277">
                  <c:v>371.18</c:v>
                </c:pt>
                <c:pt idx="278">
                  <c:v>372.52</c:v>
                </c:pt>
                <c:pt idx="279">
                  <c:v>373.86</c:v>
                </c:pt>
                <c:pt idx="280">
                  <c:v>375.2</c:v>
                </c:pt>
                <c:pt idx="281">
                  <c:v>376.54</c:v>
                </c:pt>
                <c:pt idx="282">
                  <c:v>377.88</c:v>
                </c:pt>
                <c:pt idx="283">
                  <c:v>379.21999999999969</c:v>
                </c:pt>
                <c:pt idx="284">
                  <c:v>380.56</c:v>
                </c:pt>
                <c:pt idx="285">
                  <c:v>381.9</c:v>
                </c:pt>
                <c:pt idx="286">
                  <c:v>383.24</c:v>
                </c:pt>
                <c:pt idx="287">
                  <c:v>384.58</c:v>
                </c:pt>
                <c:pt idx="288">
                  <c:v>385.91999999999899</c:v>
                </c:pt>
                <c:pt idx="289">
                  <c:v>387.26</c:v>
                </c:pt>
                <c:pt idx="290">
                  <c:v>388.6</c:v>
                </c:pt>
                <c:pt idx="291">
                  <c:v>389.94</c:v>
                </c:pt>
                <c:pt idx="292">
                  <c:v>391.28</c:v>
                </c:pt>
                <c:pt idx="293">
                  <c:v>392.62</c:v>
                </c:pt>
                <c:pt idx="294">
                  <c:v>393.96</c:v>
                </c:pt>
                <c:pt idx="295">
                  <c:v>395.3</c:v>
                </c:pt>
                <c:pt idx="296">
                  <c:v>396.64000000000038</c:v>
                </c:pt>
                <c:pt idx="297">
                  <c:v>397.97999999999894</c:v>
                </c:pt>
                <c:pt idx="298">
                  <c:v>399.32</c:v>
                </c:pt>
                <c:pt idx="299">
                  <c:v>400.66</c:v>
                </c:pt>
                <c:pt idx="300">
                  <c:v>402</c:v>
                </c:pt>
                <c:pt idx="301">
                  <c:v>403.34000000000032</c:v>
                </c:pt>
                <c:pt idx="302">
                  <c:v>404.68</c:v>
                </c:pt>
                <c:pt idx="303">
                  <c:v>406.02</c:v>
                </c:pt>
                <c:pt idx="304">
                  <c:v>407.36</c:v>
                </c:pt>
                <c:pt idx="305">
                  <c:v>408.7</c:v>
                </c:pt>
                <c:pt idx="306">
                  <c:v>410.04</c:v>
                </c:pt>
                <c:pt idx="307">
                  <c:v>411.38</c:v>
                </c:pt>
                <c:pt idx="308">
                  <c:v>412.71999999999969</c:v>
                </c:pt>
                <c:pt idx="309">
                  <c:v>414.06</c:v>
                </c:pt>
                <c:pt idx="310">
                  <c:v>415.4</c:v>
                </c:pt>
                <c:pt idx="311">
                  <c:v>416.74</c:v>
                </c:pt>
                <c:pt idx="312">
                  <c:v>418.08</c:v>
                </c:pt>
                <c:pt idx="313">
                  <c:v>419.41999999999899</c:v>
                </c:pt>
                <c:pt idx="314">
                  <c:v>420.76</c:v>
                </c:pt>
                <c:pt idx="315">
                  <c:v>422.1</c:v>
                </c:pt>
                <c:pt idx="316">
                  <c:v>423.44</c:v>
                </c:pt>
                <c:pt idx="317">
                  <c:v>424.78</c:v>
                </c:pt>
                <c:pt idx="318">
                  <c:v>426.12</c:v>
                </c:pt>
                <c:pt idx="319">
                  <c:v>427.46</c:v>
                </c:pt>
                <c:pt idx="320">
                  <c:v>428.8</c:v>
                </c:pt>
                <c:pt idx="321">
                  <c:v>430.14000000000038</c:v>
                </c:pt>
                <c:pt idx="322">
                  <c:v>431.47999999999894</c:v>
                </c:pt>
                <c:pt idx="323">
                  <c:v>432.82</c:v>
                </c:pt>
                <c:pt idx="324">
                  <c:v>434.16</c:v>
                </c:pt>
                <c:pt idx="325">
                  <c:v>435.5</c:v>
                </c:pt>
                <c:pt idx="326">
                  <c:v>436.84000000000032</c:v>
                </c:pt>
                <c:pt idx="327">
                  <c:v>438.18</c:v>
                </c:pt>
                <c:pt idx="328">
                  <c:v>439.52</c:v>
                </c:pt>
                <c:pt idx="329">
                  <c:v>440.86</c:v>
                </c:pt>
                <c:pt idx="330">
                  <c:v>442.2</c:v>
                </c:pt>
                <c:pt idx="331">
                  <c:v>443.54</c:v>
                </c:pt>
                <c:pt idx="332">
                  <c:v>444.88</c:v>
                </c:pt>
                <c:pt idx="333">
                  <c:v>446.21999999999969</c:v>
                </c:pt>
                <c:pt idx="334">
                  <c:v>447.56</c:v>
                </c:pt>
                <c:pt idx="335">
                  <c:v>448.9</c:v>
                </c:pt>
                <c:pt idx="336">
                  <c:v>450.24</c:v>
                </c:pt>
                <c:pt idx="337">
                  <c:v>451.58</c:v>
                </c:pt>
                <c:pt idx="338">
                  <c:v>452.91999999999899</c:v>
                </c:pt>
                <c:pt idx="339">
                  <c:v>454.26</c:v>
                </c:pt>
                <c:pt idx="340">
                  <c:v>455.6</c:v>
                </c:pt>
                <c:pt idx="341">
                  <c:v>456.94</c:v>
                </c:pt>
                <c:pt idx="342">
                  <c:v>458.28</c:v>
                </c:pt>
                <c:pt idx="343">
                  <c:v>459.62</c:v>
                </c:pt>
                <c:pt idx="344">
                  <c:v>460.96</c:v>
                </c:pt>
                <c:pt idx="345">
                  <c:v>462.3</c:v>
                </c:pt>
                <c:pt idx="346">
                  <c:v>463.64000000000038</c:v>
                </c:pt>
                <c:pt idx="347">
                  <c:v>464.97999999999894</c:v>
                </c:pt>
                <c:pt idx="348">
                  <c:v>466.32</c:v>
                </c:pt>
                <c:pt idx="349">
                  <c:v>467.66</c:v>
                </c:pt>
                <c:pt idx="350">
                  <c:v>469</c:v>
                </c:pt>
                <c:pt idx="351">
                  <c:v>470.34000000000032</c:v>
                </c:pt>
                <c:pt idx="352">
                  <c:v>471.68</c:v>
                </c:pt>
                <c:pt idx="353">
                  <c:v>473.02</c:v>
                </c:pt>
                <c:pt idx="354">
                  <c:v>474.36</c:v>
                </c:pt>
                <c:pt idx="355">
                  <c:v>475.7</c:v>
                </c:pt>
                <c:pt idx="356">
                  <c:v>477.04</c:v>
                </c:pt>
                <c:pt idx="357">
                  <c:v>478.38</c:v>
                </c:pt>
                <c:pt idx="358">
                  <c:v>479.71999999999969</c:v>
                </c:pt>
                <c:pt idx="359">
                  <c:v>481.06</c:v>
                </c:pt>
                <c:pt idx="360">
                  <c:v>482.4</c:v>
                </c:pt>
                <c:pt idx="361">
                  <c:v>483.74</c:v>
                </c:pt>
                <c:pt idx="362">
                  <c:v>485.08</c:v>
                </c:pt>
                <c:pt idx="363">
                  <c:v>486.41999999999899</c:v>
                </c:pt>
                <c:pt idx="364">
                  <c:v>487.76</c:v>
                </c:pt>
                <c:pt idx="365">
                  <c:v>489.1</c:v>
                </c:pt>
                <c:pt idx="366">
                  <c:v>490.44</c:v>
                </c:pt>
                <c:pt idx="367">
                  <c:v>491.78</c:v>
                </c:pt>
                <c:pt idx="368">
                  <c:v>493.12</c:v>
                </c:pt>
                <c:pt idx="369">
                  <c:v>494.46</c:v>
                </c:pt>
                <c:pt idx="370">
                  <c:v>495.8</c:v>
                </c:pt>
                <c:pt idx="371">
                  <c:v>497.14000000000038</c:v>
                </c:pt>
                <c:pt idx="372">
                  <c:v>498.47999999999894</c:v>
                </c:pt>
                <c:pt idx="373">
                  <c:v>499.82</c:v>
                </c:pt>
                <c:pt idx="374">
                  <c:v>501.16</c:v>
                </c:pt>
                <c:pt idx="375">
                  <c:v>502.5</c:v>
                </c:pt>
                <c:pt idx="376">
                  <c:v>503.84000000000032</c:v>
                </c:pt>
                <c:pt idx="377">
                  <c:v>505.18</c:v>
                </c:pt>
                <c:pt idx="378">
                  <c:v>506.52</c:v>
                </c:pt>
                <c:pt idx="379">
                  <c:v>507.86</c:v>
                </c:pt>
                <c:pt idx="380">
                  <c:v>509.2</c:v>
                </c:pt>
                <c:pt idx="381">
                  <c:v>510.54</c:v>
                </c:pt>
                <c:pt idx="382">
                  <c:v>511.88</c:v>
                </c:pt>
                <c:pt idx="383">
                  <c:v>513.22</c:v>
                </c:pt>
                <c:pt idx="384">
                  <c:v>514.55999999999949</c:v>
                </c:pt>
                <c:pt idx="385">
                  <c:v>515.9</c:v>
                </c:pt>
                <c:pt idx="386">
                  <c:v>517.24</c:v>
                </c:pt>
                <c:pt idx="387">
                  <c:v>518.58000000000004</c:v>
                </c:pt>
                <c:pt idx="388">
                  <c:v>519.91999999999996</c:v>
                </c:pt>
                <c:pt idx="389">
                  <c:v>519.91999999999996</c:v>
                </c:pt>
              </c:numCache>
            </c:numRef>
          </c:xVal>
          <c:yVal>
            <c:numRef>
              <c:f>'12july10_F5N_RyR2abN_1'!$D$1:$D$258</c:f>
              <c:numCache>
                <c:formatCode>General</c:formatCode>
                <c:ptCount val="258"/>
                <c:pt idx="0">
                  <c:v>1.0139216937299129</c:v>
                </c:pt>
                <c:pt idx="1">
                  <c:v>0.99523096923522381</c:v>
                </c:pt>
                <c:pt idx="2">
                  <c:v>1.0004599301495045</c:v>
                </c:pt>
                <c:pt idx="3">
                  <c:v>0.99903380801082986</c:v>
                </c:pt>
                <c:pt idx="4">
                  <c:v>0.99560973253022056</c:v>
                </c:pt>
                <c:pt idx="5">
                  <c:v>1.0200464160133746</c:v>
                </c:pt>
                <c:pt idx="6">
                  <c:v>0.99580003574290277</c:v>
                </c:pt>
                <c:pt idx="7">
                  <c:v>1.0076002172774134</c:v>
                </c:pt>
                <c:pt idx="8">
                  <c:v>0.97762262306161174</c:v>
                </c:pt>
                <c:pt idx="9">
                  <c:v>0.98287324075795834</c:v>
                </c:pt>
                <c:pt idx="10">
                  <c:v>0.98109876697572118</c:v>
                </c:pt>
                <c:pt idx="11">
                  <c:v>0.97233145649670072</c:v>
                </c:pt>
                <c:pt idx="12">
                  <c:v>0.99386889587757932</c:v>
                </c:pt>
                <c:pt idx="13">
                  <c:v>0.98457260697684257</c:v>
                </c:pt>
                <c:pt idx="14">
                  <c:v>0.98620654206690128</c:v>
                </c:pt>
                <c:pt idx="15">
                  <c:v>0.98122824688556454</c:v>
                </c:pt>
                <c:pt idx="16">
                  <c:v>0.9705772571487391</c:v>
                </c:pt>
                <c:pt idx="17">
                  <c:v>0.98519558504840732</c:v>
                </c:pt>
                <c:pt idx="18">
                  <c:v>0.98320408266283121</c:v>
                </c:pt>
                <c:pt idx="19">
                  <c:v>0.98303359310182659</c:v>
                </c:pt>
                <c:pt idx="20">
                  <c:v>0.98390769768892361</c:v>
                </c:pt>
                <c:pt idx="21">
                  <c:v>0.97227478023722846</c:v>
                </c:pt>
                <c:pt idx="22">
                  <c:v>0.98017397630291858</c:v>
                </c:pt>
                <c:pt idx="23">
                  <c:v>0.98615862067678561</c:v>
                </c:pt>
                <c:pt idx="24">
                  <c:v>0.96666198741939413</c:v>
                </c:pt>
                <c:pt idx="25">
                  <c:v>0.96842125537592161</c:v>
                </c:pt>
                <c:pt idx="26">
                  <c:v>0.98917029573280457</c:v>
                </c:pt>
                <c:pt idx="27">
                  <c:v>0.96963587830243581</c:v>
                </c:pt>
                <c:pt idx="28">
                  <c:v>0.97929664623764068</c:v>
                </c:pt>
                <c:pt idx="29">
                  <c:v>0.96427743747831463</c:v>
                </c:pt>
                <c:pt idx="30">
                  <c:v>0.96881522449662272</c:v>
                </c:pt>
                <c:pt idx="31">
                  <c:v>0.95655610349518161</c:v>
                </c:pt>
                <c:pt idx="32">
                  <c:v>0.97103896131124157</c:v>
                </c:pt>
                <c:pt idx="33">
                  <c:v>0.9849103606206715</c:v>
                </c:pt>
                <c:pt idx="34">
                  <c:v>0.97990165378790761</c:v>
                </c:pt>
                <c:pt idx="35">
                  <c:v>0.9801122314348788</c:v>
                </c:pt>
                <c:pt idx="36">
                  <c:v>0.97411192045270445</c:v>
                </c:pt>
                <c:pt idx="37">
                  <c:v>0.97783550462156865</c:v>
                </c:pt>
                <c:pt idx="38">
                  <c:v>0.99870941706232363</c:v>
                </c:pt>
                <c:pt idx="39">
                  <c:v>0.97810275852800865</c:v>
                </c:pt>
                <c:pt idx="40">
                  <c:v>0.9906323589140712</c:v>
                </c:pt>
                <c:pt idx="41">
                  <c:v>0.99357537736309265</c:v>
                </c:pt>
                <c:pt idx="42">
                  <c:v>0.9988379754069725</c:v>
                </c:pt>
                <c:pt idx="43">
                  <c:v>0.97493948599747315</c:v>
                </c:pt>
                <c:pt idx="44">
                  <c:v>0.96551279562169856</c:v>
                </c:pt>
                <c:pt idx="45">
                  <c:v>0.96758493496180353</c:v>
                </c:pt>
                <c:pt idx="46">
                  <c:v>0.96436406460660351</c:v>
                </c:pt>
                <c:pt idx="47">
                  <c:v>0.95540460778450265</c:v>
                </c:pt>
                <c:pt idx="48">
                  <c:v>0.9653146591048567</c:v>
                </c:pt>
                <c:pt idx="49">
                  <c:v>0.98189638165165982</c:v>
                </c:pt>
                <c:pt idx="50">
                  <c:v>0.97347880516399965</c:v>
                </c:pt>
                <c:pt idx="51">
                  <c:v>0.97253189692652764</c:v>
                </c:pt>
                <c:pt idx="52">
                  <c:v>0.98924217781798296</c:v>
                </c:pt>
                <c:pt idx="53">
                  <c:v>0.98433899020000648</c:v>
                </c:pt>
                <c:pt idx="54">
                  <c:v>0.98468918497395885</c:v>
                </c:pt>
                <c:pt idx="55">
                  <c:v>0.96830375581360806</c:v>
                </c:pt>
                <c:pt idx="56">
                  <c:v>1.0143327118067322</c:v>
                </c:pt>
                <c:pt idx="57">
                  <c:v>0.97035930698020845</c:v>
                </c:pt>
                <c:pt idx="58">
                  <c:v>0.98890258104376361</c:v>
                </c:pt>
                <c:pt idx="59">
                  <c:v>0.98904404130114176</c:v>
                </c:pt>
                <c:pt idx="60">
                  <c:v>0.98158581418107715</c:v>
                </c:pt>
                <c:pt idx="61">
                  <c:v>0.98296862275560459</c:v>
                </c:pt>
                <c:pt idx="62">
                  <c:v>0.97265999448858731</c:v>
                </c:pt>
                <c:pt idx="63">
                  <c:v>0.98818606410494658</c:v>
                </c:pt>
                <c:pt idx="64">
                  <c:v>0.97673884203997463</c:v>
                </c:pt>
                <c:pt idx="65">
                  <c:v>0.98062554324828599</c:v>
                </c:pt>
                <c:pt idx="66">
                  <c:v>1.0062155655725156</c:v>
                </c:pt>
                <c:pt idx="67">
                  <c:v>0.98109047288896822</c:v>
                </c:pt>
                <c:pt idx="68">
                  <c:v>0.99048536926552555</c:v>
                </c:pt>
                <c:pt idx="69">
                  <c:v>0.99244277373890033</c:v>
                </c:pt>
                <c:pt idx="70">
                  <c:v>0.99864767219428696</c:v>
                </c:pt>
                <c:pt idx="71">
                  <c:v>0.99629998486098759</c:v>
                </c:pt>
                <c:pt idx="72">
                  <c:v>1.0008824677912445</c:v>
                </c:pt>
                <c:pt idx="73">
                  <c:v>0.99354634805945885</c:v>
                </c:pt>
                <c:pt idx="74">
                  <c:v>0.99488584306984262</c:v>
                </c:pt>
                <c:pt idx="75">
                  <c:v>0.97560715998097669</c:v>
                </c:pt>
                <c:pt idx="76">
                  <c:v>0.98432240202650279</c:v>
                </c:pt>
                <c:pt idx="77">
                  <c:v>1.0047065025663175</c:v>
                </c:pt>
                <c:pt idx="78">
                  <c:v>0.98941957911794409</c:v>
                </c:pt>
                <c:pt idx="79">
                  <c:v>0.98387221742893194</c:v>
                </c:pt>
                <c:pt idx="80">
                  <c:v>0.98996330258277654</c:v>
                </c:pt>
                <c:pt idx="81">
                  <c:v>0.98798838837070357</c:v>
                </c:pt>
                <c:pt idx="82">
                  <c:v>0.98901316886711588</c:v>
                </c:pt>
                <c:pt idx="83">
                  <c:v>0.99907527844459298</c:v>
                </c:pt>
                <c:pt idx="84">
                  <c:v>0.99618110295088114</c:v>
                </c:pt>
                <c:pt idx="85">
                  <c:v>0.98704931343738855</c:v>
                </c:pt>
                <c:pt idx="86">
                  <c:v>0.98299949518962515</c:v>
                </c:pt>
                <c:pt idx="87">
                  <c:v>0.98428692176650623</c:v>
                </c:pt>
                <c:pt idx="88">
                  <c:v>1.0038982898906286</c:v>
                </c:pt>
                <c:pt idx="89">
                  <c:v>0.97864832512322564</c:v>
                </c:pt>
                <c:pt idx="90">
                  <c:v>0.98827407358103769</c:v>
                </c:pt>
                <c:pt idx="91">
                  <c:v>0.98622958119677151</c:v>
                </c:pt>
                <c:pt idx="92">
                  <c:v>1.0002627151978574</c:v>
                </c:pt>
                <c:pt idx="93">
                  <c:v>0.98530156504578759</c:v>
                </c:pt>
                <c:pt idx="94">
                  <c:v>0.97640477465692077</c:v>
                </c:pt>
                <c:pt idx="95">
                  <c:v>0.98532598652344505</c:v>
                </c:pt>
                <c:pt idx="96">
                  <c:v>0.98207332216903109</c:v>
                </c:pt>
                <c:pt idx="97">
                  <c:v>0.98957716676622387</c:v>
                </c:pt>
                <c:pt idx="98">
                  <c:v>0.97868011912243891</c:v>
                </c:pt>
                <c:pt idx="99">
                  <c:v>0.98257972224347945</c:v>
                </c:pt>
                <c:pt idx="100">
                  <c:v>0.96319321602684238</c:v>
                </c:pt>
                <c:pt idx="101">
                  <c:v>0.96207259275017964</c:v>
                </c:pt>
                <c:pt idx="102">
                  <c:v>0.97546247424542087</c:v>
                </c:pt>
                <c:pt idx="103">
                  <c:v>0.96584686300474965</c:v>
                </c:pt>
                <c:pt idx="104">
                  <c:v>0.95264359846142233</c:v>
                </c:pt>
                <c:pt idx="105">
                  <c:v>0.95281362723982665</c:v>
                </c:pt>
                <c:pt idx="106">
                  <c:v>0.97513163234055811</c:v>
                </c:pt>
                <c:pt idx="107">
                  <c:v>0.95496363883888002</c:v>
                </c:pt>
                <c:pt idx="108">
                  <c:v>0.9668163495894897</c:v>
                </c:pt>
                <c:pt idx="109">
                  <c:v>0.95720949321817073</c:v>
                </c:pt>
                <c:pt idx="110">
                  <c:v>0.94755010763075032</c:v>
                </c:pt>
                <c:pt idx="111">
                  <c:v>0.95619162446071171</c:v>
                </c:pt>
                <c:pt idx="112">
                  <c:v>0.94290311513687664</c:v>
                </c:pt>
                <c:pt idx="113">
                  <c:v>0.9275512213422884</c:v>
                </c:pt>
                <c:pt idx="114">
                  <c:v>0.95577922403612003</c:v>
                </c:pt>
                <c:pt idx="115">
                  <c:v>0.9362683065182047</c:v>
                </c:pt>
                <c:pt idx="116">
                  <c:v>0.93766263465766697</c:v>
                </c:pt>
                <c:pt idx="117">
                  <c:v>0.92162141009750786</c:v>
                </c:pt>
                <c:pt idx="118">
                  <c:v>0.91370147881493335</c:v>
                </c:pt>
                <c:pt idx="119">
                  <c:v>0.92367097109033869</c:v>
                </c:pt>
                <c:pt idx="120">
                  <c:v>0.93932006966019455</c:v>
                </c:pt>
                <c:pt idx="121">
                  <c:v>0.91970731918827564</c:v>
                </c:pt>
                <c:pt idx="122">
                  <c:v>0.92687617483722495</c:v>
                </c:pt>
                <c:pt idx="123">
                  <c:v>0.94199214794199349</c:v>
                </c:pt>
                <c:pt idx="124">
                  <c:v>0.91977321109969368</c:v>
                </c:pt>
                <c:pt idx="125">
                  <c:v>0.92426215516268351</c:v>
                </c:pt>
                <c:pt idx="126">
                  <c:v>0.90698649402433018</c:v>
                </c:pt>
                <c:pt idx="127">
                  <c:v>0.90729291445154114</c:v>
                </c:pt>
                <c:pt idx="128">
                  <c:v>0.90314218481496433</c:v>
                </c:pt>
                <c:pt idx="129">
                  <c:v>0.9082674696448515</c:v>
                </c:pt>
                <c:pt idx="130">
                  <c:v>0.89017944878743549</c:v>
                </c:pt>
                <c:pt idx="131">
                  <c:v>0.8943214235546586</c:v>
                </c:pt>
                <c:pt idx="132">
                  <c:v>0.91050088289401498</c:v>
                </c:pt>
                <c:pt idx="133">
                  <c:v>0.8856098677699098</c:v>
                </c:pt>
                <c:pt idx="134">
                  <c:v>0.89263495924850456</c:v>
                </c:pt>
                <c:pt idx="135">
                  <c:v>0.9083729888596318</c:v>
                </c:pt>
                <c:pt idx="136">
                  <c:v>0.89788972398822853</c:v>
                </c:pt>
                <c:pt idx="137">
                  <c:v>0.89445965833385388</c:v>
                </c:pt>
                <c:pt idx="138">
                  <c:v>0.90194507162715865</c:v>
                </c:pt>
                <c:pt idx="139">
                  <c:v>0.91158233964990021</c:v>
                </c:pt>
                <c:pt idx="140">
                  <c:v>0.88823125996600749</c:v>
                </c:pt>
                <c:pt idx="141">
                  <c:v>0.89909559204539413</c:v>
                </c:pt>
                <c:pt idx="142">
                  <c:v>0.86565060878481859</c:v>
                </c:pt>
                <c:pt idx="143">
                  <c:v>0.87828480682046672</c:v>
                </c:pt>
                <c:pt idx="144">
                  <c:v>0.88409112832917858</c:v>
                </c:pt>
                <c:pt idx="145">
                  <c:v>0.87383456849564478</c:v>
                </c:pt>
                <c:pt idx="146">
                  <c:v>0.88240696793600171</c:v>
                </c:pt>
                <c:pt idx="147">
                  <c:v>0.87101365743491299</c:v>
                </c:pt>
                <c:pt idx="148">
                  <c:v>0.87028239545297859</c:v>
                </c:pt>
                <c:pt idx="149">
                  <c:v>0.87619147148089283</c:v>
                </c:pt>
                <c:pt idx="150">
                  <c:v>0.85671050483180122</c:v>
                </c:pt>
                <c:pt idx="151">
                  <c:v>0.86378536083090429</c:v>
                </c:pt>
                <c:pt idx="152">
                  <c:v>0.86904888043998241</c:v>
                </c:pt>
                <c:pt idx="153">
                  <c:v>0.85392277011807716</c:v>
                </c:pt>
                <c:pt idx="154">
                  <c:v>0.87683518476932909</c:v>
                </c:pt>
                <c:pt idx="155">
                  <c:v>0.8449241467752</c:v>
                </c:pt>
                <c:pt idx="156">
                  <c:v>0.82972615436811803</c:v>
                </c:pt>
                <c:pt idx="157">
                  <c:v>0.83136700119713558</c:v>
                </c:pt>
                <c:pt idx="158">
                  <c:v>0.84915735649669344</c:v>
                </c:pt>
                <c:pt idx="159">
                  <c:v>0.84254051839931365</c:v>
                </c:pt>
                <c:pt idx="160">
                  <c:v>0.82438937032606607</c:v>
                </c:pt>
                <c:pt idx="161">
                  <c:v>0.84239675422895344</c:v>
                </c:pt>
                <c:pt idx="162">
                  <c:v>0.84951400222700912</c:v>
                </c:pt>
                <c:pt idx="163">
                  <c:v>0.80935311261063625</c:v>
                </c:pt>
                <c:pt idx="164">
                  <c:v>0.84248292057465046</c:v>
                </c:pt>
                <c:pt idx="165">
                  <c:v>0.82840923770500263</c:v>
                </c:pt>
                <c:pt idx="166">
                  <c:v>0.82002760225992977</c:v>
                </c:pt>
                <c:pt idx="167">
                  <c:v>0.82393365633732663</c:v>
                </c:pt>
                <c:pt idx="168">
                  <c:v>0.80776433421511062</c:v>
                </c:pt>
                <c:pt idx="169">
                  <c:v>0.82458750684290505</c:v>
                </c:pt>
                <c:pt idx="170">
                  <c:v>0.81167868237926299</c:v>
                </c:pt>
                <c:pt idx="171">
                  <c:v>0.80244736382474546</c:v>
                </c:pt>
                <c:pt idx="172">
                  <c:v>0.7944583151525807</c:v>
                </c:pt>
                <c:pt idx="173">
                  <c:v>0.79204565747306876</c:v>
                </c:pt>
                <c:pt idx="174">
                  <c:v>0.78997996908932078</c:v>
                </c:pt>
                <c:pt idx="175">
                  <c:v>0.79229586242340733</c:v>
                </c:pt>
                <c:pt idx="176">
                  <c:v>0.80899370218473465</c:v>
                </c:pt>
                <c:pt idx="177">
                  <c:v>0.80121845663771984</c:v>
                </c:pt>
                <c:pt idx="178">
                  <c:v>0.80831589098409062</c:v>
                </c:pt>
                <c:pt idx="179">
                  <c:v>0.78286133874347474</c:v>
                </c:pt>
                <c:pt idx="180">
                  <c:v>0.77472944746614814</c:v>
                </c:pt>
                <c:pt idx="181">
                  <c:v>0.79488822531586989</c:v>
                </c:pt>
                <c:pt idx="182">
                  <c:v>0.7755846599667493</c:v>
                </c:pt>
                <c:pt idx="183">
                  <c:v>0.77746695687676159</c:v>
                </c:pt>
                <c:pt idx="184">
                  <c:v>0.77554503266338948</c:v>
                </c:pt>
                <c:pt idx="185">
                  <c:v>0.77449490912411312</c:v>
                </c:pt>
                <c:pt idx="186">
                  <c:v>0.77261998473565452</c:v>
                </c:pt>
                <c:pt idx="187">
                  <c:v>0.77022990540341119</c:v>
                </c:pt>
                <c:pt idx="188">
                  <c:v>0.77410600861198064</c:v>
                </c:pt>
                <c:pt idx="189">
                  <c:v>0.7513235346531697</c:v>
                </c:pt>
                <c:pt idx="190">
                  <c:v>0.74745710787913633</c:v>
                </c:pt>
                <c:pt idx="191">
                  <c:v>0.7637701941717161</c:v>
                </c:pt>
                <c:pt idx="192">
                  <c:v>0.76956130985470828</c:v>
                </c:pt>
                <c:pt idx="193">
                  <c:v>0.75796617657599263</c:v>
                </c:pt>
                <c:pt idx="194">
                  <c:v>0.77548328779534048</c:v>
                </c:pt>
                <c:pt idx="195">
                  <c:v>0.75334498790756688</c:v>
                </c:pt>
                <c:pt idx="196">
                  <c:v>0.74635675903675858</c:v>
                </c:pt>
                <c:pt idx="197">
                  <c:v>0.74666225789877894</c:v>
                </c:pt>
                <c:pt idx="198">
                  <c:v>0.76084606780918573</c:v>
                </c:pt>
                <c:pt idx="199">
                  <c:v>0.76881253813408268</c:v>
                </c:pt>
                <c:pt idx="200">
                  <c:v>0.75338737990651927</c:v>
                </c:pt>
                <c:pt idx="201">
                  <c:v>0.7758726490900687</c:v>
                </c:pt>
                <c:pt idx="202">
                  <c:v>0.7566875048684556</c:v>
                </c:pt>
                <c:pt idx="203">
                  <c:v>0.76440976041678266</c:v>
                </c:pt>
                <c:pt idx="204">
                  <c:v>0.75940151436661374</c:v>
                </c:pt>
                <c:pt idx="205">
                  <c:v>0.76614460689565611</c:v>
                </c:pt>
                <c:pt idx="206">
                  <c:v>0.74775154795882015</c:v>
                </c:pt>
                <c:pt idx="207">
                  <c:v>0.77193203631787566</c:v>
                </c:pt>
                <c:pt idx="208">
                  <c:v>0.77734208479289169</c:v>
                </c:pt>
                <c:pt idx="209">
                  <c:v>0.75487570769583756</c:v>
                </c:pt>
                <c:pt idx="210">
                  <c:v>0.75666769121677468</c:v>
                </c:pt>
                <c:pt idx="211">
                  <c:v>0.7534818403389677</c:v>
                </c:pt>
                <c:pt idx="212">
                  <c:v>0.75647231939551263</c:v>
                </c:pt>
                <c:pt idx="213">
                  <c:v>0.74983658921164265</c:v>
                </c:pt>
                <c:pt idx="214">
                  <c:v>0.76584463742481168</c:v>
                </c:pt>
                <c:pt idx="215">
                  <c:v>0.74458090290672452</c:v>
                </c:pt>
                <c:pt idx="216">
                  <c:v>0.7424276658294946</c:v>
                </c:pt>
                <c:pt idx="217">
                  <c:v>0.7421650197490266</c:v>
                </c:pt>
                <c:pt idx="218">
                  <c:v>0.76094144980682565</c:v>
                </c:pt>
                <c:pt idx="219">
                  <c:v>0.75612166383895962</c:v>
                </c:pt>
                <c:pt idx="220">
                  <c:v>0.76048112799211232</c:v>
                </c:pt>
                <c:pt idx="221">
                  <c:v>0.74459656951503428</c:v>
                </c:pt>
                <c:pt idx="222">
                  <c:v>0.75611060505662253</c:v>
                </c:pt>
                <c:pt idx="223">
                  <c:v>0.73651997214938203</c:v>
                </c:pt>
                <c:pt idx="224">
                  <c:v>0.75667460295573541</c:v>
                </c:pt>
                <c:pt idx="225">
                  <c:v>0.75896331011657503</c:v>
                </c:pt>
                <c:pt idx="226">
                  <c:v>0.74313128085558966</c:v>
                </c:pt>
                <c:pt idx="227">
                  <c:v>0.73790185915871764</c:v>
                </c:pt>
                <c:pt idx="228">
                  <c:v>0.74360726927860865</c:v>
                </c:pt>
                <c:pt idx="229">
                  <c:v>0.75531114725029025</c:v>
                </c:pt>
                <c:pt idx="230">
                  <c:v>0.74543427227694392</c:v>
                </c:pt>
                <c:pt idx="231">
                  <c:v>0.73029157378153564</c:v>
                </c:pt>
                <c:pt idx="232">
                  <c:v>0.73951275511890757</c:v>
                </c:pt>
                <c:pt idx="233">
                  <c:v>0.74150241437409792</c:v>
                </c:pt>
                <c:pt idx="234">
                  <c:v>0.74471176516436166</c:v>
                </c:pt>
                <c:pt idx="235">
                  <c:v>0.74926752270396757</c:v>
                </c:pt>
                <c:pt idx="236">
                  <c:v>0.74353861267161281</c:v>
                </c:pt>
                <c:pt idx="237">
                  <c:v>0.75513098125474132</c:v>
                </c:pt>
                <c:pt idx="238">
                  <c:v>0.75153595543052765</c:v>
                </c:pt>
                <c:pt idx="239">
                  <c:v>0.75534063733652446</c:v>
                </c:pt>
                <c:pt idx="240">
                  <c:v>0.74522139071698679</c:v>
                </c:pt>
                <c:pt idx="241">
                  <c:v>0.75396381893575404</c:v>
                </c:pt>
                <c:pt idx="242">
                  <c:v>0.72418436123678331</c:v>
                </c:pt>
                <c:pt idx="243">
                  <c:v>0.73498187983955665</c:v>
                </c:pt>
                <c:pt idx="244">
                  <c:v>0.75639352557137263</c:v>
                </c:pt>
                <c:pt idx="245">
                  <c:v>0.73737149838921112</c:v>
                </c:pt>
                <c:pt idx="246">
                  <c:v>0.74323910398335735</c:v>
                </c:pt>
                <c:pt idx="247">
                  <c:v>0.73164581383503546</c:v>
                </c:pt>
                <c:pt idx="248">
                  <c:v>0.7483081733363679</c:v>
                </c:pt>
                <c:pt idx="249">
                  <c:v>0.75500795230126072</c:v>
                </c:pt>
                <c:pt idx="250">
                  <c:v>0.75392833867576592</c:v>
                </c:pt>
                <c:pt idx="251">
                  <c:v>0.73933443225375428</c:v>
                </c:pt>
                <c:pt idx="252">
                  <c:v>0.75240176593087282</c:v>
                </c:pt>
                <c:pt idx="253">
                  <c:v>0.75513466751552416</c:v>
                </c:pt>
                <c:pt idx="254">
                  <c:v>0.75201839480991151</c:v>
                </c:pt>
                <c:pt idx="255">
                  <c:v>0.75115166274437406</c:v>
                </c:pt>
                <c:pt idx="256">
                  <c:v>0.74611300504278155</c:v>
                </c:pt>
                <c:pt idx="257">
                  <c:v>0.7603599421690229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49316600"/>
        <c:axId val="249316992"/>
      </c:scatterChart>
      <c:valAx>
        <c:axId val="249316600"/>
        <c:scaling>
          <c:orientation val="minMax"/>
          <c:max val="35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/>
                  <a:t>Time, s</a:t>
                </a:r>
              </a:p>
            </c:rich>
          </c:tx>
          <c:layout>
            <c:manualLayout>
              <c:xMode val="edge"/>
              <c:yMode val="edge"/>
              <c:x val="0.74131168449473173"/>
              <c:y val="0.9052967913424800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 rot="0" vert="horz"/>
          <a:lstStyle/>
          <a:p>
            <a:pPr>
              <a:defRPr sz="1200" b="1" i="0" u="none" strike="noStrike" baseline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</a:defRPr>
            </a:pPr>
            <a:endParaRPr lang="en-US"/>
          </a:p>
        </c:txPr>
        <c:crossAx val="249316992"/>
        <c:crosses val="autoZero"/>
        <c:crossBetween val="midCat"/>
        <c:majorUnit val="100"/>
        <c:minorUnit val="20"/>
      </c:valAx>
      <c:valAx>
        <c:axId val="249316992"/>
        <c:scaling>
          <c:orientation val="minMax"/>
          <c:max val="1.1000000000000001"/>
          <c:min val="0.60000000000000064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prstClr val="black"/>
            </a:solidFill>
          </a:ln>
        </c:spPr>
        <c:crossAx val="249316600"/>
        <c:crosses val="autoZero"/>
        <c:crossBetween val="midCat"/>
        <c:majorUnit val="0.1"/>
        <c:minorUnit val="4.0000000000000022E-2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 b="1">
          <a:latin typeface="Times New Roman" pitchFamily="18" charset="0"/>
          <a:cs typeface="Times New Roman" pitchFamily="18" charset="0"/>
        </a:defRPr>
      </a:pPr>
      <a:endParaRPr lang="en-US"/>
    </a:p>
  </c:txPr>
  <c:externalData r:id="rId2">
    <c:autoUpdate val="0"/>
  </c:externalData>
  <c:userShapes r:id="rId3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6391666666666671"/>
          <c:y val="0.11990740740740741"/>
          <c:w val="0.78052777777777749"/>
          <c:h val="0.61245370370370367"/>
        </c:manualLayout>
      </c:layout>
      <c:scatterChart>
        <c:scatterStyle val="smoothMarker"/>
        <c:varyColors val="0"/>
        <c:ser>
          <c:idx val="1"/>
          <c:order val="0"/>
          <c:spPr>
            <a:ln>
              <a:solidFill>
                <a:schemeClr val="tx1"/>
              </a:solidFill>
            </a:ln>
          </c:spPr>
          <c:marker>
            <c:symbol val="none"/>
          </c:marker>
          <c:xVal>
            <c:numRef>
              <c:f>'14july10_F5N_RyR2ab cADPR_2'!$A$1:$A$502</c:f>
              <c:numCache>
                <c:formatCode>General</c:formatCode>
                <c:ptCount val="502"/>
                <c:pt idx="0">
                  <c:v>0</c:v>
                </c:pt>
                <c:pt idx="1">
                  <c:v>1.34</c:v>
                </c:pt>
                <c:pt idx="2">
                  <c:v>2.68</c:v>
                </c:pt>
                <c:pt idx="3">
                  <c:v>4.0199999999999996</c:v>
                </c:pt>
                <c:pt idx="4">
                  <c:v>5.3599999999999985</c:v>
                </c:pt>
                <c:pt idx="5">
                  <c:v>6.7</c:v>
                </c:pt>
                <c:pt idx="6">
                  <c:v>8.0400000000000009</c:v>
                </c:pt>
                <c:pt idx="7">
                  <c:v>9.3800000000000008</c:v>
                </c:pt>
                <c:pt idx="8">
                  <c:v>10.72</c:v>
                </c:pt>
                <c:pt idx="9">
                  <c:v>12.06</c:v>
                </c:pt>
                <c:pt idx="10">
                  <c:v>13.4</c:v>
                </c:pt>
                <c:pt idx="11">
                  <c:v>14.74</c:v>
                </c:pt>
                <c:pt idx="12">
                  <c:v>16.079999999999988</c:v>
                </c:pt>
                <c:pt idx="13">
                  <c:v>17.420000000000002</c:v>
                </c:pt>
                <c:pt idx="14">
                  <c:v>18.760000000000002</c:v>
                </c:pt>
                <c:pt idx="15">
                  <c:v>20.100000000000001</c:v>
                </c:pt>
                <c:pt idx="16">
                  <c:v>21.439999999999987</c:v>
                </c:pt>
                <c:pt idx="17">
                  <c:v>22.779999999999987</c:v>
                </c:pt>
                <c:pt idx="18">
                  <c:v>24.12</c:v>
                </c:pt>
                <c:pt idx="19">
                  <c:v>25.459999999999987</c:v>
                </c:pt>
                <c:pt idx="20">
                  <c:v>26.8</c:v>
                </c:pt>
                <c:pt idx="21">
                  <c:v>28.14</c:v>
                </c:pt>
                <c:pt idx="22">
                  <c:v>29.479999999999986</c:v>
                </c:pt>
                <c:pt idx="23">
                  <c:v>30.82</c:v>
                </c:pt>
                <c:pt idx="24">
                  <c:v>32.160000000000011</c:v>
                </c:pt>
                <c:pt idx="25">
                  <c:v>33.5</c:v>
                </c:pt>
                <c:pt idx="26">
                  <c:v>34.840000000000003</c:v>
                </c:pt>
                <c:pt idx="27">
                  <c:v>36.18</c:v>
                </c:pt>
                <c:pt idx="28">
                  <c:v>37.520000000000003</c:v>
                </c:pt>
                <c:pt idx="29">
                  <c:v>38.86</c:v>
                </c:pt>
                <c:pt idx="30">
                  <c:v>40.200000000000003</c:v>
                </c:pt>
                <c:pt idx="31">
                  <c:v>41.54</c:v>
                </c:pt>
                <c:pt idx="32">
                  <c:v>42.88</c:v>
                </c:pt>
                <c:pt idx="33">
                  <c:v>44.220000000000013</c:v>
                </c:pt>
                <c:pt idx="34">
                  <c:v>45.56</c:v>
                </c:pt>
                <c:pt idx="35">
                  <c:v>46.9</c:v>
                </c:pt>
                <c:pt idx="36">
                  <c:v>48.24</c:v>
                </c:pt>
                <c:pt idx="37">
                  <c:v>49.58</c:v>
                </c:pt>
                <c:pt idx="38">
                  <c:v>50.92</c:v>
                </c:pt>
                <c:pt idx="39">
                  <c:v>52.260000000000012</c:v>
                </c:pt>
                <c:pt idx="40">
                  <c:v>53.6</c:v>
                </c:pt>
                <c:pt idx="41">
                  <c:v>54.94</c:v>
                </c:pt>
                <c:pt idx="42">
                  <c:v>56.28</c:v>
                </c:pt>
                <c:pt idx="43">
                  <c:v>57.620000000000012</c:v>
                </c:pt>
                <c:pt idx="44">
                  <c:v>58.96</c:v>
                </c:pt>
                <c:pt idx="45">
                  <c:v>60.3</c:v>
                </c:pt>
                <c:pt idx="46">
                  <c:v>61.64</c:v>
                </c:pt>
                <c:pt idx="47">
                  <c:v>62.98</c:v>
                </c:pt>
                <c:pt idx="48">
                  <c:v>64.319999999999993</c:v>
                </c:pt>
                <c:pt idx="49">
                  <c:v>65.66</c:v>
                </c:pt>
                <c:pt idx="50">
                  <c:v>67</c:v>
                </c:pt>
                <c:pt idx="51">
                  <c:v>68.34</c:v>
                </c:pt>
                <c:pt idx="52">
                  <c:v>69.679999999999978</c:v>
                </c:pt>
                <c:pt idx="53">
                  <c:v>71.02</c:v>
                </c:pt>
                <c:pt idx="54">
                  <c:v>72.36</c:v>
                </c:pt>
                <c:pt idx="55">
                  <c:v>73.7</c:v>
                </c:pt>
                <c:pt idx="56">
                  <c:v>75.040000000000006</c:v>
                </c:pt>
                <c:pt idx="57">
                  <c:v>76.38</c:v>
                </c:pt>
                <c:pt idx="58">
                  <c:v>77.72</c:v>
                </c:pt>
                <c:pt idx="59">
                  <c:v>79.06</c:v>
                </c:pt>
                <c:pt idx="60">
                  <c:v>80.400000000000006</c:v>
                </c:pt>
                <c:pt idx="61">
                  <c:v>81.739999999999995</c:v>
                </c:pt>
                <c:pt idx="62">
                  <c:v>83.08</c:v>
                </c:pt>
                <c:pt idx="63">
                  <c:v>84.42</c:v>
                </c:pt>
                <c:pt idx="64">
                  <c:v>85.76</c:v>
                </c:pt>
                <c:pt idx="65">
                  <c:v>87.1</c:v>
                </c:pt>
                <c:pt idx="66">
                  <c:v>88.440000000000026</c:v>
                </c:pt>
                <c:pt idx="67">
                  <c:v>89.78</c:v>
                </c:pt>
                <c:pt idx="68">
                  <c:v>91.11999999999999</c:v>
                </c:pt>
                <c:pt idx="69">
                  <c:v>92.460000000000022</c:v>
                </c:pt>
                <c:pt idx="70">
                  <c:v>93.8</c:v>
                </c:pt>
                <c:pt idx="71">
                  <c:v>95.14</c:v>
                </c:pt>
                <c:pt idx="72">
                  <c:v>96.48</c:v>
                </c:pt>
                <c:pt idx="73">
                  <c:v>97.82</c:v>
                </c:pt>
                <c:pt idx="74">
                  <c:v>99.16</c:v>
                </c:pt>
                <c:pt idx="75">
                  <c:v>100.5</c:v>
                </c:pt>
                <c:pt idx="76">
                  <c:v>101.84</c:v>
                </c:pt>
                <c:pt idx="77">
                  <c:v>103.17999999999998</c:v>
                </c:pt>
                <c:pt idx="78">
                  <c:v>104.52</c:v>
                </c:pt>
                <c:pt idx="79">
                  <c:v>105.86</c:v>
                </c:pt>
                <c:pt idx="80">
                  <c:v>107.2</c:v>
                </c:pt>
                <c:pt idx="81">
                  <c:v>108.54</c:v>
                </c:pt>
                <c:pt idx="82">
                  <c:v>109.88</c:v>
                </c:pt>
                <c:pt idx="83">
                  <c:v>111.22</c:v>
                </c:pt>
                <c:pt idx="84">
                  <c:v>112.56</c:v>
                </c:pt>
                <c:pt idx="85">
                  <c:v>113.9</c:v>
                </c:pt>
                <c:pt idx="86">
                  <c:v>115.24000000000002</c:v>
                </c:pt>
                <c:pt idx="87">
                  <c:v>116.58</c:v>
                </c:pt>
                <c:pt idx="88">
                  <c:v>117.92</c:v>
                </c:pt>
                <c:pt idx="89">
                  <c:v>119.26</c:v>
                </c:pt>
                <c:pt idx="90">
                  <c:v>120.6</c:v>
                </c:pt>
                <c:pt idx="91">
                  <c:v>121.94000000000025</c:v>
                </c:pt>
                <c:pt idx="92">
                  <c:v>123.28</c:v>
                </c:pt>
                <c:pt idx="93">
                  <c:v>124.61999999999999</c:v>
                </c:pt>
                <c:pt idx="94">
                  <c:v>125.96000000000002</c:v>
                </c:pt>
                <c:pt idx="95">
                  <c:v>127.3</c:v>
                </c:pt>
                <c:pt idx="96">
                  <c:v>128.63999999999999</c:v>
                </c:pt>
                <c:pt idx="97">
                  <c:v>129.97999999999999</c:v>
                </c:pt>
                <c:pt idx="98">
                  <c:v>131.3200000000005</c:v>
                </c:pt>
                <c:pt idx="99">
                  <c:v>132.66</c:v>
                </c:pt>
                <c:pt idx="100">
                  <c:v>134</c:v>
                </c:pt>
                <c:pt idx="101">
                  <c:v>135.34</c:v>
                </c:pt>
                <c:pt idx="102">
                  <c:v>136.68</c:v>
                </c:pt>
                <c:pt idx="103">
                  <c:v>138.02000000000001</c:v>
                </c:pt>
                <c:pt idx="104">
                  <c:v>139.36000000000001</c:v>
                </c:pt>
                <c:pt idx="105">
                  <c:v>140.69999999999999</c:v>
                </c:pt>
                <c:pt idx="106">
                  <c:v>142.04</c:v>
                </c:pt>
                <c:pt idx="107">
                  <c:v>143.38000000000051</c:v>
                </c:pt>
                <c:pt idx="108">
                  <c:v>144.72</c:v>
                </c:pt>
                <c:pt idx="109">
                  <c:v>146.06</c:v>
                </c:pt>
                <c:pt idx="110">
                  <c:v>147.4</c:v>
                </c:pt>
                <c:pt idx="111">
                  <c:v>148.73999999999998</c:v>
                </c:pt>
                <c:pt idx="112">
                  <c:v>150.08000000000001</c:v>
                </c:pt>
                <c:pt idx="113">
                  <c:v>151.41999999999999</c:v>
                </c:pt>
                <c:pt idx="114">
                  <c:v>152.76</c:v>
                </c:pt>
                <c:pt idx="115">
                  <c:v>154.1</c:v>
                </c:pt>
                <c:pt idx="116">
                  <c:v>155.44</c:v>
                </c:pt>
                <c:pt idx="117">
                  <c:v>156.78</c:v>
                </c:pt>
                <c:pt idx="118">
                  <c:v>158.12</c:v>
                </c:pt>
                <c:pt idx="119">
                  <c:v>159.46</c:v>
                </c:pt>
                <c:pt idx="120">
                  <c:v>160.80000000000001</c:v>
                </c:pt>
                <c:pt idx="121">
                  <c:v>162.13999999999999</c:v>
                </c:pt>
                <c:pt idx="122">
                  <c:v>163.47999999999999</c:v>
                </c:pt>
                <c:pt idx="123">
                  <c:v>164.8200000000005</c:v>
                </c:pt>
                <c:pt idx="124">
                  <c:v>166.16</c:v>
                </c:pt>
                <c:pt idx="125">
                  <c:v>167.5</c:v>
                </c:pt>
                <c:pt idx="126">
                  <c:v>168.84</c:v>
                </c:pt>
                <c:pt idx="127">
                  <c:v>170.18</c:v>
                </c:pt>
                <c:pt idx="128">
                  <c:v>171.52</c:v>
                </c:pt>
                <c:pt idx="129">
                  <c:v>172.86</c:v>
                </c:pt>
                <c:pt idx="130">
                  <c:v>174.2</c:v>
                </c:pt>
                <c:pt idx="131">
                  <c:v>175.54</c:v>
                </c:pt>
                <c:pt idx="132">
                  <c:v>176.88000000000051</c:v>
                </c:pt>
                <c:pt idx="133">
                  <c:v>178.22</c:v>
                </c:pt>
                <c:pt idx="134">
                  <c:v>179.56</c:v>
                </c:pt>
                <c:pt idx="135">
                  <c:v>180.9</c:v>
                </c:pt>
                <c:pt idx="136">
                  <c:v>182.23999999999998</c:v>
                </c:pt>
                <c:pt idx="137">
                  <c:v>183.58</c:v>
                </c:pt>
                <c:pt idx="138">
                  <c:v>184.92000000000004</c:v>
                </c:pt>
                <c:pt idx="139">
                  <c:v>186.26</c:v>
                </c:pt>
                <c:pt idx="140">
                  <c:v>187.6</c:v>
                </c:pt>
                <c:pt idx="141">
                  <c:v>188.94</c:v>
                </c:pt>
                <c:pt idx="142">
                  <c:v>190.28</c:v>
                </c:pt>
                <c:pt idx="143">
                  <c:v>191.62</c:v>
                </c:pt>
                <c:pt idx="144">
                  <c:v>192.96</c:v>
                </c:pt>
                <c:pt idx="145">
                  <c:v>194.3</c:v>
                </c:pt>
                <c:pt idx="146">
                  <c:v>195.64</c:v>
                </c:pt>
                <c:pt idx="147">
                  <c:v>196.98000000000027</c:v>
                </c:pt>
                <c:pt idx="148">
                  <c:v>198.3200000000005</c:v>
                </c:pt>
                <c:pt idx="149">
                  <c:v>199.66</c:v>
                </c:pt>
                <c:pt idx="150">
                  <c:v>201</c:v>
                </c:pt>
                <c:pt idx="151">
                  <c:v>202.34</c:v>
                </c:pt>
                <c:pt idx="152">
                  <c:v>203.68</c:v>
                </c:pt>
                <c:pt idx="153">
                  <c:v>205.02</c:v>
                </c:pt>
                <c:pt idx="154">
                  <c:v>206.36</c:v>
                </c:pt>
                <c:pt idx="155">
                  <c:v>207.7</c:v>
                </c:pt>
                <c:pt idx="156">
                  <c:v>209.04</c:v>
                </c:pt>
                <c:pt idx="157">
                  <c:v>210.38000000000051</c:v>
                </c:pt>
                <c:pt idx="158">
                  <c:v>211.72</c:v>
                </c:pt>
                <c:pt idx="159">
                  <c:v>213.06</c:v>
                </c:pt>
                <c:pt idx="160">
                  <c:v>214.4</c:v>
                </c:pt>
                <c:pt idx="161">
                  <c:v>215.73999999999998</c:v>
                </c:pt>
                <c:pt idx="162">
                  <c:v>217.08</c:v>
                </c:pt>
                <c:pt idx="163">
                  <c:v>218.42000000000004</c:v>
                </c:pt>
                <c:pt idx="164">
                  <c:v>219.76</c:v>
                </c:pt>
                <c:pt idx="165">
                  <c:v>221.1</c:v>
                </c:pt>
                <c:pt idx="166">
                  <c:v>222.44</c:v>
                </c:pt>
                <c:pt idx="167">
                  <c:v>223.78</c:v>
                </c:pt>
                <c:pt idx="168">
                  <c:v>225.12</c:v>
                </c:pt>
                <c:pt idx="169">
                  <c:v>226.46</c:v>
                </c:pt>
                <c:pt idx="170">
                  <c:v>227.8</c:v>
                </c:pt>
                <c:pt idx="171">
                  <c:v>229.14</c:v>
                </c:pt>
                <c:pt idx="172">
                  <c:v>230.48000000000027</c:v>
                </c:pt>
                <c:pt idx="173">
                  <c:v>231.8200000000005</c:v>
                </c:pt>
                <c:pt idx="174">
                  <c:v>233.16</c:v>
                </c:pt>
                <c:pt idx="175">
                  <c:v>234.5</c:v>
                </c:pt>
                <c:pt idx="176">
                  <c:v>235.84</c:v>
                </c:pt>
                <c:pt idx="177">
                  <c:v>237.18</c:v>
                </c:pt>
                <c:pt idx="178">
                  <c:v>238.52</c:v>
                </c:pt>
                <c:pt idx="179">
                  <c:v>239.86</c:v>
                </c:pt>
                <c:pt idx="180">
                  <c:v>241.2</c:v>
                </c:pt>
                <c:pt idx="181">
                  <c:v>242.54</c:v>
                </c:pt>
                <c:pt idx="182">
                  <c:v>243.88000000000051</c:v>
                </c:pt>
                <c:pt idx="183">
                  <c:v>245.22</c:v>
                </c:pt>
                <c:pt idx="184">
                  <c:v>246.56</c:v>
                </c:pt>
                <c:pt idx="185">
                  <c:v>247.9</c:v>
                </c:pt>
                <c:pt idx="186">
                  <c:v>249.23999999999998</c:v>
                </c:pt>
                <c:pt idx="187">
                  <c:v>250.58</c:v>
                </c:pt>
                <c:pt idx="188">
                  <c:v>251.92000000000004</c:v>
                </c:pt>
                <c:pt idx="189">
                  <c:v>253.26</c:v>
                </c:pt>
                <c:pt idx="190">
                  <c:v>254.6</c:v>
                </c:pt>
                <c:pt idx="191">
                  <c:v>255.94</c:v>
                </c:pt>
                <c:pt idx="192">
                  <c:v>257.27999999999969</c:v>
                </c:pt>
                <c:pt idx="193">
                  <c:v>258.62</c:v>
                </c:pt>
                <c:pt idx="194">
                  <c:v>259.95999999999964</c:v>
                </c:pt>
                <c:pt idx="195">
                  <c:v>261.3</c:v>
                </c:pt>
                <c:pt idx="196">
                  <c:v>262.64000000000038</c:v>
                </c:pt>
                <c:pt idx="197">
                  <c:v>263.979999999999</c:v>
                </c:pt>
                <c:pt idx="198">
                  <c:v>265.32</c:v>
                </c:pt>
                <c:pt idx="199">
                  <c:v>266.66000000000008</c:v>
                </c:pt>
                <c:pt idx="200">
                  <c:v>268</c:v>
                </c:pt>
                <c:pt idx="201">
                  <c:v>269.33999999999969</c:v>
                </c:pt>
                <c:pt idx="202">
                  <c:v>270.68</c:v>
                </c:pt>
                <c:pt idx="203">
                  <c:v>272.02</c:v>
                </c:pt>
                <c:pt idx="204">
                  <c:v>273.36</c:v>
                </c:pt>
                <c:pt idx="205">
                  <c:v>274.7</c:v>
                </c:pt>
                <c:pt idx="206">
                  <c:v>276.04000000000002</c:v>
                </c:pt>
                <c:pt idx="207">
                  <c:v>277.38</c:v>
                </c:pt>
                <c:pt idx="208">
                  <c:v>278.72000000000003</c:v>
                </c:pt>
                <c:pt idx="209">
                  <c:v>280.06</c:v>
                </c:pt>
                <c:pt idx="210">
                  <c:v>281.39999999999969</c:v>
                </c:pt>
                <c:pt idx="211">
                  <c:v>282.74</c:v>
                </c:pt>
                <c:pt idx="212">
                  <c:v>284.08</c:v>
                </c:pt>
                <c:pt idx="213">
                  <c:v>285.41999999999899</c:v>
                </c:pt>
                <c:pt idx="214">
                  <c:v>286.76</c:v>
                </c:pt>
                <c:pt idx="215">
                  <c:v>288.10000000000002</c:v>
                </c:pt>
                <c:pt idx="216">
                  <c:v>289.44</c:v>
                </c:pt>
                <c:pt idx="217">
                  <c:v>290.77999999999969</c:v>
                </c:pt>
                <c:pt idx="218">
                  <c:v>292.12</c:v>
                </c:pt>
                <c:pt idx="219">
                  <c:v>293.45999999999964</c:v>
                </c:pt>
                <c:pt idx="220">
                  <c:v>294.8</c:v>
                </c:pt>
                <c:pt idx="221">
                  <c:v>296.14000000000038</c:v>
                </c:pt>
                <c:pt idx="222">
                  <c:v>297.479999999999</c:v>
                </c:pt>
                <c:pt idx="223">
                  <c:v>298.82</c:v>
                </c:pt>
                <c:pt idx="224">
                  <c:v>300.16000000000008</c:v>
                </c:pt>
                <c:pt idx="225">
                  <c:v>301.5</c:v>
                </c:pt>
                <c:pt idx="226">
                  <c:v>302.83999999999969</c:v>
                </c:pt>
                <c:pt idx="227">
                  <c:v>304.18</c:v>
                </c:pt>
                <c:pt idx="228">
                  <c:v>305.52</c:v>
                </c:pt>
                <c:pt idx="229">
                  <c:v>306.86</c:v>
                </c:pt>
                <c:pt idx="230">
                  <c:v>308.2</c:v>
                </c:pt>
                <c:pt idx="231">
                  <c:v>309.54000000000002</c:v>
                </c:pt>
                <c:pt idx="232">
                  <c:v>310.88</c:v>
                </c:pt>
                <c:pt idx="233">
                  <c:v>312.22000000000003</c:v>
                </c:pt>
                <c:pt idx="234">
                  <c:v>313.56</c:v>
                </c:pt>
                <c:pt idx="235">
                  <c:v>314.89999999999969</c:v>
                </c:pt>
                <c:pt idx="236">
                  <c:v>316.24</c:v>
                </c:pt>
                <c:pt idx="237">
                  <c:v>317.58</c:v>
                </c:pt>
                <c:pt idx="238">
                  <c:v>318.91999999999899</c:v>
                </c:pt>
                <c:pt idx="239">
                  <c:v>320.26</c:v>
                </c:pt>
                <c:pt idx="240">
                  <c:v>321.60000000000002</c:v>
                </c:pt>
                <c:pt idx="241">
                  <c:v>322.94</c:v>
                </c:pt>
                <c:pt idx="242">
                  <c:v>324.27999999999969</c:v>
                </c:pt>
                <c:pt idx="243">
                  <c:v>325.62</c:v>
                </c:pt>
                <c:pt idx="244">
                  <c:v>326.95999999999964</c:v>
                </c:pt>
                <c:pt idx="245">
                  <c:v>328.3</c:v>
                </c:pt>
                <c:pt idx="246">
                  <c:v>329.64000000000038</c:v>
                </c:pt>
                <c:pt idx="247">
                  <c:v>330.979999999999</c:v>
                </c:pt>
                <c:pt idx="248">
                  <c:v>332.32</c:v>
                </c:pt>
                <c:pt idx="249">
                  <c:v>333.66</c:v>
                </c:pt>
                <c:pt idx="250">
                  <c:v>335</c:v>
                </c:pt>
                <c:pt idx="251">
                  <c:v>336.34000000000032</c:v>
                </c:pt>
                <c:pt idx="252">
                  <c:v>337.68</c:v>
                </c:pt>
                <c:pt idx="253">
                  <c:v>339.02</c:v>
                </c:pt>
                <c:pt idx="254">
                  <c:v>340.36</c:v>
                </c:pt>
                <c:pt idx="255">
                  <c:v>341.7</c:v>
                </c:pt>
                <c:pt idx="256">
                  <c:v>343.04</c:v>
                </c:pt>
                <c:pt idx="257">
                  <c:v>344.38</c:v>
                </c:pt>
                <c:pt idx="258">
                  <c:v>345.71999999999969</c:v>
                </c:pt>
                <c:pt idx="259">
                  <c:v>347.06</c:v>
                </c:pt>
                <c:pt idx="260">
                  <c:v>348.4</c:v>
                </c:pt>
                <c:pt idx="261">
                  <c:v>349.74</c:v>
                </c:pt>
                <c:pt idx="262">
                  <c:v>351.08</c:v>
                </c:pt>
                <c:pt idx="263">
                  <c:v>352.41999999999899</c:v>
                </c:pt>
                <c:pt idx="264">
                  <c:v>353.76</c:v>
                </c:pt>
                <c:pt idx="265">
                  <c:v>355.1</c:v>
                </c:pt>
                <c:pt idx="266">
                  <c:v>356.44</c:v>
                </c:pt>
                <c:pt idx="267">
                  <c:v>357.78</c:v>
                </c:pt>
                <c:pt idx="268">
                  <c:v>359.12</c:v>
                </c:pt>
                <c:pt idx="269">
                  <c:v>360.46</c:v>
                </c:pt>
                <c:pt idx="270">
                  <c:v>361.8</c:v>
                </c:pt>
                <c:pt idx="271">
                  <c:v>363.14000000000038</c:v>
                </c:pt>
                <c:pt idx="272">
                  <c:v>364.479999999999</c:v>
                </c:pt>
                <c:pt idx="273">
                  <c:v>365.82</c:v>
                </c:pt>
                <c:pt idx="274">
                  <c:v>367.16</c:v>
                </c:pt>
                <c:pt idx="275">
                  <c:v>368.5</c:v>
                </c:pt>
                <c:pt idx="276">
                  <c:v>369.84000000000032</c:v>
                </c:pt>
                <c:pt idx="277">
                  <c:v>371.18</c:v>
                </c:pt>
                <c:pt idx="278">
                  <c:v>372.52</c:v>
                </c:pt>
                <c:pt idx="279">
                  <c:v>373.86</c:v>
                </c:pt>
                <c:pt idx="280">
                  <c:v>375.2</c:v>
                </c:pt>
                <c:pt idx="281">
                  <c:v>376.54</c:v>
                </c:pt>
                <c:pt idx="282">
                  <c:v>377.88</c:v>
                </c:pt>
                <c:pt idx="283">
                  <c:v>379.21999999999969</c:v>
                </c:pt>
                <c:pt idx="284">
                  <c:v>380.56</c:v>
                </c:pt>
                <c:pt idx="285">
                  <c:v>381.9</c:v>
                </c:pt>
                <c:pt idx="286">
                  <c:v>383.24</c:v>
                </c:pt>
                <c:pt idx="287">
                  <c:v>384.58</c:v>
                </c:pt>
                <c:pt idx="288">
                  <c:v>385.91999999999899</c:v>
                </c:pt>
                <c:pt idx="289">
                  <c:v>387.26</c:v>
                </c:pt>
                <c:pt idx="290">
                  <c:v>388.6</c:v>
                </c:pt>
                <c:pt idx="291">
                  <c:v>389.94</c:v>
                </c:pt>
                <c:pt idx="292">
                  <c:v>391.28</c:v>
                </c:pt>
                <c:pt idx="293">
                  <c:v>392.62</c:v>
                </c:pt>
                <c:pt idx="294">
                  <c:v>393.96</c:v>
                </c:pt>
                <c:pt idx="295">
                  <c:v>395.3</c:v>
                </c:pt>
                <c:pt idx="296">
                  <c:v>396.64000000000038</c:v>
                </c:pt>
                <c:pt idx="297">
                  <c:v>397.979999999999</c:v>
                </c:pt>
                <c:pt idx="298">
                  <c:v>399.32</c:v>
                </c:pt>
                <c:pt idx="299">
                  <c:v>400.66</c:v>
                </c:pt>
                <c:pt idx="300">
                  <c:v>402</c:v>
                </c:pt>
                <c:pt idx="301">
                  <c:v>403.34000000000032</c:v>
                </c:pt>
                <c:pt idx="302">
                  <c:v>404.68</c:v>
                </c:pt>
                <c:pt idx="303">
                  <c:v>406.02</c:v>
                </c:pt>
                <c:pt idx="304">
                  <c:v>407.36</c:v>
                </c:pt>
                <c:pt idx="305">
                  <c:v>408.7</c:v>
                </c:pt>
                <c:pt idx="306">
                  <c:v>410.04</c:v>
                </c:pt>
                <c:pt idx="307">
                  <c:v>411.38</c:v>
                </c:pt>
                <c:pt idx="308">
                  <c:v>412.71999999999969</c:v>
                </c:pt>
                <c:pt idx="309">
                  <c:v>414.06</c:v>
                </c:pt>
                <c:pt idx="310">
                  <c:v>415.4</c:v>
                </c:pt>
                <c:pt idx="311">
                  <c:v>416.74</c:v>
                </c:pt>
                <c:pt idx="312">
                  <c:v>418.08</c:v>
                </c:pt>
                <c:pt idx="313">
                  <c:v>419.41999999999899</c:v>
                </c:pt>
                <c:pt idx="314">
                  <c:v>420.76</c:v>
                </c:pt>
                <c:pt idx="315">
                  <c:v>422.1</c:v>
                </c:pt>
                <c:pt idx="316">
                  <c:v>423.44</c:v>
                </c:pt>
                <c:pt idx="317">
                  <c:v>424.78</c:v>
                </c:pt>
                <c:pt idx="318">
                  <c:v>426.12</c:v>
                </c:pt>
                <c:pt idx="319">
                  <c:v>427.46</c:v>
                </c:pt>
                <c:pt idx="320">
                  <c:v>428.8</c:v>
                </c:pt>
                <c:pt idx="321">
                  <c:v>430.14000000000038</c:v>
                </c:pt>
                <c:pt idx="322">
                  <c:v>431.479999999999</c:v>
                </c:pt>
                <c:pt idx="323">
                  <c:v>432.82</c:v>
                </c:pt>
                <c:pt idx="324">
                  <c:v>434.16</c:v>
                </c:pt>
                <c:pt idx="325">
                  <c:v>435.5</c:v>
                </c:pt>
                <c:pt idx="326">
                  <c:v>436.84000000000032</c:v>
                </c:pt>
                <c:pt idx="327">
                  <c:v>438.18</c:v>
                </c:pt>
                <c:pt idx="328">
                  <c:v>439.52</c:v>
                </c:pt>
                <c:pt idx="329">
                  <c:v>440.86</c:v>
                </c:pt>
                <c:pt idx="330">
                  <c:v>442.2</c:v>
                </c:pt>
                <c:pt idx="331">
                  <c:v>443.54</c:v>
                </c:pt>
                <c:pt idx="332">
                  <c:v>444.88</c:v>
                </c:pt>
                <c:pt idx="333">
                  <c:v>446.21999999999969</c:v>
                </c:pt>
                <c:pt idx="334">
                  <c:v>447.56</c:v>
                </c:pt>
                <c:pt idx="335">
                  <c:v>448.9</c:v>
                </c:pt>
                <c:pt idx="336">
                  <c:v>450.24</c:v>
                </c:pt>
                <c:pt idx="337">
                  <c:v>451.58</c:v>
                </c:pt>
                <c:pt idx="338">
                  <c:v>452.91999999999899</c:v>
                </c:pt>
                <c:pt idx="339">
                  <c:v>454.26</c:v>
                </c:pt>
                <c:pt idx="340">
                  <c:v>455.6</c:v>
                </c:pt>
                <c:pt idx="341">
                  <c:v>456.94</c:v>
                </c:pt>
                <c:pt idx="342">
                  <c:v>458.28</c:v>
                </c:pt>
                <c:pt idx="343">
                  <c:v>459.62</c:v>
                </c:pt>
                <c:pt idx="344">
                  <c:v>460.96</c:v>
                </c:pt>
                <c:pt idx="345">
                  <c:v>462.3</c:v>
                </c:pt>
                <c:pt idx="346">
                  <c:v>463.64000000000038</c:v>
                </c:pt>
                <c:pt idx="347">
                  <c:v>464.979999999999</c:v>
                </c:pt>
                <c:pt idx="348">
                  <c:v>466.32</c:v>
                </c:pt>
                <c:pt idx="349">
                  <c:v>467.66</c:v>
                </c:pt>
                <c:pt idx="350">
                  <c:v>469</c:v>
                </c:pt>
                <c:pt idx="351">
                  <c:v>470.34000000000032</c:v>
                </c:pt>
                <c:pt idx="352">
                  <c:v>471.68</c:v>
                </c:pt>
                <c:pt idx="353">
                  <c:v>473.02</c:v>
                </c:pt>
                <c:pt idx="354">
                  <c:v>474.36</c:v>
                </c:pt>
                <c:pt idx="355">
                  <c:v>475.7</c:v>
                </c:pt>
                <c:pt idx="356">
                  <c:v>477.04</c:v>
                </c:pt>
                <c:pt idx="357">
                  <c:v>478.38</c:v>
                </c:pt>
                <c:pt idx="358">
                  <c:v>479.71999999999969</c:v>
                </c:pt>
                <c:pt idx="359">
                  <c:v>481.06</c:v>
                </c:pt>
                <c:pt idx="360">
                  <c:v>482.4</c:v>
                </c:pt>
                <c:pt idx="361">
                  <c:v>483.74</c:v>
                </c:pt>
                <c:pt idx="362">
                  <c:v>485.08</c:v>
                </c:pt>
                <c:pt idx="363">
                  <c:v>486.41999999999899</c:v>
                </c:pt>
                <c:pt idx="364">
                  <c:v>487.76</c:v>
                </c:pt>
                <c:pt idx="365">
                  <c:v>489.1</c:v>
                </c:pt>
                <c:pt idx="366">
                  <c:v>490.44</c:v>
                </c:pt>
                <c:pt idx="367">
                  <c:v>491.78</c:v>
                </c:pt>
                <c:pt idx="368">
                  <c:v>493.12</c:v>
                </c:pt>
                <c:pt idx="369">
                  <c:v>494.46</c:v>
                </c:pt>
                <c:pt idx="370">
                  <c:v>495.8</c:v>
                </c:pt>
                <c:pt idx="371">
                  <c:v>497.14000000000038</c:v>
                </c:pt>
                <c:pt idx="372">
                  <c:v>498.479999999999</c:v>
                </c:pt>
                <c:pt idx="373">
                  <c:v>499.82</c:v>
                </c:pt>
                <c:pt idx="374">
                  <c:v>501.16</c:v>
                </c:pt>
                <c:pt idx="375">
                  <c:v>502.5</c:v>
                </c:pt>
                <c:pt idx="376">
                  <c:v>503.84000000000032</c:v>
                </c:pt>
                <c:pt idx="377">
                  <c:v>505.18</c:v>
                </c:pt>
                <c:pt idx="378">
                  <c:v>506.52</c:v>
                </c:pt>
                <c:pt idx="379">
                  <c:v>507.86</c:v>
                </c:pt>
                <c:pt idx="380">
                  <c:v>509.2</c:v>
                </c:pt>
                <c:pt idx="381">
                  <c:v>510.54</c:v>
                </c:pt>
                <c:pt idx="382">
                  <c:v>511.88</c:v>
                </c:pt>
                <c:pt idx="383">
                  <c:v>513.22</c:v>
                </c:pt>
                <c:pt idx="384">
                  <c:v>514.55999999999949</c:v>
                </c:pt>
                <c:pt idx="385">
                  <c:v>515.9</c:v>
                </c:pt>
                <c:pt idx="386">
                  <c:v>517.24</c:v>
                </c:pt>
                <c:pt idx="387">
                  <c:v>518.58000000000004</c:v>
                </c:pt>
                <c:pt idx="388">
                  <c:v>519.91999999999996</c:v>
                </c:pt>
                <c:pt idx="389">
                  <c:v>521.26</c:v>
                </c:pt>
                <c:pt idx="390">
                  <c:v>522.6</c:v>
                </c:pt>
                <c:pt idx="391">
                  <c:v>523.93999999999949</c:v>
                </c:pt>
                <c:pt idx="392">
                  <c:v>525.28000000000054</c:v>
                </c:pt>
                <c:pt idx="393">
                  <c:v>526.62</c:v>
                </c:pt>
                <c:pt idx="394">
                  <c:v>527.95999999999947</c:v>
                </c:pt>
                <c:pt idx="395">
                  <c:v>529.29999999999995</c:v>
                </c:pt>
                <c:pt idx="396">
                  <c:v>530.64</c:v>
                </c:pt>
                <c:pt idx="397">
                  <c:v>531.98</c:v>
                </c:pt>
                <c:pt idx="398">
                  <c:v>533.31999999999948</c:v>
                </c:pt>
                <c:pt idx="399">
                  <c:v>534.66</c:v>
                </c:pt>
                <c:pt idx="400">
                  <c:v>536</c:v>
                </c:pt>
                <c:pt idx="401">
                  <c:v>537.33999999999946</c:v>
                </c:pt>
                <c:pt idx="402">
                  <c:v>538.67999999999995</c:v>
                </c:pt>
                <c:pt idx="403">
                  <c:v>540.02</c:v>
                </c:pt>
                <c:pt idx="404">
                  <c:v>541.35999999999797</c:v>
                </c:pt>
                <c:pt idx="405">
                  <c:v>542.70000000000005</c:v>
                </c:pt>
                <c:pt idx="406">
                  <c:v>544.04</c:v>
                </c:pt>
                <c:pt idx="407">
                  <c:v>545.38</c:v>
                </c:pt>
                <c:pt idx="408">
                  <c:v>546.72</c:v>
                </c:pt>
                <c:pt idx="409">
                  <c:v>548.05999999999949</c:v>
                </c:pt>
                <c:pt idx="410">
                  <c:v>549.4</c:v>
                </c:pt>
                <c:pt idx="411">
                  <c:v>550.74</c:v>
                </c:pt>
                <c:pt idx="412">
                  <c:v>552.08000000000004</c:v>
                </c:pt>
                <c:pt idx="413">
                  <c:v>553.41999999999996</c:v>
                </c:pt>
                <c:pt idx="414">
                  <c:v>554.76</c:v>
                </c:pt>
                <c:pt idx="415">
                  <c:v>556.1</c:v>
                </c:pt>
                <c:pt idx="416">
                  <c:v>557.43999999999949</c:v>
                </c:pt>
                <c:pt idx="417">
                  <c:v>558.78000000000054</c:v>
                </c:pt>
                <c:pt idx="418">
                  <c:v>560.12</c:v>
                </c:pt>
                <c:pt idx="419">
                  <c:v>561.45999999999947</c:v>
                </c:pt>
                <c:pt idx="420">
                  <c:v>562.79999999999995</c:v>
                </c:pt>
                <c:pt idx="421">
                  <c:v>564.14</c:v>
                </c:pt>
                <c:pt idx="422">
                  <c:v>565.48</c:v>
                </c:pt>
                <c:pt idx="423">
                  <c:v>566.81999999999948</c:v>
                </c:pt>
                <c:pt idx="424">
                  <c:v>568.16</c:v>
                </c:pt>
                <c:pt idx="425">
                  <c:v>569.5</c:v>
                </c:pt>
                <c:pt idx="426">
                  <c:v>570.83999999999946</c:v>
                </c:pt>
                <c:pt idx="427">
                  <c:v>572.17999999999995</c:v>
                </c:pt>
                <c:pt idx="428">
                  <c:v>573.52</c:v>
                </c:pt>
                <c:pt idx="429">
                  <c:v>574.85999999999797</c:v>
                </c:pt>
                <c:pt idx="430">
                  <c:v>576.20000000000005</c:v>
                </c:pt>
                <c:pt idx="431">
                  <c:v>577.54</c:v>
                </c:pt>
                <c:pt idx="432">
                  <c:v>578.88</c:v>
                </c:pt>
                <c:pt idx="433">
                  <c:v>580.22</c:v>
                </c:pt>
                <c:pt idx="434">
                  <c:v>581.55999999999949</c:v>
                </c:pt>
                <c:pt idx="435">
                  <c:v>582.9</c:v>
                </c:pt>
                <c:pt idx="436">
                  <c:v>584.24</c:v>
                </c:pt>
                <c:pt idx="437">
                  <c:v>585.58000000000004</c:v>
                </c:pt>
                <c:pt idx="438">
                  <c:v>586.91999999999996</c:v>
                </c:pt>
                <c:pt idx="439">
                  <c:v>588.26</c:v>
                </c:pt>
                <c:pt idx="440">
                  <c:v>589.6</c:v>
                </c:pt>
                <c:pt idx="441">
                  <c:v>590.93999999999949</c:v>
                </c:pt>
                <c:pt idx="442">
                  <c:v>592.28000000000054</c:v>
                </c:pt>
                <c:pt idx="443">
                  <c:v>593.62</c:v>
                </c:pt>
                <c:pt idx="444">
                  <c:v>594.95999999999947</c:v>
                </c:pt>
                <c:pt idx="445">
                  <c:v>596.29999999999995</c:v>
                </c:pt>
                <c:pt idx="446">
                  <c:v>597.64</c:v>
                </c:pt>
                <c:pt idx="447">
                  <c:v>598.98</c:v>
                </c:pt>
                <c:pt idx="448">
                  <c:v>600.31999999999948</c:v>
                </c:pt>
                <c:pt idx="449">
                  <c:v>601.66</c:v>
                </c:pt>
                <c:pt idx="450">
                  <c:v>603</c:v>
                </c:pt>
                <c:pt idx="451">
                  <c:v>604.33999999999946</c:v>
                </c:pt>
                <c:pt idx="452">
                  <c:v>605.67999999999995</c:v>
                </c:pt>
                <c:pt idx="453">
                  <c:v>607.02</c:v>
                </c:pt>
                <c:pt idx="454">
                  <c:v>608.35999999999797</c:v>
                </c:pt>
                <c:pt idx="455">
                  <c:v>609.70000000000005</c:v>
                </c:pt>
                <c:pt idx="456">
                  <c:v>611.04</c:v>
                </c:pt>
                <c:pt idx="457">
                  <c:v>612.38</c:v>
                </c:pt>
                <c:pt idx="458">
                  <c:v>613.72</c:v>
                </c:pt>
                <c:pt idx="459">
                  <c:v>615.05999999999949</c:v>
                </c:pt>
                <c:pt idx="460">
                  <c:v>616.4</c:v>
                </c:pt>
                <c:pt idx="461">
                  <c:v>617.74</c:v>
                </c:pt>
                <c:pt idx="462">
                  <c:v>619.08000000000004</c:v>
                </c:pt>
                <c:pt idx="463">
                  <c:v>620.41999999999996</c:v>
                </c:pt>
                <c:pt idx="464">
                  <c:v>621.76</c:v>
                </c:pt>
                <c:pt idx="465">
                  <c:v>623.1</c:v>
                </c:pt>
                <c:pt idx="466">
                  <c:v>624.43999999999949</c:v>
                </c:pt>
                <c:pt idx="467">
                  <c:v>625.78000000000054</c:v>
                </c:pt>
                <c:pt idx="468">
                  <c:v>627.12</c:v>
                </c:pt>
                <c:pt idx="469">
                  <c:v>628.45999999999947</c:v>
                </c:pt>
                <c:pt idx="470">
                  <c:v>629.79999999999995</c:v>
                </c:pt>
                <c:pt idx="471">
                  <c:v>631.14</c:v>
                </c:pt>
                <c:pt idx="472">
                  <c:v>632.48</c:v>
                </c:pt>
                <c:pt idx="473">
                  <c:v>633.81999999999948</c:v>
                </c:pt>
                <c:pt idx="474">
                  <c:v>635.16</c:v>
                </c:pt>
                <c:pt idx="475">
                  <c:v>636.5</c:v>
                </c:pt>
                <c:pt idx="476">
                  <c:v>637.83999999999946</c:v>
                </c:pt>
                <c:pt idx="477">
                  <c:v>639.17999999999995</c:v>
                </c:pt>
                <c:pt idx="478">
                  <c:v>640.52</c:v>
                </c:pt>
                <c:pt idx="479">
                  <c:v>641.85999999999797</c:v>
                </c:pt>
                <c:pt idx="480">
                  <c:v>643.20000000000005</c:v>
                </c:pt>
                <c:pt idx="481">
                  <c:v>644.54</c:v>
                </c:pt>
                <c:pt idx="482">
                  <c:v>645.88</c:v>
                </c:pt>
                <c:pt idx="483">
                  <c:v>647.22</c:v>
                </c:pt>
                <c:pt idx="484">
                  <c:v>648.55999999999949</c:v>
                </c:pt>
                <c:pt idx="485">
                  <c:v>649.9</c:v>
                </c:pt>
                <c:pt idx="486">
                  <c:v>651.24</c:v>
                </c:pt>
                <c:pt idx="487">
                  <c:v>652.58000000000004</c:v>
                </c:pt>
                <c:pt idx="488">
                  <c:v>653.91999999999996</c:v>
                </c:pt>
                <c:pt idx="489">
                  <c:v>655.26</c:v>
                </c:pt>
                <c:pt idx="490">
                  <c:v>656.6</c:v>
                </c:pt>
                <c:pt idx="491">
                  <c:v>657.93999999999949</c:v>
                </c:pt>
                <c:pt idx="492">
                  <c:v>659.28000000000054</c:v>
                </c:pt>
                <c:pt idx="493">
                  <c:v>660.62</c:v>
                </c:pt>
                <c:pt idx="494">
                  <c:v>661.95999999999947</c:v>
                </c:pt>
                <c:pt idx="495">
                  <c:v>663.3</c:v>
                </c:pt>
                <c:pt idx="496">
                  <c:v>664.64</c:v>
                </c:pt>
                <c:pt idx="497">
                  <c:v>665.98</c:v>
                </c:pt>
                <c:pt idx="498">
                  <c:v>667.31999999999948</c:v>
                </c:pt>
                <c:pt idx="499">
                  <c:v>668.66</c:v>
                </c:pt>
              </c:numCache>
            </c:numRef>
          </c:xVal>
          <c:yVal>
            <c:numRef>
              <c:f>'14july10_F5N_RyR2ab cADPR_2'!$D$131:$D$502</c:f>
              <c:numCache>
                <c:formatCode>General</c:formatCode>
                <c:ptCount val="372"/>
                <c:pt idx="0">
                  <c:v>1.0198682674412478</c:v>
                </c:pt>
                <c:pt idx="1">
                  <c:v>1.0190034103240455</c:v>
                </c:pt>
                <c:pt idx="2">
                  <c:v>1.0056492201466138</c:v>
                </c:pt>
                <c:pt idx="3">
                  <c:v>0.99884980639145138</c:v>
                </c:pt>
                <c:pt idx="4">
                  <c:v>1.0147959136275386</c:v>
                </c:pt>
                <c:pt idx="5">
                  <c:v>1.0050750081066526</c:v>
                </c:pt>
                <c:pt idx="6">
                  <c:v>1.0131887392506664</c:v>
                </c:pt>
                <c:pt idx="7">
                  <c:v>1.0082641410774378</c:v>
                </c:pt>
                <c:pt idx="8">
                  <c:v>1.0031179094434881</c:v>
                </c:pt>
                <c:pt idx="9">
                  <c:v>0.9957150864259906</c:v>
                </c:pt>
                <c:pt idx="10">
                  <c:v>1.0052851396312985</c:v>
                </c:pt>
                <c:pt idx="11">
                  <c:v>1.0058155558376958</c:v>
                </c:pt>
                <c:pt idx="12">
                  <c:v>0.99845608627159854</c:v>
                </c:pt>
                <c:pt idx="13">
                  <c:v>1.012801212481012</c:v>
                </c:pt>
                <c:pt idx="14">
                  <c:v>0.9943963452155703</c:v>
                </c:pt>
                <c:pt idx="15">
                  <c:v>0.98910324270544958</c:v>
                </c:pt>
                <c:pt idx="16">
                  <c:v>1.0007812468894957</c:v>
                </c:pt>
                <c:pt idx="17">
                  <c:v>1.0050559856738965</c:v>
                </c:pt>
                <c:pt idx="18">
                  <c:v>0.99254187921286052</c:v>
                </c:pt>
                <c:pt idx="19">
                  <c:v>1.0100739264822831</c:v>
                </c:pt>
                <c:pt idx="20">
                  <c:v>1.01090295064475</c:v>
                </c:pt>
                <c:pt idx="21">
                  <c:v>1.0215400296130621</c:v>
                </c:pt>
                <c:pt idx="22">
                  <c:v>0.99934881346469995</c:v>
                </c:pt>
                <c:pt idx="23">
                  <c:v>1.0099925281653659</c:v>
                </c:pt>
                <c:pt idx="24">
                  <c:v>1.0083327103117961</c:v>
                </c:pt>
                <c:pt idx="25">
                  <c:v>0.99823533757519023</c:v>
                </c:pt>
                <c:pt idx="26">
                  <c:v>1.0134156812972759</c:v>
                </c:pt>
                <c:pt idx="27">
                  <c:v>1.0006746327896265</c:v>
                </c:pt>
                <c:pt idx="28">
                  <c:v>1.0105543535049231</c:v>
                </c:pt>
                <c:pt idx="29">
                  <c:v>0.99392299630743619</c:v>
                </c:pt>
                <c:pt idx="30">
                  <c:v>1.0031121584754439</c:v>
                </c:pt>
                <c:pt idx="31">
                  <c:v>0.99379647501049562</c:v>
                </c:pt>
                <c:pt idx="32">
                  <c:v>0.9969674703128395</c:v>
                </c:pt>
                <c:pt idx="33">
                  <c:v>0.99158102516756053</c:v>
                </c:pt>
                <c:pt idx="34">
                  <c:v>0.98509879941906342</c:v>
                </c:pt>
                <c:pt idx="35">
                  <c:v>1.0156501535729658</c:v>
                </c:pt>
                <c:pt idx="36">
                  <c:v>0.99823622233950271</c:v>
                </c:pt>
                <c:pt idx="37">
                  <c:v>1.0054373190933459</c:v>
                </c:pt>
                <c:pt idx="38">
                  <c:v>0.99119349839791338</c:v>
                </c:pt>
                <c:pt idx="39">
                  <c:v>0.99226317845386558</c:v>
                </c:pt>
                <c:pt idx="40">
                  <c:v>0.99496878772689956</c:v>
                </c:pt>
                <c:pt idx="41">
                  <c:v>1.0113010945861698</c:v>
                </c:pt>
                <c:pt idx="42">
                  <c:v>1.0010245570759175</c:v>
                </c:pt>
                <c:pt idx="43">
                  <c:v>0.99490729660706123</c:v>
                </c:pt>
                <c:pt idx="44">
                  <c:v>1.0053811365593908</c:v>
                </c:pt>
                <c:pt idx="45">
                  <c:v>0.98523018691973019</c:v>
                </c:pt>
                <c:pt idx="46">
                  <c:v>0.99295904558703907</c:v>
                </c:pt>
                <c:pt idx="47">
                  <c:v>1.0064578947298581</c:v>
                </c:pt>
                <c:pt idx="48">
                  <c:v>0.99646226988938713</c:v>
                </c:pt>
                <c:pt idx="49">
                  <c:v>0.99741250676291249</c:v>
                </c:pt>
                <c:pt idx="50">
                  <c:v>0.99398404504512039</c:v>
                </c:pt>
                <c:pt idx="51">
                  <c:v>1.0026003223196398</c:v>
                </c:pt>
                <c:pt idx="52">
                  <c:v>0.9873284054910243</c:v>
                </c:pt>
                <c:pt idx="53">
                  <c:v>0.99543903995993555</c:v>
                </c:pt>
                <c:pt idx="54">
                  <c:v>0.99177523093454822</c:v>
                </c:pt>
                <c:pt idx="55">
                  <c:v>1.0029719233316341</c:v>
                </c:pt>
                <c:pt idx="56">
                  <c:v>0.9988104343794636</c:v>
                </c:pt>
                <c:pt idx="57">
                  <c:v>0.9820662697318987</c:v>
                </c:pt>
                <c:pt idx="58">
                  <c:v>0.99822250849262906</c:v>
                </c:pt>
                <c:pt idx="59">
                  <c:v>1.0093802712598914</c:v>
                </c:pt>
                <c:pt idx="60">
                  <c:v>0.98963764035126756</c:v>
                </c:pt>
                <c:pt idx="61">
                  <c:v>1.0048321403023854</c:v>
                </c:pt>
                <c:pt idx="62">
                  <c:v>1.0017359075845935</c:v>
                </c:pt>
                <c:pt idx="63">
                  <c:v>0.99782746122630939</c:v>
                </c:pt>
                <c:pt idx="64">
                  <c:v>1.006504344856356</c:v>
                </c:pt>
                <c:pt idx="65">
                  <c:v>0.99836672507585356</c:v>
                </c:pt>
                <c:pt idx="66">
                  <c:v>0.98390525235911652</c:v>
                </c:pt>
                <c:pt idx="67">
                  <c:v>0.98296297836441549</c:v>
                </c:pt>
                <c:pt idx="68">
                  <c:v>0.98529123565741761</c:v>
                </c:pt>
                <c:pt idx="69">
                  <c:v>0.99576330608111829</c:v>
                </c:pt>
                <c:pt idx="70">
                  <c:v>0.99432114024885754</c:v>
                </c:pt>
                <c:pt idx="71">
                  <c:v>0.9849550252179945</c:v>
                </c:pt>
                <c:pt idx="72">
                  <c:v>0.97774154176375083</c:v>
                </c:pt>
                <c:pt idx="73">
                  <c:v>0.99666045709578865</c:v>
                </c:pt>
                <c:pt idx="74">
                  <c:v>1.0064601066406431</c:v>
                </c:pt>
                <c:pt idx="75">
                  <c:v>0.98642063730458585</c:v>
                </c:pt>
                <c:pt idx="76">
                  <c:v>0.98414988969200967</c:v>
                </c:pt>
                <c:pt idx="77">
                  <c:v>0.99659011833280353</c:v>
                </c:pt>
                <c:pt idx="78">
                  <c:v>0.98544916608751432</c:v>
                </c:pt>
                <c:pt idx="79">
                  <c:v>1.0072227734795438</c:v>
                </c:pt>
                <c:pt idx="80">
                  <c:v>0.99346336124617063</c:v>
                </c:pt>
                <c:pt idx="81">
                  <c:v>1.0017664319534398</c:v>
                </c:pt>
                <c:pt idx="82">
                  <c:v>1.0017965139401213</c:v>
                </c:pt>
                <c:pt idx="83">
                  <c:v>0.98834455730596249</c:v>
                </c:pt>
                <c:pt idx="84">
                  <c:v>0.9853107004723286</c:v>
                </c:pt>
                <c:pt idx="85">
                  <c:v>1.0067985289908521</c:v>
                </c:pt>
                <c:pt idx="86">
                  <c:v>0.98603001385983313</c:v>
                </c:pt>
                <c:pt idx="87">
                  <c:v>0.9995722164540507</c:v>
                </c:pt>
                <c:pt idx="88">
                  <c:v>0.98569513056688474</c:v>
                </c:pt>
                <c:pt idx="89">
                  <c:v>1.0096337562359243</c:v>
                </c:pt>
                <c:pt idx="90">
                  <c:v>1.0005857139760463</c:v>
                </c:pt>
                <c:pt idx="91">
                  <c:v>0.99890997036481965</c:v>
                </c:pt>
                <c:pt idx="92">
                  <c:v>0.98503199971333488</c:v>
                </c:pt>
                <c:pt idx="93">
                  <c:v>0.99848793778690936</c:v>
                </c:pt>
                <c:pt idx="94">
                  <c:v>0.99511035001718651</c:v>
                </c:pt>
                <c:pt idx="95">
                  <c:v>0.99408225388400429</c:v>
                </c:pt>
                <c:pt idx="96">
                  <c:v>0.9888019804564413</c:v>
                </c:pt>
                <c:pt idx="97">
                  <c:v>0.97906957299946995</c:v>
                </c:pt>
                <c:pt idx="98">
                  <c:v>0.99736163281484691</c:v>
                </c:pt>
                <c:pt idx="99">
                  <c:v>0.98231444612205376</c:v>
                </c:pt>
                <c:pt idx="100">
                  <c:v>0.97329427393807688</c:v>
                </c:pt>
                <c:pt idx="101">
                  <c:v>0.97117880246265265</c:v>
                </c:pt>
                <c:pt idx="102">
                  <c:v>0.99899756203193246</c:v>
                </c:pt>
                <c:pt idx="103">
                  <c:v>0.98876835941249841</c:v>
                </c:pt>
                <c:pt idx="104">
                  <c:v>0.97757786036561145</c:v>
                </c:pt>
                <c:pt idx="105">
                  <c:v>0.98266613993697505</c:v>
                </c:pt>
                <c:pt idx="106">
                  <c:v>0.97794415279171965</c:v>
                </c:pt>
                <c:pt idx="107">
                  <c:v>0.96991314711108978</c:v>
                </c:pt>
                <c:pt idx="108">
                  <c:v>0.97642147340686314</c:v>
                </c:pt>
                <c:pt idx="109">
                  <c:v>0.9987684080745366</c:v>
                </c:pt>
                <c:pt idx="110">
                  <c:v>0.98184021244961006</c:v>
                </c:pt>
                <c:pt idx="111">
                  <c:v>0.97896870986764151</c:v>
                </c:pt>
                <c:pt idx="112">
                  <c:v>0.98746112013816456</c:v>
                </c:pt>
                <c:pt idx="113">
                  <c:v>0.98575042833652371</c:v>
                </c:pt>
                <c:pt idx="114">
                  <c:v>0.99025343631400164</c:v>
                </c:pt>
                <c:pt idx="115">
                  <c:v>0.97217371993404955</c:v>
                </c:pt>
                <c:pt idx="116">
                  <c:v>1.0008657418815141</c:v>
                </c:pt>
                <c:pt idx="117">
                  <c:v>0.99503426028615949</c:v>
                </c:pt>
                <c:pt idx="118">
                  <c:v>0.97648473405533054</c:v>
                </c:pt>
                <c:pt idx="119">
                  <c:v>0.97435953017245414</c:v>
                </c:pt>
                <c:pt idx="120">
                  <c:v>0.99820171653124612</c:v>
                </c:pt>
                <c:pt idx="121">
                  <c:v>0.9643448828992317</c:v>
                </c:pt>
                <c:pt idx="122">
                  <c:v>0.96332209535193447</c:v>
                </c:pt>
                <c:pt idx="123">
                  <c:v>0.97581275555864211</c:v>
                </c:pt>
                <c:pt idx="124">
                  <c:v>0.96044838085918582</c:v>
                </c:pt>
                <c:pt idx="125">
                  <c:v>0.97952036041759161</c:v>
                </c:pt>
                <c:pt idx="126">
                  <c:v>0.98004856471320956</c:v>
                </c:pt>
                <c:pt idx="127">
                  <c:v>0.95678412945163649</c:v>
                </c:pt>
                <c:pt idx="128">
                  <c:v>0.96944864584609813</c:v>
                </c:pt>
                <c:pt idx="129">
                  <c:v>0.96700492681008465</c:v>
                </c:pt>
                <c:pt idx="130">
                  <c:v>0.9790704577637882</c:v>
                </c:pt>
                <c:pt idx="131">
                  <c:v>0.9789218173589932</c:v>
                </c:pt>
                <c:pt idx="132">
                  <c:v>0.95913494823465151</c:v>
                </c:pt>
                <c:pt idx="133">
                  <c:v>0.97745045430435584</c:v>
                </c:pt>
                <c:pt idx="134">
                  <c:v>0.96289431180598561</c:v>
                </c:pt>
                <c:pt idx="135">
                  <c:v>0.97293550200863665</c:v>
                </c:pt>
                <c:pt idx="136">
                  <c:v>0.96908677724156178</c:v>
                </c:pt>
                <c:pt idx="137">
                  <c:v>0.97304653993007761</c:v>
                </c:pt>
                <c:pt idx="138">
                  <c:v>0.96415288904303476</c:v>
                </c:pt>
                <c:pt idx="139">
                  <c:v>0.95858949103490487</c:v>
                </c:pt>
                <c:pt idx="140">
                  <c:v>0.96219269370476879</c:v>
                </c:pt>
                <c:pt idx="141">
                  <c:v>0.96708145892326813</c:v>
                </c:pt>
                <c:pt idx="142">
                  <c:v>0.9607576059870232</c:v>
                </c:pt>
                <c:pt idx="143">
                  <c:v>0.96685584402313296</c:v>
                </c:pt>
                <c:pt idx="144">
                  <c:v>0.96419889678737958</c:v>
                </c:pt>
                <c:pt idx="145">
                  <c:v>0.94562150048064864</c:v>
                </c:pt>
                <c:pt idx="146">
                  <c:v>0.97283242696602323</c:v>
                </c:pt>
                <c:pt idx="147">
                  <c:v>0.97016397779418484</c:v>
                </c:pt>
                <c:pt idx="148">
                  <c:v>0.94452748940605258</c:v>
                </c:pt>
                <c:pt idx="149">
                  <c:v>0.94569405115442118</c:v>
                </c:pt>
                <c:pt idx="150">
                  <c:v>0.9495874565193636</c:v>
                </c:pt>
                <c:pt idx="151">
                  <c:v>0.93758341668550715</c:v>
                </c:pt>
                <c:pt idx="152">
                  <c:v>0.9541846918963105</c:v>
                </c:pt>
                <c:pt idx="153">
                  <c:v>0.94863500773505172</c:v>
                </c:pt>
                <c:pt idx="154">
                  <c:v>0.94583517106254489</c:v>
                </c:pt>
                <c:pt idx="155">
                  <c:v>0.97002285788605913</c:v>
                </c:pt>
                <c:pt idx="156">
                  <c:v>0.96297040153701274</c:v>
                </c:pt>
                <c:pt idx="157">
                  <c:v>0.9445911924366831</c:v>
                </c:pt>
                <c:pt idx="158">
                  <c:v>0.95102210185495006</c:v>
                </c:pt>
                <c:pt idx="159">
                  <c:v>0.9444027376377413</c:v>
                </c:pt>
                <c:pt idx="160">
                  <c:v>0.94177233333141663</c:v>
                </c:pt>
                <c:pt idx="161">
                  <c:v>0.92723565564795951</c:v>
                </c:pt>
                <c:pt idx="162">
                  <c:v>0.94047040264296833</c:v>
                </c:pt>
                <c:pt idx="163">
                  <c:v>0.94067611034603593</c:v>
                </c:pt>
                <c:pt idx="164">
                  <c:v>0.95045187125440778</c:v>
                </c:pt>
                <c:pt idx="165">
                  <c:v>0.96868819091798308</c:v>
                </c:pt>
                <c:pt idx="166">
                  <c:v>0.93351527036849358</c:v>
                </c:pt>
                <c:pt idx="167">
                  <c:v>0.94151840597322056</c:v>
                </c:pt>
                <c:pt idx="168">
                  <c:v>0.94714329510119422</c:v>
                </c:pt>
                <c:pt idx="169">
                  <c:v>0.95262485241025541</c:v>
                </c:pt>
                <c:pt idx="170">
                  <c:v>0.94036998189329857</c:v>
                </c:pt>
                <c:pt idx="171">
                  <c:v>0.94199175488135478</c:v>
                </c:pt>
                <c:pt idx="172">
                  <c:v>0.94109947007041694</c:v>
                </c:pt>
                <c:pt idx="173">
                  <c:v>0.92854643397955061</c:v>
                </c:pt>
                <c:pt idx="174">
                  <c:v>0.9321261903950866</c:v>
                </c:pt>
                <c:pt idx="175">
                  <c:v>0.93587803346975273</c:v>
                </c:pt>
                <c:pt idx="176">
                  <c:v>0.92408500992484366</c:v>
                </c:pt>
                <c:pt idx="177">
                  <c:v>0.93030623020063352</c:v>
                </c:pt>
                <c:pt idx="178">
                  <c:v>0.92171030250534325</c:v>
                </c:pt>
                <c:pt idx="179">
                  <c:v>0.93906362738327875</c:v>
                </c:pt>
                <c:pt idx="180">
                  <c:v>0.92370898509127886</c:v>
                </c:pt>
                <c:pt idx="181">
                  <c:v>0.92615049221650925</c:v>
                </c:pt>
                <c:pt idx="182">
                  <c:v>0.90713602233852964</c:v>
                </c:pt>
                <c:pt idx="183">
                  <c:v>0.92908658259341181</c:v>
                </c:pt>
                <c:pt idx="184">
                  <c:v>0.93157896366671067</c:v>
                </c:pt>
                <c:pt idx="185">
                  <c:v>0.92136480204062088</c:v>
                </c:pt>
                <c:pt idx="186">
                  <c:v>0.93554447732326962</c:v>
                </c:pt>
                <c:pt idx="187">
                  <c:v>0.9207888204720307</c:v>
                </c:pt>
                <c:pt idx="188">
                  <c:v>0.92000359214311833</c:v>
                </c:pt>
                <c:pt idx="189">
                  <c:v>0.92315202595544354</c:v>
                </c:pt>
                <c:pt idx="190">
                  <c:v>0.9184804703761007</c:v>
                </c:pt>
                <c:pt idx="191">
                  <c:v>0.91768506725757393</c:v>
                </c:pt>
                <c:pt idx="192">
                  <c:v>0.92855837829779309</c:v>
                </c:pt>
                <c:pt idx="193">
                  <c:v>0.93069729602754314</c:v>
                </c:pt>
                <c:pt idx="194">
                  <c:v>0.9101105999631055</c:v>
                </c:pt>
                <c:pt idx="195">
                  <c:v>0.92760592951348508</c:v>
                </c:pt>
                <c:pt idx="196">
                  <c:v>0.91659946144396198</c:v>
                </c:pt>
                <c:pt idx="197">
                  <c:v>0.92209605974636222</c:v>
                </c:pt>
                <c:pt idx="198">
                  <c:v>0.91956120998598057</c:v>
                </c:pt>
                <c:pt idx="199">
                  <c:v>0.91846896844001458</c:v>
                </c:pt>
                <c:pt idx="200">
                  <c:v>0.91544794068893953</c:v>
                </c:pt>
                <c:pt idx="201">
                  <c:v>0.90823711152763653</c:v>
                </c:pt>
                <c:pt idx="202">
                  <c:v>0.9116983095250637</c:v>
                </c:pt>
                <c:pt idx="203">
                  <c:v>0.9064852781853836</c:v>
                </c:pt>
                <c:pt idx="204">
                  <c:v>0.92367094022576568</c:v>
                </c:pt>
                <c:pt idx="205">
                  <c:v>0.90876708535188599</c:v>
                </c:pt>
                <c:pt idx="206">
                  <c:v>0.90408358545429757</c:v>
                </c:pt>
                <c:pt idx="207">
                  <c:v>0.92268973660124065</c:v>
                </c:pt>
                <c:pt idx="208">
                  <c:v>0.89477851916111961</c:v>
                </c:pt>
                <c:pt idx="209">
                  <c:v>0.9198814946677466</c:v>
                </c:pt>
                <c:pt idx="210">
                  <c:v>0.90868966847439014</c:v>
                </c:pt>
                <c:pt idx="211">
                  <c:v>0.90254188363668264</c:v>
                </c:pt>
                <c:pt idx="212">
                  <c:v>0.91394914994056597</c:v>
                </c:pt>
                <c:pt idx="213">
                  <c:v>0.9050453242639096</c:v>
                </c:pt>
                <c:pt idx="214">
                  <c:v>0.90902499414949856</c:v>
                </c:pt>
                <c:pt idx="215">
                  <c:v>0.90229238010005586</c:v>
                </c:pt>
                <c:pt idx="216">
                  <c:v>0.88825382472553538</c:v>
                </c:pt>
                <c:pt idx="217">
                  <c:v>0.90440652442900638</c:v>
                </c:pt>
                <c:pt idx="218">
                  <c:v>0.90868524465281664</c:v>
                </c:pt>
                <c:pt idx="219">
                  <c:v>0.89503952463382963</c:v>
                </c:pt>
                <c:pt idx="220">
                  <c:v>0.89898114965390286</c:v>
                </c:pt>
                <c:pt idx="221">
                  <c:v>0.9011421864915069</c:v>
                </c:pt>
                <c:pt idx="222">
                  <c:v>0.89750359324907181</c:v>
                </c:pt>
                <c:pt idx="223">
                  <c:v>0.9100181420922614</c:v>
                </c:pt>
                <c:pt idx="224">
                  <c:v>0.90771908202163354</c:v>
                </c:pt>
                <c:pt idx="225">
                  <c:v>0.89802693134096157</c:v>
                </c:pt>
                <c:pt idx="226">
                  <c:v>0.90736296438513719</c:v>
                </c:pt>
                <c:pt idx="227">
                  <c:v>0.89361682361648265</c:v>
                </c:pt>
                <c:pt idx="228">
                  <c:v>0.90409641453685463</c:v>
                </c:pt>
                <c:pt idx="229">
                  <c:v>0.90850254082191506</c:v>
                </c:pt>
                <c:pt idx="230">
                  <c:v>0.88354909048440644</c:v>
                </c:pt>
                <c:pt idx="231">
                  <c:v>0.91073435880466458</c:v>
                </c:pt>
                <c:pt idx="232">
                  <c:v>0.90350096815335057</c:v>
                </c:pt>
                <c:pt idx="233">
                  <c:v>0.8903409837428985</c:v>
                </c:pt>
                <c:pt idx="234">
                  <c:v>0.89155974658580472</c:v>
                </c:pt>
                <c:pt idx="235">
                  <c:v>0.88688155527410262</c:v>
                </c:pt>
                <c:pt idx="236">
                  <c:v>0.89286477394935349</c:v>
                </c:pt>
                <c:pt idx="237">
                  <c:v>0.87638869288901899</c:v>
                </c:pt>
                <c:pt idx="238">
                  <c:v>0.90006056211731056</c:v>
                </c:pt>
                <c:pt idx="239">
                  <c:v>0.90304531453150405</c:v>
                </c:pt>
                <c:pt idx="240">
                  <c:v>0.89389021578959493</c:v>
                </c:pt>
                <c:pt idx="241">
                  <c:v>0.90589027418403922</c:v>
                </c:pt>
                <c:pt idx="242">
                  <c:v>0.90150449747820061</c:v>
                </c:pt>
                <c:pt idx="243">
                  <c:v>0.8864303254738245</c:v>
                </c:pt>
                <c:pt idx="244">
                  <c:v>0.91589386190333166</c:v>
                </c:pt>
                <c:pt idx="245">
                  <c:v>0.88780259492525471</c:v>
                </c:pt>
                <c:pt idx="246">
                  <c:v>0.89581413579097247</c:v>
                </c:pt>
                <c:pt idx="247">
                  <c:v>0.90289844365533489</c:v>
                </c:pt>
                <c:pt idx="248">
                  <c:v>0.8939468407057054</c:v>
                </c:pt>
                <c:pt idx="249">
                  <c:v>0.89107710765237069</c:v>
                </c:pt>
                <c:pt idx="250">
                  <c:v>0.89393445400530624</c:v>
                </c:pt>
                <c:pt idx="251">
                  <c:v>0.89309348552459455</c:v>
                </c:pt>
                <c:pt idx="252">
                  <c:v>0.91026853039320277</c:v>
                </c:pt>
                <c:pt idx="253">
                  <c:v>0.89968851872316169</c:v>
                </c:pt>
                <c:pt idx="254">
                  <c:v>0.89230162146332104</c:v>
                </c:pt>
                <c:pt idx="255">
                  <c:v>0.89717446092416253</c:v>
                </c:pt>
                <c:pt idx="256">
                  <c:v>0.89493733435553113</c:v>
                </c:pt>
                <c:pt idx="257">
                  <c:v>0.88778401487465786</c:v>
                </c:pt>
                <c:pt idx="258">
                  <c:v>0.90660914518938163</c:v>
                </c:pt>
                <c:pt idx="259">
                  <c:v>0.90225964382042978</c:v>
                </c:pt>
                <c:pt idx="260">
                  <c:v>0.90358900220262051</c:v>
                </c:pt>
                <c:pt idx="261">
                  <c:v>0.90562042106818796</c:v>
                </c:pt>
                <c:pt idx="262">
                  <c:v>0.89204238551923731</c:v>
                </c:pt>
                <c:pt idx="263">
                  <c:v>0.90231449920791207</c:v>
                </c:pt>
                <c:pt idx="264">
                  <c:v>0.88759246340061759</c:v>
                </c:pt>
                <c:pt idx="265">
                  <c:v>0.88685855140193137</c:v>
                </c:pt>
                <c:pt idx="266">
                  <c:v>0.90561422771798517</c:v>
                </c:pt>
                <c:pt idx="267">
                  <c:v>0.88321199528066496</c:v>
                </c:pt>
                <c:pt idx="268">
                  <c:v>0.89204592457649856</c:v>
                </c:pt>
                <c:pt idx="269">
                  <c:v>0.89122486329285433</c:v>
                </c:pt>
                <c:pt idx="270">
                  <c:v>0.88515228342186159</c:v>
                </c:pt>
                <c:pt idx="271">
                  <c:v>0.90310282421192856</c:v>
                </c:pt>
                <c:pt idx="272">
                  <c:v>0.90085861952878721</c:v>
                </c:pt>
                <c:pt idx="273">
                  <c:v>0.90746957848500953</c:v>
                </c:pt>
                <c:pt idx="274">
                  <c:v>0.90094311452079834</c:v>
                </c:pt>
                <c:pt idx="275">
                  <c:v>0.90870869090714468</c:v>
                </c:pt>
                <c:pt idx="276">
                  <c:v>0.89331290707453059</c:v>
                </c:pt>
                <c:pt idx="277">
                  <c:v>0.89918553021049863</c:v>
                </c:pt>
                <c:pt idx="278">
                  <c:v>0.90345274849822077</c:v>
                </c:pt>
                <c:pt idx="279">
                  <c:v>0.89352967433152763</c:v>
                </c:pt>
                <c:pt idx="280">
                  <c:v>0.88507796321946253</c:v>
                </c:pt>
                <c:pt idx="281">
                  <c:v>0.90312538570193945</c:v>
                </c:pt>
                <c:pt idx="282">
                  <c:v>0.89955624645817944</c:v>
                </c:pt>
                <c:pt idx="283">
                  <c:v>0.89495812631691651</c:v>
                </c:pt>
                <c:pt idx="284">
                  <c:v>0.8990001720866585</c:v>
                </c:pt>
                <c:pt idx="285">
                  <c:v>0.90706789548633049</c:v>
                </c:pt>
                <c:pt idx="286">
                  <c:v>0.89441886246736857</c:v>
                </c:pt>
                <c:pt idx="287">
                  <c:v>0.90505549905352589</c:v>
                </c:pt>
                <c:pt idx="288">
                  <c:v>0.89777742780433789</c:v>
                </c:pt>
                <c:pt idx="289">
                  <c:v>0.89042017014902541</c:v>
                </c:pt>
                <c:pt idx="290">
                  <c:v>0.88772208137265629</c:v>
                </c:pt>
                <c:pt idx="291">
                  <c:v>0.88801361121421118</c:v>
                </c:pt>
                <c:pt idx="292">
                  <c:v>0.90021097205073819</c:v>
                </c:pt>
                <c:pt idx="293">
                  <c:v>0.91384386298716791</c:v>
                </c:pt>
                <c:pt idx="294">
                  <c:v>0.9140349720790496</c:v>
                </c:pt>
                <c:pt idx="295">
                  <c:v>0.8818246848358916</c:v>
                </c:pt>
                <c:pt idx="296">
                  <c:v>0.88946108563235393</c:v>
                </c:pt>
                <c:pt idx="297">
                  <c:v>0.8902817045338417</c:v>
                </c:pt>
                <c:pt idx="298">
                  <c:v>0.88752743322352179</c:v>
                </c:pt>
                <c:pt idx="299">
                  <c:v>0.90117182609603563</c:v>
                </c:pt>
                <c:pt idx="300">
                  <c:v>0.89124521287208502</c:v>
                </c:pt>
                <c:pt idx="301">
                  <c:v>0.89391543157254905</c:v>
                </c:pt>
                <c:pt idx="302">
                  <c:v>0.9080371547926106</c:v>
                </c:pt>
                <c:pt idx="303">
                  <c:v>0.89952527970717844</c:v>
                </c:pt>
                <c:pt idx="304">
                  <c:v>0.89130803113839563</c:v>
                </c:pt>
                <c:pt idx="305">
                  <c:v>0.88484394305833791</c:v>
                </c:pt>
                <c:pt idx="306">
                  <c:v>0.90690067503093352</c:v>
                </c:pt>
                <c:pt idx="307">
                  <c:v>0.89036044855781149</c:v>
                </c:pt>
                <c:pt idx="308">
                  <c:v>0.8962047592357234</c:v>
                </c:pt>
                <c:pt idx="309">
                  <c:v>0.8906603836603495</c:v>
                </c:pt>
                <c:pt idx="310">
                  <c:v>0.88476431427005386</c:v>
                </c:pt>
                <c:pt idx="311">
                  <c:v>0.88622196347781412</c:v>
                </c:pt>
                <c:pt idx="312">
                  <c:v>0.8960561188309234</c:v>
                </c:pt>
                <c:pt idx="313">
                  <c:v>0.88146502814214056</c:v>
                </c:pt>
                <c:pt idx="314">
                  <c:v>0.88784285170155652</c:v>
                </c:pt>
                <c:pt idx="315">
                  <c:v>0.89952837638227878</c:v>
                </c:pt>
                <c:pt idx="316">
                  <c:v>0.88244800129529455</c:v>
                </c:pt>
                <c:pt idx="317">
                  <c:v>0.89771284000939588</c:v>
                </c:pt>
                <c:pt idx="318">
                  <c:v>0.88978402460706552</c:v>
                </c:pt>
                <c:pt idx="319">
                  <c:v>0.88347211598905973</c:v>
                </c:pt>
                <c:pt idx="320">
                  <c:v>0.8958371396631436</c:v>
                </c:pt>
                <c:pt idx="321">
                  <c:v>0.87885674294367466</c:v>
                </c:pt>
                <c:pt idx="322">
                  <c:v>0.89077938446061888</c:v>
                </c:pt>
                <c:pt idx="323">
                  <c:v>0.88976898361372225</c:v>
                </c:pt>
                <c:pt idx="324">
                  <c:v>0.8968656781784855</c:v>
                </c:pt>
                <c:pt idx="325">
                  <c:v>0.88569774062160933</c:v>
                </c:pt>
                <c:pt idx="326">
                  <c:v>0.89639763785623339</c:v>
                </c:pt>
                <c:pt idx="327">
                  <c:v>0.88644359693853869</c:v>
                </c:pt>
                <c:pt idx="328">
                  <c:v>0.88447543872144452</c:v>
                </c:pt>
                <c:pt idx="329">
                  <c:v>0.89581944437685845</c:v>
                </c:pt>
                <c:pt idx="330">
                  <c:v>0.88439757946178876</c:v>
                </c:pt>
                <c:pt idx="331">
                  <c:v>0.88477360429535379</c:v>
                </c:pt>
                <c:pt idx="332">
                  <c:v>0.88955000444594057</c:v>
                </c:pt>
                <c:pt idx="333">
                  <c:v>0.88804192367226709</c:v>
                </c:pt>
                <c:pt idx="334">
                  <c:v>0.89430428548867069</c:v>
                </c:pt>
                <c:pt idx="335">
                  <c:v>0.88372737049372962</c:v>
                </c:pt>
                <c:pt idx="336">
                  <c:v>0.88634273380671158</c:v>
                </c:pt>
                <c:pt idx="337">
                  <c:v>0.87395559102477671</c:v>
                </c:pt>
                <c:pt idx="338">
                  <c:v>0.89128281535543818</c:v>
                </c:pt>
                <c:pt idx="339">
                  <c:v>0.89801764131565986</c:v>
                </c:pt>
                <c:pt idx="340">
                  <c:v>0.90147397310935806</c:v>
                </c:pt>
                <c:pt idx="341">
                  <c:v>0.88190696791711709</c:v>
                </c:pt>
                <c:pt idx="342">
                  <c:v>0.89382031940876561</c:v>
                </c:pt>
                <c:pt idx="343">
                  <c:v>0.8732570695986579</c:v>
                </c:pt>
                <c:pt idx="344">
                  <c:v>0.88514166625009216</c:v>
                </c:pt>
                <c:pt idx="345">
                  <c:v>0.8918924179679707</c:v>
                </c:pt>
                <c:pt idx="346">
                  <c:v>0.89194108000525552</c:v>
                </c:pt>
                <c:pt idx="347">
                  <c:v>0.87685496368263671</c:v>
                </c:pt>
                <c:pt idx="348">
                  <c:v>0.88661391406903589</c:v>
                </c:pt>
                <c:pt idx="349">
                  <c:v>0.89479090586151955</c:v>
                </c:pt>
                <c:pt idx="350">
                  <c:v>0.90206809234639074</c:v>
                </c:pt>
                <c:pt idx="351">
                  <c:v>0.89096076114504208</c:v>
                </c:pt>
                <c:pt idx="352">
                  <c:v>0.9075974269284216</c:v>
                </c:pt>
                <c:pt idx="353">
                  <c:v>0.87843603751223753</c:v>
                </c:pt>
                <c:pt idx="354">
                  <c:v>0.8843542260103896</c:v>
                </c:pt>
                <c:pt idx="355">
                  <c:v>0.89131024304918061</c:v>
                </c:pt>
                <c:pt idx="356">
                  <c:v>0.88087931416609599</c:v>
                </c:pt>
                <c:pt idx="357">
                  <c:v>0.88203658588915579</c:v>
                </c:pt>
                <c:pt idx="358">
                  <c:v>0.90400793810542768</c:v>
                </c:pt>
                <c:pt idx="359">
                  <c:v>0.89638657830230273</c:v>
                </c:pt>
                <c:pt idx="360">
                  <c:v>0.88596715135530357</c:v>
                </c:pt>
                <c:pt idx="361">
                  <c:v>0.89050201084809499</c:v>
                </c:pt>
                <c:pt idx="362">
                  <c:v>0.87768133355216715</c:v>
                </c:pt>
                <c:pt idx="363">
                  <c:v>0.90316033389235428</c:v>
                </c:pt>
                <c:pt idx="364">
                  <c:v>0.88108236757621661</c:v>
                </c:pt>
                <c:pt idx="365">
                  <c:v>0.88881653482941059</c:v>
                </c:pt>
                <c:pt idx="366">
                  <c:v>0.86703673408718163</c:v>
                </c:pt>
                <c:pt idx="367">
                  <c:v>0.87464261051480974</c:v>
                </c:pt>
                <c:pt idx="368">
                  <c:v>0.88413347731397995</c:v>
                </c:pt>
                <c:pt idx="369">
                  <c:v>0.8775083621287256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49317776"/>
        <c:axId val="249318168"/>
      </c:scatterChart>
      <c:valAx>
        <c:axId val="249317776"/>
        <c:scaling>
          <c:orientation val="minMax"/>
          <c:max val="50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Time, s</a:t>
                </a:r>
              </a:p>
            </c:rich>
          </c:tx>
          <c:layout>
            <c:manualLayout>
              <c:xMode val="edge"/>
              <c:yMode val="edge"/>
              <c:x val="0.75583125262670681"/>
              <c:y val="0.8339829116068299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prstClr val="black"/>
            </a:solidFill>
          </a:ln>
        </c:spPr>
        <c:txPr>
          <a:bodyPr rot="0" vert="horz"/>
          <a:lstStyle/>
          <a:p>
            <a:pPr>
              <a:defRPr sz="1200" b="1" i="0" u="none" strike="noStrike" baseline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</a:defRPr>
            </a:pPr>
            <a:endParaRPr lang="en-US"/>
          </a:p>
        </c:txPr>
        <c:crossAx val="249318168"/>
        <c:crosses val="autoZero"/>
        <c:crossBetween val="midCat"/>
        <c:majorUnit val="100"/>
        <c:minorUnit val="20"/>
      </c:valAx>
      <c:valAx>
        <c:axId val="249318168"/>
        <c:scaling>
          <c:orientation val="minMax"/>
          <c:max val="1.1000000000000001"/>
          <c:min val="0.60000000000000064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prstClr val="black"/>
            </a:solidFill>
          </a:ln>
        </c:spPr>
        <c:crossAx val="249317776"/>
        <c:crosses val="autoZero"/>
        <c:crossBetween val="midCat"/>
        <c:majorUnit val="0.1"/>
        <c:minorUnit val="4.0000000000000022E-2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 b="1">
          <a:latin typeface="Times New Roman" pitchFamily="18" charset="0"/>
          <a:cs typeface="Times New Roman" pitchFamily="18" charset="0"/>
        </a:defRPr>
      </a:pPr>
      <a:endParaRPr lang="en-US"/>
    </a:p>
  </c:txPr>
  <c:externalData r:id="rId2">
    <c:autoUpdate val="0"/>
  </c:externalData>
  <c:userShapes r:id="rId3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8.7223008015087228E-2"/>
          <c:y val="0.14868168457360098"/>
          <c:w val="0.86704474546327892"/>
          <c:h val="0.66427072413689126"/>
        </c:manualLayout>
      </c:layout>
      <c:scatterChart>
        <c:scatterStyle val="smoothMarker"/>
        <c:varyColors val="0"/>
        <c:ser>
          <c:idx val="0"/>
          <c:order val="0"/>
          <c:spPr>
            <a:ln w="28575">
              <a:solidFill>
                <a:schemeClr val="tx1"/>
              </a:solidFill>
              <a:prstDash val="solid"/>
            </a:ln>
          </c:spPr>
          <c:marker>
            <c:symbol val="none"/>
          </c:marker>
          <c:xVal>
            <c:numRef>
              <c:f>'4may07_abRy3_cANip3_2a'!$C$1:$C$545</c:f>
              <c:numCache>
                <c:formatCode>General</c:formatCode>
                <c:ptCount val="545"/>
                <c:pt idx="0">
                  <c:v>0</c:v>
                </c:pt>
                <c:pt idx="1">
                  <c:v>1.63</c:v>
                </c:pt>
                <c:pt idx="2">
                  <c:v>3.26</c:v>
                </c:pt>
                <c:pt idx="3">
                  <c:v>4.8899999999999997</c:v>
                </c:pt>
                <c:pt idx="4">
                  <c:v>6.52</c:v>
                </c:pt>
                <c:pt idx="5">
                  <c:v>8.15</c:v>
                </c:pt>
                <c:pt idx="6">
                  <c:v>9.7799999999999994</c:v>
                </c:pt>
                <c:pt idx="7">
                  <c:v>11.41</c:v>
                </c:pt>
                <c:pt idx="8">
                  <c:v>13.04</c:v>
                </c:pt>
                <c:pt idx="9">
                  <c:v>14.67</c:v>
                </c:pt>
                <c:pt idx="10">
                  <c:v>16.3</c:v>
                </c:pt>
                <c:pt idx="11">
                  <c:v>17.93</c:v>
                </c:pt>
                <c:pt idx="12">
                  <c:v>19.559999999999999</c:v>
                </c:pt>
                <c:pt idx="13">
                  <c:v>21.19</c:v>
                </c:pt>
                <c:pt idx="14">
                  <c:v>22.82</c:v>
                </c:pt>
                <c:pt idx="15">
                  <c:v>24.45</c:v>
                </c:pt>
                <c:pt idx="16">
                  <c:v>26.08</c:v>
                </c:pt>
                <c:pt idx="17">
                  <c:v>27.71</c:v>
                </c:pt>
                <c:pt idx="18">
                  <c:v>29.34</c:v>
                </c:pt>
                <c:pt idx="19">
                  <c:v>30.97</c:v>
                </c:pt>
                <c:pt idx="20">
                  <c:v>32.6</c:v>
                </c:pt>
                <c:pt idx="21">
                  <c:v>34.229999999999997</c:v>
                </c:pt>
                <c:pt idx="22">
                  <c:v>35.86</c:v>
                </c:pt>
                <c:pt idx="23">
                  <c:v>37.49</c:v>
                </c:pt>
                <c:pt idx="24">
                  <c:v>39.119999999999997</c:v>
                </c:pt>
                <c:pt idx="25">
                  <c:v>40.75</c:v>
                </c:pt>
                <c:pt idx="26">
                  <c:v>42.38</c:v>
                </c:pt>
                <c:pt idx="27">
                  <c:v>44.01</c:v>
                </c:pt>
                <c:pt idx="28">
                  <c:v>45.64</c:v>
                </c:pt>
                <c:pt idx="29">
                  <c:v>47.27</c:v>
                </c:pt>
                <c:pt idx="30">
                  <c:v>48.9</c:v>
                </c:pt>
                <c:pt idx="31">
                  <c:v>50.53</c:v>
                </c:pt>
                <c:pt idx="32">
                  <c:v>52.16</c:v>
                </c:pt>
                <c:pt idx="33">
                  <c:v>53.79</c:v>
                </c:pt>
                <c:pt idx="34">
                  <c:v>55.42</c:v>
                </c:pt>
                <c:pt idx="35">
                  <c:v>57.05</c:v>
                </c:pt>
                <c:pt idx="36">
                  <c:v>58.68</c:v>
                </c:pt>
                <c:pt idx="37">
                  <c:v>60.31</c:v>
                </c:pt>
                <c:pt idx="38">
                  <c:v>61.94</c:v>
                </c:pt>
                <c:pt idx="39">
                  <c:v>63.57</c:v>
                </c:pt>
                <c:pt idx="40">
                  <c:v>65.2</c:v>
                </c:pt>
                <c:pt idx="41">
                  <c:v>66.83</c:v>
                </c:pt>
                <c:pt idx="42">
                  <c:v>68.459999999999994</c:v>
                </c:pt>
                <c:pt idx="43">
                  <c:v>70.09</c:v>
                </c:pt>
                <c:pt idx="44">
                  <c:v>71.72</c:v>
                </c:pt>
                <c:pt idx="45">
                  <c:v>73.349999999999994</c:v>
                </c:pt>
                <c:pt idx="46">
                  <c:v>74.98</c:v>
                </c:pt>
                <c:pt idx="47">
                  <c:v>76.61</c:v>
                </c:pt>
                <c:pt idx="48">
                  <c:v>78.239999999999995</c:v>
                </c:pt>
                <c:pt idx="49">
                  <c:v>79.87</c:v>
                </c:pt>
                <c:pt idx="50">
                  <c:v>81.5</c:v>
                </c:pt>
                <c:pt idx="51">
                  <c:v>83.13</c:v>
                </c:pt>
                <c:pt idx="52">
                  <c:v>84.76</c:v>
                </c:pt>
                <c:pt idx="53">
                  <c:v>86.39</c:v>
                </c:pt>
                <c:pt idx="54">
                  <c:v>88.02</c:v>
                </c:pt>
                <c:pt idx="55">
                  <c:v>89.65</c:v>
                </c:pt>
                <c:pt idx="56">
                  <c:v>91.28</c:v>
                </c:pt>
                <c:pt idx="57">
                  <c:v>92.91</c:v>
                </c:pt>
                <c:pt idx="58">
                  <c:v>94.54</c:v>
                </c:pt>
                <c:pt idx="59">
                  <c:v>96.17</c:v>
                </c:pt>
                <c:pt idx="60">
                  <c:v>97.8</c:v>
                </c:pt>
                <c:pt idx="61">
                  <c:v>99.43</c:v>
                </c:pt>
                <c:pt idx="62">
                  <c:v>101.06</c:v>
                </c:pt>
                <c:pt idx="63">
                  <c:v>102.69</c:v>
                </c:pt>
                <c:pt idx="64">
                  <c:v>104.32</c:v>
                </c:pt>
                <c:pt idx="65">
                  <c:v>105.95</c:v>
                </c:pt>
                <c:pt idx="66">
                  <c:v>107.58</c:v>
                </c:pt>
                <c:pt idx="67">
                  <c:v>109.21</c:v>
                </c:pt>
                <c:pt idx="68">
                  <c:v>110.84</c:v>
                </c:pt>
                <c:pt idx="69">
                  <c:v>112.47</c:v>
                </c:pt>
                <c:pt idx="70">
                  <c:v>114.1</c:v>
                </c:pt>
                <c:pt idx="71">
                  <c:v>115.73</c:v>
                </c:pt>
                <c:pt idx="72">
                  <c:v>117.36</c:v>
                </c:pt>
                <c:pt idx="73">
                  <c:v>118.99</c:v>
                </c:pt>
                <c:pt idx="74">
                  <c:v>120.62</c:v>
                </c:pt>
                <c:pt idx="75">
                  <c:v>122.25</c:v>
                </c:pt>
                <c:pt idx="76">
                  <c:v>123.88</c:v>
                </c:pt>
                <c:pt idx="77">
                  <c:v>125.51</c:v>
                </c:pt>
                <c:pt idx="78">
                  <c:v>127.14</c:v>
                </c:pt>
                <c:pt idx="79">
                  <c:v>128.77000000000001</c:v>
                </c:pt>
                <c:pt idx="80">
                  <c:v>130.4</c:v>
                </c:pt>
                <c:pt idx="81">
                  <c:v>132.03</c:v>
                </c:pt>
                <c:pt idx="82">
                  <c:v>133.66</c:v>
                </c:pt>
                <c:pt idx="83">
                  <c:v>135.29</c:v>
                </c:pt>
                <c:pt idx="84">
                  <c:v>136.91999999999999</c:v>
                </c:pt>
                <c:pt idx="85">
                  <c:v>138.55000000000001</c:v>
                </c:pt>
                <c:pt idx="86">
                  <c:v>140.18</c:v>
                </c:pt>
                <c:pt idx="87">
                  <c:v>141.81</c:v>
                </c:pt>
                <c:pt idx="88">
                  <c:v>143.44</c:v>
                </c:pt>
                <c:pt idx="89">
                  <c:v>145.07</c:v>
                </c:pt>
                <c:pt idx="90">
                  <c:v>146.69999999999999</c:v>
                </c:pt>
                <c:pt idx="91">
                  <c:v>148.33000000000001</c:v>
                </c:pt>
                <c:pt idx="92">
                  <c:v>149.96</c:v>
                </c:pt>
                <c:pt idx="93">
                  <c:v>151.59</c:v>
                </c:pt>
                <c:pt idx="94">
                  <c:v>153.22</c:v>
                </c:pt>
                <c:pt idx="95">
                  <c:v>154.85</c:v>
                </c:pt>
                <c:pt idx="96">
                  <c:v>156.47999999999999</c:v>
                </c:pt>
                <c:pt idx="97">
                  <c:v>158.11000000000001</c:v>
                </c:pt>
                <c:pt idx="98">
                  <c:v>159.74</c:v>
                </c:pt>
                <c:pt idx="99">
                  <c:v>161.37</c:v>
                </c:pt>
                <c:pt idx="100">
                  <c:v>163</c:v>
                </c:pt>
                <c:pt idx="101">
                  <c:v>164.63</c:v>
                </c:pt>
                <c:pt idx="102">
                  <c:v>166.26</c:v>
                </c:pt>
                <c:pt idx="103">
                  <c:v>167.89</c:v>
                </c:pt>
                <c:pt idx="104">
                  <c:v>169.52</c:v>
                </c:pt>
                <c:pt idx="105">
                  <c:v>171.15</c:v>
                </c:pt>
                <c:pt idx="106">
                  <c:v>172.78</c:v>
                </c:pt>
                <c:pt idx="107">
                  <c:v>174.41</c:v>
                </c:pt>
                <c:pt idx="108">
                  <c:v>176.04</c:v>
                </c:pt>
                <c:pt idx="109">
                  <c:v>177.67</c:v>
                </c:pt>
                <c:pt idx="110">
                  <c:v>179.3</c:v>
                </c:pt>
                <c:pt idx="111">
                  <c:v>180.93</c:v>
                </c:pt>
                <c:pt idx="112">
                  <c:v>182.56</c:v>
                </c:pt>
                <c:pt idx="113">
                  <c:v>184.19</c:v>
                </c:pt>
                <c:pt idx="114">
                  <c:v>185.82</c:v>
                </c:pt>
                <c:pt idx="115">
                  <c:v>187.45</c:v>
                </c:pt>
                <c:pt idx="116">
                  <c:v>189.08</c:v>
                </c:pt>
                <c:pt idx="117">
                  <c:v>190.71</c:v>
                </c:pt>
                <c:pt idx="118">
                  <c:v>192.34</c:v>
                </c:pt>
                <c:pt idx="119">
                  <c:v>193.97</c:v>
                </c:pt>
                <c:pt idx="120">
                  <c:v>195.6</c:v>
                </c:pt>
                <c:pt idx="121">
                  <c:v>197.23</c:v>
                </c:pt>
                <c:pt idx="122">
                  <c:v>198.86</c:v>
                </c:pt>
                <c:pt idx="123">
                  <c:v>200.49</c:v>
                </c:pt>
                <c:pt idx="124">
                  <c:v>202.12</c:v>
                </c:pt>
                <c:pt idx="125">
                  <c:v>203.75</c:v>
                </c:pt>
                <c:pt idx="126">
                  <c:v>205.38</c:v>
                </c:pt>
                <c:pt idx="127">
                  <c:v>207.01</c:v>
                </c:pt>
                <c:pt idx="128">
                  <c:v>208.64</c:v>
                </c:pt>
                <c:pt idx="129">
                  <c:v>210.27</c:v>
                </c:pt>
                <c:pt idx="130">
                  <c:v>211.9</c:v>
                </c:pt>
                <c:pt idx="131">
                  <c:v>213.53</c:v>
                </c:pt>
                <c:pt idx="132">
                  <c:v>215.16</c:v>
                </c:pt>
                <c:pt idx="133">
                  <c:v>216.79</c:v>
                </c:pt>
                <c:pt idx="134">
                  <c:v>218.42</c:v>
                </c:pt>
                <c:pt idx="135">
                  <c:v>220.05</c:v>
                </c:pt>
                <c:pt idx="136">
                  <c:v>221.68</c:v>
                </c:pt>
                <c:pt idx="137">
                  <c:v>223.31</c:v>
                </c:pt>
                <c:pt idx="138">
                  <c:v>224.94</c:v>
                </c:pt>
                <c:pt idx="139">
                  <c:v>226.57</c:v>
                </c:pt>
                <c:pt idx="140">
                  <c:v>228.2</c:v>
                </c:pt>
                <c:pt idx="141">
                  <c:v>229.83</c:v>
                </c:pt>
                <c:pt idx="142">
                  <c:v>231.46</c:v>
                </c:pt>
                <c:pt idx="143">
                  <c:v>233.09</c:v>
                </c:pt>
                <c:pt idx="144">
                  <c:v>234.72</c:v>
                </c:pt>
                <c:pt idx="145">
                  <c:v>236.35</c:v>
                </c:pt>
                <c:pt idx="146">
                  <c:v>237.98</c:v>
                </c:pt>
                <c:pt idx="147">
                  <c:v>239.61</c:v>
                </c:pt>
                <c:pt idx="148">
                  <c:v>241.24</c:v>
                </c:pt>
                <c:pt idx="149">
                  <c:v>242.87</c:v>
                </c:pt>
                <c:pt idx="150">
                  <c:v>244.5</c:v>
                </c:pt>
                <c:pt idx="151">
                  <c:v>246.13</c:v>
                </c:pt>
                <c:pt idx="152">
                  <c:v>247.76</c:v>
                </c:pt>
                <c:pt idx="153">
                  <c:v>249.39</c:v>
                </c:pt>
                <c:pt idx="154">
                  <c:v>251.02</c:v>
                </c:pt>
                <c:pt idx="155">
                  <c:v>252.65</c:v>
                </c:pt>
                <c:pt idx="156">
                  <c:v>254.28</c:v>
                </c:pt>
                <c:pt idx="157">
                  <c:v>255.91</c:v>
                </c:pt>
                <c:pt idx="158">
                  <c:v>257.54000000000002</c:v>
                </c:pt>
                <c:pt idx="159">
                  <c:v>259.17</c:v>
                </c:pt>
                <c:pt idx="160">
                  <c:v>260.8</c:v>
                </c:pt>
                <c:pt idx="161">
                  <c:v>262.43</c:v>
                </c:pt>
                <c:pt idx="162">
                  <c:v>264.06</c:v>
                </c:pt>
                <c:pt idx="163">
                  <c:v>265.69</c:v>
                </c:pt>
                <c:pt idx="164">
                  <c:v>267.32</c:v>
                </c:pt>
                <c:pt idx="165">
                  <c:v>268.95</c:v>
                </c:pt>
                <c:pt idx="166">
                  <c:v>270.58</c:v>
                </c:pt>
                <c:pt idx="167">
                  <c:v>272.20999999999998</c:v>
                </c:pt>
                <c:pt idx="168">
                  <c:v>273.83999999999997</c:v>
                </c:pt>
                <c:pt idx="169">
                  <c:v>275.47000000000003</c:v>
                </c:pt>
                <c:pt idx="170">
                  <c:v>277.10000000000002</c:v>
                </c:pt>
                <c:pt idx="171">
                  <c:v>278.73</c:v>
                </c:pt>
                <c:pt idx="172">
                  <c:v>280.36</c:v>
                </c:pt>
                <c:pt idx="173">
                  <c:v>281.99</c:v>
                </c:pt>
                <c:pt idx="174">
                  <c:v>283.62</c:v>
                </c:pt>
                <c:pt idx="175">
                  <c:v>285.25</c:v>
                </c:pt>
                <c:pt idx="176">
                  <c:v>286.88</c:v>
                </c:pt>
                <c:pt idx="177">
                  <c:v>288.51</c:v>
                </c:pt>
                <c:pt idx="178">
                  <c:v>290.14</c:v>
                </c:pt>
                <c:pt idx="179">
                  <c:v>291.77</c:v>
                </c:pt>
                <c:pt idx="180">
                  <c:v>293.39999999999998</c:v>
                </c:pt>
                <c:pt idx="181">
                  <c:v>295.02999999999997</c:v>
                </c:pt>
                <c:pt idx="182">
                  <c:v>296.66000000000003</c:v>
                </c:pt>
                <c:pt idx="183">
                  <c:v>298.29000000000002</c:v>
                </c:pt>
                <c:pt idx="184">
                  <c:v>299.92</c:v>
                </c:pt>
                <c:pt idx="185">
                  <c:v>301.55</c:v>
                </c:pt>
                <c:pt idx="186">
                  <c:v>303.18</c:v>
                </c:pt>
                <c:pt idx="187">
                  <c:v>304.81</c:v>
                </c:pt>
                <c:pt idx="188">
                  <c:v>306.44</c:v>
                </c:pt>
                <c:pt idx="189">
                  <c:v>308.07</c:v>
                </c:pt>
                <c:pt idx="190">
                  <c:v>309.7</c:v>
                </c:pt>
                <c:pt idx="191">
                  <c:v>311.33</c:v>
                </c:pt>
                <c:pt idx="192">
                  <c:v>312.95999999999998</c:v>
                </c:pt>
                <c:pt idx="193">
                  <c:v>314.58999999999997</c:v>
                </c:pt>
                <c:pt idx="194">
                  <c:v>316.22000000000003</c:v>
                </c:pt>
                <c:pt idx="195">
                  <c:v>317.85000000000002</c:v>
                </c:pt>
                <c:pt idx="196">
                  <c:v>319.48</c:v>
                </c:pt>
                <c:pt idx="197">
                  <c:v>321.11</c:v>
                </c:pt>
                <c:pt idx="198">
                  <c:v>322.74</c:v>
                </c:pt>
                <c:pt idx="199">
                  <c:v>324.37</c:v>
                </c:pt>
                <c:pt idx="200">
                  <c:v>326</c:v>
                </c:pt>
                <c:pt idx="201">
                  <c:v>327.63</c:v>
                </c:pt>
                <c:pt idx="202">
                  <c:v>329.26</c:v>
                </c:pt>
                <c:pt idx="203">
                  <c:v>330.89</c:v>
                </c:pt>
                <c:pt idx="204">
                  <c:v>332.52</c:v>
                </c:pt>
                <c:pt idx="205">
                  <c:v>334.15</c:v>
                </c:pt>
                <c:pt idx="206">
                  <c:v>335.78</c:v>
                </c:pt>
                <c:pt idx="207">
                  <c:v>337.41</c:v>
                </c:pt>
                <c:pt idx="208">
                  <c:v>339.04</c:v>
                </c:pt>
                <c:pt idx="209">
                  <c:v>340.67</c:v>
                </c:pt>
                <c:pt idx="210">
                  <c:v>342.3</c:v>
                </c:pt>
                <c:pt idx="211">
                  <c:v>343.93</c:v>
                </c:pt>
                <c:pt idx="212">
                  <c:v>345.56</c:v>
                </c:pt>
                <c:pt idx="213">
                  <c:v>347.19</c:v>
                </c:pt>
                <c:pt idx="214">
                  <c:v>348.82</c:v>
                </c:pt>
                <c:pt idx="215">
                  <c:v>350.45</c:v>
                </c:pt>
                <c:pt idx="216">
                  <c:v>352.08</c:v>
                </c:pt>
                <c:pt idx="217">
                  <c:v>353.71</c:v>
                </c:pt>
                <c:pt idx="218">
                  <c:v>355.34</c:v>
                </c:pt>
                <c:pt idx="219">
                  <c:v>356.97</c:v>
                </c:pt>
                <c:pt idx="220">
                  <c:v>358.6</c:v>
                </c:pt>
                <c:pt idx="221">
                  <c:v>360.23</c:v>
                </c:pt>
                <c:pt idx="222">
                  <c:v>361.86</c:v>
                </c:pt>
                <c:pt idx="223">
                  <c:v>363.49</c:v>
                </c:pt>
                <c:pt idx="224">
                  <c:v>365.12</c:v>
                </c:pt>
                <c:pt idx="225">
                  <c:v>366.75</c:v>
                </c:pt>
                <c:pt idx="226">
                  <c:v>368.38</c:v>
                </c:pt>
                <c:pt idx="227">
                  <c:v>370.01</c:v>
                </c:pt>
                <c:pt idx="228">
                  <c:v>371.64</c:v>
                </c:pt>
                <c:pt idx="229">
                  <c:v>373.27</c:v>
                </c:pt>
                <c:pt idx="230">
                  <c:v>374.9</c:v>
                </c:pt>
                <c:pt idx="231">
                  <c:v>376.53</c:v>
                </c:pt>
                <c:pt idx="232">
                  <c:v>378.16</c:v>
                </c:pt>
                <c:pt idx="233">
                  <c:v>379.79</c:v>
                </c:pt>
                <c:pt idx="234">
                  <c:v>381.42</c:v>
                </c:pt>
                <c:pt idx="235">
                  <c:v>383.05</c:v>
                </c:pt>
                <c:pt idx="236">
                  <c:v>384.68</c:v>
                </c:pt>
                <c:pt idx="237">
                  <c:v>386.31</c:v>
                </c:pt>
                <c:pt idx="238">
                  <c:v>387.94</c:v>
                </c:pt>
                <c:pt idx="239">
                  <c:v>389.57</c:v>
                </c:pt>
                <c:pt idx="240">
                  <c:v>391.2</c:v>
                </c:pt>
                <c:pt idx="241">
                  <c:v>392.83</c:v>
                </c:pt>
                <c:pt idx="242">
                  <c:v>394.46</c:v>
                </c:pt>
                <c:pt idx="243">
                  <c:v>396.09</c:v>
                </c:pt>
                <c:pt idx="244">
                  <c:v>397.72</c:v>
                </c:pt>
                <c:pt idx="245">
                  <c:v>399.35</c:v>
                </c:pt>
                <c:pt idx="246">
                  <c:v>400.98</c:v>
                </c:pt>
                <c:pt idx="247">
                  <c:v>402.61</c:v>
                </c:pt>
                <c:pt idx="248">
                  <c:v>404.24</c:v>
                </c:pt>
                <c:pt idx="249">
                  <c:v>405.87</c:v>
                </c:pt>
                <c:pt idx="250">
                  <c:v>407.5</c:v>
                </c:pt>
                <c:pt idx="251">
                  <c:v>409.13</c:v>
                </c:pt>
                <c:pt idx="252">
                  <c:v>410.76</c:v>
                </c:pt>
                <c:pt idx="253">
                  <c:v>412.39</c:v>
                </c:pt>
                <c:pt idx="254">
                  <c:v>414.02</c:v>
                </c:pt>
                <c:pt idx="255">
                  <c:v>415.65</c:v>
                </c:pt>
                <c:pt idx="256">
                  <c:v>417.28</c:v>
                </c:pt>
                <c:pt idx="257">
                  <c:v>418.91</c:v>
                </c:pt>
                <c:pt idx="258">
                  <c:v>420.54</c:v>
                </c:pt>
                <c:pt idx="259">
                  <c:v>422.17</c:v>
                </c:pt>
                <c:pt idx="260">
                  <c:v>423.8</c:v>
                </c:pt>
                <c:pt idx="261">
                  <c:v>425.43</c:v>
                </c:pt>
                <c:pt idx="262">
                  <c:v>427.06</c:v>
                </c:pt>
                <c:pt idx="263">
                  <c:v>428.69</c:v>
                </c:pt>
                <c:pt idx="264">
                  <c:v>430.32</c:v>
                </c:pt>
                <c:pt idx="265">
                  <c:v>431.95</c:v>
                </c:pt>
                <c:pt idx="266">
                  <c:v>433.58</c:v>
                </c:pt>
                <c:pt idx="267">
                  <c:v>435.21</c:v>
                </c:pt>
                <c:pt idx="268">
                  <c:v>436.84</c:v>
                </c:pt>
                <c:pt idx="269">
                  <c:v>438.47</c:v>
                </c:pt>
                <c:pt idx="270">
                  <c:v>440.1</c:v>
                </c:pt>
                <c:pt idx="271">
                  <c:v>441.73</c:v>
                </c:pt>
                <c:pt idx="272">
                  <c:v>443.36</c:v>
                </c:pt>
                <c:pt idx="273">
                  <c:v>444.99</c:v>
                </c:pt>
                <c:pt idx="274">
                  <c:v>446.62</c:v>
                </c:pt>
                <c:pt idx="275">
                  <c:v>448.25</c:v>
                </c:pt>
                <c:pt idx="276">
                  <c:v>449.88</c:v>
                </c:pt>
                <c:pt idx="277">
                  <c:v>451.51</c:v>
                </c:pt>
                <c:pt idx="278">
                  <c:v>453.14</c:v>
                </c:pt>
                <c:pt idx="279">
                  <c:v>454.77</c:v>
                </c:pt>
                <c:pt idx="280">
                  <c:v>456.4</c:v>
                </c:pt>
                <c:pt idx="281">
                  <c:v>458.03</c:v>
                </c:pt>
                <c:pt idx="282">
                  <c:v>459.66</c:v>
                </c:pt>
                <c:pt idx="283">
                  <c:v>461.29</c:v>
                </c:pt>
                <c:pt idx="284">
                  <c:v>462.92</c:v>
                </c:pt>
                <c:pt idx="285">
                  <c:v>464.55</c:v>
                </c:pt>
                <c:pt idx="286">
                  <c:v>466.18</c:v>
                </c:pt>
                <c:pt idx="287">
                  <c:v>467.81</c:v>
                </c:pt>
                <c:pt idx="288">
                  <c:v>469.44</c:v>
                </c:pt>
                <c:pt idx="289">
                  <c:v>471.07</c:v>
                </c:pt>
                <c:pt idx="290">
                  <c:v>472.7</c:v>
                </c:pt>
                <c:pt idx="291">
                  <c:v>474.33</c:v>
                </c:pt>
                <c:pt idx="292">
                  <c:v>475.96</c:v>
                </c:pt>
                <c:pt idx="293">
                  <c:v>477.59</c:v>
                </c:pt>
                <c:pt idx="294">
                  <c:v>479.22</c:v>
                </c:pt>
                <c:pt idx="295">
                  <c:v>480.85</c:v>
                </c:pt>
                <c:pt idx="296">
                  <c:v>482.48</c:v>
                </c:pt>
                <c:pt idx="297">
                  <c:v>484.11</c:v>
                </c:pt>
                <c:pt idx="298">
                  <c:v>485.74</c:v>
                </c:pt>
                <c:pt idx="299">
                  <c:v>487.37</c:v>
                </c:pt>
                <c:pt idx="300">
                  <c:v>489</c:v>
                </c:pt>
                <c:pt idx="301">
                  <c:v>490.63</c:v>
                </c:pt>
                <c:pt idx="302">
                  <c:v>492.26</c:v>
                </c:pt>
                <c:pt idx="303">
                  <c:v>493.89</c:v>
                </c:pt>
                <c:pt idx="304">
                  <c:v>495.52</c:v>
                </c:pt>
                <c:pt idx="305">
                  <c:v>497.15</c:v>
                </c:pt>
                <c:pt idx="306">
                  <c:v>498.78</c:v>
                </c:pt>
                <c:pt idx="307">
                  <c:v>500.41</c:v>
                </c:pt>
                <c:pt idx="308">
                  <c:v>502.04</c:v>
                </c:pt>
                <c:pt idx="309">
                  <c:v>503.67</c:v>
                </c:pt>
                <c:pt idx="310">
                  <c:v>505.3</c:v>
                </c:pt>
                <c:pt idx="311">
                  <c:v>506.93</c:v>
                </c:pt>
                <c:pt idx="312">
                  <c:v>508.56</c:v>
                </c:pt>
                <c:pt idx="313">
                  <c:v>510.19</c:v>
                </c:pt>
                <c:pt idx="314">
                  <c:v>511.82</c:v>
                </c:pt>
                <c:pt idx="315">
                  <c:v>513.45000000000005</c:v>
                </c:pt>
                <c:pt idx="316">
                  <c:v>515.08000000000004</c:v>
                </c:pt>
                <c:pt idx="317">
                  <c:v>516.71</c:v>
                </c:pt>
                <c:pt idx="318">
                  <c:v>518.34</c:v>
                </c:pt>
                <c:pt idx="319">
                  <c:v>519.97</c:v>
                </c:pt>
                <c:pt idx="320">
                  <c:v>521.6</c:v>
                </c:pt>
                <c:pt idx="321">
                  <c:v>523.23</c:v>
                </c:pt>
                <c:pt idx="322">
                  <c:v>524.86</c:v>
                </c:pt>
                <c:pt idx="323">
                  <c:v>526.49</c:v>
                </c:pt>
                <c:pt idx="324">
                  <c:v>528.12</c:v>
                </c:pt>
                <c:pt idx="325">
                  <c:v>529.75</c:v>
                </c:pt>
                <c:pt idx="326">
                  <c:v>531.38</c:v>
                </c:pt>
                <c:pt idx="327">
                  <c:v>533.01</c:v>
                </c:pt>
                <c:pt idx="328">
                  <c:v>534.64</c:v>
                </c:pt>
                <c:pt idx="329">
                  <c:v>536.27</c:v>
                </c:pt>
                <c:pt idx="330">
                  <c:v>537.9</c:v>
                </c:pt>
                <c:pt idx="331">
                  <c:v>539.53</c:v>
                </c:pt>
                <c:pt idx="332">
                  <c:v>541.16</c:v>
                </c:pt>
                <c:pt idx="333">
                  <c:v>542.79</c:v>
                </c:pt>
                <c:pt idx="334">
                  <c:v>544.41999999999996</c:v>
                </c:pt>
                <c:pt idx="335">
                  <c:v>546.04999999999995</c:v>
                </c:pt>
                <c:pt idx="336">
                  <c:v>547.67999999999995</c:v>
                </c:pt>
                <c:pt idx="337">
                  <c:v>549.30999999999995</c:v>
                </c:pt>
                <c:pt idx="338">
                  <c:v>550.94000000000005</c:v>
                </c:pt>
                <c:pt idx="339">
                  <c:v>552.57000000000005</c:v>
                </c:pt>
                <c:pt idx="340">
                  <c:v>554.20000000000005</c:v>
                </c:pt>
                <c:pt idx="341">
                  <c:v>555.83000000000004</c:v>
                </c:pt>
                <c:pt idx="342">
                  <c:v>557.46</c:v>
                </c:pt>
                <c:pt idx="343">
                  <c:v>559.09</c:v>
                </c:pt>
                <c:pt idx="344">
                  <c:v>560.72</c:v>
                </c:pt>
                <c:pt idx="345">
                  <c:v>562.35</c:v>
                </c:pt>
                <c:pt idx="346">
                  <c:v>563.98</c:v>
                </c:pt>
                <c:pt idx="347">
                  <c:v>565.61</c:v>
                </c:pt>
                <c:pt idx="348">
                  <c:v>567.24</c:v>
                </c:pt>
                <c:pt idx="349">
                  <c:v>568.87</c:v>
                </c:pt>
                <c:pt idx="350">
                  <c:v>570.5</c:v>
                </c:pt>
                <c:pt idx="351">
                  <c:v>572.13</c:v>
                </c:pt>
                <c:pt idx="352">
                  <c:v>573.76</c:v>
                </c:pt>
                <c:pt idx="353">
                  <c:v>575.39</c:v>
                </c:pt>
                <c:pt idx="354">
                  <c:v>577.02</c:v>
                </c:pt>
                <c:pt idx="355">
                  <c:v>578.65</c:v>
                </c:pt>
                <c:pt idx="356">
                  <c:v>580.28</c:v>
                </c:pt>
                <c:pt idx="357">
                  <c:v>581.91</c:v>
                </c:pt>
                <c:pt idx="358">
                  <c:v>583.54</c:v>
                </c:pt>
                <c:pt idx="359">
                  <c:v>585.16999999999996</c:v>
                </c:pt>
                <c:pt idx="360">
                  <c:v>586.79999999999995</c:v>
                </c:pt>
                <c:pt idx="361">
                  <c:v>588.42999999999995</c:v>
                </c:pt>
                <c:pt idx="362">
                  <c:v>590.05999999999995</c:v>
                </c:pt>
                <c:pt idx="363">
                  <c:v>591.69000000000005</c:v>
                </c:pt>
                <c:pt idx="364">
                  <c:v>593.32000000000005</c:v>
                </c:pt>
                <c:pt idx="365">
                  <c:v>594.95000000000005</c:v>
                </c:pt>
                <c:pt idx="366">
                  <c:v>596.58000000000004</c:v>
                </c:pt>
                <c:pt idx="367">
                  <c:v>598.21</c:v>
                </c:pt>
                <c:pt idx="368">
                  <c:v>599.84</c:v>
                </c:pt>
                <c:pt idx="369">
                  <c:v>601.47</c:v>
                </c:pt>
                <c:pt idx="370">
                  <c:v>603.1</c:v>
                </c:pt>
                <c:pt idx="371">
                  <c:v>604.73</c:v>
                </c:pt>
                <c:pt idx="372">
                  <c:v>606.36</c:v>
                </c:pt>
                <c:pt idx="373">
                  <c:v>607.99</c:v>
                </c:pt>
                <c:pt idx="374">
                  <c:v>609.62</c:v>
                </c:pt>
                <c:pt idx="375">
                  <c:v>611.25</c:v>
                </c:pt>
                <c:pt idx="376">
                  <c:v>612.88</c:v>
                </c:pt>
                <c:pt idx="377">
                  <c:v>614.51</c:v>
                </c:pt>
                <c:pt idx="378">
                  <c:v>616.14</c:v>
                </c:pt>
                <c:pt idx="379">
                  <c:v>617.77</c:v>
                </c:pt>
                <c:pt idx="380">
                  <c:v>619.4</c:v>
                </c:pt>
                <c:pt idx="381">
                  <c:v>621.03</c:v>
                </c:pt>
                <c:pt idx="382">
                  <c:v>622.66</c:v>
                </c:pt>
                <c:pt idx="383">
                  <c:v>624.29</c:v>
                </c:pt>
                <c:pt idx="384">
                  <c:v>625.91999999999996</c:v>
                </c:pt>
                <c:pt idx="385">
                  <c:v>627.54999999999995</c:v>
                </c:pt>
                <c:pt idx="386">
                  <c:v>629.17999999999995</c:v>
                </c:pt>
                <c:pt idx="387">
                  <c:v>630.80999999999995</c:v>
                </c:pt>
                <c:pt idx="388">
                  <c:v>632.44000000000005</c:v>
                </c:pt>
                <c:pt idx="389">
                  <c:v>634.07000000000005</c:v>
                </c:pt>
                <c:pt idx="390">
                  <c:v>635.70000000000005</c:v>
                </c:pt>
                <c:pt idx="391">
                  <c:v>637.33000000000004</c:v>
                </c:pt>
                <c:pt idx="392">
                  <c:v>638.96</c:v>
                </c:pt>
                <c:pt idx="393">
                  <c:v>640.59</c:v>
                </c:pt>
                <c:pt idx="394">
                  <c:v>642.22</c:v>
                </c:pt>
                <c:pt idx="395">
                  <c:v>643.85</c:v>
                </c:pt>
                <c:pt idx="396">
                  <c:v>645.48</c:v>
                </c:pt>
                <c:pt idx="397">
                  <c:v>647.11</c:v>
                </c:pt>
                <c:pt idx="398">
                  <c:v>648.74</c:v>
                </c:pt>
                <c:pt idx="399">
                  <c:v>650.37</c:v>
                </c:pt>
                <c:pt idx="400">
                  <c:v>652</c:v>
                </c:pt>
                <c:pt idx="401">
                  <c:v>653.63</c:v>
                </c:pt>
                <c:pt idx="402">
                  <c:v>655.26</c:v>
                </c:pt>
                <c:pt idx="403">
                  <c:v>656.89</c:v>
                </c:pt>
                <c:pt idx="404">
                  <c:v>658.52</c:v>
                </c:pt>
                <c:pt idx="405">
                  <c:v>660.15</c:v>
                </c:pt>
                <c:pt idx="406">
                  <c:v>661.78</c:v>
                </c:pt>
                <c:pt idx="407">
                  <c:v>663.41</c:v>
                </c:pt>
                <c:pt idx="408">
                  <c:v>665.04</c:v>
                </c:pt>
                <c:pt idx="409">
                  <c:v>666.67</c:v>
                </c:pt>
                <c:pt idx="410">
                  <c:v>668.3</c:v>
                </c:pt>
                <c:pt idx="411">
                  <c:v>669.93</c:v>
                </c:pt>
                <c:pt idx="412">
                  <c:v>671.56</c:v>
                </c:pt>
                <c:pt idx="413">
                  <c:v>673.18999999999994</c:v>
                </c:pt>
                <c:pt idx="414">
                  <c:v>674.81999999999994</c:v>
                </c:pt>
                <c:pt idx="415">
                  <c:v>676.44999999999993</c:v>
                </c:pt>
                <c:pt idx="416">
                  <c:v>678.07999999999993</c:v>
                </c:pt>
                <c:pt idx="417">
                  <c:v>679.70999999999992</c:v>
                </c:pt>
                <c:pt idx="418">
                  <c:v>681.33999999999992</c:v>
                </c:pt>
                <c:pt idx="419">
                  <c:v>682.96999999999991</c:v>
                </c:pt>
                <c:pt idx="420">
                  <c:v>684.59999999999991</c:v>
                </c:pt>
                <c:pt idx="421">
                  <c:v>686.2299999999999</c:v>
                </c:pt>
                <c:pt idx="422">
                  <c:v>687.8599999999999</c:v>
                </c:pt>
                <c:pt idx="423">
                  <c:v>689.4899999999999</c:v>
                </c:pt>
                <c:pt idx="424">
                  <c:v>691.11999999999989</c:v>
                </c:pt>
                <c:pt idx="425">
                  <c:v>692.74999999999989</c:v>
                </c:pt>
                <c:pt idx="426">
                  <c:v>694.37999999999988</c:v>
                </c:pt>
                <c:pt idx="427">
                  <c:v>696.00999999999988</c:v>
                </c:pt>
                <c:pt idx="428">
                  <c:v>697.63999999999987</c:v>
                </c:pt>
                <c:pt idx="429">
                  <c:v>699.26999999999987</c:v>
                </c:pt>
                <c:pt idx="430">
                  <c:v>700.89999999999986</c:v>
                </c:pt>
                <c:pt idx="431">
                  <c:v>702.52999999999986</c:v>
                </c:pt>
                <c:pt idx="432">
                  <c:v>704.15999999999985</c:v>
                </c:pt>
                <c:pt idx="433">
                  <c:v>705.78999999999985</c:v>
                </c:pt>
                <c:pt idx="434">
                  <c:v>707.41999999999985</c:v>
                </c:pt>
                <c:pt idx="435">
                  <c:v>709.04999999999984</c:v>
                </c:pt>
                <c:pt idx="436">
                  <c:v>710.67999999999984</c:v>
                </c:pt>
                <c:pt idx="437">
                  <c:v>712.30999999999983</c:v>
                </c:pt>
                <c:pt idx="438">
                  <c:v>713.93999999999983</c:v>
                </c:pt>
                <c:pt idx="439">
                  <c:v>715.56999999999982</c:v>
                </c:pt>
                <c:pt idx="440">
                  <c:v>717.19999999999982</c:v>
                </c:pt>
                <c:pt idx="441">
                  <c:v>718.82999999999981</c:v>
                </c:pt>
                <c:pt idx="442">
                  <c:v>720.45999999999981</c:v>
                </c:pt>
                <c:pt idx="443">
                  <c:v>722.0899999999998</c:v>
                </c:pt>
                <c:pt idx="444">
                  <c:v>723.7199999999998</c:v>
                </c:pt>
                <c:pt idx="445">
                  <c:v>725.3499999999998</c:v>
                </c:pt>
                <c:pt idx="446">
                  <c:v>726.97999999999979</c:v>
                </c:pt>
                <c:pt idx="447">
                  <c:v>728.60999999999979</c:v>
                </c:pt>
                <c:pt idx="448">
                  <c:v>730.23999999999978</c:v>
                </c:pt>
                <c:pt idx="449">
                  <c:v>731.86999999999978</c:v>
                </c:pt>
                <c:pt idx="450">
                  <c:v>733.49999999999977</c:v>
                </c:pt>
                <c:pt idx="451">
                  <c:v>735.12999999999977</c:v>
                </c:pt>
                <c:pt idx="452">
                  <c:v>736.75999999999976</c:v>
                </c:pt>
                <c:pt idx="453">
                  <c:v>738.38999999999976</c:v>
                </c:pt>
                <c:pt idx="454">
                  <c:v>740.01999999999975</c:v>
                </c:pt>
                <c:pt idx="455">
                  <c:v>741.64999999999975</c:v>
                </c:pt>
                <c:pt idx="456">
                  <c:v>743.27999999999975</c:v>
                </c:pt>
                <c:pt idx="457">
                  <c:v>744.90999999999974</c:v>
                </c:pt>
                <c:pt idx="458">
                  <c:v>746.53999999999974</c:v>
                </c:pt>
                <c:pt idx="459">
                  <c:v>748.16999999999973</c:v>
                </c:pt>
                <c:pt idx="460">
                  <c:v>749.79999999999973</c:v>
                </c:pt>
                <c:pt idx="461">
                  <c:v>751.42999999999972</c:v>
                </c:pt>
                <c:pt idx="462">
                  <c:v>753.05999999999972</c:v>
                </c:pt>
                <c:pt idx="463">
                  <c:v>754.68999999999971</c:v>
                </c:pt>
                <c:pt idx="464">
                  <c:v>756.31999999999971</c:v>
                </c:pt>
                <c:pt idx="465">
                  <c:v>757.9499999999997</c:v>
                </c:pt>
                <c:pt idx="466">
                  <c:v>759.5799999999997</c:v>
                </c:pt>
                <c:pt idx="467">
                  <c:v>761.2099999999997</c:v>
                </c:pt>
                <c:pt idx="468">
                  <c:v>762.83999999999969</c:v>
                </c:pt>
                <c:pt idx="469">
                  <c:v>764.46999999999969</c:v>
                </c:pt>
                <c:pt idx="470">
                  <c:v>766.09999999999968</c:v>
                </c:pt>
                <c:pt idx="471">
                  <c:v>767.72999999999968</c:v>
                </c:pt>
                <c:pt idx="472">
                  <c:v>769.35999999999967</c:v>
                </c:pt>
                <c:pt idx="473">
                  <c:v>770.98999999999967</c:v>
                </c:pt>
                <c:pt idx="474">
                  <c:v>772.61999999999966</c:v>
                </c:pt>
                <c:pt idx="475">
                  <c:v>774.24999999999966</c:v>
                </c:pt>
                <c:pt idx="476">
                  <c:v>775.87999999999965</c:v>
                </c:pt>
                <c:pt idx="477">
                  <c:v>777.50999999999965</c:v>
                </c:pt>
                <c:pt idx="478">
                  <c:v>779.13999999999965</c:v>
                </c:pt>
                <c:pt idx="479">
                  <c:v>780.76999999999964</c:v>
                </c:pt>
                <c:pt idx="480">
                  <c:v>782.39999999999964</c:v>
                </c:pt>
                <c:pt idx="481">
                  <c:v>784.02999999999963</c:v>
                </c:pt>
                <c:pt idx="482">
                  <c:v>785.65999999999963</c:v>
                </c:pt>
                <c:pt idx="483">
                  <c:v>787.28999999999962</c:v>
                </c:pt>
                <c:pt idx="484">
                  <c:v>788.91999999999962</c:v>
                </c:pt>
                <c:pt idx="485">
                  <c:v>790.54999999999961</c:v>
                </c:pt>
                <c:pt idx="486">
                  <c:v>792.17999999999961</c:v>
                </c:pt>
                <c:pt idx="487">
                  <c:v>793.8099999999996</c:v>
                </c:pt>
                <c:pt idx="488">
                  <c:v>795.4399999999996</c:v>
                </c:pt>
                <c:pt idx="489">
                  <c:v>797.0699999999996</c:v>
                </c:pt>
                <c:pt idx="490">
                  <c:v>798.69999999999959</c:v>
                </c:pt>
                <c:pt idx="491">
                  <c:v>800.32999999999959</c:v>
                </c:pt>
                <c:pt idx="492">
                  <c:v>801.95999999999958</c:v>
                </c:pt>
                <c:pt idx="493">
                  <c:v>803.58999999999958</c:v>
                </c:pt>
                <c:pt idx="494">
                  <c:v>805.21999999999957</c:v>
                </c:pt>
                <c:pt idx="495">
                  <c:v>806.84999999999957</c:v>
                </c:pt>
                <c:pt idx="496">
                  <c:v>808.47999999999956</c:v>
                </c:pt>
                <c:pt idx="497">
                  <c:v>810.10999999999956</c:v>
                </c:pt>
                <c:pt idx="498">
                  <c:v>811.73999999999955</c:v>
                </c:pt>
                <c:pt idx="499">
                  <c:v>813.36999999999955</c:v>
                </c:pt>
                <c:pt idx="500">
                  <c:v>814.99999999999955</c:v>
                </c:pt>
                <c:pt idx="501">
                  <c:v>816.62999999999954</c:v>
                </c:pt>
                <c:pt idx="502">
                  <c:v>818.25999999999954</c:v>
                </c:pt>
                <c:pt idx="503">
                  <c:v>819.88999999999953</c:v>
                </c:pt>
                <c:pt idx="504">
                  <c:v>821.51999999999953</c:v>
                </c:pt>
                <c:pt idx="505">
                  <c:v>823.14999999999952</c:v>
                </c:pt>
                <c:pt idx="506">
                  <c:v>824.77999999999952</c:v>
                </c:pt>
                <c:pt idx="507">
                  <c:v>826.40999999999951</c:v>
                </c:pt>
                <c:pt idx="508">
                  <c:v>828.03999999999951</c:v>
                </c:pt>
                <c:pt idx="509">
                  <c:v>829.6699999999995</c:v>
                </c:pt>
                <c:pt idx="510">
                  <c:v>831.2999999999995</c:v>
                </c:pt>
                <c:pt idx="511">
                  <c:v>832.9299999999995</c:v>
                </c:pt>
                <c:pt idx="512">
                  <c:v>834.55999999999949</c:v>
                </c:pt>
                <c:pt idx="513">
                  <c:v>836.18999999999949</c:v>
                </c:pt>
                <c:pt idx="514">
                  <c:v>837.81999999999948</c:v>
                </c:pt>
                <c:pt idx="515">
                  <c:v>839.44999999999948</c:v>
                </c:pt>
                <c:pt idx="516">
                  <c:v>841.07999999999947</c:v>
                </c:pt>
                <c:pt idx="517">
                  <c:v>842.70999999999947</c:v>
                </c:pt>
                <c:pt idx="518">
                  <c:v>844.33999999999946</c:v>
                </c:pt>
                <c:pt idx="519">
                  <c:v>845.96999999999946</c:v>
                </c:pt>
                <c:pt idx="520">
                  <c:v>847.59999999999945</c:v>
                </c:pt>
                <c:pt idx="521">
                  <c:v>849.22999999999945</c:v>
                </c:pt>
                <c:pt idx="522">
                  <c:v>850.85999999999945</c:v>
                </c:pt>
                <c:pt idx="523">
                  <c:v>852.48999999999944</c:v>
                </c:pt>
                <c:pt idx="524">
                  <c:v>854.11999999999944</c:v>
                </c:pt>
                <c:pt idx="525">
                  <c:v>855.74999999999943</c:v>
                </c:pt>
                <c:pt idx="526">
                  <c:v>857.37999999999943</c:v>
                </c:pt>
                <c:pt idx="527">
                  <c:v>859.00999999999942</c:v>
                </c:pt>
                <c:pt idx="528">
                  <c:v>860.63999999999942</c:v>
                </c:pt>
                <c:pt idx="529">
                  <c:v>862.26999999999941</c:v>
                </c:pt>
                <c:pt idx="530">
                  <c:v>863.89999999999941</c:v>
                </c:pt>
                <c:pt idx="531">
                  <c:v>865.5299999999994</c:v>
                </c:pt>
                <c:pt idx="532">
                  <c:v>867.1599999999994</c:v>
                </c:pt>
                <c:pt idx="533">
                  <c:v>868.7899999999994</c:v>
                </c:pt>
                <c:pt idx="534">
                  <c:v>870.41999999999939</c:v>
                </c:pt>
                <c:pt idx="535">
                  <c:v>872.04999999999939</c:v>
                </c:pt>
                <c:pt idx="536">
                  <c:v>873.67999999999938</c:v>
                </c:pt>
                <c:pt idx="537">
                  <c:v>875.30999999999938</c:v>
                </c:pt>
                <c:pt idx="538">
                  <c:v>876.93999999999937</c:v>
                </c:pt>
                <c:pt idx="539">
                  <c:v>878.56999999999937</c:v>
                </c:pt>
                <c:pt idx="540">
                  <c:v>880.19999999999936</c:v>
                </c:pt>
                <c:pt idx="541">
                  <c:v>881.82999999999936</c:v>
                </c:pt>
                <c:pt idx="542">
                  <c:v>883.45999999999935</c:v>
                </c:pt>
                <c:pt idx="543">
                  <c:v>885.08999999999935</c:v>
                </c:pt>
                <c:pt idx="544">
                  <c:v>886.71999999999935</c:v>
                </c:pt>
              </c:numCache>
            </c:numRef>
          </c:xVal>
          <c:yVal>
            <c:numRef>
              <c:f>'4may07_abRy3_cANip3_2a'!$J$1:$J$430</c:f>
              <c:numCache>
                <c:formatCode>General</c:formatCode>
                <c:ptCount val="430"/>
                <c:pt idx="0">
                  <c:v>1.0031565667079438</c:v>
                </c:pt>
                <c:pt idx="1">
                  <c:v>0.99967324251803857</c:v>
                </c:pt>
                <c:pt idx="2">
                  <c:v>1.000137086626562</c:v>
                </c:pt>
                <c:pt idx="3">
                  <c:v>1.0010988604721263</c:v>
                </c:pt>
                <c:pt idx="4">
                  <c:v>0.99813700111081749</c:v>
                </c:pt>
                <c:pt idx="5">
                  <c:v>0.99747465478498176</c:v>
                </c:pt>
                <c:pt idx="6">
                  <c:v>1.0000849464514807</c:v>
                </c:pt>
                <c:pt idx="7">
                  <c:v>1.0004924683168426</c:v>
                </c:pt>
                <c:pt idx="8">
                  <c:v>1.0002095506399142</c:v>
                </c:pt>
                <c:pt idx="9">
                  <c:v>1.002317940324708</c:v>
                </c:pt>
                <c:pt idx="10">
                  <c:v>1.0008093940888951</c:v>
                </c:pt>
                <c:pt idx="11">
                  <c:v>1.0008031174869096</c:v>
                </c:pt>
                <c:pt idx="12">
                  <c:v>1.0028070161991283</c:v>
                </c:pt>
                <c:pt idx="13">
                  <c:v>1.0009598771247346</c:v>
                </c:pt>
                <c:pt idx="14">
                  <c:v>0.99887865701231726</c:v>
                </c:pt>
                <c:pt idx="15">
                  <c:v>0.99783010989941623</c:v>
                </c:pt>
                <c:pt idx="16">
                  <c:v>0.99752072712110773</c:v>
                </c:pt>
                <c:pt idx="17">
                  <c:v>0.99899925123619027</c:v>
                </c:pt>
                <c:pt idx="18">
                  <c:v>0.99791946061386638</c:v>
                </c:pt>
                <c:pt idx="19">
                  <c:v>0.99794209637017772</c:v>
                </c:pt>
                <c:pt idx="20">
                  <c:v>0.99452138859218231</c:v>
                </c:pt>
                <c:pt idx="21">
                  <c:v>0.9941343392333325</c:v>
                </c:pt>
                <c:pt idx="22">
                  <c:v>0.99690328873693368</c:v>
                </c:pt>
                <c:pt idx="23">
                  <c:v>0.99541316905189348</c:v>
                </c:pt>
                <c:pt idx="24">
                  <c:v>0.99488528710502933</c:v>
                </c:pt>
                <c:pt idx="25">
                  <c:v>0.99478985061238079</c:v>
                </c:pt>
                <c:pt idx="26">
                  <c:v>0.99339752871013409</c:v>
                </c:pt>
                <c:pt idx="27">
                  <c:v>0.99363208488661725</c:v>
                </c:pt>
                <c:pt idx="28">
                  <c:v>0.99742246965898984</c:v>
                </c:pt>
                <c:pt idx="29">
                  <c:v>0.99973075009361567</c:v>
                </c:pt>
                <c:pt idx="30">
                  <c:v>0.99783996876267311</c:v>
                </c:pt>
                <c:pt idx="31">
                  <c:v>0.99566361229785327</c:v>
                </c:pt>
                <c:pt idx="32">
                  <c:v>0.99729235700069041</c:v>
                </c:pt>
                <c:pt idx="33">
                  <c:v>0.9983575555443347</c:v>
                </c:pt>
                <c:pt idx="34">
                  <c:v>0.99747962730223827</c:v>
                </c:pt>
                <c:pt idx="35">
                  <c:v>0.9984842115505691</c:v>
                </c:pt>
                <c:pt idx="36">
                  <c:v>0.99631446820112401</c:v>
                </c:pt>
                <c:pt idx="37">
                  <c:v>0.99498102683948708</c:v>
                </c:pt>
                <c:pt idx="38">
                  <c:v>0.99526689349945707</c:v>
                </c:pt>
                <c:pt idx="39">
                  <c:v>0.99545719804294697</c:v>
                </c:pt>
                <c:pt idx="40">
                  <c:v>0.99342981272746933</c:v>
                </c:pt>
                <c:pt idx="41">
                  <c:v>0.99236401315435352</c:v>
                </c:pt>
                <c:pt idx="42">
                  <c:v>0.98988453631156104</c:v>
                </c:pt>
                <c:pt idx="43">
                  <c:v>0.989467625719889</c:v>
                </c:pt>
                <c:pt idx="44">
                  <c:v>0.99420010796151304</c:v>
                </c:pt>
                <c:pt idx="45">
                  <c:v>0.99021552302385474</c:v>
                </c:pt>
                <c:pt idx="46">
                  <c:v>0.9906791429526316</c:v>
                </c:pt>
                <c:pt idx="47">
                  <c:v>0.98857947008284119</c:v>
                </c:pt>
                <c:pt idx="48">
                  <c:v>0.98859278630906089</c:v>
                </c:pt>
                <c:pt idx="49">
                  <c:v>0.99050457459674712</c:v>
                </c:pt>
                <c:pt idx="50">
                  <c:v>0.98793034928510892</c:v>
                </c:pt>
                <c:pt idx="51">
                  <c:v>0.98367799772538911</c:v>
                </c:pt>
                <c:pt idx="52">
                  <c:v>0.98822973175512074</c:v>
                </c:pt>
                <c:pt idx="53">
                  <c:v>0.98960928787786573</c:v>
                </c:pt>
                <c:pt idx="54">
                  <c:v>0.98641604711042818</c:v>
                </c:pt>
                <c:pt idx="55">
                  <c:v>0.98857250692738718</c:v>
                </c:pt>
                <c:pt idx="56">
                  <c:v>0.98889649197597329</c:v>
                </c:pt>
                <c:pt idx="57">
                  <c:v>0.99000190141774325</c:v>
                </c:pt>
                <c:pt idx="58">
                  <c:v>0.99042429955162248</c:v>
                </c:pt>
                <c:pt idx="59">
                  <c:v>0.99175131619252099</c:v>
                </c:pt>
                <c:pt idx="60">
                  <c:v>0.99202920612275136</c:v>
                </c:pt>
                <c:pt idx="61">
                  <c:v>0.99491142300485735</c:v>
                </c:pt>
                <c:pt idx="62">
                  <c:v>0.99131855987764772</c:v>
                </c:pt>
                <c:pt idx="63">
                  <c:v>0.993696791090807</c:v>
                </c:pt>
                <c:pt idx="64">
                  <c:v>0.993716979081956</c:v>
                </c:pt>
                <c:pt idx="65">
                  <c:v>0.9940071313999681</c:v>
                </c:pt>
                <c:pt idx="66">
                  <c:v>0.9959008824796669</c:v>
                </c:pt>
                <c:pt idx="67">
                  <c:v>0.99751200982575972</c:v>
                </c:pt>
                <c:pt idx="68">
                  <c:v>0.99782755781415489</c:v>
                </c:pt>
                <c:pt idx="69">
                  <c:v>1.0028257602211714</c:v>
                </c:pt>
                <c:pt idx="70">
                  <c:v>0.99754469853367156</c:v>
                </c:pt>
                <c:pt idx="71">
                  <c:v>0.9950799797246288</c:v>
                </c:pt>
                <c:pt idx="72">
                  <c:v>0.99837222676808368</c:v>
                </c:pt>
                <c:pt idx="73">
                  <c:v>0.99547342183407261</c:v>
                </c:pt>
                <c:pt idx="74">
                  <c:v>1.0027222434027001</c:v>
                </c:pt>
                <c:pt idx="75">
                  <c:v>0.99971004374234951</c:v>
                </c:pt>
                <c:pt idx="76">
                  <c:v>1.0012119692062513</c:v>
                </c:pt>
                <c:pt idx="77">
                  <c:v>0.99928620636448406</c:v>
                </c:pt>
                <c:pt idx="78">
                  <c:v>0.99750180170193559</c:v>
                </c:pt>
                <c:pt idx="79">
                  <c:v>0.99532821291578422</c:v>
                </c:pt>
                <c:pt idx="80">
                  <c:v>0.99350306837228231</c:v>
                </c:pt>
                <c:pt idx="81">
                  <c:v>0.99312764288453159</c:v>
                </c:pt>
                <c:pt idx="82">
                  <c:v>0.99265167129924281</c:v>
                </c:pt>
                <c:pt idx="83">
                  <c:v>0.99176485945219739</c:v>
                </c:pt>
                <c:pt idx="84">
                  <c:v>0.98886893539935761</c:v>
                </c:pt>
                <c:pt idx="85">
                  <c:v>0.98808106197449619</c:v>
                </c:pt>
                <c:pt idx="86">
                  <c:v>0.98827995378769862</c:v>
                </c:pt>
                <c:pt idx="87">
                  <c:v>0.98489704872252049</c:v>
                </c:pt>
                <c:pt idx="88">
                  <c:v>0.99008829037083834</c:v>
                </c:pt>
                <c:pt idx="89">
                  <c:v>0.98926219412075966</c:v>
                </c:pt>
                <c:pt idx="90">
                  <c:v>0.9875640383031179</c:v>
                </c:pt>
                <c:pt idx="91">
                  <c:v>0.99259573591643802</c:v>
                </c:pt>
                <c:pt idx="92">
                  <c:v>0.98628410698787994</c:v>
                </c:pt>
                <c:pt idx="93">
                  <c:v>0.99111207595806405</c:v>
                </c:pt>
                <c:pt idx="94">
                  <c:v>0.99478150347589711</c:v>
                </c:pt>
                <c:pt idx="95">
                  <c:v>0.99504466349947351</c:v>
                </c:pt>
                <c:pt idx="96">
                  <c:v>0.9951781085566308</c:v>
                </c:pt>
                <c:pt idx="97">
                  <c:v>0.99523011861607513</c:v>
                </c:pt>
                <c:pt idx="98">
                  <c:v>0.99784406471057452</c:v>
                </c:pt>
                <c:pt idx="99">
                  <c:v>0.99884586531121555</c:v>
                </c:pt>
                <c:pt idx="100">
                  <c:v>0.99279970594832989</c:v>
                </c:pt>
                <c:pt idx="101">
                  <c:v>0.9907176848848791</c:v>
                </c:pt>
                <c:pt idx="102">
                  <c:v>0.99095910914123353</c:v>
                </c:pt>
                <c:pt idx="103">
                  <c:v>0.98874866377061665</c:v>
                </c:pt>
                <c:pt idx="104">
                  <c:v>0.99126718651537593</c:v>
                </c:pt>
                <c:pt idx="105">
                  <c:v>0.99012518083524748</c:v>
                </c:pt>
                <c:pt idx="106">
                  <c:v>0.98396518226779195</c:v>
                </c:pt>
                <c:pt idx="107">
                  <c:v>0.9837195378571848</c:v>
                </c:pt>
                <c:pt idx="108">
                  <c:v>0.98192227777388774</c:v>
                </c:pt>
                <c:pt idx="109">
                  <c:v>0.98268470600276736</c:v>
                </c:pt>
                <c:pt idx="110">
                  <c:v>0.98267706417894529</c:v>
                </c:pt>
                <c:pt idx="111">
                  <c:v>0.97662881013186698</c:v>
                </c:pt>
                <c:pt idx="112">
                  <c:v>0.97048435238412212</c:v>
                </c:pt>
                <c:pt idx="113">
                  <c:v>0.96719928278347078</c:v>
                </c:pt>
                <c:pt idx="114">
                  <c:v>0.96349084073488989</c:v>
                </c:pt>
                <c:pt idx="115">
                  <c:v>0.96160649569747036</c:v>
                </c:pt>
                <c:pt idx="116">
                  <c:v>0.95472649346545757</c:v>
                </c:pt>
                <c:pt idx="117">
                  <c:v>0.94957974850711602</c:v>
                </c:pt>
                <c:pt idx="118">
                  <c:v>0.95368096998136132</c:v>
                </c:pt>
                <c:pt idx="119">
                  <c:v>0.95287459056523205</c:v>
                </c:pt>
                <c:pt idx="120">
                  <c:v>0.95005538523263922</c:v>
                </c:pt>
                <c:pt idx="121">
                  <c:v>0.94908915817265793</c:v>
                </c:pt>
                <c:pt idx="122">
                  <c:v>0.94259566800326844</c:v>
                </c:pt>
                <c:pt idx="123">
                  <c:v>0.94056547162515458</c:v>
                </c:pt>
                <c:pt idx="124">
                  <c:v>0.93595946487006509</c:v>
                </c:pt>
                <c:pt idx="125">
                  <c:v>0.93337953759566539</c:v>
                </c:pt>
                <c:pt idx="126">
                  <c:v>0.93248758365488627</c:v>
                </c:pt>
                <c:pt idx="127">
                  <c:v>0.92325852188790825</c:v>
                </c:pt>
                <c:pt idx="128">
                  <c:v>0.91868907999675775</c:v>
                </c:pt>
                <c:pt idx="129">
                  <c:v>0.91599151897996378</c:v>
                </c:pt>
                <c:pt idx="130">
                  <c:v>0.91367932820655895</c:v>
                </c:pt>
                <c:pt idx="131">
                  <c:v>0.9085217773048504</c:v>
                </c:pt>
                <c:pt idx="132">
                  <c:v>0.90900377685892686</c:v>
                </c:pt>
                <c:pt idx="133">
                  <c:v>0.90316616629515656</c:v>
                </c:pt>
                <c:pt idx="134">
                  <c:v>0.89991976616300973</c:v>
                </c:pt>
                <c:pt idx="135">
                  <c:v>0.89663868796915958</c:v>
                </c:pt>
                <c:pt idx="136">
                  <c:v>0.89282514876073882</c:v>
                </c:pt>
                <c:pt idx="137">
                  <c:v>0.88858177270396765</c:v>
                </c:pt>
                <c:pt idx="138">
                  <c:v>0.89005790880001379</c:v>
                </c:pt>
                <c:pt idx="139">
                  <c:v>0.88511716893327907</c:v>
                </c:pt>
                <c:pt idx="140">
                  <c:v>0.88290785312550835</c:v>
                </c:pt>
                <c:pt idx="141">
                  <c:v>0.88203230451150538</c:v>
                </c:pt>
                <c:pt idx="142">
                  <c:v>0.8801922156065628</c:v>
                </c:pt>
                <c:pt idx="143">
                  <c:v>0.87773608897339939</c:v>
                </c:pt>
                <c:pt idx="144">
                  <c:v>0.87217742440900792</c:v>
                </c:pt>
                <c:pt idx="145">
                  <c:v>0.86631490169566794</c:v>
                </c:pt>
                <c:pt idx="146">
                  <c:v>0.86163991311856114</c:v>
                </c:pt>
                <c:pt idx="147">
                  <c:v>0.85706376512106575</c:v>
                </c:pt>
                <c:pt idx="148">
                  <c:v>0.85259066717869747</c:v>
                </c:pt>
                <c:pt idx="149">
                  <c:v>0.85558345449363449</c:v>
                </c:pt>
                <c:pt idx="150">
                  <c:v>0.85044837098111303</c:v>
                </c:pt>
                <c:pt idx="151">
                  <c:v>0.85130128090446866</c:v>
                </c:pt>
                <c:pt idx="152">
                  <c:v>0.84931685198001083</c:v>
                </c:pt>
                <c:pt idx="153">
                  <c:v>0.84841273486334012</c:v>
                </c:pt>
                <c:pt idx="154">
                  <c:v>0.84455719693084541</c:v>
                </c:pt>
                <c:pt idx="155">
                  <c:v>0.84181068022684169</c:v>
                </c:pt>
                <c:pt idx="156">
                  <c:v>0.83763370651856006</c:v>
                </c:pt>
                <c:pt idx="157">
                  <c:v>0.83686257369838613</c:v>
                </c:pt>
                <c:pt idx="158">
                  <c:v>0.83552791665901827</c:v>
                </c:pt>
                <c:pt idx="159">
                  <c:v>0.83333799160506428</c:v>
                </c:pt>
                <c:pt idx="160">
                  <c:v>0.83317865772606936</c:v>
                </c:pt>
                <c:pt idx="161">
                  <c:v>0.82973985929161442</c:v>
                </c:pt>
                <c:pt idx="162">
                  <c:v>0.82846213954396175</c:v>
                </c:pt>
                <c:pt idx="163">
                  <c:v>0.82781320021464122</c:v>
                </c:pt>
                <c:pt idx="164">
                  <c:v>0.82905859885890987</c:v>
                </c:pt>
                <c:pt idx="165">
                  <c:v>0.82905923415331428</c:v>
                </c:pt>
                <c:pt idx="166">
                  <c:v>0.82760587073849878</c:v>
                </c:pt>
                <c:pt idx="167">
                  <c:v>0.82535578052732317</c:v>
                </c:pt>
                <c:pt idx="168">
                  <c:v>0.82746608323720272</c:v>
                </c:pt>
                <c:pt idx="169">
                  <c:v>0.82654832314175719</c:v>
                </c:pt>
                <c:pt idx="170">
                  <c:v>0.82925494675736722</c:v>
                </c:pt>
                <c:pt idx="171">
                  <c:v>0.828718849252149</c:v>
                </c:pt>
                <c:pt idx="172">
                  <c:v>0.82928835585655258</c:v>
                </c:pt>
                <c:pt idx="173">
                  <c:v>0.8311872364790821</c:v>
                </c:pt>
                <c:pt idx="174">
                  <c:v>0.83174489189848289</c:v>
                </c:pt>
                <c:pt idx="175">
                  <c:v>0.83383753327157628</c:v>
                </c:pt>
                <c:pt idx="176">
                  <c:v>0.83509702476150882</c:v>
                </c:pt>
                <c:pt idx="177">
                  <c:v>0.831110217174588</c:v>
                </c:pt>
                <c:pt idx="178">
                  <c:v>0.8275085964401192</c:v>
                </c:pt>
                <c:pt idx="179">
                  <c:v>0.82919900234290411</c:v>
                </c:pt>
                <c:pt idx="180">
                  <c:v>0.83219859340909574</c:v>
                </c:pt>
                <c:pt idx="181">
                  <c:v>0.83577647200368732</c:v>
                </c:pt>
                <c:pt idx="182">
                  <c:v>0.83633157127995084</c:v>
                </c:pt>
                <c:pt idx="183">
                  <c:v>0.83804053299138981</c:v>
                </c:pt>
                <c:pt idx="184">
                  <c:v>0.83641046111832307</c:v>
                </c:pt>
                <c:pt idx="185">
                  <c:v>0.83706867543087082</c:v>
                </c:pt>
                <c:pt idx="186">
                  <c:v>0.83616731637875974</c:v>
                </c:pt>
                <c:pt idx="187">
                  <c:v>0.83567863313919744</c:v>
                </c:pt>
                <c:pt idx="188">
                  <c:v>0.83413483159911184</c:v>
                </c:pt>
                <c:pt idx="189">
                  <c:v>0.83268441921727276</c:v>
                </c:pt>
                <c:pt idx="190">
                  <c:v>0.8341856032993068</c:v>
                </c:pt>
                <c:pt idx="191">
                  <c:v>0.83435011181436369</c:v>
                </c:pt>
                <c:pt idx="192">
                  <c:v>0.8317694630469743</c:v>
                </c:pt>
                <c:pt idx="193">
                  <c:v>0.83129542588772176</c:v>
                </c:pt>
                <c:pt idx="194">
                  <c:v>0.83461129491581465</c:v>
                </c:pt>
                <c:pt idx="195">
                  <c:v>0.8388207243884872</c:v>
                </c:pt>
                <c:pt idx="196">
                  <c:v>0.84200248514720988</c:v>
                </c:pt>
                <c:pt idx="197">
                  <c:v>0.8421613206175943</c:v>
                </c:pt>
                <c:pt idx="198">
                  <c:v>0.84241933854630902</c:v>
                </c:pt>
                <c:pt idx="199">
                  <c:v>0.84302132135966945</c:v>
                </c:pt>
                <c:pt idx="200">
                  <c:v>0.83752884704239394</c:v>
                </c:pt>
                <c:pt idx="201">
                  <c:v>0.83897863307354226</c:v>
                </c:pt>
                <c:pt idx="202">
                  <c:v>0.84317679365774656</c:v>
                </c:pt>
                <c:pt idx="203">
                  <c:v>0.84019135611165185</c:v>
                </c:pt>
                <c:pt idx="204">
                  <c:v>0.84070775167917611</c:v>
                </c:pt>
                <c:pt idx="205">
                  <c:v>0.84323400210128963</c:v>
                </c:pt>
                <c:pt idx="206">
                  <c:v>0.84430237412529507</c:v>
                </c:pt>
                <c:pt idx="207">
                  <c:v>0.84385433512593488</c:v>
                </c:pt>
                <c:pt idx="208">
                  <c:v>0.84210417566900631</c:v>
                </c:pt>
                <c:pt idx="209">
                  <c:v>0.84175614978892754</c:v>
                </c:pt>
                <c:pt idx="210">
                  <c:v>0.84333739501946126</c:v>
                </c:pt>
                <c:pt idx="211">
                  <c:v>0.84257716465594923</c:v>
                </c:pt>
                <c:pt idx="212">
                  <c:v>0.8390645817838619</c:v>
                </c:pt>
                <c:pt idx="213">
                  <c:v>0.83818559499182765</c:v>
                </c:pt>
                <c:pt idx="214">
                  <c:v>0.83700126250249895</c:v>
                </c:pt>
                <c:pt idx="215">
                  <c:v>0.83545622380765072</c:v>
                </c:pt>
                <c:pt idx="216">
                  <c:v>0.83302142455631967</c:v>
                </c:pt>
                <c:pt idx="217">
                  <c:v>0.8283311074529156</c:v>
                </c:pt>
                <c:pt idx="218">
                  <c:v>0.8346328968782557</c:v>
                </c:pt>
                <c:pt idx="219">
                  <c:v>0.83523219911944524</c:v>
                </c:pt>
                <c:pt idx="220">
                  <c:v>0.83418069082595858</c:v>
                </c:pt>
                <c:pt idx="221">
                  <c:v>0.83770198987898725</c:v>
                </c:pt>
                <c:pt idx="222">
                  <c:v>0.837119475219953</c:v>
                </c:pt>
                <c:pt idx="223">
                  <c:v>0.83589651697829481</c:v>
                </c:pt>
                <c:pt idx="224">
                  <c:v>0.83571798467019109</c:v>
                </c:pt>
                <c:pt idx="225">
                  <c:v>0.8400386947038293</c:v>
                </c:pt>
                <c:pt idx="226">
                  <c:v>0.84105313124556069</c:v>
                </c:pt>
                <c:pt idx="227">
                  <c:v>0.84089274169584338</c:v>
                </c:pt>
                <c:pt idx="228">
                  <c:v>0.84058563006744169</c:v>
                </c:pt>
                <c:pt idx="229">
                  <c:v>0.84037260845191397</c:v>
                </c:pt>
                <c:pt idx="230">
                  <c:v>0.84142027134103259</c:v>
                </c:pt>
                <c:pt idx="231">
                  <c:v>0.84109566395630664</c:v>
                </c:pt>
                <c:pt idx="232">
                  <c:v>0.84410821968792193</c:v>
                </c:pt>
                <c:pt idx="233">
                  <c:v>0.84465222997694545</c:v>
                </c:pt>
                <c:pt idx="234">
                  <c:v>0.84554069680783284</c:v>
                </c:pt>
                <c:pt idx="235">
                  <c:v>0.84991473853700639</c:v>
                </c:pt>
                <c:pt idx="236">
                  <c:v>0.84918587247217225</c:v>
                </c:pt>
                <c:pt idx="237">
                  <c:v>0.84866931008983137</c:v>
                </c:pt>
                <c:pt idx="238">
                  <c:v>0.85035839423024895</c:v>
                </c:pt>
                <c:pt idx="239">
                  <c:v>0.85176361762448616</c:v>
                </c:pt>
                <c:pt idx="240">
                  <c:v>0.85379804947168303</c:v>
                </c:pt>
                <c:pt idx="241">
                  <c:v>0.85452479830038242</c:v>
                </c:pt>
                <c:pt idx="242">
                  <c:v>0.85692021546675845</c:v>
                </c:pt>
                <c:pt idx="243">
                  <c:v>0.85468196833024246</c:v>
                </c:pt>
                <c:pt idx="244">
                  <c:v>0.85470304623739579</c:v>
                </c:pt>
                <c:pt idx="245">
                  <c:v>0.85923909260918585</c:v>
                </c:pt>
                <c:pt idx="246">
                  <c:v>0.86117987805963092</c:v>
                </c:pt>
                <c:pt idx="247">
                  <c:v>0.86156227518250239</c:v>
                </c:pt>
                <c:pt idx="248">
                  <c:v>0.86121964292710773</c:v>
                </c:pt>
                <c:pt idx="249">
                  <c:v>0.86485566278557757</c:v>
                </c:pt>
                <c:pt idx="250">
                  <c:v>0.86835103596697161</c:v>
                </c:pt>
                <c:pt idx="251">
                  <c:v>0.87315485019433292</c:v>
                </c:pt>
                <c:pt idx="252">
                  <c:v>0.87867165258737534</c:v>
                </c:pt>
                <c:pt idx="253">
                  <c:v>0.88196300344662371</c:v>
                </c:pt>
                <c:pt idx="254">
                  <c:v>0.88253900667257945</c:v>
                </c:pt>
                <c:pt idx="255">
                  <c:v>0.88529919013659653</c:v>
                </c:pt>
                <c:pt idx="256">
                  <c:v>0.88945015104782521</c:v>
                </c:pt>
                <c:pt idx="257">
                  <c:v>0.88933700000684324</c:v>
                </c:pt>
                <c:pt idx="258">
                  <c:v>0.88982156826300218</c:v>
                </c:pt>
                <c:pt idx="259">
                  <c:v>0.88998685163558777</c:v>
                </c:pt>
                <c:pt idx="260">
                  <c:v>0.89023473194021308</c:v>
                </c:pt>
                <c:pt idx="261">
                  <c:v>0.89202918448041302</c:v>
                </c:pt>
                <c:pt idx="262">
                  <c:v>0.89425996903393334</c:v>
                </c:pt>
                <c:pt idx="263">
                  <c:v>0.89435233497322564</c:v>
                </c:pt>
                <c:pt idx="264">
                  <c:v>0.89754369713541393</c:v>
                </c:pt>
                <c:pt idx="265">
                  <c:v>0.90159737660996575</c:v>
                </c:pt>
                <c:pt idx="266">
                  <c:v>0.90507040633224911</c:v>
                </c:pt>
                <c:pt idx="267">
                  <c:v>0.90629856796260932</c:v>
                </c:pt>
                <c:pt idx="268">
                  <c:v>0.905270036792715</c:v>
                </c:pt>
                <c:pt idx="269">
                  <c:v>0.90640418947336443</c:v>
                </c:pt>
                <c:pt idx="270">
                  <c:v>0.90381841734160906</c:v>
                </c:pt>
                <c:pt idx="271">
                  <c:v>0.90575123373467703</c:v>
                </c:pt>
                <c:pt idx="272">
                  <c:v>0.91208588649709099</c:v>
                </c:pt>
                <c:pt idx="273">
                  <c:v>0.91410372642142712</c:v>
                </c:pt>
                <c:pt idx="274">
                  <c:v>0.91696322397609775</c:v>
                </c:pt>
                <c:pt idx="275">
                  <c:v>0.92239920812930087</c:v>
                </c:pt>
                <c:pt idx="276">
                  <c:v>0.92538835187481028</c:v>
                </c:pt>
                <c:pt idx="277">
                  <c:v>0.93240912404688325</c:v>
                </c:pt>
                <c:pt idx="278">
                  <c:v>0.93764143671257827</c:v>
                </c:pt>
                <c:pt idx="279">
                  <c:v>0.94152907658672069</c:v>
                </c:pt>
                <c:pt idx="280">
                  <c:v>0.94832107549067124</c:v>
                </c:pt>
                <c:pt idx="281">
                  <c:v>0.95329983671630614</c:v>
                </c:pt>
                <c:pt idx="282">
                  <c:v>0.95681390880429773</c:v>
                </c:pt>
                <c:pt idx="283">
                  <c:v>0.96489821806228115</c:v>
                </c:pt>
                <c:pt idx="284">
                  <c:v>0.96580448027998267</c:v>
                </c:pt>
                <c:pt idx="285">
                  <c:v>0.97158191373186242</c:v>
                </c:pt>
                <c:pt idx="286">
                  <c:v>0.97183300907672909</c:v>
                </c:pt>
                <c:pt idx="287">
                  <c:v>0.97412468577731126</c:v>
                </c:pt>
                <c:pt idx="288">
                  <c:v>0.98294958024079859</c:v>
                </c:pt>
                <c:pt idx="289">
                  <c:v>0.98494978837090608</c:v>
                </c:pt>
                <c:pt idx="290">
                  <c:v>0.98770229108932561</c:v>
                </c:pt>
                <c:pt idx="291">
                  <c:v>0.99157425979608327</c:v>
                </c:pt>
                <c:pt idx="292">
                  <c:v>0.99420352067067741</c:v>
                </c:pt>
                <c:pt idx="293">
                  <c:v>0.99352320280659989</c:v>
                </c:pt>
                <c:pt idx="294">
                  <c:v>0.9965477929063038</c:v>
                </c:pt>
                <c:pt idx="295">
                  <c:v>0.99205813175073976</c:v>
                </c:pt>
                <c:pt idx="296">
                  <c:v>0.99237942794197664</c:v>
                </c:pt>
                <c:pt idx="297">
                  <c:v>0.995364433410447</c:v>
                </c:pt>
                <c:pt idx="298">
                  <c:v>0.99520335874502708</c:v>
                </c:pt>
                <c:pt idx="299">
                  <c:v>0.9940320673874804</c:v>
                </c:pt>
                <c:pt idx="300">
                  <c:v>0.996748530914362</c:v>
                </c:pt>
                <c:pt idx="301">
                  <c:v>0.9926345356133689</c:v>
                </c:pt>
                <c:pt idx="302">
                  <c:v>0.99532344747473234</c:v>
                </c:pt>
                <c:pt idx="303">
                  <c:v>0.99484416664899222</c:v>
                </c:pt>
                <c:pt idx="304">
                  <c:v>0.99927342681307307</c:v>
                </c:pt>
                <c:pt idx="305">
                  <c:v>0.99685400741802965</c:v>
                </c:pt>
                <c:pt idx="306">
                  <c:v>0.99363696160000381</c:v>
                </c:pt>
                <c:pt idx="307">
                  <c:v>0.9936149163184379</c:v>
                </c:pt>
                <c:pt idx="308">
                  <c:v>0.99067338034894314</c:v>
                </c:pt>
                <c:pt idx="309">
                  <c:v>0.98860935566819286</c:v>
                </c:pt>
                <c:pt idx="310">
                  <c:v>0.98506097348368371</c:v>
                </c:pt>
                <c:pt idx="311">
                  <c:v>0.98584366633421205</c:v>
                </c:pt>
                <c:pt idx="312">
                  <c:v>0.9847542175545464</c:v>
                </c:pt>
                <c:pt idx="313">
                  <c:v>0.98827910697837473</c:v>
                </c:pt>
                <c:pt idx="314">
                  <c:v>0.9881159881318905</c:v>
                </c:pt>
                <c:pt idx="315">
                  <c:v>0.98574282180648887</c:v>
                </c:pt>
                <c:pt idx="316">
                  <c:v>0.98600251152582763</c:v>
                </c:pt>
                <c:pt idx="317">
                  <c:v>0.98489316513214342</c:v>
                </c:pt>
                <c:pt idx="318">
                  <c:v>0.98348066773188647</c:v>
                </c:pt>
                <c:pt idx="319">
                  <c:v>0.98761560050480313</c:v>
                </c:pt>
                <c:pt idx="320">
                  <c:v>0.98687010384764262</c:v>
                </c:pt>
                <c:pt idx="321">
                  <c:v>0.98560671923137955</c:v>
                </c:pt>
                <c:pt idx="322">
                  <c:v>0.98309978944016452</c:v>
                </c:pt>
                <c:pt idx="323">
                  <c:v>0.98316233890407467</c:v>
                </c:pt>
                <c:pt idx="324">
                  <c:v>0.98570347146082027</c:v>
                </c:pt>
                <c:pt idx="325">
                  <c:v>0.98749830250353654</c:v>
                </c:pt>
                <c:pt idx="326">
                  <c:v>0.98638446936205737</c:v>
                </c:pt>
                <c:pt idx="327">
                  <c:v>0.99384728321991034</c:v>
                </c:pt>
                <c:pt idx="328">
                  <c:v>0.99604061064103888</c:v>
                </c:pt>
                <c:pt idx="329">
                  <c:v>0.99613396335595461</c:v>
                </c:pt>
                <c:pt idx="330">
                  <c:v>0.99490846745168249</c:v>
                </c:pt>
                <c:pt idx="331">
                  <c:v>0.99341361027657293</c:v>
                </c:pt>
                <c:pt idx="332">
                  <c:v>0.99257051435612276</c:v>
                </c:pt>
                <c:pt idx="333">
                  <c:v>0.99411250537008222</c:v>
                </c:pt>
                <c:pt idx="334">
                  <c:v>0.99004108711498207</c:v>
                </c:pt>
                <c:pt idx="335">
                  <c:v>0.9880292104205094</c:v>
                </c:pt>
                <c:pt idx="336">
                  <c:v>0.99046742653580011</c:v>
                </c:pt>
                <c:pt idx="337">
                  <c:v>0.98342253931272006</c:v>
                </c:pt>
                <c:pt idx="338">
                  <c:v>0.98310397381643355</c:v>
                </c:pt>
                <c:pt idx="339">
                  <c:v>0.98241898712827713</c:v>
                </c:pt>
                <c:pt idx="340">
                  <c:v>0.98018078792481744</c:v>
                </c:pt>
                <c:pt idx="341">
                  <c:v>0.97792082009112824</c:v>
                </c:pt>
                <c:pt idx="342">
                  <c:v>0.97189029862239606</c:v>
                </c:pt>
                <c:pt idx="343">
                  <c:v>0.97228219048082509</c:v>
                </c:pt>
                <c:pt idx="344">
                  <c:v>0.97395838150006397</c:v>
                </c:pt>
                <c:pt idx="345">
                  <c:v>0.96220015142666981</c:v>
                </c:pt>
                <c:pt idx="346">
                  <c:v>0.95685517860240232</c:v>
                </c:pt>
                <c:pt idx="347">
                  <c:v>0.95307262897591782</c:v>
                </c:pt>
                <c:pt idx="348">
                  <c:v>0.95149321305794976</c:v>
                </c:pt>
                <c:pt idx="349">
                  <c:v>0.94829899495083525</c:v>
                </c:pt>
                <c:pt idx="350">
                  <c:v>0.94390148260202877</c:v>
                </c:pt>
                <c:pt idx="351">
                  <c:v>0.93977201547804023</c:v>
                </c:pt>
                <c:pt idx="352">
                  <c:v>0.94062311467614812</c:v>
                </c:pt>
                <c:pt idx="353">
                  <c:v>0.93943895623703155</c:v>
                </c:pt>
                <c:pt idx="354">
                  <c:v>0.93265954713300103</c:v>
                </c:pt>
                <c:pt idx="355">
                  <c:v>0.92624161021508755</c:v>
                </c:pt>
                <c:pt idx="356">
                  <c:v>0.92216658518800843</c:v>
                </c:pt>
                <c:pt idx="357">
                  <c:v>0.91365290789031761</c:v>
                </c:pt>
                <c:pt idx="358">
                  <c:v>0.91047976518754814</c:v>
                </c:pt>
                <c:pt idx="359">
                  <c:v>0.90848269153263017</c:v>
                </c:pt>
                <c:pt idx="360">
                  <c:v>0.90791445850420738</c:v>
                </c:pt>
                <c:pt idx="361">
                  <c:v>0.89569801074310029</c:v>
                </c:pt>
                <c:pt idx="362">
                  <c:v>0.88591350519701151</c:v>
                </c:pt>
                <c:pt idx="363">
                  <c:v>0.88051363977982999</c:v>
                </c:pt>
                <c:pt idx="364">
                  <c:v>0.87453867204300673</c:v>
                </c:pt>
                <c:pt idx="365">
                  <c:v>0.86994428967499982</c:v>
                </c:pt>
                <c:pt idx="366">
                  <c:v>0.86238328543930953</c:v>
                </c:pt>
                <c:pt idx="367">
                  <c:v>0.85990595967322259</c:v>
                </c:pt>
                <c:pt idx="368">
                  <c:v>0.85338455788174206</c:v>
                </c:pt>
                <c:pt idx="369">
                  <c:v>0.84815417589041919</c:v>
                </c:pt>
                <c:pt idx="370">
                  <c:v>0.83939276397937457</c:v>
                </c:pt>
                <c:pt idx="371">
                  <c:v>0.83544239873959469</c:v>
                </c:pt>
                <c:pt idx="372">
                  <c:v>0.82546319087343778</c:v>
                </c:pt>
                <c:pt idx="373">
                  <c:v>0.82591878545860808</c:v>
                </c:pt>
                <c:pt idx="374">
                  <c:v>0.81931532061225232</c:v>
                </c:pt>
                <c:pt idx="375">
                  <c:v>0.81653869100885135</c:v>
                </c:pt>
                <c:pt idx="376">
                  <c:v>0.8134727436805741</c:v>
                </c:pt>
                <c:pt idx="377">
                  <c:v>0.81006928698004588</c:v>
                </c:pt>
                <c:pt idx="378">
                  <c:v>0.80013859479724025</c:v>
                </c:pt>
                <c:pt idx="379">
                  <c:v>0.79898309446151183</c:v>
                </c:pt>
                <c:pt idx="380">
                  <c:v>0.79614894783749512</c:v>
                </c:pt>
                <c:pt idx="381">
                  <c:v>0.79339843417408362</c:v>
                </c:pt>
                <c:pt idx="382">
                  <c:v>0.7895792256379599</c:v>
                </c:pt>
                <c:pt idx="383">
                  <c:v>0.7832917825736051</c:v>
                </c:pt>
                <c:pt idx="384">
                  <c:v>0.78209556460487817</c:v>
                </c:pt>
                <c:pt idx="385">
                  <c:v>0.77586709904142837</c:v>
                </c:pt>
                <c:pt idx="386">
                  <c:v>0.77507591362423678</c:v>
                </c:pt>
                <c:pt idx="387">
                  <c:v>0.76974325649619546</c:v>
                </c:pt>
                <c:pt idx="388">
                  <c:v>0.76703463654329784</c:v>
                </c:pt>
                <c:pt idx="389">
                  <c:v>0.76123936199434061</c:v>
                </c:pt>
                <c:pt idx="390">
                  <c:v>0.76175132072523788</c:v>
                </c:pt>
                <c:pt idx="391">
                  <c:v>0.75563712822425488</c:v>
                </c:pt>
                <c:pt idx="392">
                  <c:v>0.74935480108029129</c:v>
                </c:pt>
                <c:pt idx="393">
                  <c:v>0.74596576181145846</c:v>
                </c:pt>
                <c:pt idx="394">
                  <c:v>0.73877349095150346</c:v>
                </c:pt>
                <c:pt idx="395">
                  <c:v>0.73124804468995608</c:v>
                </c:pt>
                <c:pt idx="396">
                  <c:v>0.72652238896594079</c:v>
                </c:pt>
                <c:pt idx="397">
                  <c:v>0.71973131155905667</c:v>
                </c:pt>
                <c:pt idx="398">
                  <c:v>0.71543394786358439</c:v>
                </c:pt>
                <c:pt idx="399">
                  <c:v>0.71049679751257688</c:v>
                </c:pt>
                <c:pt idx="400">
                  <c:v>0.70534894001566251</c:v>
                </c:pt>
                <c:pt idx="401">
                  <c:v>0.70504581789106191</c:v>
                </c:pt>
                <c:pt idx="402">
                  <c:v>0.69651286277982227</c:v>
                </c:pt>
                <c:pt idx="403">
                  <c:v>0.69326206704481697</c:v>
                </c:pt>
                <c:pt idx="404">
                  <c:v>0.68604572302474343</c:v>
                </c:pt>
                <c:pt idx="405">
                  <c:v>0.68184257755810751</c:v>
                </c:pt>
                <c:pt idx="406">
                  <c:v>0.67625358178860351</c:v>
                </c:pt>
                <c:pt idx="407">
                  <c:v>0.67062872565535381</c:v>
                </c:pt>
                <c:pt idx="408">
                  <c:v>0.66180100315983437</c:v>
                </c:pt>
                <c:pt idx="409">
                  <c:v>0.66103775647830809</c:v>
                </c:pt>
                <c:pt idx="410">
                  <c:v>0.66304766644576185</c:v>
                </c:pt>
                <c:pt idx="411">
                  <c:v>0.65800916460264836</c:v>
                </c:pt>
                <c:pt idx="412">
                  <c:v>0.65517209274681021</c:v>
                </c:pt>
                <c:pt idx="413">
                  <c:v>0.65563077293755123</c:v>
                </c:pt>
                <c:pt idx="414">
                  <c:v>0.65672057443766652</c:v>
                </c:pt>
                <c:pt idx="415">
                  <c:v>0.65366675330095725</c:v>
                </c:pt>
                <c:pt idx="416">
                  <c:v>0.65158940786597985</c:v>
                </c:pt>
                <c:pt idx="417">
                  <c:v>0.6502917213559809</c:v>
                </c:pt>
                <c:pt idx="418">
                  <c:v>0.65058471423380404</c:v>
                </c:pt>
                <c:pt idx="419">
                  <c:v>0.64924090499873288</c:v>
                </c:pt>
                <c:pt idx="420">
                  <c:v>0.65449437763348151</c:v>
                </c:pt>
                <c:pt idx="421">
                  <c:v>0.65423068458893718</c:v>
                </c:pt>
                <c:pt idx="422">
                  <c:v>0.65344758100342293</c:v>
                </c:pt>
                <c:pt idx="423">
                  <c:v>0.65221488229855284</c:v>
                </c:pt>
                <c:pt idx="424">
                  <c:v>0.65107070305948067</c:v>
                </c:pt>
                <c:pt idx="425">
                  <c:v>0.65275133566780774</c:v>
                </c:pt>
                <c:pt idx="426">
                  <c:v>0.65518174563807985</c:v>
                </c:pt>
                <c:pt idx="427">
                  <c:v>0.65318391902582562</c:v>
                </c:pt>
                <c:pt idx="428">
                  <c:v>0.65190458605429868</c:v>
                </c:pt>
                <c:pt idx="429">
                  <c:v>0.65509920987975567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49318952"/>
        <c:axId val="249319344"/>
      </c:scatterChart>
      <c:valAx>
        <c:axId val="249318952"/>
        <c:scaling>
          <c:orientation val="minMax"/>
          <c:max val="80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200" b="1" i="0" u="none" strike="noStrike" baseline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</a:defRPr>
            </a:pPr>
            <a:endParaRPr lang="en-US"/>
          </a:p>
        </c:txPr>
        <c:crossAx val="249319344"/>
        <c:crosses val="autoZero"/>
        <c:crossBetween val="midCat"/>
      </c:valAx>
      <c:valAx>
        <c:axId val="249319344"/>
        <c:scaling>
          <c:orientation val="minMax"/>
          <c:max val="1.1000000000000001"/>
          <c:min val="0.6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200" b="1" i="0" u="none" strike="noStrike" baseline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</a:defRPr>
            </a:pPr>
            <a:endParaRPr lang="en-US"/>
          </a:p>
        </c:txPr>
        <c:crossAx val="249318952"/>
        <c:crosses val="autoZero"/>
        <c:crossBetween val="midCat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>
      <a:noFill/>
    </a:ln>
  </c:spPr>
  <c:txPr>
    <a:bodyPr/>
    <a:lstStyle/>
    <a:p>
      <a:pPr>
        <a:defRPr sz="1200" b="1" i="0" u="none" strike="noStrike" baseline="0">
          <a:solidFill>
            <a:srgbClr val="000000"/>
          </a:solidFill>
          <a:latin typeface="Times New Roman"/>
          <a:ea typeface="Times New Roman"/>
          <a:cs typeface="Times New Roman"/>
        </a:defRPr>
      </a:pPr>
      <a:endParaRPr lang="en-US"/>
    </a:p>
  </c:txPr>
  <c:externalData r:id="rId1">
    <c:autoUpdate val="0"/>
  </c:externalData>
  <c:userShapes r:id="rId2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8.8438228438228433E-2"/>
          <c:y val="4.3951985226223456E-2"/>
          <c:w val="0.89446775446775451"/>
          <c:h val="0.6482102582392846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00FF"/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J$18</c:f>
                <c:numCache>
                  <c:formatCode>General</c:formatCode>
                  <c:ptCount val="1"/>
                  <c:pt idx="0">
                    <c:v>1.857451550546146</c:v>
                  </c:pt>
                </c:numCache>
              </c:numRef>
            </c:plus>
            <c:minus>
              <c:numRef>
                <c:f>Sheet1!$J$18</c:f>
                <c:numCache>
                  <c:formatCode>General</c:formatCode>
                  <c:ptCount val="1"/>
                  <c:pt idx="0">
                    <c:v>1.857451550546146</c:v>
                  </c:pt>
                </c:numCache>
              </c:numRef>
            </c:minus>
          </c:errBars>
          <c:val>
            <c:numRef>
              <c:f>Sheet1!$CD$1:$CY$1</c:f>
              <c:numCache>
                <c:formatCode>General</c:formatCode>
                <c:ptCount val="22"/>
                <c:pt idx="0">
                  <c:v>27.283333333333331</c:v>
                </c:pt>
              </c:numCache>
            </c:numRef>
          </c:val>
        </c:ser>
        <c:ser>
          <c:idx val="1"/>
          <c:order val="1"/>
          <c:spPr>
            <a:solidFill>
              <a:srgbClr val="0000FF"/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AU$10</c:f>
                <c:numCache>
                  <c:formatCode>General</c:formatCode>
                  <c:ptCount val="1"/>
                  <c:pt idx="0">
                    <c:v>1.6552945357246827</c:v>
                  </c:pt>
                </c:numCache>
              </c:numRef>
            </c:plus>
            <c:minus>
              <c:numRef>
                <c:f>Sheet1!$AU$10</c:f>
                <c:numCache>
                  <c:formatCode>General</c:formatCode>
                  <c:ptCount val="1"/>
                  <c:pt idx="0">
                    <c:v>1.6552945357246827</c:v>
                  </c:pt>
                </c:numCache>
              </c:numRef>
            </c:minus>
          </c:errBars>
          <c:val>
            <c:numRef>
              <c:f>Sheet1!$CD$2:$CY$2</c:f>
              <c:numCache>
                <c:formatCode>General</c:formatCode>
                <c:ptCount val="22"/>
                <c:pt idx="1">
                  <c:v>17.200000000000003</c:v>
                </c:pt>
              </c:numCache>
            </c:numRef>
          </c:val>
        </c:ser>
        <c:ser>
          <c:idx val="2"/>
          <c:order val="2"/>
          <c:spPr>
            <a:solidFill>
              <a:srgbClr val="0000FF"/>
            </a:solidFill>
            <a:ln>
              <a:solidFill>
                <a:srgbClr val="000000"/>
              </a:solidFill>
            </a:ln>
          </c:spPr>
          <c:invertIfNegative val="0"/>
          <c:trendline>
            <c:trendlineType val="linear"/>
            <c:dispRSqr val="0"/>
            <c:dispEq val="0"/>
          </c:trendline>
          <c:errBars>
            <c:errBarType val="both"/>
            <c:errValType val="cust"/>
            <c:noEndCap val="0"/>
            <c:plus>
              <c:numRef>
                <c:f>Sheet1!$O$18</c:f>
                <c:numCache>
                  <c:formatCode>General</c:formatCode>
                  <c:ptCount val="1"/>
                  <c:pt idx="0">
                    <c:v>1.0199400853862832</c:v>
                  </c:pt>
                </c:numCache>
              </c:numRef>
            </c:plus>
            <c:minus>
              <c:numRef>
                <c:f>Sheet1!$O$18</c:f>
                <c:numCache>
                  <c:formatCode>General</c:formatCode>
                  <c:ptCount val="1"/>
                  <c:pt idx="0">
                    <c:v>1.0199400853862832</c:v>
                  </c:pt>
                </c:numCache>
              </c:numRef>
            </c:minus>
          </c:errBars>
          <c:val>
            <c:numRef>
              <c:f>Sheet1!$CD$3:$CY$3</c:f>
              <c:numCache>
                <c:formatCode>General</c:formatCode>
                <c:ptCount val="22"/>
                <c:pt idx="2">
                  <c:v>24.416666666666668</c:v>
                </c:pt>
              </c:numCache>
            </c:numRef>
          </c:val>
        </c:ser>
        <c:ser>
          <c:idx val="3"/>
          <c:order val="3"/>
          <c:spPr>
            <a:solidFill>
              <a:srgbClr val="0000FF"/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BG$15</c:f>
                <c:numCache>
                  <c:formatCode>General</c:formatCode>
                  <c:ptCount val="1"/>
                  <c:pt idx="0">
                    <c:v>0.33166247903554108</c:v>
                  </c:pt>
                </c:numCache>
              </c:numRef>
            </c:plus>
            <c:minus>
              <c:numRef>
                <c:f>Sheet1!$BG$15</c:f>
                <c:numCache>
                  <c:formatCode>General</c:formatCode>
                  <c:ptCount val="1"/>
                  <c:pt idx="0">
                    <c:v>0.33166247903554108</c:v>
                  </c:pt>
                </c:numCache>
              </c:numRef>
            </c:minus>
          </c:errBars>
          <c:val>
            <c:numRef>
              <c:f>Sheet1!$CD$4:$CY$4</c:f>
              <c:numCache>
                <c:formatCode>General</c:formatCode>
                <c:ptCount val="22"/>
                <c:pt idx="3">
                  <c:v>5.1000000000000005</c:v>
                </c:pt>
              </c:numCache>
            </c:numRef>
          </c:val>
        </c:ser>
        <c:ser>
          <c:idx val="4"/>
          <c:order val="4"/>
          <c:spPr>
            <a:solidFill>
              <a:srgbClr val="0000FF"/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M$18</c:f>
                <c:numCache>
                  <c:formatCode>General</c:formatCode>
                  <c:ptCount val="1"/>
                  <c:pt idx="0">
                    <c:v>0.47871355387816839</c:v>
                  </c:pt>
                </c:numCache>
              </c:numRef>
            </c:plus>
            <c:minus>
              <c:numRef>
                <c:f>Sheet1!$M$18</c:f>
                <c:numCache>
                  <c:formatCode>General</c:formatCode>
                  <c:ptCount val="1"/>
                  <c:pt idx="0">
                    <c:v>0.47871355387816839</c:v>
                  </c:pt>
                </c:numCache>
              </c:numRef>
            </c:minus>
          </c:errBars>
          <c:val>
            <c:numRef>
              <c:f>Sheet1!$CD$5:$CY$5</c:f>
              <c:numCache>
                <c:formatCode>General</c:formatCode>
                <c:ptCount val="22"/>
                <c:pt idx="4">
                  <c:v>4.75</c:v>
                </c:pt>
              </c:numCache>
            </c:numRef>
          </c:val>
        </c:ser>
        <c:ser>
          <c:idx val="5"/>
          <c:order val="5"/>
          <c:spPr>
            <a:solidFill>
              <a:srgbClr val="0000FF"/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BQ$15</c:f>
                <c:numCache>
                  <c:formatCode>General</c:formatCode>
                  <c:ptCount val="1"/>
                  <c:pt idx="0">
                    <c:v>0.39999999999999991</c:v>
                  </c:pt>
                </c:numCache>
              </c:numRef>
            </c:plus>
            <c:minus>
              <c:numRef>
                <c:f>Sheet1!$BQ$15</c:f>
                <c:numCache>
                  <c:formatCode>General</c:formatCode>
                  <c:ptCount val="1"/>
                  <c:pt idx="0">
                    <c:v>0.39999999999999991</c:v>
                  </c:pt>
                </c:numCache>
              </c:numRef>
            </c:minus>
          </c:errBars>
          <c:val>
            <c:numRef>
              <c:f>Sheet1!$CD$6:$CY$6</c:f>
              <c:numCache>
                <c:formatCode>General</c:formatCode>
                <c:ptCount val="22"/>
                <c:pt idx="5">
                  <c:v>1.8999999999999997</c:v>
                </c:pt>
              </c:numCache>
            </c:numRef>
          </c:val>
        </c:ser>
        <c:ser>
          <c:idx val="6"/>
          <c:order val="6"/>
          <c:spPr>
            <a:solidFill>
              <a:srgbClr val="0000FF"/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AI$10</c:f>
                <c:numCache>
                  <c:formatCode>General</c:formatCode>
                  <c:ptCount val="1"/>
                  <c:pt idx="0">
                    <c:v>0.14529663145135577</c:v>
                  </c:pt>
                </c:numCache>
              </c:numRef>
            </c:plus>
            <c:minus>
              <c:numRef>
                <c:f>Sheet1!$AI$10</c:f>
                <c:numCache>
                  <c:formatCode>General</c:formatCode>
                  <c:ptCount val="1"/>
                  <c:pt idx="0">
                    <c:v>0.14529663145135577</c:v>
                  </c:pt>
                </c:numCache>
              </c:numRef>
            </c:minus>
          </c:errBars>
          <c:val>
            <c:numRef>
              <c:f>Sheet1!$CD$7:$CY$7</c:f>
              <c:numCache>
                <c:formatCode>General</c:formatCode>
                <c:ptCount val="22"/>
                <c:pt idx="6">
                  <c:v>1.2666666666666666</c:v>
                </c:pt>
              </c:numCache>
            </c:numRef>
          </c:val>
        </c:ser>
        <c:ser>
          <c:idx val="7"/>
          <c:order val="7"/>
          <c:invertIfNegative val="0"/>
          <c:val>
            <c:numRef>
              <c:f>Sheet1!$CD$8:$CY$8</c:f>
              <c:numCache>
                <c:formatCode>General</c:formatCode>
                <c:ptCount val="22"/>
              </c:numCache>
            </c:numRef>
          </c:val>
        </c:ser>
        <c:ser>
          <c:idx val="8"/>
          <c:order val="8"/>
          <c:spPr>
            <a:solidFill>
              <a:srgbClr val="FF99FF"/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A$18</c:f>
                <c:numCache>
                  <c:formatCode>General</c:formatCode>
                  <c:ptCount val="1"/>
                  <c:pt idx="0">
                    <c:v>0.89752746785574855</c:v>
                  </c:pt>
                </c:numCache>
              </c:numRef>
            </c:plus>
            <c:minus>
              <c:numRef>
                <c:f>Sheet1!$A$18</c:f>
                <c:numCache>
                  <c:formatCode>General</c:formatCode>
                  <c:ptCount val="1"/>
                  <c:pt idx="0">
                    <c:v>0.89752746785574855</c:v>
                  </c:pt>
                </c:numCache>
              </c:numRef>
            </c:minus>
          </c:errBars>
          <c:val>
            <c:numRef>
              <c:f>Sheet1!$CD$9:$CY$9</c:f>
              <c:numCache>
                <c:formatCode>General</c:formatCode>
                <c:ptCount val="22"/>
                <c:pt idx="8">
                  <c:v>21.666666666666668</c:v>
                </c:pt>
              </c:numCache>
            </c:numRef>
          </c:val>
        </c:ser>
        <c:ser>
          <c:idx val="9"/>
          <c:order val="9"/>
          <c:spPr>
            <a:solidFill>
              <a:srgbClr val="FF99FF"/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AR$10</c:f>
                <c:numCache>
                  <c:formatCode>General</c:formatCode>
                  <c:ptCount val="1"/>
                  <c:pt idx="0">
                    <c:v>2.4958298553119911</c:v>
                  </c:pt>
                </c:numCache>
              </c:numRef>
            </c:plus>
            <c:minus>
              <c:numRef>
                <c:f>Sheet1!$AR$10</c:f>
                <c:numCache>
                  <c:formatCode>General</c:formatCode>
                  <c:ptCount val="1"/>
                  <c:pt idx="0">
                    <c:v>2.4958298553119911</c:v>
                  </c:pt>
                </c:numCache>
              </c:numRef>
            </c:minus>
          </c:errBars>
          <c:val>
            <c:numRef>
              <c:f>Sheet1!$CD$10:$CY$10</c:f>
              <c:numCache>
                <c:formatCode>General</c:formatCode>
                <c:ptCount val="22"/>
                <c:pt idx="9">
                  <c:v>18.75</c:v>
                </c:pt>
              </c:numCache>
            </c:numRef>
          </c:val>
        </c:ser>
        <c:ser>
          <c:idx val="10"/>
          <c:order val="10"/>
          <c:spPr>
            <a:solidFill>
              <a:srgbClr val="FF99FF"/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CB$15</c:f>
                <c:numCache>
                  <c:formatCode>General</c:formatCode>
                  <c:ptCount val="1"/>
                  <c:pt idx="0">
                    <c:v>0.68007352543677102</c:v>
                  </c:pt>
                </c:numCache>
              </c:numRef>
            </c:plus>
            <c:minus>
              <c:numRef>
                <c:f>Sheet1!$CB$15</c:f>
                <c:numCache>
                  <c:formatCode>General</c:formatCode>
                  <c:ptCount val="1"/>
                  <c:pt idx="0">
                    <c:v>0.68007352543677102</c:v>
                  </c:pt>
                </c:numCache>
              </c:numRef>
            </c:minus>
          </c:errBars>
          <c:val>
            <c:numRef>
              <c:f>Sheet1!$CD$11:$CY$11</c:f>
              <c:numCache>
                <c:formatCode>General</c:formatCode>
                <c:ptCount val="22"/>
                <c:pt idx="10">
                  <c:v>9.8000000000000007</c:v>
                </c:pt>
              </c:numCache>
            </c:numRef>
          </c:val>
        </c:ser>
        <c:ser>
          <c:idx val="11"/>
          <c:order val="11"/>
          <c:spPr>
            <a:solidFill>
              <a:srgbClr val="FF99FF"/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BJ$15</c:f>
                <c:numCache>
                  <c:formatCode>General</c:formatCode>
                  <c:ptCount val="1"/>
                  <c:pt idx="0">
                    <c:v>1.1135528725660035</c:v>
                  </c:pt>
                </c:numCache>
              </c:numRef>
            </c:plus>
            <c:minus>
              <c:numRef>
                <c:f>Sheet1!$BJ$15</c:f>
                <c:numCache>
                  <c:formatCode>General</c:formatCode>
                  <c:ptCount val="1"/>
                  <c:pt idx="0">
                    <c:v>1.1135528725660035</c:v>
                  </c:pt>
                </c:numCache>
              </c:numRef>
            </c:minus>
          </c:errBars>
          <c:val>
            <c:numRef>
              <c:f>Sheet1!$CD$12:$CY$12</c:f>
              <c:numCache>
                <c:formatCode>General</c:formatCode>
                <c:ptCount val="22"/>
                <c:pt idx="11">
                  <c:v>15.2</c:v>
                </c:pt>
              </c:numCache>
            </c:numRef>
          </c:val>
        </c:ser>
        <c:ser>
          <c:idx val="12"/>
          <c:order val="12"/>
          <c:spPr>
            <a:solidFill>
              <a:srgbClr val="FF99FF"/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D$18</c:f>
                <c:numCache>
                  <c:formatCode>General</c:formatCode>
                  <c:ptCount val="1"/>
                  <c:pt idx="0">
                    <c:v>0.56275591056516949</c:v>
                  </c:pt>
                </c:numCache>
              </c:numRef>
            </c:plus>
            <c:minus>
              <c:numRef>
                <c:f>Sheet1!$D$18</c:f>
                <c:numCache>
                  <c:formatCode>General</c:formatCode>
                  <c:ptCount val="1"/>
                  <c:pt idx="0">
                    <c:v>0.56275591056516949</c:v>
                  </c:pt>
                </c:numCache>
              </c:numRef>
            </c:minus>
          </c:errBars>
          <c:val>
            <c:numRef>
              <c:f>Sheet1!$CD$13:$CY$13</c:f>
              <c:numCache>
                <c:formatCode>General</c:formatCode>
                <c:ptCount val="22"/>
                <c:pt idx="12">
                  <c:v>3.6181818181818182</c:v>
                </c:pt>
              </c:numCache>
            </c:numRef>
          </c:val>
        </c:ser>
        <c:ser>
          <c:idx val="13"/>
          <c:order val="13"/>
          <c:spPr>
            <a:solidFill>
              <a:srgbClr val="FF99FF"/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BT$15</c:f>
                <c:numCache>
                  <c:formatCode>General</c:formatCode>
                  <c:ptCount val="1"/>
                  <c:pt idx="0">
                    <c:v>0.54772255750516607</c:v>
                  </c:pt>
                </c:numCache>
              </c:numRef>
            </c:plus>
            <c:minus>
              <c:numRef>
                <c:f>Sheet1!$BT$15</c:f>
                <c:numCache>
                  <c:formatCode>General</c:formatCode>
                  <c:ptCount val="1"/>
                  <c:pt idx="0">
                    <c:v>0.54772255750516607</c:v>
                  </c:pt>
                </c:numCache>
              </c:numRef>
            </c:minus>
          </c:errBars>
          <c:val>
            <c:numRef>
              <c:f>Sheet1!$CD$14:$CY$14</c:f>
              <c:numCache>
                <c:formatCode>General</c:formatCode>
                <c:ptCount val="22"/>
                <c:pt idx="13">
                  <c:v>10.999999999999998</c:v>
                </c:pt>
              </c:numCache>
            </c:numRef>
          </c:val>
        </c:ser>
        <c:ser>
          <c:idx val="14"/>
          <c:order val="14"/>
          <c:spPr>
            <a:solidFill>
              <a:srgbClr val="FF99FF"/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AF$10</c:f>
                <c:numCache>
                  <c:formatCode>General</c:formatCode>
                  <c:ptCount val="1"/>
                  <c:pt idx="0">
                    <c:v>0.88191710368819698</c:v>
                  </c:pt>
                </c:numCache>
              </c:numRef>
            </c:plus>
            <c:minus>
              <c:numRef>
                <c:f>Sheet1!$AF$10</c:f>
                <c:numCache>
                  <c:formatCode>General</c:formatCode>
                  <c:ptCount val="1"/>
                  <c:pt idx="0">
                    <c:v>0.88191710368819698</c:v>
                  </c:pt>
                </c:numCache>
              </c:numRef>
            </c:minus>
          </c:errBars>
          <c:val>
            <c:numRef>
              <c:f>Sheet1!$CD$15:$CY$15</c:f>
              <c:numCache>
                <c:formatCode>General</c:formatCode>
                <c:ptCount val="22"/>
                <c:pt idx="14">
                  <c:v>2.3333333333333335</c:v>
                </c:pt>
              </c:numCache>
            </c:numRef>
          </c:val>
        </c:ser>
        <c:ser>
          <c:idx val="15"/>
          <c:order val="15"/>
          <c:spPr>
            <a:solidFill>
              <a:srgbClr val="92D050"/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G$18</c:f>
                <c:numCache>
                  <c:formatCode>General</c:formatCode>
                  <c:ptCount val="1"/>
                  <c:pt idx="0">
                    <c:v>1.6996731711975921</c:v>
                  </c:pt>
                </c:numCache>
              </c:numRef>
            </c:plus>
            <c:minus>
              <c:numRef>
                <c:f>Sheet1!$G$18</c:f>
                <c:numCache>
                  <c:formatCode>General</c:formatCode>
                  <c:ptCount val="1"/>
                  <c:pt idx="0">
                    <c:v>1.6996731711975921</c:v>
                  </c:pt>
                </c:numCache>
              </c:numRef>
            </c:minus>
          </c:errBars>
          <c:val>
            <c:numRef>
              <c:f>Sheet1!$CD$16:$CY$16</c:f>
              <c:numCache>
                <c:formatCode>General</c:formatCode>
                <c:ptCount val="22"/>
                <c:pt idx="16">
                  <c:v>24.333333333333332</c:v>
                </c:pt>
              </c:numCache>
            </c:numRef>
          </c:val>
        </c:ser>
        <c:ser>
          <c:idx val="16"/>
          <c:order val="16"/>
          <c:spPr>
            <a:solidFill>
              <a:srgbClr val="92D050"/>
            </a:solidFill>
            <a:ln>
              <a:solidFill>
                <a:prstClr val="black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AX$10</c:f>
                <c:numCache>
                  <c:formatCode>General</c:formatCode>
                  <c:ptCount val="1"/>
                  <c:pt idx="0">
                    <c:v>2.5625508125043424</c:v>
                  </c:pt>
                </c:numCache>
              </c:numRef>
            </c:plus>
            <c:minus>
              <c:numRef>
                <c:f>Sheet1!$AX$10</c:f>
                <c:numCache>
                  <c:formatCode>General</c:formatCode>
                  <c:ptCount val="1"/>
                  <c:pt idx="0">
                    <c:v>2.5625508125043424</c:v>
                  </c:pt>
                </c:numCache>
              </c:numRef>
            </c:minus>
          </c:errBars>
          <c:val>
            <c:numRef>
              <c:f>Sheet1!$CD$17:$CY$17</c:f>
              <c:numCache>
                <c:formatCode>General</c:formatCode>
                <c:ptCount val="22"/>
                <c:pt idx="17">
                  <c:v>24.6</c:v>
                </c:pt>
              </c:numCache>
            </c:numRef>
          </c:val>
        </c:ser>
        <c:ser>
          <c:idx val="17"/>
          <c:order val="17"/>
          <c:spPr>
            <a:solidFill>
              <a:srgbClr val="92D050"/>
            </a:solidFill>
            <a:ln>
              <a:solidFill>
                <a:prstClr val="black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BM$15</c:f>
                <c:numCache>
                  <c:formatCode>General</c:formatCode>
                  <c:ptCount val="1"/>
                  <c:pt idx="0">
                    <c:v>2.4852241922438876</c:v>
                  </c:pt>
                </c:numCache>
              </c:numRef>
            </c:plus>
            <c:minus>
              <c:numRef>
                <c:f>Sheet1!$BM$15</c:f>
                <c:numCache>
                  <c:formatCode>General</c:formatCode>
                  <c:ptCount val="1"/>
                  <c:pt idx="0">
                    <c:v>2.4852241922438876</c:v>
                  </c:pt>
                </c:numCache>
              </c:numRef>
            </c:minus>
          </c:errBars>
          <c:val>
            <c:numRef>
              <c:f>Sheet1!$CD$18:$CY$18</c:f>
              <c:numCache>
                <c:formatCode>General</c:formatCode>
                <c:ptCount val="22"/>
                <c:pt idx="18">
                  <c:v>21.625</c:v>
                </c:pt>
              </c:numCache>
            </c:numRef>
          </c:val>
        </c:ser>
        <c:ser>
          <c:idx val="18"/>
          <c:order val="18"/>
          <c:spPr>
            <a:solidFill>
              <a:srgbClr val="92D050"/>
            </a:solidFill>
            <a:ln>
              <a:solidFill>
                <a:prstClr val="black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BW$15</c:f>
                <c:numCache>
                  <c:formatCode>General</c:formatCode>
                  <c:ptCount val="1"/>
                  <c:pt idx="0">
                    <c:v>1.4691773694340542</c:v>
                  </c:pt>
                </c:numCache>
              </c:numRef>
            </c:plus>
            <c:minus>
              <c:numRef>
                <c:f>Sheet1!$BW$15</c:f>
                <c:numCache>
                  <c:formatCode>General</c:formatCode>
                  <c:ptCount val="1"/>
                  <c:pt idx="0">
                    <c:v>1.4691773694340542</c:v>
                  </c:pt>
                </c:numCache>
              </c:numRef>
            </c:minus>
          </c:errBars>
          <c:val>
            <c:numRef>
              <c:f>Sheet1!$CD$19:$CY$19</c:f>
              <c:numCache>
                <c:formatCode>General</c:formatCode>
                <c:ptCount val="22"/>
                <c:pt idx="19">
                  <c:v>25.124999999999996</c:v>
                </c:pt>
              </c:numCache>
            </c:numRef>
          </c:val>
        </c:ser>
        <c:ser>
          <c:idx val="19"/>
          <c:order val="19"/>
          <c:spPr>
            <a:solidFill>
              <a:srgbClr val="92D050"/>
            </a:solidFill>
            <a:ln>
              <a:solidFill>
                <a:prstClr val="black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AL$10</c:f>
                <c:numCache>
                  <c:formatCode>General</c:formatCode>
                  <c:ptCount val="1"/>
                  <c:pt idx="0">
                    <c:v>2.1655008518571295</c:v>
                  </c:pt>
                </c:numCache>
              </c:numRef>
            </c:plus>
            <c:minus>
              <c:numRef>
                <c:f>Sheet1!$AL$10</c:f>
                <c:numCache>
                  <c:formatCode>General</c:formatCode>
                  <c:ptCount val="1"/>
                  <c:pt idx="0">
                    <c:v>2.1655008518571295</c:v>
                  </c:pt>
                </c:numCache>
              </c:numRef>
            </c:minus>
          </c:errBars>
          <c:val>
            <c:numRef>
              <c:f>Sheet1!$CD$20:$CY$20</c:f>
              <c:numCache>
                <c:formatCode>General</c:formatCode>
                <c:ptCount val="22"/>
                <c:pt idx="20">
                  <c:v>23.25</c:v>
                </c:pt>
              </c:numCache>
            </c:numRef>
          </c:val>
        </c:ser>
        <c:ser>
          <c:idx val="20"/>
          <c:order val="20"/>
          <c:spPr>
            <a:solidFill>
              <a:srgbClr val="7030A0"/>
            </a:solidFill>
            <a:ln>
              <a:solidFill>
                <a:prstClr val="black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BA$10</c:f>
                <c:numCache>
                  <c:formatCode>General</c:formatCode>
                  <c:ptCount val="1"/>
                  <c:pt idx="0">
                    <c:v>1.0000000000000009</c:v>
                  </c:pt>
                </c:numCache>
              </c:numRef>
            </c:plus>
            <c:minus>
              <c:numRef>
                <c:f>Sheet1!$BA$10</c:f>
                <c:numCache>
                  <c:formatCode>General</c:formatCode>
                  <c:ptCount val="1"/>
                  <c:pt idx="0">
                    <c:v>1.0000000000000009</c:v>
                  </c:pt>
                </c:numCache>
              </c:numRef>
            </c:minus>
          </c:errBars>
          <c:val>
            <c:numRef>
              <c:f>Sheet1!$CD$21:$CY$21</c:f>
              <c:numCache>
                <c:formatCode>General</c:formatCode>
                <c:ptCount val="22"/>
                <c:pt idx="21">
                  <c:v>3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9"/>
        <c:overlap val="100"/>
        <c:axId val="249320128"/>
        <c:axId val="249320520"/>
      </c:barChart>
      <c:catAx>
        <c:axId val="2493201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12700">
            <a:solidFill>
              <a:srgbClr val="000000"/>
            </a:solidFill>
          </a:ln>
        </c:spPr>
        <c:txPr>
          <a:bodyPr/>
          <a:lstStyle/>
          <a:p>
            <a:pPr>
              <a:defRPr>
                <a:solidFill>
                  <a:schemeClr val="bg1"/>
                </a:solidFill>
              </a:defRPr>
            </a:pPr>
            <a:endParaRPr lang="en-US"/>
          </a:p>
        </c:txPr>
        <c:crossAx val="249320520"/>
        <c:crosses val="autoZero"/>
        <c:auto val="1"/>
        <c:lblAlgn val="ctr"/>
        <c:lblOffset val="100"/>
        <c:noMultiLvlLbl val="0"/>
      </c:catAx>
      <c:valAx>
        <c:axId val="24932052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 b="1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200" b="1">
                    <a:latin typeface="Symbol" pitchFamily="18" charset="2"/>
                    <a:cs typeface="Times New Roman" pitchFamily="18" charset="0"/>
                  </a:rPr>
                  <a:t>D</a:t>
                </a:r>
                <a:r>
                  <a:rPr lang="en-US" sz="1200" b="1">
                    <a:latin typeface="Times New Roman" pitchFamily="18" charset="0"/>
                    <a:cs typeface="Times New Roman" pitchFamily="18" charset="0"/>
                  </a:rPr>
                  <a:t>F/Fo*100%, Fluo-5N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 b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24932012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  <c:userShapes r:id="rId2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4117721568251818E-2"/>
          <c:y val="0.12978763855023653"/>
          <c:w val="0.88235382819347397"/>
          <c:h val="0.72978950856936275"/>
        </c:manualLayout>
      </c:layout>
      <c:scatterChart>
        <c:scatterStyle val="smoothMarker"/>
        <c:varyColors val="0"/>
        <c:ser>
          <c:idx val="0"/>
          <c:order val="0"/>
          <c:spPr>
            <a:ln w="25400">
              <a:solidFill>
                <a:schemeClr val="tx1"/>
              </a:solidFill>
              <a:prstDash val="solid"/>
            </a:ln>
          </c:spPr>
          <c:marker>
            <c:symbol val="none"/>
          </c:marker>
          <c:xVal>
            <c:numRef>
              <c:f>'2may07_abRy3_N_1a'!$C$1:$C$422</c:f>
              <c:numCache>
                <c:formatCode>General</c:formatCode>
                <c:ptCount val="422"/>
                <c:pt idx="0">
                  <c:v>0</c:v>
                </c:pt>
                <c:pt idx="1">
                  <c:v>1.63</c:v>
                </c:pt>
                <c:pt idx="2">
                  <c:v>3.26</c:v>
                </c:pt>
                <c:pt idx="3">
                  <c:v>4.8899999999999997</c:v>
                </c:pt>
                <c:pt idx="4">
                  <c:v>6.52</c:v>
                </c:pt>
                <c:pt idx="5">
                  <c:v>8.15</c:v>
                </c:pt>
                <c:pt idx="6">
                  <c:v>9.7799999999999994</c:v>
                </c:pt>
                <c:pt idx="7">
                  <c:v>11.41</c:v>
                </c:pt>
                <c:pt idx="8">
                  <c:v>13.04</c:v>
                </c:pt>
                <c:pt idx="9">
                  <c:v>14.67</c:v>
                </c:pt>
                <c:pt idx="10">
                  <c:v>16.3</c:v>
                </c:pt>
                <c:pt idx="11">
                  <c:v>17.93</c:v>
                </c:pt>
                <c:pt idx="12">
                  <c:v>19.559999999999999</c:v>
                </c:pt>
                <c:pt idx="13">
                  <c:v>21.19</c:v>
                </c:pt>
                <c:pt idx="14">
                  <c:v>22.82</c:v>
                </c:pt>
                <c:pt idx="15">
                  <c:v>24.45</c:v>
                </c:pt>
                <c:pt idx="16">
                  <c:v>26.08</c:v>
                </c:pt>
                <c:pt idx="17">
                  <c:v>27.71</c:v>
                </c:pt>
                <c:pt idx="18">
                  <c:v>29.34</c:v>
                </c:pt>
                <c:pt idx="19">
                  <c:v>30.97</c:v>
                </c:pt>
                <c:pt idx="20">
                  <c:v>32.6</c:v>
                </c:pt>
                <c:pt idx="21">
                  <c:v>34.229999999999997</c:v>
                </c:pt>
                <c:pt idx="22">
                  <c:v>35.86</c:v>
                </c:pt>
                <c:pt idx="23">
                  <c:v>37.49</c:v>
                </c:pt>
                <c:pt idx="24">
                  <c:v>39.119999999999997</c:v>
                </c:pt>
                <c:pt idx="25">
                  <c:v>40.75</c:v>
                </c:pt>
                <c:pt idx="26">
                  <c:v>42.38</c:v>
                </c:pt>
                <c:pt idx="27">
                  <c:v>44.01</c:v>
                </c:pt>
                <c:pt idx="28">
                  <c:v>45.64</c:v>
                </c:pt>
                <c:pt idx="29">
                  <c:v>47.27</c:v>
                </c:pt>
                <c:pt idx="30">
                  <c:v>48.9</c:v>
                </c:pt>
                <c:pt idx="31">
                  <c:v>50.53</c:v>
                </c:pt>
                <c:pt idx="32">
                  <c:v>52.16</c:v>
                </c:pt>
                <c:pt idx="33">
                  <c:v>53.79</c:v>
                </c:pt>
                <c:pt idx="34">
                  <c:v>55.42</c:v>
                </c:pt>
                <c:pt idx="35">
                  <c:v>57.05</c:v>
                </c:pt>
                <c:pt idx="36">
                  <c:v>58.68</c:v>
                </c:pt>
                <c:pt idx="37">
                  <c:v>60.31</c:v>
                </c:pt>
                <c:pt idx="38">
                  <c:v>61.94</c:v>
                </c:pt>
                <c:pt idx="39">
                  <c:v>63.57</c:v>
                </c:pt>
                <c:pt idx="40">
                  <c:v>65.2</c:v>
                </c:pt>
                <c:pt idx="41">
                  <c:v>66.83</c:v>
                </c:pt>
                <c:pt idx="42">
                  <c:v>68.459999999999994</c:v>
                </c:pt>
                <c:pt idx="43">
                  <c:v>70.09</c:v>
                </c:pt>
                <c:pt idx="44">
                  <c:v>71.72</c:v>
                </c:pt>
                <c:pt idx="45">
                  <c:v>73.349999999999994</c:v>
                </c:pt>
                <c:pt idx="46">
                  <c:v>74.98</c:v>
                </c:pt>
                <c:pt idx="47">
                  <c:v>76.61</c:v>
                </c:pt>
                <c:pt idx="48">
                  <c:v>78.239999999999995</c:v>
                </c:pt>
                <c:pt idx="49">
                  <c:v>79.87</c:v>
                </c:pt>
                <c:pt idx="50">
                  <c:v>81.5</c:v>
                </c:pt>
                <c:pt idx="51">
                  <c:v>83.13</c:v>
                </c:pt>
                <c:pt idx="52">
                  <c:v>84.76</c:v>
                </c:pt>
                <c:pt idx="53">
                  <c:v>86.39</c:v>
                </c:pt>
                <c:pt idx="54">
                  <c:v>88.02</c:v>
                </c:pt>
                <c:pt idx="55">
                  <c:v>89.65</c:v>
                </c:pt>
                <c:pt idx="56">
                  <c:v>91.28</c:v>
                </c:pt>
                <c:pt idx="57">
                  <c:v>92.91</c:v>
                </c:pt>
                <c:pt idx="58">
                  <c:v>94.54</c:v>
                </c:pt>
                <c:pt idx="59">
                  <c:v>96.17</c:v>
                </c:pt>
                <c:pt idx="60">
                  <c:v>97.8</c:v>
                </c:pt>
                <c:pt idx="61">
                  <c:v>99.43</c:v>
                </c:pt>
                <c:pt idx="62">
                  <c:v>101.06</c:v>
                </c:pt>
                <c:pt idx="63">
                  <c:v>102.69</c:v>
                </c:pt>
                <c:pt idx="64">
                  <c:v>104.32</c:v>
                </c:pt>
                <c:pt idx="65">
                  <c:v>105.95</c:v>
                </c:pt>
                <c:pt idx="66">
                  <c:v>107.58</c:v>
                </c:pt>
                <c:pt idx="67">
                  <c:v>109.21</c:v>
                </c:pt>
                <c:pt idx="68">
                  <c:v>110.84</c:v>
                </c:pt>
                <c:pt idx="69">
                  <c:v>112.47</c:v>
                </c:pt>
                <c:pt idx="70">
                  <c:v>114.1</c:v>
                </c:pt>
                <c:pt idx="71">
                  <c:v>115.73</c:v>
                </c:pt>
                <c:pt idx="72">
                  <c:v>117.36</c:v>
                </c:pt>
                <c:pt idx="73">
                  <c:v>118.99</c:v>
                </c:pt>
                <c:pt idx="74">
                  <c:v>120.62</c:v>
                </c:pt>
                <c:pt idx="75">
                  <c:v>122.25</c:v>
                </c:pt>
                <c:pt idx="76">
                  <c:v>123.88</c:v>
                </c:pt>
                <c:pt idx="77">
                  <c:v>125.51</c:v>
                </c:pt>
                <c:pt idx="78">
                  <c:v>127.14</c:v>
                </c:pt>
                <c:pt idx="79">
                  <c:v>128.77000000000001</c:v>
                </c:pt>
                <c:pt idx="80">
                  <c:v>130.4</c:v>
                </c:pt>
                <c:pt idx="81">
                  <c:v>132.03</c:v>
                </c:pt>
                <c:pt idx="82">
                  <c:v>133.66</c:v>
                </c:pt>
                <c:pt idx="83">
                  <c:v>135.29</c:v>
                </c:pt>
                <c:pt idx="84">
                  <c:v>136.91999999999999</c:v>
                </c:pt>
                <c:pt idx="85">
                  <c:v>138.55000000000001</c:v>
                </c:pt>
                <c:pt idx="86">
                  <c:v>140.18</c:v>
                </c:pt>
                <c:pt idx="87">
                  <c:v>141.81</c:v>
                </c:pt>
                <c:pt idx="88">
                  <c:v>143.44</c:v>
                </c:pt>
                <c:pt idx="89">
                  <c:v>145.07</c:v>
                </c:pt>
                <c:pt idx="90">
                  <c:v>146.69999999999999</c:v>
                </c:pt>
                <c:pt idx="91">
                  <c:v>148.33000000000001</c:v>
                </c:pt>
                <c:pt idx="92">
                  <c:v>149.96</c:v>
                </c:pt>
                <c:pt idx="93">
                  <c:v>151.59</c:v>
                </c:pt>
                <c:pt idx="94">
                  <c:v>153.22</c:v>
                </c:pt>
                <c:pt idx="95">
                  <c:v>154.85</c:v>
                </c:pt>
                <c:pt idx="96">
                  <c:v>156.47999999999999</c:v>
                </c:pt>
                <c:pt idx="97">
                  <c:v>158.11000000000001</c:v>
                </c:pt>
                <c:pt idx="98">
                  <c:v>159.74</c:v>
                </c:pt>
                <c:pt idx="99">
                  <c:v>161.37</c:v>
                </c:pt>
                <c:pt idx="100">
                  <c:v>163</c:v>
                </c:pt>
                <c:pt idx="101">
                  <c:v>164.63</c:v>
                </c:pt>
                <c:pt idx="102">
                  <c:v>166.26</c:v>
                </c:pt>
                <c:pt idx="103">
                  <c:v>167.89</c:v>
                </c:pt>
                <c:pt idx="104">
                  <c:v>169.52</c:v>
                </c:pt>
                <c:pt idx="105">
                  <c:v>171.15</c:v>
                </c:pt>
                <c:pt idx="106">
                  <c:v>172.78</c:v>
                </c:pt>
                <c:pt idx="107">
                  <c:v>174.41</c:v>
                </c:pt>
                <c:pt idx="108">
                  <c:v>176.04</c:v>
                </c:pt>
                <c:pt idx="109">
                  <c:v>177.67</c:v>
                </c:pt>
                <c:pt idx="110">
                  <c:v>179.3</c:v>
                </c:pt>
                <c:pt idx="111">
                  <c:v>180.93</c:v>
                </c:pt>
                <c:pt idx="112">
                  <c:v>182.56</c:v>
                </c:pt>
                <c:pt idx="113">
                  <c:v>184.19</c:v>
                </c:pt>
                <c:pt idx="114">
                  <c:v>185.82</c:v>
                </c:pt>
                <c:pt idx="115">
                  <c:v>187.45</c:v>
                </c:pt>
                <c:pt idx="116">
                  <c:v>189.08</c:v>
                </c:pt>
                <c:pt idx="117">
                  <c:v>190.71</c:v>
                </c:pt>
                <c:pt idx="118">
                  <c:v>192.34</c:v>
                </c:pt>
                <c:pt idx="119">
                  <c:v>193.97</c:v>
                </c:pt>
                <c:pt idx="120">
                  <c:v>195.6</c:v>
                </c:pt>
                <c:pt idx="121">
                  <c:v>197.23</c:v>
                </c:pt>
                <c:pt idx="122">
                  <c:v>198.86</c:v>
                </c:pt>
                <c:pt idx="123">
                  <c:v>200.49</c:v>
                </c:pt>
                <c:pt idx="124">
                  <c:v>202.12</c:v>
                </c:pt>
                <c:pt idx="125">
                  <c:v>203.75</c:v>
                </c:pt>
                <c:pt idx="126">
                  <c:v>205.38</c:v>
                </c:pt>
                <c:pt idx="127">
                  <c:v>207.01</c:v>
                </c:pt>
                <c:pt idx="128">
                  <c:v>208.64</c:v>
                </c:pt>
                <c:pt idx="129">
                  <c:v>210.27</c:v>
                </c:pt>
                <c:pt idx="130">
                  <c:v>211.9</c:v>
                </c:pt>
                <c:pt idx="131">
                  <c:v>213.53</c:v>
                </c:pt>
                <c:pt idx="132">
                  <c:v>215.16</c:v>
                </c:pt>
                <c:pt idx="133">
                  <c:v>216.79</c:v>
                </c:pt>
                <c:pt idx="134">
                  <c:v>218.42</c:v>
                </c:pt>
                <c:pt idx="135">
                  <c:v>220.05</c:v>
                </c:pt>
                <c:pt idx="136">
                  <c:v>221.68</c:v>
                </c:pt>
                <c:pt idx="137">
                  <c:v>223.31</c:v>
                </c:pt>
                <c:pt idx="138">
                  <c:v>224.94</c:v>
                </c:pt>
                <c:pt idx="139">
                  <c:v>226.57</c:v>
                </c:pt>
                <c:pt idx="140">
                  <c:v>228.2</c:v>
                </c:pt>
                <c:pt idx="141">
                  <c:v>229.83</c:v>
                </c:pt>
                <c:pt idx="142">
                  <c:v>231.46</c:v>
                </c:pt>
                <c:pt idx="143">
                  <c:v>233.09</c:v>
                </c:pt>
                <c:pt idx="144">
                  <c:v>234.72</c:v>
                </c:pt>
                <c:pt idx="145">
                  <c:v>236.35</c:v>
                </c:pt>
                <c:pt idx="146">
                  <c:v>237.98</c:v>
                </c:pt>
                <c:pt idx="147">
                  <c:v>239.61</c:v>
                </c:pt>
                <c:pt idx="148">
                  <c:v>241.24</c:v>
                </c:pt>
                <c:pt idx="149">
                  <c:v>242.87</c:v>
                </c:pt>
                <c:pt idx="150">
                  <c:v>244.5</c:v>
                </c:pt>
                <c:pt idx="151">
                  <c:v>246.13</c:v>
                </c:pt>
                <c:pt idx="152">
                  <c:v>247.76</c:v>
                </c:pt>
                <c:pt idx="153">
                  <c:v>249.39</c:v>
                </c:pt>
                <c:pt idx="154">
                  <c:v>251.02</c:v>
                </c:pt>
                <c:pt idx="155">
                  <c:v>252.65</c:v>
                </c:pt>
                <c:pt idx="156">
                  <c:v>254.28</c:v>
                </c:pt>
                <c:pt idx="157">
                  <c:v>255.91</c:v>
                </c:pt>
                <c:pt idx="158">
                  <c:v>257.54000000000002</c:v>
                </c:pt>
                <c:pt idx="159">
                  <c:v>259.17</c:v>
                </c:pt>
                <c:pt idx="160">
                  <c:v>260.8</c:v>
                </c:pt>
                <c:pt idx="161">
                  <c:v>262.43</c:v>
                </c:pt>
                <c:pt idx="162">
                  <c:v>264.06</c:v>
                </c:pt>
                <c:pt idx="163">
                  <c:v>265.69</c:v>
                </c:pt>
                <c:pt idx="164">
                  <c:v>267.32</c:v>
                </c:pt>
                <c:pt idx="165">
                  <c:v>268.95</c:v>
                </c:pt>
                <c:pt idx="166">
                  <c:v>270.58</c:v>
                </c:pt>
                <c:pt idx="167">
                  <c:v>272.20999999999998</c:v>
                </c:pt>
                <c:pt idx="168">
                  <c:v>273.83999999999997</c:v>
                </c:pt>
                <c:pt idx="169">
                  <c:v>275.47000000000003</c:v>
                </c:pt>
                <c:pt idx="170">
                  <c:v>277.10000000000002</c:v>
                </c:pt>
                <c:pt idx="171">
                  <c:v>278.73</c:v>
                </c:pt>
                <c:pt idx="172">
                  <c:v>280.36</c:v>
                </c:pt>
                <c:pt idx="173">
                  <c:v>281.99</c:v>
                </c:pt>
                <c:pt idx="174">
                  <c:v>283.62</c:v>
                </c:pt>
                <c:pt idx="175">
                  <c:v>285.25</c:v>
                </c:pt>
                <c:pt idx="176">
                  <c:v>286.88</c:v>
                </c:pt>
                <c:pt idx="177">
                  <c:v>288.51</c:v>
                </c:pt>
                <c:pt idx="178">
                  <c:v>290.14</c:v>
                </c:pt>
                <c:pt idx="179">
                  <c:v>291.77</c:v>
                </c:pt>
                <c:pt idx="180">
                  <c:v>293.39999999999998</c:v>
                </c:pt>
                <c:pt idx="181">
                  <c:v>295.02999999999997</c:v>
                </c:pt>
                <c:pt idx="182">
                  <c:v>296.66000000000003</c:v>
                </c:pt>
                <c:pt idx="183">
                  <c:v>298.29000000000002</c:v>
                </c:pt>
                <c:pt idx="184">
                  <c:v>299.92</c:v>
                </c:pt>
                <c:pt idx="185">
                  <c:v>301.55</c:v>
                </c:pt>
                <c:pt idx="186">
                  <c:v>303.18</c:v>
                </c:pt>
                <c:pt idx="187">
                  <c:v>304.81</c:v>
                </c:pt>
                <c:pt idx="188">
                  <c:v>306.44</c:v>
                </c:pt>
                <c:pt idx="189">
                  <c:v>308.07</c:v>
                </c:pt>
                <c:pt idx="190">
                  <c:v>309.7</c:v>
                </c:pt>
                <c:pt idx="191">
                  <c:v>311.33</c:v>
                </c:pt>
                <c:pt idx="192">
                  <c:v>312.95999999999998</c:v>
                </c:pt>
                <c:pt idx="193">
                  <c:v>314.58999999999997</c:v>
                </c:pt>
                <c:pt idx="194">
                  <c:v>316.22000000000003</c:v>
                </c:pt>
                <c:pt idx="195">
                  <c:v>317.85000000000002</c:v>
                </c:pt>
                <c:pt idx="196">
                  <c:v>319.48</c:v>
                </c:pt>
                <c:pt idx="197">
                  <c:v>321.11</c:v>
                </c:pt>
                <c:pt idx="198">
                  <c:v>322.74</c:v>
                </c:pt>
                <c:pt idx="199">
                  <c:v>324.37</c:v>
                </c:pt>
                <c:pt idx="200">
                  <c:v>326</c:v>
                </c:pt>
                <c:pt idx="201">
                  <c:v>327.63</c:v>
                </c:pt>
                <c:pt idx="202">
                  <c:v>329.26</c:v>
                </c:pt>
                <c:pt idx="203">
                  <c:v>330.89</c:v>
                </c:pt>
                <c:pt idx="204">
                  <c:v>332.52</c:v>
                </c:pt>
                <c:pt idx="205">
                  <c:v>334.15</c:v>
                </c:pt>
                <c:pt idx="206">
                  <c:v>335.78</c:v>
                </c:pt>
                <c:pt idx="207">
                  <c:v>337.41</c:v>
                </c:pt>
                <c:pt idx="208">
                  <c:v>339.04</c:v>
                </c:pt>
                <c:pt idx="209">
                  <c:v>340.67</c:v>
                </c:pt>
                <c:pt idx="210">
                  <c:v>342.3</c:v>
                </c:pt>
                <c:pt idx="211">
                  <c:v>343.93</c:v>
                </c:pt>
                <c:pt idx="212">
                  <c:v>345.56</c:v>
                </c:pt>
                <c:pt idx="213">
                  <c:v>347.19</c:v>
                </c:pt>
                <c:pt idx="214">
                  <c:v>348.82</c:v>
                </c:pt>
                <c:pt idx="215">
                  <c:v>350.45</c:v>
                </c:pt>
                <c:pt idx="216">
                  <c:v>352.08</c:v>
                </c:pt>
                <c:pt idx="217">
                  <c:v>353.71</c:v>
                </c:pt>
                <c:pt idx="218">
                  <c:v>355.34</c:v>
                </c:pt>
                <c:pt idx="219">
                  <c:v>356.97</c:v>
                </c:pt>
                <c:pt idx="220">
                  <c:v>358.6</c:v>
                </c:pt>
                <c:pt idx="221">
                  <c:v>360.23</c:v>
                </c:pt>
                <c:pt idx="222">
                  <c:v>361.86</c:v>
                </c:pt>
                <c:pt idx="223">
                  <c:v>363.49</c:v>
                </c:pt>
                <c:pt idx="224">
                  <c:v>365.12</c:v>
                </c:pt>
                <c:pt idx="225">
                  <c:v>366.75</c:v>
                </c:pt>
                <c:pt idx="226">
                  <c:v>368.38</c:v>
                </c:pt>
                <c:pt idx="227">
                  <c:v>370.01</c:v>
                </c:pt>
                <c:pt idx="228">
                  <c:v>371.64</c:v>
                </c:pt>
                <c:pt idx="229">
                  <c:v>373.27</c:v>
                </c:pt>
                <c:pt idx="230">
                  <c:v>374.9</c:v>
                </c:pt>
                <c:pt idx="231">
                  <c:v>376.53</c:v>
                </c:pt>
                <c:pt idx="232">
                  <c:v>378.16</c:v>
                </c:pt>
                <c:pt idx="233">
                  <c:v>379.79</c:v>
                </c:pt>
                <c:pt idx="234">
                  <c:v>381.42</c:v>
                </c:pt>
                <c:pt idx="235">
                  <c:v>383.05</c:v>
                </c:pt>
                <c:pt idx="236">
                  <c:v>384.68</c:v>
                </c:pt>
                <c:pt idx="237">
                  <c:v>386.31</c:v>
                </c:pt>
                <c:pt idx="238">
                  <c:v>387.94</c:v>
                </c:pt>
                <c:pt idx="239">
                  <c:v>389.57</c:v>
                </c:pt>
                <c:pt idx="240">
                  <c:v>391.2</c:v>
                </c:pt>
                <c:pt idx="241">
                  <c:v>392.83</c:v>
                </c:pt>
                <c:pt idx="242">
                  <c:v>394.46</c:v>
                </c:pt>
                <c:pt idx="243">
                  <c:v>396.09</c:v>
                </c:pt>
                <c:pt idx="244">
                  <c:v>397.72</c:v>
                </c:pt>
                <c:pt idx="245">
                  <c:v>399.35</c:v>
                </c:pt>
                <c:pt idx="246">
                  <c:v>400.98</c:v>
                </c:pt>
                <c:pt idx="247">
                  <c:v>402.61</c:v>
                </c:pt>
                <c:pt idx="248">
                  <c:v>404.24</c:v>
                </c:pt>
                <c:pt idx="249">
                  <c:v>405.87</c:v>
                </c:pt>
                <c:pt idx="250">
                  <c:v>407.5</c:v>
                </c:pt>
                <c:pt idx="251">
                  <c:v>409.13</c:v>
                </c:pt>
                <c:pt idx="252">
                  <c:v>410.76</c:v>
                </c:pt>
                <c:pt idx="253">
                  <c:v>412.39</c:v>
                </c:pt>
                <c:pt idx="254">
                  <c:v>414.02</c:v>
                </c:pt>
                <c:pt idx="255">
                  <c:v>415.65</c:v>
                </c:pt>
                <c:pt idx="256">
                  <c:v>417.28</c:v>
                </c:pt>
                <c:pt idx="257">
                  <c:v>418.91</c:v>
                </c:pt>
                <c:pt idx="258">
                  <c:v>420.54</c:v>
                </c:pt>
                <c:pt idx="259">
                  <c:v>422.17</c:v>
                </c:pt>
                <c:pt idx="260">
                  <c:v>423.8</c:v>
                </c:pt>
                <c:pt idx="261">
                  <c:v>425.43</c:v>
                </c:pt>
                <c:pt idx="262">
                  <c:v>427.06</c:v>
                </c:pt>
                <c:pt idx="263">
                  <c:v>428.69</c:v>
                </c:pt>
                <c:pt idx="264">
                  <c:v>430.32</c:v>
                </c:pt>
                <c:pt idx="265">
                  <c:v>431.95</c:v>
                </c:pt>
                <c:pt idx="266">
                  <c:v>433.58</c:v>
                </c:pt>
                <c:pt idx="267">
                  <c:v>435.21</c:v>
                </c:pt>
                <c:pt idx="268">
                  <c:v>436.84</c:v>
                </c:pt>
                <c:pt idx="269">
                  <c:v>438.47</c:v>
                </c:pt>
                <c:pt idx="270">
                  <c:v>440.1</c:v>
                </c:pt>
                <c:pt idx="271">
                  <c:v>441.73</c:v>
                </c:pt>
                <c:pt idx="272">
                  <c:v>443.36</c:v>
                </c:pt>
                <c:pt idx="273">
                  <c:v>444.99</c:v>
                </c:pt>
                <c:pt idx="274">
                  <c:v>446.62</c:v>
                </c:pt>
                <c:pt idx="275">
                  <c:v>448.25</c:v>
                </c:pt>
                <c:pt idx="276">
                  <c:v>449.88</c:v>
                </c:pt>
                <c:pt idx="277">
                  <c:v>451.51</c:v>
                </c:pt>
                <c:pt idx="278">
                  <c:v>453.14</c:v>
                </c:pt>
                <c:pt idx="279">
                  <c:v>454.77</c:v>
                </c:pt>
                <c:pt idx="280">
                  <c:v>456.4</c:v>
                </c:pt>
                <c:pt idx="281">
                  <c:v>458.03</c:v>
                </c:pt>
                <c:pt idx="282">
                  <c:v>459.66</c:v>
                </c:pt>
                <c:pt idx="283">
                  <c:v>461.29</c:v>
                </c:pt>
                <c:pt idx="284">
                  <c:v>462.92</c:v>
                </c:pt>
                <c:pt idx="285">
                  <c:v>464.55</c:v>
                </c:pt>
                <c:pt idx="286">
                  <c:v>466.18</c:v>
                </c:pt>
                <c:pt idx="287">
                  <c:v>467.81</c:v>
                </c:pt>
                <c:pt idx="288">
                  <c:v>469.44</c:v>
                </c:pt>
                <c:pt idx="289">
                  <c:v>471.07</c:v>
                </c:pt>
                <c:pt idx="290">
                  <c:v>472.7</c:v>
                </c:pt>
                <c:pt idx="291">
                  <c:v>474.33</c:v>
                </c:pt>
                <c:pt idx="292">
                  <c:v>475.96</c:v>
                </c:pt>
                <c:pt idx="293">
                  <c:v>477.59</c:v>
                </c:pt>
                <c:pt idx="294">
                  <c:v>479.22</c:v>
                </c:pt>
                <c:pt idx="295">
                  <c:v>480.85</c:v>
                </c:pt>
                <c:pt idx="296">
                  <c:v>482.48</c:v>
                </c:pt>
                <c:pt idx="297">
                  <c:v>484.11</c:v>
                </c:pt>
                <c:pt idx="298">
                  <c:v>485.74</c:v>
                </c:pt>
                <c:pt idx="299">
                  <c:v>487.37</c:v>
                </c:pt>
                <c:pt idx="300">
                  <c:v>489</c:v>
                </c:pt>
                <c:pt idx="301">
                  <c:v>490.63</c:v>
                </c:pt>
                <c:pt idx="302">
                  <c:v>492.26</c:v>
                </c:pt>
                <c:pt idx="303">
                  <c:v>493.89</c:v>
                </c:pt>
                <c:pt idx="304">
                  <c:v>495.52</c:v>
                </c:pt>
                <c:pt idx="305">
                  <c:v>497.15</c:v>
                </c:pt>
                <c:pt idx="306">
                  <c:v>498.78</c:v>
                </c:pt>
                <c:pt idx="307">
                  <c:v>500.41</c:v>
                </c:pt>
                <c:pt idx="308">
                  <c:v>502.04</c:v>
                </c:pt>
                <c:pt idx="309">
                  <c:v>503.67</c:v>
                </c:pt>
                <c:pt idx="310">
                  <c:v>505.3</c:v>
                </c:pt>
                <c:pt idx="311">
                  <c:v>506.93</c:v>
                </c:pt>
                <c:pt idx="312">
                  <c:v>508.56</c:v>
                </c:pt>
                <c:pt idx="313">
                  <c:v>510.19</c:v>
                </c:pt>
                <c:pt idx="314">
                  <c:v>511.82</c:v>
                </c:pt>
                <c:pt idx="315">
                  <c:v>513.45000000000005</c:v>
                </c:pt>
                <c:pt idx="316">
                  <c:v>515.08000000000004</c:v>
                </c:pt>
                <c:pt idx="317">
                  <c:v>516.71</c:v>
                </c:pt>
                <c:pt idx="318">
                  <c:v>518.34</c:v>
                </c:pt>
                <c:pt idx="319">
                  <c:v>519.97</c:v>
                </c:pt>
                <c:pt idx="320">
                  <c:v>521.6</c:v>
                </c:pt>
                <c:pt idx="321">
                  <c:v>523.23</c:v>
                </c:pt>
                <c:pt idx="322">
                  <c:v>524.86</c:v>
                </c:pt>
                <c:pt idx="323">
                  <c:v>526.49</c:v>
                </c:pt>
                <c:pt idx="324">
                  <c:v>528.12</c:v>
                </c:pt>
                <c:pt idx="325">
                  <c:v>529.75</c:v>
                </c:pt>
                <c:pt idx="326">
                  <c:v>531.38</c:v>
                </c:pt>
                <c:pt idx="327">
                  <c:v>533.01</c:v>
                </c:pt>
                <c:pt idx="328">
                  <c:v>534.64</c:v>
                </c:pt>
                <c:pt idx="329">
                  <c:v>536.27</c:v>
                </c:pt>
                <c:pt idx="330">
                  <c:v>537.9</c:v>
                </c:pt>
                <c:pt idx="331">
                  <c:v>539.53</c:v>
                </c:pt>
                <c:pt idx="332">
                  <c:v>541.16</c:v>
                </c:pt>
                <c:pt idx="333">
                  <c:v>542.79</c:v>
                </c:pt>
                <c:pt idx="334">
                  <c:v>544.41999999999996</c:v>
                </c:pt>
                <c:pt idx="335">
                  <c:v>546.04999999999995</c:v>
                </c:pt>
                <c:pt idx="336">
                  <c:v>547.67999999999995</c:v>
                </c:pt>
                <c:pt idx="337">
                  <c:v>549.30999999999995</c:v>
                </c:pt>
                <c:pt idx="338">
                  <c:v>550.94000000000005</c:v>
                </c:pt>
                <c:pt idx="339">
                  <c:v>552.57000000000005</c:v>
                </c:pt>
                <c:pt idx="340">
                  <c:v>554.20000000000005</c:v>
                </c:pt>
                <c:pt idx="341">
                  <c:v>555.83000000000004</c:v>
                </c:pt>
                <c:pt idx="342">
                  <c:v>557.46</c:v>
                </c:pt>
                <c:pt idx="343">
                  <c:v>559.09</c:v>
                </c:pt>
                <c:pt idx="344">
                  <c:v>560.72</c:v>
                </c:pt>
                <c:pt idx="345">
                  <c:v>562.35</c:v>
                </c:pt>
                <c:pt idx="346">
                  <c:v>563.98</c:v>
                </c:pt>
                <c:pt idx="347">
                  <c:v>565.61</c:v>
                </c:pt>
                <c:pt idx="348">
                  <c:v>567.24</c:v>
                </c:pt>
                <c:pt idx="349">
                  <c:v>568.87</c:v>
                </c:pt>
                <c:pt idx="350">
                  <c:v>570.5</c:v>
                </c:pt>
                <c:pt idx="351">
                  <c:v>572.13</c:v>
                </c:pt>
                <c:pt idx="352">
                  <c:v>573.76</c:v>
                </c:pt>
                <c:pt idx="353">
                  <c:v>575.39</c:v>
                </c:pt>
                <c:pt idx="354">
                  <c:v>577.02</c:v>
                </c:pt>
                <c:pt idx="355">
                  <c:v>578.65</c:v>
                </c:pt>
                <c:pt idx="356">
                  <c:v>580.28</c:v>
                </c:pt>
                <c:pt idx="357">
                  <c:v>581.91</c:v>
                </c:pt>
                <c:pt idx="358">
                  <c:v>583.54</c:v>
                </c:pt>
                <c:pt idx="359">
                  <c:v>585.16999999999996</c:v>
                </c:pt>
                <c:pt idx="360">
                  <c:v>586.79999999999995</c:v>
                </c:pt>
                <c:pt idx="361">
                  <c:v>588.42999999999995</c:v>
                </c:pt>
                <c:pt idx="362">
                  <c:v>590.05999999999995</c:v>
                </c:pt>
                <c:pt idx="363">
                  <c:v>591.69000000000005</c:v>
                </c:pt>
                <c:pt idx="364">
                  <c:v>593.32000000000005</c:v>
                </c:pt>
                <c:pt idx="365">
                  <c:v>594.95000000000005</c:v>
                </c:pt>
                <c:pt idx="366">
                  <c:v>596.58000000000004</c:v>
                </c:pt>
                <c:pt idx="367">
                  <c:v>598.21</c:v>
                </c:pt>
                <c:pt idx="368">
                  <c:v>599.84</c:v>
                </c:pt>
                <c:pt idx="369">
                  <c:v>601.47</c:v>
                </c:pt>
                <c:pt idx="370">
                  <c:v>603.1</c:v>
                </c:pt>
                <c:pt idx="371">
                  <c:v>604.73</c:v>
                </c:pt>
                <c:pt idx="372">
                  <c:v>606.36</c:v>
                </c:pt>
                <c:pt idx="373">
                  <c:v>607.99</c:v>
                </c:pt>
                <c:pt idx="374">
                  <c:v>609.62</c:v>
                </c:pt>
                <c:pt idx="375">
                  <c:v>611.25</c:v>
                </c:pt>
                <c:pt idx="376">
                  <c:v>612.88</c:v>
                </c:pt>
                <c:pt idx="377">
                  <c:v>614.51</c:v>
                </c:pt>
                <c:pt idx="378">
                  <c:v>616.14</c:v>
                </c:pt>
                <c:pt idx="379">
                  <c:v>617.77</c:v>
                </c:pt>
                <c:pt idx="380">
                  <c:v>619.4</c:v>
                </c:pt>
                <c:pt idx="381">
                  <c:v>621.03</c:v>
                </c:pt>
                <c:pt idx="382">
                  <c:v>622.66</c:v>
                </c:pt>
                <c:pt idx="383">
                  <c:v>624.29</c:v>
                </c:pt>
                <c:pt idx="384">
                  <c:v>625.91999999999996</c:v>
                </c:pt>
                <c:pt idx="385">
                  <c:v>627.54999999999995</c:v>
                </c:pt>
                <c:pt idx="386">
                  <c:v>629.17999999999995</c:v>
                </c:pt>
                <c:pt idx="387">
                  <c:v>630.80999999999995</c:v>
                </c:pt>
                <c:pt idx="388">
                  <c:v>632.44000000000005</c:v>
                </c:pt>
                <c:pt idx="389">
                  <c:v>634.07000000000005</c:v>
                </c:pt>
                <c:pt idx="390">
                  <c:v>635.70000000000005</c:v>
                </c:pt>
                <c:pt idx="391">
                  <c:v>637.33000000000004</c:v>
                </c:pt>
                <c:pt idx="392">
                  <c:v>638.96</c:v>
                </c:pt>
                <c:pt idx="393">
                  <c:v>640.59</c:v>
                </c:pt>
                <c:pt idx="394">
                  <c:v>642.22</c:v>
                </c:pt>
                <c:pt idx="395">
                  <c:v>643.85</c:v>
                </c:pt>
                <c:pt idx="396">
                  <c:v>645.48</c:v>
                </c:pt>
                <c:pt idx="397">
                  <c:v>647.11</c:v>
                </c:pt>
                <c:pt idx="398">
                  <c:v>648.74</c:v>
                </c:pt>
                <c:pt idx="399">
                  <c:v>650.37</c:v>
                </c:pt>
              </c:numCache>
            </c:numRef>
          </c:xVal>
          <c:yVal>
            <c:numRef>
              <c:f>'2may07_abRy3_N_1a'!$F$1:$F$422</c:f>
              <c:numCache>
                <c:formatCode>General</c:formatCode>
                <c:ptCount val="422"/>
                <c:pt idx="0">
                  <c:v>1.0016721491228069</c:v>
                </c:pt>
                <c:pt idx="1">
                  <c:v>1.005455043859649</c:v>
                </c:pt>
                <c:pt idx="2">
                  <c:v>1.0043311403508772</c:v>
                </c:pt>
                <c:pt idx="3">
                  <c:v>1.0029057017543861</c:v>
                </c:pt>
                <c:pt idx="4">
                  <c:v>0.99936951754385983</c:v>
                </c:pt>
                <c:pt idx="5">
                  <c:v>0.99917763157894735</c:v>
                </c:pt>
                <c:pt idx="6">
                  <c:v>1.0000822368421052</c:v>
                </c:pt>
                <c:pt idx="7">
                  <c:v>1.0060855263157895</c:v>
                </c:pt>
                <c:pt idx="8">
                  <c:v>1.0070723684210525</c:v>
                </c:pt>
                <c:pt idx="9">
                  <c:v>1.0041392543859649</c:v>
                </c:pt>
                <c:pt idx="10">
                  <c:v>1.0027686403508771</c:v>
                </c:pt>
                <c:pt idx="11">
                  <c:v>1.0077576754385966</c:v>
                </c:pt>
                <c:pt idx="12">
                  <c:v>1.0111293859649122</c:v>
                </c:pt>
                <c:pt idx="13">
                  <c:v>1.0093201754385965</c:v>
                </c:pt>
                <c:pt idx="14">
                  <c:v>1.002467105263158</c:v>
                </c:pt>
                <c:pt idx="15">
                  <c:v>0.99978070175438594</c:v>
                </c:pt>
                <c:pt idx="16">
                  <c:v>1.0035910087719297</c:v>
                </c:pt>
                <c:pt idx="17">
                  <c:v>1.0041666666666667</c:v>
                </c:pt>
                <c:pt idx="18">
                  <c:v>1.0091831140350875</c:v>
                </c:pt>
                <c:pt idx="19">
                  <c:v>1.0080317982456142</c:v>
                </c:pt>
                <c:pt idx="20">
                  <c:v>1.0105263157894735</c:v>
                </c:pt>
                <c:pt idx="21">
                  <c:v>1.0087171052631578</c:v>
                </c:pt>
                <c:pt idx="22">
                  <c:v>1.0026041666666667</c:v>
                </c:pt>
                <c:pt idx="23">
                  <c:v>1.0028234649122807</c:v>
                </c:pt>
                <c:pt idx="24">
                  <c:v>1.0014802631578947</c:v>
                </c:pt>
                <c:pt idx="25">
                  <c:v>1.0028234649122807</c:v>
                </c:pt>
                <c:pt idx="26">
                  <c:v>0.99731359649122808</c:v>
                </c:pt>
                <c:pt idx="27">
                  <c:v>0.99405153508771937</c:v>
                </c:pt>
                <c:pt idx="28">
                  <c:v>0.99081688596491235</c:v>
                </c:pt>
                <c:pt idx="29">
                  <c:v>0.99539473684210533</c:v>
                </c:pt>
                <c:pt idx="30">
                  <c:v>0.99525767543859656</c:v>
                </c:pt>
                <c:pt idx="31">
                  <c:v>1.0007675438596491</c:v>
                </c:pt>
                <c:pt idx="32">
                  <c:v>0.99901315789473666</c:v>
                </c:pt>
                <c:pt idx="33">
                  <c:v>0.99906798245614026</c:v>
                </c:pt>
                <c:pt idx="34">
                  <c:v>0.99481907894736832</c:v>
                </c:pt>
                <c:pt idx="35">
                  <c:v>0.99514802631578947</c:v>
                </c:pt>
                <c:pt idx="36">
                  <c:v>0.99580592105263144</c:v>
                </c:pt>
                <c:pt idx="37">
                  <c:v>0.9983004385964912</c:v>
                </c:pt>
                <c:pt idx="38">
                  <c:v>0.99849232456140358</c:v>
                </c:pt>
                <c:pt idx="39">
                  <c:v>0.99613486842105259</c:v>
                </c:pt>
                <c:pt idx="40">
                  <c:v>0.99240679824561395</c:v>
                </c:pt>
                <c:pt idx="41">
                  <c:v>0.98856907894736834</c:v>
                </c:pt>
                <c:pt idx="42">
                  <c:v>0.99002192982456139</c:v>
                </c:pt>
                <c:pt idx="43">
                  <c:v>0.99468201754385976</c:v>
                </c:pt>
                <c:pt idx="44">
                  <c:v>1.002357456140351</c:v>
                </c:pt>
                <c:pt idx="45">
                  <c:v>1.0070175438596491</c:v>
                </c:pt>
                <c:pt idx="46">
                  <c:v>1.0084155701754385</c:v>
                </c:pt>
                <c:pt idx="47">
                  <c:v>1.0094024122807017</c:v>
                </c:pt>
                <c:pt idx="48">
                  <c:v>1.0060581140350877</c:v>
                </c:pt>
                <c:pt idx="49">
                  <c:v>1.0037006578947367</c:v>
                </c:pt>
                <c:pt idx="50">
                  <c:v>1.0009046052631578</c:v>
                </c:pt>
                <c:pt idx="51">
                  <c:v>1.003234649122807</c:v>
                </c:pt>
                <c:pt idx="52">
                  <c:v>1.0023848684210528</c:v>
                </c:pt>
                <c:pt idx="53">
                  <c:v>1.0005482456140351</c:v>
                </c:pt>
                <c:pt idx="54">
                  <c:v>0.99849232456140358</c:v>
                </c:pt>
                <c:pt idx="55">
                  <c:v>1.002357456140351</c:v>
                </c:pt>
                <c:pt idx="56">
                  <c:v>1.0014254385964911</c:v>
                </c:pt>
                <c:pt idx="57">
                  <c:v>1.000109649122807</c:v>
                </c:pt>
                <c:pt idx="58">
                  <c:v>0.99643640350877194</c:v>
                </c:pt>
                <c:pt idx="59">
                  <c:v>0.99690241228070187</c:v>
                </c:pt>
                <c:pt idx="60">
                  <c:v>0.99665570175438611</c:v>
                </c:pt>
                <c:pt idx="61">
                  <c:v>0.99465460526315785</c:v>
                </c:pt>
                <c:pt idx="62">
                  <c:v>0.99174890350877198</c:v>
                </c:pt>
                <c:pt idx="63">
                  <c:v>0.99180372807017536</c:v>
                </c:pt>
                <c:pt idx="64">
                  <c:v>0.99339364035087729</c:v>
                </c:pt>
                <c:pt idx="65">
                  <c:v>0.99076206140350875</c:v>
                </c:pt>
                <c:pt idx="66">
                  <c:v>0.98999451754385959</c:v>
                </c:pt>
                <c:pt idx="67">
                  <c:v>0.99010416666666667</c:v>
                </c:pt>
                <c:pt idx="68">
                  <c:v>0.99328399122807021</c:v>
                </c:pt>
                <c:pt idx="69">
                  <c:v>0.9921875</c:v>
                </c:pt>
                <c:pt idx="70">
                  <c:v>0.98873355263157892</c:v>
                </c:pt>
                <c:pt idx="71">
                  <c:v>0.98892543859649118</c:v>
                </c:pt>
                <c:pt idx="72">
                  <c:v>0.99103618421052631</c:v>
                </c:pt>
                <c:pt idx="73">
                  <c:v>0.99131030701754386</c:v>
                </c:pt>
                <c:pt idx="74">
                  <c:v>0.9916118421052631</c:v>
                </c:pt>
                <c:pt idx="75">
                  <c:v>0.99128289473684206</c:v>
                </c:pt>
                <c:pt idx="76">
                  <c:v>0.98933662280701762</c:v>
                </c:pt>
                <c:pt idx="77">
                  <c:v>0.98363486842105263</c:v>
                </c:pt>
                <c:pt idx="78">
                  <c:v>0.97924890350877192</c:v>
                </c:pt>
                <c:pt idx="79">
                  <c:v>0.97793311403508765</c:v>
                </c:pt>
                <c:pt idx="80">
                  <c:v>0.974890350877193</c:v>
                </c:pt>
                <c:pt idx="81">
                  <c:v>0.97354714912280704</c:v>
                </c:pt>
                <c:pt idx="82">
                  <c:v>0.97412280701754383</c:v>
                </c:pt>
                <c:pt idx="83">
                  <c:v>0.97349232456140367</c:v>
                </c:pt>
                <c:pt idx="84">
                  <c:v>0.96905153508771935</c:v>
                </c:pt>
                <c:pt idx="85">
                  <c:v>0.96277412280701757</c:v>
                </c:pt>
                <c:pt idx="86">
                  <c:v>0.95973135964912293</c:v>
                </c:pt>
                <c:pt idx="87">
                  <c:v>0.96112938596491226</c:v>
                </c:pt>
                <c:pt idx="88">
                  <c:v>0.96186951754385974</c:v>
                </c:pt>
                <c:pt idx="89">
                  <c:v>0.96433662280701749</c:v>
                </c:pt>
                <c:pt idx="90">
                  <c:v>0.96384320175438598</c:v>
                </c:pt>
                <c:pt idx="91">
                  <c:v>0.96334978070175448</c:v>
                </c:pt>
                <c:pt idx="92">
                  <c:v>0.96326754385964908</c:v>
                </c:pt>
                <c:pt idx="93">
                  <c:v>0.96140350877192982</c:v>
                </c:pt>
                <c:pt idx="94">
                  <c:v>0.95701754385964899</c:v>
                </c:pt>
                <c:pt idx="95">
                  <c:v>0.95158991228070178</c:v>
                </c:pt>
                <c:pt idx="96">
                  <c:v>0.94975328947368409</c:v>
                </c:pt>
                <c:pt idx="97">
                  <c:v>0.95227521929824555</c:v>
                </c:pt>
                <c:pt idx="98">
                  <c:v>0.95460526315789485</c:v>
                </c:pt>
                <c:pt idx="99">
                  <c:v>0.94989035087719298</c:v>
                </c:pt>
                <c:pt idx="100">
                  <c:v>0.94459978070175443</c:v>
                </c:pt>
                <c:pt idx="101">
                  <c:v>0.93848684210526301</c:v>
                </c:pt>
                <c:pt idx="102">
                  <c:v>0.94117324561403504</c:v>
                </c:pt>
                <c:pt idx="103">
                  <c:v>0.94057017543859656</c:v>
                </c:pt>
                <c:pt idx="104">
                  <c:v>0.93870614035087707</c:v>
                </c:pt>
                <c:pt idx="105">
                  <c:v>0.93366228070175439</c:v>
                </c:pt>
                <c:pt idx="106">
                  <c:v>0.92779605263157894</c:v>
                </c:pt>
                <c:pt idx="107">
                  <c:v>0.92900219298245623</c:v>
                </c:pt>
                <c:pt idx="108">
                  <c:v>0.92828947368421044</c:v>
                </c:pt>
                <c:pt idx="109">
                  <c:v>0.92842653508771933</c:v>
                </c:pt>
                <c:pt idx="110">
                  <c:v>0.92519188596491231</c:v>
                </c:pt>
                <c:pt idx="111">
                  <c:v>0.92335526315789462</c:v>
                </c:pt>
                <c:pt idx="112">
                  <c:v>0.92530153508771928</c:v>
                </c:pt>
                <c:pt idx="113">
                  <c:v>0.92195723684210529</c:v>
                </c:pt>
                <c:pt idx="114">
                  <c:v>0.9213815789473685</c:v>
                </c:pt>
                <c:pt idx="115">
                  <c:v>0.91811951754385968</c:v>
                </c:pt>
                <c:pt idx="116">
                  <c:v>0.91770833333333324</c:v>
                </c:pt>
                <c:pt idx="117">
                  <c:v>0.91162280701754383</c:v>
                </c:pt>
                <c:pt idx="118">
                  <c:v>0.90720942982456132</c:v>
                </c:pt>
                <c:pt idx="119">
                  <c:v>0.90597587719298234</c:v>
                </c:pt>
                <c:pt idx="120">
                  <c:v>0.90871710526315785</c:v>
                </c:pt>
                <c:pt idx="121">
                  <c:v>0.90803179824561397</c:v>
                </c:pt>
                <c:pt idx="122">
                  <c:v>0.90962171052631569</c:v>
                </c:pt>
                <c:pt idx="123">
                  <c:v>0.90775767543859642</c:v>
                </c:pt>
                <c:pt idx="124">
                  <c:v>0.90693530701754399</c:v>
                </c:pt>
                <c:pt idx="125">
                  <c:v>0.90032894736842106</c:v>
                </c:pt>
                <c:pt idx="126">
                  <c:v>0.89712171052631573</c:v>
                </c:pt>
                <c:pt idx="127">
                  <c:v>0.89402412280701749</c:v>
                </c:pt>
                <c:pt idx="128">
                  <c:v>0.89665570175438603</c:v>
                </c:pt>
                <c:pt idx="129">
                  <c:v>0.89588815789473697</c:v>
                </c:pt>
                <c:pt idx="130">
                  <c:v>0.9001370614035088</c:v>
                </c:pt>
                <c:pt idx="131">
                  <c:v>0.90120614035087721</c:v>
                </c:pt>
                <c:pt idx="132">
                  <c:v>0.90238486842105259</c:v>
                </c:pt>
                <c:pt idx="133">
                  <c:v>0.89687499999999998</c:v>
                </c:pt>
                <c:pt idx="134">
                  <c:v>0.89070723684210529</c:v>
                </c:pt>
                <c:pt idx="135">
                  <c:v>0.89073464912280709</c:v>
                </c:pt>
                <c:pt idx="136">
                  <c:v>0.88856907894736847</c:v>
                </c:pt>
                <c:pt idx="137">
                  <c:v>0.89043311403508774</c:v>
                </c:pt>
                <c:pt idx="138">
                  <c:v>0.88484100877192995</c:v>
                </c:pt>
                <c:pt idx="139">
                  <c:v>0.88969298245614026</c:v>
                </c:pt>
                <c:pt idx="140">
                  <c:v>0.88711622807017543</c:v>
                </c:pt>
                <c:pt idx="141">
                  <c:v>0.88681469298245619</c:v>
                </c:pt>
                <c:pt idx="142">
                  <c:v>0.88092105263157894</c:v>
                </c:pt>
                <c:pt idx="143">
                  <c:v>0.88237390350877198</c:v>
                </c:pt>
                <c:pt idx="144">
                  <c:v>0.88135964912280695</c:v>
                </c:pt>
                <c:pt idx="145">
                  <c:v>0.88105811403508782</c:v>
                </c:pt>
                <c:pt idx="146">
                  <c:v>0.87842653508771928</c:v>
                </c:pt>
                <c:pt idx="147">
                  <c:v>0.87752192982456145</c:v>
                </c:pt>
                <c:pt idx="148">
                  <c:v>0.87746710526315796</c:v>
                </c:pt>
                <c:pt idx="149">
                  <c:v>0.87532894736842104</c:v>
                </c:pt>
                <c:pt idx="150">
                  <c:v>0.87360197368421055</c:v>
                </c:pt>
                <c:pt idx="151">
                  <c:v>0.872203947368421</c:v>
                </c:pt>
                <c:pt idx="152">
                  <c:v>0.87050438596491231</c:v>
                </c:pt>
                <c:pt idx="153">
                  <c:v>0.87162828947368409</c:v>
                </c:pt>
                <c:pt idx="154">
                  <c:v>0.87014802631578958</c:v>
                </c:pt>
                <c:pt idx="155">
                  <c:v>0.86979166666666663</c:v>
                </c:pt>
                <c:pt idx="156">
                  <c:v>0.86625548245614026</c:v>
                </c:pt>
                <c:pt idx="157">
                  <c:v>0.86535087719298243</c:v>
                </c:pt>
                <c:pt idx="158">
                  <c:v>0.85967653508771935</c:v>
                </c:pt>
                <c:pt idx="159">
                  <c:v>0.85841557017543868</c:v>
                </c:pt>
                <c:pt idx="160">
                  <c:v>0.85759320175438603</c:v>
                </c:pt>
                <c:pt idx="161">
                  <c:v>0.86088267543859642</c:v>
                </c:pt>
                <c:pt idx="162">
                  <c:v>0.86378837719298251</c:v>
                </c:pt>
                <c:pt idx="163">
                  <c:v>0.86411732456140344</c:v>
                </c:pt>
                <c:pt idx="164">
                  <c:v>0.86296600877192986</c:v>
                </c:pt>
                <c:pt idx="165">
                  <c:v>0.85786732456140358</c:v>
                </c:pt>
                <c:pt idx="166">
                  <c:v>0.85685307017543855</c:v>
                </c:pt>
                <c:pt idx="167">
                  <c:v>0.85893640350877198</c:v>
                </c:pt>
                <c:pt idx="168">
                  <c:v>0.85953947368421046</c:v>
                </c:pt>
                <c:pt idx="169">
                  <c:v>0.85874451754385961</c:v>
                </c:pt>
                <c:pt idx="170">
                  <c:v>0.85614035087719298</c:v>
                </c:pt>
                <c:pt idx="171">
                  <c:v>0.85487938596491231</c:v>
                </c:pt>
                <c:pt idx="172">
                  <c:v>0.85485197368421051</c:v>
                </c:pt>
                <c:pt idx="173">
                  <c:v>0.85408442982456123</c:v>
                </c:pt>
                <c:pt idx="174">
                  <c:v>0.8520559210526315</c:v>
                </c:pt>
                <c:pt idx="175">
                  <c:v>0.85290570175438596</c:v>
                </c:pt>
                <c:pt idx="176">
                  <c:v>0.85271381578947369</c:v>
                </c:pt>
                <c:pt idx="177">
                  <c:v>0.85597587719298229</c:v>
                </c:pt>
                <c:pt idx="178">
                  <c:v>0.85038377192982451</c:v>
                </c:pt>
                <c:pt idx="179">
                  <c:v>0.85194627192982442</c:v>
                </c:pt>
                <c:pt idx="180">
                  <c:v>0.85312500000000002</c:v>
                </c:pt>
                <c:pt idx="181">
                  <c:v>0.85696271929824563</c:v>
                </c:pt>
                <c:pt idx="182">
                  <c:v>0.85320723684210531</c:v>
                </c:pt>
                <c:pt idx="183">
                  <c:v>0.84890350877192977</c:v>
                </c:pt>
                <c:pt idx="184">
                  <c:v>0.84849232456140344</c:v>
                </c:pt>
                <c:pt idx="185">
                  <c:v>0.85123355263157885</c:v>
                </c:pt>
                <c:pt idx="186">
                  <c:v>0.8537280701754385</c:v>
                </c:pt>
                <c:pt idx="187">
                  <c:v>0.84950657894736847</c:v>
                </c:pt>
                <c:pt idx="188">
                  <c:v>0.85112390350877198</c:v>
                </c:pt>
                <c:pt idx="189">
                  <c:v>0.85230263157894737</c:v>
                </c:pt>
                <c:pt idx="190">
                  <c:v>0.85794956140350875</c:v>
                </c:pt>
                <c:pt idx="191">
                  <c:v>0.85419407894736843</c:v>
                </c:pt>
                <c:pt idx="192">
                  <c:v>0.84980811403508782</c:v>
                </c:pt>
                <c:pt idx="193">
                  <c:v>0.84602521929824548</c:v>
                </c:pt>
                <c:pt idx="194">
                  <c:v>0.84964364035087714</c:v>
                </c:pt>
                <c:pt idx="195">
                  <c:v>0.85202850877192982</c:v>
                </c:pt>
                <c:pt idx="196">
                  <c:v>0.85128837719298245</c:v>
                </c:pt>
                <c:pt idx="197">
                  <c:v>0.84893092105263157</c:v>
                </c:pt>
                <c:pt idx="198">
                  <c:v>0.85035635964912271</c:v>
                </c:pt>
                <c:pt idx="199">
                  <c:v>0.84816337719298251</c:v>
                </c:pt>
                <c:pt idx="200">
                  <c:v>0.84717653508771928</c:v>
                </c:pt>
                <c:pt idx="201">
                  <c:v>0.84709429824561411</c:v>
                </c:pt>
                <c:pt idx="202">
                  <c:v>0.84942434210526319</c:v>
                </c:pt>
                <c:pt idx="203">
                  <c:v>0.84851973684210524</c:v>
                </c:pt>
                <c:pt idx="204">
                  <c:v>0.84939692982456139</c:v>
                </c:pt>
                <c:pt idx="205">
                  <c:v>0.84646381578947361</c:v>
                </c:pt>
                <c:pt idx="206">
                  <c:v>0.84525767543859642</c:v>
                </c:pt>
                <c:pt idx="207">
                  <c:v>0.83845942982456145</c:v>
                </c:pt>
                <c:pt idx="208">
                  <c:v>0.84161184210526319</c:v>
                </c:pt>
                <c:pt idx="209">
                  <c:v>0.84333881578947356</c:v>
                </c:pt>
                <c:pt idx="210">
                  <c:v>0.84616228070175437</c:v>
                </c:pt>
                <c:pt idx="211">
                  <c:v>0.84580592105263153</c:v>
                </c:pt>
                <c:pt idx="212">
                  <c:v>0.84166666666666679</c:v>
                </c:pt>
                <c:pt idx="213">
                  <c:v>0.83895285087719296</c:v>
                </c:pt>
                <c:pt idx="214">
                  <c:v>0.83791118421052635</c:v>
                </c:pt>
                <c:pt idx="215">
                  <c:v>0.83730811403508776</c:v>
                </c:pt>
                <c:pt idx="216">
                  <c:v>0.83695175438596492</c:v>
                </c:pt>
                <c:pt idx="217">
                  <c:v>0.83777412280701746</c:v>
                </c:pt>
                <c:pt idx="218">
                  <c:v>0.83667763157894737</c:v>
                </c:pt>
                <c:pt idx="219">
                  <c:v>0.83928179824561389</c:v>
                </c:pt>
                <c:pt idx="220">
                  <c:v>0.83993969298245619</c:v>
                </c:pt>
                <c:pt idx="221">
                  <c:v>0.84311951754385961</c:v>
                </c:pt>
                <c:pt idx="222">
                  <c:v>0.84163925438596487</c:v>
                </c:pt>
                <c:pt idx="223">
                  <c:v>0.83980263157894741</c:v>
                </c:pt>
                <c:pt idx="224">
                  <c:v>0.84109100877192977</c:v>
                </c:pt>
                <c:pt idx="225">
                  <c:v>0.83936403508771917</c:v>
                </c:pt>
                <c:pt idx="226">
                  <c:v>0.83826754385964908</c:v>
                </c:pt>
                <c:pt idx="227">
                  <c:v>0.83368969298245599</c:v>
                </c:pt>
                <c:pt idx="228">
                  <c:v>0.83750000000000002</c:v>
                </c:pt>
                <c:pt idx="229">
                  <c:v>0.83859649122807012</c:v>
                </c:pt>
                <c:pt idx="230">
                  <c:v>0.83999451754385968</c:v>
                </c:pt>
                <c:pt idx="231">
                  <c:v>0.83717105263157887</c:v>
                </c:pt>
                <c:pt idx="232">
                  <c:v>0.83662280701754377</c:v>
                </c:pt>
                <c:pt idx="233">
                  <c:v>0.83944627192982457</c:v>
                </c:pt>
                <c:pt idx="234">
                  <c:v>0.83977521929824561</c:v>
                </c:pt>
                <c:pt idx="235">
                  <c:v>0.84037828947368409</c:v>
                </c:pt>
                <c:pt idx="236">
                  <c:v>0.83777412280701746</c:v>
                </c:pt>
                <c:pt idx="237">
                  <c:v>0.83544407894736838</c:v>
                </c:pt>
                <c:pt idx="238">
                  <c:v>0.83478618421052631</c:v>
                </c:pt>
                <c:pt idx="239">
                  <c:v>0.83506030701754386</c:v>
                </c:pt>
                <c:pt idx="240">
                  <c:v>0.83256578947368431</c:v>
                </c:pt>
                <c:pt idx="241">
                  <c:v>0.83067434210526325</c:v>
                </c:pt>
                <c:pt idx="242">
                  <c:v>0.82493969298245606</c:v>
                </c:pt>
                <c:pt idx="243">
                  <c:v>0.82710526315789468</c:v>
                </c:pt>
                <c:pt idx="244">
                  <c:v>0.82669407894736835</c:v>
                </c:pt>
                <c:pt idx="245">
                  <c:v>0.83182565789473673</c:v>
                </c:pt>
                <c:pt idx="246">
                  <c:v>0.82946820175438596</c:v>
                </c:pt>
                <c:pt idx="247">
                  <c:v>0.82878289473684197</c:v>
                </c:pt>
                <c:pt idx="248">
                  <c:v>0.82779605263157885</c:v>
                </c:pt>
                <c:pt idx="249">
                  <c:v>0.82839912280701755</c:v>
                </c:pt>
                <c:pt idx="250">
                  <c:v>0.82746710526315803</c:v>
                </c:pt>
                <c:pt idx="251">
                  <c:v>0.82672697368421044</c:v>
                </c:pt>
                <c:pt idx="252">
                  <c:v>0.82738486842105263</c:v>
                </c:pt>
                <c:pt idx="253">
                  <c:v>0.82820723684210529</c:v>
                </c:pt>
                <c:pt idx="254">
                  <c:v>0.82949561403508776</c:v>
                </c:pt>
                <c:pt idx="255">
                  <c:v>0.8280975877192982</c:v>
                </c:pt>
                <c:pt idx="256">
                  <c:v>0.82886513157894737</c:v>
                </c:pt>
                <c:pt idx="257">
                  <c:v>0.82658991228070178</c:v>
                </c:pt>
                <c:pt idx="258">
                  <c:v>0.82787828947368425</c:v>
                </c:pt>
                <c:pt idx="259">
                  <c:v>0.82927631578947369</c:v>
                </c:pt>
                <c:pt idx="260">
                  <c:v>0.8286732456140351</c:v>
                </c:pt>
                <c:pt idx="261">
                  <c:v>0.82785087719298245</c:v>
                </c:pt>
                <c:pt idx="262">
                  <c:v>0.82820723684210529</c:v>
                </c:pt>
                <c:pt idx="263">
                  <c:v>0.82935855263157909</c:v>
                </c:pt>
                <c:pt idx="264">
                  <c:v>0.82971491228070182</c:v>
                </c:pt>
                <c:pt idx="265">
                  <c:v>0.82628837719298254</c:v>
                </c:pt>
                <c:pt idx="266">
                  <c:v>0.82963267543859642</c:v>
                </c:pt>
                <c:pt idx="267">
                  <c:v>0.83133223684210522</c:v>
                </c:pt>
                <c:pt idx="268">
                  <c:v>0.8336896929824561</c:v>
                </c:pt>
                <c:pt idx="269">
                  <c:v>0.83141447368421062</c:v>
                </c:pt>
                <c:pt idx="270">
                  <c:v>0.8299067982456142</c:v>
                </c:pt>
                <c:pt idx="271">
                  <c:v>0.82894736842105265</c:v>
                </c:pt>
                <c:pt idx="272">
                  <c:v>0.82743969298245623</c:v>
                </c:pt>
                <c:pt idx="273">
                  <c:v>0.82902960526315794</c:v>
                </c:pt>
                <c:pt idx="274">
                  <c:v>0.83097587719298238</c:v>
                </c:pt>
                <c:pt idx="275">
                  <c:v>0.83155153508771928</c:v>
                </c:pt>
                <c:pt idx="276">
                  <c:v>0.83495065789473688</c:v>
                </c:pt>
                <c:pt idx="277">
                  <c:v>0.83610197368421046</c:v>
                </c:pt>
                <c:pt idx="278">
                  <c:v>0.83371436403508759</c:v>
                </c:pt>
                <c:pt idx="279">
                  <c:v>0.82952028508771924</c:v>
                </c:pt>
                <c:pt idx="280">
                  <c:v>0.82453125000000005</c:v>
                </c:pt>
                <c:pt idx="281">
                  <c:v>0.82598684210526319</c:v>
                </c:pt>
                <c:pt idx="282">
                  <c:v>0.82787828947368425</c:v>
                </c:pt>
                <c:pt idx="283">
                  <c:v>0.82998903508771926</c:v>
                </c:pt>
                <c:pt idx="284">
                  <c:v>0.83072916666666663</c:v>
                </c:pt>
                <c:pt idx="285">
                  <c:v>0.82660910087719286</c:v>
                </c:pt>
                <c:pt idx="286">
                  <c:v>0.82633497807017553</c:v>
                </c:pt>
                <c:pt idx="287">
                  <c:v>0.82622532894736844</c:v>
                </c:pt>
                <c:pt idx="288">
                  <c:v>0.82782346491228076</c:v>
                </c:pt>
                <c:pt idx="289">
                  <c:v>0.82505208333333335</c:v>
                </c:pt>
                <c:pt idx="290">
                  <c:v>0.82357182017543862</c:v>
                </c:pt>
                <c:pt idx="291">
                  <c:v>0.82398300438596495</c:v>
                </c:pt>
                <c:pt idx="292">
                  <c:v>0.82593201754385959</c:v>
                </c:pt>
                <c:pt idx="293">
                  <c:v>0.82998903508771926</c:v>
                </c:pt>
                <c:pt idx="294">
                  <c:v>0.82881030701754377</c:v>
                </c:pt>
                <c:pt idx="295">
                  <c:v>0.83119517543859656</c:v>
                </c:pt>
                <c:pt idx="296">
                  <c:v>0.83223684210526316</c:v>
                </c:pt>
                <c:pt idx="297">
                  <c:v>0.83574561403508774</c:v>
                </c:pt>
                <c:pt idx="298">
                  <c:v>0.8342379385964912</c:v>
                </c:pt>
                <c:pt idx="299">
                  <c:v>0.83251096491228072</c:v>
                </c:pt>
                <c:pt idx="300">
                  <c:v>0.83141447368421051</c:v>
                </c:pt>
                <c:pt idx="301">
                  <c:v>0.83582785087719291</c:v>
                </c:pt>
                <c:pt idx="302">
                  <c:v>0.83678728070175445</c:v>
                </c:pt>
                <c:pt idx="303">
                  <c:v>0.84013157894736834</c:v>
                </c:pt>
                <c:pt idx="304">
                  <c:v>0.83645833333333341</c:v>
                </c:pt>
                <c:pt idx="305">
                  <c:v>0.84057017543859658</c:v>
                </c:pt>
                <c:pt idx="306">
                  <c:v>0.84166666666666667</c:v>
                </c:pt>
                <c:pt idx="307">
                  <c:v>0.84355811403508785</c:v>
                </c:pt>
                <c:pt idx="308">
                  <c:v>0.84298245614035094</c:v>
                </c:pt>
                <c:pt idx="309">
                  <c:v>0.84533991228070171</c:v>
                </c:pt>
                <c:pt idx="310">
                  <c:v>0.84813596491228072</c:v>
                </c:pt>
                <c:pt idx="311">
                  <c:v>0.84459978070175445</c:v>
                </c:pt>
                <c:pt idx="312">
                  <c:v>0.84577850877192995</c:v>
                </c:pt>
                <c:pt idx="313">
                  <c:v>0.84665570175438598</c:v>
                </c:pt>
                <c:pt idx="314">
                  <c:v>0.85041118421052631</c:v>
                </c:pt>
                <c:pt idx="315">
                  <c:v>0.84931469298245632</c:v>
                </c:pt>
                <c:pt idx="316">
                  <c:v>0.84969846491228074</c:v>
                </c:pt>
                <c:pt idx="317">
                  <c:v>0.85109649122807018</c:v>
                </c:pt>
                <c:pt idx="318">
                  <c:v>0.85071271929824555</c:v>
                </c:pt>
                <c:pt idx="319">
                  <c:v>0.85252192982456132</c:v>
                </c:pt>
                <c:pt idx="320">
                  <c:v>0.85131578947368425</c:v>
                </c:pt>
                <c:pt idx="321">
                  <c:v>0.85411184210526325</c:v>
                </c:pt>
                <c:pt idx="322">
                  <c:v>0.85290570175438596</c:v>
                </c:pt>
                <c:pt idx="323">
                  <c:v>0.85660635964912279</c:v>
                </c:pt>
                <c:pt idx="324">
                  <c:v>0.85751096491228074</c:v>
                </c:pt>
                <c:pt idx="325">
                  <c:v>0.86450109649122808</c:v>
                </c:pt>
                <c:pt idx="326">
                  <c:v>0.86968201754385965</c:v>
                </c:pt>
                <c:pt idx="327">
                  <c:v>0.87343749999999998</c:v>
                </c:pt>
                <c:pt idx="328">
                  <c:v>0.87626096491228067</c:v>
                </c:pt>
                <c:pt idx="329">
                  <c:v>0.87469846491228065</c:v>
                </c:pt>
                <c:pt idx="330">
                  <c:v>0.87741228070175437</c:v>
                </c:pt>
                <c:pt idx="331">
                  <c:v>0.87716557017543861</c:v>
                </c:pt>
                <c:pt idx="332">
                  <c:v>0.87738486842105268</c:v>
                </c:pt>
                <c:pt idx="333">
                  <c:v>0.87563048245614039</c:v>
                </c:pt>
                <c:pt idx="334">
                  <c:v>0.87299890350877185</c:v>
                </c:pt>
                <c:pt idx="335">
                  <c:v>0.87423245614035094</c:v>
                </c:pt>
                <c:pt idx="336">
                  <c:v>0.87425986842105263</c:v>
                </c:pt>
                <c:pt idx="337">
                  <c:v>0.87439692982456141</c:v>
                </c:pt>
                <c:pt idx="338">
                  <c:v>0.87190241228070187</c:v>
                </c:pt>
                <c:pt idx="339">
                  <c:v>0.87132675438596474</c:v>
                </c:pt>
                <c:pt idx="340">
                  <c:v>0.87508223684210529</c:v>
                </c:pt>
                <c:pt idx="341">
                  <c:v>0.88141447368421055</c:v>
                </c:pt>
                <c:pt idx="342">
                  <c:v>0.8845120614035088</c:v>
                </c:pt>
                <c:pt idx="343">
                  <c:v>0.885608552631579</c:v>
                </c:pt>
                <c:pt idx="344">
                  <c:v>0.88366228070175445</c:v>
                </c:pt>
                <c:pt idx="345">
                  <c:v>0.88308662280701755</c:v>
                </c:pt>
                <c:pt idx="346">
                  <c:v>0.88086622807017545</c:v>
                </c:pt>
                <c:pt idx="347">
                  <c:v>0.88385416666666661</c:v>
                </c:pt>
                <c:pt idx="348">
                  <c:v>0.88963815789473688</c:v>
                </c:pt>
                <c:pt idx="349">
                  <c:v>0.88821271929824563</c:v>
                </c:pt>
                <c:pt idx="350">
                  <c:v>0.89147478070175445</c:v>
                </c:pt>
                <c:pt idx="351">
                  <c:v>0.89185855263157887</c:v>
                </c:pt>
                <c:pt idx="352">
                  <c:v>0.90241228070175439</c:v>
                </c:pt>
                <c:pt idx="353">
                  <c:v>0.90466008771929829</c:v>
                </c:pt>
                <c:pt idx="354">
                  <c:v>0.90356359649122808</c:v>
                </c:pt>
                <c:pt idx="355">
                  <c:v>0.90391995614035092</c:v>
                </c:pt>
                <c:pt idx="356">
                  <c:v>0.9067982456140351</c:v>
                </c:pt>
                <c:pt idx="357">
                  <c:v>0.91313048245614026</c:v>
                </c:pt>
                <c:pt idx="358">
                  <c:v>0.91480263157894726</c:v>
                </c:pt>
                <c:pt idx="359">
                  <c:v>0.91165021929824563</c:v>
                </c:pt>
                <c:pt idx="360">
                  <c:v>0.91038925438596496</c:v>
                </c:pt>
                <c:pt idx="361">
                  <c:v>0.90989583333333324</c:v>
                </c:pt>
                <c:pt idx="362">
                  <c:v>0.91280153508771933</c:v>
                </c:pt>
                <c:pt idx="363">
                  <c:v>0.91167763157894743</c:v>
                </c:pt>
                <c:pt idx="364">
                  <c:v>0.91345942982456141</c:v>
                </c:pt>
                <c:pt idx="365">
                  <c:v>0.91167763157894732</c:v>
                </c:pt>
                <c:pt idx="366">
                  <c:v>0.91441885964912284</c:v>
                </c:pt>
                <c:pt idx="367">
                  <c:v>0.91159539473684204</c:v>
                </c:pt>
                <c:pt idx="368">
                  <c:v>0.91302083333333328</c:v>
                </c:pt>
                <c:pt idx="369">
                  <c:v>0.91408991228070169</c:v>
                </c:pt>
                <c:pt idx="370">
                  <c:v>0.91858552631578938</c:v>
                </c:pt>
                <c:pt idx="371">
                  <c:v>0.9219024122807018</c:v>
                </c:pt>
                <c:pt idx="372">
                  <c:v>0.92626096491228072</c:v>
                </c:pt>
                <c:pt idx="373">
                  <c:v>0.9302631578947369</c:v>
                </c:pt>
                <c:pt idx="374">
                  <c:v>0.9318804824561403</c:v>
                </c:pt>
                <c:pt idx="375">
                  <c:v>0.93009868421052622</c:v>
                </c:pt>
                <c:pt idx="376">
                  <c:v>0.9274671052631579</c:v>
                </c:pt>
                <c:pt idx="377">
                  <c:v>0.92491776315789476</c:v>
                </c:pt>
                <c:pt idx="378">
                  <c:v>0.92582236842105259</c:v>
                </c:pt>
                <c:pt idx="379">
                  <c:v>0.92362938596491218</c:v>
                </c:pt>
                <c:pt idx="380">
                  <c:v>0.92584978070175439</c:v>
                </c:pt>
                <c:pt idx="381">
                  <c:v>0.92231359649122802</c:v>
                </c:pt>
                <c:pt idx="382">
                  <c:v>0.924671052631579</c:v>
                </c:pt>
                <c:pt idx="383">
                  <c:v>0.92343750000000002</c:v>
                </c:pt>
                <c:pt idx="384">
                  <c:v>0.92280701754385974</c:v>
                </c:pt>
                <c:pt idx="385">
                  <c:v>0.91916118421052639</c:v>
                </c:pt>
                <c:pt idx="386">
                  <c:v>0.91833881578947363</c:v>
                </c:pt>
                <c:pt idx="387">
                  <c:v>0.91592653508771926</c:v>
                </c:pt>
                <c:pt idx="388">
                  <c:v>0.92086074561403519</c:v>
                </c:pt>
                <c:pt idx="389">
                  <c:v>0.92664473684210524</c:v>
                </c:pt>
                <c:pt idx="390">
                  <c:v>0.93292214912280702</c:v>
                </c:pt>
                <c:pt idx="391">
                  <c:v>0.93144188596491218</c:v>
                </c:pt>
                <c:pt idx="392">
                  <c:v>0.92645285087719298</c:v>
                </c:pt>
                <c:pt idx="393">
                  <c:v>0.92332785087719305</c:v>
                </c:pt>
                <c:pt idx="394">
                  <c:v>0.92406798245614041</c:v>
                </c:pt>
                <c:pt idx="395">
                  <c:v>0.9240953947368421</c:v>
                </c:pt>
                <c:pt idx="396">
                  <c:v>0.92478070175438598</c:v>
                </c:pt>
                <c:pt idx="397">
                  <c:v>0.92436951754385976</c:v>
                </c:pt>
                <c:pt idx="398">
                  <c:v>0.92765758663186892</c:v>
                </c:pt>
                <c:pt idx="399">
                  <c:v>0.930945655719878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49321304"/>
        <c:axId val="249321696"/>
      </c:scatterChart>
      <c:valAx>
        <c:axId val="249321304"/>
        <c:scaling>
          <c:orientation val="minMax"/>
          <c:max val="70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200" b="1" i="0" u="none" strike="noStrike" baseline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</a:defRPr>
            </a:pPr>
            <a:endParaRPr lang="en-US"/>
          </a:p>
        </c:txPr>
        <c:crossAx val="249321696"/>
        <c:crosses val="autoZero"/>
        <c:crossBetween val="midCat"/>
        <c:majorUnit val="200"/>
        <c:minorUnit val="40"/>
      </c:valAx>
      <c:valAx>
        <c:axId val="249321696"/>
        <c:scaling>
          <c:orientation val="minMax"/>
          <c:max val="1.1000000000000001"/>
          <c:min val="0.6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200" b="1" i="0" u="none" strike="noStrike" baseline="0">
                <a:solidFill>
                  <a:srgbClr val="000000"/>
                </a:solidFill>
                <a:latin typeface="Times New Roman"/>
                <a:ea typeface="Times New Roman"/>
                <a:cs typeface="Times New Roman"/>
              </a:defRPr>
            </a:pPr>
            <a:endParaRPr lang="en-US"/>
          </a:p>
        </c:txPr>
        <c:crossAx val="249321304"/>
        <c:crosses val="autoZero"/>
        <c:crossBetween val="midCat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>
      <a:noFill/>
    </a:ln>
  </c:spPr>
  <c:txPr>
    <a:bodyPr/>
    <a:lstStyle/>
    <a:p>
      <a:pPr>
        <a:defRPr sz="1200" b="1" i="0" u="none" strike="noStrike" baseline="0">
          <a:solidFill>
            <a:srgbClr val="000000"/>
          </a:solidFill>
          <a:latin typeface="Times New Roman"/>
          <a:ea typeface="Times New Roman"/>
          <a:cs typeface="Times New Roman"/>
        </a:defRPr>
      </a:pPr>
      <a:endParaRPr lang="en-US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1035</cdr:x>
      <cdr:y>0.10391</cdr:y>
    </cdr:to>
    <cdr:sp macro="" textlink="">
      <cdr:nvSpPr>
        <cdr:cNvPr id="2049" name="Text Box 1"/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-1" y="0"/>
          <a:ext cx="376508" cy="240066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1">
          <a:noFill/>
          <a:miter lim="800000"/>
          <a:headEnd/>
          <a:tailEnd/>
        </a:ln>
        <a:effectLst xmlns:a="http://schemas.openxmlformats.org/drawingml/2006/main"/>
      </cdr:spPr>
      <cdr:txBody>
        <a:bodyPr xmlns:a="http://schemas.openxmlformats.org/drawingml/2006/main" wrap="square" lIns="18288" tIns="27432" rIns="18288" bIns="27432" anchor="ctr" upright="1">
          <a:spAutoFit/>
        </a:bodyPr>
        <a:lstStyle xmlns:a="http://schemas.openxmlformats.org/drawingml/2006/main"/>
        <a:p xmlns:a="http://schemas.openxmlformats.org/drawingml/2006/main">
          <a:pPr algn="ctr" rtl="0">
            <a:defRPr sz="1000"/>
          </a:pPr>
          <a:r>
            <a:rPr lang="en-GB" sz="1200" b="1" i="0" u="none" strike="noStrike" baseline="0" dirty="0">
              <a:solidFill>
                <a:srgbClr val="000000"/>
              </a:solidFill>
              <a:latin typeface="Times New Roman"/>
              <a:cs typeface="Times New Roman"/>
            </a:rPr>
            <a:t>F/</a:t>
          </a:r>
          <a:r>
            <a:rPr lang="en-GB" sz="1200" b="1" i="0" u="none" strike="noStrike" baseline="0" dirty="0" err="1">
              <a:solidFill>
                <a:srgbClr val="000000"/>
              </a:solidFill>
              <a:latin typeface="Times New Roman"/>
              <a:cs typeface="Times New Roman"/>
            </a:rPr>
            <a:t>Fo</a:t>
          </a:r>
          <a:endParaRPr lang="en-GB" sz="1200" b="1" i="0" u="none" strike="noStrike" baseline="0" dirty="0">
            <a:solidFill>
              <a:srgbClr val="000000"/>
            </a:solidFill>
            <a:latin typeface="Times New Roman"/>
            <a:cs typeface="Times New Roman"/>
          </a:endParaRPr>
        </a:p>
      </cdr:txBody>
    </cdr:sp>
  </cdr:relSizeAnchor>
  <cdr:relSizeAnchor xmlns:cdr="http://schemas.openxmlformats.org/drawingml/2006/chartDrawing">
    <cdr:from>
      <cdr:x>0.72861</cdr:x>
      <cdr:y>0.86108</cdr:y>
    </cdr:from>
    <cdr:to>
      <cdr:x>0.91921</cdr:x>
      <cdr:y>0.96499</cdr:y>
    </cdr:to>
    <cdr:sp macro="" textlink="">
      <cdr:nvSpPr>
        <cdr:cNvPr id="2050" name="Text Box 2"/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2517885" y="2046153"/>
          <a:ext cx="658664" cy="246911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1">
          <a:noFill/>
          <a:miter lim="800000"/>
          <a:headEnd/>
          <a:tailEnd/>
        </a:ln>
        <a:effectLst xmlns:a="http://schemas.openxmlformats.org/drawingml/2006/main"/>
      </cdr:spPr>
      <cdr:txBody>
        <a:bodyPr xmlns:a="http://schemas.openxmlformats.org/drawingml/2006/main" wrap="square" lIns="18288" tIns="27432" rIns="18288" bIns="27432" anchor="ctr" upright="1">
          <a:spAutoFit/>
        </a:bodyPr>
        <a:lstStyle xmlns:a="http://schemas.openxmlformats.org/drawingml/2006/main"/>
        <a:p xmlns:a="http://schemas.openxmlformats.org/drawingml/2006/main">
          <a:pPr algn="ctr" rtl="0">
            <a:defRPr sz="1000"/>
          </a:pPr>
          <a:r>
            <a:rPr lang="en-GB" sz="1200" b="1" i="0" u="none" strike="noStrike" baseline="0" dirty="0">
              <a:solidFill>
                <a:srgbClr val="000000"/>
              </a:solidFill>
              <a:latin typeface="Times New Roman"/>
              <a:cs typeface="Times New Roman"/>
            </a:rPr>
            <a:t>Time, s</a:t>
          </a:r>
        </a:p>
      </cdr:txBody>
    </cdr:sp>
  </cdr:relSizeAnchor>
  <cdr:relSizeAnchor xmlns:cdr="http://schemas.openxmlformats.org/drawingml/2006/chartDrawing">
    <cdr:from>
      <cdr:x>0.64741</cdr:x>
      <cdr:y>0.07866</cdr:y>
    </cdr:from>
    <cdr:to>
      <cdr:x>0.94431</cdr:x>
      <cdr:y>0.07866</cdr:y>
    </cdr:to>
    <cdr:sp macro="" textlink="">
      <cdr:nvSpPr>
        <cdr:cNvPr id="2051" name="Line 3"/>
        <cdr:cNvSpPr>
          <a:spLocks xmlns:a="http://schemas.openxmlformats.org/drawingml/2006/main" noChangeShapeType="1"/>
        </cdr:cNvSpPr>
      </cdr:nvSpPr>
      <cdr:spPr bwMode="auto">
        <a:xfrm xmlns:a="http://schemas.openxmlformats.org/drawingml/2006/main" flipV="1">
          <a:off x="2355038" y="181742"/>
          <a:ext cx="1080000" cy="0"/>
        </a:xfrm>
        <a:prstGeom xmlns:a="http://schemas.openxmlformats.org/drawingml/2006/main" prst="line">
          <a:avLst/>
        </a:prstGeom>
        <a:noFill xmlns:a="http://schemas.openxmlformats.org/drawingml/2006/main"/>
        <a:ln xmlns:a="http://schemas.openxmlformats.org/drawingml/2006/main" w="25400">
          <a:solidFill>
            <a:srgbClr val="000000"/>
          </a:solidFill>
          <a:round/>
          <a:headEnd/>
          <a:tailEnd/>
        </a:ln>
      </cdr:spPr>
    </cdr:sp>
  </cdr:relSizeAnchor>
  <cdr:relSizeAnchor xmlns:cdr="http://schemas.openxmlformats.org/drawingml/2006/chartDrawing">
    <cdr:from>
      <cdr:x>0.12405</cdr:x>
      <cdr:y>0.1606</cdr:y>
    </cdr:from>
    <cdr:to>
      <cdr:x>0.23292</cdr:x>
      <cdr:y>0.1606</cdr:y>
    </cdr:to>
    <cdr:sp macro="" textlink="">
      <cdr:nvSpPr>
        <cdr:cNvPr id="2053" name="Line 5"/>
        <cdr:cNvSpPr>
          <a:spLocks xmlns:a="http://schemas.openxmlformats.org/drawingml/2006/main" noChangeShapeType="1"/>
        </cdr:cNvSpPr>
      </cdr:nvSpPr>
      <cdr:spPr bwMode="auto">
        <a:xfrm xmlns:a="http://schemas.openxmlformats.org/drawingml/2006/main" flipV="1">
          <a:off x="451261" y="371048"/>
          <a:ext cx="396000" cy="0"/>
        </a:xfrm>
        <a:prstGeom xmlns:a="http://schemas.openxmlformats.org/drawingml/2006/main" prst="line">
          <a:avLst/>
        </a:prstGeom>
        <a:noFill xmlns:a="http://schemas.openxmlformats.org/drawingml/2006/main"/>
        <a:ln xmlns:a="http://schemas.openxmlformats.org/drawingml/2006/main" w="25400">
          <a:solidFill>
            <a:srgbClr val="000000"/>
          </a:solidFill>
          <a:round/>
          <a:headEnd/>
          <a:tailEnd/>
        </a:ln>
      </cdr:spPr>
    </cdr:sp>
  </cdr:relSizeAnchor>
  <cdr:relSizeAnchor xmlns:cdr="http://schemas.openxmlformats.org/drawingml/2006/chartDrawing">
    <cdr:from>
      <cdr:x>0.38777</cdr:x>
      <cdr:y>0.1606</cdr:y>
    </cdr:from>
    <cdr:to>
      <cdr:x>0.47219</cdr:x>
      <cdr:y>0.1606</cdr:y>
    </cdr:to>
    <cdr:sp macro="" textlink="">
      <cdr:nvSpPr>
        <cdr:cNvPr id="2054" name="Line 6"/>
        <cdr:cNvSpPr>
          <a:spLocks xmlns:a="http://schemas.openxmlformats.org/drawingml/2006/main" noChangeShapeType="1"/>
        </cdr:cNvSpPr>
      </cdr:nvSpPr>
      <cdr:spPr bwMode="auto">
        <a:xfrm xmlns:a="http://schemas.openxmlformats.org/drawingml/2006/main" flipV="1">
          <a:off x="1484784" y="390576"/>
          <a:ext cx="323268" cy="0"/>
        </a:xfrm>
        <a:prstGeom xmlns:a="http://schemas.openxmlformats.org/drawingml/2006/main" prst="line">
          <a:avLst/>
        </a:prstGeom>
        <a:noFill xmlns:a="http://schemas.openxmlformats.org/drawingml/2006/main"/>
        <a:ln xmlns:a="http://schemas.openxmlformats.org/drawingml/2006/main" w="25400">
          <a:solidFill>
            <a:srgbClr val="000000"/>
          </a:solidFill>
          <a:round/>
          <a:headEnd/>
          <a:tailEnd/>
        </a:ln>
      </cdr:spPr>
    </cdr:sp>
  </cdr:relSizeAnchor>
  <cdr:relSizeAnchor xmlns:cdr="http://schemas.openxmlformats.org/drawingml/2006/chartDrawing">
    <cdr:from>
      <cdr:x>0.73407</cdr:x>
      <cdr:y>0.1606</cdr:y>
    </cdr:from>
    <cdr:to>
      <cdr:x>0.9419</cdr:x>
      <cdr:y>0.1606</cdr:y>
    </cdr:to>
    <cdr:sp macro="" textlink="">
      <cdr:nvSpPr>
        <cdr:cNvPr id="2055" name="Line 7"/>
        <cdr:cNvSpPr>
          <a:spLocks xmlns:a="http://schemas.openxmlformats.org/drawingml/2006/main" noChangeShapeType="1"/>
        </cdr:cNvSpPr>
      </cdr:nvSpPr>
      <cdr:spPr bwMode="auto">
        <a:xfrm xmlns:a="http://schemas.openxmlformats.org/drawingml/2006/main" flipV="1">
          <a:off x="2670269" y="371048"/>
          <a:ext cx="756000" cy="0"/>
        </a:xfrm>
        <a:prstGeom xmlns:a="http://schemas.openxmlformats.org/drawingml/2006/main" prst="line">
          <a:avLst/>
        </a:prstGeom>
        <a:noFill xmlns:a="http://schemas.openxmlformats.org/drawingml/2006/main"/>
        <a:ln xmlns:a="http://schemas.openxmlformats.org/drawingml/2006/main" w="25400">
          <a:solidFill>
            <a:srgbClr val="000000"/>
          </a:solidFill>
          <a:round/>
          <a:headEnd/>
          <a:tailEnd/>
        </a:ln>
      </cdr:spPr>
    </cdr:sp>
  </cdr:relSizeAnchor>
  <cdr:relSizeAnchor xmlns:cdr="http://schemas.openxmlformats.org/drawingml/2006/chartDrawing">
    <cdr:from>
      <cdr:x>0.81702</cdr:x>
      <cdr:y>0.23578</cdr:y>
    </cdr:from>
    <cdr:to>
      <cdr:x>0.93319</cdr:x>
      <cdr:y>0.23578</cdr:y>
    </cdr:to>
    <cdr:sp macro="" textlink="">
      <cdr:nvSpPr>
        <cdr:cNvPr id="2056" name="Line 8"/>
        <cdr:cNvSpPr>
          <a:spLocks xmlns:a="http://schemas.openxmlformats.org/drawingml/2006/main" noChangeShapeType="1"/>
        </cdr:cNvSpPr>
      </cdr:nvSpPr>
      <cdr:spPr bwMode="auto">
        <a:xfrm xmlns:a="http://schemas.openxmlformats.org/drawingml/2006/main">
          <a:off x="5030394" y="840856"/>
          <a:ext cx="714832" cy="0"/>
        </a:xfrm>
        <a:prstGeom xmlns:a="http://schemas.openxmlformats.org/drawingml/2006/main" prst="line">
          <a:avLst/>
        </a:prstGeom>
        <a:noFill xmlns:a="http://schemas.openxmlformats.org/drawingml/2006/main"/>
        <a:ln xmlns:a="http://schemas.openxmlformats.org/drawingml/2006/main" w="25400">
          <a:solidFill>
            <a:srgbClr val="000000"/>
          </a:solidFill>
          <a:round/>
          <a:headEnd/>
          <a:tailEnd/>
        </a:ln>
      </cdr:spPr>
    </cdr:sp>
  </cdr:relSizeAnchor>
  <cdr:relSizeAnchor xmlns:cdr="http://schemas.openxmlformats.org/drawingml/2006/chartDrawing">
    <cdr:from>
      <cdr:x>0.65672</cdr:x>
      <cdr:y>4.11186E-7</cdr:y>
    </cdr:from>
    <cdr:to>
      <cdr:x>0.85791</cdr:x>
      <cdr:y>0.08883</cdr:y>
    </cdr:to>
    <cdr:sp macro="" textlink="">
      <cdr:nvSpPr>
        <cdr:cNvPr id="2057" name="Text Box 9"/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2514631" y="1"/>
          <a:ext cx="770354" cy="216023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1">
          <a:noFill/>
          <a:miter lim="800000"/>
          <a:headEnd/>
          <a:tailEnd/>
        </a:ln>
        <a:effectLst xmlns:a="http://schemas.openxmlformats.org/drawingml/2006/main"/>
      </cdr:spPr>
      <cdr:txBody>
        <a:bodyPr xmlns:a="http://schemas.openxmlformats.org/drawingml/2006/main" vertOverflow="clip" wrap="square" lIns="27432" tIns="27432" rIns="27432" bIns="27432" anchor="ctr" upright="1"/>
        <a:lstStyle xmlns:a="http://schemas.openxmlformats.org/drawingml/2006/main"/>
        <a:p xmlns:a="http://schemas.openxmlformats.org/drawingml/2006/main">
          <a:pPr algn="ctr" rtl="0">
            <a:defRPr sz="1000"/>
          </a:pPr>
          <a:r>
            <a:rPr lang="en-GB" sz="1200" b="1" dirty="0" err="1">
              <a:solidFill>
                <a:srgbClr val="000000"/>
              </a:solidFill>
              <a:latin typeface="Times New Roman"/>
              <a:cs typeface="Times New Roman"/>
            </a:rPr>
            <a:t>a</a:t>
          </a:r>
          <a:r>
            <a:rPr lang="en-GB" sz="1200" b="1" i="0" u="none" strike="noStrike" baseline="0" dirty="0" err="1" smtClean="0">
              <a:solidFill>
                <a:srgbClr val="000000"/>
              </a:solidFill>
              <a:latin typeface="Times New Roman"/>
              <a:cs typeface="Times New Roman"/>
            </a:rPr>
            <a:t>b</a:t>
          </a:r>
          <a:r>
            <a:rPr lang="en-GB" sz="1200" b="1" i="0" u="none" strike="noStrike" baseline="0" dirty="0" smtClean="0">
              <a:solidFill>
                <a:srgbClr val="000000"/>
              </a:solidFill>
              <a:latin typeface="Times New Roman"/>
              <a:cs typeface="Times New Roman"/>
            </a:rPr>
            <a:t> </a:t>
          </a:r>
          <a:r>
            <a:rPr lang="en-GB" sz="1200" b="1" i="0" u="none" strike="noStrike" baseline="0" dirty="0" err="1" smtClean="0">
              <a:solidFill>
                <a:srgbClr val="000000"/>
              </a:solidFill>
              <a:latin typeface="Times New Roman"/>
              <a:cs typeface="Times New Roman"/>
            </a:rPr>
            <a:t>RyR</a:t>
          </a:r>
          <a:r>
            <a:rPr lang="en-GB" sz="1200" b="1" i="0" u="none" strike="noStrike" baseline="0" dirty="0" smtClean="0">
              <a:solidFill>
                <a:srgbClr val="000000"/>
              </a:solidFill>
              <a:latin typeface="Times New Roman"/>
              <a:cs typeface="Times New Roman"/>
            </a:rPr>
            <a:t> </a:t>
          </a:r>
          <a:r>
            <a:rPr lang="en-GB" sz="1200" b="1" i="0" u="none" strike="noStrike" baseline="0" dirty="0">
              <a:solidFill>
                <a:schemeClr val="tx1"/>
              </a:solidFill>
              <a:latin typeface="Times New Roman"/>
              <a:cs typeface="Times New Roman"/>
            </a:rPr>
            <a:t>1</a:t>
          </a:r>
          <a:r>
            <a:rPr lang="en-GB" sz="1200" b="1" i="0" u="none" strike="noStrike" baseline="0" dirty="0">
              <a:solidFill>
                <a:srgbClr val="000000"/>
              </a:solidFill>
              <a:latin typeface="Times New Roman"/>
              <a:cs typeface="Times New Roman"/>
            </a:rPr>
            <a:t> </a:t>
          </a:r>
        </a:p>
      </cdr:txBody>
    </cdr:sp>
  </cdr:relSizeAnchor>
  <cdr:relSizeAnchor xmlns:cdr="http://schemas.openxmlformats.org/drawingml/2006/chartDrawing">
    <cdr:from>
      <cdr:x>0.10826</cdr:x>
      <cdr:y>0.05116</cdr:y>
    </cdr:from>
    <cdr:to>
      <cdr:x>0.28991</cdr:x>
      <cdr:y>0.16054</cdr:y>
    </cdr:to>
    <cdr:sp macro="" textlink="">
      <cdr:nvSpPr>
        <cdr:cNvPr id="2058" name="Text Box 10"/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374109" y="112296"/>
          <a:ext cx="627754" cy="240066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1">
          <a:noFill/>
          <a:miter lim="800000"/>
          <a:headEnd/>
          <a:tailEnd/>
        </a:ln>
        <a:effectLst xmlns:a="http://schemas.openxmlformats.org/drawingml/2006/main"/>
      </cdr:spPr>
      <cdr:txBody>
        <a:bodyPr xmlns:a="http://schemas.openxmlformats.org/drawingml/2006/main" wrap="square" lIns="18288" tIns="27432" rIns="18288" bIns="27432" anchor="ctr" upright="1">
          <a:spAutoFit/>
        </a:bodyPr>
        <a:lstStyle xmlns:a="http://schemas.openxmlformats.org/drawingml/2006/main"/>
        <a:p xmlns:a="http://schemas.openxmlformats.org/drawingml/2006/main">
          <a:pPr algn="ctr" rtl="0">
            <a:defRPr sz="1000"/>
          </a:pPr>
          <a:r>
            <a:rPr lang="en-GB" sz="1200" b="1" i="0" u="none" strike="noStrike" baseline="0" dirty="0">
              <a:solidFill>
                <a:srgbClr val="000000"/>
              </a:solidFill>
              <a:latin typeface="Times New Roman"/>
              <a:cs typeface="Times New Roman"/>
            </a:rPr>
            <a:t>NAADP</a:t>
          </a:r>
        </a:p>
      </cdr:txBody>
    </cdr:sp>
  </cdr:relSizeAnchor>
  <cdr:relSizeAnchor xmlns:cdr="http://schemas.openxmlformats.org/drawingml/2006/chartDrawing">
    <cdr:from>
      <cdr:x>0.38028</cdr:x>
      <cdr:y>0.05722</cdr:y>
    </cdr:from>
    <cdr:to>
      <cdr:x>0.54674</cdr:x>
      <cdr:y>0.16112</cdr:y>
    </cdr:to>
    <cdr:sp macro="" textlink="">
      <cdr:nvSpPr>
        <cdr:cNvPr id="2059" name="Text Box 11"/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1383321" y="132191"/>
          <a:ext cx="605517" cy="240066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1">
          <a:noFill/>
          <a:miter lim="800000"/>
          <a:headEnd/>
          <a:tailEnd/>
        </a:ln>
        <a:effectLst xmlns:a="http://schemas.openxmlformats.org/drawingml/2006/main"/>
      </cdr:spPr>
      <cdr:txBody>
        <a:bodyPr xmlns:a="http://schemas.openxmlformats.org/drawingml/2006/main" wrap="square" lIns="18288" tIns="27432" rIns="18288" bIns="27432" anchor="ctr" upright="1">
          <a:spAutoFit/>
        </a:bodyPr>
        <a:lstStyle xmlns:a="http://schemas.openxmlformats.org/drawingml/2006/main"/>
        <a:p xmlns:a="http://schemas.openxmlformats.org/drawingml/2006/main">
          <a:pPr algn="ctr" rtl="0">
            <a:defRPr sz="1000"/>
          </a:pPr>
          <a:r>
            <a:rPr lang="en-GB" sz="1200" b="1" i="0" u="none" strike="noStrike" baseline="0" dirty="0">
              <a:solidFill>
                <a:srgbClr val="000000"/>
              </a:solidFill>
              <a:latin typeface="Times New Roman"/>
              <a:cs typeface="Times New Roman"/>
            </a:rPr>
            <a:t>NAADP</a:t>
          </a:r>
        </a:p>
      </cdr:txBody>
    </cdr:sp>
  </cdr:relSizeAnchor>
  <cdr:relSizeAnchor xmlns:cdr="http://schemas.openxmlformats.org/drawingml/2006/chartDrawing">
    <cdr:from>
      <cdr:x>0.7249</cdr:x>
      <cdr:y>0.06233</cdr:y>
    </cdr:from>
    <cdr:to>
      <cdr:x>0.91296</cdr:x>
      <cdr:y>0.16624</cdr:y>
    </cdr:to>
    <cdr:sp macro="" textlink="">
      <cdr:nvSpPr>
        <cdr:cNvPr id="2060" name="Text Box 12"/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2636911" y="144016"/>
          <a:ext cx="684076" cy="240066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1">
          <a:noFill/>
          <a:miter lim="800000"/>
          <a:headEnd/>
          <a:tailEnd/>
        </a:ln>
        <a:effectLst xmlns:a="http://schemas.openxmlformats.org/drawingml/2006/main"/>
      </cdr:spPr>
      <cdr:txBody>
        <a:bodyPr xmlns:a="http://schemas.openxmlformats.org/drawingml/2006/main" wrap="square" lIns="18288" tIns="27432" rIns="18288" bIns="27432" anchor="ctr" upright="1">
          <a:spAutoFit/>
        </a:bodyPr>
        <a:lstStyle xmlns:a="http://schemas.openxmlformats.org/drawingml/2006/main"/>
        <a:p xmlns:a="http://schemas.openxmlformats.org/drawingml/2006/main">
          <a:pPr algn="ctr" rtl="0">
            <a:defRPr sz="1000"/>
          </a:pPr>
          <a:r>
            <a:rPr lang="en-GB" sz="1200" b="1" i="0" u="none" strike="noStrike" baseline="0" dirty="0">
              <a:solidFill>
                <a:srgbClr val="000000"/>
              </a:solidFill>
              <a:latin typeface="Times New Roman"/>
              <a:cs typeface="Times New Roman"/>
            </a:rPr>
            <a:t>NAADP</a:t>
          </a:r>
        </a:p>
      </cdr:txBody>
    </cdr:sp>
  </cdr:relSizeAnchor>
  <cdr:relSizeAnchor xmlns:cdr="http://schemas.openxmlformats.org/drawingml/2006/chartDrawing">
    <cdr:from>
      <cdr:x>0.64423</cdr:x>
      <cdr:y>0.13116</cdr:y>
    </cdr:from>
    <cdr:to>
      <cdr:x>0.68435</cdr:x>
      <cdr:y>0.84451</cdr:y>
    </cdr:to>
    <cdr:sp macro="" textlink="">
      <cdr:nvSpPr>
        <cdr:cNvPr id="2061" name="Rectangle 13"/>
        <cdr:cNvSpPr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3967232" y="469167"/>
          <a:ext cx="246860" cy="2534402"/>
        </a:xfrm>
        <a:prstGeom xmlns:a="http://schemas.openxmlformats.org/drawingml/2006/main" prst="rect">
          <a:avLst/>
        </a:prstGeom>
        <a:solidFill xmlns:a="http://schemas.openxmlformats.org/drawingml/2006/main">
          <a:srgbClr val="FFFFFF"/>
        </a:solidFill>
        <a:ln xmlns:a="http://schemas.openxmlformats.org/drawingml/2006/main" w="9525">
          <a:noFill/>
          <a:miter lim="800000"/>
          <a:headEnd/>
          <a:tailEnd/>
        </a:ln>
      </cdr:spPr>
    </cdr:sp>
  </cdr:relSizeAnchor>
  <cdr:relSizeAnchor xmlns:cdr="http://schemas.openxmlformats.org/drawingml/2006/chartDrawing">
    <cdr:from>
      <cdr:x>0.25575</cdr:x>
      <cdr:y>0.80166</cdr:y>
    </cdr:from>
    <cdr:to>
      <cdr:x>0.37913</cdr:x>
      <cdr:y>0.91399</cdr:y>
    </cdr:to>
    <cdr:sp macro="" textlink="">
      <cdr:nvSpPr>
        <cdr:cNvPr id="2064" name="Text Box 16"/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883801" y="1904949"/>
          <a:ext cx="426368" cy="266935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1">
          <a:noFill/>
          <a:miter lim="800000"/>
          <a:headEnd/>
          <a:tailEnd/>
        </a:ln>
        <a:effectLst xmlns:a="http://schemas.openxmlformats.org/drawingml/2006/main"/>
      </cdr:spPr>
      <cdr:txBody>
        <a:bodyPr xmlns:a="http://schemas.openxmlformats.org/drawingml/2006/main" vertOverflow="clip" wrap="square" lIns="27432" tIns="27432" rIns="27432" bIns="27432" anchor="ctr" upright="1"/>
        <a:lstStyle xmlns:a="http://schemas.openxmlformats.org/drawingml/2006/main"/>
        <a:p xmlns:a="http://schemas.openxmlformats.org/drawingml/2006/main">
          <a:pPr algn="ctr" rtl="0">
            <a:defRPr sz="1000"/>
          </a:pPr>
          <a:r>
            <a:rPr lang="en-GB" sz="1200" b="1" i="0" u="none" strike="noStrike" baseline="0" dirty="0" smtClean="0">
              <a:solidFill>
                <a:srgbClr val="000000"/>
              </a:solidFill>
              <a:latin typeface="Times New Roman"/>
              <a:cs typeface="Times New Roman"/>
            </a:rPr>
            <a:t>500</a:t>
          </a:r>
          <a:endParaRPr lang="en-GB" sz="1200" b="1" i="0" u="none" strike="noStrike" baseline="0" dirty="0">
            <a:solidFill>
              <a:srgbClr val="000000"/>
            </a:solidFill>
            <a:latin typeface="Times New Roman"/>
            <a:cs typeface="Times New Roman"/>
          </a:endParaRPr>
        </a:p>
      </cdr:txBody>
    </cdr:sp>
  </cdr:relSizeAnchor>
  <cdr:relSizeAnchor xmlns:cdr="http://schemas.openxmlformats.org/drawingml/2006/chartDrawing">
    <cdr:from>
      <cdr:x>0.45706</cdr:x>
      <cdr:y>0.80313</cdr:y>
    </cdr:from>
    <cdr:to>
      <cdr:x>0.57944</cdr:x>
      <cdr:y>0.9125</cdr:y>
    </cdr:to>
    <cdr:sp macro="" textlink="">
      <cdr:nvSpPr>
        <cdr:cNvPr id="2066" name="Text Box 18"/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1579471" y="1908443"/>
          <a:ext cx="422916" cy="259906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1">
          <a:noFill/>
          <a:miter lim="800000"/>
          <a:headEnd/>
          <a:tailEnd/>
        </a:ln>
        <a:effectLst xmlns:a="http://schemas.openxmlformats.org/drawingml/2006/main"/>
      </cdr:spPr>
      <cdr:txBody>
        <a:bodyPr xmlns:a="http://schemas.openxmlformats.org/drawingml/2006/main" wrap="square" lIns="18288" tIns="27432" rIns="18288" bIns="27432" anchor="ctr" upright="1">
          <a:spAutoFit/>
        </a:bodyPr>
        <a:lstStyle xmlns:a="http://schemas.openxmlformats.org/drawingml/2006/main"/>
        <a:p xmlns:a="http://schemas.openxmlformats.org/drawingml/2006/main">
          <a:pPr algn="ctr" rtl="0">
            <a:defRPr sz="1000"/>
          </a:pPr>
          <a:r>
            <a:rPr lang="en-GB" sz="1200" b="1" i="0" u="none" strike="noStrike" baseline="0" dirty="0">
              <a:solidFill>
                <a:srgbClr val="000000"/>
              </a:solidFill>
              <a:latin typeface="Times New Roman"/>
              <a:cs typeface="Times New Roman"/>
            </a:rPr>
            <a:t>1000</a:t>
          </a:r>
        </a:p>
      </cdr:txBody>
    </cdr:sp>
  </cdr:relSizeAnchor>
  <cdr:relSizeAnchor xmlns:cdr="http://schemas.openxmlformats.org/drawingml/2006/chartDrawing">
    <cdr:from>
      <cdr:x>0.8691</cdr:x>
      <cdr:y>0.80411</cdr:y>
    </cdr:from>
    <cdr:to>
      <cdr:x>0.98435</cdr:x>
      <cdr:y>0.90802</cdr:y>
    </cdr:to>
    <cdr:sp macro="" textlink="">
      <cdr:nvSpPr>
        <cdr:cNvPr id="2071" name="Text Box 23"/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3003393" y="1910780"/>
          <a:ext cx="398284" cy="246911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1">
          <a:noFill/>
          <a:miter lim="800000"/>
          <a:headEnd/>
          <a:tailEnd/>
        </a:ln>
        <a:effectLst xmlns:a="http://schemas.openxmlformats.org/drawingml/2006/main"/>
      </cdr:spPr>
      <cdr:txBody>
        <a:bodyPr xmlns:a="http://schemas.openxmlformats.org/drawingml/2006/main" wrap="square" lIns="18288" tIns="27432" rIns="18288" bIns="27432" anchor="ctr" upright="1">
          <a:spAutoFit/>
        </a:bodyPr>
        <a:lstStyle xmlns:a="http://schemas.openxmlformats.org/drawingml/2006/main"/>
        <a:p xmlns:a="http://schemas.openxmlformats.org/drawingml/2006/main">
          <a:pPr algn="ctr" rtl="0">
            <a:defRPr sz="1000"/>
          </a:pPr>
          <a:r>
            <a:rPr lang="en-GB" sz="1200" b="1" i="0" u="none" strike="noStrike" baseline="0" dirty="0">
              <a:solidFill>
                <a:srgbClr val="000000"/>
              </a:solidFill>
              <a:latin typeface="Times New Roman"/>
              <a:cs typeface="Times New Roman"/>
            </a:rPr>
            <a:t>3200</a:t>
          </a:r>
        </a:p>
      </cdr:txBody>
    </cdr:sp>
  </cdr:relSizeAnchor>
  <cdr:relSizeAnchor xmlns:cdr="http://schemas.openxmlformats.org/drawingml/2006/chartDrawing">
    <cdr:from>
      <cdr:x>0.8209</cdr:x>
      <cdr:y>0.14012</cdr:y>
    </cdr:from>
    <cdr:to>
      <cdr:x>0.91735</cdr:x>
      <cdr:y>0.24402</cdr:y>
    </cdr:to>
    <cdr:sp macro="" textlink="">
      <cdr:nvSpPr>
        <cdr:cNvPr id="2072" name="Text Box 24"/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2986123" y="323722"/>
          <a:ext cx="350842" cy="240066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1">
          <a:noFill/>
          <a:miter lim="800000"/>
          <a:headEnd/>
          <a:tailEnd/>
        </a:ln>
        <a:effectLst xmlns:a="http://schemas.openxmlformats.org/drawingml/2006/main"/>
      </cdr:spPr>
      <cdr:txBody>
        <a:bodyPr xmlns:a="http://schemas.openxmlformats.org/drawingml/2006/main" wrap="square" lIns="18288" tIns="27432" rIns="18288" bIns="27432" anchor="ctr" upright="1">
          <a:spAutoFit/>
        </a:bodyPr>
        <a:lstStyle xmlns:a="http://schemas.openxmlformats.org/drawingml/2006/main"/>
        <a:p xmlns:a="http://schemas.openxmlformats.org/drawingml/2006/main">
          <a:pPr algn="ctr" rtl="0">
            <a:defRPr sz="1000"/>
          </a:pPr>
          <a:r>
            <a:rPr lang="en-GB" sz="1200" b="1" i="0" u="none" strike="noStrike" baseline="0" dirty="0">
              <a:solidFill>
                <a:srgbClr val="000000"/>
              </a:solidFill>
              <a:latin typeface="Times New Roman"/>
              <a:cs typeface="Times New Roman"/>
            </a:rPr>
            <a:t>IP</a:t>
          </a:r>
          <a:r>
            <a:rPr lang="en-GB" sz="1200" b="1" i="0" u="none" strike="noStrike" baseline="-25000" dirty="0">
              <a:solidFill>
                <a:srgbClr val="000000"/>
              </a:solidFill>
              <a:latin typeface="Times New Roman"/>
              <a:cs typeface="Times New Roman"/>
            </a:rPr>
            <a:t>3</a:t>
          </a:r>
        </a:p>
      </cdr:txBody>
    </cdr:sp>
  </cdr:relSizeAnchor>
  <cdr:relSizeAnchor xmlns:cdr="http://schemas.openxmlformats.org/drawingml/2006/chartDrawing">
    <cdr:from>
      <cdr:x>0.66973</cdr:x>
      <cdr:y>0.80611</cdr:y>
    </cdr:from>
    <cdr:to>
      <cdr:x>0.78257</cdr:x>
      <cdr:y>0.90483</cdr:y>
    </cdr:to>
    <cdr:sp macro="" textlink="">
      <cdr:nvSpPr>
        <cdr:cNvPr id="26" name="Text Box 18"/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2314422" y="1915539"/>
          <a:ext cx="389923" cy="234565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1">
          <a:noFill/>
          <a:miter lim="800000"/>
          <a:headEnd/>
          <a:tailEnd/>
        </a:ln>
        <a:effectLst xmlns:a="http://schemas.openxmlformats.org/drawingml/2006/main"/>
      </cdr:spPr>
      <cdr:txBody>
        <a:bodyPr xmlns:a="http://schemas.openxmlformats.org/drawingml/2006/main" wrap="square" lIns="18288" tIns="27432" rIns="18288" bIns="27432" anchor="ctr" upright="1">
          <a:spAutoFit/>
        </a:bodyPr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pPr algn="ctr" rtl="0">
            <a:defRPr sz="1000"/>
          </a:pPr>
          <a:r>
            <a:rPr lang="en-GB" sz="1200" b="1" i="0" u="none" strike="noStrike" baseline="0" dirty="0" smtClean="0">
              <a:solidFill>
                <a:srgbClr val="000000"/>
              </a:solidFill>
              <a:latin typeface="Times New Roman"/>
              <a:cs typeface="Times New Roman"/>
            </a:rPr>
            <a:t>2700</a:t>
          </a:r>
          <a:endParaRPr lang="en-GB" sz="1200" b="1" i="0" u="none" strike="noStrike" baseline="0" dirty="0">
            <a:solidFill>
              <a:srgbClr val="000000"/>
            </a:solidFill>
            <a:latin typeface="Times New Roman"/>
            <a:cs typeface="Times New Roman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23797</cdr:x>
      <cdr:y>0.182</cdr:y>
    </cdr:from>
    <cdr:to>
      <cdr:x>0.30096</cdr:x>
      <cdr:y>0.182</cdr:y>
    </cdr:to>
    <cdr:sp macro="" textlink="">
      <cdr:nvSpPr>
        <cdr:cNvPr id="2049" name="Line 1"/>
        <cdr:cNvSpPr>
          <a:spLocks xmlns:a="http://schemas.openxmlformats.org/drawingml/2006/main" noChangeShapeType="1"/>
        </cdr:cNvSpPr>
      </cdr:nvSpPr>
      <cdr:spPr bwMode="auto">
        <a:xfrm xmlns:a="http://schemas.openxmlformats.org/drawingml/2006/main">
          <a:off x="1087984" y="499261"/>
          <a:ext cx="288000" cy="0"/>
        </a:xfrm>
        <a:prstGeom xmlns:a="http://schemas.openxmlformats.org/drawingml/2006/main" prst="line">
          <a:avLst/>
        </a:prstGeom>
        <a:noFill xmlns:a="http://schemas.openxmlformats.org/drawingml/2006/main"/>
        <a:ln xmlns:a="http://schemas.openxmlformats.org/drawingml/2006/main" w="19050">
          <a:solidFill>
            <a:srgbClr val="000000"/>
          </a:solidFill>
          <a:round/>
          <a:headEnd/>
          <a:tailEnd/>
        </a:ln>
      </cdr:spPr>
      <cdr:txBody>
        <a:bodyPr xmlns:a="http://schemas.openxmlformats.org/drawingml/2006/main"/>
        <a:lstStyle xmlns:a="http://schemas.openxmlformats.org/drawingml/2006/main"/>
        <a:p xmlns:a="http://schemas.openxmlformats.org/drawingml/2006/main">
          <a:endParaRPr lang="en-GB"/>
        </a:p>
      </cdr:txBody>
    </cdr:sp>
  </cdr:relSizeAnchor>
  <cdr:relSizeAnchor xmlns:cdr="http://schemas.openxmlformats.org/drawingml/2006/chartDrawing">
    <cdr:from>
      <cdr:x>0.80625</cdr:x>
      <cdr:y>0.19444</cdr:y>
    </cdr:from>
    <cdr:to>
      <cdr:x>0.90074</cdr:x>
      <cdr:y>0.19444</cdr:y>
    </cdr:to>
    <cdr:sp macro="" textlink="">
      <cdr:nvSpPr>
        <cdr:cNvPr id="2050" name="Line 2"/>
        <cdr:cNvSpPr>
          <a:spLocks xmlns:a="http://schemas.openxmlformats.org/drawingml/2006/main" noChangeShapeType="1"/>
        </cdr:cNvSpPr>
      </cdr:nvSpPr>
      <cdr:spPr bwMode="auto">
        <a:xfrm xmlns:a="http://schemas.openxmlformats.org/drawingml/2006/main">
          <a:off x="3686175" y="533400"/>
          <a:ext cx="432000" cy="0"/>
        </a:xfrm>
        <a:prstGeom xmlns:a="http://schemas.openxmlformats.org/drawingml/2006/main" prst="line">
          <a:avLst/>
        </a:prstGeom>
        <a:noFill xmlns:a="http://schemas.openxmlformats.org/drawingml/2006/main"/>
        <a:ln xmlns:a="http://schemas.openxmlformats.org/drawingml/2006/main" w="19050">
          <a:solidFill>
            <a:srgbClr val="000000"/>
          </a:solidFill>
          <a:round/>
          <a:headEnd/>
          <a:tailEnd/>
        </a:ln>
      </cdr:spPr>
      <cdr:txBody>
        <a:bodyPr xmlns:a="http://schemas.openxmlformats.org/drawingml/2006/main"/>
        <a:lstStyle xmlns:a="http://schemas.openxmlformats.org/drawingml/2006/main"/>
        <a:p xmlns:a="http://schemas.openxmlformats.org/drawingml/2006/main">
          <a:endParaRPr lang="en-GB"/>
        </a:p>
      </cdr:txBody>
    </cdr:sp>
  </cdr:relSizeAnchor>
  <cdr:relSizeAnchor xmlns:cdr="http://schemas.openxmlformats.org/drawingml/2006/chartDrawing">
    <cdr:from>
      <cdr:x>0.60089</cdr:x>
      <cdr:y>0.12862</cdr:y>
    </cdr:from>
    <cdr:to>
      <cdr:x>0.9001</cdr:x>
      <cdr:y>0.12862</cdr:y>
    </cdr:to>
    <cdr:sp macro="" textlink="">
      <cdr:nvSpPr>
        <cdr:cNvPr id="2051" name="Line 3"/>
        <cdr:cNvSpPr>
          <a:spLocks xmlns:a="http://schemas.openxmlformats.org/drawingml/2006/main" noChangeShapeType="1"/>
        </cdr:cNvSpPr>
      </cdr:nvSpPr>
      <cdr:spPr bwMode="auto">
        <a:xfrm xmlns:a="http://schemas.openxmlformats.org/drawingml/2006/main" flipV="1">
          <a:off x="2017181" y="371356"/>
          <a:ext cx="1004445" cy="0"/>
        </a:xfrm>
        <a:prstGeom xmlns:a="http://schemas.openxmlformats.org/drawingml/2006/main" prst="line">
          <a:avLst/>
        </a:prstGeom>
        <a:noFill xmlns:a="http://schemas.openxmlformats.org/drawingml/2006/main"/>
        <a:ln xmlns:a="http://schemas.openxmlformats.org/drawingml/2006/main" w="19050">
          <a:solidFill>
            <a:srgbClr val="000000"/>
          </a:solidFill>
          <a:round/>
          <a:headEnd/>
          <a:tailEnd/>
        </a:ln>
      </cdr:spPr>
      <cdr:txBody>
        <a:bodyPr xmlns:a="http://schemas.openxmlformats.org/drawingml/2006/main"/>
        <a:lstStyle xmlns:a="http://schemas.openxmlformats.org/drawingml/2006/main"/>
        <a:p xmlns:a="http://schemas.openxmlformats.org/drawingml/2006/main">
          <a:endParaRPr lang="en-GB"/>
        </a:p>
      </cdr:txBody>
    </cdr:sp>
  </cdr:relSizeAnchor>
  <cdr:relSizeAnchor xmlns:cdr="http://schemas.openxmlformats.org/drawingml/2006/chartDrawing">
    <cdr:from>
      <cdr:x>0.56384</cdr:x>
      <cdr:y>0.05477</cdr:y>
    </cdr:from>
    <cdr:to>
      <cdr:x>0.90705</cdr:x>
      <cdr:y>0.14103</cdr:y>
    </cdr:to>
    <cdr:sp macro="" textlink="">
      <cdr:nvSpPr>
        <cdr:cNvPr id="2052" name="Text Box 4"/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1892821" y="158130"/>
          <a:ext cx="1152127" cy="249051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1">
          <a:noFill/>
          <a:miter lim="800000"/>
          <a:headEnd/>
          <a:tailEnd/>
        </a:ln>
        <a:effectLst xmlns:a="http://schemas.openxmlformats.org/drawingml/2006/main"/>
      </cdr:spPr>
      <cdr:txBody>
        <a:bodyPr xmlns:a="http://schemas.openxmlformats.org/drawingml/2006/main" wrap="square" lIns="18288" tIns="27432" rIns="18288" bIns="27432" anchor="ctr" upright="1">
          <a:noAutofit/>
        </a:bodyPr>
        <a:lstStyle xmlns:a="http://schemas.openxmlformats.org/drawingml/2006/main"/>
        <a:p xmlns:a="http://schemas.openxmlformats.org/drawingml/2006/main">
          <a:pPr algn="ctr" rtl="0">
            <a:defRPr sz="1000"/>
          </a:pPr>
          <a:r>
            <a:rPr lang="en-GB" sz="1200" b="1" i="0" u="none" strike="noStrike" baseline="0" dirty="0" err="1">
              <a:solidFill>
                <a:srgbClr val="000000"/>
              </a:solidFill>
              <a:latin typeface="Times New Roman"/>
              <a:cs typeface="Times New Roman"/>
            </a:rPr>
            <a:t>ab</a:t>
          </a:r>
          <a:r>
            <a:rPr lang="en-GB" sz="1200" b="1" i="0" u="none" strike="noStrike" baseline="0" dirty="0">
              <a:solidFill>
                <a:srgbClr val="000000"/>
              </a:solidFill>
              <a:latin typeface="Times New Roman"/>
              <a:cs typeface="Times New Roman"/>
            </a:rPr>
            <a:t> </a:t>
          </a:r>
          <a:r>
            <a:rPr lang="en-GB" sz="1200" b="1" i="0" u="none" strike="noStrike" baseline="0" dirty="0" err="1">
              <a:solidFill>
                <a:srgbClr val="000000"/>
              </a:solidFill>
              <a:latin typeface="Times New Roman"/>
              <a:cs typeface="Times New Roman"/>
            </a:rPr>
            <a:t>RyR</a:t>
          </a:r>
          <a:r>
            <a:rPr lang="en-GB" sz="1200" b="1" i="0" u="none" strike="noStrike" baseline="0" dirty="0">
              <a:solidFill>
                <a:srgbClr val="000000"/>
              </a:solidFill>
              <a:latin typeface="Times New Roman"/>
              <a:cs typeface="Times New Roman"/>
            </a:rPr>
            <a:t> </a:t>
          </a:r>
          <a:r>
            <a:rPr lang="en-GB" sz="1200" b="1" i="0" u="none" strike="noStrike" baseline="0" dirty="0" smtClean="0">
              <a:solidFill>
                <a:srgbClr val="000000"/>
              </a:solidFill>
              <a:latin typeface="Times New Roman"/>
              <a:cs typeface="Times New Roman"/>
            </a:rPr>
            <a:t>1+2+3</a:t>
          </a:r>
          <a:endParaRPr lang="en-GB" sz="1200" b="1" i="0" u="none" strike="noStrike" baseline="0" dirty="0">
            <a:solidFill>
              <a:srgbClr val="000000"/>
            </a:solidFill>
            <a:latin typeface="Times New Roman"/>
            <a:cs typeface="Times New Roman"/>
          </a:endParaRPr>
        </a:p>
      </cdr:txBody>
    </cdr:sp>
  </cdr:relSizeAnchor>
  <cdr:relSizeAnchor xmlns:cdr="http://schemas.openxmlformats.org/drawingml/2006/chartDrawing">
    <cdr:from>
      <cdr:x>0.17711</cdr:x>
      <cdr:y>0.10391</cdr:y>
    </cdr:from>
    <cdr:to>
      <cdr:x>0.34871</cdr:x>
      <cdr:y>0.18706</cdr:y>
    </cdr:to>
    <cdr:sp macro="" textlink="">
      <cdr:nvSpPr>
        <cdr:cNvPr id="2053" name="Text Box 5"/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594568" y="300025"/>
          <a:ext cx="576060" cy="240072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1">
          <a:noFill/>
          <a:miter lim="800000"/>
          <a:headEnd/>
          <a:tailEnd/>
        </a:ln>
        <a:effectLst xmlns:a="http://schemas.openxmlformats.org/drawingml/2006/main"/>
      </cdr:spPr>
      <cdr:txBody>
        <a:bodyPr xmlns:a="http://schemas.openxmlformats.org/drawingml/2006/main" wrap="square" lIns="18288" tIns="27432" rIns="18288" bIns="27432" anchor="ctr" upright="1">
          <a:spAutoFit/>
        </a:bodyPr>
        <a:lstStyle xmlns:a="http://schemas.openxmlformats.org/drawingml/2006/main"/>
        <a:p xmlns:a="http://schemas.openxmlformats.org/drawingml/2006/main">
          <a:pPr algn="ctr" rtl="0">
            <a:defRPr sz="1000"/>
          </a:pPr>
          <a:r>
            <a:rPr lang="en-GB" sz="1200" b="1" i="0" u="none" strike="noStrike" baseline="0" dirty="0" err="1">
              <a:solidFill>
                <a:srgbClr val="000000"/>
              </a:solidFill>
              <a:latin typeface="Times New Roman"/>
              <a:cs typeface="Times New Roman"/>
            </a:rPr>
            <a:t>cADPR</a:t>
          </a:r>
          <a:endParaRPr lang="en-GB" sz="1200" b="1" i="0" u="none" strike="noStrike" baseline="0" dirty="0">
            <a:solidFill>
              <a:srgbClr val="000000"/>
            </a:solidFill>
            <a:latin typeface="Times New Roman"/>
            <a:cs typeface="Times New Roman"/>
          </a:endParaRPr>
        </a:p>
      </cdr:txBody>
    </cdr:sp>
  </cdr:relSizeAnchor>
  <cdr:relSizeAnchor xmlns:cdr="http://schemas.openxmlformats.org/drawingml/2006/chartDrawing">
    <cdr:from>
      <cdr:x>0.79583</cdr:x>
      <cdr:y>0.11806</cdr:y>
    </cdr:from>
    <cdr:to>
      <cdr:x>0.91232</cdr:x>
      <cdr:y>0.20276</cdr:y>
    </cdr:to>
    <cdr:sp macro="" textlink="">
      <cdr:nvSpPr>
        <cdr:cNvPr id="8" name="Text Box 5"/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3638550" y="323850"/>
          <a:ext cx="532583" cy="232371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1">
          <a:noFill/>
          <a:miter lim="800000"/>
          <a:headEnd/>
          <a:tailEnd/>
        </a:ln>
        <a:effectLst xmlns:a="http://schemas.openxmlformats.org/drawingml/2006/main"/>
      </cdr:spPr>
      <cdr:txBody>
        <a:bodyPr xmlns:a="http://schemas.openxmlformats.org/drawingml/2006/main" wrap="none" lIns="18288" tIns="27432" rIns="18288" bIns="27432" anchor="ctr" upright="1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 rtl="0">
            <a:defRPr sz="1000"/>
          </a:pPr>
          <a:r>
            <a:rPr lang="en-GB" sz="1200" b="1" i="0" u="none" strike="noStrike" baseline="0">
              <a:solidFill>
                <a:srgbClr val="000000"/>
              </a:solidFill>
              <a:latin typeface="Times New Roman"/>
              <a:cs typeface="Times New Roman"/>
            </a:rPr>
            <a:t>cADPR</a:t>
          </a:r>
        </a:p>
      </cdr:txBody>
    </cdr:sp>
  </cdr:relSizeAnchor>
  <cdr:relSizeAnchor xmlns:cdr="http://schemas.openxmlformats.org/drawingml/2006/chartDrawing">
    <cdr:from>
      <cdr:x>0.34167</cdr:x>
      <cdr:y>0.71181</cdr:y>
    </cdr:from>
    <cdr:to>
      <cdr:x>0.44167</cdr:x>
      <cdr:y>0.8125</cdr:y>
    </cdr:to>
    <cdr:sp macro="" textlink="">
      <cdr:nvSpPr>
        <cdr:cNvPr id="9" name="TextBox 8"/>
        <cdr:cNvSpPr txBox="1"/>
      </cdr:nvSpPr>
      <cdr:spPr>
        <a:xfrm xmlns:a="http://schemas.openxmlformats.org/drawingml/2006/main">
          <a:off x="1562100" y="1952624"/>
          <a:ext cx="457200" cy="2762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pPr algn="ctr"/>
          <a:r>
            <a:rPr lang="en-GB" sz="1200" b="1">
              <a:latin typeface="Times New Roman" pitchFamily="18" charset="0"/>
              <a:cs typeface="Times New Roman" pitchFamily="18" charset="0"/>
            </a:rPr>
            <a:t>500</a:t>
          </a:r>
        </a:p>
      </cdr:txBody>
    </cdr:sp>
  </cdr:relSizeAnchor>
  <cdr:relSizeAnchor xmlns:cdr="http://schemas.openxmlformats.org/drawingml/2006/chartDrawing">
    <cdr:from>
      <cdr:x>0.8</cdr:x>
      <cdr:y>0.71181</cdr:y>
    </cdr:from>
    <cdr:to>
      <cdr:x>0.9</cdr:x>
      <cdr:y>0.8125</cdr:y>
    </cdr:to>
    <cdr:sp macro="" textlink="">
      <cdr:nvSpPr>
        <cdr:cNvPr id="11" name="TextBox 1"/>
        <cdr:cNvSpPr txBox="1"/>
      </cdr:nvSpPr>
      <cdr:spPr>
        <a:xfrm xmlns:a="http://schemas.openxmlformats.org/drawingml/2006/main">
          <a:off x="3657600" y="1952625"/>
          <a:ext cx="457200" cy="2762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200" b="1">
              <a:latin typeface="Times New Roman" pitchFamily="18" charset="0"/>
              <a:cs typeface="Times New Roman" pitchFamily="18" charset="0"/>
            </a:rPr>
            <a:t>3000</a:t>
          </a:r>
        </a:p>
      </cdr:txBody>
    </cdr:sp>
  </cdr:relSizeAnchor>
  <cdr:relSizeAnchor xmlns:cdr="http://schemas.openxmlformats.org/drawingml/2006/chartDrawing">
    <cdr:from>
      <cdr:x>0.60625</cdr:x>
      <cdr:y>0.17708</cdr:y>
    </cdr:from>
    <cdr:to>
      <cdr:x>0.70833</cdr:x>
      <cdr:y>0.76389</cdr:y>
    </cdr:to>
    <cdr:sp macro="" textlink="">
      <cdr:nvSpPr>
        <cdr:cNvPr id="12" name="Rectangle 11"/>
        <cdr:cNvSpPr/>
      </cdr:nvSpPr>
      <cdr:spPr>
        <a:xfrm xmlns:a="http://schemas.openxmlformats.org/drawingml/2006/main">
          <a:off x="2771776" y="485775"/>
          <a:ext cx="466724" cy="1609725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3833</cdr:x>
      <cdr:y>0.1881</cdr:y>
    </cdr:from>
    <cdr:to>
      <cdr:x>0.92323</cdr:x>
      <cdr:y>0.1881</cdr:y>
    </cdr:to>
    <cdr:sp macro="" textlink="">
      <cdr:nvSpPr>
        <cdr:cNvPr id="3" name="Straight Connector 2"/>
        <cdr:cNvSpPr/>
      </cdr:nvSpPr>
      <cdr:spPr>
        <a:xfrm xmlns:a="http://schemas.openxmlformats.org/drawingml/2006/main" flipV="1">
          <a:off x="1328943" y="446532"/>
          <a:ext cx="1872000" cy="0"/>
        </a:xfrm>
        <a:prstGeom xmlns:a="http://schemas.openxmlformats.org/drawingml/2006/main" prst="line">
          <a:avLst/>
        </a:prstGeom>
        <a:ln xmlns:a="http://schemas.openxmlformats.org/drawingml/2006/main" w="19050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GB"/>
        </a:p>
      </cdr:txBody>
    </cdr:sp>
  </cdr:relSizeAnchor>
  <cdr:relSizeAnchor xmlns:cdr="http://schemas.openxmlformats.org/drawingml/2006/chartDrawing">
    <cdr:from>
      <cdr:x>0.34578</cdr:x>
      <cdr:y>0.0887</cdr:y>
    </cdr:from>
    <cdr:to>
      <cdr:x>0.57363</cdr:x>
      <cdr:y>0.182</cdr:y>
    </cdr:to>
    <cdr:sp macro="" textlink="">
      <cdr:nvSpPr>
        <cdr:cNvPr id="4" name="TextBox 3"/>
        <cdr:cNvSpPr txBox="1"/>
      </cdr:nvSpPr>
      <cdr:spPr>
        <a:xfrm xmlns:a="http://schemas.openxmlformats.org/drawingml/2006/main">
          <a:off x="1198853" y="210564"/>
          <a:ext cx="789987" cy="22148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pPr algn="ctr"/>
          <a:r>
            <a:rPr lang="en-GB" sz="1200" b="1" dirty="0" smtClean="0">
              <a:latin typeface="Times New Roman" pitchFamily="18" charset="0"/>
              <a:cs typeface="Times New Roman" pitchFamily="18" charset="0"/>
            </a:rPr>
            <a:t>NAADP</a:t>
          </a:r>
          <a:endParaRPr lang="en-GB" sz="1200" b="1" dirty="0">
            <a:latin typeface="Times New Roman" pitchFamily="18" charset="0"/>
            <a:cs typeface="Times New Roman" pitchFamily="18" charset="0"/>
          </a:endParaRPr>
        </a:p>
      </cdr:txBody>
    </cdr:sp>
  </cdr:relSizeAnchor>
  <cdr:relSizeAnchor xmlns:cdr="http://schemas.openxmlformats.org/drawingml/2006/chartDrawing">
    <cdr:from>
      <cdr:x>0.13016</cdr:x>
      <cdr:y>0.0887</cdr:y>
    </cdr:from>
    <cdr:to>
      <cdr:x>0.92099</cdr:x>
      <cdr:y>0.0887</cdr:y>
    </cdr:to>
    <cdr:sp macro="" textlink="">
      <cdr:nvSpPr>
        <cdr:cNvPr id="5" name="Straight Connector 4"/>
        <cdr:cNvSpPr/>
      </cdr:nvSpPr>
      <cdr:spPr>
        <a:xfrm xmlns:a="http://schemas.openxmlformats.org/drawingml/2006/main" flipV="1">
          <a:off x="451262" y="210563"/>
          <a:ext cx="2741902" cy="0"/>
        </a:xfrm>
        <a:prstGeom xmlns:a="http://schemas.openxmlformats.org/drawingml/2006/main" prst="line">
          <a:avLst/>
        </a:prstGeom>
        <a:ln xmlns:a="http://schemas.openxmlformats.org/drawingml/2006/main" w="19050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GB"/>
        </a:p>
      </cdr:txBody>
    </cdr:sp>
  </cdr:relSizeAnchor>
  <cdr:relSizeAnchor xmlns:cdr="http://schemas.openxmlformats.org/drawingml/2006/chartDrawing">
    <cdr:from>
      <cdr:x>0.14224</cdr:x>
      <cdr:y>0</cdr:y>
    </cdr:from>
    <cdr:to>
      <cdr:x>0.36594</cdr:x>
      <cdr:y>0.091</cdr:y>
    </cdr:to>
    <cdr:sp macro="" textlink="">
      <cdr:nvSpPr>
        <cdr:cNvPr id="6" name="TextBox 1"/>
        <cdr:cNvSpPr txBox="1"/>
      </cdr:nvSpPr>
      <cdr:spPr>
        <a:xfrm xmlns:a="http://schemas.openxmlformats.org/drawingml/2006/main">
          <a:off x="493160" y="0"/>
          <a:ext cx="775600" cy="2160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200" b="1" dirty="0" err="1">
              <a:latin typeface="Times New Roman" pitchFamily="18" charset="0"/>
              <a:cs typeface="Times New Roman" pitchFamily="18" charset="0"/>
            </a:rPr>
            <a:t>ab</a:t>
          </a:r>
          <a:r>
            <a:rPr lang="en-GB" sz="1200" b="1" dirty="0">
              <a:latin typeface="Times New Roman" pitchFamily="18" charset="0"/>
              <a:cs typeface="Times New Roman" pitchFamily="18" charset="0"/>
            </a:rPr>
            <a:t> </a:t>
          </a:r>
          <a:r>
            <a:rPr lang="en-GB" sz="1200" b="1" dirty="0" err="1">
              <a:latin typeface="Times New Roman" pitchFamily="18" charset="0"/>
              <a:cs typeface="Times New Roman" pitchFamily="18" charset="0"/>
            </a:rPr>
            <a:t>RyR</a:t>
          </a:r>
          <a:r>
            <a:rPr lang="en-GB" sz="1200" b="1" dirty="0">
              <a:latin typeface="Times New Roman" pitchFamily="18" charset="0"/>
              <a:cs typeface="Times New Roman" pitchFamily="18" charset="0"/>
            </a:rPr>
            <a:t> </a:t>
          </a:r>
          <a:r>
            <a:rPr lang="en-GB" sz="1200" b="1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rPr>
            <a:t>2</a:t>
          </a:r>
        </a:p>
      </cdr:txBody>
    </cdr:sp>
  </cdr:relSizeAnchor>
  <cdr:relSizeAnchor xmlns:cdr="http://schemas.openxmlformats.org/drawingml/2006/chartDrawing">
    <cdr:from>
      <cdr:x>2.88426E-7</cdr:x>
      <cdr:y>0</cdr:y>
    </cdr:from>
    <cdr:to>
      <cdr:x>0.15825</cdr:x>
      <cdr:y>0.12133</cdr:y>
    </cdr:to>
    <cdr:sp macro="" textlink="">
      <cdr:nvSpPr>
        <cdr:cNvPr id="10" name="TextBox 1"/>
        <cdr:cNvSpPr txBox="1"/>
      </cdr:nvSpPr>
      <cdr:spPr>
        <a:xfrm xmlns:a="http://schemas.openxmlformats.org/drawingml/2006/main">
          <a:off x="1" y="0"/>
          <a:ext cx="548680" cy="28803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pPr algn="ctr"/>
          <a:r>
            <a:rPr lang="en-GB" sz="1200" b="1" dirty="0" smtClean="0">
              <a:latin typeface="Times New Roman" pitchFamily="18" charset="0"/>
              <a:cs typeface="Times New Roman" pitchFamily="18" charset="0"/>
            </a:rPr>
            <a:t>F/</a:t>
          </a:r>
          <a:r>
            <a:rPr lang="en-GB" sz="1200" b="1" dirty="0" err="1" smtClean="0">
              <a:latin typeface="Times New Roman" pitchFamily="18" charset="0"/>
              <a:cs typeface="Times New Roman" pitchFamily="18" charset="0"/>
            </a:rPr>
            <a:t>Fo</a:t>
          </a:r>
          <a:endParaRPr lang="en-GB" sz="1200" b="1" dirty="0">
            <a:solidFill>
              <a:srgbClr val="FF0000"/>
            </a:solidFill>
            <a:latin typeface="Times New Roman" pitchFamily="18" charset="0"/>
            <a:cs typeface="Times New Roman" pitchFamily="18" charset="0"/>
          </a:endParaRPr>
        </a:p>
      </cdr:txBody>
    </cdr:sp>
  </cdr:relSizeAnchor>
  <cdr:relSizeAnchor xmlns:cdr="http://schemas.openxmlformats.org/drawingml/2006/chartDrawing">
    <cdr:from>
      <cdr:x>0</cdr:x>
      <cdr:y>0</cdr:y>
    </cdr:from>
    <cdr:to>
      <cdr:x>0.15825</cdr:x>
      <cdr:y>0.12133</cdr:y>
    </cdr:to>
    <cdr:sp macro="" textlink="">
      <cdr:nvSpPr>
        <cdr:cNvPr id="7" name="TextBox 1"/>
        <cdr:cNvSpPr txBox="1"/>
      </cdr:nvSpPr>
      <cdr:spPr>
        <a:xfrm xmlns:a="http://schemas.openxmlformats.org/drawingml/2006/main">
          <a:off x="0" y="0"/>
          <a:ext cx="548667" cy="2880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pPr algn="ctr"/>
          <a:r>
            <a:rPr lang="en-GB" sz="1200" b="1" dirty="0" smtClean="0">
              <a:latin typeface="Times New Roman" pitchFamily="18" charset="0"/>
              <a:cs typeface="Times New Roman" pitchFamily="18" charset="0"/>
            </a:rPr>
            <a:t>F/</a:t>
          </a:r>
          <a:r>
            <a:rPr lang="en-GB" sz="1200" b="1" dirty="0" err="1" smtClean="0">
              <a:latin typeface="Times New Roman" pitchFamily="18" charset="0"/>
              <a:cs typeface="Times New Roman" pitchFamily="18" charset="0"/>
            </a:rPr>
            <a:t>Fo</a:t>
          </a:r>
          <a:endParaRPr lang="en-GB" sz="1200" b="1" dirty="0">
            <a:solidFill>
              <a:srgbClr val="FF0000"/>
            </a:solidFill>
            <a:latin typeface="Times New Roman" pitchFamily="18" charset="0"/>
            <a:cs typeface="Times New Roman" pitchFamily="18" charset="0"/>
          </a:endParaRPr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16001</cdr:x>
      <cdr:y>0.09482</cdr:y>
    </cdr:from>
    <cdr:to>
      <cdr:x>0.93499</cdr:x>
      <cdr:y>0.09482</cdr:y>
    </cdr:to>
    <cdr:sp macro="" textlink="">
      <cdr:nvSpPr>
        <cdr:cNvPr id="3" name="Straight Connector 2"/>
        <cdr:cNvSpPr/>
      </cdr:nvSpPr>
      <cdr:spPr>
        <a:xfrm xmlns:a="http://schemas.openxmlformats.org/drawingml/2006/main" flipV="1">
          <a:off x="548641" y="242091"/>
          <a:ext cx="2657181" cy="0"/>
        </a:xfrm>
        <a:prstGeom xmlns:a="http://schemas.openxmlformats.org/drawingml/2006/main" prst="line">
          <a:avLst/>
        </a:prstGeom>
        <a:ln xmlns:a="http://schemas.openxmlformats.org/drawingml/2006/main" w="19050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GB"/>
        </a:p>
      </cdr:txBody>
    </cdr:sp>
  </cdr:relSizeAnchor>
  <cdr:relSizeAnchor xmlns:cdr="http://schemas.openxmlformats.org/drawingml/2006/chartDrawing">
    <cdr:from>
      <cdr:x>0.31604</cdr:x>
      <cdr:y>0.19568</cdr:y>
    </cdr:from>
    <cdr:to>
      <cdr:x>0.93669</cdr:x>
      <cdr:y>0.19568</cdr:y>
    </cdr:to>
    <cdr:sp macro="" textlink="">
      <cdr:nvSpPr>
        <cdr:cNvPr id="4" name="Straight Connector 3"/>
        <cdr:cNvSpPr/>
      </cdr:nvSpPr>
      <cdr:spPr>
        <a:xfrm xmlns:a="http://schemas.openxmlformats.org/drawingml/2006/main" flipV="1">
          <a:off x="1083624" y="499608"/>
          <a:ext cx="2128027" cy="0"/>
        </a:xfrm>
        <a:prstGeom xmlns:a="http://schemas.openxmlformats.org/drawingml/2006/main" prst="line">
          <a:avLst/>
        </a:prstGeom>
        <a:ln xmlns:a="http://schemas.openxmlformats.org/drawingml/2006/main" w="19050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GB"/>
        </a:p>
      </cdr:txBody>
    </cdr:sp>
  </cdr:relSizeAnchor>
  <cdr:relSizeAnchor xmlns:cdr="http://schemas.openxmlformats.org/drawingml/2006/chartDrawing">
    <cdr:from>
      <cdr:x>0.15833</cdr:x>
      <cdr:y>0</cdr:y>
    </cdr:from>
    <cdr:to>
      <cdr:x>0.39903</cdr:x>
      <cdr:y>0.11992</cdr:y>
    </cdr:to>
    <cdr:sp macro="" textlink="">
      <cdr:nvSpPr>
        <cdr:cNvPr id="5" name="TextBox 4"/>
        <cdr:cNvSpPr txBox="1"/>
      </cdr:nvSpPr>
      <cdr:spPr>
        <a:xfrm xmlns:a="http://schemas.openxmlformats.org/drawingml/2006/main">
          <a:off x="542869" y="0"/>
          <a:ext cx="825283" cy="30618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pPr algn="ctr"/>
          <a:r>
            <a:rPr lang="en-GB" sz="1200" b="1" dirty="0" err="1">
              <a:latin typeface="Times New Roman" pitchFamily="18" charset="0"/>
              <a:cs typeface="Times New Roman" pitchFamily="18" charset="0"/>
            </a:rPr>
            <a:t>ab</a:t>
          </a:r>
          <a:r>
            <a:rPr lang="en-GB" sz="1200" b="1" dirty="0">
              <a:latin typeface="Times New Roman" pitchFamily="18" charset="0"/>
              <a:cs typeface="Times New Roman" pitchFamily="18" charset="0"/>
            </a:rPr>
            <a:t> </a:t>
          </a:r>
          <a:r>
            <a:rPr lang="en-GB" sz="1200" b="1" dirty="0" err="1" smtClean="0">
              <a:latin typeface="Times New Roman" pitchFamily="18" charset="0"/>
              <a:cs typeface="Times New Roman" pitchFamily="18" charset="0"/>
            </a:rPr>
            <a:t>RyR</a:t>
          </a:r>
          <a:r>
            <a:rPr lang="en-GB" sz="1200" b="1" dirty="0" smtClean="0">
              <a:latin typeface="Times New Roman" pitchFamily="18" charset="0"/>
              <a:cs typeface="Times New Roman" pitchFamily="18" charset="0"/>
            </a:rPr>
            <a:t> 2</a:t>
          </a:r>
          <a:endParaRPr lang="en-GB" sz="1200" b="1" dirty="0">
            <a:latin typeface="Times New Roman" pitchFamily="18" charset="0"/>
            <a:cs typeface="Times New Roman" pitchFamily="18" charset="0"/>
          </a:endParaRPr>
        </a:p>
      </cdr:txBody>
    </cdr:sp>
  </cdr:relSizeAnchor>
  <cdr:relSizeAnchor xmlns:cdr="http://schemas.openxmlformats.org/drawingml/2006/chartDrawing">
    <cdr:from>
      <cdr:x>0.31223</cdr:x>
      <cdr:y>0.1031</cdr:y>
    </cdr:from>
    <cdr:to>
      <cdr:x>0.49334</cdr:x>
      <cdr:y>0.23105</cdr:y>
    </cdr:to>
    <cdr:sp macro="" textlink="">
      <cdr:nvSpPr>
        <cdr:cNvPr id="6" name="TextBox 1"/>
        <cdr:cNvSpPr txBox="1"/>
      </cdr:nvSpPr>
      <cdr:spPr>
        <a:xfrm xmlns:a="http://schemas.openxmlformats.org/drawingml/2006/main">
          <a:off x="1070544" y="263241"/>
          <a:ext cx="620989" cy="3266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200" b="1" dirty="0" err="1">
              <a:latin typeface="Times New Roman" pitchFamily="18" charset="0"/>
              <a:cs typeface="Times New Roman" pitchFamily="18" charset="0"/>
            </a:rPr>
            <a:t>cADPR</a:t>
          </a:r>
          <a:endParaRPr lang="en-GB" sz="1200" b="1" dirty="0">
            <a:latin typeface="Times New Roman" pitchFamily="18" charset="0"/>
            <a:cs typeface="Times New Roman" pitchFamily="18" charset="0"/>
          </a:endParaRPr>
        </a:p>
      </cdr:txBody>
    </cdr:sp>
  </cdr:relSizeAnchor>
  <cdr:relSizeAnchor xmlns:cdr="http://schemas.openxmlformats.org/drawingml/2006/chartDrawing">
    <cdr:from>
      <cdr:x>0.02421</cdr:x>
      <cdr:y>0</cdr:y>
    </cdr:from>
    <cdr:to>
      <cdr:x>0.18423</cdr:x>
      <cdr:y>0.11281</cdr:y>
    </cdr:to>
    <cdr:sp macro="" textlink="">
      <cdr:nvSpPr>
        <cdr:cNvPr id="7" name="TextBox 1"/>
        <cdr:cNvSpPr txBox="1"/>
      </cdr:nvSpPr>
      <cdr:spPr>
        <a:xfrm xmlns:a="http://schemas.openxmlformats.org/drawingml/2006/main">
          <a:off x="83016" y="-13946"/>
          <a:ext cx="548664" cy="28802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pPr algn="ctr"/>
          <a:r>
            <a:rPr lang="en-GB" sz="1200" b="1" dirty="0" smtClean="0">
              <a:latin typeface="Times New Roman" pitchFamily="18" charset="0"/>
              <a:cs typeface="Times New Roman" pitchFamily="18" charset="0"/>
            </a:rPr>
            <a:t>F/</a:t>
          </a:r>
          <a:r>
            <a:rPr lang="en-GB" sz="1200" b="1" dirty="0" err="1" smtClean="0">
              <a:latin typeface="Times New Roman" pitchFamily="18" charset="0"/>
              <a:cs typeface="Times New Roman" pitchFamily="18" charset="0"/>
            </a:rPr>
            <a:t>Fo</a:t>
          </a:r>
          <a:endParaRPr lang="en-GB" sz="1200" b="1" dirty="0">
            <a:solidFill>
              <a:srgbClr val="FF0000"/>
            </a:solidFill>
            <a:latin typeface="Times New Roman" pitchFamily="18" charset="0"/>
            <a:cs typeface="Times New Roman" pitchFamily="18" charset="0"/>
          </a:endParaRPr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00989</cdr:x>
      <cdr:y>0.01675</cdr:y>
    </cdr:from>
    <cdr:to>
      <cdr:x>0.0763</cdr:x>
      <cdr:y>0.09093</cdr:y>
    </cdr:to>
    <cdr:sp macro="" textlink="">
      <cdr:nvSpPr>
        <cdr:cNvPr id="2049" name="Text Box 1"/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50800" y="50800"/>
          <a:ext cx="358281" cy="236273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ffectLst xmlns:a="http://schemas.openxmlformats.org/drawingml/2006/main"/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xmlns:mc="http://schemas.openxmlformats.org/markup-compatibility/2006" val="000000" mc:Ignorable="a14" a14:legacySpreadsheetColorIndex="64"/>
              </a:solidFill>
            </a14:hiddenFill>
          </a:ext>
          <a:ext uri="{91240B29-F687-4F45-9708-019B960494DF}">
            <a14:hiddenLine xmlns:a14="http://schemas.microsoft.com/office/drawing/2010/main" w="1">
              <a:solidFill>
                <a:srgbClr xmlns:mc="http://schemas.openxmlformats.org/markup-compatibility/2006" val="FFFFFF" mc:Ignorable="a14" a14:legacySpreadsheetColorIndex="65"/>
              </a:solidFill>
              <a:miter lim="800000"/>
              <a:headEnd/>
              <a:tailEnd/>
            </a14:hiddenLine>
          </a:ex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rgbClr val="808080"/>
                </a:outerShdw>
              </a:effectLst>
            </a14:hiddenEffects>
          </a:ext>
        </a:extLst>
      </cdr:spPr>
      <cdr:txBody>
        <a:bodyPr xmlns:a="http://schemas.openxmlformats.org/drawingml/2006/main" wrap="none" lIns="27432" tIns="32004" rIns="27432" bIns="32004" anchor="ctr" upright="1">
          <a:spAutoFit/>
        </a:bodyPr>
        <a:lstStyle xmlns:a="http://schemas.openxmlformats.org/drawingml/2006/main"/>
        <a:p xmlns:a="http://schemas.openxmlformats.org/drawingml/2006/main">
          <a:pPr algn="ctr" rtl="0">
            <a:defRPr sz="1000"/>
          </a:pPr>
          <a:r>
            <a:rPr lang="en-GB" sz="1200" b="1" i="0" u="none" strike="noStrike" baseline="0">
              <a:solidFill>
                <a:srgbClr val="000000"/>
              </a:solidFill>
              <a:latin typeface="Times New Roman"/>
              <a:cs typeface="Times New Roman"/>
            </a:rPr>
            <a:t>F/Fo</a:t>
          </a:r>
        </a:p>
      </cdr:txBody>
    </cdr:sp>
  </cdr:relSizeAnchor>
  <cdr:relSizeAnchor xmlns:cdr="http://schemas.openxmlformats.org/drawingml/2006/chartDrawing">
    <cdr:from>
      <cdr:x>0.73551</cdr:x>
      <cdr:y>0.87912</cdr:y>
    </cdr:from>
    <cdr:to>
      <cdr:x>0.93319</cdr:x>
      <cdr:y>0.97977</cdr:y>
    </cdr:to>
    <cdr:sp macro="" textlink="">
      <cdr:nvSpPr>
        <cdr:cNvPr id="2050" name="Text Box 2"/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2378095" y="2177501"/>
          <a:ext cx="639148" cy="24929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ffectLst xmlns:a="http://schemas.openxmlformats.org/drawingml/2006/main"/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xmlns:mc="http://schemas.openxmlformats.org/markup-compatibility/2006" val="000000" mc:Ignorable="a14" a14:legacySpreadsheetColorIndex="64"/>
              </a:solidFill>
            </a14:hiddenFill>
          </a:ext>
          <a:ext uri="{91240B29-F687-4F45-9708-019B960494DF}">
            <a14:hiddenLine xmlns:a14="http://schemas.microsoft.com/office/drawing/2010/main" w="1">
              <a:solidFill>
                <a:srgbClr xmlns:mc="http://schemas.openxmlformats.org/markup-compatibility/2006" val="FFFFFF" mc:Ignorable="a14" a14:legacySpreadsheetColorIndex="65"/>
              </a:solidFill>
              <a:miter lim="800000"/>
              <a:headEnd/>
              <a:tailEnd/>
            </a14:hiddenLine>
          </a:ex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rgbClr val="808080"/>
                </a:outerShdw>
              </a:effectLst>
            </a14:hiddenEffects>
          </a:ext>
        </a:extLst>
      </cdr:spPr>
      <cdr:txBody>
        <a:bodyPr xmlns:a="http://schemas.openxmlformats.org/drawingml/2006/main" wrap="square" lIns="27432" tIns="32004" rIns="27432" bIns="32004" anchor="ctr" upright="1">
          <a:spAutoFit/>
        </a:bodyPr>
        <a:lstStyle xmlns:a="http://schemas.openxmlformats.org/drawingml/2006/main"/>
        <a:p xmlns:a="http://schemas.openxmlformats.org/drawingml/2006/main">
          <a:pPr algn="ctr" rtl="0">
            <a:defRPr sz="1000"/>
          </a:pPr>
          <a:r>
            <a:rPr lang="en-GB" sz="1200" b="1" i="0" u="none" strike="noStrike" baseline="0" dirty="0">
              <a:solidFill>
                <a:srgbClr val="000000"/>
              </a:solidFill>
              <a:latin typeface="Times New Roman"/>
              <a:cs typeface="Times New Roman"/>
            </a:rPr>
            <a:t>Time, s</a:t>
          </a:r>
        </a:p>
      </cdr:txBody>
    </cdr:sp>
  </cdr:relSizeAnchor>
  <cdr:relSizeAnchor xmlns:cdr="http://schemas.openxmlformats.org/drawingml/2006/chartDrawing">
    <cdr:from>
      <cdr:x>0.23877</cdr:x>
      <cdr:y>0.18733</cdr:y>
    </cdr:from>
    <cdr:to>
      <cdr:x>0.41251</cdr:x>
      <cdr:y>0.18733</cdr:y>
    </cdr:to>
    <cdr:sp macro="" textlink="">
      <cdr:nvSpPr>
        <cdr:cNvPr id="2051" name="Line 3"/>
        <cdr:cNvSpPr>
          <a:spLocks xmlns:a="http://schemas.openxmlformats.org/drawingml/2006/main" noChangeShapeType="1"/>
        </cdr:cNvSpPr>
      </cdr:nvSpPr>
      <cdr:spPr bwMode="auto">
        <a:xfrm xmlns:a="http://schemas.openxmlformats.org/drawingml/2006/main">
          <a:off x="1286334" y="595264"/>
          <a:ext cx="936000" cy="0"/>
        </a:xfrm>
        <a:prstGeom xmlns:a="http://schemas.openxmlformats.org/drawingml/2006/main" prst="line">
          <a:avLst/>
        </a:prstGeom>
        <a:noFill xmlns:a="http://schemas.openxmlformats.org/drawingml/2006/main"/>
        <a:ln xmlns:a="http://schemas.openxmlformats.org/drawingml/2006/main" w="25400">
          <a:solidFill>
            <a:srgbClr xmlns:mc="http://schemas.openxmlformats.org/markup-compatibility/2006" xmlns:a14="http://schemas.microsoft.com/office/drawing/2010/main" val="000000" mc:Ignorable="a14" a14:legacySpreadsheetColorIndex="64"/>
          </a:solidFill>
          <a:round/>
          <a:headEnd/>
          <a:tailEnd/>
        </a:ln>
        <a:extLst xmlns:a="http://schemas.openxmlformats.org/drawingml/2006/main">
          <a:ext uri="{909E8E84-426E-40DD-AFC4-6F175D3DCCD1}">
            <a14:hiddenFill xmlns:a14="http://schemas.microsoft.com/office/drawing/2010/main">
              <a:noFill/>
            </a14:hiddenFill>
          </a:ext>
        </a:extLst>
      </cdr:spPr>
    </cdr:sp>
  </cdr:relSizeAnchor>
  <cdr:relSizeAnchor xmlns:cdr="http://schemas.openxmlformats.org/drawingml/2006/chartDrawing">
    <cdr:from>
      <cdr:x>0.66468</cdr:x>
      <cdr:y>0.233</cdr:y>
    </cdr:from>
    <cdr:to>
      <cdr:x>0.8024</cdr:x>
      <cdr:y>0.233</cdr:y>
    </cdr:to>
    <cdr:sp macro="" textlink="">
      <cdr:nvSpPr>
        <cdr:cNvPr id="2053" name="Line 5"/>
        <cdr:cNvSpPr>
          <a:spLocks xmlns:a="http://schemas.openxmlformats.org/drawingml/2006/main" noChangeShapeType="1"/>
        </cdr:cNvSpPr>
      </cdr:nvSpPr>
      <cdr:spPr bwMode="auto">
        <a:xfrm xmlns:a="http://schemas.openxmlformats.org/drawingml/2006/main">
          <a:off x="3583371" y="739610"/>
          <a:ext cx="743003" cy="0"/>
        </a:xfrm>
        <a:prstGeom xmlns:a="http://schemas.openxmlformats.org/drawingml/2006/main" prst="line">
          <a:avLst/>
        </a:prstGeom>
        <a:noFill xmlns:a="http://schemas.openxmlformats.org/drawingml/2006/main"/>
        <a:ln xmlns:a="http://schemas.openxmlformats.org/drawingml/2006/main" w="25400">
          <a:solidFill>
            <a:srgbClr xmlns:mc="http://schemas.openxmlformats.org/markup-compatibility/2006" xmlns:a14="http://schemas.microsoft.com/office/drawing/2010/main" val="000000" mc:Ignorable="a14" a14:legacySpreadsheetColorIndex="64"/>
          </a:solidFill>
          <a:round/>
          <a:headEnd/>
          <a:tailEnd/>
        </a:ln>
        <a:extLst xmlns:a="http://schemas.openxmlformats.org/drawingml/2006/main">
          <a:ext uri="{909E8E84-426E-40DD-AFC4-6F175D3DCCD1}">
            <a14:hiddenFill xmlns:a14="http://schemas.microsoft.com/office/drawing/2010/main">
              <a:noFill/>
            </a14:hiddenFill>
          </a:ext>
        </a:extLst>
      </cdr:spPr>
    </cdr:sp>
  </cdr:relSizeAnchor>
  <cdr:relSizeAnchor xmlns:cdr="http://schemas.openxmlformats.org/drawingml/2006/chartDrawing">
    <cdr:from>
      <cdr:x>0.23214</cdr:x>
      <cdr:y>0.11215</cdr:y>
    </cdr:from>
    <cdr:to>
      <cdr:x>0.4167</cdr:x>
      <cdr:y>0.19937</cdr:y>
    </cdr:to>
    <cdr:sp macro="" textlink="">
      <cdr:nvSpPr>
        <cdr:cNvPr id="2054" name="Text Box 6"/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836712" y="277792"/>
          <a:ext cx="665239" cy="216025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ffectLst xmlns:a="http://schemas.openxmlformats.org/drawingml/2006/main"/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xmlns:mc="http://schemas.openxmlformats.org/markup-compatibility/2006" val="000000" mc:Ignorable="a14" a14:legacySpreadsheetColorIndex="64"/>
              </a:solidFill>
            </a14:hiddenFill>
          </a:ext>
          <a:ext uri="{91240B29-F687-4F45-9708-019B960494DF}">
            <a14:hiddenLine xmlns:a14="http://schemas.microsoft.com/office/drawing/2010/main" w="1">
              <a:solidFill>
                <a:srgbClr xmlns:mc="http://schemas.openxmlformats.org/markup-compatibility/2006" val="FFFFFF" mc:Ignorable="a14" a14:legacySpreadsheetColorIndex="65"/>
              </a:solidFill>
              <a:miter lim="800000"/>
              <a:headEnd/>
              <a:tailEnd/>
            </a14:hiddenLine>
          </a:ex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rgbClr val="808080"/>
                </a:outerShdw>
              </a:effectLst>
            </a14:hiddenEffects>
          </a:ext>
        </a:extLst>
      </cdr:spPr>
      <cdr:txBody>
        <a:bodyPr xmlns:a="http://schemas.openxmlformats.org/drawingml/2006/main" vertOverflow="clip" wrap="square" lIns="36576" tIns="32004" rIns="36576" bIns="32004" anchor="ctr" upright="1"/>
        <a:lstStyle xmlns:a="http://schemas.openxmlformats.org/drawingml/2006/main"/>
        <a:p xmlns:a="http://schemas.openxmlformats.org/drawingml/2006/main">
          <a:pPr algn="ctr" rtl="0">
            <a:defRPr sz="1000"/>
          </a:pPr>
          <a:r>
            <a:rPr lang="en-GB" sz="1200" b="1" i="0" u="none" strike="noStrike" baseline="0" dirty="0" err="1">
              <a:solidFill>
                <a:srgbClr val="000000"/>
              </a:solidFill>
              <a:latin typeface="Times New Roman"/>
              <a:cs typeface="Times New Roman"/>
            </a:rPr>
            <a:t>cADPR</a:t>
          </a:r>
          <a:endParaRPr lang="en-GB" sz="1200" b="1" i="0" u="none" strike="noStrike" baseline="0" dirty="0">
            <a:solidFill>
              <a:srgbClr val="000000"/>
            </a:solidFill>
            <a:latin typeface="Times New Roman"/>
            <a:cs typeface="Times New Roman"/>
          </a:endParaRPr>
        </a:p>
      </cdr:txBody>
    </cdr:sp>
  </cdr:relSizeAnchor>
  <cdr:relSizeAnchor xmlns:cdr="http://schemas.openxmlformats.org/drawingml/2006/chartDrawing">
    <cdr:from>
      <cdr:x>0.65167</cdr:x>
      <cdr:y>0.11216</cdr:y>
    </cdr:from>
    <cdr:to>
      <cdr:x>0.79151</cdr:x>
      <cdr:y>0.233</cdr:y>
    </cdr:to>
    <cdr:sp macro="" textlink="">
      <cdr:nvSpPr>
        <cdr:cNvPr id="2056" name="Text Box 8"/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2348880" y="277812"/>
          <a:ext cx="504056" cy="299305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ffectLst xmlns:a="http://schemas.openxmlformats.org/drawingml/2006/main"/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xmlns:mc="http://schemas.openxmlformats.org/markup-compatibility/2006" val="000000" mc:Ignorable="a14" a14:legacySpreadsheetColorIndex="64"/>
              </a:solidFill>
            </a14:hiddenFill>
          </a:ext>
          <a:ext uri="{91240B29-F687-4F45-9708-019B960494DF}">
            <a14:hiddenLine xmlns:a14="http://schemas.microsoft.com/office/drawing/2010/main" w="1">
              <a:solidFill>
                <a:srgbClr xmlns:mc="http://schemas.openxmlformats.org/markup-compatibility/2006" val="FFFFFF" mc:Ignorable="a14" a14:legacySpreadsheetColorIndex="65"/>
              </a:solidFill>
              <a:miter lim="800000"/>
              <a:headEnd/>
              <a:tailEnd/>
            </a14:hiddenLine>
          </a:ex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rgbClr val="808080"/>
                </a:outerShdw>
              </a:effectLst>
            </a14:hiddenEffects>
          </a:ext>
        </a:extLst>
      </cdr:spPr>
      <cdr:txBody>
        <a:bodyPr xmlns:a="http://schemas.openxmlformats.org/drawingml/2006/main" vertOverflow="clip" wrap="square" lIns="36576" tIns="32004" rIns="36576" bIns="32004" anchor="ctr" upright="1"/>
        <a:lstStyle xmlns:a="http://schemas.openxmlformats.org/drawingml/2006/main"/>
        <a:p xmlns:a="http://schemas.openxmlformats.org/drawingml/2006/main">
          <a:pPr algn="ctr" rtl="0">
            <a:defRPr sz="1000"/>
          </a:pPr>
          <a:r>
            <a:rPr lang="en-GB" sz="1200" b="1" i="0" u="none" strike="noStrike" baseline="0" dirty="0">
              <a:solidFill>
                <a:srgbClr val="000000"/>
              </a:solidFill>
              <a:latin typeface="Times New Roman"/>
              <a:cs typeface="Times New Roman"/>
            </a:rPr>
            <a:t>IP</a:t>
          </a:r>
          <a:r>
            <a:rPr lang="en-GB" sz="1200" b="1" i="0" u="none" strike="noStrike" baseline="-25000" dirty="0">
              <a:solidFill>
                <a:srgbClr val="000000"/>
              </a:solidFill>
              <a:latin typeface="Times New Roman"/>
              <a:cs typeface="Times New Roman"/>
            </a:rPr>
            <a:t>3</a:t>
          </a:r>
        </a:p>
      </cdr:txBody>
    </cdr:sp>
  </cdr:relSizeAnchor>
  <cdr:relSizeAnchor xmlns:cdr="http://schemas.openxmlformats.org/drawingml/2006/chartDrawing">
    <cdr:from>
      <cdr:x>0.08134</cdr:x>
      <cdr:y>0.00999</cdr:y>
    </cdr:from>
    <cdr:to>
      <cdr:x>0.35414</cdr:x>
      <cdr:y>0.11064</cdr:y>
    </cdr:to>
    <cdr:sp macro="" textlink="">
      <cdr:nvSpPr>
        <cdr:cNvPr id="2058" name="Text Box 10"/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262995" y="24738"/>
          <a:ext cx="882040" cy="24929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ffectLst xmlns:a="http://schemas.openxmlformats.org/drawingml/2006/main"/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xmlns:mc="http://schemas.openxmlformats.org/markup-compatibility/2006" val="000000" mc:Ignorable="a14" a14:legacySpreadsheetColorIndex="64"/>
              </a:solidFill>
            </a14:hiddenFill>
          </a:ext>
          <a:ext uri="{91240B29-F687-4F45-9708-019B960494DF}">
            <a14:hiddenLine xmlns:a14="http://schemas.microsoft.com/office/drawing/2010/main" w="1">
              <a:solidFill>
                <a:srgbClr xmlns:mc="http://schemas.openxmlformats.org/markup-compatibility/2006" val="FFFFFF" mc:Ignorable="a14" a14:legacySpreadsheetColorIndex="65"/>
              </a:solidFill>
              <a:miter lim="800000"/>
              <a:headEnd/>
              <a:tailEnd/>
            </a14:hiddenLine>
          </a:ex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rgbClr val="808080"/>
                </a:outerShdw>
              </a:effectLst>
            </a14:hiddenEffects>
          </a:ext>
        </a:extLst>
      </cdr:spPr>
      <cdr:txBody>
        <a:bodyPr xmlns:a="http://schemas.openxmlformats.org/drawingml/2006/main" wrap="square" lIns="27432" tIns="32004" rIns="27432" bIns="32004" anchor="ctr" upright="1">
          <a:spAutoFit/>
        </a:bodyPr>
        <a:lstStyle xmlns:a="http://schemas.openxmlformats.org/drawingml/2006/main"/>
        <a:p xmlns:a="http://schemas.openxmlformats.org/drawingml/2006/main">
          <a:pPr algn="ctr" rtl="0">
            <a:defRPr sz="1000"/>
          </a:pPr>
          <a:r>
            <a:rPr lang="en-GB" sz="1200" b="1" i="0" u="none" strike="noStrike" baseline="0" dirty="0" smtClean="0">
              <a:solidFill>
                <a:srgbClr val="000000"/>
              </a:solidFill>
              <a:latin typeface="Times New Roman"/>
              <a:cs typeface="Times New Roman"/>
            </a:rPr>
            <a:t>ab </a:t>
          </a:r>
          <a:r>
            <a:rPr lang="en-GB" sz="1200" b="1" i="0" u="none" strike="noStrike" baseline="0" dirty="0" err="1" smtClean="0">
              <a:solidFill>
                <a:srgbClr val="000000"/>
              </a:solidFill>
              <a:latin typeface="Times New Roman"/>
              <a:cs typeface="Times New Roman"/>
            </a:rPr>
            <a:t>RyR</a:t>
          </a:r>
          <a:r>
            <a:rPr lang="en-GB" sz="1200" b="1" i="0" u="none" strike="noStrike" baseline="0" dirty="0" smtClean="0">
              <a:solidFill>
                <a:srgbClr val="000000"/>
              </a:solidFill>
              <a:latin typeface="Times New Roman"/>
              <a:cs typeface="Times New Roman"/>
            </a:rPr>
            <a:t> 3</a:t>
          </a:r>
          <a:endParaRPr lang="en-GB" sz="1200" b="1" i="0" u="none" strike="noStrike" baseline="0" dirty="0">
            <a:solidFill>
              <a:srgbClr val="000000"/>
            </a:solidFill>
            <a:latin typeface="Times New Roman"/>
            <a:cs typeface="Times New Roman"/>
          </a:endParaRPr>
        </a:p>
      </cdr:txBody>
    </cdr:sp>
  </cdr:relSizeAnchor>
  <cdr:relSizeAnchor xmlns:cdr="http://schemas.openxmlformats.org/drawingml/2006/chartDrawing">
    <cdr:from>
      <cdr:x>0.08405</cdr:x>
      <cdr:y>0.11216</cdr:y>
    </cdr:from>
    <cdr:to>
      <cdr:x>0.80317</cdr:x>
      <cdr:y>0.11216</cdr:y>
    </cdr:to>
    <cdr:sp macro="" textlink="">
      <cdr:nvSpPr>
        <cdr:cNvPr id="9" name="Line 3"/>
        <cdr:cNvSpPr>
          <a:spLocks xmlns:a="http://schemas.openxmlformats.org/drawingml/2006/main" noChangeShapeType="1"/>
        </cdr:cNvSpPr>
      </cdr:nvSpPr>
      <cdr:spPr bwMode="auto">
        <a:xfrm xmlns:a="http://schemas.openxmlformats.org/drawingml/2006/main">
          <a:off x="302965" y="277812"/>
          <a:ext cx="2592000" cy="0"/>
        </a:xfrm>
        <a:prstGeom xmlns:a="http://schemas.openxmlformats.org/drawingml/2006/main" prst="line">
          <a:avLst/>
        </a:prstGeom>
        <a:noFill xmlns:a="http://schemas.openxmlformats.org/drawingml/2006/main"/>
        <a:ln xmlns:a="http://schemas.openxmlformats.org/drawingml/2006/main" w="25400">
          <a:solidFill>
            <a:srgbClr xmlns:mc="http://schemas.openxmlformats.org/markup-compatibility/2006" xmlns:a14="http://schemas.microsoft.com/office/drawing/2010/main" val="000000" mc:Ignorable="a14" a14:legacySpreadsheetColorIndex="64"/>
          </a:solidFill>
          <a:round/>
          <a:headEnd/>
          <a:tailEnd/>
        </a:ln>
        <a:extLst xmlns:a="http://schemas.openxmlformats.org/drawingml/2006/main">
          <a:ext uri="{909E8E84-426E-40DD-AFC4-6F175D3DCCD1}">
            <a14:hiddenFill xmlns:a14="http://schemas.microsoft.com/office/drawing/2010/main">
              <a:noFill/>
            </a14:hiddenFill>
          </a:ext>
        </a:extLst>
      </cdr:spPr>
    </cdr: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.08028</cdr:x>
      <cdr:y>0.6556</cdr:y>
    </cdr:from>
    <cdr:to>
      <cdr:x>0.11712</cdr:x>
      <cdr:y>0.89904</cdr:y>
    </cdr:to>
    <cdr:sp macro="" textlink="">
      <cdr:nvSpPr>
        <cdr:cNvPr id="2" name="TextBox 1"/>
        <cdr:cNvSpPr txBox="1">
          <a:spLocks xmlns:a="http://schemas.openxmlformats.org/drawingml/2006/main" noChangeAspect="1"/>
        </cdr:cNvSpPr>
      </cdr:nvSpPr>
      <cdr:spPr>
        <a:xfrm xmlns:a="http://schemas.openxmlformats.org/drawingml/2006/main" rot="-4200000">
          <a:off x="294769" y="1978220"/>
          <a:ext cx="655939" cy="23242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pPr algn="ctr"/>
          <a:r>
            <a:rPr lang="en-GB" sz="1000" b="1" dirty="0">
              <a:latin typeface="Times New Roman" pitchFamily="18" charset="0"/>
              <a:cs typeface="Times New Roman" pitchFamily="18" charset="0"/>
            </a:rPr>
            <a:t>control</a:t>
          </a:r>
        </a:p>
      </cdr:txBody>
    </cdr:sp>
  </cdr:relSizeAnchor>
  <cdr:relSizeAnchor xmlns:cdr="http://schemas.openxmlformats.org/drawingml/2006/chartDrawing">
    <cdr:from>
      <cdr:x>0.11878</cdr:x>
      <cdr:y>0.63734</cdr:y>
    </cdr:from>
    <cdr:to>
      <cdr:x>0.15302</cdr:x>
      <cdr:y>0.90459</cdr:y>
    </cdr:to>
    <cdr:sp macro="" textlink="">
      <cdr:nvSpPr>
        <cdr:cNvPr id="3" name="TextBox 1"/>
        <cdr:cNvSpPr txBox="1">
          <a:spLocks xmlns:a="http://schemas.openxmlformats.org/drawingml/2006/main" noChangeAspect="1"/>
        </cdr:cNvSpPr>
      </cdr:nvSpPr>
      <cdr:spPr>
        <a:xfrm xmlns:a="http://schemas.openxmlformats.org/drawingml/2006/main" rot="-4200000">
          <a:off x="497375" y="1969313"/>
          <a:ext cx="720080" cy="2160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000" b="1" dirty="0" smtClean="0">
              <a:latin typeface="Times New Roman" pitchFamily="18" charset="0"/>
              <a:cs typeface="Times New Roman" pitchFamily="18" charset="0"/>
            </a:rPr>
            <a:t>abRyR3</a:t>
          </a:r>
          <a:endParaRPr lang="en-GB" sz="1000" b="1" dirty="0">
            <a:latin typeface="Times New Roman" pitchFamily="18" charset="0"/>
            <a:cs typeface="Times New Roman" pitchFamily="18" charset="0"/>
          </a:endParaRPr>
        </a:p>
      </cdr:txBody>
    </cdr:sp>
  </cdr:relSizeAnchor>
  <cdr:relSizeAnchor xmlns:cdr="http://schemas.openxmlformats.org/drawingml/2006/chartDrawing">
    <cdr:from>
      <cdr:x>0.13898</cdr:x>
      <cdr:y>0.91705</cdr:y>
    </cdr:from>
    <cdr:to>
      <cdr:x>0.292</cdr:x>
      <cdr:y>0.99718</cdr:y>
    </cdr:to>
    <cdr:sp macro="" textlink="">
      <cdr:nvSpPr>
        <cdr:cNvPr id="19" name="TextBox 1"/>
        <cdr:cNvSpPr txBox="1"/>
      </cdr:nvSpPr>
      <cdr:spPr>
        <a:xfrm xmlns:a="http://schemas.openxmlformats.org/drawingml/2006/main">
          <a:off x="876866" y="2470941"/>
          <a:ext cx="965452" cy="215905"/>
        </a:xfrm>
        <a:prstGeom xmlns:a="http://schemas.openxmlformats.org/drawingml/2006/main" prst="rect">
          <a:avLst/>
        </a:prstGeom>
        <a:solidFill xmlns:a="http://schemas.openxmlformats.org/drawingml/2006/main">
          <a:srgbClr val="6699FF"/>
        </a:solidFill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000" b="1" dirty="0">
              <a:latin typeface="Times New Roman" pitchFamily="18" charset="0"/>
              <a:cs typeface="Times New Roman" pitchFamily="18" charset="0"/>
            </a:rPr>
            <a:t>100 </a:t>
          </a:r>
          <a:r>
            <a:rPr lang="en-GB" sz="1000" b="1" dirty="0" err="1">
              <a:latin typeface="Times New Roman" pitchFamily="18" charset="0"/>
              <a:cs typeface="Times New Roman" pitchFamily="18" charset="0"/>
            </a:rPr>
            <a:t>nM</a:t>
          </a:r>
          <a:r>
            <a:rPr lang="en-GB" sz="1000" b="1" dirty="0">
              <a:latin typeface="Times New Roman" pitchFamily="18" charset="0"/>
              <a:cs typeface="Times New Roman" pitchFamily="18" charset="0"/>
            </a:rPr>
            <a:t> NAADP</a:t>
          </a:r>
        </a:p>
      </cdr:txBody>
    </cdr:sp>
  </cdr:relSizeAnchor>
  <cdr:relSizeAnchor xmlns:cdr="http://schemas.openxmlformats.org/drawingml/2006/chartDrawing">
    <cdr:from>
      <cdr:x>0.496</cdr:x>
      <cdr:y>0.914</cdr:y>
    </cdr:from>
    <cdr:to>
      <cdr:x>0.63378</cdr:x>
      <cdr:y>1</cdr:y>
    </cdr:to>
    <cdr:sp macro="" textlink="">
      <cdr:nvSpPr>
        <cdr:cNvPr id="21" name="TextBox 1"/>
        <cdr:cNvSpPr txBox="1"/>
      </cdr:nvSpPr>
      <cdr:spPr>
        <a:xfrm xmlns:a="http://schemas.openxmlformats.org/drawingml/2006/main">
          <a:off x="3643029" y="3259471"/>
          <a:ext cx="1011968" cy="306689"/>
        </a:xfrm>
        <a:prstGeom xmlns:a="http://schemas.openxmlformats.org/drawingml/2006/main" prst="rect">
          <a:avLst/>
        </a:prstGeom>
        <a:solidFill xmlns:a="http://schemas.openxmlformats.org/drawingml/2006/main">
          <a:srgbClr val="FFCCFF"/>
        </a:solidFill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000" b="1" dirty="0">
              <a:latin typeface="Times New Roman" pitchFamily="18" charset="0"/>
              <a:cs typeface="Times New Roman" pitchFamily="18" charset="0"/>
            </a:rPr>
            <a:t>10 </a:t>
          </a:r>
          <a:r>
            <a:rPr lang="en-GB" sz="1000" b="1" dirty="0" err="1">
              <a:latin typeface="Symbol" pitchFamily="18" charset="2"/>
              <a:cs typeface="Times New Roman" pitchFamily="18" charset="0"/>
            </a:rPr>
            <a:t>m</a:t>
          </a:r>
          <a:r>
            <a:rPr lang="en-GB" sz="1000" b="1" dirty="0" err="1">
              <a:latin typeface="Times New Roman" pitchFamily="18" charset="0"/>
              <a:cs typeface="Times New Roman" pitchFamily="18" charset="0"/>
            </a:rPr>
            <a:t>M</a:t>
          </a:r>
          <a:r>
            <a:rPr lang="en-GB" sz="1000" b="1" dirty="0">
              <a:latin typeface="Times New Roman" pitchFamily="18" charset="0"/>
              <a:cs typeface="Times New Roman" pitchFamily="18" charset="0"/>
            </a:rPr>
            <a:t> </a:t>
          </a:r>
          <a:r>
            <a:rPr lang="en-GB" sz="1000" b="1" dirty="0" err="1">
              <a:latin typeface="Times New Roman" pitchFamily="18" charset="0"/>
              <a:cs typeface="Times New Roman" pitchFamily="18" charset="0"/>
            </a:rPr>
            <a:t>cADPR</a:t>
          </a:r>
          <a:endParaRPr lang="en-GB" sz="1000" b="1" dirty="0">
            <a:latin typeface="Times New Roman" pitchFamily="18" charset="0"/>
            <a:cs typeface="Times New Roman" pitchFamily="18" charset="0"/>
          </a:endParaRPr>
        </a:p>
      </cdr:txBody>
    </cdr:sp>
  </cdr:relSizeAnchor>
  <cdr:relSizeAnchor xmlns:cdr="http://schemas.openxmlformats.org/drawingml/2006/chartDrawing">
    <cdr:from>
      <cdr:x>0.75232</cdr:x>
      <cdr:y>0.91705</cdr:y>
    </cdr:from>
    <cdr:to>
      <cdr:x>0.90535</cdr:x>
      <cdr:y>0.99718</cdr:y>
    </cdr:to>
    <cdr:sp macro="" textlink="">
      <cdr:nvSpPr>
        <cdr:cNvPr id="28" name="TextBox 1"/>
        <cdr:cNvSpPr txBox="1"/>
      </cdr:nvSpPr>
      <cdr:spPr>
        <a:xfrm xmlns:a="http://schemas.openxmlformats.org/drawingml/2006/main">
          <a:off x="4746657" y="2470940"/>
          <a:ext cx="965516" cy="215905"/>
        </a:xfrm>
        <a:prstGeom xmlns:a="http://schemas.openxmlformats.org/drawingml/2006/main" prst="rect">
          <a:avLst/>
        </a:prstGeom>
        <a:solidFill xmlns:a="http://schemas.openxmlformats.org/drawingml/2006/main">
          <a:srgbClr val="CCFF99"/>
        </a:solidFill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000" b="1" dirty="0">
              <a:latin typeface="Times New Roman" pitchFamily="18" charset="0"/>
              <a:cs typeface="Times New Roman" pitchFamily="18" charset="0"/>
            </a:rPr>
            <a:t>10 </a:t>
          </a:r>
          <a:r>
            <a:rPr lang="en-GB" sz="1000" b="1" dirty="0" err="1">
              <a:latin typeface="Symbol" pitchFamily="18" charset="2"/>
              <a:cs typeface="Times New Roman" pitchFamily="18" charset="0"/>
            </a:rPr>
            <a:t>m</a:t>
          </a:r>
          <a:r>
            <a:rPr lang="en-GB" sz="1000" b="1" dirty="0" err="1">
              <a:latin typeface="Times New Roman" pitchFamily="18" charset="0"/>
              <a:cs typeface="Times New Roman" pitchFamily="18" charset="0"/>
            </a:rPr>
            <a:t>M</a:t>
          </a:r>
          <a:r>
            <a:rPr lang="en-GB" sz="1000" b="1" dirty="0">
              <a:latin typeface="Times New Roman" pitchFamily="18" charset="0"/>
              <a:cs typeface="Times New Roman" pitchFamily="18" charset="0"/>
            </a:rPr>
            <a:t> IP</a:t>
          </a:r>
          <a:r>
            <a:rPr lang="en-GB" sz="1000" b="1" baseline="-25000" dirty="0">
              <a:latin typeface="Times New Roman" pitchFamily="18" charset="0"/>
              <a:cs typeface="Times New Roman" pitchFamily="18" charset="0"/>
            </a:rPr>
            <a:t>3</a:t>
          </a:r>
        </a:p>
      </cdr:txBody>
    </cdr:sp>
  </cdr:relSizeAnchor>
  <cdr:relSizeAnchor xmlns:cdr="http://schemas.openxmlformats.org/drawingml/2006/chartDrawing">
    <cdr:from>
      <cdr:x>0.15858</cdr:x>
      <cdr:y>0.64203</cdr:y>
    </cdr:from>
    <cdr:to>
      <cdr:x>0.19282</cdr:x>
      <cdr:y>0.90928</cdr:y>
    </cdr:to>
    <cdr:sp macro="" textlink="">
      <cdr:nvSpPr>
        <cdr:cNvPr id="27" name="TextBox 1"/>
        <cdr:cNvSpPr txBox="1">
          <a:spLocks xmlns:a="http://schemas.openxmlformats.org/drawingml/2006/main" noChangeAspect="1"/>
        </cdr:cNvSpPr>
      </cdr:nvSpPr>
      <cdr:spPr>
        <a:xfrm xmlns:a="http://schemas.openxmlformats.org/drawingml/2006/main" rot="-4200000">
          <a:off x="748524" y="1981948"/>
          <a:ext cx="720080" cy="2160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000" b="1" dirty="0" smtClean="0">
              <a:latin typeface="Times New Roman" pitchFamily="18" charset="0"/>
              <a:cs typeface="Times New Roman" pitchFamily="18" charset="0"/>
            </a:rPr>
            <a:t>abRyR2</a:t>
          </a:r>
          <a:endParaRPr lang="en-GB" sz="1000" b="1" dirty="0">
            <a:latin typeface="Times New Roman" pitchFamily="18" charset="0"/>
            <a:cs typeface="Times New Roman" pitchFamily="18" charset="0"/>
          </a:endParaRPr>
        </a:p>
      </cdr:txBody>
    </cdr:sp>
  </cdr:relSizeAnchor>
  <cdr:relSizeAnchor xmlns:cdr="http://schemas.openxmlformats.org/drawingml/2006/chartDrawing">
    <cdr:from>
      <cdr:x>0.20007</cdr:x>
      <cdr:y>0.64226</cdr:y>
    </cdr:from>
    <cdr:to>
      <cdr:x>0.23431</cdr:x>
      <cdr:y>0.90951</cdr:y>
    </cdr:to>
    <cdr:sp macro="" textlink="">
      <cdr:nvSpPr>
        <cdr:cNvPr id="29" name="TextBox 1"/>
        <cdr:cNvSpPr txBox="1">
          <a:spLocks xmlns:a="http://schemas.openxmlformats.org/drawingml/2006/main" noChangeAspect="1"/>
        </cdr:cNvSpPr>
      </cdr:nvSpPr>
      <cdr:spPr>
        <a:xfrm xmlns:a="http://schemas.openxmlformats.org/drawingml/2006/main" rot="-4200000">
          <a:off x="1010268" y="1982557"/>
          <a:ext cx="720080" cy="2160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000" b="1" dirty="0" smtClean="0">
              <a:latin typeface="Times New Roman" pitchFamily="18" charset="0"/>
              <a:cs typeface="Times New Roman" pitchFamily="18" charset="0"/>
            </a:rPr>
            <a:t>abRyR1</a:t>
          </a:r>
          <a:endParaRPr lang="en-GB" sz="1000" b="1" dirty="0">
            <a:latin typeface="Times New Roman" pitchFamily="18" charset="0"/>
            <a:cs typeface="Times New Roman" pitchFamily="18" charset="0"/>
          </a:endParaRPr>
        </a:p>
      </cdr:txBody>
    </cdr:sp>
  </cdr:relSizeAnchor>
  <cdr:relSizeAnchor xmlns:cdr="http://schemas.openxmlformats.org/drawingml/2006/chartDrawing">
    <cdr:from>
      <cdr:x>0.24036</cdr:x>
      <cdr:y>0.65357</cdr:y>
    </cdr:from>
    <cdr:to>
      <cdr:x>0.27459</cdr:x>
      <cdr:y>0.92081</cdr:y>
    </cdr:to>
    <cdr:sp macro="" textlink="">
      <cdr:nvSpPr>
        <cdr:cNvPr id="30" name="TextBox 1"/>
        <cdr:cNvSpPr txBox="1">
          <a:spLocks xmlns:a="http://schemas.openxmlformats.org/drawingml/2006/main" noChangeAspect="1"/>
        </cdr:cNvSpPr>
      </cdr:nvSpPr>
      <cdr:spPr>
        <a:xfrm xmlns:a="http://schemas.openxmlformats.org/drawingml/2006/main" rot="-4200000">
          <a:off x="1264452" y="2013026"/>
          <a:ext cx="720080" cy="2160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000" b="1" dirty="0" smtClean="0">
              <a:latin typeface="Times New Roman" pitchFamily="18" charset="0"/>
              <a:cs typeface="Times New Roman" pitchFamily="18" charset="0"/>
            </a:rPr>
            <a:t>abRyR1,2</a:t>
          </a:r>
          <a:endParaRPr lang="en-GB" sz="1000" b="1" dirty="0">
            <a:latin typeface="Times New Roman" pitchFamily="18" charset="0"/>
            <a:cs typeface="Times New Roman" pitchFamily="18" charset="0"/>
          </a:endParaRPr>
        </a:p>
      </cdr:txBody>
    </cdr:sp>
  </cdr:relSizeAnchor>
  <cdr:relSizeAnchor xmlns:cdr="http://schemas.openxmlformats.org/drawingml/2006/chartDrawing">
    <cdr:from>
      <cdr:x>0.28021</cdr:x>
      <cdr:y>0.65074</cdr:y>
    </cdr:from>
    <cdr:to>
      <cdr:x>0.31445</cdr:x>
      <cdr:y>0.91799</cdr:y>
    </cdr:to>
    <cdr:sp macro="" textlink="">
      <cdr:nvSpPr>
        <cdr:cNvPr id="31" name="TextBox 1"/>
        <cdr:cNvSpPr txBox="1">
          <a:spLocks xmlns:a="http://schemas.openxmlformats.org/drawingml/2006/main" noChangeAspect="1"/>
        </cdr:cNvSpPr>
      </cdr:nvSpPr>
      <cdr:spPr>
        <a:xfrm xmlns:a="http://schemas.openxmlformats.org/drawingml/2006/main" rot="-4200000">
          <a:off x="1515913" y="2005407"/>
          <a:ext cx="720080" cy="2160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000" b="1" dirty="0" smtClean="0">
              <a:latin typeface="Times New Roman" pitchFamily="18" charset="0"/>
              <a:cs typeface="Times New Roman" pitchFamily="18" charset="0"/>
            </a:rPr>
            <a:t>abRyR1,3</a:t>
          </a:r>
          <a:endParaRPr lang="en-GB" sz="1000" b="1" dirty="0">
            <a:latin typeface="Times New Roman" pitchFamily="18" charset="0"/>
            <a:cs typeface="Times New Roman" pitchFamily="18" charset="0"/>
          </a:endParaRPr>
        </a:p>
      </cdr:txBody>
    </cdr:sp>
  </cdr:relSizeAnchor>
  <cdr:relSizeAnchor xmlns:cdr="http://schemas.openxmlformats.org/drawingml/2006/chartDrawing">
    <cdr:from>
      <cdr:x>0.3232</cdr:x>
      <cdr:y>0.67008</cdr:y>
    </cdr:from>
    <cdr:to>
      <cdr:x>0.35743</cdr:x>
      <cdr:y>0.93732</cdr:y>
    </cdr:to>
    <cdr:sp macro="" textlink="">
      <cdr:nvSpPr>
        <cdr:cNvPr id="32" name="TextBox 1"/>
        <cdr:cNvSpPr txBox="1">
          <a:spLocks xmlns:a="http://schemas.openxmlformats.org/drawingml/2006/main" noChangeAspect="1"/>
        </cdr:cNvSpPr>
      </cdr:nvSpPr>
      <cdr:spPr>
        <a:xfrm xmlns:a="http://schemas.openxmlformats.org/drawingml/2006/main" rot="-4200000">
          <a:off x="1787116" y="2057513"/>
          <a:ext cx="720080" cy="2160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000" b="1" dirty="0" smtClean="0">
              <a:latin typeface="Times New Roman" pitchFamily="18" charset="0"/>
              <a:cs typeface="Times New Roman" pitchFamily="18" charset="0"/>
            </a:rPr>
            <a:t>abRyR1,2,3</a:t>
          </a:r>
          <a:endParaRPr lang="en-GB" sz="1000" b="1" dirty="0">
            <a:latin typeface="Times New Roman" pitchFamily="18" charset="0"/>
            <a:cs typeface="Times New Roman" pitchFamily="18" charset="0"/>
          </a:endParaRPr>
        </a:p>
      </cdr:txBody>
    </cdr:sp>
  </cdr:relSizeAnchor>
  <cdr:relSizeAnchor xmlns:cdr="http://schemas.openxmlformats.org/drawingml/2006/chartDrawing">
    <cdr:from>
      <cdr:x>0.40248</cdr:x>
      <cdr:y>0.64935</cdr:y>
    </cdr:from>
    <cdr:to>
      <cdr:x>0.43932</cdr:x>
      <cdr:y>0.89279</cdr:y>
    </cdr:to>
    <cdr:sp macro="" textlink="">
      <cdr:nvSpPr>
        <cdr:cNvPr id="33" name="TextBox 1"/>
        <cdr:cNvSpPr txBox="1">
          <a:spLocks xmlns:a="http://schemas.openxmlformats.org/drawingml/2006/main" noChangeAspect="1"/>
        </cdr:cNvSpPr>
      </cdr:nvSpPr>
      <cdr:spPr>
        <a:xfrm xmlns:a="http://schemas.openxmlformats.org/drawingml/2006/main" rot="-4200000">
          <a:off x="2327600" y="1961392"/>
          <a:ext cx="655939" cy="23242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000" b="1" dirty="0">
              <a:latin typeface="Times New Roman" pitchFamily="18" charset="0"/>
              <a:cs typeface="Times New Roman" pitchFamily="18" charset="0"/>
            </a:rPr>
            <a:t>control</a:t>
          </a:r>
        </a:p>
      </cdr:txBody>
    </cdr:sp>
  </cdr:relSizeAnchor>
  <cdr:relSizeAnchor xmlns:cdr="http://schemas.openxmlformats.org/drawingml/2006/chartDrawing">
    <cdr:from>
      <cdr:x>0.44446</cdr:x>
      <cdr:y>0.63923</cdr:y>
    </cdr:from>
    <cdr:to>
      <cdr:x>0.4787</cdr:x>
      <cdr:y>0.90648</cdr:y>
    </cdr:to>
    <cdr:sp macro="" textlink="">
      <cdr:nvSpPr>
        <cdr:cNvPr id="34" name="TextBox 1"/>
        <cdr:cNvSpPr txBox="1">
          <a:spLocks xmlns:a="http://schemas.openxmlformats.org/drawingml/2006/main" noChangeAspect="1"/>
        </cdr:cNvSpPr>
      </cdr:nvSpPr>
      <cdr:spPr>
        <a:xfrm xmlns:a="http://schemas.openxmlformats.org/drawingml/2006/main" rot="-4200000">
          <a:off x="2552235" y="1974393"/>
          <a:ext cx="720080" cy="2160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000" b="1" dirty="0" smtClean="0">
              <a:latin typeface="Times New Roman" pitchFamily="18" charset="0"/>
              <a:cs typeface="Times New Roman" pitchFamily="18" charset="0"/>
            </a:rPr>
            <a:t>abRyR3</a:t>
          </a:r>
          <a:endParaRPr lang="en-GB" sz="1000" b="1" dirty="0">
            <a:latin typeface="Times New Roman" pitchFamily="18" charset="0"/>
            <a:cs typeface="Times New Roman" pitchFamily="18" charset="0"/>
          </a:endParaRPr>
        </a:p>
      </cdr:txBody>
    </cdr:sp>
  </cdr:relSizeAnchor>
  <cdr:relSizeAnchor xmlns:cdr="http://schemas.openxmlformats.org/drawingml/2006/chartDrawing">
    <cdr:from>
      <cdr:x>0.48548</cdr:x>
      <cdr:y>0.63826</cdr:y>
    </cdr:from>
    <cdr:to>
      <cdr:x>0.51972</cdr:x>
      <cdr:y>0.90551</cdr:y>
    </cdr:to>
    <cdr:sp macro="" textlink="">
      <cdr:nvSpPr>
        <cdr:cNvPr id="35" name="TextBox 1"/>
        <cdr:cNvSpPr txBox="1">
          <a:spLocks xmlns:a="http://schemas.openxmlformats.org/drawingml/2006/main" noChangeAspect="1"/>
        </cdr:cNvSpPr>
      </cdr:nvSpPr>
      <cdr:spPr>
        <a:xfrm xmlns:a="http://schemas.openxmlformats.org/drawingml/2006/main" rot="-4200000">
          <a:off x="2811004" y="1971787"/>
          <a:ext cx="720080" cy="2160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000" b="1" dirty="0" smtClean="0">
              <a:latin typeface="Times New Roman" pitchFamily="18" charset="0"/>
              <a:cs typeface="Times New Roman" pitchFamily="18" charset="0"/>
            </a:rPr>
            <a:t>abRyR2</a:t>
          </a:r>
          <a:endParaRPr lang="en-GB" sz="1000" b="1" dirty="0">
            <a:latin typeface="Times New Roman" pitchFamily="18" charset="0"/>
            <a:cs typeface="Times New Roman" pitchFamily="18" charset="0"/>
          </a:endParaRPr>
        </a:p>
      </cdr:txBody>
    </cdr:sp>
  </cdr:relSizeAnchor>
  <cdr:relSizeAnchor xmlns:cdr="http://schemas.openxmlformats.org/drawingml/2006/chartDrawing">
    <cdr:from>
      <cdr:x>0.52455</cdr:x>
      <cdr:y>0.64132</cdr:y>
    </cdr:from>
    <cdr:to>
      <cdr:x>0.55879</cdr:x>
      <cdr:y>0.90856</cdr:y>
    </cdr:to>
    <cdr:sp macro="" textlink="">
      <cdr:nvSpPr>
        <cdr:cNvPr id="36" name="TextBox 1"/>
        <cdr:cNvSpPr txBox="1">
          <a:spLocks xmlns:a="http://schemas.openxmlformats.org/drawingml/2006/main" noChangeAspect="1"/>
        </cdr:cNvSpPr>
      </cdr:nvSpPr>
      <cdr:spPr>
        <a:xfrm xmlns:a="http://schemas.openxmlformats.org/drawingml/2006/main" rot="-4200000">
          <a:off x="3057508" y="1980017"/>
          <a:ext cx="720080" cy="2160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000" b="1" dirty="0" smtClean="0">
              <a:latin typeface="Times New Roman" pitchFamily="18" charset="0"/>
              <a:cs typeface="Times New Roman" pitchFamily="18" charset="0"/>
            </a:rPr>
            <a:t>abRyR1</a:t>
          </a:r>
          <a:endParaRPr lang="en-GB" sz="1000" b="1" dirty="0">
            <a:latin typeface="Times New Roman" pitchFamily="18" charset="0"/>
            <a:cs typeface="Times New Roman" pitchFamily="18" charset="0"/>
          </a:endParaRPr>
        </a:p>
      </cdr:txBody>
    </cdr:sp>
  </cdr:relSizeAnchor>
  <cdr:relSizeAnchor xmlns:cdr="http://schemas.openxmlformats.org/drawingml/2006/chartDrawing">
    <cdr:from>
      <cdr:x>0.56846</cdr:x>
      <cdr:y>0.65545</cdr:y>
    </cdr:from>
    <cdr:to>
      <cdr:x>0.6027</cdr:x>
      <cdr:y>0.9227</cdr:y>
    </cdr:to>
    <cdr:sp macro="" textlink="">
      <cdr:nvSpPr>
        <cdr:cNvPr id="37" name="TextBox 1"/>
        <cdr:cNvSpPr txBox="1">
          <a:spLocks xmlns:a="http://schemas.openxmlformats.org/drawingml/2006/main" noChangeAspect="1"/>
        </cdr:cNvSpPr>
      </cdr:nvSpPr>
      <cdr:spPr>
        <a:xfrm xmlns:a="http://schemas.openxmlformats.org/drawingml/2006/main" rot="-4200000">
          <a:off x="3334553" y="2018105"/>
          <a:ext cx="720080" cy="2160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000" b="1" dirty="0" smtClean="0">
              <a:latin typeface="Times New Roman" pitchFamily="18" charset="0"/>
              <a:cs typeface="Times New Roman" pitchFamily="18" charset="0"/>
            </a:rPr>
            <a:t>abRyR1,2</a:t>
          </a:r>
          <a:endParaRPr lang="en-GB" sz="1000" b="1" dirty="0">
            <a:latin typeface="Times New Roman" pitchFamily="18" charset="0"/>
            <a:cs typeface="Times New Roman" pitchFamily="18" charset="0"/>
          </a:endParaRPr>
        </a:p>
      </cdr:txBody>
    </cdr:sp>
  </cdr:relSizeAnchor>
  <cdr:relSizeAnchor xmlns:cdr="http://schemas.openxmlformats.org/drawingml/2006/chartDrawing">
    <cdr:from>
      <cdr:x>0.60469</cdr:x>
      <cdr:y>0.66111</cdr:y>
    </cdr:from>
    <cdr:to>
      <cdr:x>0.63893</cdr:x>
      <cdr:y>0.92836</cdr:y>
    </cdr:to>
    <cdr:sp macro="" textlink="">
      <cdr:nvSpPr>
        <cdr:cNvPr id="38" name="TextBox 1"/>
        <cdr:cNvSpPr txBox="1">
          <a:spLocks xmlns:a="http://schemas.openxmlformats.org/drawingml/2006/main" noChangeAspect="1"/>
        </cdr:cNvSpPr>
      </cdr:nvSpPr>
      <cdr:spPr>
        <a:xfrm xmlns:a="http://schemas.openxmlformats.org/drawingml/2006/main" rot="-4200000">
          <a:off x="3563154" y="2033347"/>
          <a:ext cx="720080" cy="2160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000" b="1" dirty="0" smtClean="0">
              <a:latin typeface="Times New Roman" pitchFamily="18" charset="0"/>
              <a:cs typeface="Times New Roman" pitchFamily="18" charset="0"/>
            </a:rPr>
            <a:t>abRyR1,3</a:t>
          </a:r>
          <a:endParaRPr lang="en-GB" sz="1000" b="1" dirty="0">
            <a:latin typeface="Times New Roman" pitchFamily="18" charset="0"/>
            <a:cs typeface="Times New Roman" pitchFamily="18" charset="0"/>
          </a:endParaRPr>
        </a:p>
      </cdr:txBody>
    </cdr:sp>
  </cdr:relSizeAnchor>
  <cdr:relSizeAnchor xmlns:cdr="http://schemas.openxmlformats.org/drawingml/2006/chartDrawing">
    <cdr:from>
      <cdr:x>0.64647</cdr:x>
      <cdr:y>0.66914</cdr:y>
    </cdr:from>
    <cdr:to>
      <cdr:x>0.68071</cdr:x>
      <cdr:y>0.93638</cdr:y>
    </cdr:to>
    <cdr:sp macro="" textlink="">
      <cdr:nvSpPr>
        <cdr:cNvPr id="39" name="TextBox 1"/>
        <cdr:cNvSpPr txBox="1">
          <a:spLocks xmlns:a="http://schemas.openxmlformats.org/drawingml/2006/main" noChangeAspect="1"/>
        </cdr:cNvSpPr>
      </cdr:nvSpPr>
      <cdr:spPr>
        <a:xfrm xmlns:a="http://schemas.openxmlformats.org/drawingml/2006/main" rot="-4200000">
          <a:off x="3826735" y="2054973"/>
          <a:ext cx="720080" cy="2160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000" b="1" dirty="0" smtClean="0">
              <a:latin typeface="Times New Roman" pitchFamily="18" charset="0"/>
              <a:cs typeface="Times New Roman" pitchFamily="18" charset="0"/>
            </a:rPr>
            <a:t>abRyR1,2,3</a:t>
          </a:r>
          <a:endParaRPr lang="en-GB" sz="1000" b="1" dirty="0">
            <a:latin typeface="Times New Roman" pitchFamily="18" charset="0"/>
            <a:cs typeface="Times New Roman" pitchFamily="18" charset="0"/>
          </a:endParaRPr>
        </a:p>
      </cdr:txBody>
    </cdr:sp>
  </cdr:relSizeAnchor>
  <cdr:relSizeAnchor xmlns:cdr="http://schemas.openxmlformats.org/drawingml/2006/chartDrawing">
    <cdr:from>
      <cdr:x>0.72808</cdr:x>
      <cdr:y>0.6556</cdr:y>
    </cdr:from>
    <cdr:to>
      <cdr:x>0.76492</cdr:x>
      <cdr:y>0.89904</cdr:y>
    </cdr:to>
    <cdr:sp macro="" textlink="">
      <cdr:nvSpPr>
        <cdr:cNvPr id="40" name="TextBox 1"/>
        <cdr:cNvSpPr txBox="1">
          <a:spLocks xmlns:a="http://schemas.openxmlformats.org/drawingml/2006/main" noChangeAspect="1"/>
        </cdr:cNvSpPr>
      </cdr:nvSpPr>
      <cdr:spPr>
        <a:xfrm xmlns:a="http://schemas.openxmlformats.org/drawingml/2006/main" rot="-4200000">
          <a:off x="4381921" y="1978219"/>
          <a:ext cx="655939" cy="23242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000" b="1" dirty="0">
              <a:latin typeface="Times New Roman" pitchFamily="18" charset="0"/>
              <a:cs typeface="Times New Roman" pitchFamily="18" charset="0"/>
            </a:rPr>
            <a:t>control</a:t>
          </a:r>
        </a:p>
      </cdr:txBody>
    </cdr:sp>
  </cdr:relSizeAnchor>
  <cdr:relSizeAnchor xmlns:cdr="http://schemas.openxmlformats.org/drawingml/2006/chartDrawing">
    <cdr:from>
      <cdr:x>0.76894</cdr:x>
      <cdr:y>0.64394</cdr:y>
    </cdr:from>
    <cdr:to>
      <cdr:x>0.80318</cdr:x>
      <cdr:y>0.91119</cdr:y>
    </cdr:to>
    <cdr:sp macro="" textlink="">
      <cdr:nvSpPr>
        <cdr:cNvPr id="41" name="TextBox 1"/>
        <cdr:cNvSpPr txBox="1">
          <a:spLocks xmlns:a="http://schemas.openxmlformats.org/drawingml/2006/main" noChangeAspect="1"/>
        </cdr:cNvSpPr>
      </cdr:nvSpPr>
      <cdr:spPr>
        <a:xfrm xmlns:a="http://schemas.openxmlformats.org/drawingml/2006/main" rot="-4200000">
          <a:off x="4599475" y="1987092"/>
          <a:ext cx="720080" cy="2160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000" b="1" dirty="0" smtClean="0">
              <a:latin typeface="Times New Roman" pitchFamily="18" charset="0"/>
              <a:cs typeface="Times New Roman" pitchFamily="18" charset="0"/>
            </a:rPr>
            <a:t>abRyR3</a:t>
          </a:r>
          <a:endParaRPr lang="en-GB" sz="1000" b="1" dirty="0">
            <a:latin typeface="Times New Roman" pitchFamily="18" charset="0"/>
            <a:cs typeface="Times New Roman" pitchFamily="18" charset="0"/>
          </a:endParaRPr>
        </a:p>
      </cdr:txBody>
    </cdr:sp>
  </cdr:relSizeAnchor>
  <cdr:relSizeAnchor xmlns:cdr="http://schemas.openxmlformats.org/drawingml/2006/chartDrawing">
    <cdr:from>
      <cdr:x>0.80837</cdr:x>
      <cdr:y>0.64414</cdr:y>
    </cdr:from>
    <cdr:to>
      <cdr:x>0.8426</cdr:x>
      <cdr:y>0.91139</cdr:y>
    </cdr:to>
    <cdr:sp macro="" textlink="">
      <cdr:nvSpPr>
        <cdr:cNvPr id="42" name="TextBox 1"/>
        <cdr:cNvSpPr txBox="1">
          <a:spLocks xmlns:a="http://schemas.openxmlformats.org/drawingml/2006/main" noChangeAspect="1"/>
        </cdr:cNvSpPr>
      </cdr:nvSpPr>
      <cdr:spPr>
        <a:xfrm xmlns:a="http://schemas.openxmlformats.org/drawingml/2006/main" rot="-4200000">
          <a:off x="4848207" y="1987635"/>
          <a:ext cx="720080" cy="2160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000" b="1" dirty="0" smtClean="0">
              <a:latin typeface="Times New Roman" pitchFamily="18" charset="0"/>
              <a:cs typeface="Times New Roman" pitchFamily="18" charset="0"/>
            </a:rPr>
            <a:t>abRyR1</a:t>
          </a:r>
          <a:endParaRPr lang="en-GB" sz="1000" b="1" dirty="0">
            <a:latin typeface="Times New Roman" pitchFamily="18" charset="0"/>
            <a:cs typeface="Times New Roman" pitchFamily="18" charset="0"/>
          </a:endParaRPr>
        </a:p>
      </cdr:txBody>
    </cdr:sp>
  </cdr:relSizeAnchor>
  <cdr:relSizeAnchor xmlns:cdr="http://schemas.openxmlformats.org/drawingml/2006/chartDrawing">
    <cdr:from>
      <cdr:x>0.84986</cdr:x>
      <cdr:y>0.65828</cdr:y>
    </cdr:from>
    <cdr:to>
      <cdr:x>0.8841</cdr:x>
      <cdr:y>0.92553</cdr:y>
    </cdr:to>
    <cdr:sp macro="" textlink="">
      <cdr:nvSpPr>
        <cdr:cNvPr id="43" name="TextBox 1"/>
        <cdr:cNvSpPr txBox="1">
          <a:spLocks xmlns:a="http://schemas.openxmlformats.org/drawingml/2006/main" noChangeAspect="1"/>
        </cdr:cNvSpPr>
      </cdr:nvSpPr>
      <cdr:spPr>
        <a:xfrm xmlns:a="http://schemas.openxmlformats.org/drawingml/2006/main" rot="-4200000">
          <a:off x="5110013" y="2025727"/>
          <a:ext cx="720080" cy="2160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000" b="1" dirty="0" smtClean="0">
              <a:latin typeface="Times New Roman" pitchFamily="18" charset="0"/>
              <a:cs typeface="Times New Roman" pitchFamily="18" charset="0"/>
            </a:rPr>
            <a:t>abRyR1,3</a:t>
          </a:r>
          <a:endParaRPr lang="en-GB" sz="1000" b="1" dirty="0">
            <a:latin typeface="Times New Roman" pitchFamily="18" charset="0"/>
            <a:cs typeface="Times New Roman" pitchFamily="18" charset="0"/>
          </a:endParaRPr>
        </a:p>
      </cdr:txBody>
    </cdr:sp>
  </cdr:relSizeAnchor>
  <cdr:relSizeAnchor xmlns:cdr="http://schemas.openxmlformats.org/drawingml/2006/chartDrawing">
    <cdr:from>
      <cdr:x>0.88968</cdr:x>
      <cdr:y>0.67291</cdr:y>
    </cdr:from>
    <cdr:to>
      <cdr:x>0.92392</cdr:x>
      <cdr:y>0.94015</cdr:y>
    </cdr:to>
    <cdr:sp macro="" textlink="">
      <cdr:nvSpPr>
        <cdr:cNvPr id="44" name="TextBox 1"/>
        <cdr:cNvSpPr txBox="1">
          <a:spLocks xmlns:a="http://schemas.openxmlformats.org/drawingml/2006/main" noChangeAspect="1"/>
        </cdr:cNvSpPr>
      </cdr:nvSpPr>
      <cdr:spPr>
        <a:xfrm xmlns:a="http://schemas.openxmlformats.org/drawingml/2006/main" rot="-4200000">
          <a:off x="5361227" y="2065133"/>
          <a:ext cx="720080" cy="2160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000" b="1" dirty="0" smtClean="0">
              <a:latin typeface="Times New Roman" pitchFamily="18" charset="0"/>
              <a:cs typeface="Times New Roman" pitchFamily="18" charset="0"/>
            </a:rPr>
            <a:t>abRyR1,2,3</a:t>
          </a:r>
          <a:endParaRPr lang="en-GB" sz="1000" b="1" dirty="0">
            <a:latin typeface="Times New Roman" pitchFamily="18" charset="0"/>
            <a:cs typeface="Times New Roman" pitchFamily="18" charset="0"/>
          </a:endParaRPr>
        </a:p>
      </cdr:txBody>
    </cdr:sp>
  </cdr:relSizeAnchor>
  <cdr:relSizeAnchor xmlns:cdr="http://schemas.openxmlformats.org/drawingml/2006/chartDrawing">
    <cdr:from>
      <cdr:x>0.9305</cdr:x>
      <cdr:y>0.67444</cdr:y>
    </cdr:from>
    <cdr:to>
      <cdr:x>0.96474</cdr:x>
      <cdr:y>0.94169</cdr:y>
    </cdr:to>
    <cdr:sp macro="" textlink="">
      <cdr:nvSpPr>
        <cdr:cNvPr id="45" name="TextBox 1"/>
        <cdr:cNvSpPr txBox="1">
          <a:spLocks xmlns:a="http://schemas.openxmlformats.org/drawingml/2006/main" noChangeAspect="1"/>
        </cdr:cNvSpPr>
      </cdr:nvSpPr>
      <cdr:spPr>
        <a:xfrm xmlns:a="http://schemas.openxmlformats.org/drawingml/2006/main" rot="-4200000">
          <a:off x="5618780" y="2069264"/>
          <a:ext cx="720080" cy="2160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GB" sz="1000" b="1" dirty="0" smtClean="0">
              <a:latin typeface="Times New Roman" pitchFamily="18" charset="0"/>
              <a:cs typeface="Times New Roman" pitchFamily="18" charset="0"/>
            </a:rPr>
            <a:t>abRyR1,2,3</a:t>
          </a:r>
          <a:endParaRPr lang="en-GB" sz="1000" b="1" dirty="0">
            <a:latin typeface="Times New Roman" pitchFamily="18" charset="0"/>
            <a:cs typeface="Times New Roman" pitchFamily="18" charset="0"/>
          </a:endParaRPr>
        </a:p>
      </cdr:txBody>
    </cdr:sp>
  </cdr:relSizeAnchor>
</c:userShapes>
</file>

<file path=ppt/drawings/drawing7.xml><?xml version="1.0" encoding="utf-8"?>
<c:userShapes xmlns:c="http://schemas.openxmlformats.org/drawingml/2006/chart">
  <cdr:relSizeAnchor xmlns:cdr="http://schemas.openxmlformats.org/drawingml/2006/chartDrawing">
    <cdr:from>
      <cdr:x>0.17687</cdr:x>
      <cdr:y>0.17763</cdr:y>
    </cdr:from>
    <cdr:to>
      <cdr:x>0.59224</cdr:x>
      <cdr:y>0.17763</cdr:y>
    </cdr:to>
    <cdr:sp macro="" textlink="">
      <cdr:nvSpPr>
        <cdr:cNvPr id="2049" name="Line 1"/>
        <cdr:cNvSpPr>
          <a:spLocks xmlns:a="http://schemas.openxmlformats.org/drawingml/2006/main" noChangeShapeType="1"/>
        </cdr:cNvSpPr>
      </cdr:nvSpPr>
      <cdr:spPr bwMode="auto">
        <a:xfrm xmlns:a="http://schemas.openxmlformats.org/drawingml/2006/main" flipV="1">
          <a:off x="610854" y="421108"/>
          <a:ext cx="1434591" cy="0"/>
        </a:xfrm>
        <a:prstGeom xmlns:a="http://schemas.openxmlformats.org/drawingml/2006/main" prst="line">
          <a:avLst/>
        </a:prstGeom>
        <a:noFill xmlns:a="http://schemas.openxmlformats.org/drawingml/2006/main"/>
        <a:ln xmlns:a="http://schemas.openxmlformats.org/drawingml/2006/main" w="25400">
          <a:solidFill>
            <a:srgbClr xmlns:mc="http://schemas.openxmlformats.org/markup-compatibility/2006" xmlns:a14="http://schemas.microsoft.com/office/drawing/2010/main" val="000000" mc:Ignorable="a14" a14:legacySpreadsheetColorIndex="64"/>
          </a:solidFill>
          <a:round/>
          <a:headEnd/>
          <a:tailEnd/>
        </a:ln>
        <a:extLst xmlns:a="http://schemas.openxmlformats.org/drawingml/2006/main">
          <a:ext uri="{909E8E84-426E-40DD-AFC4-6F175D3DCCD1}">
            <a14:hiddenFill xmlns:a14="http://schemas.microsoft.com/office/drawing/2010/main">
              <a:noFill/>
            </a14:hiddenFill>
          </a:ext>
        </a:extLst>
      </cdr:spPr>
    </cdr:sp>
  </cdr:relSizeAnchor>
  <cdr:relSizeAnchor xmlns:cdr="http://schemas.openxmlformats.org/drawingml/2006/chartDrawing">
    <cdr:from>
      <cdr:x>0.17535</cdr:x>
      <cdr:y>0.09112</cdr:y>
    </cdr:from>
    <cdr:to>
      <cdr:x>0.37485</cdr:x>
      <cdr:y>0.1853</cdr:y>
    </cdr:to>
    <cdr:sp macro="" textlink="">
      <cdr:nvSpPr>
        <cdr:cNvPr id="2050" name="Text Box 2"/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605608" y="216024"/>
          <a:ext cx="689022" cy="22325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ffectLst xmlns:a="http://schemas.openxmlformats.org/drawingml/2006/main"/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xmlns:mc="http://schemas.openxmlformats.org/markup-compatibility/2006" val="000000" mc:Ignorable="a14" a14:legacySpreadsheetColorIndex="64"/>
              </a:solidFill>
            </a14:hiddenFill>
          </a:ext>
          <a:ext uri="{91240B29-F687-4F45-9708-019B960494DF}">
            <a14:hiddenLine xmlns:a14="http://schemas.microsoft.com/office/drawing/2010/main" w="1">
              <a:solidFill>
                <a:srgbClr xmlns:mc="http://schemas.openxmlformats.org/markup-compatibility/2006" val="FFFFFF" mc:Ignorable="a14" a14:legacySpreadsheetColorIndex="65"/>
              </a:solidFill>
              <a:miter lim="800000"/>
              <a:headEnd/>
              <a:tailEnd/>
            </a14:hiddenLine>
          </a:ex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rgbClr val="808080"/>
                </a:outerShdw>
              </a:effectLst>
            </a14:hiddenEffects>
          </a:ext>
        </a:extLst>
      </cdr:spPr>
      <cdr:txBody>
        <a:bodyPr xmlns:a="http://schemas.openxmlformats.org/drawingml/2006/main" vertOverflow="clip" wrap="square" lIns="36576" tIns="32004" rIns="36576" bIns="32004" anchor="ctr" upright="1"/>
        <a:lstStyle xmlns:a="http://schemas.openxmlformats.org/drawingml/2006/main"/>
        <a:p xmlns:a="http://schemas.openxmlformats.org/drawingml/2006/main">
          <a:pPr algn="ctr" rtl="0">
            <a:defRPr sz="1000"/>
          </a:pPr>
          <a:r>
            <a:rPr lang="en-GB" sz="1200" b="1" i="0" u="none" strike="noStrike" baseline="0" dirty="0" smtClean="0">
              <a:solidFill>
                <a:srgbClr val="000000"/>
              </a:solidFill>
              <a:latin typeface="Times New Roman"/>
              <a:cs typeface="Times New Roman"/>
            </a:rPr>
            <a:t>NAADP</a:t>
          </a:r>
          <a:endParaRPr lang="en-GB" sz="1200" b="1" i="0" u="none" strike="noStrike" baseline="0" dirty="0">
            <a:solidFill>
              <a:srgbClr val="000000"/>
            </a:solidFill>
            <a:latin typeface="Times New Roman"/>
            <a:cs typeface="Times New Roman"/>
          </a:endParaRPr>
        </a:p>
      </cdr:txBody>
    </cdr:sp>
  </cdr:relSizeAnchor>
  <cdr:relSizeAnchor xmlns:cdr="http://schemas.openxmlformats.org/drawingml/2006/chartDrawing">
    <cdr:from>
      <cdr:x>0.11215</cdr:x>
      <cdr:y>0</cdr:y>
    </cdr:from>
    <cdr:to>
      <cdr:x>0.32281</cdr:x>
      <cdr:y>0.10943</cdr:y>
    </cdr:to>
    <cdr:sp macro="" textlink="">
      <cdr:nvSpPr>
        <cdr:cNvPr id="2053" name="Text Box 5"/>
        <cdr:cNvSpPr txBox="1">
          <a:spLocks xmlns:a="http://schemas.openxmlformats.org/drawingml/2006/main" noChangeArrowheads="1"/>
        </cdr:cNvSpPr>
      </cdr:nvSpPr>
      <cdr:spPr bwMode="auto">
        <a:xfrm xmlns:a="http://schemas.openxmlformats.org/drawingml/2006/main">
          <a:off x="387338" y="0"/>
          <a:ext cx="727573" cy="251835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noFill/>
        </a:ln>
        <a:effectLst xmlns:a="http://schemas.openxmlformats.org/drawingml/2006/main"/>
        <a:extLst xmlns:a="http://schemas.openxmlformats.org/drawingml/2006/main">
          <a:ext uri="{909E8E84-426E-40DD-AFC4-6F175D3DCCD1}">
            <a14:hiddenFill xmlns:a14="http://schemas.microsoft.com/office/drawing/2010/main">
              <a:solidFill>
                <a:srgbClr xmlns:mc="http://schemas.openxmlformats.org/markup-compatibility/2006" val="000000" mc:Ignorable="a14" a14:legacySpreadsheetColorIndex="64"/>
              </a:solidFill>
            </a14:hiddenFill>
          </a:ext>
          <a:ext uri="{91240B29-F687-4F45-9708-019B960494DF}">
            <a14:hiddenLine xmlns:a14="http://schemas.microsoft.com/office/drawing/2010/main" w="1">
              <a:solidFill>
                <a:srgbClr xmlns:mc="http://schemas.openxmlformats.org/markup-compatibility/2006" val="FFFFFF" mc:Ignorable="a14" a14:legacySpreadsheetColorIndex="65"/>
              </a:solidFill>
              <a:miter lim="800000"/>
              <a:headEnd/>
              <a:tailEnd/>
            </a14:hiddenLine>
          </a:ex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rgbClr val="808080"/>
                </a:outerShdw>
              </a:effectLst>
            </a14:hiddenEffects>
          </a:ext>
        </a:extLst>
      </cdr:spPr>
      <cdr:txBody>
        <a:bodyPr xmlns:a="http://schemas.openxmlformats.org/drawingml/2006/main" wrap="square" lIns="27432" tIns="32004" rIns="27432" bIns="32004" anchor="ctr" upright="1">
          <a:spAutoFit/>
        </a:bodyPr>
        <a:lstStyle xmlns:a="http://schemas.openxmlformats.org/drawingml/2006/main"/>
        <a:p xmlns:a="http://schemas.openxmlformats.org/drawingml/2006/main">
          <a:pPr algn="ctr" rtl="0">
            <a:defRPr sz="1000"/>
          </a:pPr>
          <a:r>
            <a:rPr lang="en-GB" sz="1200" b="1" dirty="0">
              <a:solidFill>
                <a:srgbClr val="000000"/>
              </a:solidFill>
              <a:latin typeface="Times New Roman"/>
              <a:cs typeface="Times New Roman"/>
            </a:rPr>
            <a:t>a</a:t>
          </a:r>
          <a:r>
            <a:rPr lang="en-GB" sz="1200" b="1" dirty="0" smtClean="0">
              <a:solidFill>
                <a:srgbClr val="000000"/>
              </a:solidFill>
              <a:latin typeface="Times New Roman"/>
              <a:cs typeface="Times New Roman"/>
            </a:rPr>
            <a:t>b </a:t>
          </a:r>
          <a:r>
            <a:rPr lang="en-GB" sz="1200" b="1" i="0" u="none" strike="noStrike" baseline="0" dirty="0" err="1" smtClean="0">
              <a:solidFill>
                <a:srgbClr val="000000"/>
              </a:solidFill>
              <a:latin typeface="Times New Roman"/>
              <a:cs typeface="Times New Roman"/>
            </a:rPr>
            <a:t>RyR</a:t>
          </a:r>
          <a:r>
            <a:rPr lang="en-GB" sz="1200" b="1" i="0" u="none" strike="noStrike" baseline="0" dirty="0" smtClean="0">
              <a:solidFill>
                <a:srgbClr val="000000"/>
              </a:solidFill>
              <a:latin typeface="Times New Roman"/>
              <a:cs typeface="Times New Roman"/>
            </a:rPr>
            <a:t> 3</a:t>
          </a:r>
          <a:endParaRPr lang="en-GB" sz="1200" b="1" i="0" u="none" strike="noStrike" baseline="0" dirty="0">
            <a:solidFill>
              <a:srgbClr val="000000"/>
            </a:solidFill>
            <a:latin typeface="Times New Roman"/>
            <a:cs typeface="Times New Roman"/>
          </a:endParaRPr>
        </a:p>
      </cdr:txBody>
    </cdr:sp>
  </cdr:relSizeAnchor>
  <cdr:relSizeAnchor xmlns:cdr="http://schemas.openxmlformats.org/drawingml/2006/chartDrawing">
    <cdr:from>
      <cdr:x>0.09347</cdr:x>
      <cdr:y>0.09112</cdr:y>
    </cdr:from>
    <cdr:to>
      <cdr:x>0.88565</cdr:x>
      <cdr:y>0.09112</cdr:y>
    </cdr:to>
    <cdr:sp macro="" textlink="">
      <cdr:nvSpPr>
        <cdr:cNvPr id="7" name="Line 1"/>
        <cdr:cNvSpPr>
          <a:spLocks xmlns:a="http://schemas.openxmlformats.org/drawingml/2006/main" noChangeShapeType="1"/>
        </cdr:cNvSpPr>
      </cdr:nvSpPr>
      <cdr:spPr bwMode="auto">
        <a:xfrm xmlns:a="http://schemas.openxmlformats.org/drawingml/2006/main" flipV="1">
          <a:off x="322822" y="216024"/>
          <a:ext cx="2736000" cy="0"/>
        </a:xfrm>
        <a:prstGeom xmlns:a="http://schemas.openxmlformats.org/drawingml/2006/main" prst="line">
          <a:avLst/>
        </a:prstGeom>
        <a:noFill xmlns:a="http://schemas.openxmlformats.org/drawingml/2006/main"/>
        <a:ln xmlns:a="http://schemas.openxmlformats.org/drawingml/2006/main" w="25400">
          <a:solidFill>
            <a:srgbClr xmlns:mc="http://schemas.openxmlformats.org/markup-compatibility/2006" xmlns:a14="http://schemas.microsoft.com/office/drawing/2010/main" val="000000" mc:Ignorable="a14" a14:legacySpreadsheetColorIndex="64"/>
          </a:solidFill>
          <a:round/>
          <a:headEnd/>
          <a:tailEnd/>
        </a:ln>
        <a:extLst xmlns:a="http://schemas.openxmlformats.org/drawingml/2006/main">
          <a:ext uri="{909E8E84-426E-40DD-AFC4-6F175D3DCCD1}">
            <a14:hiddenFill xmlns:a14="http://schemas.microsoft.com/office/drawing/2010/main">
              <a:noFill/>
            </a14:hiddenFill>
          </a:ext>
        </a:extLst>
      </cdr:spPr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50317" cy="497285"/>
          </a:xfrm>
          <a:prstGeom prst="rect">
            <a:avLst/>
          </a:prstGeom>
        </p:spPr>
        <p:txBody>
          <a:bodyPr vert="horz" lIns="91550" tIns="45775" rIns="91550" bIns="45775" rtlCol="0"/>
          <a:lstStyle>
            <a:lvl1pPr algn="l">
              <a:defRPr sz="1200"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5293" y="0"/>
            <a:ext cx="2950317" cy="497285"/>
          </a:xfrm>
          <a:prstGeom prst="rect">
            <a:avLst/>
          </a:prstGeom>
        </p:spPr>
        <p:txBody>
          <a:bodyPr vert="horz" lIns="91550" tIns="45775" rIns="91550" bIns="45775" rtlCol="0"/>
          <a:lstStyle>
            <a:lvl1pPr algn="r">
              <a:defRPr sz="1200"/>
            </a:lvl1pPr>
          </a:lstStyle>
          <a:p>
            <a:pPr>
              <a:defRPr/>
            </a:pPr>
            <a:fld id="{353E0444-A95E-4F13-A3BC-CB55FACD5CF2}" type="datetimeFigureOut">
              <a:rPr lang="en-GB"/>
              <a:pPr>
                <a:defRPr/>
              </a:pPr>
              <a:t>13/04/201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12963" y="744538"/>
            <a:ext cx="2581275" cy="3727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550" tIns="45775" rIns="91550" bIns="45775" rtlCol="0" anchor="ctr"/>
          <a:lstStyle/>
          <a:p>
            <a:pPr lvl="0"/>
            <a:endParaRPr lang="en-GB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720" y="4721821"/>
            <a:ext cx="5445760" cy="4472385"/>
          </a:xfrm>
          <a:prstGeom prst="rect">
            <a:avLst/>
          </a:prstGeom>
        </p:spPr>
        <p:txBody>
          <a:bodyPr vert="horz" lIns="91550" tIns="45775" rIns="91550" bIns="45775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GB" noProof="0" smtClean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440465"/>
            <a:ext cx="2950317" cy="497285"/>
          </a:xfrm>
          <a:prstGeom prst="rect">
            <a:avLst/>
          </a:prstGeom>
        </p:spPr>
        <p:txBody>
          <a:bodyPr vert="horz" lIns="91550" tIns="45775" rIns="91550" bIns="45775" rtlCol="0" anchor="b"/>
          <a:lstStyle>
            <a:lvl1pPr algn="l">
              <a:defRPr sz="1200"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5293" y="9440465"/>
            <a:ext cx="2950317" cy="497285"/>
          </a:xfrm>
          <a:prstGeom prst="rect">
            <a:avLst/>
          </a:prstGeom>
        </p:spPr>
        <p:txBody>
          <a:bodyPr vert="horz" lIns="91550" tIns="45775" rIns="91550" bIns="45775" rtlCol="0" anchor="b"/>
          <a:lstStyle>
            <a:lvl1pPr algn="r">
              <a:defRPr sz="1200"/>
            </a:lvl1pPr>
          </a:lstStyle>
          <a:p>
            <a:pPr>
              <a:defRPr/>
            </a:pPr>
            <a:fld id="{F350ACFC-64ED-44B4-9746-F60294E4D0BE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458289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8195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en-GB" altLang="en-US" dirty="0" smtClean="0"/>
          </a:p>
        </p:txBody>
      </p:sp>
      <p:sp>
        <p:nvSpPr>
          <p:cNvPr id="8196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Ctr="0" compatLnSpc="1">
            <a:prstTxWarp prst="textNoShape">
              <a:avLst/>
            </a:prstTxWarp>
          </a:bodyPr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</a:defRPr>
            </a:lvl1pPr>
            <a:lvl2pPr marL="743842" indent="-28609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</a:defRPr>
            </a:lvl2pPr>
            <a:lvl3pPr marL="1144372" indent="-228874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</a:defRPr>
            </a:lvl3pPr>
            <a:lvl4pPr marL="1602120" indent="-228874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</a:defRPr>
            </a:lvl4pPr>
            <a:lvl5pPr marL="2059869" indent="-228874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Calibri" pitchFamily="34" charset="0"/>
              </a:defRPr>
            </a:lvl5pPr>
            <a:lvl6pPr marL="2517618" indent="-228874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</a:defRPr>
            </a:lvl6pPr>
            <a:lvl7pPr marL="2975366" indent="-228874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</a:defRPr>
            </a:lvl7pPr>
            <a:lvl8pPr marL="3433115" indent="-228874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</a:defRPr>
            </a:lvl8pPr>
            <a:lvl9pPr marL="3890863" indent="-228874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</a:pPr>
            <a:fld id="{7A930DE6-E0F6-45BA-BF98-9673FD58EDB8}" type="slidenum">
              <a:rPr lang="en-GB" altLang="en-US" smtClean="0">
                <a:latin typeface="Arial" charset="0"/>
              </a:rPr>
              <a:pPr eaLnBrk="1" hangingPunct="1">
                <a:spcBef>
                  <a:spcPct val="0"/>
                </a:spcBef>
              </a:pPr>
              <a:t>1</a:t>
            </a:fld>
            <a:endParaRPr lang="en-GB" altLang="en-US" smtClean="0">
              <a:latin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698017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870C032-3B2A-4037-8BBD-3CA1836B4035}" type="datetimeFigureOut">
              <a:rPr lang="en-US"/>
              <a:pPr>
                <a:defRPr/>
              </a:pPr>
              <a:t>4/13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4F9F85-CE6E-4C88-B349-ABC24D3C6CDF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70787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52B1DA-F36E-4AAE-BEC3-1C08AF02F0D8}" type="datetimeFigureOut">
              <a:rPr lang="en-US"/>
              <a:pPr>
                <a:defRPr/>
              </a:pPr>
              <a:t>4/13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93FDF2-D0FA-457F-8076-E7DC30C93E8D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56711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B95D0E4-FE3F-4252-A6A5-930C4D81EFC4}" type="datetimeFigureOut">
              <a:rPr lang="en-US"/>
              <a:pPr>
                <a:defRPr/>
              </a:pPr>
              <a:t>4/13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E016A17-6E51-4DB8-96B6-3B404BD4E45C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3056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F68D44D-EC95-48E2-8EFC-9FAC0B29E493}" type="datetimeFigureOut">
              <a:rPr lang="en-US"/>
              <a:pPr>
                <a:defRPr/>
              </a:pPr>
              <a:t>4/13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C0B9B2-CFF0-4EF2-9A10-A795D5010CD0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43257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9E79118-A8F1-44CE-B267-4DEA64898A1F}" type="datetimeFigureOut">
              <a:rPr lang="en-US"/>
              <a:pPr>
                <a:defRPr/>
              </a:pPr>
              <a:t>4/13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6E152A8-3245-4A20-94B4-23803D73DF5B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30246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F68A6E-5FD6-47BF-866E-9D72C0B1E549}" type="datetimeFigureOut">
              <a:rPr lang="en-US"/>
              <a:pPr>
                <a:defRPr/>
              </a:pPr>
              <a:t>4/13/2015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06242B-3E83-466F-AFA3-A6D14638B464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20001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52FB72B-C15D-4A4A-8D69-3BC36CE99FBD}" type="datetimeFigureOut">
              <a:rPr lang="en-US"/>
              <a:pPr>
                <a:defRPr/>
              </a:pPr>
              <a:t>4/13/2015</a:t>
            </a:fld>
            <a:endParaRPr lang="en-GB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83B8459-5341-47A2-AAFA-358FF3FC6205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39224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11B736-4320-47D2-9786-C3B15B8419B1}" type="datetimeFigureOut">
              <a:rPr lang="en-US"/>
              <a:pPr>
                <a:defRPr/>
              </a:pPr>
              <a:t>4/13/2015</a:t>
            </a:fld>
            <a:endParaRPr lang="en-GB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4D7804A-1510-42D1-B5A9-EF45B1ECEA48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55284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EB332D-680C-4811-B8DF-5F0C96ED6EC1}" type="datetimeFigureOut">
              <a:rPr lang="en-US"/>
              <a:pPr>
                <a:defRPr/>
              </a:pPr>
              <a:t>4/13/2015</a:t>
            </a:fld>
            <a:endParaRPr lang="en-GB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9E0DD8-AB12-453F-A067-A829CE952BAE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70323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2F82777-E99C-4ACC-8F66-D2D6D522E481}" type="datetimeFigureOut">
              <a:rPr lang="en-US"/>
              <a:pPr>
                <a:defRPr/>
              </a:pPr>
              <a:t>4/13/2015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AFEB45A-D13B-4D1B-AF13-4913444FF434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80408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9194C61-C977-4945-A6EC-3BF41FC2F053}" type="datetimeFigureOut">
              <a:rPr lang="en-US"/>
              <a:pPr>
                <a:defRPr/>
              </a:pPr>
              <a:t>4/13/2015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708FF2-671C-425B-B284-FF54B4DCBD6E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22305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  <a:endParaRPr lang="en-GB" altLang="en-US" smtClean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  <a:endParaRPr lang="en-GB" altLang="en-US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2100"/>
            <a:ext cx="16002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E90ABE16-049E-4E38-B39A-D37CDCCDF295}" type="datetimeFigureOut">
              <a:rPr lang="en-US"/>
              <a:pPr>
                <a:defRPr/>
              </a:pPr>
              <a:t>4/13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2100"/>
            <a:ext cx="21717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2100"/>
            <a:ext cx="16002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B2834D5A-05E5-4BE3-BEF5-8CD33DEEBED0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Relationship Id="rId9" Type="http://schemas.openxmlformats.org/officeDocument/2006/relationships/chart" Target="../charts/char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extBox 1"/>
          <p:cNvSpPr txBox="1">
            <a:spLocks noChangeArrowheads="1"/>
          </p:cNvSpPr>
          <p:nvPr/>
        </p:nvSpPr>
        <p:spPr bwMode="auto">
          <a:xfrm>
            <a:off x="-99392" y="9669807"/>
            <a:ext cx="2452033" cy="3394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 dirty="0" err="1" smtClean="0"/>
              <a:t>Supplemenary</a:t>
            </a:r>
            <a:r>
              <a:rPr lang="en-GB" altLang="en-US" sz="1100" dirty="0" smtClean="0"/>
              <a:t> Fig.</a:t>
            </a:r>
            <a:endParaRPr lang="en-GB" altLang="en-US" sz="1100" dirty="0"/>
          </a:p>
        </p:txBody>
      </p:sp>
      <p:graphicFrame>
        <p:nvGraphicFramePr>
          <p:cNvPr id="11" name="Char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42966924"/>
              </p:ext>
            </p:extLst>
          </p:nvPr>
        </p:nvGraphicFramePr>
        <p:xfrm>
          <a:off x="1" y="207146"/>
          <a:ext cx="3455744" cy="23762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1" name="Chart 20"/>
          <p:cNvGraphicFramePr/>
          <p:nvPr>
            <p:extLst>
              <p:ext uri="{D42A27DB-BD31-4B8C-83A1-F6EECF244321}">
                <p14:modId xmlns:p14="http://schemas.microsoft.com/office/powerpoint/2010/main" val="4138038767"/>
              </p:ext>
            </p:extLst>
          </p:nvPr>
        </p:nvGraphicFramePr>
        <p:xfrm>
          <a:off x="3439264" y="68397"/>
          <a:ext cx="3356992" cy="2843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052" name="TextBox 9"/>
          <p:cNvSpPr txBox="1">
            <a:spLocks noChangeArrowheads="1"/>
          </p:cNvSpPr>
          <p:nvPr/>
        </p:nvSpPr>
        <p:spPr bwMode="auto">
          <a:xfrm>
            <a:off x="3433388" y="-44370"/>
            <a:ext cx="350838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800" b="1" dirty="0">
                <a:latin typeface="Arial" charset="0"/>
              </a:rPr>
              <a:t>B</a:t>
            </a:r>
          </a:p>
        </p:txBody>
      </p:sp>
      <p:sp>
        <p:nvSpPr>
          <p:cNvPr id="24" name="Text Box 1"/>
          <p:cNvSpPr txBox="1">
            <a:spLocks noChangeArrowheads="1"/>
          </p:cNvSpPr>
          <p:nvPr/>
        </p:nvSpPr>
        <p:spPr bwMode="auto">
          <a:xfrm>
            <a:off x="3569741" y="200472"/>
            <a:ext cx="357670" cy="246917"/>
          </a:xfrm>
          <a:prstGeom prst="rect">
            <a:avLst/>
          </a:prstGeom>
          <a:noFill/>
          <a:ln w="1">
            <a:noFill/>
            <a:miter lim="800000"/>
            <a:headEnd/>
            <a:tailEnd/>
          </a:ln>
          <a:effectLst/>
        </p:spPr>
        <p:txBody>
          <a:bodyPr wrap="square" lIns="18288" tIns="27432" rIns="18288" bIns="27432" anchor="ctr" upright="1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 rtl="0">
              <a:defRPr sz="1000"/>
            </a:pPr>
            <a:r>
              <a:rPr lang="en-GB" sz="1200" b="1" i="0" u="none" strike="noStrike" baseline="0" dirty="0">
                <a:solidFill>
                  <a:srgbClr val="000000"/>
                </a:solidFill>
                <a:latin typeface="Times New Roman"/>
                <a:cs typeface="Times New Roman"/>
              </a:rPr>
              <a:t>F/</a:t>
            </a:r>
            <a:r>
              <a:rPr lang="en-GB" sz="1200" b="1" i="0" u="none" strike="noStrike" baseline="0" dirty="0" err="1">
                <a:solidFill>
                  <a:srgbClr val="000000"/>
                </a:solidFill>
                <a:latin typeface="Times New Roman"/>
                <a:cs typeface="Times New Roman"/>
              </a:rPr>
              <a:t>Fo</a:t>
            </a:r>
            <a:endParaRPr lang="en-GB" sz="1200" b="1" i="0" u="none" strike="noStrike" baseline="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2053" name="TextBox 10"/>
          <p:cNvSpPr txBox="1">
            <a:spLocks noChangeArrowheads="1"/>
          </p:cNvSpPr>
          <p:nvPr/>
        </p:nvSpPr>
        <p:spPr bwMode="auto">
          <a:xfrm>
            <a:off x="0" y="2360712"/>
            <a:ext cx="350838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800" b="1">
                <a:latin typeface="Arial" charset="0"/>
              </a:rPr>
              <a:t>C</a:t>
            </a:r>
          </a:p>
        </p:txBody>
      </p:sp>
      <p:sp>
        <p:nvSpPr>
          <p:cNvPr id="2054" name="TextBox 11"/>
          <p:cNvSpPr txBox="1">
            <a:spLocks noChangeArrowheads="1"/>
          </p:cNvSpPr>
          <p:nvPr/>
        </p:nvSpPr>
        <p:spPr bwMode="auto">
          <a:xfrm>
            <a:off x="3417888" y="2370237"/>
            <a:ext cx="352425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800" b="1">
                <a:latin typeface="Arial" charset="0"/>
              </a:rPr>
              <a:t>D</a:t>
            </a:r>
          </a:p>
        </p:txBody>
      </p:sp>
      <p:graphicFrame>
        <p:nvGraphicFramePr>
          <p:cNvPr id="13" name="Char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39967820"/>
              </p:ext>
            </p:extLst>
          </p:nvPr>
        </p:nvGraphicFramePr>
        <p:xfrm>
          <a:off x="0" y="2648521"/>
          <a:ext cx="3467099" cy="23738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4" name="Chart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5177102"/>
              </p:ext>
            </p:extLst>
          </p:nvPr>
        </p:nvGraphicFramePr>
        <p:xfrm>
          <a:off x="3428999" y="2608568"/>
          <a:ext cx="3428723" cy="25531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2058" name="TextBox 10"/>
          <p:cNvSpPr txBox="1">
            <a:spLocks noChangeArrowheads="1"/>
          </p:cNvSpPr>
          <p:nvPr/>
        </p:nvSpPr>
        <p:spPr bwMode="auto">
          <a:xfrm>
            <a:off x="-16710" y="4689177"/>
            <a:ext cx="3524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800" b="1" dirty="0">
                <a:latin typeface="Arial" charset="0"/>
              </a:rPr>
              <a:t>E</a:t>
            </a:r>
          </a:p>
        </p:txBody>
      </p:sp>
      <p:sp>
        <p:nvSpPr>
          <p:cNvPr id="2065" name="TextBox 10"/>
          <p:cNvSpPr txBox="1">
            <a:spLocks noChangeArrowheads="1"/>
          </p:cNvSpPr>
          <p:nvPr/>
        </p:nvSpPr>
        <p:spPr bwMode="auto">
          <a:xfrm>
            <a:off x="3444875" y="4717896"/>
            <a:ext cx="325438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800" b="1" dirty="0">
                <a:latin typeface="Arial" charset="0"/>
              </a:rPr>
              <a:t>F</a:t>
            </a:r>
          </a:p>
        </p:txBody>
      </p:sp>
      <p:graphicFrame>
        <p:nvGraphicFramePr>
          <p:cNvPr id="23" name="Chart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25768341"/>
              </p:ext>
            </p:extLst>
          </p:nvPr>
        </p:nvGraphicFramePr>
        <p:xfrm>
          <a:off x="3652117" y="4961384"/>
          <a:ext cx="3233267" cy="24768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051" name="TextBox 8"/>
          <p:cNvSpPr txBox="1">
            <a:spLocks noChangeArrowheads="1"/>
          </p:cNvSpPr>
          <p:nvPr/>
        </p:nvSpPr>
        <p:spPr bwMode="auto">
          <a:xfrm>
            <a:off x="-21570" y="-26402"/>
            <a:ext cx="350838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800" b="1" dirty="0">
                <a:latin typeface="Arial" charset="0"/>
              </a:rPr>
              <a:t>A</a:t>
            </a:r>
          </a:p>
        </p:txBody>
      </p:sp>
      <p:sp>
        <p:nvSpPr>
          <p:cNvPr id="26" name="Text Box 2"/>
          <p:cNvSpPr txBox="1">
            <a:spLocks noChangeArrowheads="1"/>
          </p:cNvSpPr>
          <p:nvPr/>
        </p:nvSpPr>
        <p:spPr bwMode="auto">
          <a:xfrm>
            <a:off x="2564904" y="7178101"/>
            <a:ext cx="576064" cy="2492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xmlns:mc="http://schemas.openxmlformats.org/markup-compatibility/2006" val="000000" mc:Ignorable="a14" a14:legacySpreadsheetColorIndex="64"/>
                </a:solidFill>
              </a14:hiddenFill>
            </a:ext>
            <a:ext uri="{91240B29-F687-4F45-9708-019B960494DF}">
              <a14:hiddenLine xmlns:a14="http://schemas.microsoft.com/office/drawing/2010/main" w="1">
                <a:solidFill>
                  <a:srgbClr xmlns:mc="http://schemas.openxmlformats.org/markup-compatibility/2006" val="FFFFFF" mc:Ignorable="a14" a14:legacySpreadsheetColorIndex="65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square" lIns="27432" tIns="32004" rIns="27432" bIns="32004" anchor="ctr" upright="1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 rtl="0">
              <a:defRPr sz="1000"/>
            </a:pPr>
            <a:r>
              <a:rPr lang="en-GB" sz="1200" b="1" i="0" u="none" strike="noStrike" baseline="0" dirty="0">
                <a:solidFill>
                  <a:srgbClr val="000000"/>
                </a:solidFill>
                <a:latin typeface="Times New Roman"/>
                <a:cs typeface="Times New Roman"/>
              </a:rPr>
              <a:t>Time, s</a:t>
            </a:r>
          </a:p>
        </p:txBody>
      </p:sp>
      <p:sp>
        <p:nvSpPr>
          <p:cNvPr id="27" name="TextBox 10"/>
          <p:cNvSpPr txBox="1">
            <a:spLocks noChangeArrowheads="1"/>
          </p:cNvSpPr>
          <p:nvPr/>
        </p:nvSpPr>
        <p:spPr bwMode="auto">
          <a:xfrm>
            <a:off x="-11470" y="7178976"/>
            <a:ext cx="364202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800" b="1" dirty="0" smtClean="0">
                <a:latin typeface="Arial" charset="0"/>
              </a:rPr>
              <a:t>G</a:t>
            </a:r>
            <a:endParaRPr lang="en-GB" altLang="en-US" sz="1800" b="1" dirty="0">
              <a:latin typeface="Arial" charset="0"/>
            </a:endParaRPr>
          </a:p>
        </p:txBody>
      </p:sp>
      <p:graphicFrame>
        <p:nvGraphicFramePr>
          <p:cNvPr id="30" name="Chart 2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91583372"/>
              </p:ext>
            </p:extLst>
          </p:nvPr>
        </p:nvGraphicFramePr>
        <p:xfrm>
          <a:off x="186798" y="7302750"/>
          <a:ext cx="6317621" cy="25991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32" name="TextBox 1"/>
          <p:cNvSpPr txBox="1"/>
          <p:nvPr/>
        </p:nvSpPr>
        <p:spPr>
          <a:xfrm>
            <a:off x="6165304" y="9513933"/>
            <a:ext cx="630168" cy="387923"/>
          </a:xfrm>
          <a:prstGeom prst="rect">
            <a:avLst/>
          </a:prstGeom>
          <a:solidFill>
            <a:srgbClr val="CC99FF"/>
          </a:solidFill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b="1" dirty="0" smtClean="0">
                <a:latin typeface="Times New Roman" pitchFamily="18" charset="0"/>
                <a:cs typeface="Times New Roman" pitchFamily="18" charset="0"/>
              </a:rPr>
              <a:t>200 </a:t>
            </a:r>
            <a:r>
              <a:rPr lang="en-GB" sz="1000" b="1" dirty="0" err="1" smtClean="0">
                <a:latin typeface="Symbol" pitchFamily="18" charset="2"/>
                <a:cs typeface="Times New Roman" pitchFamily="18" charset="0"/>
              </a:rPr>
              <a:t>m</a:t>
            </a:r>
            <a:r>
              <a:rPr lang="en-GB" sz="1000" b="1" dirty="0" err="1" smtClean="0">
                <a:latin typeface="Times New Roman" pitchFamily="18" charset="0"/>
                <a:cs typeface="Times New Roman" pitchFamily="18" charset="0"/>
              </a:rPr>
              <a:t>M</a:t>
            </a:r>
            <a:endParaRPr lang="en-GB" sz="1000" b="1" dirty="0" smtClean="0">
              <a:latin typeface="Times New Roman" pitchFamily="18" charset="0"/>
              <a:cs typeface="Times New Roman" pitchFamily="18" charset="0"/>
            </a:endParaRPr>
          </a:p>
          <a:p>
            <a:pPr algn="ctr"/>
            <a:r>
              <a:rPr lang="en-GB" sz="1000" b="1" dirty="0" smtClean="0">
                <a:latin typeface="Times New Roman" pitchFamily="18" charset="0"/>
                <a:cs typeface="Times New Roman" pitchFamily="18" charset="0"/>
              </a:rPr>
              <a:t>TPEN</a:t>
            </a:r>
            <a:endParaRPr lang="en-GB" sz="1000" b="1" baseline="-250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33" name="Chart 3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633484"/>
              </p:ext>
            </p:extLst>
          </p:nvPr>
        </p:nvGraphicFramePr>
        <p:xfrm>
          <a:off x="153849" y="5022376"/>
          <a:ext cx="3453745" cy="23013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20" name="Text Box 3"/>
          <p:cNvSpPr txBox="1">
            <a:spLocks noChangeArrowheads="1"/>
          </p:cNvSpPr>
          <p:nvPr/>
        </p:nvSpPr>
        <p:spPr bwMode="auto">
          <a:xfrm>
            <a:off x="43829" y="4914270"/>
            <a:ext cx="524517" cy="2971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xmlns:mc="http://schemas.openxmlformats.org/markup-compatibility/2006" val="000000" mc:Ignorable="a14" a14:legacySpreadsheetColorIndex="64"/>
                </a:solidFill>
              </a14:hiddenFill>
            </a:ext>
            <a:ext uri="{91240B29-F687-4F45-9708-019B960494DF}">
              <a14:hiddenLine xmlns:a14="http://schemas.microsoft.com/office/drawing/2010/main" w="1">
                <a:solidFill>
                  <a:srgbClr xmlns:mc="http://schemas.openxmlformats.org/markup-compatibility/2006" val="FFFFFF" mc:Ignorable="a14" a14:legacySpreadsheetColorIndex="65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wrap="square" lIns="36576" tIns="32004" rIns="36576" bIns="32004" anchor="ctr" upright="1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 rtl="0">
              <a:defRPr sz="1000"/>
            </a:pPr>
            <a:r>
              <a:rPr lang="en-GB" sz="1200" b="1" i="0" u="none" strike="noStrike" baseline="0" dirty="0">
                <a:solidFill>
                  <a:srgbClr val="000000"/>
                </a:solidFill>
                <a:latin typeface="Times New Roman"/>
                <a:cs typeface="Times New Roman"/>
              </a:rPr>
              <a:t>F/</a:t>
            </a:r>
            <a:r>
              <a:rPr lang="en-GB" sz="1200" b="1" i="0" u="none" strike="noStrike" baseline="0" dirty="0" err="1">
                <a:solidFill>
                  <a:srgbClr val="000000"/>
                </a:solidFill>
                <a:latin typeface="Times New Roman"/>
                <a:cs typeface="Times New Roman"/>
              </a:rPr>
              <a:t>Fo</a:t>
            </a:r>
            <a:endParaRPr lang="en-GB" sz="1200" b="1" i="0" u="none" strike="noStrike" baseline="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228</TotalTime>
  <Words>106</Words>
  <Application>Microsoft Office PowerPoint</Application>
  <PresentationFormat>A4 Paper (210x297 mm)</PresentationFormat>
  <Paragraphs>7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Symbol</vt:lpstr>
      <vt:lpstr>Times New Roman</vt:lpstr>
      <vt:lpstr>Office Theme</vt:lpstr>
      <vt:lpstr>PowerPoint Presentation</vt:lpstr>
    </vt:vector>
  </TitlesOfParts>
  <Company>The University of Liverpoo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omputing Services</dc:creator>
  <cp:lastModifiedBy>Oleg</cp:lastModifiedBy>
  <cp:revision>241</cp:revision>
  <cp:lastPrinted>2014-07-30T16:10:45Z</cp:lastPrinted>
  <dcterms:created xsi:type="dcterms:W3CDTF">2010-02-05T14:05:12Z</dcterms:created>
  <dcterms:modified xsi:type="dcterms:W3CDTF">2015-04-13T15:39:48Z</dcterms:modified>
</cp:coreProperties>
</file>